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64" r:id="rId2"/>
    <p:sldId id="263" r:id="rId3"/>
    <p:sldId id="260" r:id="rId4"/>
    <p:sldId id="265"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54599"/>
    <a:srgbClr val="8B0000"/>
    <a:srgbClr val="C57F7F"/>
    <a:srgbClr val="234F9D"/>
    <a:srgbClr val="2F69D1"/>
    <a:srgbClr val="C80000"/>
    <a:srgbClr val="D6D6D6"/>
    <a:srgbClr val="FDE725"/>
    <a:srgbClr val="21908C"/>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201" autoAdjust="0"/>
    <p:restoredTop sz="90389" autoAdjust="0"/>
  </p:normalViewPr>
  <p:slideViewPr>
    <p:cSldViewPr snapToGrid="0">
      <p:cViewPr>
        <p:scale>
          <a:sx n="130" d="100"/>
          <a:sy n="130" d="100"/>
        </p:scale>
        <p:origin x="2292" y="-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96A5F40-7A02-46B7-BF59-C7B0AB64AF8C}" type="datetimeFigureOut">
              <a:rPr lang="zh-CN" altLang="en-US" smtClean="0"/>
              <a:t>2025/7/17</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6CAC02C-3879-4370-B030-2EC7C259FF12}" type="slidenum">
              <a:rPr lang="zh-CN" altLang="en-US" smtClean="0"/>
              <a:t>‹#›</a:t>
            </a:fld>
            <a:endParaRPr lang="zh-CN" altLang="en-US"/>
          </a:p>
        </p:txBody>
      </p:sp>
    </p:spTree>
    <p:extLst>
      <p:ext uri="{BB962C8B-B14F-4D97-AF65-F5344CB8AC3E}">
        <p14:creationId xmlns:p14="http://schemas.microsoft.com/office/powerpoint/2010/main" val="4035720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dirty="0"/>
              <a:t>Supplement figure2</a:t>
            </a:r>
            <a:endParaRPr lang="zh-CN" altLang="en-US" dirty="0"/>
          </a:p>
        </p:txBody>
      </p:sp>
      <p:sp>
        <p:nvSpPr>
          <p:cNvPr id="4" name="灯片编号占位符 3"/>
          <p:cNvSpPr>
            <a:spLocks noGrp="1"/>
          </p:cNvSpPr>
          <p:nvPr>
            <p:ph type="sldNum" sz="quarter" idx="5"/>
          </p:nvPr>
        </p:nvSpPr>
        <p:spPr/>
        <p:txBody>
          <a:bodyPr/>
          <a:lstStyle/>
          <a:p>
            <a:fld id="{66CAC02C-3879-4370-B030-2EC7C259FF12}" type="slidenum">
              <a:rPr lang="zh-CN" altLang="en-US" smtClean="0"/>
              <a:t>3</a:t>
            </a:fld>
            <a:endParaRPr lang="zh-CN" altLang="en-US"/>
          </a:p>
        </p:txBody>
      </p:sp>
    </p:spTree>
    <p:extLst>
      <p:ext uri="{BB962C8B-B14F-4D97-AF65-F5344CB8AC3E}">
        <p14:creationId xmlns:p14="http://schemas.microsoft.com/office/powerpoint/2010/main" val="41019549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9499855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26750523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9894286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17123246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8302849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0348172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7873895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3576606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8157344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6496157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FA793949-6772-4BB1-A477-AB77FF7BB8A9}" type="datetimeFigureOut">
              <a:rPr lang="zh-CN" altLang="en-US" smtClean="0"/>
              <a:t>2025/7/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9174062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A793949-6772-4BB1-A477-AB77FF7BB8A9}" type="datetimeFigureOut">
              <a:rPr lang="zh-CN" altLang="en-US" smtClean="0"/>
              <a:t>2025/7/17</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1963FC1-D047-4397-BAC8-7A1F7896B986}" type="slidenum">
              <a:rPr lang="zh-CN" altLang="en-US" smtClean="0"/>
              <a:t>‹#›</a:t>
            </a:fld>
            <a:endParaRPr lang="zh-CN" altLang="en-US"/>
          </a:p>
        </p:txBody>
      </p:sp>
    </p:spTree>
    <p:extLst>
      <p:ext uri="{BB962C8B-B14F-4D97-AF65-F5344CB8AC3E}">
        <p14:creationId xmlns:p14="http://schemas.microsoft.com/office/powerpoint/2010/main" val="35490029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3" Type="http://schemas.openxmlformats.org/officeDocument/2006/relationships/image" Target="../media/image11.png"/><Relationship Id="rId18" Type="http://schemas.openxmlformats.org/officeDocument/2006/relationships/image" Target="../media/image16.svg"/><Relationship Id="rId26" Type="http://schemas.openxmlformats.org/officeDocument/2006/relationships/image" Target="../media/image24.svg"/><Relationship Id="rId3" Type="http://schemas.openxmlformats.org/officeDocument/2006/relationships/image" Target="../media/image1.png"/><Relationship Id="rId21" Type="http://schemas.openxmlformats.org/officeDocument/2006/relationships/image" Target="../media/image19.png"/><Relationship Id="rId34" Type="http://schemas.openxmlformats.org/officeDocument/2006/relationships/image" Target="../media/image32.svg"/><Relationship Id="rId7" Type="http://schemas.openxmlformats.org/officeDocument/2006/relationships/image" Target="../media/image5.png"/><Relationship Id="rId12" Type="http://schemas.openxmlformats.org/officeDocument/2006/relationships/image" Target="../media/image10.svg"/><Relationship Id="rId17" Type="http://schemas.openxmlformats.org/officeDocument/2006/relationships/image" Target="../media/image15.png"/><Relationship Id="rId25" Type="http://schemas.openxmlformats.org/officeDocument/2006/relationships/image" Target="../media/image23.png"/><Relationship Id="rId33" Type="http://schemas.openxmlformats.org/officeDocument/2006/relationships/image" Target="../media/image31.png"/><Relationship Id="rId2" Type="http://schemas.openxmlformats.org/officeDocument/2006/relationships/notesSlide" Target="../notesSlides/notesSlide1.xml"/><Relationship Id="rId16" Type="http://schemas.openxmlformats.org/officeDocument/2006/relationships/image" Target="../media/image14.svg"/><Relationship Id="rId20" Type="http://schemas.openxmlformats.org/officeDocument/2006/relationships/image" Target="../media/image18.svg"/><Relationship Id="rId29" Type="http://schemas.openxmlformats.org/officeDocument/2006/relationships/image" Target="../media/image27.svg"/><Relationship Id="rId1" Type="http://schemas.openxmlformats.org/officeDocument/2006/relationships/slideLayout" Target="../slideLayouts/slideLayout7.xml"/><Relationship Id="rId6" Type="http://schemas.openxmlformats.org/officeDocument/2006/relationships/image" Target="../media/image4.svg"/><Relationship Id="rId11" Type="http://schemas.openxmlformats.org/officeDocument/2006/relationships/image" Target="../media/image9.png"/><Relationship Id="rId24" Type="http://schemas.openxmlformats.org/officeDocument/2006/relationships/image" Target="../media/image22.svg"/><Relationship Id="rId32" Type="http://schemas.openxmlformats.org/officeDocument/2006/relationships/image" Target="../media/image30.svg"/><Relationship Id="rId5" Type="http://schemas.openxmlformats.org/officeDocument/2006/relationships/image" Target="../media/image3.png"/><Relationship Id="rId15" Type="http://schemas.openxmlformats.org/officeDocument/2006/relationships/image" Target="../media/image13.png"/><Relationship Id="rId23" Type="http://schemas.openxmlformats.org/officeDocument/2006/relationships/image" Target="../media/image21.png"/><Relationship Id="rId28" Type="http://schemas.openxmlformats.org/officeDocument/2006/relationships/image" Target="../media/image26.png"/><Relationship Id="rId10" Type="http://schemas.openxmlformats.org/officeDocument/2006/relationships/image" Target="../media/image8.svg"/><Relationship Id="rId19" Type="http://schemas.openxmlformats.org/officeDocument/2006/relationships/image" Target="../media/image17.png"/><Relationship Id="rId31" Type="http://schemas.openxmlformats.org/officeDocument/2006/relationships/image" Target="../media/image29.png"/><Relationship Id="rId4" Type="http://schemas.openxmlformats.org/officeDocument/2006/relationships/image" Target="../media/image2.svg"/><Relationship Id="rId9" Type="http://schemas.openxmlformats.org/officeDocument/2006/relationships/image" Target="../media/image7.png"/><Relationship Id="rId14" Type="http://schemas.openxmlformats.org/officeDocument/2006/relationships/image" Target="../media/image12.svg"/><Relationship Id="rId22" Type="http://schemas.openxmlformats.org/officeDocument/2006/relationships/image" Target="../media/image20.svg"/><Relationship Id="rId27" Type="http://schemas.openxmlformats.org/officeDocument/2006/relationships/image" Target="../media/image25.emf"/><Relationship Id="rId30" Type="http://schemas.openxmlformats.org/officeDocument/2006/relationships/image" Target="../media/image28.emf"/><Relationship Id="rId8" Type="http://schemas.openxmlformats.org/officeDocument/2006/relationships/image" Target="../media/image6.sv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 name="文本框 108">
            <a:extLst>
              <a:ext uri="{FF2B5EF4-FFF2-40B4-BE49-F238E27FC236}">
                <a16:creationId xmlns:a16="http://schemas.microsoft.com/office/drawing/2014/main" id="{8658B51E-0202-DDC2-4E27-F3F1F4CCC770}"/>
              </a:ext>
            </a:extLst>
          </p:cNvPr>
          <p:cNvSpPr txBox="1"/>
          <p:nvPr/>
        </p:nvSpPr>
        <p:spPr>
          <a:xfrm>
            <a:off x="175501" y="578566"/>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A</a:t>
            </a:r>
            <a:endParaRPr lang="zh-CN" altLang="en-US" sz="1000" dirty="0">
              <a:latin typeface="Arial" panose="020B0604020202020204" pitchFamily="34" charset="0"/>
              <a:cs typeface="Arial" panose="020B0604020202020204" pitchFamily="34" charset="0"/>
            </a:endParaRPr>
          </a:p>
        </p:txBody>
      </p:sp>
      <p:sp>
        <p:nvSpPr>
          <p:cNvPr id="110" name="文本框 109">
            <a:extLst>
              <a:ext uri="{FF2B5EF4-FFF2-40B4-BE49-F238E27FC236}">
                <a16:creationId xmlns:a16="http://schemas.microsoft.com/office/drawing/2014/main" id="{C8055A89-ABB7-D454-6D22-E15C706B83F3}"/>
              </a:ext>
            </a:extLst>
          </p:cNvPr>
          <p:cNvSpPr txBox="1"/>
          <p:nvPr/>
        </p:nvSpPr>
        <p:spPr>
          <a:xfrm>
            <a:off x="0" y="0"/>
            <a:ext cx="1049438"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Figure S1</a:t>
            </a:r>
            <a:endParaRPr lang="zh-CN" altLang="en-US" sz="1000" dirty="0">
              <a:latin typeface="Arial" panose="020B0604020202020204" pitchFamily="34" charset="0"/>
              <a:cs typeface="Arial" panose="020B0604020202020204" pitchFamily="34" charset="0"/>
            </a:endParaRPr>
          </a:p>
        </p:txBody>
      </p:sp>
      <p:sp>
        <p:nvSpPr>
          <p:cNvPr id="482" name="文本框 481">
            <a:extLst>
              <a:ext uri="{FF2B5EF4-FFF2-40B4-BE49-F238E27FC236}">
                <a16:creationId xmlns:a16="http://schemas.microsoft.com/office/drawing/2014/main" id="{3E7AD9A0-3CF5-FDC9-A16F-F9D9FBC5A9E8}"/>
              </a:ext>
            </a:extLst>
          </p:cNvPr>
          <p:cNvSpPr txBox="1"/>
          <p:nvPr/>
        </p:nvSpPr>
        <p:spPr>
          <a:xfrm>
            <a:off x="175501" y="2963525"/>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grpSp>
        <p:nvGrpSpPr>
          <p:cNvPr id="111" name="组合 110">
            <a:extLst>
              <a:ext uri="{FF2B5EF4-FFF2-40B4-BE49-F238E27FC236}">
                <a16:creationId xmlns:a16="http://schemas.microsoft.com/office/drawing/2014/main" id="{399E678D-670E-8204-1F09-206CB92D2FBC}"/>
              </a:ext>
            </a:extLst>
          </p:cNvPr>
          <p:cNvGrpSpPr/>
          <p:nvPr/>
        </p:nvGrpSpPr>
        <p:grpSpPr>
          <a:xfrm>
            <a:off x="4433653" y="1002198"/>
            <a:ext cx="1848130" cy="1715899"/>
            <a:chOff x="4427346" y="923632"/>
            <a:chExt cx="1848130" cy="1715899"/>
          </a:xfrm>
        </p:grpSpPr>
        <p:sp>
          <p:nvSpPr>
            <p:cNvPr id="529" name="pl6">
              <a:extLst>
                <a:ext uri="{FF2B5EF4-FFF2-40B4-BE49-F238E27FC236}">
                  <a16:creationId xmlns:a16="http://schemas.microsoft.com/office/drawing/2014/main" id="{2987AC30-93C4-9F6C-2A96-FCEAAB615B9F}"/>
                </a:ext>
              </a:extLst>
            </p:cNvPr>
            <p:cNvSpPr/>
            <p:nvPr/>
          </p:nvSpPr>
          <p:spPr>
            <a:xfrm>
              <a:off x="4800450" y="1716351"/>
              <a:ext cx="0" cy="278603"/>
            </a:xfrm>
            <a:custGeom>
              <a:avLst/>
              <a:gdLst/>
              <a:ahLst/>
              <a:cxnLst/>
              <a:rect l="0" t="0" r="0" b="0"/>
              <a:pathLst>
                <a:path h="832530">
                  <a:moveTo>
                    <a:pt x="0" y="832530"/>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30" name="pl7">
              <a:extLst>
                <a:ext uri="{FF2B5EF4-FFF2-40B4-BE49-F238E27FC236}">
                  <a16:creationId xmlns:a16="http://schemas.microsoft.com/office/drawing/2014/main" id="{91B37697-F89A-970C-B1F0-2190FED1CDD2}"/>
                </a:ext>
              </a:extLst>
            </p:cNvPr>
            <p:cNvSpPr/>
            <p:nvPr/>
          </p:nvSpPr>
          <p:spPr>
            <a:xfrm>
              <a:off x="4800450" y="2230695"/>
              <a:ext cx="0" cy="257172"/>
            </a:xfrm>
            <a:custGeom>
              <a:avLst/>
              <a:gdLst/>
              <a:ahLst/>
              <a:cxnLst/>
              <a:rect l="0" t="0" r="0" b="0"/>
              <a:pathLst>
                <a:path h="768489">
                  <a:moveTo>
                    <a:pt x="0" y="0"/>
                  </a:moveTo>
                  <a:lnTo>
                    <a:pt x="0" y="768489"/>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31" name="pg8">
              <a:extLst>
                <a:ext uri="{FF2B5EF4-FFF2-40B4-BE49-F238E27FC236}">
                  <a16:creationId xmlns:a16="http://schemas.microsoft.com/office/drawing/2014/main" id="{6C189508-1DB2-0898-1DD2-2BDA019E2BE7}"/>
                </a:ext>
              </a:extLst>
            </p:cNvPr>
            <p:cNvSpPr/>
            <p:nvPr/>
          </p:nvSpPr>
          <p:spPr>
            <a:xfrm>
              <a:off x="4751608" y="1994954"/>
              <a:ext cx="97684" cy="235740"/>
            </a:xfrm>
            <a:custGeom>
              <a:avLst/>
              <a:gdLst/>
              <a:ahLst/>
              <a:cxnLst/>
              <a:rect l="0" t="0" r="0" b="0"/>
              <a:pathLst>
                <a:path w="291902" h="704448">
                  <a:moveTo>
                    <a:pt x="0" y="0"/>
                  </a:moveTo>
                  <a:lnTo>
                    <a:pt x="0" y="704448"/>
                  </a:lnTo>
                  <a:lnTo>
                    <a:pt x="291902" y="704448"/>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32" name="pl9">
              <a:extLst>
                <a:ext uri="{FF2B5EF4-FFF2-40B4-BE49-F238E27FC236}">
                  <a16:creationId xmlns:a16="http://schemas.microsoft.com/office/drawing/2014/main" id="{98C7B654-B8DD-FFDA-51E5-89827545C5C4}"/>
                </a:ext>
              </a:extLst>
            </p:cNvPr>
            <p:cNvSpPr/>
            <p:nvPr/>
          </p:nvSpPr>
          <p:spPr>
            <a:xfrm>
              <a:off x="4751608" y="2144971"/>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33" name="pl10">
              <a:extLst>
                <a:ext uri="{FF2B5EF4-FFF2-40B4-BE49-F238E27FC236}">
                  <a16:creationId xmlns:a16="http://schemas.microsoft.com/office/drawing/2014/main" id="{4D4A4272-B9E7-5390-E9A0-170358325D7F}"/>
                </a:ext>
              </a:extLst>
            </p:cNvPr>
            <p:cNvSpPr/>
            <p:nvPr/>
          </p:nvSpPr>
          <p:spPr>
            <a:xfrm>
              <a:off x="4937208" y="1630628"/>
              <a:ext cx="0" cy="188593"/>
            </a:xfrm>
            <a:custGeom>
              <a:avLst/>
              <a:gdLst/>
              <a:ahLst/>
              <a:cxnLst/>
              <a:rect l="0" t="0" r="0" b="0"/>
              <a:pathLst>
                <a:path h="563559">
                  <a:moveTo>
                    <a:pt x="0" y="563559"/>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34" name="pl11">
              <a:extLst>
                <a:ext uri="{FF2B5EF4-FFF2-40B4-BE49-F238E27FC236}">
                  <a16:creationId xmlns:a16="http://schemas.microsoft.com/office/drawing/2014/main" id="{9EFD8FC6-02ED-E910-E4EA-6E659B50488B}"/>
                </a:ext>
              </a:extLst>
            </p:cNvPr>
            <p:cNvSpPr/>
            <p:nvPr/>
          </p:nvSpPr>
          <p:spPr>
            <a:xfrm>
              <a:off x="4937208" y="2123540"/>
              <a:ext cx="0" cy="278603"/>
            </a:xfrm>
            <a:custGeom>
              <a:avLst/>
              <a:gdLst/>
              <a:ahLst/>
              <a:cxnLst/>
              <a:rect l="0" t="0" r="0" b="0"/>
              <a:pathLst>
                <a:path h="832530">
                  <a:moveTo>
                    <a:pt x="0" y="0"/>
                  </a:moveTo>
                  <a:lnTo>
                    <a:pt x="0" y="83253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35" name="pg12">
              <a:extLst>
                <a:ext uri="{FF2B5EF4-FFF2-40B4-BE49-F238E27FC236}">
                  <a16:creationId xmlns:a16="http://schemas.microsoft.com/office/drawing/2014/main" id="{CF621A0D-D4C0-2F6B-99E5-4778BED78C17}"/>
                </a:ext>
              </a:extLst>
            </p:cNvPr>
            <p:cNvSpPr/>
            <p:nvPr/>
          </p:nvSpPr>
          <p:spPr>
            <a:xfrm>
              <a:off x="4888366" y="1819220"/>
              <a:ext cx="97684" cy="304320"/>
            </a:xfrm>
            <a:custGeom>
              <a:avLst/>
              <a:gdLst/>
              <a:ahLst/>
              <a:cxnLst/>
              <a:rect l="0" t="0" r="0" b="0"/>
              <a:pathLst>
                <a:path w="291902" h="909379">
                  <a:moveTo>
                    <a:pt x="0" y="0"/>
                  </a:moveTo>
                  <a:lnTo>
                    <a:pt x="0" y="909379"/>
                  </a:lnTo>
                  <a:lnTo>
                    <a:pt x="291902" y="909379"/>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36" name="pl13">
              <a:extLst>
                <a:ext uri="{FF2B5EF4-FFF2-40B4-BE49-F238E27FC236}">
                  <a16:creationId xmlns:a16="http://schemas.microsoft.com/office/drawing/2014/main" id="{0FAE2952-0909-3AE1-8723-D369B7C3872D}"/>
                </a:ext>
              </a:extLst>
            </p:cNvPr>
            <p:cNvSpPr/>
            <p:nvPr/>
          </p:nvSpPr>
          <p:spPr>
            <a:xfrm>
              <a:off x="4888366" y="2059247"/>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37" name="pt14">
              <a:extLst>
                <a:ext uri="{FF2B5EF4-FFF2-40B4-BE49-F238E27FC236}">
                  <a16:creationId xmlns:a16="http://schemas.microsoft.com/office/drawing/2014/main" id="{2FA85EB5-B202-6C4A-3DC2-6409CBBE29D7}"/>
                </a:ext>
              </a:extLst>
            </p:cNvPr>
            <p:cNvSpPr/>
            <p:nvPr/>
          </p:nvSpPr>
          <p:spPr>
            <a:xfrm>
              <a:off x="5182878" y="187832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38" name="pt15">
              <a:extLst>
                <a:ext uri="{FF2B5EF4-FFF2-40B4-BE49-F238E27FC236}">
                  <a16:creationId xmlns:a16="http://schemas.microsoft.com/office/drawing/2014/main" id="{CEDBFDE2-2612-6242-2DD1-0A2497136E9B}"/>
                </a:ext>
              </a:extLst>
            </p:cNvPr>
            <p:cNvSpPr/>
            <p:nvPr/>
          </p:nvSpPr>
          <p:spPr>
            <a:xfrm>
              <a:off x="5182878" y="1576083"/>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39" name="pt16">
              <a:extLst>
                <a:ext uri="{FF2B5EF4-FFF2-40B4-BE49-F238E27FC236}">
                  <a16:creationId xmlns:a16="http://schemas.microsoft.com/office/drawing/2014/main" id="{0363CACE-AAFA-73C8-4D09-DB5FD4DE8E3D}"/>
                </a:ext>
              </a:extLst>
            </p:cNvPr>
            <p:cNvSpPr/>
            <p:nvPr/>
          </p:nvSpPr>
          <p:spPr>
            <a:xfrm>
              <a:off x="5182878" y="179589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40" name="pt17">
              <a:extLst>
                <a:ext uri="{FF2B5EF4-FFF2-40B4-BE49-F238E27FC236}">
                  <a16:creationId xmlns:a16="http://schemas.microsoft.com/office/drawing/2014/main" id="{1CEBF299-AB49-9110-5954-EAF5902A6912}"/>
                </a:ext>
              </a:extLst>
            </p:cNvPr>
            <p:cNvSpPr/>
            <p:nvPr/>
          </p:nvSpPr>
          <p:spPr>
            <a:xfrm>
              <a:off x="5182878" y="179589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41" name="pt18">
              <a:extLst>
                <a:ext uri="{FF2B5EF4-FFF2-40B4-BE49-F238E27FC236}">
                  <a16:creationId xmlns:a16="http://schemas.microsoft.com/office/drawing/2014/main" id="{9A5511B5-207D-A81E-51D8-9F2D9311E7D9}"/>
                </a:ext>
              </a:extLst>
            </p:cNvPr>
            <p:cNvSpPr/>
            <p:nvPr/>
          </p:nvSpPr>
          <p:spPr>
            <a:xfrm>
              <a:off x="5182878" y="1521129"/>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42" name="pl19">
              <a:extLst>
                <a:ext uri="{FF2B5EF4-FFF2-40B4-BE49-F238E27FC236}">
                  <a16:creationId xmlns:a16="http://schemas.microsoft.com/office/drawing/2014/main" id="{6485D717-A5D2-1B6D-D23F-857298877DD0}"/>
                </a:ext>
              </a:extLst>
            </p:cNvPr>
            <p:cNvSpPr/>
            <p:nvPr/>
          </p:nvSpPr>
          <p:spPr>
            <a:xfrm>
              <a:off x="5191186" y="1941588"/>
              <a:ext cx="0" cy="178599"/>
            </a:xfrm>
            <a:custGeom>
              <a:avLst/>
              <a:gdLst/>
              <a:ahLst/>
              <a:cxnLst/>
              <a:rect l="0" t="0" r="0" b="0"/>
              <a:pathLst>
                <a:path h="533695">
                  <a:moveTo>
                    <a:pt x="0" y="533695"/>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43" name="pl20">
              <a:extLst>
                <a:ext uri="{FF2B5EF4-FFF2-40B4-BE49-F238E27FC236}">
                  <a16:creationId xmlns:a16="http://schemas.microsoft.com/office/drawing/2014/main" id="{3E77BCB4-2D8F-96EF-EC5C-0D3C217CE0B1}"/>
                </a:ext>
              </a:extLst>
            </p:cNvPr>
            <p:cNvSpPr/>
            <p:nvPr/>
          </p:nvSpPr>
          <p:spPr>
            <a:xfrm>
              <a:off x="5191186" y="2243833"/>
              <a:ext cx="0" cy="0"/>
            </a:xfrm>
            <a:custGeom>
              <a:avLst/>
              <a:gdLst/>
              <a:ahLst/>
              <a:cxnLst/>
              <a:rect l="0" t="0" r="0" b="0"/>
              <a:pathLst>
                <a:path>
                  <a:moveTo>
                    <a:pt x="0" y="0"/>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44" name="pg21">
              <a:extLst>
                <a:ext uri="{FF2B5EF4-FFF2-40B4-BE49-F238E27FC236}">
                  <a16:creationId xmlns:a16="http://schemas.microsoft.com/office/drawing/2014/main" id="{FFA37C28-2C30-1D0C-87CA-AA9A1F680E4E}"/>
                </a:ext>
              </a:extLst>
            </p:cNvPr>
            <p:cNvSpPr/>
            <p:nvPr/>
          </p:nvSpPr>
          <p:spPr>
            <a:xfrm>
              <a:off x="5142344" y="2120187"/>
              <a:ext cx="97684" cy="123645"/>
            </a:xfrm>
            <a:custGeom>
              <a:avLst/>
              <a:gdLst/>
              <a:ahLst/>
              <a:cxnLst/>
              <a:rect l="0" t="0" r="0" b="0"/>
              <a:pathLst>
                <a:path w="291902" h="369481">
                  <a:moveTo>
                    <a:pt x="0" y="0"/>
                  </a:moveTo>
                  <a:lnTo>
                    <a:pt x="0" y="369481"/>
                  </a:lnTo>
                  <a:lnTo>
                    <a:pt x="291902" y="369481"/>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46" name="pl22">
              <a:extLst>
                <a:ext uri="{FF2B5EF4-FFF2-40B4-BE49-F238E27FC236}">
                  <a16:creationId xmlns:a16="http://schemas.microsoft.com/office/drawing/2014/main" id="{CD6254CC-C053-E88A-AC93-09AFCB36C4FB}"/>
                </a:ext>
              </a:extLst>
            </p:cNvPr>
            <p:cNvSpPr/>
            <p:nvPr/>
          </p:nvSpPr>
          <p:spPr>
            <a:xfrm>
              <a:off x="5142344" y="2188879"/>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47" name="pt23">
              <a:extLst>
                <a:ext uri="{FF2B5EF4-FFF2-40B4-BE49-F238E27FC236}">
                  <a16:creationId xmlns:a16="http://schemas.microsoft.com/office/drawing/2014/main" id="{AA7F2900-F7B7-9626-F995-9BE37837B9B5}"/>
                </a:ext>
              </a:extLst>
            </p:cNvPr>
            <p:cNvSpPr/>
            <p:nvPr/>
          </p:nvSpPr>
          <p:spPr>
            <a:xfrm>
              <a:off x="5319635" y="1576083"/>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48" name="pt24">
              <a:extLst>
                <a:ext uri="{FF2B5EF4-FFF2-40B4-BE49-F238E27FC236}">
                  <a16:creationId xmlns:a16="http://schemas.microsoft.com/office/drawing/2014/main" id="{23C9E262-E5B8-FFAB-817F-E9C633278D78}"/>
                </a:ext>
              </a:extLst>
            </p:cNvPr>
            <p:cNvSpPr/>
            <p:nvPr/>
          </p:nvSpPr>
          <p:spPr>
            <a:xfrm>
              <a:off x="5319635" y="1521129"/>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49" name="pt25">
              <a:extLst>
                <a:ext uri="{FF2B5EF4-FFF2-40B4-BE49-F238E27FC236}">
                  <a16:creationId xmlns:a16="http://schemas.microsoft.com/office/drawing/2014/main" id="{B410A358-D35B-E3B5-78CF-AC84E333508B}"/>
                </a:ext>
              </a:extLst>
            </p:cNvPr>
            <p:cNvSpPr/>
            <p:nvPr/>
          </p:nvSpPr>
          <p:spPr>
            <a:xfrm>
              <a:off x="5319635" y="1493652"/>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50" name="pt26">
              <a:extLst>
                <a:ext uri="{FF2B5EF4-FFF2-40B4-BE49-F238E27FC236}">
                  <a16:creationId xmlns:a16="http://schemas.microsoft.com/office/drawing/2014/main" id="{5F117535-A540-0764-CE15-E16FB6748D02}"/>
                </a:ext>
              </a:extLst>
            </p:cNvPr>
            <p:cNvSpPr/>
            <p:nvPr/>
          </p:nvSpPr>
          <p:spPr>
            <a:xfrm>
              <a:off x="5319635" y="1466176"/>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51" name="pl27">
              <a:extLst>
                <a:ext uri="{FF2B5EF4-FFF2-40B4-BE49-F238E27FC236}">
                  <a16:creationId xmlns:a16="http://schemas.microsoft.com/office/drawing/2014/main" id="{8DD5079E-6FE0-5C8B-6DDF-40A5FE074DE3}"/>
                </a:ext>
              </a:extLst>
            </p:cNvPr>
            <p:cNvSpPr/>
            <p:nvPr/>
          </p:nvSpPr>
          <p:spPr>
            <a:xfrm>
              <a:off x="5327943" y="1639344"/>
              <a:ext cx="0" cy="329721"/>
            </a:xfrm>
            <a:custGeom>
              <a:avLst/>
              <a:gdLst/>
              <a:ahLst/>
              <a:cxnLst/>
              <a:rect l="0" t="0" r="0" b="0"/>
              <a:pathLst>
                <a:path h="985284">
                  <a:moveTo>
                    <a:pt x="0" y="985284"/>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52" name="pl28">
              <a:extLst>
                <a:ext uri="{FF2B5EF4-FFF2-40B4-BE49-F238E27FC236}">
                  <a16:creationId xmlns:a16="http://schemas.microsoft.com/office/drawing/2014/main" id="{6BA1C4D4-5126-3CFE-7CED-4AA448D86B01}"/>
                </a:ext>
              </a:extLst>
            </p:cNvPr>
            <p:cNvSpPr/>
            <p:nvPr/>
          </p:nvSpPr>
          <p:spPr>
            <a:xfrm>
              <a:off x="5327943" y="2188879"/>
              <a:ext cx="0" cy="54954"/>
            </a:xfrm>
            <a:custGeom>
              <a:avLst/>
              <a:gdLst/>
              <a:ahLst/>
              <a:cxnLst/>
              <a:rect l="0" t="0" r="0" b="0"/>
              <a:pathLst>
                <a:path h="164214">
                  <a:moveTo>
                    <a:pt x="0" y="0"/>
                  </a:moveTo>
                  <a:lnTo>
                    <a:pt x="0" y="164214"/>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53" name="pg29">
              <a:extLst>
                <a:ext uri="{FF2B5EF4-FFF2-40B4-BE49-F238E27FC236}">
                  <a16:creationId xmlns:a16="http://schemas.microsoft.com/office/drawing/2014/main" id="{F7D9CB9E-AC52-7260-E802-6A32EF02A046}"/>
                </a:ext>
              </a:extLst>
            </p:cNvPr>
            <p:cNvSpPr/>
            <p:nvPr/>
          </p:nvSpPr>
          <p:spPr>
            <a:xfrm>
              <a:off x="5279101" y="1969065"/>
              <a:ext cx="97684" cy="219814"/>
            </a:xfrm>
            <a:custGeom>
              <a:avLst/>
              <a:gdLst/>
              <a:ahLst/>
              <a:cxnLst/>
              <a:rect l="0" t="0" r="0" b="0"/>
              <a:pathLst>
                <a:path w="291902" h="656856">
                  <a:moveTo>
                    <a:pt x="0" y="0"/>
                  </a:moveTo>
                  <a:lnTo>
                    <a:pt x="0" y="656856"/>
                  </a:lnTo>
                  <a:lnTo>
                    <a:pt x="291902" y="656856"/>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54" name="pl30">
              <a:extLst>
                <a:ext uri="{FF2B5EF4-FFF2-40B4-BE49-F238E27FC236}">
                  <a16:creationId xmlns:a16="http://schemas.microsoft.com/office/drawing/2014/main" id="{3A2813E5-B5ED-8E44-4FB5-99C70CAF295F}"/>
                </a:ext>
              </a:extLst>
            </p:cNvPr>
            <p:cNvSpPr/>
            <p:nvPr/>
          </p:nvSpPr>
          <p:spPr>
            <a:xfrm>
              <a:off x="5279101" y="2120187"/>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55" name="pt31">
              <a:extLst>
                <a:ext uri="{FF2B5EF4-FFF2-40B4-BE49-F238E27FC236}">
                  <a16:creationId xmlns:a16="http://schemas.microsoft.com/office/drawing/2014/main" id="{CA79DBE7-BD00-D715-C2F7-4B36D7D7C546}"/>
                </a:ext>
              </a:extLst>
            </p:cNvPr>
            <p:cNvSpPr/>
            <p:nvPr/>
          </p:nvSpPr>
          <p:spPr>
            <a:xfrm>
              <a:off x="5573613" y="1826956"/>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56" name="pt32">
              <a:extLst>
                <a:ext uri="{FF2B5EF4-FFF2-40B4-BE49-F238E27FC236}">
                  <a16:creationId xmlns:a16="http://schemas.microsoft.com/office/drawing/2014/main" id="{E7A68C4E-1E08-F109-5274-592CB6772CDC}"/>
                </a:ext>
              </a:extLst>
            </p:cNvPr>
            <p:cNvSpPr/>
            <p:nvPr/>
          </p:nvSpPr>
          <p:spPr>
            <a:xfrm>
              <a:off x="5573613" y="1876756"/>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57" name="pl33">
              <a:extLst>
                <a:ext uri="{FF2B5EF4-FFF2-40B4-BE49-F238E27FC236}">
                  <a16:creationId xmlns:a16="http://schemas.microsoft.com/office/drawing/2014/main" id="{05997B79-5B0D-F7BE-E097-715E295D9113}"/>
                </a:ext>
              </a:extLst>
            </p:cNvPr>
            <p:cNvSpPr/>
            <p:nvPr/>
          </p:nvSpPr>
          <p:spPr>
            <a:xfrm>
              <a:off x="5581921" y="1984665"/>
              <a:ext cx="0" cy="99600"/>
            </a:xfrm>
            <a:custGeom>
              <a:avLst/>
              <a:gdLst/>
              <a:ahLst/>
              <a:cxnLst/>
              <a:rect l="0" t="0" r="0" b="0"/>
              <a:pathLst>
                <a:path h="297629">
                  <a:moveTo>
                    <a:pt x="0" y="297629"/>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58" name="pl34">
              <a:extLst>
                <a:ext uri="{FF2B5EF4-FFF2-40B4-BE49-F238E27FC236}">
                  <a16:creationId xmlns:a16="http://schemas.microsoft.com/office/drawing/2014/main" id="{7928A639-60C1-8CFF-4483-AB690DBC5537}"/>
                </a:ext>
              </a:extLst>
            </p:cNvPr>
            <p:cNvSpPr/>
            <p:nvPr/>
          </p:nvSpPr>
          <p:spPr>
            <a:xfrm>
              <a:off x="5581921" y="2183866"/>
              <a:ext cx="0" cy="0"/>
            </a:xfrm>
            <a:custGeom>
              <a:avLst/>
              <a:gdLst/>
              <a:ahLst/>
              <a:cxnLst/>
              <a:rect l="0" t="0" r="0" b="0"/>
              <a:pathLst>
                <a:path>
                  <a:moveTo>
                    <a:pt x="0" y="0"/>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59" name="pg35">
              <a:extLst>
                <a:ext uri="{FF2B5EF4-FFF2-40B4-BE49-F238E27FC236}">
                  <a16:creationId xmlns:a16="http://schemas.microsoft.com/office/drawing/2014/main" id="{14C4ABA4-9CF9-BCD7-09DE-311DF51EAD7A}"/>
                </a:ext>
              </a:extLst>
            </p:cNvPr>
            <p:cNvSpPr/>
            <p:nvPr/>
          </p:nvSpPr>
          <p:spPr>
            <a:xfrm>
              <a:off x="5533079" y="2084265"/>
              <a:ext cx="97684" cy="99600"/>
            </a:xfrm>
            <a:custGeom>
              <a:avLst/>
              <a:gdLst/>
              <a:ahLst/>
              <a:cxnLst/>
              <a:rect l="0" t="0" r="0" b="0"/>
              <a:pathLst>
                <a:path w="291902" h="297629">
                  <a:moveTo>
                    <a:pt x="0" y="0"/>
                  </a:moveTo>
                  <a:lnTo>
                    <a:pt x="0" y="297629"/>
                  </a:lnTo>
                  <a:lnTo>
                    <a:pt x="291902" y="297629"/>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60" name="pl36">
              <a:extLst>
                <a:ext uri="{FF2B5EF4-FFF2-40B4-BE49-F238E27FC236}">
                  <a16:creationId xmlns:a16="http://schemas.microsoft.com/office/drawing/2014/main" id="{E19B0CEF-F03E-13EA-F819-30855504ABF3}"/>
                </a:ext>
              </a:extLst>
            </p:cNvPr>
            <p:cNvSpPr/>
            <p:nvPr/>
          </p:nvSpPr>
          <p:spPr>
            <a:xfrm>
              <a:off x="5533079" y="2183866"/>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61" name="pt37">
              <a:extLst>
                <a:ext uri="{FF2B5EF4-FFF2-40B4-BE49-F238E27FC236}">
                  <a16:creationId xmlns:a16="http://schemas.microsoft.com/office/drawing/2014/main" id="{EE74EE62-25E1-201E-81BE-37EE441F0B16}"/>
                </a:ext>
              </a:extLst>
            </p:cNvPr>
            <p:cNvSpPr/>
            <p:nvPr/>
          </p:nvSpPr>
          <p:spPr>
            <a:xfrm>
              <a:off x="5710371" y="1528155"/>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62" name="pt38">
              <a:extLst>
                <a:ext uri="{FF2B5EF4-FFF2-40B4-BE49-F238E27FC236}">
                  <a16:creationId xmlns:a16="http://schemas.microsoft.com/office/drawing/2014/main" id="{B640BF8C-F161-A420-267A-EEC7355DA743}"/>
                </a:ext>
              </a:extLst>
            </p:cNvPr>
            <p:cNvSpPr/>
            <p:nvPr/>
          </p:nvSpPr>
          <p:spPr>
            <a:xfrm>
              <a:off x="5710371" y="1030152"/>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63" name="pt39">
              <a:extLst>
                <a:ext uri="{FF2B5EF4-FFF2-40B4-BE49-F238E27FC236}">
                  <a16:creationId xmlns:a16="http://schemas.microsoft.com/office/drawing/2014/main" id="{48A92092-6353-997A-3C96-2CCC0A970F02}"/>
                </a:ext>
              </a:extLst>
            </p:cNvPr>
            <p:cNvSpPr/>
            <p:nvPr/>
          </p:nvSpPr>
          <p:spPr>
            <a:xfrm>
              <a:off x="5710371" y="1079953"/>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64" name="pl40">
              <a:extLst>
                <a:ext uri="{FF2B5EF4-FFF2-40B4-BE49-F238E27FC236}">
                  <a16:creationId xmlns:a16="http://schemas.microsoft.com/office/drawing/2014/main" id="{CC58A5B1-60EB-0FC7-8740-F2445A799017}"/>
                </a:ext>
              </a:extLst>
            </p:cNvPr>
            <p:cNvSpPr/>
            <p:nvPr/>
          </p:nvSpPr>
          <p:spPr>
            <a:xfrm>
              <a:off x="5718678" y="1735663"/>
              <a:ext cx="0" cy="261451"/>
            </a:xfrm>
            <a:custGeom>
              <a:avLst/>
              <a:gdLst/>
              <a:ahLst/>
              <a:cxnLst/>
              <a:rect l="0" t="0" r="0" b="0"/>
              <a:pathLst>
                <a:path h="781277">
                  <a:moveTo>
                    <a:pt x="0" y="781277"/>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65" name="pl41">
              <a:extLst>
                <a:ext uri="{FF2B5EF4-FFF2-40B4-BE49-F238E27FC236}">
                  <a16:creationId xmlns:a16="http://schemas.microsoft.com/office/drawing/2014/main" id="{EC76B386-539E-63A8-DCDE-3BE838C2F6A4}"/>
                </a:ext>
              </a:extLst>
            </p:cNvPr>
            <p:cNvSpPr/>
            <p:nvPr/>
          </p:nvSpPr>
          <p:spPr>
            <a:xfrm>
              <a:off x="5718678" y="2183866"/>
              <a:ext cx="0" cy="0"/>
            </a:xfrm>
            <a:custGeom>
              <a:avLst/>
              <a:gdLst/>
              <a:ahLst/>
              <a:cxnLst/>
              <a:rect l="0" t="0" r="0" b="0"/>
              <a:pathLst>
                <a:path>
                  <a:moveTo>
                    <a:pt x="0" y="0"/>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66" name="pg42">
              <a:extLst>
                <a:ext uri="{FF2B5EF4-FFF2-40B4-BE49-F238E27FC236}">
                  <a16:creationId xmlns:a16="http://schemas.microsoft.com/office/drawing/2014/main" id="{D886B8C5-E148-70BD-5ACA-A2C14F23A863}"/>
                </a:ext>
              </a:extLst>
            </p:cNvPr>
            <p:cNvSpPr/>
            <p:nvPr/>
          </p:nvSpPr>
          <p:spPr>
            <a:xfrm>
              <a:off x="5669836" y="1997115"/>
              <a:ext cx="97684" cy="186751"/>
            </a:xfrm>
            <a:custGeom>
              <a:avLst/>
              <a:gdLst/>
              <a:ahLst/>
              <a:cxnLst/>
              <a:rect l="0" t="0" r="0" b="0"/>
              <a:pathLst>
                <a:path w="291902" h="558055">
                  <a:moveTo>
                    <a:pt x="0" y="0"/>
                  </a:moveTo>
                  <a:lnTo>
                    <a:pt x="0" y="558055"/>
                  </a:lnTo>
                  <a:lnTo>
                    <a:pt x="291902" y="558055"/>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67" name="pl43">
              <a:extLst>
                <a:ext uri="{FF2B5EF4-FFF2-40B4-BE49-F238E27FC236}">
                  <a16:creationId xmlns:a16="http://schemas.microsoft.com/office/drawing/2014/main" id="{E583CE82-C03D-ACEB-6D99-D91AFD8155FF}"/>
                </a:ext>
              </a:extLst>
            </p:cNvPr>
            <p:cNvSpPr/>
            <p:nvPr/>
          </p:nvSpPr>
          <p:spPr>
            <a:xfrm>
              <a:off x="5669836" y="2134065"/>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568" name="pt44">
              <a:extLst>
                <a:ext uri="{FF2B5EF4-FFF2-40B4-BE49-F238E27FC236}">
                  <a16:creationId xmlns:a16="http://schemas.microsoft.com/office/drawing/2014/main" id="{5B69CC64-159F-CC75-1360-1C355971AC15}"/>
                </a:ext>
              </a:extLst>
            </p:cNvPr>
            <p:cNvSpPr/>
            <p:nvPr/>
          </p:nvSpPr>
          <p:spPr>
            <a:xfrm>
              <a:off x="5964349" y="1965775"/>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69" name="pt45">
              <a:extLst>
                <a:ext uri="{FF2B5EF4-FFF2-40B4-BE49-F238E27FC236}">
                  <a16:creationId xmlns:a16="http://schemas.microsoft.com/office/drawing/2014/main" id="{C5BC5AB4-D3C1-F16D-58EA-6260BB8FDFEF}"/>
                </a:ext>
              </a:extLst>
            </p:cNvPr>
            <p:cNvSpPr/>
            <p:nvPr/>
          </p:nvSpPr>
          <p:spPr>
            <a:xfrm>
              <a:off x="5964349" y="1832730"/>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70" name="pt46">
              <a:extLst>
                <a:ext uri="{FF2B5EF4-FFF2-40B4-BE49-F238E27FC236}">
                  <a16:creationId xmlns:a16="http://schemas.microsoft.com/office/drawing/2014/main" id="{61E493AB-6BF8-27A5-53C9-98DE889A313C}"/>
                </a:ext>
              </a:extLst>
            </p:cNvPr>
            <p:cNvSpPr/>
            <p:nvPr/>
          </p:nvSpPr>
          <p:spPr>
            <a:xfrm>
              <a:off x="5964349" y="1950122"/>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71" name="pt47">
              <a:extLst>
                <a:ext uri="{FF2B5EF4-FFF2-40B4-BE49-F238E27FC236}">
                  <a16:creationId xmlns:a16="http://schemas.microsoft.com/office/drawing/2014/main" id="{6495EEB7-C101-4889-E48D-1BE18914AE35}"/>
                </a:ext>
              </a:extLst>
            </p:cNvPr>
            <p:cNvSpPr/>
            <p:nvPr/>
          </p:nvSpPr>
          <p:spPr>
            <a:xfrm>
              <a:off x="5964349" y="1910992"/>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72" name="pt48">
              <a:extLst>
                <a:ext uri="{FF2B5EF4-FFF2-40B4-BE49-F238E27FC236}">
                  <a16:creationId xmlns:a16="http://schemas.microsoft.com/office/drawing/2014/main" id="{0422F2F6-82B3-6281-5F44-C4D566FFBB57}"/>
                </a:ext>
              </a:extLst>
            </p:cNvPr>
            <p:cNvSpPr/>
            <p:nvPr/>
          </p:nvSpPr>
          <p:spPr>
            <a:xfrm>
              <a:off x="5964349" y="1536901"/>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573" name="pl49">
              <a:extLst>
                <a:ext uri="{FF2B5EF4-FFF2-40B4-BE49-F238E27FC236}">
                  <a16:creationId xmlns:a16="http://schemas.microsoft.com/office/drawing/2014/main" id="{73180009-9626-BA80-F5AF-DB2EAA36365B}"/>
                </a:ext>
              </a:extLst>
            </p:cNvPr>
            <p:cNvSpPr/>
            <p:nvPr/>
          </p:nvSpPr>
          <p:spPr>
            <a:xfrm>
              <a:off x="5972656" y="2067997"/>
              <a:ext cx="0" cy="39131"/>
            </a:xfrm>
            <a:custGeom>
              <a:avLst/>
              <a:gdLst/>
              <a:ahLst/>
              <a:cxnLst/>
              <a:rect l="0" t="0" r="0" b="0"/>
              <a:pathLst>
                <a:path h="116932">
                  <a:moveTo>
                    <a:pt x="0" y="116932"/>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74" name="pl50">
              <a:extLst>
                <a:ext uri="{FF2B5EF4-FFF2-40B4-BE49-F238E27FC236}">
                  <a16:creationId xmlns:a16="http://schemas.microsoft.com/office/drawing/2014/main" id="{D242D510-394D-7932-7FDA-50B2B2359AE0}"/>
                </a:ext>
              </a:extLst>
            </p:cNvPr>
            <p:cNvSpPr/>
            <p:nvPr/>
          </p:nvSpPr>
          <p:spPr>
            <a:xfrm>
              <a:off x="5972656" y="2185389"/>
              <a:ext cx="0" cy="15652"/>
            </a:xfrm>
            <a:custGeom>
              <a:avLst/>
              <a:gdLst/>
              <a:ahLst/>
              <a:cxnLst/>
              <a:rect l="0" t="0" r="0" b="0"/>
              <a:pathLst>
                <a:path h="46772">
                  <a:moveTo>
                    <a:pt x="0" y="0"/>
                  </a:moveTo>
                  <a:lnTo>
                    <a:pt x="0" y="46772"/>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75" name="pg51">
              <a:extLst>
                <a:ext uri="{FF2B5EF4-FFF2-40B4-BE49-F238E27FC236}">
                  <a16:creationId xmlns:a16="http://schemas.microsoft.com/office/drawing/2014/main" id="{C2E8796A-131A-4BCA-2357-4D2A44750A02}"/>
                </a:ext>
              </a:extLst>
            </p:cNvPr>
            <p:cNvSpPr/>
            <p:nvPr/>
          </p:nvSpPr>
          <p:spPr>
            <a:xfrm>
              <a:off x="5923814" y="2107127"/>
              <a:ext cx="97684" cy="78262"/>
            </a:xfrm>
            <a:custGeom>
              <a:avLst/>
              <a:gdLst/>
              <a:ahLst/>
              <a:cxnLst/>
              <a:rect l="0" t="0" r="0" b="0"/>
              <a:pathLst>
                <a:path w="291902" h="233864">
                  <a:moveTo>
                    <a:pt x="0" y="0"/>
                  </a:moveTo>
                  <a:lnTo>
                    <a:pt x="0" y="233864"/>
                  </a:lnTo>
                  <a:lnTo>
                    <a:pt x="291902" y="233864"/>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704" name="pl52">
              <a:extLst>
                <a:ext uri="{FF2B5EF4-FFF2-40B4-BE49-F238E27FC236}">
                  <a16:creationId xmlns:a16="http://schemas.microsoft.com/office/drawing/2014/main" id="{DE04366B-A282-60F3-24BE-DC1EE2A3C15B}"/>
                </a:ext>
              </a:extLst>
            </p:cNvPr>
            <p:cNvSpPr/>
            <p:nvPr/>
          </p:nvSpPr>
          <p:spPr>
            <a:xfrm>
              <a:off x="5923814" y="2154085"/>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708" name="pt53">
              <a:extLst>
                <a:ext uri="{FF2B5EF4-FFF2-40B4-BE49-F238E27FC236}">
                  <a16:creationId xmlns:a16="http://schemas.microsoft.com/office/drawing/2014/main" id="{30FE33EE-3EAE-069B-5312-6C9BCF0A1DC3}"/>
                </a:ext>
              </a:extLst>
            </p:cNvPr>
            <p:cNvSpPr/>
            <p:nvPr/>
          </p:nvSpPr>
          <p:spPr>
            <a:xfrm>
              <a:off x="6101106" y="1597945"/>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709" name="pt54">
              <a:extLst>
                <a:ext uri="{FF2B5EF4-FFF2-40B4-BE49-F238E27FC236}">
                  <a16:creationId xmlns:a16="http://schemas.microsoft.com/office/drawing/2014/main" id="{872D5B38-FA13-BCD4-30B3-93A86B03C8FB}"/>
                </a:ext>
              </a:extLst>
            </p:cNvPr>
            <p:cNvSpPr/>
            <p:nvPr/>
          </p:nvSpPr>
          <p:spPr>
            <a:xfrm>
              <a:off x="6101106" y="181081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710" name="pt55">
              <a:extLst>
                <a:ext uri="{FF2B5EF4-FFF2-40B4-BE49-F238E27FC236}">
                  <a16:creationId xmlns:a16="http://schemas.microsoft.com/office/drawing/2014/main" id="{3EDE0511-5019-7604-2CB2-639B6E561856}"/>
                </a:ext>
              </a:extLst>
            </p:cNvPr>
            <p:cNvSpPr/>
            <p:nvPr/>
          </p:nvSpPr>
          <p:spPr>
            <a:xfrm>
              <a:off x="6101106" y="1120549"/>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711" name="pt56">
              <a:extLst>
                <a:ext uri="{FF2B5EF4-FFF2-40B4-BE49-F238E27FC236}">
                  <a16:creationId xmlns:a16="http://schemas.microsoft.com/office/drawing/2014/main" id="{06E438D7-AB3C-6842-BF72-F5DEDD013EA2}"/>
                </a:ext>
              </a:extLst>
            </p:cNvPr>
            <p:cNvSpPr/>
            <p:nvPr/>
          </p:nvSpPr>
          <p:spPr>
            <a:xfrm>
              <a:off x="6101106" y="1151854"/>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712" name="pt57">
              <a:extLst>
                <a:ext uri="{FF2B5EF4-FFF2-40B4-BE49-F238E27FC236}">
                  <a16:creationId xmlns:a16="http://schemas.microsoft.com/office/drawing/2014/main" id="{3FBA3C0E-4098-4010-F88E-4EC1E319F8C0}"/>
                </a:ext>
              </a:extLst>
            </p:cNvPr>
            <p:cNvSpPr/>
            <p:nvPr/>
          </p:nvSpPr>
          <p:spPr>
            <a:xfrm>
              <a:off x="6101106" y="157446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713" name="pl58">
              <a:extLst>
                <a:ext uri="{FF2B5EF4-FFF2-40B4-BE49-F238E27FC236}">
                  <a16:creationId xmlns:a16="http://schemas.microsoft.com/office/drawing/2014/main" id="{31B360DE-4B77-E9E4-0BD0-1BE8ED4F8A5A}"/>
                </a:ext>
              </a:extLst>
            </p:cNvPr>
            <p:cNvSpPr/>
            <p:nvPr/>
          </p:nvSpPr>
          <p:spPr>
            <a:xfrm>
              <a:off x="6109414" y="1981909"/>
              <a:ext cx="0" cy="67109"/>
            </a:xfrm>
            <a:custGeom>
              <a:avLst/>
              <a:gdLst/>
              <a:ahLst/>
              <a:cxnLst/>
              <a:rect l="0" t="0" r="0" b="0"/>
              <a:pathLst>
                <a:path h="200538">
                  <a:moveTo>
                    <a:pt x="0" y="200538"/>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14" name="pl59">
              <a:extLst>
                <a:ext uri="{FF2B5EF4-FFF2-40B4-BE49-F238E27FC236}">
                  <a16:creationId xmlns:a16="http://schemas.microsoft.com/office/drawing/2014/main" id="{8190D5E7-C7E3-A6E3-71F8-36A690482816}"/>
                </a:ext>
              </a:extLst>
            </p:cNvPr>
            <p:cNvSpPr/>
            <p:nvPr/>
          </p:nvSpPr>
          <p:spPr>
            <a:xfrm>
              <a:off x="6109414" y="2177563"/>
              <a:ext cx="0" cy="23478"/>
            </a:xfrm>
            <a:custGeom>
              <a:avLst/>
              <a:gdLst/>
              <a:ahLst/>
              <a:cxnLst/>
              <a:rect l="0" t="0" r="0" b="0"/>
              <a:pathLst>
                <a:path h="70159">
                  <a:moveTo>
                    <a:pt x="0" y="0"/>
                  </a:moveTo>
                  <a:lnTo>
                    <a:pt x="0" y="70159"/>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15" name="pg60">
              <a:extLst>
                <a:ext uri="{FF2B5EF4-FFF2-40B4-BE49-F238E27FC236}">
                  <a16:creationId xmlns:a16="http://schemas.microsoft.com/office/drawing/2014/main" id="{582B568D-601C-36C5-F928-321D57690A2A}"/>
                </a:ext>
              </a:extLst>
            </p:cNvPr>
            <p:cNvSpPr/>
            <p:nvPr/>
          </p:nvSpPr>
          <p:spPr>
            <a:xfrm>
              <a:off x="6060572" y="2049018"/>
              <a:ext cx="97684" cy="128544"/>
            </a:xfrm>
            <a:custGeom>
              <a:avLst/>
              <a:gdLst/>
              <a:ahLst/>
              <a:cxnLst/>
              <a:rect l="0" t="0" r="0" b="0"/>
              <a:pathLst>
                <a:path w="291902" h="384121">
                  <a:moveTo>
                    <a:pt x="0" y="0"/>
                  </a:moveTo>
                  <a:lnTo>
                    <a:pt x="0" y="384121"/>
                  </a:lnTo>
                  <a:lnTo>
                    <a:pt x="291902" y="384121"/>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716" name="pl61">
              <a:extLst>
                <a:ext uri="{FF2B5EF4-FFF2-40B4-BE49-F238E27FC236}">
                  <a16:creationId xmlns:a16="http://schemas.microsoft.com/office/drawing/2014/main" id="{BFA64D62-9F69-4ADC-3C3E-3BE94298A6F6}"/>
                </a:ext>
              </a:extLst>
            </p:cNvPr>
            <p:cNvSpPr/>
            <p:nvPr/>
          </p:nvSpPr>
          <p:spPr>
            <a:xfrm>
              <a:off x="6060572" y="2149389"/>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717" name="pt62">
              <a:extLst>
                <a:ext uri="{FF2B5EF4-FFF2-40B4-BE49-F238E27FC236}">
                  <a16:creationId xmlns:a16="http://schemas.microsoft.com/office/drawing/2014/main" id="{9005A84E-E785-A357-2708-69C1D9BBD315}"/>
                </a:ext>
              </a:extLst>
            </p:cNvPr>
            <p:cNvSpPr/>
            <p:nvPr/>
          </p:nvSpPr>
          <p:spPr>
            <a:xfrm>
              <a:off x="4820104" y="187949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18" name="pt63">
              <a:extLst>
                <a:ext uri="{FF2B5EF4-FFF2-40B4-BE49-F238E27FC236}">
                  <a16:creationId xmlns:a16="http://schemas.microsoft.com/office/drawing/2014/main" id="{0BD20E67-27CE-CD2C-C3FA-978D29AB5631}"/>
                </a:ext>
              </a:extLst>
            </p:cNvPr>
            <p:cNvSpPr/>
            <p:nvPr/>
          </p:nvSpPr>
          <p:spPr>
            <a:xfrm>
              <a:off x="4935976" y="162232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19" name="pt64">
              <a:extLst>
                <a:ext uri="{FF2B5EF4-FFF2-40B4-BE49-F238E27FC236}">
                  <a16:creationId xmlns:a16="http://schemas.microsoft.com/office/drawing/2014/main" id="{853CE496-30C8-BE4E-B47E-78273D65CEE1}"/>
                </a:ext>
              </a:extLst>
            </p:cNvPr>
            <p:cNvSpPr/>
            <p:nvPr/>
          </p:nvSpPr>
          <p:spPr>
            <a:xfrm>
              <a:off x="4801061" y="19652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0" name="pt65">
              <a:extLst>
                <a:ext uri="{FF2B5EF4-FFF2-40B4-BE49-F238E27FC236}">
                  <a16:creationId xmlns:a16="http://schemas.microsoft.com/office/drawing/2014/main" id="{790911FF-936D-FCB0-682B-C94C3594FC92}"/>
                </a:ext>
              </a:extLst>
            </p:cNvPr>
            <p:cNvSpPr/>
            <p:nvPr/>
          </p:nvSpPr>
          <p:spPr>
            <a:xfrm>
              <a:off x="4766023" y="19652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1" name="pt66">
              <a:extLst>
                <a:ext uri="{FF2B5EF4-FFF2-40B4-BE49-F238E27FC236}">
                  <a16:creationId xmlns:a16="http://schemas.microsoft.com/office/drawing/2014/main" id="{D30D88E7-46B7-E701-1603-744B0978D964}"/>
                </a:ext>
              </a:extLst>
            </p:cNvPr>
            <p:cNvSpPr/>
            <p:nvPr/>
          </p:nvSpPr>
          <p:spPr>
            <a:xfrm>
              <a:off x="4807497" y="230811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2" name="pt67">
              <a:extLst>
                <a:ext uri="{FF2B5EF4-FFF2-40B4-BE49-F238E27FC236}">
                  <a16:creationId xmlns:a16="http://schemas.microsoft.com/office/drawing/2014/main" id="{BA9B9EBF-BD86-7EB3-3B43-DB6F4E8C9159}"/>
                </a:ext>
              </a:extLst>
            </p:cNvPr>
            <p:cNvSpPr/>
            <p:nvPr/>
          </p:nvSpPr>
          <p:spPr>
            <a:xfrm>
              <a:off x="4785450" y="22223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3" name="pt68">
              <a:extLst>
                <a:ext uri="{FF2B5EF4-FFF2-40B4-BE49-F238E27FC236}">
                  <a16:creationId xmlns:a16="http://schemas.microsoft.com/office/drawing/2014/main" id="{62A0C00D-E9AB-C613-5C5D-5371F0D4DE14}"/>
                </a:ext>
              </a:extLst>
            </p:cNvPr>
            <p:cNvSpPr/>
            <p:nvPr/>
          </p:nvSpPr>
          <p:spPr>
            <a:xfrm>
              <a:off x="4815944"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4" name="pt69">
              <a:extLst>
                <a:ext uri="{FF2B5EF4-FFF2-40B4-BE49-F238E27FC236}">
                  <a16:creationId xmlns:a16="http://schemas.microsoft.com/office/drawing/2014/main" id="{06987AC3-2223-6A54-0460-05EC62449F73}"/>
                </a:ext>
              </a:extLst>
            </p:cNvPr>
            <p:cNvSpPr/>
            <p:nvPr/>
          </p:nvSpPr>
          <p:spPr>
            <a:xfrm>
              <a:off x="4780713" y="179376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5" name="pt70">
              <a:extLst>
                <a:ext uri="{FF2B5EF4-FFF2-40B4-BE49-F238E27FC236}">
                  <a16:creationId xmlns:a16="http://schemas.microsoft.com/office/drawing/2014/main" id="{2357E0A6-4654-0856-796E-A9A8AE4C801A}"/>
                </a:ext>
              </a:extLst>
            </p:cNvPr>
            <p:cNvSpPr/>
            <p:nvPr/>
          </p:nvSpPr>
          <p:spPr>
            <a:xfrm>
              <a:off x="4786849" y="22223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6" name="pt71">
              <a:extLst>
                <a:ext uri="{FF2B5EF4-FFF2-40B4-BE49-F238E27FC236}">
                  <a16:creationId xmlns:a16="http://schemas.microsoft.com/office/drawing/2014/main" id="{D5CDFBC7-0ECF-9191-AEB9-930C10CAB99C}"/>
                </a:ext>
              </a:extLst>
            </p:cNvPr>
            <p:cNvSpPr/>
            <p:nvPr/>
          </p:nvSpPr>
          <p:spPr>
            <a:xfrm>
              <a:off x="4773906"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7" name="pt72">
              <a:extLst>
                <a:ext uri="{FF2B5EF4-FFF2-40B4-BE49-F238E27FC236}">
                  <a16:creationId xmlns:a16="http://schemas.microsoft.com/office/drawing/2014/main" id="{21A2EE16-2D07-1313-8F05-1F07E188651B}"/>
                </a:ext>
              </a:extLst>
            </p:cNvPr>
            <p:cNvSpPr/>
            <p:nvPr/>
          </p:nvSpPr>
          <p:spPr>
            <a:xfrm>
              <a:off x="4937130" y="213666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8" name="pt73">
              <a:extLst>
                <a:ext uri="{FF2B5EF4-FFF2-40B4-BE49-F238E27FC236}">
                  <a16:creationId xmlns:a16="http://schemas.microsoft.com/office/drawing/2014/main" id="{0BB6D753-7DDF-224E-4D3C-E9C6DE52A51C}"/>
                </a:ext>
              </a:extLst>
            </p:cNvPr>
            <p:cNvSpPr/>
            <p:nvPr/>
          </p:nvSpPr>
          <p:spPr>
            <a:xfrm>
              <a:off x="4930083" y="162232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29" name="pt74">
              <a:extLst>
                <a:ext uri="{FF2B5EF4-FFF2-40B4-BE49-F238E27FC236}">
                  <a16:creationId xmlns:a16="http://schemas.microsoft.com/office/drawing/2014/main" id="{B5E886AA-5583-194A-B467-4FAE229982A2}"/>
                </a:ext>
              </a:extLst>
            </p:cNvPr>
            <p:cNvSpPr/>
            <p:nvPr/>
          </p:nvSpPr>
          <p:spPr>
            <a:xfrm>
              <a:off x="4938430" y="187949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0" name="pt75">
              <a:extLst>
                <a:ext uri="{FF2B5EF4-FFF2-40B4-BE49-F238E27FC236}">
                  <a16:creationId xmlns:a16="http://schemas.microsoft.com/office/drawing/2014/main" id="{552BF03E-918A-1D0F-49D4-6B3D2D060073}"/>
                </a:ext>
              </a:extLst>
            </p:cNvPr>
            <p:cNvSpPr/>
            <p:nvPr/>
          </p:nvSpPr>
          <p:spPr>
            <a:xfrm>
              <a:off x="4805371" y="179376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1" name="pt76">
              <a:extLst>
                <a:ext uri="{FF2B5EF4-FFF2-40B4-BE49-F238E27FC236}">
                  <a16:creationId xmlns:a16="http://schemas.microsoft.com/office/drawing/2014/main" id="{0F473CDA-9964-9BF3-D4B3-90A84C7EC0C3}"/>
                </a:ext>
              </a:extLst>
            </p:cNvPr>
            <p:cNvSpPr/>
            <p:nvPr/>
          </p:nvSpPr>
          <p:spPr>
            <a:xfrm>
              <a:off x="4810546" y="22223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2" name="pt77">
              <a:extLst>
                <a:ext uri="{FF2B5EF4-FFF2-40B4-BE49-F238E27FC236}">
                  <a16:creationId xmlns:a16="http://schemas.microsoft.com/office/drawing/2014/main" id="{B2609C05-7E4C-E13D-C6B9-67210059017D}"/>
                </a:ext>
              </a:extLst>
            </p:cNvPr>
            <p:cNvSpPr/>
            <p:nvPr/>
          </p:nvSpPr>
          <p:spPr>
            <a:xfrm>
              <a:off x="4776139" y="230811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3" name="pt78">
              <a:extLst>
                <a:ext uri="{FF2B5EF4-FFF2-40B4-BE49-F238E27FC236}">
                  <a16:creationId xmlns:a16="http://schemas.microsoft.com/office/drawing/2014/main" id="{C1284CFE-FC05-FDA6-A93F-95C242EA883A}"/>
                </a:ext>
              </a:extLst>
            </p:cNvPr>
            <p:cNvSpPr/>
            <p:nvPr/>
          </p:nvSpPr>
          <p:spPr>
            <a:xfrm>
              <a:off x="4776321" y="247955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4" name="pt79">
              <a:extLst>
                <a:ext uri="{FF2B5EF4-FFF2-40B4-BE49-F238E27FC236}">
                  <a16:creationId xmlns:a16="http://schemas.microsoft.com/office/drawing/2014/main" id="{17C61F47-47CA-9398-AA6D-D14CA88A1DE9}"/>
                </a:ext>
              </a:extLst>
            </p:cNvPr>
            <p:cNvSpPr/>
            <p:nvPr/>
          </p:nvSpPr>
          <p:spPr>
            <a:xfrm>
              <a:off x="4785123" y="19652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5" name="pt80">
              <a:extLst>
                <a:ext uri="{FF2B5EF4-FFF2-40B4-BE49-F238E27FC236}">
                  <a16:creationId xmlns:a16="http://schemas.microsoft.com/office/drawing/2014/main" id="{33090DF7-F5BE-E9DF-D58D-ECB1C68D76C1}"/>
                </a:ext>
              </a:extLst>
            </p:cNvPr>
            <p:cNvSpPr/>
            <p:nvPr/>
          </p:nvSpPr>
          <p:spPr>
            <a:xfrm>
              <a:off x="4771991" y="21366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6" name="pt81">
              <a:extLst>
                <a:ext uri="{FF2B5EF4-FFF2-40B4-BE49-F238E27FC236}">
                  <a16:creationId xmlns:a16="http://schemas.microsoft.com/office/drawing/2014/main" id="{725484EE-1A27-74C6-ED8D-F787FB2803D5}"/>
                </a:ext>
              </a:extLst>
            </p:cNvPr>
            <p:cNvSpPr/>
            <p:nvPr/>
          </p:nvSpPr>
          <p:spPr>
            <a:xfrm>
              <a:off x="4944629" y="179376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7" name="pt82">
              <a:extLst>
                <a:ext uri="{FF2B5EF4-FFF2-40B4-BE49-F238E27FC236}">
                  <a16:creationId xmlns:a16="http://schemas.microsoft.com/office/drawing/2014/main" id="{9278CD43-B90B-236D-254A-A8952F14D8F1}"/>
                </a:ext>
              </a:extLst>
            </p:cNvPr>
            <p:cNvSpPr/>
            <p:nvPr/>
          </p:nvSpPr>
          <p:spPr>
            <a:xfrm>
              <a:off x="4933375" y="179376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8" name="pt83">
              <a:extLst>
                <a:ext uri="{FF2B5EF4-FFF2-40B4-BE49-F238E27FC236}">
                  <a16:creationId xmlns:a16="http://schemas.microsoft.com/office/drawing/2014/main" id="{E5223171-F21A-C59F-6435-B930314C8A27}"/>
                </a:ext>
              </a:extLst>
            </p:cNvPr>
            <p:cNvSpPr/>
            <p:nvPr/>
          </p:nvSpPr>
          <p:spPr>
            <a:xfrm>
              <a:off x="4792622"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39" name="pt84">
              <a:extLst>
                <a:ext uri="{FF2B5EF4-FFF2-40B4-BE49-F238E27FC236}">
                  <a16:creationId xmlns:a16="http://schemas.microsoft.com/office/drawing/2014/main" id="{EF159701-FD1E-28BB-1DBC-CDFEFD8FA111}"/>
                </a:ext>
              </a:extLst>
            </p:cNvPr>
            <p:cNvSpPr/>
            <p:nvPr/>
          </p:nvSpPr>
          <p:spPr>
            <a:xfrm>
              <a:off x="4784360" y="2179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0" name="pt85">
              <a:extLst>
                <a:ext uri="{FF2B5EF4-FFF2-40B4-BE49-F238E27FC236}">
                  <a16:creationId xmlns:a16="http://schemas.microsoft.com/office/drawing/2014/main" id="{0C65DCA9-BF0D-0B57-266F-7E3CB4598B28}"/>
                </a:ext>
              </a:extLst>
            </p:cNvPr>
            <p:cNvSpPr/>
            <p:nvPr/>
          </p:nvSpPr>
          <p:spPr>
            <a:xfrm>
              <a:off x="4921589" y="230811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1" name="pt86">
              <a:extLst>
                <a:ext uri="{FF2B5EF4-FFF2-40B4-BE49-F238E27FC236}">
                  <a16:creationId xmlns:a16="http://schemas.microsoft.com/office/drawing/2014/main" id="{6FA3F8EA-323A-E23C-1085-37957BF4B2D4}"/>
                </a:ext>
              </a:extLst>
            </p:cNvPr>
            <p:cNvSpPr/>
            <p:nvPr/>
          </p:nvSpPr>
          <p:spPr>
            <a:xfrm>
              <a:off x="4778922"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2" name="pt87">
              <a:extLst>
                <a:ext uri="{FF2B5EF4-FFF2-40B4-BE49-F238E27FC236}">
                  <a16:creationId xmlns:a16="http://schemas.microsoft.com/office/drawing/2014/main" id="{3B447F92-A184-A0C0-895F-90F026032329}"/>
                </a:ext>
              </a:extLst>
            </p:cNvPr>
            <p:cNvSpPr/>
            <p:nvPr/>
          </p:nvSpPr>
          <p:spPr>
            <a:xfrm>
              <a:off x="4915339" y="186234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3" name="pt88">
              <a:extLst>
                <a:ext uri="{FF2B5EF4-FFF2-40B4-BE49-F238E27FC236}">
                  <a16:creationId xmlns:a16="http://schemas.microsoft.com/office/drawing/2014/main" id="{F839DB9D-A380-969B-58E7-5B4277AC72D2}"/>
                </a:ext>
              </a:extLst>
            </p:cNvPr>
            <p:cNvSpPr/>
            <p:nvPr/>
          </p:nvSpPr>
          <p:spPr>
            <a:xfrm>
              <a:off x="4939467" y="213666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4" name="pt89">
              <a:extLst>
                <a:ext uri="{FF2B5EF4-FFF2-40B4-BE49-F238E27FC236}">
                  <a16:creationId xmlns:a16="http://schemas.microsoft.com/office/drawing/2014/main" id="{7C2D31FE-BD4B-0A75-AD1F-EF910616DDA4}"/>
                </a:ext>
              </a:extLst>
            </p:cNvPr>
            <p:cNvSpPr/>
            <p:nvPr/>
          </p:nvSpPr>
          <p:spPr>
            <a:xfrm>
              <a:off x="4818494" y="21366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5" name="pt90">
              <a:extLst>
                <a:ext uri="{FF2B5EF4-FFF2-40B4-BE49-F238E27FC236}">
                  <a16:creationId xmlns:a16="http://schemas.microsoft.com/office/drawing/2014/main" id="{653A6B7B-3E09-FA96-0B08-441AA4D63E42}"/>
                </a:ext>
              </a:extLst>
            </p:cNvPr>
            <p:cNvSpPr/>
            <p:nvPr/>
          </p:nvSpPr>
          <p:spPr>
            <a:xfrm>
              <a:off x="4768329" y="230811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6" name="pt91">
              <a:extLst>
                <a:ext uri="{FF2B5EF4-FFF2-40B4-BE49-F238E27FC236}">
                  <a16:creationId xmlns:a16="http://schemas.microsoft.com/office/drawing/2014/main" id="{A93087A5-BE60-E0C7-C7FD-3EEB9FD6708E}"/>
                </a:ext>
              </a:extLst>
            </p:cNvPr>
            <p:cNvSpPr/>
            <p:nvPr/>
          </p:nvSpPr>
          <p:spPr>
            <a:xfrm>
              <a:off x="4781931" y="170804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7" name="pt92">
              <a:extLst>
                <a:ext uri="{FF2B5EF4-FFF2-40B4-BE49-F238E27FC236}">
                  <a16:creationId xmlns:a16="http://schemas.microsoft.com/office/drawing/2014/main" id="{9C3DD709-84A5-ECFF-4DB3-20E4D18EF5B2}"/>
                </a:ext>
              </a:extLst>
            </p:cNvPr>
            <p:cNvSpPr/>
            <p:nvPr/>
          </p:nvSpPr>
          <p:spPr>
            <a:xfrm>
              <a:off x="4776770" y="19652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8" name="pt93">
              <a:extLst>
                <a:ext uri="{FF2B5EF4-FFF2-40B4-BE49-F238E27FC236}">
                  <a16:creationId xmlns:a16="http://schemas.microsoft.com/office/drawing/2014/main" id="{E56B28FB-2BF9-49F9-E0ED-22E1D0938960}"/>
                </a:ext>
              </a:extLst>
            </p:cNvPr>
            <p:cNvSpPr/>
            <p:nvPr/>
          </p:nvSpPr>
          <p:spPr>
            <a:xfrm>
              <a:off x="4801643" y="21366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49" name="pt94">
              <a:extLst>
                <a:ext uri="{FF2B5EF4-FFF2-40B4-BE49-F238E27FC236}">
                  <a16:creationId xmlns:a16="http://schemas.microsoft.com/office/drawing/2014/main" id="{C8B8AD15-1C7B-88F4-6DC2-9722DCCC3382}"/>
                </a:ext>
              </a:extLst>
            </p:cNvPr>
            <p:cNvSpPr/>
            <p:nvPr/>
          </p:nvSpPr>
          <p:spPr>
            <a:xfrm>
              <a:off x="4792448"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0" name="pt95">
              <a:extLst>
                <a:ext uri="{FF2B5EF4-FFF2-40B4-BE49-F238E27FC236}">
                  <a16:creationId xmlns:a16="http://schemas.microsoft.com/office/drawing/2014/main" id="{FD985D31-93DB-2CB9-8481-A144D1BB04B5}"/>
                </a:ext>
              </a:extLst>
            </p:cNvPr>
            <p:cNvSpPr/>
            <p:nvPr/>
          </p:nvSpPr>
          <p:spPr>
            <a:xfrm>
              <a:off x="4798888"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1" name="pt96">
              <a:extLst>
                <a:ext uri="{FF2B5EF4-FFF2-40B4-BE49-F238E27FC236}">
                  <a16:creationId xmlns:a16="http://schemas.microsoft.com/office/drawing/2014/main" id="{DEE2ECEA-F026-9BAC-0AB0-99B86E848938}"/>
                </a:ext>
              </a:extLst>
            </p:cNvPr>
            <p:cNvSpPr/>
            <p:nvPr/>
          </p:nvSpPr>
          <p:spPr>
            <a:xfrm>
              <a:off x="4914656" y="170804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2" name="pt97">
              <a:extLst>
                <a:ext uri="{FF2B5EF4-FFF2-40B4-BE49-F238E27FC236}">
                  <a16:creationId xmlns:a16="http://schemas.microsoft.com/office/drawing/2014/main" id="{5E31726C-9949-E7C0-B57A-2BA4DA54FED6}"/>
                </a:ext>
              </a:extLst>
            </p:cNvPr>
            <p:cNvSpPr/>
            <p:nvPr/>
          </p:nvSpPr>
          <p:spPr>
            <a:xfrm>
              <a:off x="4945090"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3" name="pt98">
              <a:extLst>
                <a:ext uri="{FF2B5EF4-FFF2-40B4-BE49-F238E27FC236}">
                  <a16:creationId xmlns:a16="http://schemas.microsoft.com/office/drawing/2014/main" id="{5CEE706A-340C-8A4F-FE95-CB5CF99160E3}"/>
                </a:ext>
              </a:extLst>
            </p:cNvPr>
            <p:cNvSpPr/>
            <p:nvPr/>
          </p:nvSpPr>
          <p:spPr>
            <a:xfrm>
              <a:off x="4805066" y="230811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4" name="pt99">
              <a:extLst>
                <a:ext uri="{FF2B5EF4-FFF2-40B4-BE49-F238E27FC236}">
                  <a16:creationId xmlns:a16="http://schemas.microsoft.com/office/drawing/2014/main" id="{8E2B6BEE-2649-6D04-1AE9-6647DDC2327B}"/>
                </a:ext>
              </a:extLst>
            </p:cNvPr>
            <p:cNvSpPr/>
            <p:nvPr/>
          </p:nvSpPr>
          <p:spPr>
            <a:xfrm>
              <a:off x="4905347" y="19652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5" name="pt100">
              <a:extLst>
                <a:ext uri="{FF2B5EF4-FFF2-40B4-BE49-F238E27FC236}">
                  <a16:creationId xmlns:a16="http://schemas.microsoft.com/office/drawing/2014/main" id="{A5689E9F-3CEC-7A12-7B90-554792D9E6D9}"/>
                </a:ext>
              </a:extLst>
            </p:cNvPr>
            <p:cNvSpPr/>
            <p:nvPr/>
          </p:nvSpPr>
          <p:spPr>
            <a:xfrm>
              <a:off x="4917551" y="179376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6" name="pt101">
              <a:extLst>
                <a:ext uri="{FF2B5EF4-FFF2-40B4-BE49-F238E27FC236}">
                  <a16:creationId xmlns:a16="http://schemas.microsoft.com/office/drawing/2014/main" id="{57176B46-D594-0FA8-28EA-CDE4AF2610EE}"/>
                </a:ext>
              </a:extLst>
            </p:cNvPr>
            <p:cNvSpPr/>
            <p:nvPr/>
          </p:nvSpPr>
          <p:spPr>
            <a:xfrm>
              <a:off x="4926832" y="19652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7" name="pt102">
              <a:extLst>
                <a:ext uri="{FF2B5EF4-FFF2-40B4-BE49-F238E27FC236}">
                  <a16:creationId xmlns:a16="http://schemas.microsoft.com/office/drawing/2014/main" id="{757CB678-011A-F58C-DCD2-A963AD53EAB9}"/>
                </a:ext>
              </a:extLst>
            </p:cNvPr>
            <p:cNvSpPr/>
            <p:nvPr/>
          </p:nvSpPr>
          <p:spPr>
            <a:xfrm>
              <a:off x="4783821" y="239383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8" name="pt103">
              <a:extLst>
                <a:ext uri="{FF2B5EF4-FFF2-40B4-BE49-F238E27FC236}">
                  <a16:creationId xmlns:a16="http://schemas.microsoft.com/office/drawing/2014/main" id="{8749DEB9-B37F-796B-02F4-181BA300877C}"/>
                </a:ext>
              </a:extLst>
            </p:cNvPr>
            <p:cNvSpPr/>
            <p:nvPr/>
          </p:nvSpPr>
          <p:spPr>
            <a:xfrm>
              <a:off x="4910171" y="213666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59" name="pt104">
              <a:extLst>
                <a:ext uri="{FF2B5EF4-FFF2-40B4-BE49-F238E27FC236}">
                  <a16:creationId xmlns:a16="http://schemas.microsoft.com/office/drawing/2014/main" id="{97BAE098-108B-3FF3-FCE5-6535FF39A0AF}"/>
                </a:ext>
              </a:extLst>
            </p:cNvPr>
            <p:cNvSpPr/>
            <p:nvPr/>
          </p:nvSpPr>
          <p:spPr>
            <a:xfrm>
              <a:off x="4765431" y="246241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0" name="pt105">
              <a:extLst>
                <a:ext uri="{FF2B5EF4-FFF2-40B4-BE49-F238E27FC236}">
                  <a16:creationId xmlns:a16="http://schemas.microsoft.com/office/drawing/2014/main" id="{C84E647B-4C21-D4CF-4660-BEA2CB4851D2}"/>
                </a:ext>
              </a:extLst>
            </p:cNvPr>
            <p:cNvSpPr/>
            <p:nvPr/>
          </p:nvSpPr>
          <p:spPr>
            <a:xfrm>
              <a:off x="4921111"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1" name="pt106">
              <a:extLst>
                <a:ext uri="{FF2B5EF4-FFF2-40B4-BE49-F238E27FC236}">
                  <a16:creationId xmlns:a16="http://schemas.microsoft.com/office/drawing/2014/main" id="{8FF33266-7AE4-4D03-3FAE-133010BFBBE7}"/>
                </a:ext>
              </a:extLst>
            </p:cNvPr>
            <p:cNvSpPr/>
            <p:nvPr/>
          </p:nvSpPr>
          <p:spPr>
            <a:xfrm>
              <a:off x="4945870"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2" name="pt107">
              <a:extLst>
                <a:ext uri="{FF2B5EF4-FFF2-40B4-BE49-F238E27FC236}">
                  <a16:creationId xmlns:a16="http://schemas.microsoft.com/office/drawing/2014/main" id="{AFB7A29D-AEC1-A9E9-20A8-8DC8D4815C2E}"/>
                </a:ext>
              </a:extLst>
            </p:cNvPr>
            <p:cNvSpPr/>
            <p:nvPr/>
          </p:nvSpPr>
          <p:spPr>
            <a:xfrm>
              <a:off x="4940852" y="162232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3" name="pt108">
              <a:extLst>
                <a:ext uri="{FF2B5EF4-FFF2-40B4-BE49-F238E27FC236}">
                  <a16:creationId xmlns:a16="http://schemas.microsoft.com/office/drawing/2014/main" id="{841F0B6B-CEFD-AB1E-000A-72BE459BD857}"/>
                </a:ext>
              </a:extLst>
            </p:cNvPr>
            <p:cNvSpPr/>
            <p:nvPr/>
          </p:nvSpPr>
          <p:spPr>
            <a:xfrm>
              <a:off x="4922386"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4" name="pt109">
              <a:extLst>
                <a:ext uri="{FF2B5EF4-FFF2-40B4-BE49-F238E27FC236}">
                  <a16:creationId xmlns:a16="http://schemas.microsoft.com/office/drawing/2014/main" id="{73604DD0-7C28-1BC0-9902-36C4D0458860}"/>
                </a:ext>
              </a:extLst>
            </p:cNvPr>
            <p:cNvSpPr/>
            <p:nvPr/>
          </p:nvSpPr>
          <p:spPr>
            <a:xfrm>
              <a:off x="4922701"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5" name="pt110">
              <a:extLst>
                <a:ext uri="{FF2B5EF4-FFF2-40B4-BE49-F238E27FC236}">
                  <a16:creationId xmlns:a16="http://schemas.microsoft.com/office/drawing/2014/main" id="{19B2B596-56A1-8A55-3CF5-F8ABFF897312}"/>
                </a:ext>
              </a:extLst>
            </p:cNvPr>
            <p:cNvSpPr/>
            <p:nvPr/>
          </p:nvSpPr>
          <p:spPr>
            <a:xfrm>
              <a:off x="4922578"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6" name="pt111">
              <a:extLst>
                <a:ext uri="{FF2B5EF4-FFF2-40B4-BE49-F238E27FC236}">
                  <a16:creationId xmlns:a16="http://schemas.microsoft.com/office/drawing/2014/main" id="{27B010E5-42BF-6242-E13E-B2B798C4EECB}"/>
                </a:ext>
              </a:extLst>
            </p:cNvPr>
            <p:cNvSpPr/>
            <p:nvPr/>
          </p:nvSpPr>
          <p:spPr>
            <a:xfrm>
              <a:off x="4819306" y="21366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7" name="pt112">
              <a:extLst>
                <a:ext uri="{FF2B5EF4-FFF2-40B4-BE49-F238E27FC236}">
                  <a16:creationId xmlns:a16="http://schemas.microsoft.com/office/drawing/2014/main" id="{97AB73C8-FDDD-4A7D-EDAC-8EF8380A0D90}"/>
                </a:ext>
              </a:extLst>
            </p:cNvPr>
            <p:cNvSpPr/>
            <p:nvPr/>
          </p:nvSpPr>
          <p:spPr>
            <a:xfrm>
              <a:off x="4772090" y="230811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8" name="pt113">
              <a:extLst>
                <a:ext uri="{FF2B5EF4-FFF2-40B4-BE49-F238E27FC236}">
                  <a16:creationId xmlns:a16="http://schemas.microsoft.com/office/drawing/2014/main" id="{774A8BD3-BAF3-C775-755F-98B99EBB5501}"/>
                </a:ext>
              </a:extLst>
            </p:cNvPr>
            <p:cNvSpPr/>
            <p:nvPr/>
          </p:nvSpPr>
          <p:spPr>
            <a:xfrm>
              <a:off x="4789195" y="21366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69" name="pt114">
              <a:extLst>
                <a:ext uri="{FF2B5EF4-FFF2-40B4-BE49-F238E27FC236}">
                  <a16:creationId xmlns:a16="http://schemas.microsoft.com/office/drawing/2014/main" id="{3AD831FC-CCB5-830E-2235-62C115B1ADE1}"/>
                </a:ext>
              </a:extLst>
            </p:cNvPr>
            <p:cNvSpPr/>
            <p:nvPr/>
          </p:nvSpPr>
          <p:spPr>
            <a:xfrm>
              <a:off x="4913838" y="239383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0" name="pt115">
              <a:extLst>
                <a:ext uri="{FF2B5EF4-FFF2-40B4-BE49-F238E27FC236}">
                  <a16:creationId xmlns:a16="http://schemas.microsoft.com/office/drawing/2014/main" id="{4FB6C05F-D7AC-CEDF-0AE2-3AB30C199CB1}"/>
                </a:ext>
              </a:extLst>
            </p:cNvPr>
            <p:cNvSpPr/>
            <p:nvPr/>
          </p:nvSpPr>
          <p:spPr>
            <a:xfrm>
              <a:off x="4767250" y="246241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1" name="pt116">
              <a:extLst>
                <a:ext uri="{FF2B5EF4-FFF2-40B4-BE49-F238E27FC236}">
                  <a16:creationId xmlns:a16="http://schemas.microsoft.com/office/drawing/2014/main" id="{41AB789D-E627-473D-510E-ECC825AFD880}"/>
                </a:ext>
              </a:extLst>
            </p:cNvPr>
            <p:cNvSpPr/>
            <p:nvPr/>
          </p:nvSpPr>
          <p:spPr>
            <a:xfrm>
              <a:off x="4802367" y="19652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2" name="pt117">
              <a:extLst>
                <a:ext uri="{FF2B5EF4-FFF2-40B4-BE49-F238E27FC236}">
                  <a16:creationId xmlns:a16="http://schemas.microsoft.com/office/drawing/2014/main" id="{E05D4D34-C487-B022-0DCC-17CF4AF4ACAA}"/>
                </a:ext>
              </a:extLst>
            </p:cNvPr>
            <p:cNvSpPr/>
            <p:nvPr/>
          </p:nvSpPr>
          <p:spPr>
            <a:xfrm>
              <a:off x="4790928" y="187949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3" name="pt118">
              <a:extLst>
                <a:ext uri="{FF2B5EF4-FFF2-40B4-BE49-F238E27FC236}">
                  <a16:creationId xmlns:a16="http://schemas.microsoft.com/office/drawing/2014/main" id="{B6D58EB1-34F6-C012-0D42-31BEC0BA1BBF}"/>
                </a:ext>
              </a:extLst>
            </p:cNvPr>
            <p:cNvSpPr/>
            <p:nvPr/>
          </p:nvSpPr>
          <p:spPr>
            <a:xfrm>
              <a:off x="4907129"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4" name="pt119">
              <a:extLst>
                <a:ext uri="{FF2B5EF4-FFF2-40B4-BE49-F238E27FC236}">
                  <a16:creationId xmlns:a16="http://schemas.microsoft.com/office/drawing/2014/main" id="{EE7AB247-27C2-CB35-ECFC-2737865287A0}"/>
                </a:ext>
              </a:extLst>
            </p:cNvPr>
            <p:cNvSpPr/>
            <p:nvPr/>
          </p:nvSpPr>
          <p:spPr>
            <a:xfrm>
              <a:off x="4785061"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5" name="pt120">
              <a:extLst>
                <a:ext uri="{FF2B5EF4-FFF2-40B4-BE49-F238E27FC236}">
                  <a16:creationId xmlns:a16="http://schemas.microsoft.com/office/drawing/2014/main" id="{490B06CE-2ADA-2E46-2705-8B47A71D9EC7}"/>
                </a:ext>
              </a:extLst>
            </p:cNvPr>
            <p:cNvSpPr/>
            <p:nvPr/>
          </p:nvSpPr>
          <p:spPr>
            <a:xfrm>
              <a:off x="4934780"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6" name="pt121">
              <a:extLst>
                <a:ext uri="{FF2B5EF4-FFF2-40B4-BE49-F238E27FC236}">
                  <a16:creationId xmlns:a16="http://schemas.microsoft.com/office/drawing/2014/main" id="{FE8EAE42-86FE-4E6F-8B25-F254FD03A57B}"/>
                </a:ext>
              </a:extLst>
            </p:cNvPr>
            <p:cNvSpPr/>
            <p:nvPr/>
          </p:nvSpPr>
          <p:spPr>
            <a:xfrm>
              <a:off x="4811847" y="21366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7" name="pt122">
              <a:extLst>
                <a:ext uri="{FF2B5EF4-FFF2-40B4-BE49-F238E27FC236}">
                  <a16:creationId xmlns:a16="http://schemas.microsoft.com/office/drawing/2014/main" id="{1F328C2B-DE7D-8C13-A72D-BCECA74114F6}"/>
                </a:ext>
              </a:extLst>
            </p:cNvPr>
            <p:cNvSpPr/>
            <p:nvPr/>
          </p:nvSpPr>
          <p:spPr>
            <a:xfrm>
              <a:off x="4776132" y="22223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8" name="pt123">
              <a:extLst>
                <a:ext uri="{FF2B5EF4-FFF2-40B4-BE49-F238E27FC236}">
                  <a16:creationId xmlns:a16="http://schemas.microsoft.com/office/drawing/2014/main" id="{3BFDCBA3-1223-AA21-3783-6D6767195DFE}"/>
                </a:ext>
              </a:extLst>
            </p:cNvPr>
            <p:cNvSpPr/>
            <p:nvPr/>
          </p:nvSpPr>
          <p:spPr>
            <a:xfrm>
              <a:off x="4763802" y="2050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79" name="pt124">
              <a:extLst>
                <a:ext uri="{FF2B5EF4-FFF2-40B4-BE49-F238E27FC236}">
                  <a16:creationId xmlns:a16="http://schemas.microsoft.com/office/drawing/2014/main" id="{E34E4E6E-4ACB-8C2A-0C07-17D1ABF41A74}"/>
                </a:ext>
              </a:extLst>
            </p:cNvPr>
            <p:cNvSpPr/>
            <p:nvPr/>
          </p:nvSpPr>
          <p:spPr>
            <a:xfrm>
              <a:off x="4937414" y="239383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0" name="pt125">
              <a:extLst>
                <a:ext uri="{FF2B5EF4-FFF2-40B4-BE49-F238E27FC236}">
                  <a16:creationId xmlns:a16="http://schemas.microsoft.com/office/drawing/2014/main" id="{BDB1A695-962F-6C4A-3253-68621F17B0CA}"/>
                </a:ext>
              </a:extLst>
            </p:cNvPr>
            <p:cNvSpPr/>
            <p:nvPr/>
          </p:nvSpPr>
          <p:spPr>
            <a:xfrm>
              <a:off x="4902809" y="239383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1" name="pt126">
              <a:extLst>
                <a:ext uri="{FF2B5EF4-FFF2-40B4-BE49-F238E27FC236}">
                  <a16:creationId xmlns:a16="http://schemas.microsoft.com/office/drawing/2014/main" id="{136F5DE7-DA51-928E-B5A3-437FEB55F455}"/>
                </a:ext>
              </a:extLst>
            </p:cNvPr>
            <p:cNvSpPr/>
            <p:nvPr/>
          </p:nvSpPr>
          <p:spPr>
            <a:xfrm>
              <a:off x="4927658" y="20509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2" name="pt127">
              <a:extLst>
                <a:ext uri="{FF2B5EF4-FFF2-40B4-BE49-F238E27FC236}">
                  <a16:creationId xmlns:a16="http://schemas.microsoft.com/office/drawing/2014/main" id="{12583B9F-7B31-8B1C-88D3-83E95B2C8F6B}"/>
                </a:ext>
              </a:extLst>
            </p:cNvPr>
            <p:cNvSpPr/>
            <p:nvPr/>
          </p:nvSpPr>
          <p:spPr>
            <a:xfrm>
              <a:off x="4765117" y="22223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3" name="pt128">
              <a:extLst>
                <a:ext uri="{FF2B5EF4-FFF2-40B4-BE49-F238E27FC236}">
                  <a16:creationId xmlns:a16="http://schemas.microsoft.com/office/drawing/2014/main" id="{1DB1D7AD-F5BB-8EB9-8D9C-B751A587A4F2}"/>
                </a:ext>
              </a:extLst>
            </p:cNvPr>
            <p:cNvSpPr/>
            <p:nvPr/>
          </p:nvSpPr>
          <p:spPr>
            <a:xfrm>
              <a:off x="4767093" y="19652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4" name="pt129">
              <a:extLst>
                <a:ext uri="{FF2B5EF4-FFF2-40B4-BE49-F238E27FC236}">
                  <a16:creationId xmlns:a16="http://schemas.microsoft.com/office/drawing/2014/main" id="{B0B966B3-1DE5-9197-FE38-30E59E3AC6DE}"/>
                </a:ext>
              </a:extLst>
            </p:cNvPr>
            <p:cNvSpPr/>
            <p:nvPr/>
          </p:nvSpPr>
          <p:spPr>
            <a:xfrm>
              <a:off x="4804946" y="230811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5" name="pt130">
              <a:extLst>
                <a:ext uri="{FF2B5EF4-FFF2-40B4-BE49-F238E27FC236}">
                  <a16:creationId xmlns:a16="http://schemas.microsoft.com/office/drawing/2014/main" id="{5D7E14B3-B831-6B97-DD42-4AC57CDF5BD9}"/>
                </a:ext>
              </a:extLst>
            </p:cNvPr>
            <p:cNvSpPr/>
            <p:nvPr/>
          </p:nvSpPr>
          <p:spPr>
            <a:xfrm>
              <a:off x="4937473" y="19652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7" name="pt131">
              <a:extLst>
                <a:ext uri="{FF2B5EF4-FFF2-40B4-BE49-F238E27FC236}">
                  <a16:creationId xmlns:a16="http://schemas.microsoft.com/office/drawing/2014/main" id="{C10211C7-F01C-903F-8AA3-60C09E6C12C2}"/>
                </a:ext>
              </a:extLst>
            </p:cNvPr>
            <p:cNvSpPr/>
            <p:nvPr/>
          </p:nvSpPr>
          <p:spPr>
            <a:xfrm>
              <a:off x="4938020" y="179376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8" name="pt132">
              <a:extLst>
                <a:ext uri="{FF2B5EF4-FFF2-40B4-BE49-F238E27FC236}">
                  <a16:creationId xmlns:a16="http://schemas.microsoft.com/office/drawing/2014/main" id="{92A720C8-6131-5576-641C-9190EA701219}"/>
                </a:ext>
              </a:extLst>
            </p:cNvPr>
            <p:cNvSpPr/>
            <p:nvPr/>
          </p:nvSpPr>
          <p:spPr>
            <a:xfrm>
              <a:off x="4800258" y="22223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89" name="pt133">
              <a:extLst>
                <a:ext uri="{FF2B5EF4-FFF2-40B4-BE49-F238E27FC236}">
                  <a16:creationId xmlns:a16="http://schemas.microsoft.com/office/drawing/2014/main" id="{AC85D302-0DD6-B9D5-3D45-2B0AAD759B7C}"/>
                </a:ext>
              </a:extLst>
            </p:cNvPr>
            <p:cNvSpPr/>
            <p:nvPr/>
          </p:nvSpPr>
          <p:spPr>
            <a:xfrm>
              <a:off x="4814356" y="200807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90" name="pt134">
              <a:extLst>
                <a:ext uri="{FF2B5EF4-FFF2-40B4-BE49-F238E27FC236}">
                  <a16:creationId xmlns:a16="http://schemas.microsoft.com/office/drawing/2014/main" id="{10115043-5CC2-E521-BFEE-BEA03C6B3D1B}"/>
                </a:ext>
              </a:extLst>
            </p:cNvPr>
            <p:cNvSpPr/>
            <p:nvPr/>
          </p:nvSpPr>
          <p:spPr>
            <a:xfrm>
              <a:off x="4954995" y="230811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91" name="pt135">
              <a:extLst>
                <a:ext uri="{FF2B5EF4-FFF2-40B4-BE49-F238E27FC236}">
                  <a16:creationId xmlns:a16="http://schemas.microsoft.com/office/drawing/2014/main" id="{95907D03-5EBD-DC52-32DB-3722084FCC0F}"/>
                </a:ext>
              </a:extLst>
            </p:cNvPr>
            <p:cNvSpPr/>
            <p:nvPr/>
          </p:nvSpPr>
          <p:spPr>
            <a:xfrm>
              <a:off x="5185011"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92" name="pt136">
              <a:extLst>
                <a:ext uri="{FF2B5EF4-FFF2-40B4-BE49-F238E27FC236}">
                  <a16:creationId xmlns:a16="http://schemas.microsoft.com/office/drawing/2014/main" id="{E4E49773-0909-E052-267D-3B7B8A2C77D2}"/>
                </a:ext>
              </a:extLst>
            </p:cNvPr>
            <p:cNvSpPr/>
            <p:nvPr/>
          </p:nvSpPr>
          <p:spPr>
            <a:xfrm>
              <a:off x="5314011" y="207066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93" name="pt137">
              <a:extLst>
                <a:ext uri="{FF2B5EF4-FFF2-40B4-BE49-F238E27FC236}">
                  <a16:creationId xmlns:a16="http://schemas.microsoft.com/office/drawing/2014/main" id="{DC50A2D3-B809-3F02-380B-E3CE76FD9E0C}"/>
                </a:ext>
              </a:extLst>
            </p:cNvPr>
            <p:cNvSpPr/>
            <p:nvPr/>
          </p:nvSpPr>
          <p:spPr>
            <a:xfrm>
              <a:off x="5197908" y="187832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799" name="pt138">
              <a:extLst>
                <a:ext uri="{FF2B5EF4-FFF2-40B4-BE49-F238E27FC236}">
                  <a16:creationId xmlns:a16="http://schemas.microsoft.com/office/drawing/2014/main" id="{0D47F282-3A03-C2FA-EDE7-007A50B4D7E9}"/>
                </a:ext>
              </a:extLst>
            </p:cNvPr>
            <p:cNvSpPr/>
            <p:nvPr/>
          </p:nvSpPr>
          <p:spPr>
            <a:xfrm>
              <a:off x="5187367"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00" name="pt139">
              <a:extLst>
                <a:ext uri="{FF2B5EF4-FFF2-40B4-BE49-F238E27FC236}">
                  <a16:creationId xmlns:a16="http://schemas.microsoft.com/office/drawing/2014/main" id="{73BACCFC-38CE-F075-843F-7A55E0B332F1}"/>
                </a:ext>
              </a:extLst>
            </p:cNvPr>
            <p:cNvSpPr/>
            <p:nvPr/>
          </p:nvSpPr>
          <p:spPr>
            <a:xfrm>
              <a:off x="5154525" y="218057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02" name="pt140">
              <a:extLst>
                <a:ext uri="{FF2B5EF4-FFF2-40B4-BE49-F238E27FC236}">
                  <a16:creationId xmlns:a16="http://schemas.microsoft.com/office/drawing/2014/main" id="{CE19FC35-C44A-FB00-63E9-92311001BC80}"/>
                </a:ext>
              </a:extLst>
            </p:cNvPr>
            <p:cNvSpPr/>
            <p:nvPr/>
          </p:nvSpPr>
          <p:spPr>
            <a:xfrm>
              <a:off x="5184596" y="218057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04" name="pt141">
              <a:extLst>
                <a:ext uri="{FF2B5EF4-FFF2-40B4-BE49-F238E27FC236}">
                  <a16:creationId xmlns:a16="http://schemas.microsoft.com/office/drawing/2014/main" id="{15A897D6-D042-9BFE-93E0-6C036F895916}"/>
                </a:ext>
              </a:extLst>
            </p:cNvPr>
            <p:cNvSpPr/>
            <p:nvPr/>
          </p:nvSpPr>
          <p:spPr>
            <a:xfrm>
              <a:off x="5183482" y="218057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05" name="pt142">
              <a:extLst>
                <a:ext uri="{FF2B5EF4-FFF2-40B4-BE49-F238E27FC236}">
                  <a16:creationId xmlns:a16="http://schemas.microsoft.com/office/drawing/2014/main" id="{49B42F92-A835-C5AC-D350-3937AE7CF4A5}"/>
                </a:ext>
              </a:extLst>
            </p:cNvPr>
            <p:cNvSpPr/>
            <p:nvPr/>
          </p:nvSpPr>
          <p:spPr>
            <a:xfrm>
              <a:off x="5200769" y="220804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06" name="pt143">
              <a:extLst>
                <a:ext uri="{FF2B5EF4-FFF2-40B4-BE49-F238E27FC236}">
                  <a16:creationId xmlns:a16="http://schemas.microsoft.com/office/drawing/2014/main" id="{EEFE04DD-EDCA-44EB-784B-2C91A654F21A}"/>
                </a:ext>
              </a:extLst>
            </p:cNvPr>
            <p:cNvSpPr/>
            <p:nvPr/>
          </p:nvSpPr>
          <p:spPr>
            <a:xfrm>
              <a:off x="5160008" y="215309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07" name="pt144">
              <a:extLst>
                <a:ext uri="{FF2B5EF4-FFF2-40B4-BE49-F238E27FC236}">
                  <a16:creationId xmlns:a16="http://schemas.microsoft.com/office/drawing/2014/main" id="{42DAB7F6-068E-F7C6-E532-A860C9DD1A0F}"/>
                </a:ext>
              </a:extLst>
            </p:cNvPr>
            <p:cNvSpPr/>
            <p:nvPr/>
          </p:nvSpPr>
          <p:spPr>
            <a:xfrm>
              <a:off x="5176140" y="218057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10" name="pt145">
              <a:extLst>
                <a:ext uri="{FF2B5EF4-FFF2-40B4-BE49-F238E27FC236}">
                  <a16:creationId xmlns:a16="http://schemas.microsoft.com/office/drawing/2014/main" id="{A3C1A3AE-F1D8-4893-37CE-FC955A0BAEF9}"/>
                </a:ext>
              </a:extLst>
            </p:cNvPr>
            <p:cNvSpPr/>
            <p:nvPr/>
          </p:nvSpPr>
          <p:spPr>
            <a:xfrm>
              <a:off x="5316948"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11" name="pt146">
              <a:extLst>
                <a:ext uri="{FF2B5EF4-FFF2-40B4-BE49-F238E27FC236}">
                  <a16:creationId xmlns:a16="http://schemas.microsoft.com/office/drawing/2014/main" id="{4BC38DDB-3C68-6454-3B12-23DAAC7B257C}"/>
                </a:ext>
              </a:extLst>
            </p:cNvPr>
            <p:cNvSpPr/>
            <p:nvPr/>
          </p:nvSpPr>
          <p:spPr>
            <a:xfrm>
              <a:off x="5293022" y="163103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24" name="pt147">
              <a:extLst>
                <a:ext uri="{FF2B5EF4-FFF2-40B4-BE49-F238E27FC236}">
                  <a16:creationId xmlns:a16="http://schemas.microsoft.com/office/drawing/2014/main" id="{3C32E34D-5953-D488-A21D-E37A0681B406}"/>
                </a:ext>
              </a:extLst>
            </p:cNvPr>
            <p:cNvSpPr/>
            <p:nvPr/>
          </p:nvSpPr>
          <p:spPr>
            <a:xfrm>
              <a:off x="5292855" y="174094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62" name="pt148">
              <a:extLst>
                <a:ext uri="{FF2B5EF4-FFF2-40B4-BE49-F238E27FC236}">
                  <a16:creationId xmlns:a16="http://schemas.microsoft.com/office/drawing/2014/main" id="{088FDC62-1553-7F98-B9B4-E8D7786C0BD4}"/>
                </a:ext>
              </a:extLst>
            </p:cNvPr>
            <p:cNvSpPr/>
            <p:nvPr/>
          </p:nvSpPr>
          <p:spPr>
            <a:xfrm>
              <a:off x="5203873"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865" name="pt149">
              <a:extLst>
                <a:ext uri="{FF2B5EF4-FFF2-40B4-BE49-F238E27FC236}">
                  <a16:creationId xmlns:a16="http://schemas.microsoft.com/office/drawing/2014/main" id="{A3391DD3-119D-8F33-062E-C71A49E2F316}"/>
                </a:ext>
              </a:extLst>
            </p:cNvPr>
            <p:cNvSpPr/>
            <p:nvPr/>
          </p:nvSpPr>
          <p:spPr>
            <a:xfrm>
              <a:off x="5209374" y="157608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11" name="pt150">
              <a:extLst>
                <a:ext uri="{FF2B5EF4-FFF2-40B4-BE49-F238E27FC236}">
                  <a16:creationId xmlns:a16="http://schemas.microsoft.com/office/drawing/2014/main" id="{E568983E-983F-1475-A69D-D003261E8CDD}"/>
                </a:ext>
              </a:extLst>
            </p:cNvPr>
            <p:cNvSpPr/>
            <p:nvPr/>
          </p:nvSpPr>
          <p:spPr>
            <a:xfrm>
              <a:off x="5174036"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12" name="pt151">
              <a:extLst>
                <a:ext uri="{FF2B5EF4-FFF2-40B4-BE49-F238E27FC236}">
                  <a16:creationId xmlns:a16="http://schemas.microsoft.com/office/drawing/2014/main" id="{75B5DE8F-9472-BFD4-2DF3-A3C95110FD85}"/>
                </a:ext>
              </a:extLst>
            </p:cNvPr>
            <p:cNvSpPr/>
            <p:nvPr/>
          </p:nvSpPr>
          <p:spPr>
            <a:xfrm>
              <a:off x="5204782"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0" name="pt152">
              <a:extLst>
                <a:ext uri="{FF2B5EF4-FFF2-40B4-BE49-F238E27FC236}">
                  <a16:creationId xmlns:a16="http://schemas.microsoft.com/office/drawing/2014/main" id="{A28099F8-1597-4381-0F6F-1F13E64663AC}"/>
                </a:ext>
              </a:extLst>
            </p:cNvPr>
            <p:cNvSpPr/>
            <p:nvPr/>
          </p:nvSpPr>
          <p:spPr>
            <a:xfrm>
              <a:off x="5198456" y="212561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1" name="pt153">
              <a:extLst>
                <a:ext uri="{FF2B5EF4-FFF2-40B4-BE49-F238E27FC236}">
                  <a16:creationId xmlns:a16="http://schemas.microsoft.com/office/drawing/2014/main" id="{C85CD70B-B409-AFA5-5812-366F007D5673}"/>
                </a:ext>
              </a:extLst>
            </p:cNvPr>
            <p:cNvSpPr/>
            <p:nvPr/>
          </p:nvSpPr>
          <p:spPr>
            <a:xfrm>
              <a:off x="5187296" y="193328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3" name="pt154">
              <a:extLst>
                <a:ext uri="{FF2B5EF4-FFF2-40B4-BE49-F238E27FC236}">
                  <a16:creationId xmlns:a16="http://schemas.microsoft.com/office/drawing/2014/main" id="{54D21880-D2DC-885C-E421-32559825146E}"/>
                </a:ext>
              </a:extLst>
            </p:cNvPr>
            <p:cNvSpPr/>
            <p:nvPr/>
          </p:nvSpPr>
          <p:spPr>
            <a:xfrm>
              <a:off x="5343035" y="157608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4" name="pt155">
              <a:extLst>
                <a:ext uri="{FF2B5EF4-FFF2-40B4-BE49-F238E27FC236}">
                  <a16:creationId xmlns:a16="http://schemas.microsoft.com/office/drawing/2014/main" id="{2B9B09A9-6BFC-8B77-0EA9-F48943B2E353}"/>
                </a:ext>
              </a:extLst>
            </p:cNvPr>
            <p:cNvSpPr/>
            <p:nvPr/>
          </p:nvSpPr>
          <p:spPr>
            <a:xfrm>
              <a:off x="5297248" y="152112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5" name="pt156">
              <a:extLst>
                <a:ext uri="{FF2B5EF4-FFF2-40B4-BE49-F238E27FC236}">
                  <a16:creationId xmlns:a16="http://schemas.microsoft.com/office/drawing/2014/main" id="{751B416D-D8DF-26AA-1096-750C303DA9F0}"/>
                </a:ext>
              </a:extLst>
            </p:cNvPr>
            <p:cNvSpPr/>
            <p:nvPr/>
          </p:nvSpPr>
          <p:spPr>
            <a:xfrm>
              <a:off x="5181842" y="212561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6" name="pt157">
              <a:extLst>
                <a:ext uri="{FF2B5EF4-FFF2-40B4-BE49-F238E27FC236}">
                  <a16:creationId xmlns:a16="http://schemas.microsoft.com/office/drawing/2014/main" id="{1C5156AD-28F4-67FA-A1EB-05A16CEFFD01}"/>
                </a:ext>
              </a:extLst>
            </p:cNvPr>
            <p:cNvSpPr/>
            <p:nvPr/>
          </p:nvSpPr>
          <p:spPr>
            <a:xfrm>
              <a:off x="5177473" y="179589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7" name="pt158">
              <a:extLst>
                <a:ext uri="{FF2B5EF4-FFF2-40B4-BE49-F238E27FC236}">
                  <a16:creationId xmlns:a16="http://schemas.microsoft.com/office/drawing/2014/main" id="{5E96FB76-218F-FFEC-BC8A-C8AC71C2310C}"/>
                </a:ext>
              </a:extLst>
            </p:cNvPr>
            <p:cNvSpPr/>
            <p:nvPr/>
          </p:nvSpPr>
          <p:spPr>
            <a:xfrm>
              <a:off x="5343652" y="201571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8" name="pt159">
              <a:extLst>
                <a:ext uri="{FF2B5EF4-FFF2-40B4-BE49-F238E27FC236}">
                  <a16:creationId xmlns:a16="http://schemas.microsoft.com/office/drawing/2014/main" id="{442A29E3-435F-2FB6-0EEC-E4D011FEF46E}"/>
                </a:ext>
              </a:extLst>
            </p:cNvPr>
            <p:cNvSpPr/>
            <p:nvPr/>
          </p:nvSpPr>
          <p:spPr>
            <a:xfrm>
              <a:off x="5201050"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29" name="pt160">
              <a:extLst>
                <a:ext uri="{FF2B5EF4-FFF2-40B4-BE49-F238E27FC236}">
                  <a16:creationId xmlns:a16="http://schemas.microsoft.com/office/drawing/2014/main" id="{9E078556-08C0-FEFF-F974-E5BF523E8AD6}"/>
                </a:ext>
              </a:extLst>
            </p:cNvPr>
            <p:cNvSpPr/>
            <p:nvPr/>
          </p:nvSpPr>
          <p:spPr>
            <a:xfrm>
              <a:off x="5328159" y="204318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0" name="pt161">
              <a:extLst>
                <a:ext uri="{FF2B5EF4-FFF2-40B4-BE49-F238E27FC236}">
                  <a16:creationId xmlns:a16="http://schemas.microsoft.com/office/drawing/2014/main" id="{73CA9B2C-D1DF-0EC4-1038-3CFC0730F6EB}"/>
                </a:ext>
              </a:extLst>
            </p:cNvPr>
            <p:cNvSpPr/>
            <p:nvPr/>
          </p:nvSpPr>
          <p:spPr>
            <a:xfrm>
              <a:off x="5303185" y="220804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1" name="pt162">
              <a:extLst>
                <a:ext uri="{FF2B5EF4-FFF2-40B4-BE49-F238E27FC236}">
                  <a16:creationId xmlns:a16="http://schemas.microsoft.com/office/drawing/2014/main" id="{0DDF14E0-5DD8-257F-29A8-F79EA7724C25}"/>
                </a:ext>
              </a:extLst>
            </p:cNvPr>
            <p:cNvSpPr/>
            <p:nvPr/>
          </p:nvSpPr>
          <p:spPr>
            <a:xfrm>
              <a:off x="5162350" y="20431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2" name="pt163">
              <a:extLst>
                <a:ext uri="{FF2B5EF4-FFF2-40B4-BE49-F238E27FC236}">
                  <a16:creationId xmlns:a16="http://schemas.microsoft.com/office/drawing/2014/main" id="{07DC8308-FDB2-040B-4C76-E32368121A1D}"/>
                </a:ext>
              </a:extLst>
            </p:cNvPr>
            <p:cNvSpPr/>
            <p:nvPr/>
          </p:nvSpPr>
          <p:spPr>
            <a:xfrm>
              <a:off x="5189052" y="218057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3" name="pt164">
              <a:extLst>
                <a:ext uri="{FF2B5EF4-FFF2-40B4-BE49-F238E27FC236}">
                  <a16:creationId xmlns:a16="http://schemas.microsoft.com/office/drawing/2014/main" id="{FD9E2B5F-0D51-3B0F-50E8-C497E34D4B71}"/>
                </a:ext>
              </a:extLst>
            </p:cNvPr>
            <p:cNvSpPr/>
            <p:nvPr/>
          </p:nvSpPr>
          <p:spPr>
            <a:xfrm>
              <a:off x="5186983" y="179589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4" name="pt165">
              <a:extLst>
                <a:ext uri="{FF2B5EF4-FFF2-40B4-BE49-F238E27FC236}">
                  <a16:creationId xmlns:a16="http://schemas.microsoft.com/office/drawing/2014/main" id="{801B1F74-497D-EB19-FCF4-429C76AB9127}"/>
                </a:ext>
              </a:extLst>
            </p:cNvPr>
            <p:cNvSpPr/>
            <p:nvPr/>
          </p:nvSpPr>
          <p:spPr>
            <a:xfrm>
              <a:off x="5199628" y="218057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5" name="pt166">
              <a:extLst>
                <a:ext uri="{FF2B5EF4-FFF2-40B4-BE49-F238E27FC236}">
                  <a16:creationId xmlns:a16="http://schemas.microsoft.com/office/drawing/2014/main" id="{A9F281A9-B1AD-7060-CE0F-D00FC4DFCDB2}"/>
                </a:ext>
              </a:extLst>
            </p:cNvPr>
            <p:cNvSpPr/>
            <p:nvPr/>
          </p:nvSpPr>
          <p:spPr>
            <a:xfrm>
              <a:off x="5187960"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6" name="pt167">
              <a:extLst>
                <a:ext uri="{FF2B5EF4-FFF2-40B4-BE49-F238E27FC236}">
                  <a16:creationId xmlns:a16="http://schemas.microsoft.com/office/drawing/2014/main" id="{4EEE78EA-63DE-D773-A190-9F65ACF956B1}"/>
                </a:ext>
              </a:extLst>
            </p:cNvPr>
            <p:cNvSpPr/>
            <p:nvPr/>
          </p:nvSpPr>
          <p:spPr>
            <a:xfrm>
              <a:off x="5170698" y="152112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7" name="pt168">
              <a:extLst>
                <a:ext uri="{FF2B5EF4-FFF2-40B4-BE49-F238E27FC236}">
                  <a16:creationId xmlns:a16="http://schemas.microsoft.com/office/drawing/2014/main" id="{18C7FA2F-8744-4035-A568-908C57783000}"/>
                </a:ext>
              </a:extLst>
            </p:cNvPr>
            <p:cNvSpPr/>
            <p:nvPr/>
          </p:nvSpPr>
          <p:spPr>
            <a:xfrm>
              <a:off x="5188375" y="20706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8" name="pt169">
              <a:extLst>
                <a:ext uri="{FF2B5EF4-FFF2-40B4-BE49-F238E27FC236}">
                  <a16:creationId xmlns:a16="http://schemas.microsoft.com/office/drawing/2014/main" id="{9B5A898E-260A-C5F3-49D6-7AB633AADF8B}"/>
                </a:ext>
              </a:extLst>
            </p:cNvPr>
            <p:cNvSpPr/>
            <p:nvPr/>
          </p:nvSpPr>
          <p:spPr>
            <a:xfrm>
              <a:off x="5345241" y="182337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39" name="pt170">
              <a:extLst>
                <a:ext uri="{FF2B5EF4-FFF2-40B4-BE49-F238E27FC236}">
                  <a16:creationId xmlns:a16="http://schemas.microsoft.com/office/drawing/2014/main" id="{59474996-B0DC-EAC6-8B6A-98B1BB305C37}"/>
                </a:ext>
              </a:extLst>
            </p:cNvPr>
            <p:cNvSpPr/>
            <p:nvPr/>
          </p:nvSpPr>
          <p:spPr>
            <a:xfrm>
              <a:off x="5301882"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0" name="pt171">
              <a:extLst>
                <a:ext uri="{FF2B5EF4-FFF2-40B4-BE49-F238E27FC236}">
                  <a16:creationId xmlns:a16="http://schemas.microsoft.com/office/drawing/2014/main" id="{097374F0-DEE1-0CDC-F098-E2BED57B3627}"/>
                </a:ext>
              </a:extLst>
            </p:cNvPr>
            <p:cNvSpPr/>
            <p:nvPr/>
          </p:nvSpPr>
          <p:spPr>
            <a:xfrm>
              <a:off x="5205556" y="212561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1" name="pt172">
              <a:extLst>
                <a:ext uri="{FF2B5EF4-FFF2-40B4-BE49-F238E27FC236}">
                  <a16:creationId xmlns:a16="http://schemas.microsoft.com/office/drawing/2014/main" id="{FD949342-8990-A2EC-7815-A485E7B42534}"/>
                </a:ext>
              </a:extLst>
            </p:cNvPr>
            <p:cNvSpPr/>
            <p:nvPr/>
          </p:nvSpPr>
          <p:spPr>
            <a:xfrm>
              <a:off x="5312374" y="220804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2" name="pt173">
              <a:extLst>
                <a:ext uri="{FF2B5EF4-FFF2-40B4-BE49-F238E27FC236}">
                  <a16:creationId xmlns:a16="http://schemas.microsoft.com/office/drawing/2014/main" id="{32C04896-6D28-FEF2-4A5A-2EDED710AC92}"/>
                </a:ext>
              </a:extLst>
            </p:cNvPr>
            <p:cNvSpPr/>
            <p:nvPr/>
          </p:nvSpPr>
          <p:spPr>
            <a:xfrm>
              <a:off x="5318121" y="212561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3" name="pt174">
              <a:extLst>
                <a:ext uri="{FF2B5EF4-FFF2-40B4-BE49-F238E27FC236}">
                  <a16:creationId xmlns:a16="http://schemas.microsoft.com/office/drawing/2014/main" id="{7C356923-494C-60A2-FD87-16A08073768D}"/>
                </a:ext>
              </a:extLst>
            </p:cNvPr>
            <p:cNvSpPr/>
            <p:nvPr/>
          </p:nvSpPr>
          <p:spPr>
            <a:xfrm>
              <a:off x="5313759" y="209814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4" name="pt175">
              <a:extLst>
                <a:ext uri="{FF2B5EF4-FFF2-40B4-BE49-F238E27FC236}">
                  <a16:creationId xmlns:a16="http://schemas.microsoft.com/office/drawing/2014/main" id="{CFE3859C-BF74-E1D5-B547-CC9EC42AA02A}"/>
                </a:ext>
              </a:extLst>
            </p:cNvPr>
            <p:cNvSpPr/>
            <p:nvPr/>
          </p:nvSpPr>
          <p:spPr>
            <a:xfrm>
              <a:off x="5200536" y="215309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5" name="pt176">
              <a:extLst>
                <a:ext uri="{FF2B5EF4-FFF2-40B4-BE49-F238E27FC236}">
                  <a16:creationId xmlns:a16="http://schemas.microsoft.com/office/drawing/2014/main" id="{3D9EE1D1-57F8-65A5-DA65-EC63FA7081C0}"/>
                </a:ext>
              </a:extLst>
            </p:cNvPr>
            <p:cNvSpPr/>
            <p:nvPr/>
          </p:nvSpPr>
          <p:spPr>
            <a:xfrm>
              <a:off x="5325202" y="223552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6" name="pt177">
              <a:extLst>
                <a:ext uri="{FF2B5EF4-FFF2-40B4-BE49-F238E27FC236}">
                  <a16:creationId xmlns:a16="http://schemas.microsoft.com/office/drawing/2014/main" id="{5FF86AC4-17AD-5ACD-5B79-7D6B36F14122}"/>
                </a:ext>
              </a:extLst>
            </p:cNvPr>
            <p:cNvSpPr/>
            <p:nvPr/>
          </p:nvSpPr>
          <p:spPr>
            <a:xfrm>
              <a:off x="5181747"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7" name="pt178">
              <a:extLst>
                <a:ext uri="{FF2B5EF4-FFF2-40B4-BE49-F238E27FC236}">
                  <a16:creationId xmlns:a16="http://schemas.microsoft.com/office/drawing/2014/main" id="{FFDCF814-812F-6B82-3F8F-6B7795CF9ECA}"/>
                </a:ext>
              </a:extLst>
            </p:cNvPr>
            <p:cNvSpPr/>
            <p:nvPr/>
          </p:nvSpPr>
          <p:spPr>
            <a:xfrm>
              <a:off x="5346971"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8" name="pt179">
              <a:extLst>
                <a:ext uri="{FF2B5EF4-FFF2-40B4-BE49-F238E27FC236}">
                  <a16:creationId xmlns:a16="http://schemas.microsoft.com/office/drawing/2014/main" id="{2C9B557A-7FD0-9659-B25D-B0507C90017E}"/>
                </a:ext>
              </a:extLst>
            </p:cNvPr>
            <p:cNvSpPr/>
            <p:nvPr/>
          </p:nvSpPr>
          <p:spPr>
            <a:xfrm>
              <a:off x="5303493" y="19607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49" name="pt180">
              <a:extLst>
                <a:ext uri="{FF2B5EF4-FFF2-40B4-BE49-F238E27FC236}">
                  <a16:creationId xmlns:a16="http://schemas.microsoft.com/office/drawing/2014/main" id="{03F2F478-1D31-0760-8C4F-B07D5C958D1D}"/>
                </a:ext>
              </a:extLst>
            </p:cNvPr>
            <p:cNvSpPr/>
            <p:nvPr/>
          </p:nvSpPr>
          <p:spPr>
            <a:xfrm>
              <a:off x="5297243" y="149365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0" name="pt181">
              <a:extLst>
                <a:ext uri="{FF2B5EF4-FFF2-40B4-BE49-F238E27FC236}">
                  <a16:creationId xmlns:a16="http://schemas.microsoft.com/office/drawing/2014/main" id="{1530B883-85E0-D607-7421-528C90392B8C}"/>
                </a:ext>
              </a:extLst>
            </p:cNvPr>
            <p:cNvSpPr/>
            <p:nvPr/>
          </p:nvSpPr>
          <p:spPr>
            <a:xfrm>
              <a:off x="5322393"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1" name="pt182">
              <a:extLst>
                <a:ext uri="{FF2B5EF4-FFF2-40B4-BE49-F238E27FC236}">
                  <a16:creationId xmlns:a16="http://schemas.microsoft.com/office/drawing/2014/main" id="{45F69E0C-23E8-A927-D35C-3DB860DEC495}"/>
                </a:ext>
              </a:extLst>
            </p:cNvPr>
            <p:cNvSpPr/>
            <p:nvPr/>
          </p:nvSpPr>
          <p:spPr>
            <a:xfrm>
              <a:off x="5307835" y="19607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2" name="pt183">
              <a:extLst>
                <a:ext uri="{FF2B5EF4-FFF2-40B4-BE49-F238E27FC236}">
                  <a16:creationId xmlns:a16="http://schemas.microsoft.com/office/drawing/2014/main" id="{8CA83398-ED31-34A4-433A-B5D7436E8DA0}"/>
                </a:ext>
              </a:extLst>
            </p:cNvPr>
            <p:cNvSpPr/>
            <p:nvPr/>
          </p:nvSpPr>
          <p:spPr>
            <a:xfrm>
              <a:off x="5324227"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3" name="pt184">
              <a:extLst>
                <a:ext uri="{FF2B5EF4-FFF2-40B4-BE49-F238E27FC236}">
                  <a16:creationId xmlns:a16="http://schemas.microsoft.com/office/drawing/2014/main" id="{FBC3E68B-8387-26BA-79C4-A687835F360A}"/>
                </a:ext>
              </a:extLst>
            </p:cNvPr>
            <p:cNvSpPr/>
            <p:nvPr/>
          </p:nvSpPr>
          <p:spPr>
            <a:xfrm>
              <a:off x="5202232" y="212561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4" name="pt185">
              <a:extLst>
                <a:ext uri="{FF2B5EF4-FFF2-40B4-BE49-F238E27FC236}">
                  <a16:creationId xmlns:a16="http://schemas.microsoft.com/office/drawing/2014/main" id="{74EA738B-7720-3A2B-9179-42FB5B578484}"/>
                </a:ext>
              </a:extLst>
            </p:cNvPr>
            <p:cNvSpPr/>
            <p:nvPr/>
          </p:nvSpPr>
          <p:spPr>
            <a:xfrm>
              <a:off x="5155449" y="215309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5" name="pt186">
              <a:extLst>
                <a:ext uri="{FF2B5EF4-FFF2-40B4-BE49-F238E27FC236}">
                  <a16:creationId xmlns:a16="http://schemas.microsoft.com/office/drawing/2014/main" id="{F794ED4D-91AA-2FC6-41B6-8153D3CDF0EC}"/>
                </a:ext>
              </a:extLst>
            </p:cNvPr>
            <p:cNvSpPr/>
            <p:nvPr/>
          </p:nvSpPr>
          <p:spPr>
            <a:xfrm>
              <a:off x="5174096" y="209814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6" name="pt187">
              <a:extLst>
                <a:ext uri="{FF2B5EF4-FFF2-40B4-BE49-F238E27FC236}">
                  <a16:creationId xmlns:a16="http://schemas.microsoft.com/office/drawing/2014/main" id="{B65AE933-4F64-5058-B189-4A021BD908FA}"/>
                </a:ext>
              </a:extLst>
            </p:cNvPr>
            <p:cNvSpPr/>
            <p:nvPr/>
          </p:nvSpPr>
          <p:spPr>
            <a:xfrm>
              <a:off x="5321875" y="215309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7" name="pt188">
              <a:extLst>
                <a:ext uri="{FF2B5EF4-FFF2-40B4-BE49-F238E27FC236}">
                  <a16:creationId xmlns:a16="http://schemas.microsoft.com/office/drawing/2014/main" id="{3477C418-EE56-C793-4AFC-B21DC597050A}"/>
                </a:ext>
              </a:extLst>
            </p:cNvPr>
            <p:cNvSpPr/>
            <p:nvPr/>
          </p:nvSpPr>
          <p:spPr>
            <a:xfrm>
              <a:off x="5199858"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8" name="pt189">
              <a:extLst>
                <a:ext uri="{FF2B5EF4-FFF2-40B4-BE49-F238E27FC236}">
                  <a16:creationId xmlns:a16="http://schemas.microsoft.com/office/drawing/2014/main" id="{1FA1041D-10A4-43D9-9224-3475B016E58F}"/>
                </a:ext>
              </a:extLst>
            </p:cNvPr>
            <p:cNvSpPr/>
            <p:nvPr/>
          </p:nvSpPr>
          <p:spPr>
            <a:xfrm>
              <a:off x="5155316" y="209814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959" name="pt190">
              <a:extLst>
                <a:ext uri="{FF2B5EF4-FFF2-40B4-BE49-F238E27FC236}">
                  <a16:creationId xmlns:a16="http://schemas.microsoft.com/office/drawing/2014/main" id="{3E33C28B-F3A7-8467-CBB7-F6AEEBC5F174}"/>
                </a:ext>
              </a:extLst>
            </p:cNvPr>
            <p:cNvSpPr/>
            <p:nvPr/>
          </p:nvSpPr>
          <p:spPr>
            <a:xfrm>
              <a:off x="5203044"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36" name="pt191">
              <a:extLst>
                <a:ext uri="{FF2B5EF4-FFF2-40B4-BE49-F238E27FC236}">
                  <a16:creationId xmlns:a16="http://schemas.microsoft.com/office/drawing/2014/main" id="{3720079D-D214-C5CA-2741-611E62D2B746}"/>
                </a:ext>
              </a:extLst>
            </p:cNvPr>
            <p:cNvSpPr/>
            <p:nvPr/>
          </p:nvSpPr>
          <p:spPr>
            <a:xfrm>
              <a:off x="5320266"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37" name="pt192">
              <a:extLst>
                <a:ext uri="{FF2B5EF4-FFF2-40B4-BE49-F238E27FC236}">
                  <a16:creationId xmlns:a16="http://schemas.microsoft.com/office/drawing/2014/main" id="{017B830A-C710-12DE-F0F6-21928EF31761}"/>
                </a:ext>
              </a:extLst>
            </p:cNvPr>
            <p:cNvSpPr/>
            <p:nvPr/>
          </p:nvSpPr>
          <p:spPr>
            <a:xfrm>
              <a:off x="5187382" y="212561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38" name="pt193">
              <a:extLst>
                <a:ext uri="{FF2B5EF4-FFF2-40B4-BE49-F238E27FC236}">
                  <a16:creationId xmlns:a16="http://schemas.microsoft.com/office/drawing/2014/main" id="{5466DF58-13EC-228E-2DBB-FDD530CAA8B0}"/>
                </a:ext>
              </a:extLst>
            </p:cNvPr>
            <p:cNvSpPr/>
            <p:nvPr/>
          </p:nvSpPr>
          <p:spPr>
            <a:xfrm>
              <a:off x="5316612" y="209814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39" name="pt194">
              <a:extLst>
                <a:ext uri="{FF2B5EF4-FFF2-40B4-BE49-F238E27FC236}">
                  <a16:creationId xmlns:a16="http://schemas.microsoft.com/office/drawing/2014/main" id="{68F84AF9-6D43-12BD-50E0-AACC47464945}"/>
                </a:ext>
              </a:extLst>
            </p:cNvPr>
            <p:cNvSpPr/>
            <p:nvPr/>
          </p:nvSpPr>
          <p:spPr>
            <a:xfrm>
              <a:off x="5197169" y="220804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0" name="pt195">
              <a:extLst>
                <a:ext uri="{FF2B5EF4-FFF2-40B4-BE49-F238E27FC236}">
                  <a16:creationId xmlns:a16="http://schemas.microsoft.com/office/drawing/2014/main" id="{869580C6-C40C-691E-C70A-1D299D270C03}"/>
                </a:ext>
              </a:extLst>
            </p:cNvPr>
            <p:cNvSpPr/>
            <p:nvPr/>
          </p:nvSpPr>
          <p:spPr>
            <a:xfrm>
              <a:off x="5169089" y="215309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1" name="pt196">
              <a:extLst>
                <a:ext uri="{FF2B5EF4-FFF2-40B4-BE49-F238E27FC236}">
                  <a16:creationId xmlns:a16="http://schemas.microsoft.com/office/drawing/2014/main" id="{523D9E4F-0340-0B7E-24F8-6454EF4C84DD}"/>
                </a:ext>
              </a:extLst>
            </p:cNvPr>
            <p:cNvSpPr/>
            <p:nvPr/>
          </p:nvSpPr>
          <p:spPr>
            <a:xfrm>
              <a:off x="5180462"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2" name="pt197">
              <a:extLst>
                <a:ext uri="{FF2B5EF4-FFF2-40B4-BE49-F238E27FC236}">
                  <a16:creationId xmlns:a16="http://schemas.microsoft.com/office/drawing/2014/main" id="{F03CAA36-C39C-8EA2-038D-7585AA2CF6D3}"/>
                </a:ext>
              </a:extLst>
            </p:cNvPr>
            <p:cNvSpPr/>
            <p:nvPr/>
          </p:nvSpPr>
          <p:spPr>
            <a:xfrm>
              <a:off x="5302423" y="215309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3" name="pt198">
              <a:extLst>
                <a:ext uri="{FF2B5EF4-FFF2-40B4-BE49-F238E27FC236}">
                  <a16:creationId xmlns:a16="http://schemas.microsoft.com/office/drawing/2014/main" id="{BFAE1167-5A93-F0DD-D07C-0C3A62F5D88D}"/>
                </a:ext>
              </a:extLst>
            </p:cNvPr>
            <p:cNvSpPr/>
            <p:nvPr/>
          </p:nvSpPr>
          <p:spPr>
            <a:xfrm>
              <a:off x="5315395" y="220804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4" name="pt199">
              <a:extLst>
                <a:ext uri="{FF2B5EF4-FFF2-40B4-BE49-F238E27FC236}">
                  <a16:creationId xmlns:a16="http://schemas.microsoft.com/office/drawing/2014/main" id="{870ADABF-8A8F-0217-CFC0-3E4CDADAC047}"/>
                </a:ext>
              </a:extLst>
            </p:cNvPr>
            <p:cNvSpPr/>
            <p:nvPr/>
          </p:nvSpPr>
          <p:spPr>
            <a:xfrm>
              <a:off x="5325760" y="207066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5" name="pt200">
              <a:extLst>
                <a:ext uri="{FF2B5EF4-FFF2-40B4-BE49-F238E27FC236}">
                  <a16:creationId xmlns:a16="http://schemas.microsoft.com/office/drawing/2014/main" id="{CD2A1C9F-1B73-E703-89B6-70E93B7BC658}"/>
                </a:ext>
              </a:extLst>
            </p:cNvPr>
            <p:cNvSpPr/>
            <p:nvPr/>
          </p:nvSpPr>
          <p:spPr>
            <a:xfrm>
              <a:off x="5205284"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6" name="pt201">
              <a:extLst>
                <a:ext uri="{FF2B5EF4-FFF2-40B4-BE49-F238E27FC236}">
                  <a16:creationId xmlns:a16="http://schemas.microsoft.com/office/drawing/2014/main" id="{5E0F5A28-C6AD-B1B4-C413-660C31D2FCF0}"/>
                </a:ext>
              </a:extLst>
            </p:cNvPr>
            <p:cNvSpPr/>
            <p:nvPr/>
          </p:nvSpPr>
          <p:spPr>
            <a:xfrm>
              <a:off x="5204087" y="212561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47" name="pt202">
              <a:extLst>
                <a:ext uri="{FF2B5EF4-FFF2-40B4-BE49-F238E27FC236}">
                  <a16:creationId xmlns:a16="http://schemas.microsoft.com/office/drawing/2014/main" id="{16B3CE7D-00CC-7B17-0975-847B56122720}"/>
                </a:ext>
              </a:extLst>
            </p:cNvPr>
            <p:cNvSpPr/>
            <p:nvPr/>
          </p:nvSpPr>
          <p:spPr>
            <a:xfrm>
              <a:off x="5171171"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51" name="pt203">
              <a:extLst>
                <a:ext uri="{FF2B5EF4-FFF2-40B4-BE49-F238E27FC236}">
                  <a16:creationId xmlns:a16="http://schemas.microsoft.com/office/drawing/2014/main" id="{B06281EE-C29B-B9C6-0970-92E375883849}"/>
                </a:ext>
              </a:extLst>
            </p:cNvPr>
            <p:cNvSpPr/>
            <p:nvPr/>
          </p:nvSpPr>
          <p:spPr>
            <a:xfrm>
              <a:off x="5312841" y="215309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552" name="pt204">
              <a:extLst>
                <a:ext uri="{FF2B5EF4-FFF2-40B4-BE49-F238E27FC236}">
                  <a16:creationId xmlns:a16="http://schemas.microsoft.com/office/drawing/2014/main" id="{2F641D7E-F8DB-5EF1-83DD-42761B9B5E77}"/>
                </a:ext>
              </a:extLst>
            </p:cNvPr>
            <p:cNvSpPr/>
            <p:nvPr/>
          </p:nvSpPr>
          <p:spPr>
            <a:xfrm>
              <a:off x="5318555" y="146617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864" name="pt205">
              <a:extLst>
                <a:ext uri="{FF2B5EF4-FFF2-40B4-BE49-F238E27FC236}">
                  <a16:creationId xmlns:a16="http://schemas.microsoft.com/office/drawing/2014/main" id="{5FB80B9E-9B56-E08B-409B-CA879F8D9D22}"/>
                </a:ext>
              </a:extLst>
            </p:cNvPr>
            <p:cNvSpPr/>
            <p:nvPr/>
          </p:nvSpPr>
          <p:spPr>
            <a:xfrm>
              <a:off x="5168647" y="22355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869" name="pt206">
              <a:extLst>
                <a:ext uri="{FF2B5EF4-FFF2-40B4-BE49-F238E27FC236}">
                  <a16:creationId xmlns:a16="http://schemas.microsoft.com/office/drawing/2014/main" id="{E8699B18-C6B5-7089-4CA8-48FBB1765E63}"/>
                </a:ext>
              </a:extLst>
            </p:cNvPr>
            <p:cNvSpPr/>
            <p:nvPr/>
          </p:nvSpPr>
          <p:spPr>
            <a:xfrm>
              <a:off x="5179921" y="20431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875" name="pt207">
              <a:extLst>
                <a:ext uri="{FF2B5EF4-FFF2-40B4-BE49-F238E27FC236}">
                  <a16:creationId xmlns:a16="http://schemas.microsoft.com/office/drawing/2014/main" id="{8AB22534-9976-541F-C99E-57D7B51D98C8}"/>
                </a:ext>
              </a:extLst>
            </p:cNvPr>
            <p:cNvSpPr/>
            <p:nvPr/>
          </p:nvSpPr>
          <p:spPr>
            <a:xfrm>
              <a:off x="5341447" y="218057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878" name="pt208">
              <a:extLst>
                <a:ext uri="{FF2B5EF4-FFF2-40B4-BE49-F238E27FC236}">
                  <a16:creationId xmlns:a16="http://schemas.microsoft.com/office/drawing/2014/main" id="{1A07500E-3FF3-4AB8-ECD2-C70A9FCF6B13}"/>
                </a:ext>
              </a:extLst>
            </p:cNvPr>
            <p:cNvSpPr/>
            <p:nvPr/>
          </p:nvSpPr>
          <p:spPr>
            <a:xfrm>
              <a:off x="5588761"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879" name="pt209">
              <a:extLst>
                <a:ext uri="{FF2B5EF4-FFF2-40B4-BE49-F238E27FC236}">
                  <a16:creationId xmlns:a16="http://schemas.microsoft.com/office/drawing/2014/main" id="{48A6392C-910B-B393-0A3A-E2AB23C0E369}"/>
                </a:ext>
              </a:extLst>
            </p:cNvPr>
            <p:cNvSpPr/>
            <p:nvPr/>
          </p:nvSpPr>
          <p:spPr>
            <a:xfrm>
              <a:off x="5723675" y="19763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1880" name="pt210">
              <a:extLst>
                <a:ext uri="{FF2B5EF4-FFF2-40B4-BE49-F238E27FC236}">
                  <a16:creationId xmlns:a16="http://schemas.microsoft.com/office/drawing/2014/main" id="{D62257A8-FC6E-AA82-84C0-C73348C6A7EC}"/>
                </a:ext>
              </a:extLst>
            </p:cNvPr>
            <p:cNvSpPr/>
            <p:nvPr/>
          </p:nvSpPr>
          <p:spPr>
            <a:xfrm>
              <a:off x="5556271" y="182695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36" name="pt211">
              <a:extLst>
                <a:ext uri="{FF2B5EF4-FFF2-40B4-BE49-F238E27FC236}">
                  <a16:creationId xmlns:a16="http://schemas.microsoft.com/office/drawing/2014/main" id="{B51BB15F-2C3B-3FBF-595F-27534F9D172D}"/>
                </a:ext>
              </a:extLst>
            </p:cNvPr>
            <p:cNvSpPr/>
            <p:nvPr/>
          </p:nvSpPr>
          <p:spPr>
            <a:xfrm>
              <a:off x="5547671"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37" name="pt212">
              <a:extLst>
                <a:ext uri="{FF2B5EF4-FFF2-40B4-BE49-F238E27FC236}">
                  <a16:creationId xmlns:a16="http://schemas.microsoft.com/office/drawing/2014/main" id="{B27C2D58-54D3-EA65-8BB8-08E59C132D8B}"/>
                </a:ext>
              </a:extLst>
            </p:cNvPr>
            <p:cNvSpPr/>
            <p:nvPr/>
          </p:nvSpPr>
          <p:spPr>
            <a:xfrm>
              <a:off x="5569256"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38" name="pt213">
              <a:extLst>
                <a:ext uri="{FF2B5EF4-FFF2-40B4-BE49-F238E27FC236}">
                  <a16:creationId xmlns:a16="http://schemas.microsoft.com/office/drawing/2014/main" id="{5EAE01B3-FC38-A11F-9956-8DDD6DF3429E}"/>
                </a:ext>
              </a:extLst>
            </p:cNvPr>
            <p:cNvSpPr/>
            <p:nvPr/>
          </p:nvSpPr>
          <p:spPr>
            <a:xfrm>
              <a:off x="5588867"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39" name="pt214">
              <a:extLst>
                <a:ext uri="{FF2B5EF4-FFF2-40B4-BE49-F238E27FC236}">
                  <a16:creationId xmlns:a16="http://schemas.microsoft.com/office/drawing/2014/main" id="{DFF8C0D4-C468-E941-D886-784DAC32C540}"/>
                </a:ext>
              </a:extLst>
            </p:cNvPr>
            <p:cNvSpPr/>
            <p:nvPr/>
          </p:nvSpPr>
          <p:spPr>
            <a:xfrm>
              <a:off x="5548194" y="21257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0" name="pt215">
              <a:extLst>
                <a:ext uri="{FF2B5EF4-FFF2-40B4-BE49-F238E27FC236}">
                  <a16:creationId xmlns:a16="http://schemas.microsoft.com/office/drawing/2014/main" id="{63D578D3-1D0F-9560-A236-5439722F029D}"/>
                </a:ext>
              </a:extLst>
            </p:cNvPr>
            <p:cNvSpPr/>
            <p:nvPr/>
          </p:nvSpPr>
          <p:spPr>
            <a:xfrm>
              <a:off x="5544997"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1" name="pt216">
              <a:extLst>
                <a:ext uri="{FF2B5EF4-FFF2-40B4-BE49-F238E27FC236}">
                  <a16:creationId xmlns:a16="http://schemas.microsoft.com/office/drawing/2014/main" id="{6489126F-F687-8979-3B4D-CB5257C55F4D}"/>
                </a:ext>
              </a:extLst>
            </p:cNvPr>
            <p:cNvSpPr/>
            <p:nvPr/>
          </p:nvSpPr>
          <p:spPr>
            <a:xfrm>
              <a:off x="5594947" y="20261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2" name="pt217">
              <a:extLst>
                <a:ext uri="{FF2B5EF4-FFF2-40B4-BE49-F238E27FC236}">
                  <a16:creationId xmlns:a16="http://schemas.microsoft.com/office/drawing/2014/main" id="{E6995A99-EBCA-4D3C-80D1-5F12E9256E62}"/>
                </a:ext>
              </a:extLst>
            </p:cNvPr>
            <p:cNvSpPr/>
            <p:nvPr/>
          </p:nvSpPr>
          <p:spPr>
            <a:xfrm>
              <a:off x="5551302"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3" name="pt218">
              <a:extLst>
                <a:ext uri="{FF2B5EF4-FFF2-40B4-BE49-F238E27FC236}">
                  <a16:creationId xmlns:a16="http://schemas.microsoft.com/office/drawing/2014/main" id="{0A2B6BF0-2ABC-00CD-11FF-8B1932B5178F}"/>
                </a:ext>
              </a:extLst>
            </p:cNvPr>
            <p:cNvSpPr/>
            <p:nvPr/>
          </p:nvSpPr>
          <p:spPr>
            <a:xfrm>
              <a:off x="5706061" y="20759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4" name="pt219">
              <a:extLst>
                <a:ext uri="{FF2B5EF4-FFF2-40B4-BE49-F238E27FC236}">
                  <a16:creationId xmlns:a16="http://schemas.microsoft.com/office/drawing/2014/main" id="{D71C6ABE-571C-6243-B68A-59F1C0BD23F6}"/>
                </a:ext>
              </a:extLst>
            </p:cNvPr>
            <p:cNvSpPr/>
            <p:nvPr/>
          </p:nvSpPr>
          <p:spPr>
            <a:xfrm>
              <a:off x="5694530" y="172735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5" name="pt220">
              <a:extLst>
                <a:ext uri="{FF2B5EF4-FFF2-40B4-BE49-F238E27FC236}">
                  <a16:creationId xmlns:a16="http://schemas.microsoft.com/office/drawing/2014/main" id="{7D909596-FCE0-E2D6-6229-76FCFFEF6BF1}"/>
                </a:ext>
              </a:extLst>
            </p:cNvPr>
            <p:cNvSpPr/>
            <p:nvPr/>
          </p:nvSpPr>
          <p:spPr>
            <a:xfrm>
              <a:off x="5720528" y="187675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6" name="pt221">
              <a:extLst>
                <a:ext uri="{FF2B5EF4-FFF2-40B4-BE49-F238E27FC236}">
                  <a16:creationId xmlns:a16="http://schemas.microsoft.com/office/drawing/2014/main" id="{2BB3B267-A442-14BD-5640-FB7E00627D80}"/>
                </a:ext>
              </a:extLst>
            </p:cNvPr>
            <p:cNvSpPr/>
            <p:nvPr/>
          </p:nvSpPr>
          <p:spPr>
            <a:xfrm>
              <a:off x="5575257"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7" name="pt222">
              <a:extLst>
                <a:ext uri="{FF2B5EF4-FFF2-40B4-BE49-F238E27FC236}">
                  <a16:creationId xmlns:a16="http://schemas.microsoft.com/office/drawing/2014/main" id="{15135C62-F16E-B053-19CD-3B636349A9AB}"/>
                </a:ext>
              </a:extLst>
            </p:cNvPr>
            <p:cNvSpPr/>
            <p:nvPr/>
          </p:nvSpPr>
          <p:spPr>
            <a:xfrm>
              <a:off x="5594866"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8" name="pt223">
              <a:extLst>
                <a:ext uri="{FF2B5EF4-FFF2-40B4-BE49-F238E27FC236}">
                  <a16:creationId xmlns:a16="http://schemas.microsoft.com/office/drawing/2014/main" id="{8F13A139-221D-28DD-3937-1F1235D35909}"/>
                </a:ext>
              </a:extLst>
            </p:cNvPr>
            <p:cNvSpPr/>
            <p:nvPr/>
          </p:nvSpPr>
          <p:spPr>
            <a:xfrm>
              <a:off x="5595775"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49" name="pt224">
              <a:extLst>
                <a:ext uri="{FF2B5EF4-FFF2-40B4-BE49-F238E27FC236}">
                  <a16:creationId xmlns:a16="http://schemas.microsoft.com/office/drawing/2014/main" id="{B44CCC4B-0826-6FFF-74B5-E6095C9CEEF9}"/>
                </a:ext>
              </a:extLst>
            </p:cNvPr>
            <p:cNvSpPr/>
            <p:nvPr/>
          </p:nvSpPr>
          <p:spPr>
            <a:xfrm>
              <a:off x="5581186" y="19763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0" name="pt225">
              <a:extLst>
                <a:ext uri="{FF2B5EF4-FFF2-40B4-BE49-F238E27FC236}">
                  <a16:creationId xmlns:a16="http://schemas.microsoft.com/office/drawing/2014/main" id="{658198C4-67F3-B8A0-F158-1393C73FFA8D}"/>
                </a:ext>
              </a:extLst>
            </p:cNvPr>
            <p:cNvSpPr/>
            <p:nvPr/>
          </p:nvSpPr>
          <p:spPr>
            <a:xfrm>
              <a:off x="5590345"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1" name="pt226">
              <a:extLst>
                <a:ext uri="{FF2B5EF4-FFF2-40B4-BE49-F238E27FC236}">
                  <a16:creationId xmlns:a16="http://schemas.microsoft.com/office/drawing/2014/main" id="{A925C3DC-A611-922B-35B9-D62069E4DD8D}"/>
                </a:ext>
              </a:extLst>
            </p:cNvPr>
            <p:cNvSpPr/>
            <p:nvPr/>
          </p:nvSpPr>
          <p:spPr>
            <a:xfrm>
              <a:off x="5564099"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2" name="pt227">
              <a:extLst>
                <a:ext uri="{FF2B5EF4-FFF2-40B4-BE49-F238E27FC236}">
                  <a16:creationId xmlns:a16="http://schemas.microsoft.com/office/drawing/2014/main" id="{7307D481-2312-25FF-1558-53EB3DF973BF}"/>
                </a:ext>
              </a:extLst>
            </p:cNvPr>
            <p:cNvSpPr/>
            <p:nvPr/>
          </p:nvSpPr>
          <p:spPr>
            <a:xfrm>
              <a:off x="5734881" y="152815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3" name="pt228">
              <a:extLst>
                <a:ext uri="{FF2B5EF4-FFF2-40B4-BE49-F238E27FC236}">
                  <a16:creationId xmlns:a16="http://schemas.microsoft.com/office/drawing/2014/main" id="{0ACD6528-AD28-AA78-06E6-3336D843F676}"/>
                </a:ext>
              </a:extLst>
            </p:cNvPr>
            <p:cNvSpPr/>
            <p:nvPr/>
          </p:nvSpPr>
          <p:spPr>
            <a:xfrm>
              <a:off x="5698272" y="20759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4" name="pt229">
              <a:extLst>
                <a:ext uri="{FF2B5EF4-FFF2-40B4-BE49-F238E27FC236}">
                  <a16:creationId xmlns:a16="http://schemas.microsoft.com/office/drawing/2014/main" id="{C719D6A4-7A66-8951-4CA0-491FCCF986DD}"/>
                </a:ext>
              </a:extLst>
            </p:cNvPr>
            <p:cNvSpPr/>
            <p:nvPr/>
          </p:nvSpPr>
          <p:spPr>
            <a:xfrm>
              <a:off x="5582069"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5" name="pt230">
              <a:extLst>
                <a:ext uri="{FF2B5EF4-FFF2-40B4-BE49-F238E27FC236}">
                  <a16:creationId xmlns:a16="http://schemas.microsoft.com/office/drawing/2014/main" id="{6E9F9AF4-ABB5-A24F-8001-CB817263353B}"/>
                </a:ext>
              </a:extLst>
            </p:cNvPr>
            <p:cNvSpPr/>
            <p:nvPr/>
          </p:nvSpPr>
          <p:spPr>
            <a:xfrm>
              <a:off x="5558071"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6" name="pt231">
              <a:extLst>
                <a:ext uri="{FF2B5EF4-FFF2-40B4-BE49-F238E27FC236}">
                  <a16:creationId xmlns:a16="http://schemas.microsoft.com/office/drawing/2014/main" id="{26F94110-B6BA-E3F9-C034-9BA877A39C16}"/>
                </a:ext>
              </a:extLst>
            </p:cNvPr>
            <p:cNvSpPr/>
            <p:nvPr/>
          </p:nvSpPr>
          <p:spPr>
            <a:xfrm>
              <a:off x="5721346" y="20261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7" name="pt232">
              <a:extLst>
                <a:ext uri="{FF2B5EF4-FFF2-40B4-BE49-F238E27FC236}">
                  <a16:creationId xmlns:a16="http://schemas.microsoft.com/office/drawing/2014/main" id="{74234D5B-8E39-1FF2-EF48-5FBA3F54EF55}"/>
                </a:ext>
              </a:extLst>
            </p:cNvPr>
            <p:cNvSpPr/>
            <p:nvPr/>
          </p:nvSpPr>
          <p:spPr>
            <a:xfrm>
              <a:off x="5550004"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8" name="pt233">
              <a:extLst>
                <a:ext uri="{FF2B5EF4-FFF2-40B4-BE49-F238E27FC236}">
                  <a16:creationId xmlns:a16="http://schemas.microsoft.com/office/drawing/2014/main" id="{FA352CCD-E37D-C748-372E-E76CA1608B0D}"/>
                </a:ext>
              </a:extLst>
            </p:cNvPr>
            <p:cNvSpPr/>
            <p:nvPr/>
          </p:nvSpPr>
          <p:spPr>
            <a:xfrm>
              <a:off x="5713592" y="19265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59" name="pt234">
              <a:extLst>
                <a:ext uri="{FF2B5EF4-FFF2-40B4-BE49-F238E27FC236}">
                  <a16:creationId xmlns:a16="http://schemas.microsoft.com/office/drawing/2014/main" id="{F95B3FB2-A114-50B8-0F7F-3DEA18E96312}"/>
                </a:ext>
              </a:extLst>
            </p:cNvPr>
            <p:cNvSpPr/>
            <p:nvPr/>
          </p:nvSpPr>
          <p:spPr>
            <a:xfrm>
              <a:off x="5725023" y="21257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0" name="pt235">
              <a:extLst>
                <a:ext uri="{FF2B5EF4-FFF2-40B4-BE49-F238E27FC236}">
                  <a16:creationId xmlns:a16="http://schemas.microsoft.com/office/drawing/2014/main" id="{26A3C57C-69EF-4D70-D900-C3BA94B5E596}"/>
                </a:ext>
              </a:extLst>
            </p:cNvPr>
            <p:cNvSpPr/>
            <p:nvPr/>
          </p:nvSpPr>
          <p:spPr>
            <a:xfrm>
              <a:off x="5559622"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1" name="pt236">
              <a:extLst>
                <a:ext uri="{FF2B5EF4-FFF2-40B4-BE49-F238E27FC236}">
                  <a16:creationId xmlns:a16="http://schemas.microsoft.com/office/drawing/2014/main" id="{45263609-3324-2830-7A37-5C847BB8939C}"/>
                </a:ext>
              </a:extLst>
            </p:cNvPr>
            <p:cNvSpPr/>
            <p:nvPr/>
          </p:nvSpPr>
          <p:spPr>
            <a:xfrm>
              <a:off x="5561969" y="21257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2" name="pt237">
              <a:extLst>
                <a:ext uri="{FF2B5EF4-FFF2-40B4-BE49-F238E27FC236}">
                  <a16:creationId xmlns:a16="http://schemas.microsoft.com/office/drawing/2014/main" id="{A3D1755F-0E28-4A1B-A3AB-9D0F914285CB}"/>
                </a:ext>
              </a:extLst>
            </p:cNvPr>
            <p:cNvSpPr/>
            <p:nvPr/>
          </p:nvSpPr>
          <p:spPr>
            <a:xfrm>
              <a:off x="5575277"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3" name="pt238">
              <a:extLst>
                <a:ext uri="{FF2B5EF4-FFF2-40B4-BE49-F238E27FC236}">
                  <a16:creationId xmlns:a16="http://schemas.microsoft.com/office/drawing/2014/main" id="{06DE3BA9-EA20-DCC4-65E2-10D5FF8232C8}"/>
                </a:ext>
              </a:extLst>
            </p:cNvPr>
            <p:cNvSpPr/>
            <p:nvPr/>
          </p:nvSpPr>
          <p:spPr>
            <a:xfrm>
              <a:off x="5582049"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4" name="pt239">
              <a:extLst>
                <a:ext uri="{FF2B5EF4-FFF2-40B4-BE49-F238E27FC236}">
                  <a16:creationId xmlns:a16="http://schemas.microsoft.com/office/drawing/2014/main" id="{C98552EE-598B-A321-CFDB-8FEFFB8DC5AE}"/>
                </a:ext>
              </a:extLst>
            </p:cNvPr>
            <p:cNvSpPr/>
            <p:nvPr/>
          </p:nvSpPr>
          <p:spPr>
            <a:xfrm>
              <a:off x="5553647"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5" name="pt240">
              <a:extLst>
                <a:ext uri="{FF2B5EF4-FFF2-40B4-BE49-F238E27FC236}">
                  <a16:creationId xmlns:a16="http://schemas.microsoft.com/office/drawing/2014/main" id="{DED2BE1D-B141-9F7E-93AF-88D9EFBF5A9F}"/>
                </a:ext>
              </a:extLst>
            </p:cNvPr>
            <p:cNvSpPr/>
            <p:nvPr/>
          </p:nvSpPr>
          <p:spPr>
            <a:xfrm>
              <a:off x="5587910"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6" name="pt241">
              <a:extLst>
                <a:ext uri="{FF2B5EF4-FFF2-40B4-BE49-F238E27FC236}">
                  <a16:creationId xmlns:a16="http://schemas.microsoft.com/office/drawing/2014/main" id="{E32811B5-9B37-7BFB-9FE9-6E487C491929}"/>
                </a:ext>
              </a:extLst>
            </p:cNvPr>
            <p:cNvSpPr/>
            <p:nvPr/>
          </p:nvSpPr>
          <p:spPr>
            <a:xfrm>
              <a:off x="5557117"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7" name="pt242">
              <a:extLst>
                <a:ext uri="{FF2B5EF4-FFF2-40B4-BE49-F238E27FC236}">
                  <a16:creationId xmlns:a16="http://schemas.microsoft.com/office/drawing/2014/main" id="{81F618DC-74B1-4B6D-5CCC-EF705697B478}"/>
                </a:ext>
              </a:extLst>
            </p:cNvPr>
            <p:cNvSpPr/>
            <p:nvPr/>
          </p:nvSpPr>
          <p:spPr>
            <a:xfrm>
              <a:off x="5722344" y="19265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8" name="pt243">
              <a:extLst>
                <a:ext uri="{FF2B5EF4-FFF2-40B4-BE49-F238E27FC236}">
                  <a16:creationId xmlns:a16="http://schemas.microsoft.com/office/drawing/2014/main" id="{F4AEE18C-C687-9F75-3F33-8A2902E8B589}"/>
                </a:ext>
              </a:extLst>
            </p:cNvPr>
            <p:cNvSpPr/>
            <p:nvPr/>
          </p:nvSpPr>
          <p:spPr>
            <a:xfrm>
              <a:off x="5721291" y="21257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69" name="pt244">
              <a:extLst>
                <a:ext uri="{FF2B5EF4-FFF2-40B4-BE49-F238E27FC236}">
                  <a16:creationId xmlns:a16="http://schemas.microsoft.com/office/drawing/2014/main" id="{7F69DCE9-5380-FE82-3C19-1370CE91F029}"/>
                </a:ext>
              </a:extLst>
            </p:cNvPr>
            <p:cNvSpPr/>
            <p:nvPr/>
          </p:nvSpPr>
          <p:spPr>
            <a:xfrm>
              <a:off x="5571647"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0" name="pt245">
              <a:extLst>
                <a:ext uri="{FF2B5EF4-FFF2-40B4-BE49-F238E27FC236}">
                  <a16:creationId xmlns:a16="http://schemas.microsoft.com/office/drawing/2014/main" id="{4ABF27AA-3C0D-5D07-FC1D-CD6DAEFFACF0}"/>
                </a:ext>
              </a:extLst>
            </p:cNvPr>
            <p:cNvSpPr/>
            <p:nvPr/>
          </p:nvSpPr>
          <p:spPr>
            <a:xfrm>
              <a:off x="5695981"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1" name="pt246">
              <a:extLst>
                <a:ext uri="{FF2B5EF4-FFF2-40B4-BE49-F238E27FC236}">
                  <a16:creationId xmlns:a16="http://schemas.microsoft.com/office/drawing/2014/main" id="{1776E060-2855-B77D-8566-EE2BDFE8617A}"/>
                </a:ext>
              </a:extLst>
            </p:cNvPr>
            <p:cNvSpPr/>
            <p:nvPr/>
          </p:nvSpPr>
          <p:spPr>
            <a:xfrm>
              <a:off x="5706236" y="21257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2" name="pt247">
              <a:extLst>
                <a:ext uri="{FF2B5EF4-FFF2-40B4-BE49-F238E27FC236}">
                  <a16:creationId xmlns:a16="http://schemas.microsoft.com/office/drawing/2014/main" id="{F4584F03-CC07-6DA2-5E1F-912F75EEB046}"/>
                </a:ext>
              </a:extLst>
            </p:cNvPr>
            <p:cNvSpPr/>
            <p:nvPr/>
          </p:nvSpPr>
          <p:spPr>
            <a:xfrm>
              <a:off x="5719368"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3" name="pt248">
              <a:extLst>
                <a:ext uri="{FF2B5EF4-FFF2-40B4-BE49-F238E27FC236}">
                  <a16:creationId xmlns:a16="http://schemas.microsoft.com/office/drawing/2014/main" id="{1EB894CA-6CF7-0E64-FAB0-F7E2B7F4416B}"/>
                </a:ext>
              </a:extLst>
            </p:cNvPr>
            <p:cNvSpPr/>
            <p:nvPr/>
          </p:nvSpPr>
          <p:spPr>
            <a:xfrm>
              <a:off x="5578801"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4" name="pt249">
              <a:extLst>
                <a:ext uri="{FF2B5EF4-FFF2-40B4-BE49-F238E27FC236}">
                  <a16:creationId xmlns:a16="http://schemas.microsoft.com/office/drawing/2014/main" id="{B6E30260-5135-A66E-3D80-4EAD16D00978}"/>
                </a:ext>
              </a:extLst>
            </p:cNvPr>
            <p:cNvSpPr/>
            <p:nvPr/>
          </p:nvSpPr>
          <p:spPr>
            <a:xfrm>
              <a:off x="5737093"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5" name="pt250">
              <a:extLst>
                <a:ext uri="{FF2B5EF4-FFF2-40B4-BE49-F238E27FC236}">
                  <a16:creationId xmlns:a16="http://schemas.microsoft.com/office/drawing/2014/main" id="{26759C05-F03C-CFA3-07A9-03B32CBAC9B6}"/>
                </a:ext>
              </a:extLst>
            </p:cNvPr>
            <p:cNvSpPr/>
            <p:nvPr/>
          </p:nvSpPr>
          <p:spPr>
            <a:xfrm>
              <a:off x="5596276" y="19763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6" name="pt251">
              <a:extLst>
                <a:ext uri="{FF2B5EF4-FFF2-40B4-BE49-F238E27FC236}">
                  <a16:creationId xmlns:a16="http://schemas.microsoft.com/office/drawing/2014/main" id="{4B488187-7185-527F-16CA-6ED7985F919F}"/>
                </a:ext>
              </a:extLst>
            </p:cNvPr>
            <p:cNvSpPr/>
            <p:nvPr/>
          </p:nvSpPr>
          <p:spPr>
            <a:xfrm>
              <a:off x="5715866"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7" name="pt252">
              <a:extLst>
                <a:ext uri="{FF2B5EF4-FFF2-40B4-BE49-F238E27FC236}">
                  <a16:creationId xmlns:a16="http://schemas.microsoft.com/office/drawing/2014/main" id="{140A26F4-DB2A-B311-6240-D78ECEA9D011}"/>
                </a:ext>
              </a:extLst>
            </p:cNvPr>
            <p:cNvSpPr/>
            <p:nvPr/>
          </p:nvSpPr>
          <p:spPr>
            <a:xfrm>
              <a:off x="5683380"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8" name="pt253">
              <a:extLst>
                <a:ext uri="{FF2B5EF4-FFF2-40B4-BE49-F238E27FC236}">
                  <a16:creationId xmlns:a16="http://schemas.microsoft.com/office/drawing/2014/main" id="{85D4CFEE-B25E-BBE0-76CB-D9AC0C349919}"/>
                </a:ext>
              </a:extLst>
            </p:cNvPr>
            <p:cNvSpPr/>
            <p:nvPr/>
          </p:nvSpPr>
          <p:spPr>
            <a:xfrm>
              <a:off x="5703591" y="103015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79" name="pt254">
              <a:extLst>
                <a:ext uri="{FF2B5EF4-FFF2-40B4-BE49-F238E27FC236}">
                  <a16:creationId xmlns:a16="http://schemas.microsoft.com/office/drawing/2014/main" id="{9468BA62-4CC5-6F5B-93E9-29A3768104E0}"/>
                </a:ext>
              </a:extLst>
            </p:cNvPr>
            <p:cNvSpPr/>
            <p:nvPr/>
          </p:nvSpPr>
          <p:spPr>
            <a:xfrm>
              <a:off x="5707785" y="20759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0" name="pt255">
              <a:extLst>
                <a:ext uri="{FF2B5EF4-FFF2-40B4-BE49-F238E27FC236}">
                  <a16:creationId xmlns:a16="http://schemas.microsoft.com/office/drawing/2014/main" id="{DE60B3AF-2751-AF60-B2A1-A1C3D7BD6CDD}"/>
                </a:ext>
              </a:extLst>
            </p:cNvPr>
            <p:cNvSpPr/>
            <p:nvPr/>
          </p:nvSpPr>
          <p:spPr>
            <a:xfrm>
              <a:off x="5707996" y="21257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1" name="pt256">
              <a:extLst>
                <a:ext uri="{FF2B5EF4-FFF2-40B4-BE49-F238E27FC236}">
                  <a16:creationId xmlns:a16="http://schemas.microsoft.com/office/drawing/2014/main" id="{C592C2F8-D3E5-88C3-04AD-2812D3A339CA}"/>
                </a:ext>
              </a:extLst>
            </p:cNvPr>
            <p:cNvSpPr/>
            <p:nvPr/>
          </p:nvSpPr>
          <p:spPr>
            <a:xfrm>
              <a:off x="5715216" y="107995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2" name="pt257">
              <a:extLst>
                <a:ext uri="{FF2B5EF4-FFF2-40B4-BE49-F238E27FC236}">
                  <a16:creationId xmlns:a16="http://schemas.microsoft.com/office/drawing/2014/main" id="{581535CF-A67C-B31A-26C4-26BD59EE8F1F}"/>
                </a:ext>
              </a:extLst>
            </p:cNvPr>
            <p:cNvSpPr/>
            <p:nvPr/>
          </p:nvSpPr>
          <p:spPr>
            <a:xfrm>
              <a:off x="5555800"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3" name="pt258">
              <a:extLst>
                <a:ext uri="{FF2B5EF4-FFF2-40B4-BE49-F238E27FC236}">
                  <a16:creationId xmlns:a16="http://schemas.microsoft.com/office/drawing/2014/main" id="{1A46C45E-1F89-696D-0BB9-607035810C93}"/>
                </a:ext>
              </a:extLst>
            </p:cNvPr>
            <p:cNvSpPr/>
            <p:nvPr/>
          </p:nvSpPr>
          <p:spPr>
            <a:xfrm>
              <a:off x="5589362" y="21257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4" name="pt259">
              <a:extLst>
                <a:ext uri="{FF2B5EF4-FFF2-40B4-BE49-F238E27FC236}">
                  <a16:creationId xmlns:a16="http://schemas.microsoft.com/office/drawing/2014/main" id="{AEBCF1DD-4F30-61ED-B539-8355EC988331}"/>
                </a:ext>
              </a:extLst>
            </p:cNvPr>
            <p:cNvSpPr/>
            <p:nvPr/>
          </p:nvSpPr>
          <p:spPr>
            <a:xfrm>
              <a:off x="5545390" y="21257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5" name="pt260">
              <a:extLst>
                <a:ext uri="{FF2B5EF4-FFF2-40B4-BE49-F238E27FC236}">
                  <a16:creationId xmlns:a16="http://schemas.microsoft.com/office/drawing/2014/main" id="{C272A163-3D77-2AE0-E4E2-C458F2DC1A97}"/>
                </a:ext>
              </a:extLst>
            </p:cNvPr>
            <p:cNvSpPr/>
            <p:nvPr/>
          </p:nvSpPr>
          <p:spPr>
            <a:xfrm>
              <a:off x="5712734"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6" name="pt261">
              <a:extLst>
                <a:ext uri="{FF2B5EF4-FFF2-40B4-BE49-F238E27FC236}">
                  <a16:creationId xmlns:a16="http://schemas.microsoft.com/office/drawing/2014/main" id="{5D877355-9076-EFEA-90CD-FE80ABAA14BC}"/>
                </a:ext>
              </a:extLst>
            </p:cNvPr>
            <p:cNvSpPr/>
            <p:nvPr/>
          </p:nvSpPr>
          <p:spPr>
            <a:xfrm>
              <a:off x="5561268"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7" name="pt262">
              <a:extLst>
                <a:ext uri="{FF2B5EF4-FFF2-40B4-BE49-F238E27FC236}">
                  <a16:creationId xmlns:a16="http://schemas.microsoft.com/office/drawing/2014/main" id="{0B6733C1-47E8-F196-B647-EEAA741F43E2}"/>
                </a:ext>
              </a:extLst>
            </p:cNvPr>
            <p:cNvSpPr/>
            <p:nvPr/>
          </p:nvSpPr>
          <p:spPr>
            <a:xfrm>
              <a:off x="5550607" y="20759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8" name="pt263">
              <a:extLst>
                <a:ext uri="{FF2B5EF4-FFF2-40B4-BE49-F238E27FC236}">
                  <a16:creationId xmlns:a16="http://schemas.microsoft.com/office/drawing/2014/main" id="{578867E7-D680-FCD5-3AE1-275DB877B463}"/>
                </a:ext>
              </a:extLst>
            </p:cNvPr>
            <p:cNvSpPr/>
            <p:nvPr/>
          </p:nvSpPr>
          <p:spPr>
            <a:xfrm>
              <a:off x="5560706"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89" name="pt264">
              <a:extLst>
                <a:ext uri="{FF2B5EF4-FFF2-40B4-BE49-F238E27FC236}">
                  <a16:creationId xmlns:a16="http://schemas.microsoft.com/office/drawing/2014/main" id="{440DA964-F6AE-0293-FC6D-C45B9BFB095E}"/>
                </a:ext>
              </a:extLst>
            </p:cNvPr>
            <p:cNvSpPr/>
            <p:nvPr/>
          </p:nvSpPr>
          <p:spPr>
            <a:xfrm>
              <a:off x="5734562"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0" name="pt265">
              <a:extLst>
                <a:ext uri="{FF2B5EF4-FFF2-40B4-BE49-F238E27FC236}">
                  <a16:creationId xmlns:a16="http://schemas.microsoft.com/office/drawing/2014/main" id="{152AA309-3856-3D0E-8F72-EFF8034161C8}"/>
                </a:ext>
              </a:extLst>
            </p:cNvPr>
            <p:cNvSpPr/>
            <p:nvPr/>
          </p:nvSpPr>
          <p:spPr>
            <a:xfrm>
              <a:off x="5589518" y="197635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1" name="pt266">
              <a:extLst>
                <a:ext uri="{FF2B5EF4-FFF2-40B4-BE49-F238E27FC236}">
                  <a16:creationId xmlns:a16="http://schemas.microsoft.com/office/drawing/2014/main" id="{8A8B023E-0C50-7A5C-D623-4AD1906E0BC3}"/>
                </a:ext>
              </a:extLst>
            </p:cNvPr>
            <p:cNvSpPr/>
            <p:nvPr/>
          </p:nvSpPr>
          <p:spPr>
            <a:xfrm>
              <a:off x="5695155" y="207595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2" name="pt267">
              <a:extLst>
                <a:ext uri="{FF2B5EF4-FFF2-40B4-BE49-F238E27FC236}">
                  <a16:creationId xmlns:a16="http://schemas.microsoft.com/office/drawing/2014/main" id="{9D36B1B3-0CFC-52B6-1A15-E7DB8EA660E0}"/>
                </a:ext>
              </a:extLst>
            </p:cNvPr>
            <p:cNvSpPr/>
            <p:nvPr/>
          </p:nvSpPr>
          <p:spPr>
            <a:xfrm>
              <a:off x="5557992" y="187675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3" name="pt268">
              <a:extLst>
                <a:ext uri="{FF2B5EF4-FFF2-40B4-BE49-F238E27FC236}">
                  <a16:creationId xmlns:a16="http://schemas.microsoft.com/office/drawing/2014/main" id="{26B1556D-46FD-E4EB-F136-4AE5BAF02F44}"/>
                </a:ext>
              </a:extLst>
            </p:cNvPr>
            <p:cNvSpPr/>
            <p:nvPr/>
          </p:nvSpPr>
          <p:spPr>
            <a:xfrm>
              <a:off x="5575882"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4" name="pt269">
              <a:extLst>
                <a:ext uri="{FF2B5EF4-FFF2-40B4-BE49-F238E27FC236}">
                  <a16:creationId xmlns:a16="http://schemas.microsoft.com/office/drawing/2014/main" id="{A750C5C3-3C31-3F48-A0EC-76362A8812FE}"/>
                </a:ext>
              </a:extLst>
            </p:cNvPr>
            <p:cNvSpPr/>
            <p:nvPr/>
          </p:nvSpPr>
          <p:spPr>
            <a:xfrm>
              <a:off x="5579334"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5" name="pt270">
              <a:extLst>
                <a:ext uri="{FF2B5EF4-FFF2-40B4-BE49-F238E27FC236}">
                  <a16:creationId xmlns:a16="http://schemas.microsoft.com/office/drawing/2014/main" id="{B46C8322-816F-5598-07D4-F80859E5730A}"/>
                </a:ext>
              </a:extLst>
            </p:cNvPr>
            <p:cNvSpPr/>
            <p:nvPr/>
          </p:nvSpPr>
          <p:spPr>
            <a:xfrm>
              <a:off x="5696943" y="21257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6" name="pt271">
              <a:extLst>
                <a:ext uri="{FF2B5EF4-FFF2-40B4-BE49-F238E27FC236}">
                  <a16:creationId xmlns:a16="http://schemas.microsoft.com/office/drawing/2014/main" id="{3D36CE64-B263-20F3-13F2-3B78FB6A0945}"/>
                </a:ext>
              </a:extLst>
            </p:cNvPr>
            <p:cNvSpPr/>
            <p:nvPr/>
          </p:nvSpPr>
          <p:spPr>
            <a:xfrm>
              <a:off x="5682322" y="21257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7" name="pt272">
              <a:extLst>
                <a:ext uri="{FF2B5EF4-FFF2-40B4-BE49-F238E27FC236}">
                  <a16:creationId xmlns:a16="http://schemas.microsoft.com/office/drawing/2014/main" id="{247D421F-5F8E-0FEA-3B80-BB05416CFDA2}"/>
                </a:ext>
              </a:extLst>
            </p:cNvPr>
            <p:cNvSpPr/>
            <p:nvPr/>
          </p:nvSpPr>
          <p:spPr>
            <a:xfrm>
              <a:off x="5724449"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8" name="pt273">
              <a:extLst>
                <a:ext uri="{FF2B5EF4-FFF2-40B4-BE49-F238E27FC236}">
                  <a16:creationId xmlns:a16="http://schemas.microsoft.com/office/drawing/2014/main" id="{FA3A430E-BD1F-A2ED-141B-0DED07188813}"/>
                </a:ext>
              </a:extLst>
            </p:cNvPr>
            <p:cNvSpPr/>
            <p:nvPr/>
          </p:nvSpPr>
          <p:spPr>
            <a:xfrm>
              <a:off x="5590761"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399" name="pt274">
              <a:extLst>
                <a:ext uri="{FF2B5EF4-FFF2-40B4-BE49-F238E27FC236}">
                  <a16:creationId xmlns:a16="http://schemas.microsoft.com/office/drawing/2014/main" id="{3AAE01CF-A592-3CAE-9923-5939DA794B6C}"/>
                </a:ext>
              </a:extLst>
            </p:cNvPr>
            <p:cNvSpPr/>
            <p:nvPr/>
          </p:nvSpPr>
          <p:spPr>
            <a:xfrm>
              <a:off x="5579163"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0" name="pt275">
              <a:extLst>
                <a:ext uri="{FF2B5EF4-FFF2-40B4-BE49-F238E27FC236}">
                  <a16:creationId xmlns:a16="http://schemas.microsoft.com/office/drawing/2014/main" id="{339B175A-5375-33EA-B37B-9B70AFC86C24}"/>
                </a:ext>
              </a:extLst>
            </p:cNvPr>
            <p:cNvSpPr/>
            <p:nvPr/>
          </p:nvSpPr>
          <p:spPr>
            <a:xfrm>
              <a:off x="5595441"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1" name="pt276">
              <a:extLst>
                <a:ext uri="{FF2B5EF4-FFF2-40B4-BE49-F238E27FC236}">
                  <a16:creationId xmlns:a16="http://schemas.microsoft.com/office/drawing/2014/main" id="{CFFE149B-7D20-4B6A-225F-D819F95F1357}"/>
                </a:ext>
              </a:extLst>
            </p:cNvPr>
            <p:cNvSpPr/>
            <p:nvPr/>
          </p:nvSpPr>
          <p:spPr>
            <a:xfrm>
              <a:off x="5703894"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2" name="pt277">
              <a:extLst>
                <a:ext uri="{FF2B5EF4-FFF2-40B4-BE49-F238E27FC236}">
                  <a16:creationId xmlns:a16="http://schemas.microsoft.com/office/drawing/2014/main" id="{92FAD7A9-3CAF-E8D2-59F5-623038A351B0}"/>
                </a:ext>
              </a:extLst>
            </p:cNvPr>
            <p:cNvSpPr/>
            <p:nvPr/>
          </p:nvSpPr>
          <p:spPr>
            <a:xfrm>
              <a:off x="5687214"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3" name="pt278">
              <a:extLst>
                <a:ext uri="{FF2B5EF4-FFF2-40B4-BE49-F238E27FC236}">
                  <a16:creationId xmlns:a16="http://schemas.microsoft.com/office/drawing/2014/main" id="{B8C0A0AA-5FD3-EA8B-12A0-95F5AF63AFDA}"/>
                </a:ext>
              </a:extLst>
            </p:cNvPr>
            <p:cNvSpPr/>
            <p:nvPr/>
          </p:nvSpPr>
          <p:spPr>
            <a:xfrm>
              <a:off x="5580349" y="21257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4" name="pt279">
              <a:extLst>
                <a:ext uri="{FF2B5EF4-FFF2-40B4-BE49-F238E27FC236}">
                  <a16:creationId xmlns:a16="http://schemas.microsoft.com/office/drawing/2014/main" id="{7FAA7539-2275-AF12-1BD8-81C4EBBD50CE}"/>
                </a:ext>
              </a:extLst>
            </p:cNvPr>
            <p:cNvSpPr/>
            <p:nvPr/>
          </p:nvSpPr>
          <p:spPr>
            <a:xfrm>
              <a:off x="5577373" y="217555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5" name="pt280">
              <a:extLst>
                <a:ext uri="{FF2B5EF4-FFF2-40B4-BE49-F238E27FC236}">
                  <a16:creationId xmlns:a16="http://schemas.microsoft.com/office/drawing/2014/main" id="{6C740BCF-BF82-68A8-7DA2-812FB19A5941}"/>
                </a:ext>
              </a:extLst>
            </p:cNvPr>
            <p:cNvSpPr/>
            <p:nvPr/>
          </p:nvSpPr>
          <p:spPr>
            <a:xfrm>
              <a:off x="5714978" y="217555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6" name="pt281">
              <a:extLst>
                <a:ext uri="{FF2B5EF4-FFF2-40B4-BE49-F238E27FC236}">
                  <a16:creationId xmlns:a16="http://schemas.microsoft.com/office/drawing/2014/main" id="{39757A1A-7748-4046-B21E-1D5F5C6D35A5}"/>
                </a:ext>
              </a:extLst>
            </p:cNvPr>
            <p:cNvSpPr/>
            <p:nvPr/>
          </p:nvSpPr>
          <p:spPr>
            <a:xfrm>
              <a:off x="5966767" y="21770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7" name="pt282">
              <a:extLst>
                <a:ext uri="{FF2B5EF4-FFF2-40B4-BE49-F238E27FC236}">
                  <a16:creationId xmlns:a16="http://schemas.microsoft.com/office/drawing/2014/main" id="{F81933C0-6F18-12C2-7F66-9B6CAD9F6256}"/>
                </a:ext>
              </a:extLst>
            </p:cNvPr>
            <p:cNvSpPr/>
            <p:nvPr/>
          </p:nvSpPr>
          <p:spPr>
            <a:xfrm>
              <a:off x="6116584" y="203621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8" name="pt283">
              <a:extLst>
                <a:ext uri="{FF2B5EF4-FFF2-40B4-BE49-F238E27FC236}">
                  <a16:creationId xmlns:a16="http://schemas.microsoft.com/office/drawing/2014/main" id="{3078445B-8E67-DFDC-7F83-664216DA4BA1}"/>
                </a:ext>
              </a:extLst>
            </p:cNvPr>
            <p:cNvSpPr/>
            <p:nvPr/>
          </p:nvSpPr>
          <p:spPr>
            <a:xfrm>
              <a:off x="5957630" y="213795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09" name="pt284">
              <a:extLst>
                <a:ext uri="{FF2B5EF4-FFF2-40B4-BE49-F238E27FC236}">
                  <a16:creationId xmlns:a16="http://schemas.microsoft.com/office/drawing/2014/main" id="{8A932BAB-5E2D-B620-57C6-E6097DD9415A}"/>
                </a:ext>
              </a:extLst>
            </p:cNvPr>
            <p:cNvSpPr/>
            <p:nvPr/>
          </p:nvSpPr>
          <p:spPr>
            <a:xfrm>
              <a:off x="5949080" y="196577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0" name="pt285">
              <a:extLst>
                <a:ext uri="{FF2B5EF4-FFF2-40B4-BE49-F238E27FC236}">
                  <a16:creationId xmlns:a16="http://schemas.microsoft.com/office/drawing/2014/main" id="{B0831C7D-9E00-C591-C4B1-0A009A5BD6A0}"/>
                </a:ext>
              </a:extLst>
            </p:cNvPr>
            <p:cNvSpPr/>
            <p:nvPr/>
          </p:nvSpPr>
          <p:spPr>
            <a:xfrm>
              <a:off x="5984437" y="208082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1" name="pt286">
              <a:extLst>
                <a:ext uri="{FF2B5EF4-FFF2-40B4-BE49-F238E27FC236}">
                  <a16:creationId xmlns:a16="http://schemas.microsoft.com/office/drawing/2014/main" id="{03B0C1AE-12ED-1FEA-F5FB-A09B191D4F31}"/>
                </a:ext>
              </a:extLst>
            </p:cNvPr>
            <p:cNvSpPr/>
            <p:nvPr/>
          </p:nvSpPr>
          <p:spPr>
            <a:xfrm>
              <a:off x="5943078" y="216925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2" name="pt287">
              <a:extLst>
                <a:ext uri="{FF2B5EF4-FFF2-40B4-BE49-F238E27FC236}">
                  <a16:creationId xmlns:a16="http://schemas.microsoft.com/office/drawing/2014/main" id="{5491792B-072F-D4F3-5B36-F3F76A7F0C67}"/>
                </a:ext>
              </a:extLst>
            </p:cNvPr>
            <p:cNvSpPr/>
            <p:nvPr/>
          </p:nvSpPr>
          <p:spPr>
            <a:xfrm>
              <a:off x="5939254" y="205968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3" name="pt288">
              <a:extLst>
                <a:ext uri="{FF2B5EF4-FFF2-40B4-BE49-F238E27FC236}">
                  <a16:creationId xmlns:a16="http://schemas.microsoft.com/office/drawing/2014/main" id="{7508D037-FA39-AB05-CBF4-5CD08CBAAE20}"/>
                </a:ext>
              </a:extLst>
            </p:cNvPr>
            <p:cNvSpPr/>
            <p:nvPr/>
          </p:nvSpPr>
          <p:spPr>
            <a:xfrm>
              <a:off x="5961409" y="215360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4" name="pt289">
              <a:extLst>
                <a:ext uri="{FF2B5EF4-FFF2-40B4-BE49-F238E27FC236}">
                  <a16:creationId xmlns:a16="http://schemas.microsoft.com/office/drawing/2014/main" id="{7D27C47D-CD9F-3088-5D2F-805F479F6700}"/>
                </a:ext>
              </a:extLst>
            </p:cNvPr>
            <p:cNvSpPr/>
            <p:nvPr/>
          </p:nvSpPr>
          <p:spPr>
            <a:xfrm>
              <a:off x="5958542" y="210664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5" name="pt290">
              <a:extLst>
                <a:ext uri="{FF2B5EF4-FFF2-40B4-BE49-F238E27FC236}">
                  <a16:creationId xmlns:a16="http://schemas.microsoft.com/office/drawing/2014/main" id="{72D51C86-608F-826E-9F13-FC6C1E019DD4}"/>
                </a:ext>
              </a:extLst>
            </p:cNvPr>
            <p:cNvSpPr/>
            <p:nvPr/>
          </p:nvSpPr>
          <p:spPr>
            <a:xfrm>
              <a:off x="5950427" y="21770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6" name="pt291">
              <a:extLst>
                <a:ext uri="{FF2B5EF4-FFF2-40B4-BE49-F238E27FC236}">
                  <a16:creationId xmlns:a16="http://schemas.microsoft.com/office/drawing/2014/main" id="{F9203313-B0B3-05EC-350A-673BC5804CBE}"/>
                </a:ext>
              </a:extLst>
            </p:cNvPr>
            <p:cNvSpPr/>
            <p:nvPr/>
          </p:nvSpPr>
          <p:spPr>
            <a:xfrm>
              <a:off x="6089039" y="215438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7" name="pt292">
              <a:extLst>
                <a:ext uri="{FF2B5EF4-FFF2-40B4-BE49-F238E27FC236}">
                  <a16:creationId xmlns:a16="http://schemas.microsoft.com/office/drawing/2014/main" id="{0170B8A1-D875-843C-2BF3-6329CE4EB66A}"/>
                </a:ext>
              </a:extLst>
            </p:cNvPr>
            <p:cNvSpPr/>
            <p:nvPr/>
          </p:nvSpPr>
          <p:spPr>
            <a:xfrm>
              <a:off x="6127402" y="212801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8" name="pt293">
              <a:extLst>
                <a:ext uri="{FF2B5EF4-FFF2-40B4-BE49-F238E27FC236}">
                  <a16:creationId xmlns:a16="http://schemas.microsoft.com/office/drawing/2014/main" id="{4F6CA6BE-A8A8-B688-82B2-F086AF12288A}"/>
                </a:ext>
              </a:extLst>
            </p:cNvPr>
            <p:cNvSpPr/>
            <p:nvPr/>
          </p:nvSpPr>
          <p:spPr>
            <a:xfrm>
              <a:off x="6121997" y="216925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19" name="pt294">
              <a:extLst>
                <a:ext uri="{FF2B5EF4-FFF2-40B4-BE49-F238E27FC236}">
                  <a16:creationId xmlns:a16="http://schemas.microsoft.com/office/drawing/2014/main" id="{431FE1A6-4384-5E70-9840-E577691437DA}"/>
                </a:ext>
              </a:extLst>
            </p:cNvPr>
            <p:cNvSpPr/>
            <p:nvPr/>
          </p:nvSpPr>
          <p:spPr>
            <a:xfrm>
              <a:off x="5976799" y="213795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0" name="pt295">
              <a:extLst>
                <a:ext uri="{FF2B5EF4-FFF2-40B4-BE49-F238E27FC236}">
                  <a16:creationId xmlns:a16="http://schemas.microsoft.com/office/drawing/2014/main" id="{8A77A903-2D98-C86E-EA02-9E917EBBA5B5}"/>
                </a:ext>
              </a:extLst>
            </p:cNvPr>
            <p:cNvSpPr/>
            <p:nvPr/>
          </p:nvSpPr>
          <p:spPr>
            <a:xfrm>
              <a:off x="5964543" y="209882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1" name="pt296">
              <a:extLst>
                <a:ext uri="{FF2B5EF4-FFF2-40B4-BE49-F238E27FC236}">
                  <a16:creationId xmlns:a16="http://schemas.microsoft.com/office/drawing/2014/main" id="{0F1941AD-AF0E-921D-C956-0F301385C208}"/>
                </a:ext>
              </a:extLst>
            </p:cNvPr>
            <p:cNvSpPr/>
            <p:nvPr/>
          </p:nvSpPr>
          <p:spPr>
            <a:xfrm>
              <a:off x="5991349" y="207612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2" name="pt297">
              <a:extLst>
                <a:ext uri="{FF2B5EF4-FFF2-40B4-BE49-F238E27FC236}">
                  <a16:creationId xmlns:a16="http://schemas.microsoft.com/office/drawing/2014/main" id="{3EA0610F-79D4-132B-463E-26048D4A0BDA}"/>
                </a:ext>
              </a:extLst>
            </p:cNvPr>
            <p:cNvSpPr/>
            <p:nvPr/>
          </p:nvSpPr>
          <p:spPr>
            <a:xfrm>
              <a:off x="5948265" y="21770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3" name="pt298">
              <a:extLst>
                <a:ext uri="{FF2B5EF4-FFF2-40B4-BE49-F238E27FC236}">
                  <a16:creationId xmlns:a16="http://schemas.microsoft.com/office/drawing/2014/main" id="{9BCC82BC-2284-35BF-72F2-E1DB3666C511}"/>
                </a:ext>
              </a:extLst>
            </p:cNvPr>
            <p:cNvSpPr/>
            <p:nvPr/>
          </p:nvSpPr>
          <p:spPr>
            <a:xfrm>
              <a:off x="5950672" y="183273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4" name="pt299">
              <a:extLst>
                <a:ext uri="{FF2B5EF4-FFF2-40B4-BE49-F238E27FC236}">
                  <a16:creationId xmlns:a16="http://schemas.microsoft.com/office/drawing/2014/main" id="{226E5097-8451-8C48-FDF7-BA4A0C4F32B8}"/>
                </a:ext>
              </a:extLst>
            </p:cNvPr>
            <p:cNvSpPr/>
            <p:nvPr/>
          </p:nvSpPr>
          <p:spPr>
            <a:xfrm>
              <a:off x="5991530" y="209882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5" name="pt300">
              <a:extLst>
                <a:ext uri="{FF2B5EF4-FFF2-40B4-BE49-F238E27FC236}">
                  <a16:creationId xmlns:a16="http://schemas.microsoft.com/office/drawing/2014/main" id="{C96F6AC3-5BD1-2254-7E6F-A5F149EF5BD2}"/>
                </a:ext>
              </a:extLst>
            </p:cNvPr>
            <p:cNvSpPr/>
            <p:nvPr/>
          </p:nvSpPr>
          <p:spPr>
            <a:xfrm>
              <a:off x="6109597" y="197360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6" name="pt301">
              <a:extLst>
                <a:ext uri="{FF2B5EF4-FFF2-40B4-BE49-F238E27FC236}">
                  <a16:creationId xmlns:a16="http://schemas.microsoft.com/office/drawing/2014/main" id="{AE3DE5CA-FADF-3310-39BF-F56C0AEBEC0D}"/>
                </a:ext>
              </a:extLst>
            </p:cNvPr>
            <p:cNvSpPr/>
            <p:nvPr/>
          </p:nvSpPr>
          <p:spPr>
            <a:xfrm>
              <a:off x="6091958" y="219273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7" name="pt302">
              <a:extLst>
                <a:ext uri="{FF2B5EF4-FFF2-40B4-BE49-F238E27FC236}">
                  <a16:creationId xmlns:a16="http://schemas.microsoft.com/office/drawing/2014/main" id="{A725C203-945A-6EF3-698D-90A4D38C3B66}"/>
                </a:ext>
              </a:extLst>
            </p:cNvPr>
            <p:cNvSpPr/>
            <p:nvPr/>
          </p:nvSpPr>
          <p:spPr>
            <a:xfrm>
              <a:off x="5973977" y="209882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8" name="pt303">
              <a:extLst>
                <a:ext uri="{FF2B5EF4-FFF2-40B4-BE49-F238E27FC236}">
                  <a16:creationId xmlns:a16="http://schemas.microsoft.com/office/drawing/2014/main" id="{1FF93086-8002-4EA9-8ACA-B819466A6CDD}"/>
                </a:ext>
              </a:extLst>
            </p:cNvPr>
            <p:cNvSpPr/>
            <p:nvPr/>
          </p:nvSpPr>
          <p:spPr>
            <a:xfrm>
              <a:off x="5990666" y="214577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29" name="pt304">
              <a:extLst>
                <a:ext uri="{FF2B5EF4-FFF2-40B4-BE49-F238E27FC236}">
                  <a16:creationId xmlns:a16="http://schemas.microsoft.com/office/drawing/2014/main" id="{8B54033C-4557-89BE-8CF5-B12ABAF88702}"/>
                </a:ext>
              </a:extLst>
            </p:cNvPr>
            <p:cNvSpPr/>
            <p:nvPr/>
          </p:nvSpPr>
          <p:spPr>
            <a:xfrm>
              <a:off x="6083280" y="215360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0" name="pt305">
              <a:extLst>
                <a:ext uri="{FF2B5EF4-FFF2-40B4-BE49-F238E27FC236}">
                  <a16:creationId xmlns:a16="http://schemas.microsoft.com/office/drawing/2014/main" id="{02C50AA2-CC99-71B4-E307-69411AE80876}"/>
                </a:ext>
              </a:extLst>
            </p:cNvPr>
            <p:cNvSpPr/>
            <p:nvPr/>
          </p:nvSpPr>
          <p:spPr>
            <a:xfrm>
              <a:off x="5944534" y="195012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1" name="pt306">
              <a:extLst>
                <a:ext uri="{FF2B5EF4-FFF2-40B4-BE49-F238E27FC236}">
                  <a16:creationId xmlns:a16="http://schemas.microsoft.com/office/drawing/2014/main" id="{FC44F2BC-178A-60C7-3F73-44F5F85E6223}"/>
                </a:ext>
              </a:extLst>
            </p:cNvPr>
            <p:cNvSpPr/>
            <p:nvPr/>
          </p:nvSpPr>
          <p:spPr>
            <a:xfrm>
              <a:off x="6122260" y="212229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2" name="pt307">
              <a:extLst>
                <a:ext uri="{FF2B5EF4-FFF2-40B4-BE49-F238E27FC236}">
                  <a16:creationId xmlns:a16="http://schemas.microsoft.com/office/drawing/2014/main" id="{23DEFC08-99C9-7382-2C4C-EE5A0A1C2794}"/>
                </a:ext>
              </a:extLst>
            </p:cNvPr>
            <p:cNvSpPr/>
            <p:nvPr/>
          </p:nvSpPr>
          <p:spPr>
            <a:xfrm>
              <a:off x="6094362" y="218490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3" name="pt308">
              <a:extLst>
                <a:ext uri="{FF2B5EF4-FFF2-40B4-BE49-F238E27FC236}">
                  <a16:creationId xmlns:a16="http://schemas.microsoft.com/office/drawing/2014/main" id="{4DFA560C-5945-C04D-1299-01146C7A4BAB}"/>
                </a:ext>
              </a:extLst>
            </p:cNvPr>
            <p:cNvSpPr/>
            <p:nvPr/>
          </p:nvSpPr>
          <p:spPr>
            <a:xfrm>
              <a:off x="5935283" y="191099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4" name="pt309">
              <a:extLst>
                <a:ext uri="{FF2B5EF4-FFF2-40B4-BE49-F238E27FC236}">
                  <a16:creationId xmlns:a16="http://schemas.microsoft.com/office/drawing/2014/main" id="{8DC195DF-AEE7-528E-0981-A5D0E09A2749}"/>
                </a:ext>
              </a:extLst>
            </p:cNvPr>
            <p:cNvSpPr/>
            <p:nvPr/>
          </p:nvSpPr>
          <p:spPr>
            <a:xfrm>
              <a:off x="5936883" y="218490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5" name="pt310">
              <a:extLst>
                <a:ext uri="{FF2B5EF4-FFF2-40B4-BE49-F238E27FC236}">
                  <a16:creationId xmlns:a16="http://schemas.microsoft.com/office/drawing/2014/main" id="{14A21184-099F-A900-D3C8-A0881BD0C453}"/>
                </a:ext>
              </a:extLst>
            </p:cNvPr>
            <p:cNvSpPr/>
            <p:nvPr/>
          </p:nvSpPr>
          <p:spPr>
            <a:xfrm>
              <a:off x="5936478" y="211447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6" name="pt311">
              <a:extLst>
                <a:ext uri="{FF2B5EF4-FFF2-40B4-BE49-F238E27FC236}">
                  <a16:creationId xmlns:a16="http://schemas.microsoft.com/office/drawing/2014/main" id="{D99521BB-BF3C-A703-B122-EC941FB8348F}"/>
                </a:ext>
              </a:extLst>
            </p:cNvPr>
            <p:cNvSpPr/>
            <p:nvPr/>
          </p:nvSpPr>
          <p:spPr>
            <a:xfrm>
              <a:off x="5976325" y="216925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7" name="pt312">
              <a:extLst>
                <a:ext uri="{FF2B5EF4-FFF2-40B4-BE49-F238E27FC236}">
                  <a16:creationId xmlns:a16="http://schemas.microsoft.com/office/drawing/2014/main" id="{9EC49860-D800-36DB-E0CC-776F331CE514}"/>
                </a:ext>
              </a:extLst>
            </p:cNvPr>
            <p:cNvSpPr/>
            <p:nvPr/>
          </p:nvSpPr>
          <p:spPr>
            <a:xfrm>
              <a:off x="5939744" y="209882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8" name="pt313">
              <a:extLst>
                <a:ext uri="{FF2B5EF4-FFF2-40B4-BE49-F238E27FC236}">
                  <a16:creationId xmlns:a16="http://schemas.microsoft.com/office/drawing/2014/main" id="{7C68DF27-A971-50E5-F0AD-3B4DD306FB0B}"/>
                </a:ext>
              </a:extLst>
            </p:cNvPr>
            <p:cNvSpPr/>
            <p:nvPr/>
          </p:nvSpPr>
          <p:spPr>
            <a:xfrm>
              <a:off x="5954512" y="219273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39" name="pt314">
              <a:extLst>
                <a:ext uri="{FF2B5EF4-FFF2-40B4-BE49-F238E27FC236}">
                  <a16:creationId xmlns:a16="http://schemas.microsoft.com/office/drawing/2014/main" id="{8523D178-47C8-F185-C120-1B735CE38BD2}"/>
                </a:ext>
              </a:extLst>
            </p:cNvPr>
            <p:cNvSpPr/>
            <p:nvPr/>
          </p:nvSpPr>
          <p:spPr>
            <a:xfrm>
              <a:off x="5984683" y="21644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0" name="pt315">
              <a:extLst>
                <a:ext uri="{FF2B5EF4-FFF2-40B4-BE49-F238E27FC236}">
                  <a16:creationId xmlns:a16="http://schemas.microsoft.com/office/drawing/2014/main" id="{329DC8F6-02AC-3B85-9225-582DA3791FCD}"/>
                </a:ext>
              </a:extLst>
            </p:cNvPr>
            <p:cNvSpPr/>
            <p:nvPr/>
          </p:nvSpPr>
          <p:spPr>
            <a:xfrm>
              <a:off x="6103698" y="205421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1" name="pt316">
              <a:extLst>
                <a:ext uri="{FF2B5EF4-FFF2-40B4-BE49-F238E27FC236}">
                  <a16:creationId xmlns:a16="http://schemas.microsoft.com/office/drawing/2014/main" id="{B9F92C9A-EFAB-4A86-C8C8-048AA57F7859}"/>
                </a:ext>
              </a:extLst>
            </p:cNvPr>
            <p:cNvSpPr/>
            <p:nvPr/>
          </p:nvSpPr>
          <p:spPr>
            <a:xfrm>
              <a:off x="6120037" y="159794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2" name="pt317">
              <a:extLst>
                <a:ext uri="{FF2B5EF4-FFF2-40B4-BE49-F238E27FC236}">
                  <a16:creationId xmlns:a16="http://schemas.microsoft.com/office/drawing/2014/main" id="{BDD3DCFE-BB5A-554A-C0DD-D52D0A193F71}"/>
                </a:ext>
              </a:extLst>
            </p:cNvPr>
            <p:cNvSpPr/>
            <p:nvPr/>
          </p:nvSpPr>
          <p:spPr>
            <a:xfrm>
              <a:off x="5966329" y="21770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3" name="pt318">
              <a:extLst>
                <a:ext uri="{FF2B5EF4-FFF2-40B4-BE49-F238E27FC236}">
                  <a16:creationId xmlns:a16="http://schemas.microsoft.com/office/drawing/2014/main" id="{EF6D5592-909E-4B13-75D7-9EDFF225A098}"/>
                </a:ext>
              </a:extLst>
            </p:cNvPr>
            <p:cNvSpPr/>
            <p:nvPr/>
          </p:nvSpPr>
          <p:spPr>
            <a:xfrm>
              <a:off x="6107750" y="181081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4" name="pt319">
              <a:extLst>
                <a:ext uri="{FF2B5EF4-FFF2-40B4-BE49-F238E27FC236}">
                  <a16:creationId xmlns:a16="http://schemas.microsoft.com/office/drawing/2014/main" id="{AE4A2ACF-3BB8-5CF6-310B-C3D7A25DC662}"/>
                </a:ext>
              </a:extLst>
            </p:cNvPr>
            <p:cNvSpPr/>
            <p:nvPr/>
          </p:nvSpPr>
          <p:spPr>
            <a:xfrm>
              <a:off x="6104089" y="213012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5" name="pt320">
              <a:extLst>
                <a:ext uri="{FF2B5EF4-FFF2-40B4-BE49-F238E27FC236}">
                  <a16:creationId xmlns:a16="http://schemas.microsoft.com/office/drawing/2014/main" id="{3C1CE65C-F439-C991-19F9-8C48024016D0}"/>
                </a:ext>
              </a:extLst>
            </p:cNvPr>
            <p:cNvSpPr/>
            <p:nvPr/>
          </p:nvSpPr>
          <p:spPr>
            <a:xfrm>
              <a:off x="6111525" y="215360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6" name="pt321">
              <a:extLst>
                <a:ext uri="{FF2B5EF4-FFF2-40B4-BE49-F238E27FC236}">
                  <a16:creationId xmlns:a16="http://schemas.microsoft.com/office/drawing/2014/main" id="{ADFFF5F3-6E8A-2F62-0D10-197C163DCF79}"/>
                </a:ext>
              </a:extLst>
            </p:cNvPr>
            <p:cNvSpPr/>
            <p:nvPr/>
          </p:nvSpPr>
          <p:spPr>
            <a:xfrm>
              <a:off x="5971219" y="214577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7" name="pt322">
              <a:extLst>
                <a:ext uri="{FF2B5EF4-FFF2-40B4-BE49-F238E27FC236}">
                  <a16:creationId xmlns:a16="http://schemas.microsoft.com/office/drawing/2014/main" id="{6D05A2CA-DB8D-0D39-F1A8-0614D40483D5}"/>
                </a:ext>
              </a:extLst>
            </p:cNvPr>
            <p:cNvSpPr/>
            <p:nvPr/>
          </p:nvSpPr>
          <p:spPr>
            <a:xfrm>
              <a:off x="6075851" y="198925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8" name="pt323">
              <a:extLst>
                <a:ext uri="{FF2B5EF4-FFF2-40B4-BE49-F238E27FC236}">
                  <a16:creationId xmlns:a16="http://schemas.microsoft.com/office/drawing/2014/main" id="{8B09ECA2-7D03-04E1-B6B8-F5B296F13DAD}"/>
                </a:ext>
              </a:extLst>
            </p:cNvPr>
            <p:cNvSpPr/>
            <p:nvPr/>
          </p:nvSpPr>
          <p:spPr>
            <a:xfrm>
              <a:off x="5956535" y="213012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49" name="pt324">
              <a:extLst>
                <a:ext uri="{FF2B5EF4-FFF2-40B4-BE49-F238E27FC236}">
                  <a16:creationId xmlns:a16="http://schemas.microsoft.com/office/drawing/2014/main" id="{ED9F9D3C-1C01-0370-53BB-292130388E7C}"/>
                </a:ext>
              </a:extLst>
            </p:cNvPr>
            <p:cNvSpPr/>
            <p:nvPr/>
          </p:nvSpPr>
          <p:spPr>
            <a:xfrm>
              <a:off x="6119415" y="214577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0" name="pt325">
              <a:extLst>
                <a:ext uri="{FF2B5EF4-FFF2-40B4-BE49-F238E27FC236}">
                  <a16:creationId xmlns:a16="http://schemas.microsoft.com/office/drawing/2014/main" id="{E9EC3EDE-9438-8C97-97F7-DAB866ECD138}"/>
                </a:ext>
              </a:extLst>
            </p:cNvPr>
            <p:cNvSpPr/>
            <p:nvPr/>
          </p:nvSpPr>
          <p:spPr>
            <a:xfrm>
              <a:off x="6073620" y="216925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1" name="pt326">
              <a:extLst>
                <a:ext uri="{FF2B5EF4-FFF2-40B4-BE49-F238E27FC236}">
                  <a16:creationId xmlns:a16="http://schemas.microsoft.com/office/drawing/2014/main" id="{0EF715F9-55A3-8656-978C-88DA1EA9B495}"/>
                </a:ext>
              </a:extLst>
            </p:cNvPr>
            <p:cNvSpPr/>
            <p:nvPr/>
          </p:nvSpPr>
          <p:spPr>
            <a:xfrm>
              <a:off x="6096020" y="112054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2" name="pt327">
              <a:extLst>
                <a:ext uri="{FF2B5EF4-FFF2-40B4-BE49-F238E27FC236}">
                  <a16:creationId xmlns:a16="http://schemas.microsoft.com/office/drawing/2014/main" id="{F60FD642-9AD3-3F35-ACC9-53A1D7F43EAA}"/>
                </a:ext>
              </a:extLst>
            </p:cNvPr>
            <p:cNvSpPr/>
            <p:nvPr/>
          </p:nvSpPr>
          <p:spPr>
            <a:xfrm>
              <a:off x="6113507" y="216925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3" name="pt328">
              <a:extLst>
                <a:ext uri="{FF2B5EF4-FFF2-40B4-BE49-F238E27FC236}">
                  <a16:creationId xmlns:a16="http://schemas.microsoft.com/office/drawing/2014/main" id="{7EE457B5-253C-747B-6507-AD3716A3E63A}"/>
                </a:ext>
              </a:extLst>
            </p:cNvPr>
            <p:cNvSpPr/>
            <p:nvPr/>
          </p:nvSpPr>
          <p:spPr>
            <a:xfrm>
              <a:off x="6115558" y="219242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4" name="pt329">
              <a:extLst>
                <a:ext uri="{FF2B5EF4-FFF2-40B4-BE49-F238E27FC236}">
                  <a16:creationId xmlns:a16="http://schemas.microsoft.com/office/drawing/2014/main" id="{7F263D32-E50C-31F1-83A7-EBEAEA75E5B4}"/>
                </a:ext>
              </a:extLst>
            </p:cNvPr>
            <p:cNvSpPr/>
            <p:nvPr/>
          </p:nvSpPr>
          <p:spPr>
            <a:xfrm>
              <a:off x="6081152" y="115185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5" name="pt330">
              <a:extLst>
                <a:ext uri="{FF2B5EF4-FFF2-40B4-BE49-F238E27FC236}">
                  <a16:creationId xmlns:a16="http://schemas.microsoft.com/office/drawing/2014/main" id="{FB1E9DBF-0B67-21AD-C97D-BE45DE3671D1}"/>
                </a:ext>
              </a:extLst>
            </p:cNvPr>
            <p:cNvSpPr/>
            <p:nvPr/>
          </p:nvSpPr>
          <p:spPr>
            <a:xfrm>
              <a:off x="5949435" y="217042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6" name="pt331">
              <a:extLst>
                <a:ext uri="{FF2B5EF4-FFF2-40B4-BE49-F238E27FC236}">
                  <a16:creationId xmlns:a16="http://schemas.microsoft.com/office/drawing/2014/main" id="{70468D93-E9C5-633F-7BCB-3E45D65ADDF5}"/>
                </a:ext>
              </a:extLst>
            </p:cNvPr>
            <p:cNvSpPr/>
            <p:nvPr/>
          </p:nvSpPr>
          <p:spPr>
            <a:xfrm>
              <a:off x="5944472" y="215039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7" name="pt332">
              <a:extLst>
                <a:ext uri="{FF2B5EF4-FFF2-40B4-BE49-F238E27FC236}">
                  <a16:creationId xmlns:a16="http://schemas.microsoft.com/office/drawing/2014/main" id="{F0A1F231-8330-DE33-E65D-8E4E97477B02}"/>
                </a:ext>
              </a:extLst>
            </p:cNvPr>
            <p:cNvSpPr/>
            <p:nvPr/>
          </p:nvSpPr>
          <p:spPr>
            <a:xfrm>
              <a:off x="5991727" y="215360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8" name="pt333">
              <a:extLst>
                <a:ext uri="{FF2B5EF4-FFF2-40B4-BE49-F238E27FC236}">
                  <a16:creationId xmlns:a16="http://schemas.microsoft.com/office/drawing/2014/main" id="{364CF960-B4D7-1454-104E-153320A205FE}"/>
                </a:ext>
              </a:extLst>
            </p:cNvPr>
            <p:cNvSpPr/>
            <p:nvPr/>
          </p:nvSpPr>
          <p:spPr>
            <a:xfrm>
              <a:off x="6092197" y="217708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59" name="pt334">
              <a:extLst>
                <a:ext uri="{FF2B5EF4-FFF2-40B4-BE49-F238E27FC236}">
                  <a16:creationId xmlns:a16="http://schemas.microsoft.com/office/drawing/2014/main" id="{23D96A84-02F5-7101-583E-0E5FB00B7D17}"/>
                </a:ext>
              </a:extLst>
            </p:cNvPr>
            <p:cNvSpPr/>
            <p:nvPr/>
          </p:nvSpPr>
          <p:spPr>
            <a:xfrm>
              <a:off x="5950544" y="218490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0" name="pt335">
              <a:extLst>
                <a:ext uri="{FF2B5EF4-FFF2-40B4-BE49-F238E27FC236}">
                  <a16:creationId xmlns:a16="http://schemas.microsoft.com/office/drawing/2014/main" id="{B0DFF3DA-5351-C3FC-1101-5E108E41130A}"/>
                </a:ext>
              </a:extLst>
            </p:cNvPr>
            <p:cNvSpPr/>
            <p:nvPr/>
          </p:nvSpPr>
          <p:spPr>
            <a:xfrm>
              <a:off x="5989396" y="216925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1" name="pt336">
              <a:extLst>
                <a:ext uri="{FF2B5EF4-FFF2-40B4-BE49-F238E27FC236}">
                  <a16:creationId xmlns:a16="http://schemas.microsoft.com/office/drawing/2014/main" id="{305F724F-B3E4-8180-26CE-EC6FD080EF9C}"/>
                </a:ext>
              </a:extLst>
            </p:cNvPr>
            <p:cNvSpPr/>
            <p:nvPr/>
          </p:nvSpPr>
          <p:spPr>
            <a:xfrm>
              <a:off x="5980471" y="21770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2" name="pt337">
              <a:extLst>
                <a:ext uri="{FF2B5EF4-FFF2-40B4-BE49-F238E27FC236}">
                  <a16:creationId xmlns:a16="http://schemas.microsoft.com/office/drawing/2014/main" id="{7A24E82F-890F-07EB-2F8C-85F41566B47E}"/>
                </a:ext>
              </a:extLst>
            </p:cNvPr>
            <p:cNvSpPr/>
            <p:nvPr/>
          </p:nvSpPr>
          <p:spPr>
            <a:xfrm>
              <a:off x="6081042" y="215360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3" name="pt338">
              <a:extLst>
                <a:ext uri="{FF2B5EF4-FFF2-40B4-BE49-F238E27FC236}">
                  <a16:creationId xmlns:a16="http://schemas.microsoft.com/office/drawing/2014/main" id="{8DB0AFFB-C136-6927-B253-AB3FD11AEE92}"/>
                </a:ext>
              </a:extLst>
            </p:cNvPr>
            <p:cNvSpPr/>
            <p:nvPr/>
          </p:nvSpPr>
          <p:spPr>
            <a:xfrm>
              <a:off x="5958566" y="218490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4" name="pt339">
              <a:extLst>
                <a:ext uri="{FF2B5EF4-FFF2-40B4-BE49-F238E27FC236}">
                  <a16:creationId xmlns:a16="http://schemas.microsoft.com/office/drawing/2014/main" id="{63FAFB40-2006-5004-AA39-74767E535A36}"/>
                </a:ext>
              </a:extLst>
            </p:cNvPr>
            <p:cNvSpPr/>
            <p:nvPr/>
          </p:nvSpPr>
          <p:spPr>
            <a:xfrm>
              <a:off x="6117328" y="157446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5" name="pt340">
              <a:extLst>
                <a:ext uri="{FF2B5EF4-FFF2-40B4-BE49-F238E27FC236}">
                  <a16:creationId xmlns:a16="http://schemas.microsoft.com/office/drawing/2014/main" id="{CAF8CC56-410D-1E40-097F-FE865D66BB57}"/>
                </a:ext>
              </a:extLst>
            </p:cNvPr>
            <p:cNvSpPr/>
            <p:nvPr/>
          </p:nvSpPr>
          <p:spPr>
            <a:xfrm>
              <a:off x="5939369" y="153690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6" name="pt341">
              <a:extLst>
                <a:ext uri="{FF2B5EF4-FFF2-40B4-BE49-F238E27FC236}">
                  <a16:creationId xmlns:a16="http://schemas.microsoft.com/office/drawing/2014/main" id="{08BA285D-2F97-936A-B70C-742FDE37FED2}"/>
                </a:ext>
              </a:extLst>
            </p:cNvPr>
            <p:cNvSpPr/>
            <p:nvPr/>
          </p:nvSpPr>
          <p:spPr>
            <a:xfrm>
              <a:off x="5984637" y="217708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7" name="pt342">
              <a:extLst>
                <a:ext uri="{FF2B5EF4-FFF2-40B4-BE49-F238E27FC236}">
                  <a16:creationId xmlns:a16="http://schemas.microsoft.com/office/drawing/2014/main" id="{39C0501A-0BFC-C015-C9E7-D46625D6A7B3}"/>
                </a:ext>
              </a:extLst>
            </p:cNvPr>
            <p:cNvSpPr/>
            <p:nvPr/>
          </p:nvSpPr>
          <p:spPr>
            <a:xfrm>
              <a:off x="5970742" y="217896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8" name="pt343">
              <a:extLst>
                <a:ext uri="{FF2B5EF4-FFF2-40B4-BE49-F238E27FC236}">
                  <a16:creationId xmlns:a16="http://schemas.microsoft.com/office/drawing/2014/main" id="{DD86D48E-9A36-1DAF-291E-84271EC76230}"/>
                </a:ext>
              </a:extLst>
            </p:cNvPr>
            <p:cNvSpPr/>
            <p:nvPr/>
          </p:nvSpPr>
          <p:spPr>
            <a:xfrm>
              <a:off x="6091038" y="212527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69" name="pt344">
              <a:extLst>
                <a:ext uri="{FF2B5EF4-FFF2-40B4-BE49-F238E27FC236}">
                  <a16:creationId xmlns:a16="http://schemas.microsoft.com/office/drawing/2014/main" id="{75011C6B-CB6C-265E-7CEA-4490C7A2715C}"/>
                </a:ext>
              </a:extLst>
            </p:cNvPr>
            <p:cNvSpPr/>
            <p:nvPr/>
          </p:nvSpPr>
          <p:spPr>
            <a:xfrm>
              <a:off x="6113767" y="213638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0" name="pt345">
              <a:extLst>
                <a:ext uri="{FF2B5EF4-FFF2-40B4-BE49-F238E27FC236}">
                  <a16:creationId xmlns:a16="http://schemas.microsoft.com/office/drawing/2014/main" id="{EB16152E-D2CA-D693-78E5-3F0260D2558B}"/>
                </a:ext>
              </a:extLst>
            </p:cNvPr>
            <p:cNvSpPr/>
            <p:nvPr/>
          </p:nvSpPr>
          <p:spPr>
            <a:xfrm>
              <a:off x="6121769" y="216722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1" name="pt346">
              <a:extLst>
                <a:ext uri="{FF2B5EF4-FFF2-40B4-BE49-F238E27FC236}">
                  <a16:creationId xmlns:a16="http://schemas.microsoft.com/office/drawing/2014/main" id="{07B81F5F-C75F-5AA3-8E1E-5AA1C49A3D8C}"/>
                </a:ext>
              </a:extLst>
            </p:cNvPr>
            <p:cNvSpPr/>
            <p:nvPr/>
          </p:nvSpPr>
          <p:spPr>
            <a:xfrm>
              <a:off x="5990895" y="212073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2" name="pt347">
              <a:extLst>
                <a:ext uri="{FF2B5EF4-FFF2-40B4-BE49-F238E27FC236}">
                  <a16:creationId xmlns:a16="http://schemas.microsoft.com/office/drawing/2014/main" id="{011AA570-EDA5-D932-F82B-904CFBA75E8D}"/>
                </a:ext>
              </a:extLst>
            </p:cNvPr>
            <p:cNvSpPr/>
            <p:nvPr/>
          </p:nvSpPr>
          <p:spPr>
            <a:xfrm>
              <a:off x="5990382" y="211055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3" name="pt348">
              <a:extLst>
                <a:ext uri="{FF2B5EF4-FFF2-40B4-BE49-F238E27FC236}">
                  <a16:creationId xmlns:a16="http://schemas.microsoft.com/office/drawing/2014/main" id="{5B934F69-9AAF-1BDA-4DF8-6E338F751D26}"/>
                </a:ext>
              </a:extLst>
            </p:cNvPr>
            <p:cNvSpPr/>
            <p:nvPr/>
          </p:nvSpPr>
          <p:spPr>
            <a:xfrm>
              <a:off x="5970644" y="217293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4" name="pt349">
              <a:extLst>
                <a:ext uri="{FF2B5EF4-FFF2-40B4-BE49-F238E27FC236}">
                  <a16:creationId xmlns:a16="http://schemas.microsoft.com/office/drawing/2014/main" id="{A2264045-2CCD-4B83-FB32-AF670C755D88}"/>
                </a:ext>
              </a:extLst>
            </p:cNvPr>
            <p:cNvSpPr/>
            <p:nvPr/>
          </p:nvSpPr>
          <p:spPr>
            <a:xfrm>
              <a:off x="6128331" y="218091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5" name="pt350">
              <a:extLst>
                <a:ext uri="{FF2B5EF4-FFF2-40B4-BE49-F238E27FC236}">
                  <a16:creationId xmlns:a16="http://schemas.microsoft.com/office/drawing/2014/main" id="{8C6D062B-461A-CDD6-48E2-70EAE9FF91ED}"/>
                </a:ext>
              </a:extLst>
            </p:cNvPr>
            <p:cNvSpPr/>
            <p:nvPr/>
          </p:nvSpPr>
          <p:spPr>
            <a:xfrm>
              <a:off x="6086208" y="217880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6" name="pt351">
              <a:extLst>
                <a:ext uri="{FF2B5EF4-FFF2-40B4-BE49-F238E27FC236}">
                  <a16:creationId xmlns:a16="http://schemas.microsoft.com/office/drawing/2014/main" id="{2FFA825F-7C1A-5BB0-E024-D52D9D039735}"/>
                </a:ext>
              </a:extLst>
            </p:cNvPr>
            <p:cNvSpPr/>
            <p:nvPr/>
          </p:nvSpPr>
          <p:spPr>
            <a:xfrm>
              <a:off x="5957990" y="218310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7" name="pt352">
              <a:extLst>
                <a:ext uri="{FF2B5EF4-FFF2-40B4-BE49-F238E27FC236}">
                  <a16:creationId xmlns:a16="http://schemas.microsoft.com/office/drawing/2014/main" id="{AD935E7C-882E-21FB-914E-A28C3D9B8A10}"/>
                </a:ext>
              </a:extLst>
            </p:cNvPr>
            <p:cNvSpPr/>
            <p:nvPr/>
          </p:nvSpPr>
          <p:spPr>
            <a:xfrm>
              <a:off x="5949323" y="210195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8" name="pt353">
              <a:extLst>
                <a:ext uri="{FF2B5EF4-FFF2-40B4-BE49-F238E27FC236}">
                  <a16:creationId xmlns:a16="http://schemas.microsoft.com/office/drawing/2014/main" id="{C4E04EEB-2B34-6B47-4DA7-754AE837D7D4}"/>
                </a:ext>
              </a:extLst>
            </p:cNvPr>
            <p:cNvSpPr/>
            <p:nvPr/>
          </p:nvSpPr>
          <p:spPr>
            <a:xfrm>
              <a:off x="6105367" y="209647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79" name="tx354">
              <a:extLst>
                <a:ext uri="{FF2B5EF4-FFF2-40B4-BE49-F238E27FC236}">
                  <a16:creationId xmlns:a16="http://schemas.microsoft.com/office/drawing/2014/main" id="{D285D872-0598-5717-63B6-A49C2149AC55}"/>
                </a:ext>
              </a:extLst>
            </p:cNvPr>
            <p:cNvSpPr/>
            <p:nvPr/>
          </p:nvSpPr>
          <p:spPr>
            <a:xfrm>
              <a:off x="4857064" y="979697"/>
              <a:ext cx="23529" cy="18422"/>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a:t>
              </a:r>
            </a:p>
          </p:txBody>
        </p:sp>
        <p:sp>
          <p:nvSpPr>
            <p:cNvPr id="2480" name="tx355">
              <a:extLst>
                <a:ext uri="{FF2B5EF4-FFF2-40B4-BE49-F238E27FC236}">
                  <a16:creationId xmlns:a16="http://schemas.microsoft.com/office/drawing/2014/main" id="{A3EC02E6-4F8E-98D1-BB2D-FD2C7C8846D5}"/>
                </a:ext>
              </a:extLst>
            </p:cNvPr>
            <p:cNvSpPr/>
            <p:nvPr/>
          </p:nvSpPr>
          <p:spPr>
            <a:xfrm>
              <a:off x="5247800" y="979697"/>
              <a:ext cx="23529" cy="18422"/>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a:t>
              </a:r>
            </a:p>
          </p:txBody>
        </p:sp>
        <p:sp>
          <p:nvSpPr>
            <p:cNvPr id="2481" name="tx356">
              <a:extLst>
                <a:ext uri="{FF2B5EF4-FFF2-40B4-BE49-F238E27FC236}">
                  <a16:creationId xmlns:a16="http://schemas.microsoft.com/office/drawing/2014/main" id="{B242134B-2E0B-8C40-8F1D-765FD6FFB679}"/>
                </a:ext>
              </a:extLst>
            </p:cNvPr>
            <p:cNvSpPr/>
            <p:nvPr/>
          </p:nvSpPr>
          <p:spPr>
            <a:xfrm>
              <a:off x="5638535" y="979697"/>
              <a:ext cx="23529" cy="18422"/>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a:t>
              </a:r>
            </a:p>
          </p:txBody>
        </p:sp>
        <p:sp>
          <p:nvSpPr>
            <p:cNvPr id="2482" name="tx357">
              <a:extLst>
                <a:ext uri="{FF2B5EF4-FFF2-40B4-BE49-F238E27FC236}">
                  <a16:creationId xmlns:a16="http://schemas.microsoft.com/office/drawing/2014/main" id="{FA5C74E1-28C4-A137-7335-3D7630E699EB}"/>
                </a:ext>
              </a:extLst>
            </p:cNvPr>
            <p:cNvSpPr/>
            <p:nvPr/>
          </p:nvSpPr>
          <p:spPr>
            <a:xfrm>
              <a:off x="6009106" y="965349"/>
              <a:ext cx="63857" cy="32770"/>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ns</a:t>
              </a:r>
            </a:p>
          </p:txBody>
        </p:sp>
        <p:sp>
          <p:nvSpPr>
            <p:cNvPr id="2483" name="pl358">
              <a:extLst>
                <a:ext uri="{FF2B5EF4-FFF2-40B4-BE49-F238E27FC236}">
                  <a16:creationId xmlns:a16="http://schemas.microsoft.com/office/drawing/2014/main" id="{DE44255E-18C4-C25C-1C59-9F160C0D117A}"/>
                </a:ext>
              </a:extLst>
            </p:cNvPr>
            <p:cNvSpPr/>
            <p:nvPr/>
          </p:nvSpPr>
          <p:spPr>
            <a:xfrm>
              <a:off x="4640739" y="923632"/>
              <a:ext cx="0" cy="1638722"/>
            </a:xfrm>
            <a:custGeom>
              <a:avLst/>
              <a:gdLst/>
              <a:ahLst/>
              <a:cxnLst/>
              <a:rect l="0" t="0" r="0" b="0"/>
              <a:pathLst>
                <a:path h="4896888">
                  <a:moveTo>
                    <a:pt x="0" y="4896888"/>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84" name="tx359">
              <a:extLst>
                <a:ext uri="{FF2B5EF4-FFF2-40B4-BE49-F238E27FC236}">
                  <a16:creationId xmlns:a16="http://schemas.microsoft.com/office/drawing/2014/main" id="{4A35E780-EF2F-9358-55AE-958BEA1DBB93}"/>
                </a:ext>
              </a:extLst>
            </p:cNvPr>
            <p:cNvSpPr/>
            <p:nvPr/>
          </p:nvSpPr>
          <p:spPr>
            <a:xfrm>
              <a:off x="4532427" y="2439362"/>
              <a:ext cx="56684" cy="4582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2</a:t>
              </a:r>
            </a:p>
          </p:txBody>
        </p:sp>
        <p:sp>
          <p:nvSpPr>
            <p:cNvPr id="2485" name="tx360">
              <a:extLst>
                <a:ext uri="{FF2B5EF4-FFF2-40B4-BE49-F238E27FC236}">
                  <a16:creationId xmlns:a16="http://schemas.microsoft.com/office/drawing/2014/main" id="{A64B49A2-1EA7-C7D8-57B4-4269755FEE7F}"/>
                </a:ext>
              </a:extLst>
            </p:cNvPr>
            <p:cNvSpPr/>
            <p:nvPr/>
          </p:nvSpPr>
          <p:spPr>
            <a:xfrm>
              <a:off x="4553656" y="2022148"/>
              <a:ext cx="35455" cy="46598"/>
            </a:xfrm>
            <a:prstGeom prst="rect">
              <a:avLst/>
            </a:prstGeom>
            <a:noFill/>
            <a:ln w="9525">
              <a:noFill/>
            </a:ln>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0</a:t>
              </a:r>
            </a:p>
          </p:txBody>
        </p:sp>
        <p:sp>
          <p:nvSpPr>
            <p:cNvPr id="2486" name="tx361">
              <a:extLst>
                <a:ext uri="{FF2B5EF4-FFF2-40B4-BE49-F238E27FC236}">
                  <a16:creationId xmlns:a16="http://schemas.microsoft.com/office/drawing/2014/main" id="{2D46E2DC-0B25-4E6E-12E1-8610398FE942}"/>
                </a:ext>
              </a:extLst>
            </p:cNvPr>
            <p:cNvSpPr/>
            <p:nvPr/>
          </p:nvSpPr>
          <p:spPr>
            <a:xfrm>
              <a:off x="4553656" y="1606489"/>
              <a:ext cx="35455" cy="45820"/>
            </a:xfrm>
            <a:prstGeom prst="rect">
              <a:avLst/>
            </a:prstGeom>
            <a:noFill/>
            <a:ln w="9525">
              <a:noFill/>
            </a:ln>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2</a:t>
              </a:r>
            </a:p>
          </p:txBody>
        </p:sp>
        <p:sp>
          <p:nvSpPr>
            <p:cNvPr id="2487" name="tx362">
              <a:extLst>
                <a:ext uri="{FF2B5EF4-FFF2-40B4-BE49-F238E27FC236}">
                  <a16:creationId xmlns:a16="http://schemas.microsoft.com/office/drawing/2014/main" id="{30EC01F0-5496-7802-0174-E39B3B3F34BF}"/>
                </a:ext>
              </a:extLst>
            </p:cNvPr>
            <p:cNvSpPr/>
            <p:nvPr/>
          </p:nvSpPr>
          <p:spPr>
            <a:xfrm>
              <a:off x="4553656" y="1190239"/>
              <a:ext cx="35455" cy="45633"/>
            </a:xfrm>
            <a:prstGeom prst="rect">
              <a:avLst/>
            </a:prstGeom>
            <a:noFill/>
            <a:ln w="9525">
              <a:noFill/>
            </a:ln>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4</a:t>
              </a:r>
            </a:p>
          </p:txBody>
        </p:sp>
        <p:sp>
          <p:nvSpPr>
            <p:cNvPr id="2488" name="pl363">
              <a:extLst>
                <a:ext uri="{FF2B5EF4-FFF2-40B4-BE49-F238E27FC236}">
                  <a16:creationId xmlns:a16="http://schemas.microsoft.com/office/drawing/2014/main" id="{9F3CDED7-5B7D-3D10-BABC-970AFF2C6B75}"/>
                </a:ext>
              </a:extLst>
            </p:cNvPr>
            <p:cNvSpPr/>
            <p:nvPr/>
          </p:nvSpPr>
          <p:spPr>
            <a:xfrm>
              <a:off x="4614278" y="2497291"/>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89" name="pl364">
              <a:extLst>
                <a:ext uri="{FF2B5EF4-FFF2-40B4-BE49-F238E27FC236}">
                  <a16:creationId xmlns:a16="http://schemas.microsoft.com/office/drawing/2014/main" id="{A761AA45-FC2C-1C7D-B51B-1EB0BD7640E2}"/>
                </a:ext>
              </a:extLst>
            </p:cNvPr>
            <p:cNvSpPr/>
            <p:nvPr/>
          </p:nvSpPr>
          <p:spPr>
            <a:xfrm>
              <a:off x="4614278" y="2080854"/>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0" name="pl365">
              <a:extLst>
                <a:ext uri="{FF2B5EF4-FFF2-40B4-BE49-F238E27FC236}">
                  <a16:creationId xmlns:a16="http://schemas.microsoft.com/office/drawing/2014/main" id="{23CB9227-6479-73FB-A513-BB06807FA734}"/>
                </a:ext>
              </a:extLst>
            </p:cNvPr>
            <p:cNvSpPr/>
            <p:nvPr/>
          </p:nvSpPr>
          <p:spPr>
            <a:xfrm>
              <a:off x="4614278" y="1664417"/>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1" name="pl366">
              <a:extLst>
                <a:ext uri="{FF2B5EF4-FFF2-40B4-BE49-F238E27FC236}">
                  <a16:creationId xmlns:a16="http://schemas.microsoft.com/office/drawing/2014/main" id="{DE4FB122-EF5D-96E2-0D88-68B4BAD40B88}"/>
                </a:ext>
              </a:extLst>
            </p:cNvPr>
            <p:cNvSpPr/>
            <p:nvPr/>
          </p:nvSpPr>
          <p:spPr>
            <a:xfrm>
              <a:off x="4614278" y="1247981"/>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2" name="pl367">
              <a:extLst>
                <a:ext uri="{FF2B5EF4-FFF2-40B4-BE49-F238E27FC236}">
                  <a16:creationId xmlns:a16="http://schemas.microsoft.com/office/drawing/2014/main" id="{F10D6D0A-8947-85E0-CFA7-7B1EC6492052}"/>
                </a:ext>
              </a:extLst>
            </p:cNvPr>
            <p:cNvSpPr/>
            <p:nvPr/>
          </p:nvSpPr>
          <p:spPr>
            <a:xfrm>
              <a:off x="4634388" y="2562354"/>
              <a:ext cx="1641088" cy="0"/>
            </a:xfrm>
            <a:custGeom>
              <a:avLst/>
              <a:gdLst/>
              <a:ahLst/>
              <a:cxnLst/>
              <a:rect l="0" t="0" r="0" b="0"/>
              <a:pathLst>
                <a:path w="4903957">
                  <a:moveTo>
                    <a:pt x="0" y="0"/>
                  </a:moveTo>
                  <a:lnTo>
                    <a:pt x="4903957"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3" name="pl368">
              <a:extLst>
                <a:ext uri="{FF2B5EF4-FFF2-40B4-BE49-F238E27FC236}">
                  <a16:creationId xmlns:a16="http://schemas.microsoft.com/office/drawing/2014/main" id="{80CC63F4-2009-2874-AC36-4C32B2C7A880}"/>
                </a:ext>
              </a:extLst>
            </p:cNvPr>
            <p:cNvSpPr/>
            <p:nvPr/>
          </p:nvSpPr>
          <p:spPr>
            <a:xfrm>
              <a:off x="4868829" y="2564471"/>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4" name="pl369">
              <a:extLst>
                <a:ext uri="{FF2B5EF4-FFF2-40B4-BE49-F238E27FC236}">
                  <a16:creationId xmlns:a16="http://schemas.microsoft.com/office/drawing/2014/main" id="{E595A69A-58B1-D746-9040-C8C55B64BA81}"/>
                </a:ext>
              </a:extLst>
            </p:cNvPr>
            <p:cNvSpPr/>
            <p:nvPr/>
          </p:nvSpPr>
          <p:spPr>
            <a:xfrm>
              <a:off x="5259564" y="2564471"/>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5" name="pl370">
              <a:extLst>
                <a:ext uri="{FF2B5EF4-FFF2-40B4-BE49-F238E27FC236}">
                  <a16:creationId xmlns:a16="http://schemas.microsoft.com/office/drawing/2014/main" id="{C6A6A663-F558-3262-12FD-3752693FF82D}"/>
                </a:ext>
              </a:extLst>
            </p:cNvPr>
            <p:cNvSpPr/>
            <p:nvPr/>
          </p:nvSpPr>
          <p:spPr>
            <a:xfrm>
              <a:off x="5650300" y="2564471"/>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6" name="pl371">
              <a:extLst>
                <a:ext uri="{FF2B5EF4-FFF2-40B4-BE49-F238E27FC236}">
                  <a16:creationId xmlns:a16="http://schemas.microsoft.com/office/drawing/2014/main" id="{198B1E3A-08BC-811D-6423-40A88DD9444F}"/>
                </a:ext>
              </a:extLst>
            </p:cNvPr>
            <p:cNvSpPr/>
            <p:nvPr/>
          </p:nvSpPr>
          <p:spPr>
            <a:xfrm>
              <a:off x="6041035" y="2564471"/>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497" name="tx372">
              <a:extLst>
                <a:ext uri="{FF2B5EF4-FFF2-40B4-BE49-F238E27FC236}">
                  <a16:creationId xmlns:a16="http://schemas.microsoft.com/office/drawing/2014/main" id="{66C654C7-3789-74A8-8595-B64999D3B9F5}"/>
                </a:ext>
              </a:extLst>
            </p:cNvPr>
            <p:cNvSpPr/>
            <p:nvPr/>
          </p:nvSpPr>
          <p:spPr>
            <a:xfrm>
              <a:off x="4805048" y="2592341"/>
              <a:ext cx="127562"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VAS</a:t>
              </a:r>
            </a:p>
          </p:txBody>
        </p:sp>
        <p:sp>
          <p:nvSpPr>
            <p:cNvPr id="2498" name="tx373">
              <a:extLst>
                <a:ext uri="{FF2B5EF4-FFF2-40B4-BE49-F238E27FC236}">
                  <a16:creationId xmlns:a16="http://schemas.microsoft.com/office/drawing/2014/main" id="{0A1348EA-177F-5431-81FD-5D633311006C}"/>
                </a:ext>
              </a:extLst>
            </p:cNvPr>
            <p:cNvSpPr/>
            <p:nvPr/>
          </p:nvSpPr>
          <p:spPr>
            <a:xfrm>
              <a:off x="5201137" y="2592341"/>
              <a:ext cx="116854"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TJC</a:t>
              </a:r>
            </a:p>
          </p:txBody>
        </p:sp>
        <p:sp>
          <p:nvSpPr>
            <p:cNvPr id="2499" name="tx374">
              <a:extLst>
                <a:ext uri="{FF2B5EF4-FFF2-40B4-BE49-F238E27FC236}">
                  <a16:creationId xmlns:a16="http://schemas.microsoft.com/office/drawing/2014/main" id="{48D4392F-BE77-CF9C-299D-627D57A1C88F}"/>
                </a:ext>
              </a:extLst>
            </p:cNvPr>
            <p:cNvSpPr/>
            <p:nvPr/>
          </p:nvSpPr>
          <p:spPr>
            <a:xfrm>
              <a:off x="5590083" y="2592341"/>
              <a:ext cx="120434"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SJC</a:t>
              </a:r>
            </a:p>
          </p:txBody>
        </p:sp>
        <p:sp>
          <p:nvSpPr>
            <p:cNvPr id="2500" name="tx375">
              <a:extLst>
                <a:ext uri="{FF2B5EF4-FFF2-40B4-BE49-F238E27FC236}">
                  <a16:creationId xmlns:a16="http://schemas.microsoft.com/office/drawing/2014/main" id="{FE0B77D9-F223-53A1-6113-959FE5502495}"/>
                </a:ext>
              </a:extLst>
            </p:cNvPr>
            <p:cNvSpPr/>
            <p:nvPr/>
          </p:nvSpPr>
          <p:spPr>
            <a:xfrm>
              <a:off x="5973736" y="2592341"/>
              <a:ext cx="134597"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CRP</a:t>
              </a:r>
            </a:p>
          </p:txBody>
        </p:sp>
        <p:sp>
          <p:nvSpPr>
            <p:cNvPr id="2501" name="tx376">
              <a:extLst>
                <a:ext uri="{FF2B5EF4-FFF2-40B4-BE49-F238E27FC236}">
                  <a16:creationId xmlns:a16="http://schemas.microsoft.com/office/drawing/2014/main" id="{6F9C05C3-876D-7F1C-6397-5E2E7CD050ED}"/>
                </a:ext>
              </a:extLst>
            </p:cNvPr>
            <p:cNvSpPr/>
            <p:nvPr/>
          </p:nvSpPr>
          <p:spPr>
            <a:xfrm rot="16200000">
              <a:off x="4268422" y="1719398"/>
              <a:ext cx="365037"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Scaled value</a:t>
              </a:r>
            </a:p>
          </p:txBody>
        </p:sp>
      </p:grpSp>
      <p:grpSp>
        <p:nvGrpSpPr>
          <p:cNvPr id="112" name="组合 111">
            <a:extLst>
              <a:ext uri="{FF2B5EF4-FFF2-40B4-BE49-F238E27FC236}">
                <a16:creationId xmlns:a16="http://schemas.microsoft.com/office/drawing/2014/main" id="{888E0EBC-A4CE-8773-F003-E13EBDDD6182}"/>
              </a:ext>
            </a:extLst>
          </p:cNvPr>
          <p:cNvGrpSpPr/>
          <p:nvPr/>
        </p:nvGrpSpPr>
        <p:grpSpPr>
          <a:xfrm>
            <a:off x="372073" y="972829"/>
            <a:ext cx="1437149" cy="1729097"/>
            <a:chOff x="365766" y="953796"/>
            <a:chExt cx="1437149" cy="1729097"/>
          </a:xfrm>
        </p:grpSpPr>
        <p:sp>
          <p:nvSpPr>
            <p:cNvPr id="2503" name="pg6">
              <a:extLst>
                <a:ext uri="{FF2B5EF4-FFF2-40B4-BE49-F238E27FC236}">
                  <a16:creationId xmlns:a16="http://schemas.microsoft.com/office/drawing/2014/main" id="{983EF0E2-1841-26AA-0833-31DFDC02D0EB}"/>
                </a:ext>
              </a:extLst>
            </p:cNvPr>
            <p:cNvSpPr/>
            <p:nvPr/>
          </p:nvSpPr>
          <p:spPr>
            <a:xfrm>
              <a:off x="788211" y="1354484"/>
              <a:ext cx="320433" cy="999621"/>
            </a:xfrm>
            <a:custGeom>
              <a:avLst/>
              <a:gdLst/>
              <a:ahLst/>
              <a:cxnLst/>
              <a:rect l="0" t="0" r="0" b="0"/>
              <a:pathLst>
                <a:path w="957528" h="2987102">
                  <a:moveTo>
                    <a:pt x="448211" y="2987102"/>
                  </a:moveTo>
                  <a:lnTo>
                    <a:pt x="447979" y="2981256"/>
                  </a:lnTo>
                  <a:lnTo>
                    <a:pt x="447754" y="2975410"/>
                  </a:lnTo>
                  <a:lnTo>
                    <a:pt x="447545" y="2969565"/>
                  </a:lnTo>
                  <a:lnTo>
                    <a:pt x="447345" y="2963719"/>
                  </a:lnTo>
                  <a:lnTo>
                    <a:pt x="447152" y="2957874"/>
                  </a:lnTo>
                  <a:lnTo>
                    <a:pt x="446975" y="2952028"/>
                  </a:lnTo>
                  <a:lnTo>
                    <a:pt x="446805" y="2946182"/>
                  </a:lnTo>
                  <a:lnTo>
                    <a:pt x="446644" y="2940337"/>
                  </a:lnTo>
                  <a:lnTo>
                    <a:pt x="446495" y="2934491"/>
                  </a:lnTo>
                  <a:lnTo>
                    <a:pt x="446352" y="2928646"/>
                  </a:lnTo>
                  <a:lnTo>
                    <a:pt x="446219" y="2922800"/>
                  </a:lnTo>
                  <a:lnTo>
                    <a:pt x="446095" y="2916954"/>
                  </a:lnTo>
                  <a:lnTo>
                    <a:pt x="445977" y="2911109"/>
                  </a:lnTo>
                  <a:lnTo>
                    <a:pt x="445868" y="2905263"/>
                  </a:lnTo>
                  <a:lnTo>
                    <a:pt x="445766" y="2899418"/>
                  </a:lnTo>
                  <a:lnTo>
                    <a:pt x="445669" y="2893572"/>
                  </a:lnTo>
                  <a:lnTo>
                    <a:pt x="445581" y="2887726"/>
                  </a:lnTo>
                  <a:lnTo>
                    <a:pt x="445497" y="2881881"/>
                  </a:lnTo>
                  <a:lnTo>
                    <a:pt x="445418" y="2876035"/>
                  </a:lnTo>
                  <a:lnTo>
                    <a:pt x="445346" y="2870190"/>
                  </a:lnTo>
                  <a:lnTo>
                    <a:pt x="445277" y="2864344"/>
                  </a:lnTo>
                  <a:lnTo>
                    <a:pt x="445213" y="2858498"/>
                  </a:lnTo>
                  <a:lnTo>
                    <a:pt x="445153" y="2852653"/>
                  </a:lnTo>
                  <a:lnTo>
                    <a:pt x="445095" y="2846807"/>
                  </a:lnTo>
                  <a:lnTo>
                    <a:pt x="445041" y="2840962"/>
                  </a:lnTo>
                  <a:lnTo>
                    <a:pt x="444990" y="2835116"/>
                  </a:lnTo>
                  <a:lnTo>
                    <a:pt x="444941" y="2829270"/>
                  </a:lnTo>
                  <a:lnTo>
                    <a:pt x="444894" y="2823425"/>
                  </a:lnTo>
                  <a:lnTo>
                    <a:pt x="444849" y="2817579"/>
                  </a:lnTo>
                  <a:lnTo>
                    <a:pt x="444805" y="2811734"/>
                  </a:lnTo>
                  <a:lnTo>
                    <a:pt x="444763" y="2805888"/>
                  </a:lnTo>
                  <a:lnTo>
                    <a:pt x="444721" y="2800042"/>
                  </a:lnTo>
                  <a:lnTo>
                    <a:pt x="444681" y="2794197"/>
                  </a:lnTo>
                  <a:lnTo>
                    <a:pt x="444641" y="2788351"/>
                  </a:lnTo>
                  <a:lnTo>
                    <a:pt x="444601" y="2782505"/>
                  </a:lnTo>
                  <a:lnTo>
                    <a:pt x="444562" y="2776660"/>
                  </a:lnTo>
                  <a:lnTo>
                    <a:pt x="444524" y="2770814"/>
                  </a:lnTo>
                  <a:lnTo>
                    <a:pt x="444485" y="2764969"/>
                  </a:lnTo>
                  <a:lnTo>
                    <a:pt x="444447" y="2759123"/>
                  </a:lnTo>
                  <a:lnTo>
                    <a:pt x="444408" y="2753277"/>
                  </a:lnTo>
                  <a:lnTo>
                    <a:pt x="444370" y="2747432"/>
                  </a:lnTo>
                  <a:lnTo>
                    <a:pt x="444332" y="2741586"/>
                  </a:lnTo>
                  <a:lnTo>
                    <a:pt x="444294" y="2735741"/>
                  </a:lnTo>
                  <a:lnTo>
                    <a:pt x="444256" y="2729895"/>
                  </a:lnTo>
                  <a:lnTo>
                    <a:pt x="444219" y="2724049"/>
                  </a:lnTo>
                  <a:lnTo>
                    <a:pt x="444182" y="2718204"/>
                  </a:lnTo>
                  <a:lnTo>
                    <a:pt x="444145" y="2712358"/>
                  </a:lnTo>
                  <a:lnTo>
                    <a:pt x="444109" y="2706513"/>
                  </a:lnTo>
                  <a:lnTo>
                    <a:pt x="444073" y="2700667"/>
                  </a:lnTo>
                  <a:lnTo>
                    <a:pt x="444038" y="2694821"/>
                  </a:lnTo>
                  <a:lnTo>
                    <a:pt x="444004" y="2688976"/>
                  </a:lnTo>
                  <a:lnTo>
                    <a:pt x="443971" y="2683130"/>
                  </a:lnTo>
                  <a:lnTo>
                    <a:pt x="443940" y="2677285"/>
                  </a:lnTo>
                  <a:lnTo>
                    <a:pt x="443909" y="2671439"/>
                  </a:lnTo>
                  <a:lnTo>
                    <a:pt x="443880" y="2665593"/>
                  </a:lnTo>
                  <a:lnTo>
                    <a:pt x="443853" y="2659748"/>
                  </a:lnTo>
                  <a:lnTo>
                    <a:pt x="443828" y="2653902"/>
                  </a:lnTo>
                  <a:lnTo>
                    <a:pt x="443804" y="2648057"/>
                  </a:lnTo>
                  <a:lnTo>
                    <a:pt x="443782" y="2642211"/>
                  </a:lnTo>
                  <a:lnTo>
                    <a:pt x="443763" y="2636365"/>
                  </a:lnTo>
                  <a:lnTo>
                    <a:pt x="443745" y="2630520"/>
                  </a:lnTo>
                  <a:lnTo>
                    <a:pt x="443730" y="2624674"/>
                  </a:lnTo>
                  <a:lnTo>
                    <a:pt x="443717" y="2618829"/>
                  </a:lnTo>
                  <a:lnTo>
                    <a:pt x="443706" y="2612983"/>
                  </a:lnTo>
                  <a:lnTo>
                    <a:pt x="443699" y="2607137"/>
                  </a:lnTo>
                  <a:lnTo>
                    <a:pt x="443692" y="2601292"/>
                  </a:lnTo>
                  <a:lnTo>
                    <a:pt x="443690" y="2595446"/>
                  </a:lnTo>
                  <a:lnTo>
                    <a:pt x="443689" y="2589601"/>
                  </a:lnTo>
                  <a:lnTo>
                    <a:pt x="443690" y="2583755"/>
                  </a:lnTo>
                  <a:lnTo>
                    <a:pt x="443694" y="2577909"/>
                  </a:lnTo>
                  <a:lnTo>
                    <a:pt x="443700" y="2572064"/>
                  </a:lnTo>
                  <a:lnTo>
                    <a:pt x="443709" y="2566218"/>
                  </a:lnTo>
                  <a:lnTo>
                    <a:pt x="443720" y="2560373"/>
                  </a:lnTo>
                  <a:lnTo>
                    <a:pt x="443732" y="2554527"/>
                  </a:lnTo>
                  <a:lnTo>
                    <a:pt x="443746" y="2548681"/>
                  </a:lnTo>
                  <a:lnTo>
                    <a:pt x="443762" y="2542836"/>
                  </a:lnTo>
                  <a:lnTo>
                    <a:pt x="443780" y="2536990"/>
                  </a:lnTo>
                  <a:lnTo>
                    <a:pt x="443799" y="2531145"/>
                  </a:lnTo>
                  <a:lnTo>
                    <a:pt x="443819" y="2525299"/>
                  </a:lnTo>
                  <a:lnTo>
                    <a:pt x="443840" y="2519453"/>
                  </a:lnTo>
                  <a:lnTo>
                    <a:pt x="443862" y="2513608"/>
                  </a:lnTo>
                  <a:lnTo>
                    <a:pt x="443884" y="2507762"/>
                  </a:lnTo>
                  <a:lnTo>
                    <a:pt x="443907" y="2501917"/>
                  </a:lnTo>
                  <a:lnTo>
                    <a:pt x="443930" y="2496071"/>
                  </a:lnTo>
                  <a:lnTo>
                    <a:pt x="443953" y="2490225"/>
                  </a:lnTo>
                  <a:lnTo>
                    <a:pt x="443975" y="2484380"/>
                  </a:lnTo>
                  <a:lnTo>
                    <a:pt x="443997" y="2478534"/>
                  </a:lnTo>
                  <a:lnTo>
                    <a:pt x="444018" y="2472689"/>
                  </a:lnTo>
                  <a:lnTo>
                    <a:pt x="444038" y="2466843"/>
                  </a:lnTo>
                  <a:lnTo>
                    <a:pt x="444056" y="2460997"/>
                  </a:lnTo>
                  <a:lnTo>
                    <a:pt x="444074" y="2455152"/>
                  </a:lnTo>
                  <a:lnTo>
                    <a:pt x="444089" y="2449306"/>
                  </a:lnTo>
                  <a:lnTo>
                    <a:pt x="444102" y="2443461"/>
                  </a:lnTo>
                  <a:lnTo>
                    <a:pt x="444114" y="2437615"/>
                  </a:lnTo>
                  <a:lnTo>
                    <a:pt x="444122" y="2431769"/>
                  </a:lnTo>
                  <a:lnTo>
                    <a:pt x="444128" y="2425924"/>
                  </a:lnTo>
                  <a:lnTo>
                    <a:pt x="444132" y="2420078"/>
                  </a:lnTo>
                  <a:lnTo>
                    <a:pt x="444132" y="2414233"/>
                  </a:lnTo>
                  <a:lnTo>
                    <a:pt x="444129" y="2408387"/>
                  </a:lnTo>
                  <a:lnTo>
                    <a:pt x="444123" y="2402541"/>
                  </a:lnTo>
                  <a:lnTo>
                    <a:pt x="444113" y="2396696"/>
                  </a:lnTo>
                  <a:lnTo>
                    <a:pt x="444101" y="2390850"/>
                  </a:lnTo>
                  <a:lnTo>
                    <a:pt x="444084" y="2385005"/>
                  </a:lnTo>
                  <a:lnTo>
                    <a:pt x="444063" y="2379159"/>
                  </a:lnTo>
                  <a:lnTo>
                    <a:pt x="444039" y="2373313"/>
                  </a:lnTo>
                  <a:lnTo>
                    <a:pt x="444009" y="2367468"/>
                  </a:lnTo>
                  <a:lnTo>
                    <a:pt x="443975" y="2361622"/>
                  </a:lnTo>
                  <a:lnTo>
                    <a:pt x="443939" y="2355777"/>
                  </a:lnTo>
                  <a:lnTo>
                    <a:pt x="443895" y="2349931"/>
                  </a:lnTo>
                  <a:lnTo>
                    <a:pt x="443848" y="2344085"/>
                  </a:lnTo>
                  <a:lnTo>
                    <a:pt x="443796" y="2338240"/>
                  </a:lnTo>
                  <a:lnTo>
                    <a:pt x="443738" y="2332394"/>
                  </a:lnTo>
                  <a:lnTo>
                    <a:pt x="443676" y="2326549"/>
                  </a:lnTo>
                  <a:lnTo>
                    <a:pt x="443608" y="2320703"/>
                  </a:lnTo>
                  <a:lnTo>
                    <a:pt x="443533" y="2314857"/>
                  </a:lnTo>
                  <a:lnTo>
                    <a:pt x="443454" y="2309012"/>
                  </a:lnTo>
                  <a:lnTo>
                    <a:pt x="443367" y="2303166"/>
                  </a:lnTo>
                  <a:lnTo>
                    <a:pt x="443274" y="2297321"/>
                  </a:lnTo>
                  <a:lnTo>
                    <a:pt x="443176" y="2291475"/>
                  </a:lnTo>
                  <a:lnTo>
                    <a:pt x="443067" y="2285629"/>
                  </a:lnTo>
                  <a:lnTo>
                    <a:pt x="442952" y="2279784"/>
                  </a:lnTo>
                  <a:lnTo>
                    <a:pt x="442831" y="2273938"/>
                  </a:lnTo>
                  <a:lnTo>
                    <a:pt x="442697" y="2268093"/>
                  </a:lnTo>
                  <a:lnTo>
                    <a:pt x="442557" y="2262247"/>
                  </a:lnTo>
                  <a:lnTo>
                    <a:pt x="442407" y="2256401"/>
                  </a:lnTo>
                  <a:lnTo>
                    <a:pt x="442244" y="2250556"/>
                  </a:lnTo>
                  <a:lnTo>
                    <a:pt x="442073" y="2244710"/>
                  </a:lnTo>
                  <a:lnTo>
                    <a:pt x="441888" y="2238865"/>
                  </a:lnTo>
                  <a:lnTo>
                    <a:pt x="441690" y="2233019"/>
                  </a:lnTo>
                  <a:lnTo>
                    <a:pt x="441482" y="2227173"/>
                  </a:lnTo>
                  <a:lnTo>
                    <a:pt x="441255" y="2221328"/>
                  </a:lnTo>
                  <a:lnTo>
                    <a:pt x="441013" y="2215482"/>
                  </a:lnTo>
                  <a:lnTo>
                    <a:pt x="440761" y="2209637"/>
                  </a:lnTo>
                  <a:lnTo>
                    <a:pt x="440481" y="2203791"/>
                  </a:lnTo>
                  <a:lnTo>
                    <a:pt x="440188" y="2197945"/>
                  </a:lnTo>
                  <a:lnTo>
                    <a:pt x="439877" y="2192100"/>
                  </a:lnTo>
                  <a:lnTo>
                    <a:pt x="439537" y="2186254"/>
                  </a:lnTo>
                  <a:lnTo>
                    <a:pt x="439181" y="2180409"/>
                  </a:lnTo>
                  <a:lnTo>
                    <a:pt x="438800" y="2174563"/>
                  </a:lnTo>
                  <a:lnTo>
                    <a:pt x="438387" y="2168717"/>
                  </a:lnTo>
                  <a:lnTo>
                    <a:pt x="437957" y="2162872"/>
                  </a:lnTo>
                  <a:lnTo>
                    <a:pt x="437490" y="2157026"/>
                  </a:lnTo>
                  <a:lnTo>
                    <a:pt x="436993" y="2151181"/>
                  </a:lnTo>
                  <a:lnTo>
                    <a:pt x="436473" y="2145335"/>
                  </a:lnTo>
                  <a:lnTo>
                    <a:pt x="435905" y="2139489"/>
                  </a:lnTo>
                  <a:lnTo>
                    <a:pt x="435308" y="2133644"/>
                  </a:lnTo>
                  <a:lnTo>
                    <a:pt x="434682" y="2127798"/>
                  </a:lnTo>
                  <a:lnTo>
                    <a:pt x="433998" y="2121953"/>
                  </a:lnTo>
                  <a:lnTo>
                    <a:pt x="433285" y="2116107"/>
                  </a:lnTo>
                  <a:lnTo>
                    <a:pt x="432532" y="2110261"/>
                  </a:lnTo>
                  <a:lnTo>
                    <a:pt x="431719" y="2104416"/>
                  </a:lnTo>
                  <a:lnTo>
                    <a:pt x="430874" y="2098570"/>
                  </a:lnTo>
                  <a:lnTo>
                    <a:pt x="429974" y="2092725"/>
                  </a:lnTo>
                  <a:lnTo>
                    <a:pt x="429016" y="2086879"/>
                  </a:lnTo>
                  <a:lnTo>
                    <a:pt x="428023" y="2081033"/>
                  </a:lnTo>
                  <a:lnTo>
                    <a:pt x="426956" y="2075188"/>
                  </a:lnTo>
                  <a:lnTo>
                    <a:pt x="425837" y="2069342"/>
                  </a:lnTo>
                  <a:lnTo>
                    <a:pt x="424678" y="2063497"/>
                  </a:lnTo>
                  <a:lnTo>
                    <a:pt x="423428" y="2057651"/>
                  </a:lnTo>
                  <a:lnTo>
                    <a:pt x="422131" y="2051805"/>
                  </a:lnTo>
                  <a:lnTo>
                    <a:pt x="420781" y="2045960"/>
                  </a:lnTo>
                  <a:lnTo>
                    <a:pt x="419338" y="2040114"/>
                  </a:lnTo>
                  <a:lnTo>
                    <a:pt x="417847" y="2034269"/>
                  </a:lnTo>
                  <a:lnTo>
                    <a:pt x="416287" y="2028423"/>
                  </a:lnTo>
                  <a:lnTo>
                    <a:pt x="414640" y="2022577"/>
                  </a:lnTo>
                  <a:lnTo>
                    <a:pt x="412943" y="2016732"/>
                  </a:lnTo>
                  <a:lnTo>
                    <a:pt x="411158" y="2010886"/>
                  </a:lnTo>
                  <a:lnTo>
                    <a:pt x="409294" y="2005041"/>
                  </a:lnTo>
                  <a:lnTo>
                    <a:pt x="407379" y="1999195"/>
                  </a:lnTo>
                  <a:lnTo>
                    <a:pt x="405356" y="1993349"/>
                  </a:lnTo>
                  <a:lnTo>
                    <a:pt x="403266" y="1987504"/>
                  </a:lnTo>
                  <a:lnTo>
                    <a:pt x="401120" y="1981658"/>
                  </a:lnTo>
                  <a:lnTo>
                    <a:pt x="398853" y="1975813"/>
                  </a:lnTo>
                  <a:lnTo>
                    <a:pt x="396529" y="1969967"/>
                  </a:lnTo>
                  <a:lnTo>
                    <a:pt x="394134" y="1964121"/>
                  </a:lnTo>
                  <a:lnTo>
                    <a:pt x="391629" y="1958276"/>
                  </a:lnTo>
                  <a:lnTo>
                    <a:pt x="389068" y="1952430"/>
                  </a:lnTo>
                  <a:lnTo>
                    <a:pt x="386419" y="1946585"/>
                  </a:lnTo>
                  <a:lnTo>
                    <a:pt x="383676" y="1940739"/>
                  </a:lnTo>
                  <a:lnTo>
                    <a:pt x="380877" y="1934893"/>
                  </a:lnTo>
                  <a:lnTo>
                    <a:pt x="377974" y="1929048"/>
                  </a:lnTo>
                  <a:lnTo>
                    <a:pt x="374994" y="1923202"/>
                  </a:lnTo>
                  <a:lnTo>
                    <a:pt x="371960" y="1917357"/>
                  </a:lnTo>
                  <a:lnTo>
                    <a:pt x="368809" y="1911511"/>
                  </a:lnTo>
                  <a:lnTo>
                    <a:pt x="365598" y="1905665"/>
                  </a:lnTo>
                  <a:lnTo>
                    <a:pt x="362326" y="1899820"/>
                  </a:lnTo>
                  <a:lnTo>
                    <a:pt x="358943" y="1893974"/>
                  </a:lnTo>
                  <a:lnTo>
                    <a:pt x="355510" y="1888129"/>
                  </a:lnTo>
                  <a:lnTo>
                    <a:pt x="352005" y="1882283"/>
                  </a:lnTo>
                  <a:lnTo>
                    <a:pt x="348409" y="1876437"/>
                  </a:lnTo>
                  <a:lnTo>
                    <a:pt x="344766" y="1870592"/>
                  </a:lnTo>
                  <a:lnTo>
                    <a:pt x="341043" y="1864746"/>
                  </a:lnTo>
                  <a:lnTo>
                    <a:pt x="337249" y="1858901"/>
                  </a:lnTo>
                  <a:lnTo>
                    <a:pt x="333411" y="1853055"/>
                  </a:lnTo>
                  <a:lnTo>
                    <a:pt x="329489" y="1847209"/>
                  </a:lnTo>
                  <a:lnTo>
                    <a:pt x="325514" y="1841364"/>
                  </a:lnTo>
                  <a:lnTo>
                    <a:pt x="321500" y="1835518"/>
                  </a:lnTo>
                  <a:lnTo>
                    <a:pt x="317401" y="1829673"/>
                  </a:lnTo>
                  <a:lnTo>
                    <a:pt x="313265" y="1823827"/>
                  </a:lnTo>
                  <a:lnTo>
                    <a:pt x="309087" y="1817981"/>
                  </a:lnTo>
                  <a:lnTo>
                    <a:pt x="304843" y="1812136"/>
                  </a:lnTo>
                  <a:lnTo>
                    <a:pt x="300569" y="1806290"/>
                  </a:lnTo>
                  <a:lnTo>
                    <a:pt x="296251" y="1800445"/>
                  </a:lnTo>
                  <a:lnTo>
                    <a:pt x="291886" y="1794599"/>
                  </a:lnTo>
                  <a:lnTo>
                    <a:pt x="287497" y="1788753"/>
                  </a:lnTo>
                  <a:lnTo>
                    <a:pt x="283066" y="1782908"/>
                  </a:lnTo>
                  <a:lnTo>
                    <a:pt x="278605" y="1777062"/>
                  </a:lnTo>
                  <a:lnTo>
                    <a:pt x="274124" y="1771217"/>
                  </a:lnTo>
                  <a:lnTo>
                    <a:pt x="269608" y="1765371"/>
                  </a:lnTo>
                  <a:lnTo>
                    <a:pt x="265075" y="1759525"/>
                  </a:lnTo>
                  <a:lnTo>
                    <a:pt x="260526" y="1753680"/>
                  </a:lnTo>
                  <a:lnTo>
                    <a:pt x="255953" y="1747834"/>
                  </a:lnTo>
                  <a:lnTo>
                    <a:pt x="251372" y="1741989"/>
                  </a:lnTo>
                  <a:lnTo>
                    <a:pt x="246779" y="1736143"/>
                  </a:lnTo>
                  <a:lnTo>
                    <a:pt x="242176" y="1730297"/>
                  </a:lnTo>
                  <a:lnTo>
                    <a:pt x="237570" y="1724452"/>
                  </a:lnTo>
                  <a:lnTo>
                    <a:pt x="232959" y="1718606"/>
                  </a:lnTo>
                  <a:lnTo>
                    <a:pt x="228349" y="1712761"/>
                  </a:lnTo>
                  <a:lnTo>
                    <a:pt x="223740" y="1706915"/>
                  </a:lnTo>
                  <a:lnTo>
                    <a:pt x="219137" y="1701069"/>
                  </a:lnTo>
                  <a:lnTo>
                    <a:pt x="214540" y="1695224"/>
                  </a:lnTo>
                  <a:lnTo>
                    <a:pt x="209949" y="1689378"/>
                  </a:lnTo>
                  <a:lnTo>
                    <a:pt x="205374" y="1683533"/>
                  </a:lnTo>
                  <a:lnTo>
                    <a:pt x="200810" y="1677687"/>
                  </a:lnTo>
                  <a:lnTo>
                    <a:pt x="196258" y="1671841"/>
                  </a:lnTo>
                  <a:lnTo>
                    <a:pt x="191731" y="1665996"/>
                  </a:lnTo>
                  <a:lnTo>
                    <a:pt x="187217" y="1660150"/>
                  </a:lnTo>
                  <a:lnTo>
                    <a:pt x="182723" y="1654305"/>
                  </a:lnTo>
                  <a:lnTo>
                    <a:pt x="178258" y="1648459"/>
                  </a:lnTo>
                  <a:lnTo>
                    <a:pt x="173809" y="1642613"/>
                  </a:lnTo>
                  <a:lnTo>
                    <a:pt x="169390" y="1636768"/>
                  </a:lnTo>
                  <a:lnTo>
                    <a:pt x="165001" y="1630922"/>
                  </a:lnTo>
                  <a:lnTo>
                    <a:pt x="160631" y="1625077"/>
                  </a:lnTo>
                  <a:lnTo>
                    <a:pt x="156302" y="1619231"/>
                  </a:lnTo>
                  <a:lnTo>
                    <a:pt x="152000" y="1613385"/>
                  </a:lnTo>
                  <a:lnTo>
                    <a:pt x="147721" y="1607540"/>
                  </a:lnTo>
                  <a:lnTo>
                    <a:pt x="143493" y="1601694"/>
                  </a:lnTo>
                  <a:lnTo>
                    <a:pt x="139290" y="1595849"/>
                  </a:lnTo>
                  <a:lnTo>
                    <a:pt x="135118" y="1590003"/>
                  </a:lnTo>
                  <a:lnTo>
                    <a:pt x="130997" y="1584157"/>
                  </a:lnTo>
                  <a:lnTo>
                    <a:pt x="126901" y="1578312"/>
                  </a:lnTo>
                  <a:lnTo>
                    <a:pt x="122847" y="1572466"/>
                  </a:lnTo>
                  <a:lnTo>
                    <a:pt x="118840" y="1566621"/>
                  </a:lnTo>
                  <a:lnTo>
                    <a:pt x="114862" y="1560775"/>
                  </a:lnTo>
                  <a:lnTo>
                    <a:pt x="110935" y="1554929"/>
                  </a:lnTo>
                  <a:lnTo>
                    <a:pt x="107052" y="1549084"/>
                  </a:lnTo>
                  <a:lnTo>
                    <a:pt x="103198" y="1543238"/>
                  </a:lnTo>
                  <a:lnTo>
                    <a:pt x="99409" y="1537393"/>
                  </a:lnTo>
                  <a:lnTo>
                    <a:pt x="95658" y="1531547"/>
                  </a:lnTo>
                  <a:lnTo>
                    <a:pt x="91941" y="1525701"/>
                  </a:lnTo>
                  <a:lnTo>
                    <a:pt x="88297" y="1519856"/>
                  </a:lnTo>
                  <a:lnTo>
                    <a:pt x="84687" y="1514010"/>
                  </a:lnTo>
                  <a:lnTo>
                    <a:pt x="81124" y="1508165"/>
                  </a:lnTo>
                  <a:lnTo>
                    <a:pt x="77629" y="1502319"/>
                  </a:lnTo>
                  <a:lnTo>
                    <a:pt x="74170" y="1496473"/>
                  </a:lnTo>
                  <a:lnTo>
                    <a:pt x="70773" y="1490628"/>
                  </a:lnTo>
                  <a:lnTo>
                    <a:pt x="67438" y="1484782"/>
                  </a:lnTo>
                  <a:lnTo>
                    <a:pt x="64143" y="1478937"/>
                  </a:lnTo>
                  <a:lnTo>
                    <a:pt x="60924" y="1473091"/>
                  </a:lnTo>
                  <a:lnTo>
                    <a:pt x="57763" y="1467245"/>
                  </a:lnTo>
                  <a:lnTo>
                    <a:pt x="54644" y="1461400"/>
                  </a:lnTo>
                  <a:lnTo>
                    <a:pt x="51620" y="1455554"/>
                  </a:lnTo>
                  <a:lnTo>
                    <a:pt x="48646" y="1449709"/>
                  </a:lnTo>
                  <a:lnTo>
                    <a:pt x="45727" y="1443863"/>
                  </a:lnTo>
                  <a:lnTo>
                    <a:pt x="42907" y="1438017"/>
                  </a:lnTo>
                  <a:lnTo>
                    <a:pt x="40136" y="1432172"/>
                  </a:lnTo>
                  <a:lnTo>
                    <a:pt x="37438" y="1426326"/>
                  </a:lnTo>
                  <a:lnTo>
                    <a:pt x="34835" y="1420481"/>
                  </a:lnTo>
                  <a:lnTo>
                    <a:pt x="32284" y="1414635"/>
                  </a:lnTo>
                  <a:lnTo>
                    <a:pt x="29828" y="1408789"/>
                  </a:lnTo>
                  <a:lnTo>
                    <a:pt x="27459" y="1402944"/>
                  </a:lnTo>
                  <a:lnTo>
                    <a:pt x="25147" y="1397098"/>
                  </a:lnTo>
                  <a:lnTo>
                    <a:pt x="22953" y="1391252"/>
                  </a:lnTo>
                  <a:lnTo>
                    <a:pt x="20837" y="1385407"/>
                  </a:lnTo>
                  <a:lnTo>
                    <a:pt x="18782" y="1379561"/>
                  </a:lnTo>
                  <a:lnTo>
                    <a:pt x="16872" y="1373716"/>
                  </a:lnTo>
                  <a:lnTo>
                    <a:pt x="15027" y="1367870"/>
                  </a:lnTo>
                  <a:lnTo>
                    <a:pt x="13267" y="1362024"/>
                  </a:lnTo>
                  <a:lnTo>
                    <a:pt x="11642" y="1356179"/>
                  </a:lnTo>
                  <a:lnTo>
                    <a:pt x="10087" y="1350333"/>
                  </a:lnTo>
                  <a:lnTo>
                    <a:pt x="8642" y="1344488"/>
                  </a:lnTo>
                  <a:lnTo>
                    <a:pt x="7321" y="1338642"/>
                  </a:lnTo>
                  <a:lnTo>
                    <a:pt x="6072" y="1332796"/>
                  </a:lnTo>
                  <a:lnTo>
                    <a:pt x="4960" y="1326951"/>
                  </a:lnTo>
                  <a:lnTo>
                    <a:pt x="3958" y="1321105"/>
                  </a:lnTo>
                  <a:lnTo>
                    <a:pt x="3031" y="1315260"/>
                  </a:lnTo>
                  <a:lnTo>
                    <a:pt x="2269" y="1309414"/>
                  </a:lnTo>
                  <a:lnTo>
                    <a:pt x="1598" y="1303568"/>
                  </a:lnTo>
                  <a:lnTo>
                    <a:pt x="1016" y="1297723"/>
                  </a:lnTo>
                  <a:lnTo>
                    <a:pt x="606" y="1291877"/>
                  </a:lnTo>
                  <a:lnTo>
                    <a:pt x="278" y="1286032"/>
                  </a:lnTo>
                  <a:lnTo>
                    <a:pt x="61" y="1280186"/>
                  </a:lnTo>
                  <a:lnTo>
                    <a:pt x="0" y="1274340"/>
                  </a:lnTo>
                  <a:lnTo>
                    <a:pt x="19" y="1268495"/>
                  </a:lnTo>
                  <a:lnTo>
                    <a:pt x="176" y="1262649"/>
                  </a:lnTo>
                  <a:lnTo>
                    <a:pt x="465" y="1256804"/>
                  </a:lnTo>
                  <a:lnTo>
                    <a:pt x="836" y="1250958"/>
                  </a:lnTo>
                  <a:lnTo>
                    <a:pt x="1366" y="1245112"/>
                  </a:lnTo>
                  <a:lnTo>
                    <a:pt x="2004" y="1239267"/>
                  </a:lnTo>
                  <a:lnTo>
                    <a:pt x="2724" y="1233421"/>
                  </a:lnTo>
                  <a:lnTo>
                    <a:pt x="3622" y="1227576"/>
                  </a:lnTo>
                  <a:lnTo>
                    <a:pt x="4605" y="1221730"/>
                  </a:lnTo>
                  <a:lnTo>
                    <a:pt x="5684" y="1215884"/>
                  </a:lnTo>
                  <a:lnTo>
                    <a:pt x="6923" y="1210039"/>
                  </a:lnTo>
                  <a:lnTo>
                    <a:pt x="8239" y="1204193"/>
                  </a:lnTo>
                  <a:lnTo>
                    <a:pt x="9669" y="1198348"/>
                  </a:lnTo>
                  <a:lnTo>
                    <a:pt x="11231" y="1192502"/>
                  </a:lnTo>
                  <a:lnTo>
                    <a:pt x="12866" y="1186656"/>
                  </a:lnTo>
                  <a:lnTo>
                    <a:pt x="14627" y="1180811"/>
                  </a:lnTo>
                  <a:lnTo>
                    <a:pt x="16493" y="1174965"/>
                  </a:lnTo>
                  <a:lnTo>
                    <a:pt x="18428" y="1169120"/>
                  </a:lnTo>
                  <a:lnTo>
                    <a:pt x="20497" y="1163274"/>
                  </a:lnTo>
                  <a:lnTo>
                    <a:pt x="22645" y="1157428"/>
                  </a:lnTo>
                  <a:lnTo>
                    <a:pt x="24858" y="1151583"/>
                  </a:lnTo>
                  <a:lnTo>
                    <a:pt x="27205" y="1145737"/>
                  </a:lnTo>
                  <a:lnTo>
                    <a:pt x="29609" y="1139892"/>
                  </a:lnTo>
                  <a:lnTo>
                    <a:pt x="32086" y="1134046"/>
                  </a:lnTo>
                  <a:lnTo>
                    <a:pt x="34667" y="1128200"/>
                  </a:lnTo>
                  <a:lnTo>
                    <a:pt x="37298" y="1122355"/>
                  </a:lnTo>
                  <a:lnTo>
                    <a:pt x="40006" y="1116509"/>
                  </a:lnTo>
                  <a:lnTo>
                    <a:pt x="42790" y="1110664"/>
                  </a:lnTo>
                  <a:lnTo>
                    <a:pt x="45617" y="1104818"/>
                  </a:lnTo>
                  <a:lnTo>
                    <a:pt x="48520" y="1098972"/>
                  </a:lnTo>
                  <a:lnTo>
                    <a:pt x="51475" y="1093127"/>
                  </a:lnTo>
                  <a:lnTo>
                    <a:pt x="54467" y="1087281"/>
                  </a:lnTo>
                  <a:lnTo>
                    <a:pt x="57528" y="1081436"/>
                  </a:lnTo>
                  <a:lnTo>
                    <a:pt x="60621" y="1075590"/>
                  </a:lnTo>
                  <a:lnTo>
                    <a:pt x="63747" y="1069744"/>
                  </a:lnTo>
                  <a:lnTo>
                    <a:pt x="66925" y="1063899"/>
                  </a:lnTo>
                  <a:lnTo>
                    <a:pt x="70123" y="1058053"/>
                  </a:lnTo>
                  <a:lnTo>
                    <a:pt x="73350" y="1052208"/>
                  </a:lnTo>
                  <a:lnTo>
                    <a:pt x="76608" y="1046362"/>
                  </a:lnTo>
                  <a:lnTo>
                    <a:pt x="79879" y="1040516"/>
                  </a:lnTo>
                  <a:lnTo>
                    <a:pt x="83172" y="1034671"/>
                  </a:lnTo>
                  <a:lnTo>
                    <a:pt x="86477" y="1028825"/>
                  </a:lnTo>
                  <a:lnTo>
                    <a:pt x="89790" y="1022980"/>
                  </a:lnTo>
                  <a:lnTo>
                    <a:pt x="93113" y="1017134"/>
                  </a:lnTo>
                  <a:lnTo>
                    <a:pt x="96437" y="1011288"/>
                  </a:lnTo>
                  <a:lnTo>
                    <a:pt x="99763" y="1005443"/>
                  </a:lnTo>
                  <a:lnTo>
                    <a:pt x="103084" y="999597"/>
                  </a:lnTo>
                  <a:lnTo>
                    <a:pt x="106399" y="993752"/>
                  </a:lnTo>
                  <a:lnTo>
                    <a:pt x="109708" y="987906"/>
                  </a:lnTo>
                  <a:lnTo>
                    <a:pt x="112999" y="982060"/>
                  </a:lnTo>
                  <a:lnTo>
                    <a:pt x="116280" y="976215"/>
                  </a:lnTo>
                  <a:lnTo>
                    <a:pt x="119545" y="970369"/>
                  </a:lnTo>
                  <a:lnTo>
                    <a:pt x="122785" y="964524"/>
                  </a:lnTo>
                  <a:lnTo>
                    <a:pt x="126010" y="958678"/>
                  </a:lnTo>
                  <a:lnTo>
                    <a:pt x="129206" y="952832"/>
                  </a:lnTo>
                  <a:lnTo>
                    <a:pt x="132374" y="946987"/>
                  </a:lnTo>
                  <a:lnTo>
                    <a:pt x="135524" y="941141"/>
                  </a:lnTo>
                  <a:lnTo>
                    <a:pt x="138631" y="935296"/>
                  </a:lnTo>
                  <a:lnTo>
                    <a:pt x="141711" y="929450"/>
                  </a:lnTo>
                  <a:lnTo>
                    <a:pt x="144768" y="923604"/>
                  </a:lnTo>
                  <a:lnTo>
                    <a:pt x="147772" y="917759"/>
                  </a:lnTo>
                  <a:lnTo>
                    <a:pt x="150751" y="911913"/>
                  </a:lnTo>
                  <a:lnTo>
                    <a:pt x="153695" y="906068"/>
                  </a:lnTo>
                  <a:lnTo>
                    <a:pt x="156589" y="900222"/>
                  </a:lnTo>
                  <a:lnTo>
                    <a:pt x="159455" y="894376"/>
                  </a:lnTo>
                  <a:lnTo>
                    <a:pt x="162277" y="888531"/>
                  </a:lnTo>
                  <a:lnTo>
                    <a:pt x="165052" y="882685"/>
                  </a:lnTo>
                  <a:lnTo>
                    <a:pt x="167798" y="876840"/>
                  </a:lnTo>
                  <a:lnTo>
                    <a:pt x="170490" y="870994"/>
                  </a:lnTo>
                  <a:lnTo>
                    <a:pt x="173141" y="865148"/>
                  </a:lnTo>
                  <a:lnTo>
                    <a:pt x="175762" y="859303"/>
                  </a:lnTo>
                  <a:lnTo>
                    <a:pt x="178319" y="853457"/>
                  </a:lnTo>
                  <a:lnTo>
                    <a:pt x="180843" y="847612"/>
                  </a:lnTo>
                  <a:lnTo>
                    <a:pt x="183333" y="841766"/>
                  </a:lnTo>
                  <a:lnTo>
                    <a:pt x="185759" y="835920"/>
                  </a:lnTo>
                  <a:lnTo>
                    <a:pt x="188155" y="830075"/>
                  </a:lnTo>
                  <a:lnTo>
                    <a:pt x="190509" y="824229"/>
                  </a:lnTo>
                  <a:lnTo>
                    <a:pt x="192808" y="818384"/>
                  </a:lnTo>
                  <a:lnTo>
                    <a:pt x="195079" y="812538"/>
                  </a:lnTo>
                  <a:lnTo>
                    <a:pt x="197300" y="806692"/>
                  </a:lnTo>
                  <a:lnTo>
                    <a:pt x="199476" y="800847"/>
                  </a:lnTo>
                  <a:lnTo>
                    <a:pt x="201624" y="795001"/>
                  </a:lnTo>
                  <a:lnTo>
                    <a:pt x="203717" y="789156"/>
                  </a:lnTo>
                  <a:lnTo>
                    <a:pt x="205776" y="783310"/>
                  </a:lnTo>
                  <a:lnTo>
                    <a:pt x="207807" y="777464"/>
                  </a:lnTo>
                  <a:lnTo>
                    <a:pt x="209779" y="771619"/>
                  </a:lnTo>
                  <a:lnTo>
                    <a:pt x="211726" y="765773"/>
                  </a:lnTo>
                  <a:lnTo>
                    <a:pt x="213640" y="759928"/>
                  </a:lnTo>
                  <a:lnTo>
                    <a:pt x="215507" y="754082"/>
                  </a:lnTo>
                  <a:lnTo>
                    <a:pt x="217350" y="748236"/>
                  </a:lnTo>
                  <a:lnTo>
                    <a:pt x="219158" y="742391"/>
                  </a:lnTo>
                  <a:lnTo>
                    <a:pt x="220928" y="736545"/>
                  </a:lnTo>
                  <a:lnTo>
                    <a:pt x="222677" y="730700"/>
                  </a:lnTo>
                  <a:lnTo>
                    <a:pt x="224389" y="724854"/>
                  </a:lnTo>
                  <a:lnTo>
                    <a:pt x="226073" y="719008"/>
                  </a:lnTo>
                  <a:lnTo>
                    <a:pt x="227738" y="713163"/>
                  </a:lnTo>
                  <a:lnTo>
                    <a:pt x="229367" y="707317"/>
                  </a:lnTo>
                  <a:lnTo>
                    <a:pt x="230976" y="701472"/>
                  </a:lnTo>
                  <a:lnTo>
                    <a:pt x="232568" y="695626"/>
                  </a:lnTo>
                  <a:lnTo>
                    <a:pt x="234128" y="689780"/>
                  </a:lnTo>
                  <a:lnTo>
                    <a:pt x="235676" y="683935"/>
                  </a:lnTo>
                  <a:lnTo>
                    <a:pt x="237205" y="678089"/>
                  </a:lnTo>
                  <a:lnTo>
                    <a:pt x="238713" y="672244"/>
                  </a:lnTo>
                  <a:lnTo>
                    <a:pt x="240210" y="666398"/>
                  </a:lnTo>
                  <a:lnTo>
                    <a:pt x="241692" y="660552"/>
                  </a:lnTo>
                  <a:lnTo>
                    <a:pt x="243160" y="654707"/>
                  </a:lnTo>
                  <a:lnTo>
                    <a:pt x="244621" y="648861"/>
                  </a:lnTo>
                  <a:lnTo>
                    <a:pt x="246070" y="643016"/>
                  </a:lnTo>
                  <a:lnTo>
                    <a:pt x="247513" y="637170"/>
                  </a:lnTo>
                  <a:lnTo>
                    <a:pt x="248951" y="631324"/>
                  </a:lnTo>
                  <a:lnTo>
                    <a:pt x="250383" y="625479"/>
                  </a:lnTo>
                  <a:lnTo>
                    <a:pt x="251813" y="619633"/>
                  </a:lnTo>
                  <a:lnTo>
                    <a:pt x="253241" y="613788"/>
                  </a:lnTo>
                  <a:lnTo>
                    <a:pt x="254671" y="607942"/>
                  </a:lnTo>
                  <a:lnTo>
                    <a:pt x="256101" y="602096"/>
                  </a:lnTo>
                  <a:lnTo>
                    <a:pt x="257535" y="596251"/>
                  </a:lnTo>
                  <a:lnTo>
                    <a:pt x="258974" y="590405"/>
                  </a:lnTo>
                  <a:lnTo>
                    <a:pt x="260418" y="584560"/>
                  </a:lnTo>
                  <a:lnTo>
                    <a:pt x="261869" y="578714"/>
                  </a:lnTo>
                  <a:lnTo>
                    <a:pt x="263331" y="572868"/>
                  </a:lnTo>
                  <a:lnTo>
                    <a:pt x="264799" y="567023"/>
                  </a:lnTo>
                  <a:lnTo>
                    <a:pt x="266281" y="561177"/>
                  </a:lnTo>
                  <a:lnTo>
                    <a:pt x="267775" y="555332"/>
                  </a:lnTo>
                  <a:lnTo>
                    <a:pt x="269277" y="549486"/>
                  </a:lnTo>
                  <a:lnTo>
                    <a:pt x="270801" y="543640"/>
                  </a:lnTo>
                  <a:lnTo>
                    <a:pt x="272336" y="537795"/>
                  </a:lnTo>
                  <a:lnTo>
                    <a:pt x="273884" y="531949"/>
                  </a:lnTo>
                  <a:lnTo>
                    <a:pt x="275455" y="526104"/>
                  </a:lnTo>
                  <a:lnTo>
                    <a:pt x="277038" y="520258"/>
                  </a:lnTo>
                  <a:lnTo>
                    <a:pt x="278639" y="514412"/>
                  </a:lnTo>
                  <a:lnTo>
                    <a:pt x="280262" y="508567"/>
                  </a:lnTo>
                  <a:lnTo>
                    <a:pt x="281898" y="502721"/>
                  </a:lnTo>
                  <a:lnTo>
                    <a:pt x="283557" y="496876"/>
                  </a:lnTo>
                  <a:lnTo>
                    <a:pt x="285236" y="491030"/>
                  </a:lnTo>
                  <a:lnTo>
                    <a:pt x="286927" y="485184"/>
                  </a:lnTo>
                  <a:lnTo>
                    <a:pt x="288647" y="479339"/>
                  </a:lnTo>
                  <a:lnTo>
                    <a:pt x="290381" y="473493"/>
                  </a:lnTo>
                  <a:lnTo>
                    <a:pt x="292130" y="467648"/>
                  </a:lnTo>
                  <a:lnTo>
                    <a:pt x="293907" y="461802"/>
                  </a:lnTo>
                  <a:lnTo>
                    <a:pt x="295696" y="455956"/>
                  </a:lnTo>
                  <a:lnTo>
                    <a:pt x="297503" y="450111"/>
                  </a:lnTo>
                  <a:lnTo>
                    <a:pt x="299331" y="444265"/>
                  </a:lnTo>
                  <a:lnTo>
                    <a:pt x="301172" y="438420"/>
                  </a:lnTo>
                  <a:lnTo>
                    <a:pt x="303030" y="432574"/>
                  </a:lnTo>
                  <a:lnTo>
                    <a:pt x="304906" y="426728"/>
                  </a:lnTo>
                  <a:lnTo>
                    <a:pt x="306791" y="420883"/>
                  </a:lnTo>
                  <a:lnTo>
                    <a:pt x="308694" y="415037"/>
                  </a:lnTo>
                  <a:lnTo>
                    <a:pt x="310609" y="409192"/>
                  </a:lnTo>
                  <a:lnTo>
                    <a:pt x="312531" y="403346"/>
                  </a:lnTo>
                  <a:lnTo>
                    <a:pt x="314470" y="397500"/>
                  </a:lnTo>
                  <a:lnTo>
                    <a:pt x="316414" y="391655"/>
                  </a:lnTo>
                  <a:lnTo>
                    <a:pt x="318366" y="385809"/>
                  </a:lnTo>
                  <a:lnTo>
                    <a:pt x="320327" y="379964"/>
                  </a:lnTo>
                  <a:lnTo>
                    <a:pt x="322291" y="374118"/>
                  </a:lnTo>
                  <a:lnTo>
                    <a:pt x="324260" y="368272"/>
                  </a:lnTo>
                  <a:lnTo>
                    <a:pt x="326231" y="362427"/>
                  </a:lnTo>
                  <a:lnTo>
                    <a:pt x="328204" y="356581"/>
                  </a:lnTo>
                  <a:lnTo>
                    <a:pt x="330177" y="350736"/>
                  </a:lnTo>
                  <a:lnTo>
                    <a:pt x="332148" y="344890"/>
                  </a:lnTo>
                  <a:lnTo>
                    <a:pt x="334117" y="339044"/>
                  </a:lnTo>
                  <a:lnTo>
                    <a:pt x="336081" y="333199"/>
                  </a:lnTo>
                  <a:lnTo>
                    <a:pt x="338039" y="327353"/>
                  </a:lnTo>
                  <a:lnTo>
                    <a:pt x="339993" y="321508"/>
                  </a:lnTo>
                  <a:lnTo>
                    <a:pt x="341935" y="315662"/>
                  </a:lnTo>
                  <a:lnTo>
                    <a:pt x="343869" y="309816"/>
                  </a:lnTo>
                  <a:lnTo>
                    <a:pt x="345794" y="303971"/>
                  </a:lnTo>
                  <a:lnTo>
                    <a:pt x="347703" y="298125"/>
                  </a:lnTo>
                  <a:lnTo>
                    <a:pt x="349603" y="292280"/>
                  </a:lnTo>
                  <a:lnTo>
                    <a:pt x="351488" y="286434"/>
                  </a:lnTo>
                  <a:lnTo>
                    <a:pt x="353355" y="280588"/>
                  </a:lnTo>
                  <a:lnTo>
                    <a:pt x="355211" y="274743"/>
                  </a:lnTo>
                  <a:lnTo>
                    <a:pt x="357045" y="268897"/>
                  </a:lnTo>
                  <a:lnTo>
                    <a:pt x="358861" y="263052"/>
                  </a:lnTo>
                  <a:lnTo>
                    <a:pt x="360665" y="257206"/>
                  </a:lnTo>
                  <a:lnTo>
                    <a:pt x="362440" y="251360"/>
                  </a:lnTo>
                  <a:lnTo>
                    <a:pt x="364199" y="245515"/>
                  </a:lnTo>
                  <a:lnTo>
                    <a:pt x="365942" y="239669"/>
                  </a:lnTo>
                  <a:lnTo>
                    <a:pt x="367654" y="233824"/>
                  </a:lnTo>
                  <a:lnTo>
                    <a:pt x="369351" y="227978"/>
                  </a:lnTo>
                  <a:lnTo>
                    <a:pt x="371027" y="222132"/>
                  </a:lnTo>
                  <a:lnTo>
                    <a:pt x="372674" y="216287"/>
                  </a:lnTo>
                  <a:lnTo>
                    <a:pt x="374306" y="210441"/>
                  </a:lnTo>
                  <a:lnTo>
                    <a:pt x="375912" y="204596"/>
                  </a:lnTo>
                  <a:lnTo>
                    <a:pt x="377493" y="198750"/>
                  </a:lnTo>
                  <a:lnTo>
                    <a:pt x="379058" y="192904"/>
                  </a:lnTo>
                  <a:lnTo>
                    <a:pt x="380594" y="187059"/>
                  </a:lnTo>
                  <a:lnTo>
                    <a:pt x="382109" y="181213"/>
                  </a:lnTo>
                  <a:lnTo>
                    <a:pt x="383609" y="175368"/>
                  </a:lnTo>
                  <a:lnTo>
                    <a:pt x="385076" y="169522"/>
                  </a:lnTo>
                  <a:lnTo>
                    <a:pt x="386527" y="163676"/>
                  </a:lnTo>
                  <a:lnTo>
                    <a:pt x="387960" y="157831"/>
                  </a:lnTo>
                  <a:lnTo>
                    <a:pt x="389365" y="151985"/>
                  </a:lnTo>
                  <a:lnTo>
                    <a:pt x="390756" y="146140"/>
                  </a:lnTo>
                  <a:lnTo>
                    <a:pt x="392127" y="140294"/>
                  </a:lnTo>
                  <a:lnTo>
                    <a:pt x="393474" y="134448"/>
                  </a:lnTo>
                  <a:lnTo>
                    <a:pt x="394809" y="128603"/>
                  </a:lnTo>
                  <a:lnTo>
                    <a:pt x="396123" y="122757"/>
                  </a:lnTo>
                  <a:lnTo>
                    <a:pt x="397419" y="116912"/>
                  </a:lnTo>
                  <a:lnTo>
                    <a:pt x="398703" y="111066"/>
                  </a:lnTo>
                  <a:lnTo>
                    <a:pt x="399965" y="105220"/>
                  </a:lnTo>
                  <a:lnTo>
                    <a:pt x="401216" y="99375"/>
                  </a:lnTo>
                  <a:lnTo>
                    <a:pt x="402455" y="93529"/>
                  </a:lnTo>
                  <a:lnTo>
                    <a:pt x="403674" y="87684"/>
                  </a:lnTo>
                  <a:lnTo>
                    <a:pt x="404884" y="81838"/>
                  </a:lnTo>
                  <a:lnTo>
                    <a:pt x="406083" y="75992"/>
                  </a:lnTo>
                  <a:lnTo>
                    <a:pt x="407267" y="70147"/>
                  </a:lnTo>
                  <a:lnTo>
                    <a:pt x="408443" y="64301"/>
                  </a:lnTo>
                  <a:lnTo>
                    <a:pt x="409608" y="58456"/>
                  </a:lnTo>
                  <a:lnTo>
                    <a:pt x="410763" y="52610"/>
                  </a:lnTo>
                  <a:lnTo>
                    <a:pt x="411911" y="46764"/>
                  </a:lnTo>
                  <a:lnTo>
                    <a:pt x="413049" y="40919"/>
                  </a:lnTo>
                  <a:lnTo>
                    <a:pt x="414179" y="35073"/>
                  </a:lnTo>
                  <a:lnTo>
                    <a:pt x="415304" y="29228"/>
                  </a:lnTo>
                  <a:lnTo>
                    <a:pt x="416419" y="23382"/>
                  </a:lnTo>
                  <a:lnTo>
                    <a:pt x="417530" y="17536"/>
                  </a:lnTo>
                  <a:lnTo>
                    <a:pt x="418635" y="11691"/>
                  </a:lnTo>
                  <a:lnTo>
                    <a:pt x="419733" y="5845"/>
                  </a:lnTo>
                  <a:lnTo>
                    <a:pt x="420827" y="0"/>
                  </a:lnTo>
                  <a:lnTo>
                    <a:pt x="536701" y="0"/>
                  </a:lnTo>
                  <a:lnTo>
                    <a:pt x="537795" y="5845"/>
                  </a:lnTo>
                  <a:lnTo>
                    <a:pt x="538892" y="11691"/>
                  </a:lnTo>
                  <a:lnTo>
                    <a:pt x="539998" y="17536"/>
                  </a:lnTo>
                  <a:lnTo>
                    <a:pt x="541108" y="23382"/>
                  </a:lnTo>
                  <a:lnTo>
                    <a:pt x="542223" y="29228"/>
                  </a:lnTo>
                  <a:lnTo>
                    <a:pt x="543349" y="35073"/>
                  </a:lnTo>
                  <a:lnTo>
                    <a:pt x="544479" y="40919"/>
                  </a:lnTo>
                  <a:lnTo>
                    <a:pt x="545616" y="46764"/>
                  </a:lnTo>
                  <a:lnTo>
                    <a:pt x="546765" y="52610"/>
                  </a:lnTo>
                  <a:lnTo>
                    <a:pt x="547919" y="58456"/>
                  </a:lnTo>
                  <a:lnTo>
                    <a:pt x="549084" y="64301"/>
                  </a:lnTo>
                  <a:lnTo>
                    <a:pt x="550261" y="70147"/>
                  </a:lnTo>
                  <a:lnTo>
                    <a:pt x="551444" y="75992"/>
                  </a:lnTo>
                  <a:lnTo>
                    <a:pt x="552643" y="81838"/>
                  </a:lnTo>
                  <a:lnTo>
                    <a:pt x="553854" y="87684"/>
                  </a:lnTo>
                  <a:lnTo>
                    <a:pt x="555072" y="93529"/>
                  </a:lnTo>
                  <a:lnTo>
                    <a:pt x="556312" y="99375"/>
                  </a:lnTo>
                  <a:lnTo>
                    <a:pt x="557562" y="105220"/>
                  </a:lnTo>
                  <a:lnTo>
                    <a:pt x="558824" y="111066"/>
                  </a:lnTo>
                  <a:lnTo>
                    <a:pt x="560109" y="116912"/>
                  </a:lnTo>
                  <a:lnTo>
                    <a:pt x="561405" y="122757"/>
                  </a:lnTo>
                  <a:lnTo>
                    <a:pt x="562718" y="128603"/>
                  </a:lnTo>
                  <a:lnTo>
                    <a:pt x="564053" y="134448"/>
                  </a:lnTo>
                  <a:lnTo>
                    <a:pt x="565401" y="140294"/>
                  </a:lnTo>
                  <a:lnTo>
                    <a:pt x="566771" y="146140"/>
                  </a:lnTo>
                  <a:lnTo>
                    <a:pt x="568162" y="151985"/>
                  </a:lnTo>
                  <a:lnTo>
                    <a:pt x="569567" y="157831"/>
                  </a:lnTo>
                  <a:lnTo>
                    <a:pt x="571000" y="163676"/>
                  </a:lnTo>
                  <a:lnTo>
                    <a:pt x="572452" y="169522"/>
                  </a:lnTo>
                  <a:lnTo>
                    <a:pt x="573918" y="175368"/>
                  </a:lnTo>
                  <a:lnTo>
                    <a:pt x="575418" y="181213"/>
                  </a:lnTo>
                  <a:lnTo>
                    <a:pt x="576934" y="187059"/>
                  </a:lnTo>
                  <a:lnTo>
                    <a:pt x="578469" y="192904"/>
                  </a:lnTo>
                  <a:lnTo>
                    <a:pt x="580035" y="198750"/>
                  </a:lnTo>
                  <a:lnTo>
                    <a:pt x="581616" y="204596"/>
                  </a:lnTo>
                  <a:lnTo>
                    <a:pt x="583222" y="210441"/>
                  </a:lnTo>
                  <a:lnTo>
                    <a:pt x="584854" y="216287"/>
                  </a:lnTo>
                  <a:lnTo>
                    <a:pt x="586501" y="222132"/>
                  </a:lnTo>
                  <a:lnTo>
                    <a:pt x="588177" y="227978"/>
                  </a:lnTo>
                  <a:lnTo>
                    <a:pt x="589874" y="233824"/>
                  </a:lnTo>
                  <a:lnTo>
                    <a:pt x="591586" y="239669"/>
                  </a:lnTo>
                  <a:lnTo>
                    <a:pt x="593329" y="245515"/>
                  </a:lnTo>
                  <a:lnTo>
                    <a:pt x="595088" y="251360"/>
                  </a:lnTo>
                  <a:lnTo>
                    <a:pt x="596863" y="257206"/>
                  </a:lnTo>
                  <a:lnTo>
                    <a:pt x="598667" y="263052"/>
                  </a:lnTo>
                  <a:lnTo>
                    <a:pt x="600483" y="268897"/>
                  </a:lnTo>
                  <a:lnTo>
                    <a:pt x="602317" y="274743"/>
                  </a:lnTo>
                  <a:lnTo>
                    <a:pt x="604173" y="280588"/>
                  </a:lnTo>
                  <a:lnTo>
                    <a:pt x="606040" y="286434"/>
                  </a:lnTo>
                  <a:lnTo>
                    <a:pt x="607924" y="292280"/>
                  </a:lnTo>
                  <a:lnTo>
                    <a:pt x="609824" y="298125"/>
                  </a:lnTo>
                  <a:lnTo>
                    <a:pt x="611733" y="303971"/>
                  </a:lnTo>
                  <a:lnTo>
                    <a:pt x="613658" y="309816"/>
                  </a:lnTo>
                  <a:lnTo>
                    <a:pt x="615593" y="315662"/>
                  </a:lnTo>
                  <a:lnTo>
                    <a:pt x="617534" y="321508"/>
                  </a:lnTo>
                  <a:lnTo>
                    <a:pt x="619488" y="327353"/>
                  </a:lnTo>
                  <a:lnTo>
                    <a:pt x="621447" y="333199"/>
                  </a:lnTo>
                  <a:lnTo>
                    <a:pt x="623410" y="339044"/>
                  </a:lnTo>
                  <a:lnTo>
                    <a:pt x="625380" y="344890"/>
                  </a:lnTo>
                  <a:lnTo>
                    <a:pt x="627350" y="350736"/>
                  </a:lnTo>
                  <a:lnTo>
                    <a:pt x="629323" y="356581"/>
                  </a:lnTo>
                  <a:lnTo>
                    <a:pt x="631296" y="362427"/>
                  </a:lnTo>
                  <a:lnTo>
                    <a:pt x="633268" y="368272"/>
                  </a:lnTo>
                  <a:lnTo>
                    <a:pt x="635237" y="374118"/>
                  </a:lnTo>
                  <a:lnTo>
                    <a:pt x="637201" y="379964"/>
                  </a:lnTo>
                  <a:lnTo>
                    <a:pt x="639162" y="385809"/>
                  </a:lnTo>
                  <a:lnTo>
                    <a:pt x="641113" y="391655"/>
                  </a:lnTo>
                  <a:lnTo>
                    <a:pt x="643058" y="397500"/>
                  </a:lnTo>
                  <a:lnTo>
                    <a:pt x="644996" y="403346"/>
                  </a:lnTo>
                  <a:lnTo>
                    <a:pt x="646919" y="409192"/>
                  </a:lnTo>
                  <a:lnTo>
                    <a:pt x="648833" y="415037"/>
                  </a:lnTo>
                  <a:lnTo>
                    <a:pt x="650736" y="420883"/>
                  </a:lnTo>
                  <a:lnTo>
                    <a:pt x="652622" y="426728"/>
                  </a:lnTo>
                  <a:lnTo>
                    <a:pt x="654497" y="432574"/>
                  </a:lnTo>
                  <a:lnTo>
                    <a:pt x="656356" y="438420"/>
                  </a:lnTo>
                  <a:lnTo>
                    <a:pt x="658196" y="444265"/>
                  </a:lnTo>
                  <a:lnTo>
                    <a:pt x="660025" y="450111"/>
                  </a:lnTo>
                  <a:lnTo>
                    <a:pt x="661831" y="455956"/>
                  </a:lnTo>
                  <a:lnTo>
                    <a:pt x="663621" y="461802"/>
                  </a:lnTo>
                  <a:lnTo>
                    <a:pt x="665397" y="467648"/>
                  </a:lnTo>
                  <a:lnTo>
                    <a:pt x="667146" y="473493"/>
                  </a:lnTo>
                  <a:lnTo>
                    <a:pt x="668881" y="479339"/>
                  </a:lnTo>
                  <a:lnTo>
                    <a:pt x="670600" y="485184"/>
                  </a:lnTo>
                  <a:lnTo>
                    <a:pt x="672292" y="491030"/>
                  </a:lnTo>
                  <a:lnTo>
                    <a:pt x="673970" y="496876"/>
                  </a:lnTo>
                  <a:lnTo>
                    <a:pt x="675629" y="502721"/>
                  </a:lnTo>
                  <a:lnTo>
                    <a:pt x="677265" y="508567"/>
                  </a:lnTo>
                  <a:lnTo>
                    <a:pt x="678888" y="514412"/>
                  </a:lnTo>
                  <a:lnTo>
                    <a:pt x="680490" y="520258"/>
                  </a:lnTo>
                  <a:lnTo>
                    <a:pt x="682072" y="526104"/>
                  </a:lnTo>
                  <a:lnTo>
                    <a:pt x="683643" y="531949"/>
                  </a:lnTo>
                  <a:lnTo>
                    <a:pt x="685192" y="537795"/>
                  </a:lnTo>
                  <a:lnTo>
                    <a:pt x="686726" y="543640"/>
                  </a:lnTo>
                  <a:lnTo>
                    <a:pt x="688250" y="549486"/>
                  </a:lnTo>
                  <a:lnTo>
                    <a:pt x="689753" y="555332"/>
                  </a:lnTo>
                  <a:lnTo>
                    <a:pt x="691246" y="561177"/>
                  </a:lnTo>
                  <a:lnTo>
                    <a:pt x="692729" y="567023"/>
                  </a:lnTo>
                  <a:lnTo>
                    <a:pt x="694197" y="572868"/>
                  </a:lnTo>
                  <a:lnTo>
                    <a:pt x="695658" y="578714"/>
                  </a:lnTo>
                  <a:lnTo>
                    <a:pt x="697110" y="584560"/>
                  </a:lnTo>
                  <a:lnTo>
                    <a:pt x="698553" y="590405"/>
                  </a:lnTo>
                  <a:lnTo>
                    <a:pt x="699993" y="596251"/>
                  </a:lnTo>
                  <a:lnTo>
                    <a:pt x="701426" y="602096"/>
                  </a:lnTo>
                  <a:lnTo>
                    <a:pt x="702857" y="607942"/>
                  </a:lnTo>
                  <a:lnTo>
                    <a:pt x="704286" y="613788"/>
                  </a:lnTo>
                  <a:lnTo>
                    <a:pt x="705715" y="619633"/>
                  </a:lnTo>
                  <a:lnTo>
                    <a:pt x="707145" y="625479"/>
                  </a:lnTo>
                  <a:lnTo>
                    <a:pt x="708576" y="631324"/>
                  </a:lnTo>
                  <a:lnTo>
                    <a:pt x="710014" y="637170"/>
                  </a:lnTo>
                  <a:lnTo>
                    <a:pt x="711457" y="643016"/>
                  </a:lnTo>
                  <a:lnTo>
                    <a:pt x="712906" y="648861"/>
                  </a:lnTo>
                  <a:lnTo>
                    <a:pt x="714367" y="654707"/>
                  </a:lnTo>
                  <a:lnTo>
                    <a:pt x="715836" y="660552"/>
                  </a:lnTo>
                  <a:lnTo>
                    <a:pt x="717317" y="666398"/>
                  </a:lnTo>
                  <a:lnTo>
                    <a:pt x="718815" y="672244"/>
                  </a:lnTo>
                  <a:lnTo>
                    <a:pt x="720322" y="678089"/>
                  </a:lnTo>
                  <a:lnTo>
                    <a:pt x="721852" y="683935"/>
                  </a:lnTo>
                  <a:lnTo>
                    <a:pt x="723399" y="689780"/>
                  </a:lnTo>
                  <a:lnTo>
                    <a:pt x="724959" y="695626"/>
                  </a:lnTo>
                  <a:lnTo>
                    <a:pt x="726551" y="701472"/>
                  </a:lnTo>
                  <a:lnTo>
                    <a:pt x="728161" y="707317"/>
                  </a:lnTo>
                  <a:lnTo>
                    <a:pt x="729789" y="713163"/>
                  </a:lnTo>
                  <a:lnTo>
                    <a:pt x="731455" y="719008"/>
                  </a:lnTo>
                  <a:lnTo>
                    <a:pt x="733139" y="724854"/>
                  </a:lnTo>
                  <a:lnTo>
                    <a:pt x="734851" y="730700"/>
                  </a:lnTo>
                  <a:lnTo>
                    <a:pt x="736600" y="736545"/>
                  </a:lnTo>
                  <a:lnTo>
                    <a:pt x="738370" y="742391"/>
                  </a:lnTo>
                  <a:lnTo>
                    <a:pt x="740178" y="748236"/>
                  </a:lnTo>
                  <a:lnTo>
                    <a:pt x="742021" y="754082"/>
                  </a:lnTo>
                  <a:lnTo>
                    <a:pt x="743887" y="759928"/>
                  </a:lnTo>
                  <a:lnTo>
                    <a:pt x="745802" y="765773"/>
                  </a:lnTo>
                  <a:lnTo>
                    <a:pt x="747749" y="771619"/>
                  </a:lnTo>
                  <a:lnTo>
                    <a:pt x="749721" y="777464"/>
                  </a:lnTo>
                  <a:lnTo>
                    <a:pt x="751752" y="783310"/>
                  </a:lnTo>
                  <a:lnTo>
                    <a:pt x="753810" y="789156"/>
                  </a:lnTo>
                  <a:lnTo>
                    <a:pt x="755903" y="795001"/>
                  </a:lnTo>
                  <a:lnTo>
                    <a:pt x="758051" y="800847"/>
                  </a:lnTo>
                  <a:lnTo>
                    <a:pt x="760228" y="806692"/>
                  </a:lnTo>
                  <a:lnTo>
                    <a:pt x="762448" y="812538"/>
                  </a:lnTo>
                  <a:lnTo>
                    <a:pt x="764719" y="818384"/>
                  </a:lnTo>
                  <a:lnTo>
                    <a:pt x="767019" y="824229"/>
                  </a:lnTo>
                  <a:lnTo>
                    <a:pt x="769372" y="830075"/>
                  </a:lnTo>
                  <a:lnTo>
                    <a:pt x="771769" y="835920"/>
                  </a:lnTo>
                  <a:lnTo>
                    <a:pt x="774195" y="841766"/>
                  </a:lnTo>
                  <a:lnTo>
                    <a:pt x="776684" y="847612"/>
                  </a:lnTo>
                  <a:lnTo>
                    <a:pt x="779208" y="853457"/>
                  </a:lnTo>
                  <a:lnTo>
                    <a:pt x="781765" y="859303"/>
                  </a:lnTo>
                  <a:lnTo>
                    <a:pt x="784386" y="865148"/>
                  </a:lnTo>
                  <a:lnTo>
                    <a:pt x="787037" y="870994"/>
                  </a:lnTo>
                  <a:lnTo>
                    <a:pt x="789729" y="876840"/>
                  </a:lnTo>
                  <a:lnTo>
                    <a:pt x="792475" y="882685"/>
                  </a:lnTo>
                  <a:lnTo>
                    <a:pt x="795250" y="888531"/>
                  </a:lnTo>
                  <a:lnTo>
                    <a:pt x="798072" y="894376"/>
                  </a:lnTo>
                  <a:lnTo>
                    <a:pt x="800939" y="900222"/>
                  </a:lnTo>
                  <a:lnTo>
                    <a:pt x="803832" y="906068"/>
                  </a:lnTo>
                  <a:lnTo>
                    <a:pt x="806777" y="911913"/>
                  </a:lnTo>
                  <a:lnTo>
                    <a:pt x="809755" y="917759"/>
                  </a:lnTo>
                  <a:lnTo>
                    <a:pt x="812759" y="923604"/>
                  </a:lnTo>
                  <a:lnTo>
                    <a:pt x="815816" y="929450"/>
                  </a:lnTo>
                  <a:lnTo>
                    <a:pt x="818896" y="935296"/>
                  </a:lnTo>
                  <a:lnTo>
                    <a:pt x="822004" y="941141"/>
                  </a:lnTo>
                  <a:lnTo>
                    <a:pt x="825153" y="946987"/>
                  </a:lnTo>
                  <a:lnTo>
                    <a:pt x="828322" y="952832"/>
                  </a:lnTo>
                  <a:lnTo>
                    <a:pt x="831518" y="958678"/>
                  </a:lnTo>
                  <a:lnTo>
                    <a:pt x="834743" y="964524"/>
                  </a:lnTo>
                  <a:lnTo>
                    <a:pt x="837983" y="970369"/>
                  </a:lnTo>
                  <a:lnTo>
                    <a:pt x="841247" y="976215"/>
                  </a:lnTo>
                  <a:lnTo>
                    <a:pt x="844528" y="982060"/>
                  </a:lnTo>
                  <a:lnTo>
                    <a:pt x="847820" y="987906"/>
                  </a:lnTo>
                  <a:lnTo>
                    <a:pt x="851129" y="993752"/>
                  </a:lnTo>
                  <a:lnTo>
                    <a:pt x="854444" y="999597"/>
                  </a:lnTo>
                  <a:lnTo>
                    <a:pt x="857765" y="1005443"/>
                  </a:lnTo>
                  <a:lnTo>
                    <a:pt x="861090" y="1011288"/>
                  </a:lnTo>
                  <a:lnTo>
                    <a:pt x="864414" y="1017134"/>
                  </a:lnTo>
                  <a:lnTo>
                    <a:pt x="867737" y="1022980"/>
                  </a:lnTo>
                  <a:lnTo>
                    <a:pt x="871050" y="1028825"/>
                  </a:lnTo>
                  <a:lnTo>
                    <a:pt x="874356" y="1034671"/>
                  </a:lnTo>
                  <a:lnTo>
                    <a:pt x="877648" y="1040516"/>
                  </a:lnTo>
                  <a:lnTo>
                    <a:pt x="880920" y="1046362"/>
                  </a:lnTo>
                  <a:lnTo>
                    <a:pt x="884177" y="1052208"/>
                  </a:lnTo>
                  <a:lnTo>
                    <a:pt x="887404" y="1058053"/>
                  </a:lnTo>
                  <a:lnTo>
                    <a:pt x="890603" y="1063899"/>
                  </a:lnTo>
                  <a:lnTo>
                    <a:pt x="893781" y="1069744"/>
                  </a:lnTo>
                  <a:lnTo>
                    <a:pt x="896906" y="1075590"/>
                  </a:lnTo>
                  <a:lnTo>
                    <a:pt x="900000" y="1081436"/>
                  </a:lnTo>
                  <a:lnTo>
                    <a:pt x="903061" y="1087281"/>
                  </a:lnTo>
                  <a:lnTo>
                    <a:pt x="906052" y="1093127"/>
                  </a:lnTo>
                  <a:lnTo>
                    <a:pt x="909007" y="1098972"/>
                  </a:lnTo>
                  <a:lnTo>
                    <a:pt x="911910" y="1104818"/>
                  </a:lnTo>
                  <a:lnTo>
                    <a:pt x="914738" y="1110664"/>
                  </a:lnTo>
                  <a:lnTo>
                    <a:pt x="917522" y="1116509"/>
                  </a:lnTo>
                  <a:lnTo>
                    <a:pt x="920230" y="1122355"/>
                  </a:lnTo>
                  <a:lnTo>
                    <a:pt x="922861" y="1128200"/>
                  </a:lnTo>
                  <a:lnTo>
                    <a:pt x="925441" y="1134046"/>
                  </a:lnTo>
                  <a:lnTo>
                    <a:pt x="927919" y="1139892"/>
                  </a:lnTo>
                  <a:lnTo>
                    <a:pt x="930322" y="1145737"/>
                  </a:lnTo>
                  <a:lnTo>
                    <a:pt x="932669" y="1151583"/>
                  </a:lnTo>
                  <a:lnTo>
                    <a:pt x="934883" y="1157428"/>
                  </a:lnTo>
                  <a:lnTo>
                    <a:pt x="937030" y="1163274"/>
                  </a:lnTo>
                  <a:lnTo>
                    <a:pt x="939100" y="1169120"/>
                  </a:lnTo>
                  <a:lnTo>
                    <a:pt x="941034" y="1174965"/>
                  </a:lnTo>
                  <a:lnTo>
                    <a:pt x="942900" y="1180811"/>
                  </a:lnTo>
                  <a:lnTo>
                    <a:pt x="944662" y="1186656"/>
                  </a:lnTo>
                  <a:lnTo>
                    <a:pt x="946297" y="1192502"/>
                  </a:lnTo>
                  <a:lnTo>
                    <a:pt x="947859" y="1198348"/>
                  </a:lnTo>
                  <a:lnTo>
                    <a:pt x="949288" y="1204193"/>
                  </a:lnTo>
                  <a:lnTo>
                    <a:pt x="950604" y="1210039"/>
                  </a:lnTo>
                  <a:lnTo>
                    <a:pt x="951844" y="1215884"/>
                  </a:lnTo>
                  <a:lnTo>
                    <a:pt x="952923" y="1221730"/>
                  </a:lnTo>
                  <a:lnTo>
                    <a:pt x="953905" y="1227576"/>
                  </a:lnTo>
                  <a:lnTo>
                    <a:pt x="954803" y="1233421"/>
                  </a:lnTo>
                  <a:lnTo>
                    <a:pt x="955523" y="1239267"/>
                  </a:lnTo>
                  <a:lnTo>
                    <a:pt x="956162" y="1245112"/>
                  </a:lnTo>
                  <a:lnTo>
                    <a:pt x="956692" y="1250958"/>
                  </a:lnTo>
                  <a:lnTo>
                    <a:pt x="957063" y="1256804"/>
                  </a:lnTo>
                  <a:lnTo>
                    <a:pt x="957351" y="1262649"/>
                  </a:lnTo>
                  <a:lnTo>
                    <a:pt x="957508" y="1268495"/>
                  </a:lnTo>
                  <a:lnTo>
                    <a:pt x="957528" y="1274340"/>
                  </a:lnTo>
                  <a:lnTo>
                    <a:pt x="957466" y="1280186"/>
                  </a:lnTo>
                  <a:lnTo>
                    <a:pt x="957250" y="1286032"/>
                  </a:lnTo>
                  <a:lnTo>
                    <a:pt x="956921" y="1291877"/>
                  </a:lnTo>
                  <a:lnTo>
                    <a:pt x="956512" y="1297723"/>
                  </a:lnTo>
                  <a:lnTo>
                    <a:pt x="955929" y="1303568"/>
                  </a:lnTo>
                  <a:lnTo>
                    <a:pt x="955258" y="1309414"/>
                  </a:lnTo>
                  <a:lnTo>
                    <a:pt x="954496" y="1315260"/>
                  </a:lnTo>
                  <a:lnTo>
                    <a:pt x="953570" y="1321105"/>
                  </a:lnTo>
                  <a:lnTo>
                    <a:pt x="952567" y="1326951"/>
                  </a:lnTo>
                  <a:lnTo>
                    <a:pt x="951455" y="1332796"/>
                  </a:lnTo>
                  <a:lnTo>
                    <a:pt x="950207" y="1338642"/>
                  </a:lnTo>
                  <a:lnTo>
                    <a:pt x="948886" y="1344488"/>
                  </a:lnTo>
                  <a:lnTo>
                    <a:pt x="947440" y="1350333"/>
                  </a:lnTo>
                  <a:lnTo>
                    <a:pt x="945885" y="1356179"/>
                  </a:lnTo>
                  <a:lnTo>
                    <a:pt x="944261" y="1362024"/>
                  </a:lnTo>
                  <a:lnTo>
                    <a:pt x="942501" y="1367870"/>
                  </a:lnTo>
                  <a:lnTo>
                    <a:pt x="940656" y="1373716"/>
                  </a:lnTo>
                  <a:lnTo>
                    <a:pt x="938745" y="1379561"/>
                  </a:lnTo>
                  <a:lnTo>
                    <a:pt x="936691" y="1385407"/>
                  </a:lnTo>
                  <a:lnTo>
                    <a:pt x="934575" y="1391252"/>
                  </a:lnTo>
                  <a:lnTo>
                    <a:pt x="932381" y="1397098"/>
                  </a:lnTo>
                  <a:lnTo>
                    <a:pt x="930069" y="1402944"/>
                  </a:lnTo>
                  <a:lnTo>
                    <a:pt x="927699" y="1408789"/>
                  </a:lnTo>
                  <a:lnTo>
                    <a:pt x="925243" y="1414635"/>
                  </a:lnTo>
                  <a:lnTo>
                    <a:pt x="922693" y="1420481"/>
                  </a:lnTo>
                  <a:lnTo>
                    <a:pt x="920089" y="1426326"/>
                  </a:lnTo>
                  <a:lnTo>
                    <a:pt x="917391" y="1432172"/>
                  </a:lnTo>
                  <a:lnTo>
                    <a:pt x="914621" y="1438017"/>
                  </a:lnTo>
                  <a:lnTo>
                    <a:pt x="911801" y="1443863"/>
                  </a:lnTo>
                  <a:lnTo>
                    <a:pt x="908881" y="1449709"/>
                  </a:lnTo>
                  <a:lnTo>
                    <a:pt x="905907" y="1455554"/>
                  </a:lnTo>
                  <a:lnTo>
                    <a:pt x="902884" y="1461400"/>
                  </a:lnTo>
                  <a:lnTo>
                    <a:pt x="899764" y="1467245"/>
                  </a:lnTo>
                  <a:lnTo>
                    <a:pt x="896603" y="1473091"/>
                  </a:lnTo>
                  <a:lnTo>
                    <a:pt x="893385" y="1478937"/>
                  </a:lnTo>
                  <a:lnTo>
                    <a:pt x="890089" y="1484782"/>
                  </a:lnTo>
                  <a:lnTo>
                    <a:pt x="886755" y="1490628"/>
                  </a:lnTo>
                  <a:lnTo>
                    <a:pt x="883357" y="1496473"/>
                  </a:lnTo>
                  <a:lnTo>
                    <a:pt x="879899" y="1502319"/>
                  </a:lnTo>
                  <a:lnTo>
                    <a:pt x="876403" y="1508165"/>
                  </a:lnTo>
                  <a:lnTo>
                    <a:pt x="872840" y="1514010"/>
                  </a:lnTo>
                  <a:lnTo>
                    <a:pt x="869230" y="1519856"/>
                  </a:lnTo>
                  <a:lnTo>
                    <a:pt x="865586" y="1525701"/>
                  </a:lnTo>
                  <a:lnTo>
                    <a:pt x="861869" y="1531547"/>
                  </a:lnTo>
                  <a:lnTo>
                    <a:pt x="858118" y="1537393"/>
                  </a:lnTo>
                  <a:lnTo>
                    <a:pt x="854329" y="1543238"/>
                  </a:lnTo>
                  <a:lnTo>
                    <a:pt x="850476" y="1549084"/>
                  </a:lnTo>
                  <a:lnTo>
                    <a:pt x="846592" y="1554929"/>
                  </a:lnTo>
                  <a:lnTo>
                    <a:pt x="842666" y="1560775"/>
                  </a:lnTo>
                  <a:lnTo>
                    <a:pt x="838687" y="1566621"/>
                  </a:lnTo>
                  <a:lnTo>
                    <a:pt x="834681" y="1572466"/>
                  </a:lnTo>
                  <a:lnTo>
                    <a:pt x="830626" y="1578312"/>
                  </a:lnTo>
                  <a:lnTo>
                    <a:pt x="826531" y="1584157"/>
                  </a:lnTo>
                  <a:lnTo>
                    <a:pt x="822410" y="1590003"/>
                  </a:lnTo>
                  <a:lnTo>
                    <a:pt x="818237" y="1595849"/>
                  </a:lnTo>
                  <a:lnTo>
                    <a:pt x="814034" y="1601694"/>
                  </a:lnTo>
                  <a:lnTo>
                    <a:pt x="809807" y="1607540"/>
                  </a:lnTo>
                  <a:lnTo>
                    <a:pt x="805527" y="1613385"/>
                  </a:lnTo>
                  <a:lnTo>
                    <a:pt x="801226" y="1619231"/>
                  </a:lnTo>
                  <a:lnTo>
                    <a:pt x="796896" y="1625077"/>
                  </a:lnTo>
                  <a:lnTo>
                    <a:pt x="792526" y="1630922"/>
                  </a:lnTo>
                  <a:lnTo>
                    <a:pt x="788137" y="1636768"/>
                  </a:lnTo>
                  <a:lnTo>
                    <a:pt x="783718" y="1642613"/>
                  </a:lnTo>
                  <a:lnTo>
                    <a:pt x="779270" y="1648459"/>
                  </a:lnTo>
                  <a:lnTo>
                    <a:pt x="774804" y="1654305"/>
                  </a:lnTo>
                  <a:lnTo>
                    <a:pt x="770311" y="1660150"/>
                  </a:lnTo>
                  <a:lnTo>
                    <a:pt x="765797" y="1665996"/>
                  </a:lnTo>
                  <a:lnTo>
                    <a:pt x="761269" y="1671841"/>
                  </a:lnTo>
                  <a:lnTo>
                    <a:pt x="756717" y="1677687"/>
                  </a:lnTo>
                  <a:lnTo>
                    <a:pt x="752153" y="1683533"/>
                  </a:lnTo>
                  <a:lnTo>
                    <a:pt x="747579" y="1689378"/>
                  </a:lnTo>
                  <a:lnTo>
                    <a:pt x="742987" y="1695224"/>
                  </a:lnTo>
                  <a:lnTo>
                    <a:pt x="738391" y="1701069"/>
                  </a:lnTo>
                  <a:lnTo>
                    <a:pt x="733787" y="1706915"/>
                  </a:lnTo>
                  <a:lnTo>
                    <a:pt x="729178" y="1712761"/>
                  </a:lnTo>
                  <a:lnTo>
                    <a:pt x="724568" y="1718606"/>
                  </a:lnTo>
                  <a:lnTo>
                    <a:pt x="719958" y="1724452"/>
                  </a:lnTo>
                  <a:lnTo>
                    <a:pt x="715351" y="1730297"/>
                  </a:lnTo>
                  <a:lnTo>
                    <a:pt x="710748" y="1736143"/>
                  </a:lnTo>
                  <a:lnTo>
                    <a:pt x="706156" y="1741989"/>
                  </a:lnTo>
                  <a:lnTo>
                    <a:pt x="701574" y="1747834"/>
                  </a:lnTo>
                  <a:lnTo>
                    <a:pt x="697001" y="1753680"/>
                  </a:lnTo>
                  <a:lnTo>
                    <a:pt x="692453" y="1759525"/>
                  </a:lnTo>
                  <a:lnTo>
                    <a:pt x="687920" y="1765371"/>
                  </a:lnTo>
                  <a:lnTo>
                    <a:pt x="683403" y="1771217"/>
                  </a:lnTo>
                  <a:lnTo>
                    <a:pt x="678923" y="1777062"/>
                  </a:lnTo>
                  <a:lnTo>
                    <a:pt x="674462" y="1782908"/>
                  </a:lnTo>
                  <a:lnTo>
                    <a:pt x="670031" y="1788753"/>
                  </a:lnTo>
                  <a:lnTo>
                    <a:pt x="665641" y="1794599"/>
                  </a:lnTo>
                  <a:lnTo>
                    <a:pt x="661277" y="1800445"/>
                  </a:lnTo>
                  <a:lnTo>
                    <a:pt x="656959" y="1806290"/>
                  </a:lnTo>
                  <a:lnTo>
                    <a:pt x="652685" y="1812136"/>
                  </a:lnTo>
                  <a:lnTo>
                    <a:pt x="648441" y="1817981"/>
                  </a:lnTo>
                  <a:lnTo>
                    <a:pt x="644262" y="1823827"/>
                  </a:lnTo>
                  <a:lnTo>
                    <a:pt x="640127" y="1829673"/>
                  </a:lnTo>
                  <a:lnTo>
                    <a:pt x="636028" y="1835518"/>
                  </a:lnTo>
                  <a:lnTo>
                    <a:pt x="632013" y="1841364"/>
                  </a:lnTo>
                  <a:lnTo>
                    <a:pt x="628039" y="1847209"/>
                  </a:lnTo>
                  <a:lnTo>
                    <a:pt x="624117" y="1853055"/>
                  </a:lnTo>
                  <a:lnTo>
                    <a:pt x="620279" y="1858901"/>
                  </a:lnTo>
                  <a:lnTo>
                    <a:pt x="616485" y="1864746"/>
                  </a:lnTo>
                  <a:lnTo>
                    <a:pt x="612762" y="1870592"/>
                  </a:lnTo>
                  <a:lnTo>
                    <a:pt x="609118" y="1876437"/>
                  </a:lnTo>
                  <a:lnTo>
                    <a:pt x="605522" y="1882283"/>
                  </a:lnTo>
                  <a:lnTo>
                    <a:pt x="602018" y="1888129"/>
                  </a:lnTo>
                  <a:lnTo>
                    <a:pt x="598584" y="1893974"/>
                  </a:lnTo>
                  <a:lnTo>
                    <a:pt x="595201" y="1899820"/>
                  </a:lnTo>
                  <a:lnTo>
                    <a:pt x="591930" y="1905665"/>
                  </a:lnTo>
                  <a:lnTo>
                    <a:pt x="588718" y="1911511"/>
                  </a:lnTo>
                  <a:lnTo>
                    <a:pt x="585568" y="1917357"/>
                  </a:lnTo>
                  <a:lnTo>
                    <a:pt x="582533" y="1923202"/>
                  </a:lnTo>
                  <a:lnTo>
                    <a:pt x="579553" y="1929048"/>
                  </a:lnTo>
                  <a:lnTo>
                    <a:pt x="576651" y="1934893"/>
                  </a:lnTo>
                  <a:lnTo>
                    <a:pt x="573852" y="1940739"/>
                  </a:lnTo>
                  <a:lnTo>
                    <a:pt x="571108" y="1946585"/>
                  </a:lnTo>
                  <a:lnTo>
                    <a:pt x="568459" y="1952430"/>
                  </a:lnTo>
                  <a:lnTo>
                    <a:pt x="565898" y="1958276"/>
                  </a:lnTo>
                  <a:lnTo>
                    <a:pt x="563394" y="1964121"/>
                  </a:lnTo>
                  <a:lnTo>
                    <a:pt x="560998" y="1969967"/>
                  </a:lnTo>
                  <a:lnTo>
                    <a:pt x="558675" y="1975813"/>
                  </a:lnTo>
                  <a:lnTo>
                    <a:pt x="556407" y="1981658"/>
                  </a:lnTo>
                  <a:lnTo>
                    <a:pt x="554262" y="1987504"/>
                  </a:lnTo>
                  <a:lnTo>
                    <a:pt x="552172" y="1993349"/>
                  </a:lnTo>
                  <a:lnTo>
                    <a:pt x="550149" y="1999195"/>
                  </a:lnTo>
                  <a:lnTo>
                    <a:pt x="548233" y="2005041"/>
                  </a:lnTo>
                  <a:lnTo>
                    <a:pt x="546370" y="2010886"/>
                  </a:lnTo>
                  <a:lnTo>
                    <a:pt x="544584" y="2016732"/>
                  </a:lnTo>
                  <a:lnTo>
                    <a:pt x="542887" y="2022577"/>
                  </a:lnTo>
                  <a:lnTo>
                    <a:pt x="541240" y="2028423"/>
                  </a:lnTo>
                  <a:lnTo>
                    <a:pt x="539680" y="2034269"/>
                  </a:lnTo>
                  <a:lnTo>
                    <a:pt x="538190" y="2040114"/>
                  </a:lnTo>
                  <a:lnTo>
                    <a:pt x="536747" y="2045960"/>
                  </a:lnTo>
                  <a:lnTo>
                    <a:pt x="535397" y="2051805"/>
                  </a:lnTo>
                  <a:lnTo>
                    <a:pt x="534100" y="2057651"/>
                  </a:lnTo>
                  <a:lnTo>
                    <a:pt x="532849" y="2063497"/>
                  </a:lnTo>
                  <a:lnTo>
                    <a:pt x="531690" y="2069342"/>
                  </a:lnTo>
                  <a:lnTo>
                    <a:pt x="530571" y="2075188"/>
                  </a:lnTo>
                  <a:lnTo>
                    <a:pt x="529505" y="2081033"/>
                  </a:lnTo>
                  <a:lnTo>
                    <a:pt x="528511" y="2086879"/>
                  </a:lnTo>
                  <a:lnTo>
                    <a:pt x="527554" y="2092725"/>
                  </a:lnTo>
                  <a:lnTo>
                    <a:pt x="526653" y="2098570"/>
                  </a:lnTo>
                  <a:lnTo>
                    <a:pt x="525808" y="2104416"/>
                  </a:lnTo>
                  <a:lnTo>
                    <a:pt x="524996" y="2110261"/>
                  </a:lnTo>
                  <a:lnTo>
                    <a:pt x="524242" y="2116107"/>
                  </a:lnTo>
                  <a:lnTo>
                    <a:pt x="523529" y="2121953"/>
                  </a:lnTo>
                  <a:lnTo>
                    <a:pt x="522845" y="2127798"/>
                  </a:lnTo>
                  <a:lnTo>
                    <a:pt x="522220" y="2133644"/>
                  </a:lnTo>
                  <a:lnTo>
                    <a:pt x="521622" y="2139489"/>
                  </a:lnTo>
                  <a:lnTo>
                    <a:pt x="521054" y="2145335"/>
                  </a:lnTo>
                  <a:lnTo>
                    <a:pt x="520535" y="2151181"/>
                  </a:lnTo>
                  <a:lnTo>
                    <a:pt x="520037" y="2157026"/>
                  </a:lnTo>
                  <a:lnTo>
                    <a:pt x="519571" y="2162872"/>
                  </a:lnTo>
                  <a:lnTo>
                    <a:pt x="519140" y="2168717"/>
                  </a:lnTo>
                  <a:lnTo>
                    <a:pt x="518728" y="2174563"/>
                  </a:lnTo>
                  <a:lnTo>
                    <a:pt x="518346" y="2180409"/>
                  </a:lnTo>
                  <a:lnTo>
                    <a:pt x="517990" y="2186254"/>
                  </a:lnTo>
                  <a:lnTo>
                    <a:pt x="517650" y="2192100"/>
                  </a:lnTo>
                  <a:lnTo>
                    <a:pt x="517340" y="2197945"/>
                  </a:lnTo>
                  <a:lnTo>
                    <a:pt x="517046" y="2203791"/>
                  </a:lnTo>
                  <a:lnTo>
                    <a:pt x="516766" y="2209637"/>
                  </a:lnTo>
                  <a:lnTo>
                    <a:pt x="516514" y="2215482"/>
                  </a:lnTo>
                  <a:lnTo>
                    <a:pt x="516273" y="2221328"/>
                  </a:lnTo>
                  <a:lnTo>
                    <a:pt x="516045" y="2227173"/>
                  </a:lnTo>
                  <a:lnTo>
                    <a:pt x="515838" y="2233019"/>
                  </a:lnTo>
                  <a:lnTo>
                    <a:pt x="515639" y="2238865"/>
                  </a:lnTo>
                  <a:lnTo>
                    <a:pt x="515454" y="2244710"/>
                  </a:lnTo>
                  <a:lnTo>
                    <a:pt x="515284" y="2250556"/>
                  </a:lnTo>
                  <a:lnTo>
                    <a:pt x="515120" y="2256401"/>
                  </a:lnTo>
                  <a:lnTo>
                    <a:pt x="514971" y="2262247"/>
                  </a:lnTo>
                  <a:lnTo>
                    <a:pt x="514830" y="2268093"/>
                  </a:lnTo>
                  <a:lnTo>
                    <a:pt x="514696" y="2273938"/>
                  </a:lnTo>
                  <a:lnTo>
                    <a:pt x="514575" y="2279784"/>
                  </a:lnTo>
                  <a:lnTo>
                    <a:pt x="514460" y="2285629"/>
                  </a:lnTo>
                  <a:lnTo>
                    <a:pt x="514351" y="2291475"/>
                  </a:lnTo>
                  <a:lnTo>
                    <a:pt x="514253" y="2297321"/>
                  </a:lnTo>
                  <a:lnTo>
                    <a:pt x="514160" y="2303166"/>
                  </a:lnTo>
                  <a:lnTo>
                    <a:pt x="514073" y="2309012"/>
                  </a:lnTo>
                  <a:lnTo>
                    <a:pt x="513994" y="2314857"/>
                  </a:lnTo>
                  <a:lnTo>
                    <a:pt x="513920" y="2320703"/>
                  </a:lnTo>
                  <a:lnTo>
                    <a:pt x="513851" y="2326549"/>
                  </a:lnTo>
                  <a:lnTo>
                    <a:pt x="513789" y="2332394"/>
                  </a:lnTo>
                  <a:lnTo>
                    <a:pt x="513731" y="2338240"/>
                  </a:lnTo>
                  <a:lnTo>
                    <a:pt x="513679" y="2344085"/>
                  </a:lnTo>
                  <a:lnTo>
                    <a:pt x="513632" y="2349931"/>
                  </a:lnTo>
                  <a:lnTo>
                    <a:pt x="513589" y="2355777"/>
                  </a:lnTo>
                  <a:lnTo>
                    <a:pt x="513552" y="2361622"/>
                  </a:lnTo>
                  <a:lnTo>
                    <a:pt x="513519" y="2367468"/>
                  </a:lnTo>
                  <a:lnTo>
                    <a:pt x="513489" y="2373313"/>
                  </a:lnTo>
                  <a:lnTo>
                    <a:pt x="513465" y="2379159"/>
                  </a:lnTo>
                  <a:lnTo>
                    <a:pt x="513444" y="2385005"/>
                  </a:lnTo>
                  <a:lnTo>
                    <a:pt x="513427" y="2390850"/>
                  </a:lnTo>
                  <a:lnTo>
                    <a:pt x="513414" y="2396696"/>
                  </a:lnTo>
                  <a:lnTo>
                    <a:pt x="513404" y="2402541"/>
                  </a:lnTo>
                  <a:lnTo>
                    <a:pt x="513398" y="2408387"/>
                  </a:lnTo>
                  <a:lnTo>
                    <a:pt x="513396" y="2414233"/>
                  </a:lnTo>
                  <a:lnTo>
                    <a:pt x="513396" y="2420078"/>
                  </a:lnTo>
                  <a:lnTo>
                    <a:pt x="513399" y="2425924"/>
                  </a:lnTo>
                  <a:lnTo>
                    <a:pt x="513406" y="2431769"/>
                  </a:lnTo>
                  <a:lnTo>
                    <a:pt x="513414" y="2437615"/>
                  </a:lnTo>
                  <a:lnTo>
                    <a:pt x="513426" y="2443461"/>
                  </a:lnTo>
                  <a:lnTo>
                    <a:pt x="513439" y="2449306"/>
                  </a:lnTo>
                  <a:lnTo>
                    <a:pt x="513454" y="2455152"/>
                  </a:lnTo>
                  <a:lnTo>
                    <a:pt x="513471" y="2460997"/>
                  </a:lnTo>
                  <a:lnTo>
                    <a:pt x="513490" y="2466843"/>
                  </a:lnTo>
                  <a:lnTo>
                    <a:pt x="513509" y="2472689"/>
                  </a:lnTo>
                  <a:lnTo>
                    <a:pt x="513530" y="2478534"/>
                  </a:lnTo>
                  <a:lnTo>
                    <a:pt x="513552" y="2484380"/>
                  </a:lnTo>
                  <a:lnTo>
                    <a:pt x="513575" y="2490225"/>
                  </a:lnTo>
                  <a:lnTo>
                    <a:pt x="513597" y="2496071"/>
                  </a:lnTo>
                  <a:lnTo>
                    <a:pt x="513620" y="2501917"/>
                  </a:lnTo>
                  <a:lnTo>
                    <a:pt x="513643" y="2507762"/>
                  </a:lnTo>
                  <a:lnTo>
                    <a:pt x="513665" y="2513608"/>
                  </a:lnTo>
                  <a:lnTo>
                    <a:pt x="513687" y="2519453"/>
                  </a:lnTo>
                  <a:lnTo>
                    <a:pt x="513708" y="2525299"/>
                  </a:lnTo>
                  <a:lnTo>
                    <a:pt x="513729" y="2531145"/>
                  </a:lnTo>
                  <a:lnTo>
                    <a:pt x="513748" y="2536990"/>
                  </a:lnTo>
                  <a:lnTo>
                    <a:pt x="513765" y="2542836"/>
                  </a:lnTo>
                  <a:lnTo>
                    <a:pt x="513781" y="2548681"/>
                  </a:lnTo>
                  <a:lnTo>
                    <a:pt x="513796" y="2554527"/>
                  </a:lnTo>
                  <a:lnTo>
                    <a:pt x="513808" y="2560373"/>
                  </a:lnTo>
                  <a:lnTo>
                    <a:pt x="513819" y="2566218"/>
                  </a:lnTo>
                  <a:lnTo>
                    <a:pt x="513827" y="2572064"/>
                  </a:lnTo>
                  <a:lnTo>
                    <a:pt x="513833" y="2577909"/>
                  </a:lnTo>
                  <a:lnTo>
                    <a:pt x="513838" y="2583755"/>
                  </a:lnTo>
                  <a:lnTo>
                    <a:pt x="513839" y="2589601"/>
                  </a:lnTo>
                  <a:lnTo>
                    <a:pt x="513838" y="2595446"/>
                  </a:lnTo>
                  <a:lnTo>
                    <a:pt x="513835" y="2601292"/>
                  </a:lnTo>
                  <a:lnTo>
                    <a:pt x="513829" y="2607137"/>
                  </a:lnTo>
                  <a:lnTo>
                    <a:pt x="513821" y="2612983"/>
                  </a:lnTo>
                  <a:lnTo>
                    <a:pt x="513811" y="2618829"/>
                  </a:lnTo>
                  <a:lnTo>
                    <a:pt x="513797" y="2624674"/>
                  </a:lnTo>
                  <a:lnTo>
                    <a:pt x="513783" y="2630520"/>
                  </a:lnTo>
                  <a:lnTo>
                    <a:pt x="513765" y="2636365"/>
                  </a:lnTo>
                  <a:lnTo>
                    <a:pt x="513745" y="2642211"/>
                  </a:lnTo>
                  <a:lnTo>
                    <a:pt x="513724" y="2648057"/>
                  </a:lnTo>
                  <a:lnTo>
                    <a:pt x="513700" y="2653902"/>
                  </a:lnTo>
                  <a:lnTo>
                    <a:pt x="513674" y="2659748"/>
                  </a:lnTo>
                  <a:lnTo>
                    <a:pt x="513647" y="2665593"/>
                  </a:lnTo>
                  <a:lnTo>
                    <a:pt x="513618" y="2671439"/>
                  </a:lnTo>
                  <a:lnTo>
                    <a:pt x="513588" y="2677285"/>
                  </a:lnTo>
                  <a:lnTo>
                    <a:pt x="513556" y="2683130"/>
                  </a:lnTo>
                  <a:lnTo>
                    <a:pt x="513523" y="2688976"/>
                  </a:lnTo>
                  <a:lnTo>
                    <a:pt x="513489" y="2694821"/>
                  </a:lnTo>
                  <a:lnTo>
                    <a:pt x="513455" y="2700667"/>
                  </a:lnTo>
                  <a:lnTo>
                    <a:pt x="513419" y="2706513"/>
                  </a:lnTo>
                  <a:lnTo>
                    <a:pt x="513383" y="2712358"/>
                  </a:lnTo>
                  <a:lnTo>
                    <a:pt x="513346" y="2718204"/>
                  </a:lnTo>
                  <a:lnTo>
                    <a:pt x="513309" y="2724049"/>
                  </a:lnTo>
                  <a:lnTo>
                    <a:pt x="513271" y="2729895"/>
                  </a:lnTo>
                  <a:lnTo>
                    <a:pt x="513233" y="2735741"/>
                  </a:lnTo>
                  <a:lnTo>
                    <a:pt x="513195" y="2741586"/>
                  </a:lnTo>
                  <a:lnTo>
                    <a:pt x="513157" y="2747432"/>
                  </a:lnTo>
                  <a:lnTo>
                    <a:pt x="513119" y="2753277"/>
                  </a:lnTo>
                  <a:lnTo>
                    <a:pt x="513081" y="2759123"/>
                  </a:lnTo>
                  <a:lnTo>
                    <a:pt x="513042" y="2764969"/>
                  </a:lnTo>
                  <a:lnTo>
                    <a:pt x="513004" y="2770814"/>
                  </a:lnTo>
                  <a:lnTo>
                    <a:pt x="512965" y="2776660"/>
                  </a:lnTo>
                  <a:lnTo>
                    <a:pt x="512926" y="2782505"/>
                  </a:lnTo>
                  <a:lnTo>
                    <a:pt x="512887" y="2788351"/>
                  </a:lnTo>
                  <a:lnTo>
                    <a:pt x="512847" y="2794197"/>
                  </a:lnTo>
                  <a:lnTo>
                    <a:pt x="512806" y="2800042"/>
                  </a:lnTo>
                  <a:lnTo>
                    <a:pt x="512765" y="2805888"/>
                  </a:lnTo>
                  <a:lnTo>
                    <a:pt x="512723" y="2811734"/>
                  </a:lnTo>
                  <a:lnTo>
                    <a:pt x="512679" y="2817579"/>
                  </a:lnTo>
                  <a:lnTo>
                    <a:pt x="512633" y="2823425"/>
                  </a:lnTo>
                  <a:lnTo>
                    <a:pt x="512587" y="2829270"/>
                  </a:lnTo>
                  <a:lnTo>
                    <a:pt x="512537" y="2835116"/>
                  </a:lnTo>
                  <a:lnTo>
                    <a:pt x="512486" y="2840962"/>
                  </a:lnTo>
                  <a:lnTo>
                    <a:pt x="512432" y="2846807"/>
                  </a:lnTo>
                  <a:lnTo>
                    <a:pt x="512375" y="2852653"/>
                  </a:lnTo>
                  <a:lnTo>
                    <a:pt x="512315" y="2858498"/>
                  </a:lnTo>
                  <a:lnTo>
                    <a:pt x="512250" y="2864344"/>
                  </a:lnTo>
                  <a:lnTo>
                    <a:pt x="512181" y="2870190"/>
                  </a:lnTo>
                  <a:lnTo>
                    <a:pt x="512109" y="2876035"/>
                  </a:lnTo>
                  <a:lnTo>
                    <a:pt x="512030" y="2881881"/>
                  </a:lnTo>
                  <a:lnTo>
                    <a:pt x="511946" y="2887726"/>
                  </a:lnTo>
                  <a:lnTo>
                    <a:pt x="511858" y="2893572"/>
                  </a:lnTo>
                  <a:lnTo>
                    <a:pt x="511761" y="2899418"/>
                  </a:lnTo>
                  <a:lnTo>
                    <a:pt x="511659" y="2905263"/>
                  </a:lnTo>
                  <a:lnTo>
                    <a:pt x="511551" y="2911109"/>
                  </a:lnTo>
                  <a:lnTo>
                    <a:pt x="511432" y="2916954"/>
                  </a:lnTo>
                  <a:lnTo>
                    <a:pt x="511308" y="2922800"/>
                  </a:lnTo>
                  <a:lnTo>
                    <a:pt x="511176" y="2928646"/>
                  </a:lnTo>
                  <a:lnTo>
                    <a:pt x="511033" y="2934491"/>
                  </a:lnTo>
                  <a:lnTo>
                    <a:pt x="510884" y="2940337"/>
                  </a:lnTo>
                  <a:lnTo>
                    <a:pt x="510723" y="2946182"/>
                  </a:lnTo>
                  <a:lnTo>
                    <a:pt x="510552" y="2952028"/>
                  </a:lnTo>
                  <a:lnTo>
                    <a:pt x="510375" y="2957874"/>
                  </a:lnTo>
                  <a:lnTo>
                    <a:pt x="510183" y="2963719"/>
                  </a:lnTo>
                  <a:lnTo>
                    <a:pt x="509982" y="2969565"/>
                  </a:lnTo>
                  <a:lnTo>
                    <a:pt x="509774" y="2975410"/>
                  </a:lnTo>
                  <a:lnTo>
                    <a:pt x="509549" y="2981256"/>
                  </a:lnTo>
                  <a:lnTo>
                    <a:pt x="509317" y="2987102"/>
                  </a:lnTo>
                  <a:close/>
                </a:path>
              </a:pathLst>
            </a:custGeom>
            <a:solidFill>
              <a:srgbClr val="21908C">
                <a:alpha val="29803"/>
              </a:srgbClr>
            </a:solidFill>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04" name="pg7">
              <a:extLst>
                <a:ext uri="{FF2B5EF4-FFF2-40B4-BE49-F238E27FC236}">
                  <a16:creationId xmlns:a16="http://schemas.microsoft.com/office/drawing/2014/main" id="{5CB224D5-E717-2F09-4B93-5E2A910CB262}"/>
                </a:ext>
              </a:extLst>
            </p:cNvPr>
            <p:cNvSpPr/>
            <p:nvPr/>
          </p:nvSpPr>
          <p:spPr>
            <a:xfrm>
              <a:off x="1326983" y="1370871"/>
              <a:ext cx="311000" cy="786587"/>
            </a:xfrm>
            <a:custGeom>
              <a:avLst/>
              <a:gdLst/>
              <a:ahLst/>
              <a:cxnLst/>
              <a:rect l="0" t="0" r="0" b="0"/>
              <a:pathLst>
                <a:path w="929340" h="2350506">
                  <a:moveTo>
                    <a:pt x="404593" y="2350506"/>
                  </a:moveTo>
                  <a:lnTo>
                    <a:pt x="404103" y="2345906"/>
                  </a:lnTo>
                  <a:lnTo>
                    <a:pt x="403630" y="2341306"/>
                  </a:lnTo>
                  <a:lnTo>
                    <a:pt x="403171" y="2336707"/>
                  </a:lnTo>
                  <a:lnTo>
                    <a:pt x="402725" y="2332107"/>
                  </a:lnTo>
                  <a:lnTo>
                    <a:pt x="402300" y="2327507"/>
                  </a:lnTo>
                  <a:lnTo>
                    <a:pt x="401882" y="2322907"/>
                  </a:lnTo>
                  <a:lnTo>
                    <a:pt x="401489" y="2318307"/>
                  </a:lnTo>
                  <a:lnTo>
                    <a:pt x="401105" y="2313707"/>
                  </a:lnTo>
                  <a:lnTo>
                    <a:pt x="400741" y="2309108"/>
                  </a:lnTo>
                  <a:lnTo>
                    <a:pt x="400391" y="2304508"/>
                  </a:lnTo>
                  <a:lnTo>
                    <a:pt x="400054" y="2299908"/>
                  </a:lnTo>
                  <a:lnTo>
                    <a:pt x="399740" y="2295308"/>
                  </a:lnTo>
                  <a:lnTo>
                    <a:pt x="399432" y="2290708"/>
                  </a:lnTo>
                  <a:lnTo>
                    <a:pt x="399152" y="2286109"/>
                  </a:lnTo>
                  <a:lnTo>
                    <a:pt x="398879" y="2281509"/>
                  </a:lnTo>
                  <a:lnTo>
                    <a:pt x="398625" y="2276909"/>
                  </a:lnTo>
                  <a:lnTo>
                    <a:pt x="398387" y="2272309"/>
                  </a:lnTo>
                  <a:lnTo>
                    <a:pt x="398161" y="2267709"/>
                  </a:lnTo>
                  <a:lnTo>
                    <a:pt x="397956" y="2263109"/>
                  </a:lnTo>
                  <a:lnTo>
                    <a:pt x="397757" y="2258510"/>
                  </a:lnTo>
                  <a:lnTo>
                    <a:pt x="397584" y="2253910"/>
                  </a:lnTo>
                  <a:lnTo>
                    <a:pt x="397418" y="2249310"/>
                  </a:lnTo>
                  <a:lnTo>
                    <a:pt x="397269" y="2244710"/>
                  </a:lnTo>
                  <a:lnTo>
                    <a:pt x="397134" y="2240110"/>
                  </a:lnTo>
                  <a:lnTo>
                    <a:pt x="397009" y="2235511"/>
                  </a:lnTo>
                  <a:lnTo>
                    <a:pt x="396903" y="2230911"/>
                  </a:lnTo>
                  <a:lnTo>
                    <a:pt x="396802" y="2226311"/>
                  </a:lnTo>
                  <a:lnTo>
                    <a:pt x="396722" y="2221711"/>
                  </a:lnTo>
                  <a:lnTo>
                    <a:pt x="396648" y="2217111"/>
                  </a:lnTo>
                  <a:lnTo>
                    <a:pt x="396587" y="2212512"/>
                  </a:lnTo>
                  <a:lnTo>
                    <a:pt x="396537" y="2207912"/>
                  </a:lnTo>
                  <a:lnTo>
                    <a:pt x="396495" y="2203312"/>
                  </a:lnTo>
                  <a:lnTo>
                    <a:pt x="396466" y="2198712"/>
                  </a:lnTo>
                  <a:lnTo>
                    <a:pt x="396441" y="2194112"/>
                  </a:lnTo>
                  <a:lnTo>
                    <a:pt x="396430" y="2189512"/>
                  </a:lnTo>
                  <a:lnTo>
                    <a:pt x="396422" y="2184913"/>
                  </a:lnTo>
                  <a:lnTo>
                    <a:pt x="396423" y="2180313"/>
                  </a:lnTo>
                  <a:lnTo>
                    <a:pt x="396430" y="2175713"/>
                  </a:lnTo>
                  <a:lnTo>
                    <a:pt x="396441" y="2171113"/>
                  </a:lnTo>
                  <a:lnTo>
                    <a:pt x="396458" y="2166513"/>
                  </a:lnTo>
                  <a:lnTo>
                    <a:pt x="396477" y="2161914"/>
                  </a:lnTo>
                  <a:lnTo>
                    <a:pt x="396501" y="2157314"/>
                  </a:lnTo>
                  <a:lnTo>
                    <a:pt x="396526" y="2152714"/>
                  </a:lnTo>
                  <a:lnTo>
                    <a:pt x="396552" y="2148114"/>
                  </a:lnTo>
                  <a:lnTo>
                    <a:pt x="396579" y="2143514"/>
                  </a:lnTo>
                  <a:lnTo>
                    <a:pt x="396605" y="2138914"/>
                  </a:lnTo>
                  <a:lnTo>
                    <a:pt x="396629" y="2134315"/>
                  </a:lnTo>
                  <a:lnTo>
                    <a:pt x="396652" y="2129715"/>
                  </a:lnTo>
                  <a:lnTo>
                    <a:pt x="396670" y="2125115"/>
                  </a:lnTo>
                  <a:lnTo>
                    <a:pt x="396684" y="2120515"/>
                  </a:lnTo>
                  <a:lnTo>
                    <a:pt x="396692" y="2115915"/>
                  </a:lnTo>
                  <a:lnTo>
                    <a:pt x="396694" y="2111316"/>
                  </a:lnTo>
                  <a:lnTo>
                    <a:pt x="396690" y="2106716"/>
                  </a:lnTo>
                  <a:lnTo>
                    <a:pt x="396675" y="2102116"/>
                  </a:lnTo>
                  <a:lnTo>
                    <a:pt x="396655" y="2097516"/>
                  </a:lnTo>
                  <a:lnTo>
                    <a:pt x="396617" y="2092916"/>
                  </a:lnTo>
                  <a:lnTo>
                    <a:pt x="396573" y="2088316"/>
                  </a:lnTo>
                  <a:lnTo>
                    <a:pt x="396514" y="2083717"/>
                  </a:lnTo>
                  <a:lnTo>
                    <a:pt x="396441" y="2079117"/>
                  </a:lnTo>
                  <a:lnTo>
                    <a:pt x="396357" y="2074517"/>
                  </a:lnTo>
                  <a:lnTo>
                    <a:pt x="396250" y="2069917"/>
                  </a:lnTo>
                  <a:lnTo>
                    <a:pt x="396137" y="2065317"/>
                  </a:lnTo>
                  <a:lnTo>
                    <a:pt x="395992" y="2060718"/>
                  </a:lnTo>
                  <a:lnTo>
                    <a:pt x="395838" y="2056118"/>
                  </a:lnTo>
                  <a:lnTo>
                    <a:pt x="395658" y="2051518"/>
                  </a:lnTo>
                  <a:lnTo>
                    <a:pt x="395459" y="2046918"/>
                  </a:lnTo>
                  <a:lnTo>
                    <a:pt x="395240" y="2042318"/>
                  </a:lnTo>
                  <a:lnTo>
                    <a:pt x="394991" y="2037718"/>
                  </a:lnTo>
                  <a:lnTo>
                    <a:pt x="394730" y="2033119"/>
                  </a:lnTo>
                  <a:lnTo>
                    <a:pt x="394426" y="2028519"/>
                  </a:lnTo>
                  <a:lnTo>
                    <a:pt x="394108" y="2023919"/>
                  </a:lnTo>
                  <a:lnTo>
                    <a:pt x="393756" y="2019319"/>
                  </a:lnTo>
                  <a:lnTo>
                    <a:pt x="393377" y="2014719"/>
                  </a:lnTo>
                  <a:lnTo>
                    <a:pt x="392972" y="2010120"/>
                  </a:lnTo>
                  <a:lnTo>
                    <a:pt x="392527" y="2005520"/>
                  </a:lnTo>
                  <a:lnTo>
                    <a:pt x="392068" y="2000920"/>
                  </a:lnTo>
                  <a:lnTo>
                    <a:pt x="391552" y="1996320"/>
                  </a:lnTo>
                  <a:lnTo>
                    <a:pt x="391021" y="1991720"/>
                  </a:lnTo>
                  <a:lnTo>
                    <a:pt x="390444" y="1987120"/>
                  </a:lnTo>
                  <a:lnTo>
                    <a:pt x="389836" y="1982521"/>
                  </a:lnTo>
                  <a:lnTo>
                    <a:pt x="389196" y="1977921"/>
                  </a:lnTo>
                  <a:lnTo>
                    <a:pt x="388506" y="1973321"/>
                  </a:lnTo>
                  <a:lnTo>
                    <a:pt x="387800" y="1968721"/>
                  </a:lnTo>
                  <a:lnTo>
                    <a:pt x="387025" y="1964121"/>
                  </a:lnTo>
                  <a:lnTo>
                    <a:pt x="386233" y="1959522"/>
                  </a:lnTo>
                  <a:lnTo>
                    <a:pt x="385386" y="1954922"/>
                  </a:lnTo>
                  <a:lnTo>
                    <a:pt x="384504" y="1950322"/>
                  </a:lnTo>
                  <a:lnTo>
                    <a:pt x="383583" y="1945722"/>
                  </a:lnTo>
                  <a:lnTo>
                    <a:pt x="382607" y="1941122"/>
                  </a:lnTo>
                  <a:lnTo>
                    <a:pt x="381610" y="1936522"/>
                  </a:lnTo>
                  <a:lnTo>
                    <a:pt x="380536" y="1931923"/>
                  </a:lnTo>
                  <a:lnTo>
                    <a:pt x="379442" y="1927323"/>
                  </a:lnTo>
                  <a:lnTo>
                    <a:pt x="378286" y="1922723"/>
                  </a:lnTo>
                  <a:lnTo>
                    <a:pt x="377091" y="1918123"/>
                  </a:lnTo>
                  <a:lnTo>
                    <a:pt x="375853" y="1913523"/>
                  </a:lnTo>
                  <a:lnTo>
                    <a:pt x="374553" y="1908924"/>
                  </a:lnTo>
                  <a:lnTo>
                    <a:pt x="373231" y="1904324"/>
                  </a:lnTo>
                  <a:lnTo>
                    <a:pt x="371824" y="1899724"/>
                  </a:lnTo>
                  <a:lnTo>
                    <a:pt x="370396" y="1895124"/>
                  </a:lnTo>
                  <a:lnTo>
                    <a:pt x="368901" y="1890524"/>
                  </a:lnTo>
                  <a:lnTo>
                    <a:pt x="367362" y="1885924"/>
                  </a:lnTo>
                  <a:lnTo>
                    <a:pt x="365778" y="1881325"/>
                  </a:lnTo>
                  <a:lnTo>
                    <a:pt x="364128" y="1876725"/>
                  </a:lnTo>
                  <a:lnTo>
                    <a:pt x="362454" y="1872125"/>
                  </a:lnTo>
                  <a:lnTo>
                    <a:pt x="360691" y="1867525"/>
                  </a:lnTo>
                  <a:lnTo>
                    <a:pt x="358905" y="1862925"/>
                  </a:lnTo>
                  <a:lnTo>
                    <a:pt x="357048" y="1858326"/>
                  </a:lnTo>
                  <a:lnTo>
                    <a:pt x="355147" y="1853726"/>
                  </a:lnTo>
                  <a:lnTo>
                    <a:pt x="353197" y="1849126"/>
                  </a:lnTo>
                  <a:lnTo>
                    <a:pt x="351180" y="1844526"/>
                  </a:lnTo>
                  <a:lnTo>
                    <a:pt x="349138" y="1839926"/>
                  </a:lnTo>
                  <a:lnTo>
                    <a:pt x="347004" y="1835327"/>
                  </a:lnTo>
                  <a:lnTo>
                    <a:pt x="344847" y="1830727"/>
                  </a:lnTo>
                  <a:lnTo>
                    <a:pt x="342618" y="1826127"/>
                  </a:lnTo>
                  <a:lnTo>
                    <a:pt x="340344" y="1821527"/>
                  </a:lnTo>
                  <a:lnTo>
                    <a:pt x="338021" y="1816927"/>
                  </a:lnTo>
                  <a:lnTo>
                    <a:pt x="335631" y="1812327"/>
                  </a:lnTo>
                  <a:lnTo>
                    <a:pt x="333215" y="1807728"/>
                  </a:lnTo>
                  <a:lnTo>
                    <a:pt x="330709" y="1803128"/>
                  </a:lnTo>
                  <a:lnTo>
                    <a:pt x="328179" y="1798528"/>
                  </a:lnTo>
                  <a:lnTo>
                    <a:pt x="325578" y="1793928"/>
                  </a:lnTo>
                  <a:lnTo>
                    <a:pt x="322933" y="1789328"/>
                  </a:lnTo>
                  <a:lnTo>
                    <a:pt x="320241" y="1784729"/>
                  </a:lnTo>
                  <a:lnTo>
                    <a:pt x="317483" y="1780129"/>
                  </a:lnTo>
                  <a:lnTo>
                    <a:pt x="314699" y="1775529"/>
                  </a:lnTo>
                  <a:lnTo>
                    <a:pt x="311830" y="1770929"/>
                  </a:lnTo>
                  <a:lnTo>
                    <a:pt x="308938" y="1766329"/>
                  </a:lnTo>
                  <a:lnTo>
                    <a:pt x="305977" y="1761729"/>
                  </a:lnTo>
                  <a:lnTo>
                    <a:pt x="302977" y="1757130"/>
                  </a:lnTo>
                  <a:lnTo>
                    <a:pt x="299930" y="1752530"/>
                  </a:lnTo>
                  <a:lnTo>
                    <a:pt x="296823" y="1747930"/>
                  </a:lnTo>
                  <a:lnTo>
                    <a:pt x="293692" y="1743330"/>
                  </a:lnTo>
                  <a:lnTo>
                    <a:pt x="290482" y="1738730"/>
                  </a:lnTo>
                  <a:lnTo>
                    <a:pt x="287252" y="1734131"/>
                  </a:lnTo>
                  <a:lnTo>
                    <a:pt x="283958" y="1729531"/>
                  </a:lnTo>
                  <a:lnTo>
                    <a:pt x="280629" y="1724931"/>
                  </a:lnTo>
                  <a:lnTo>
                    <a:pt x="277259" y="1720331"/>
                  </a:lnTo>
                  <a:lnTo>
                    <a:pt x="273835" y="1715731"/>
                  </a:lnTo>
                  <a:lnTo>
                    <a:pt x="270390" y="1711131"/>
                  </a:lnTo>
                  <a:lnTo>
                    <a:pt x="266876" y="1706532"/>
                  </a:lnTo>
                  <a:lnTo>
                    <a:pt x="263345" y="1701932"/>
                  </a:lnTo>
                  <a:lnTo>
                    <a:pt x="259760" y="1697332"/>
                  </a:lnTo>
                  <a:lnTo>
                    <a:pt x="256145" y="1692732"/>
                  </a:lnTo>
                  <a:lnTo>
                    <a:pt x="252495" y="1688132"/>
                  </a:lnTo>
                  <a:lnTo>
                    <a:pt x="248802" y="1683533"/>
                  </a:lnTo>
                  <a:lnTo>
                    <a:pt x="245091" y="1678933"/>
                  </a:lnTo>
                  <a:lnTo>
                    <a:pt x="241326" y="1674333"/>
                  </a:lnTo>
                  <a:lnTo>
                    <a:pt x="237547" y="1669733"/>
                  </a:lnTo>
                  <a:lnTo>
                    <a:pt x="233726" y="1665133"/>
                  </a:lnTo>
                  <a:lnTo>
                    <a:pt x="229883" y="1660533"/>
                  </a:lnTo>
                  <a:lnTo>
                    <a:pt x="226014" y="1655934"/>
                  </a:lnTo>
                  <a:lnTo>
                    <a:pt x="222114" y="1651334"/>
                  </a:lnTo>
                  <a:lnTo>
                    <a:pt x="218202" y="1646734"/>
                  </a:lnTo>
                  <a:lnTo>
                    <a:pt x="214252" y="1642134"/>
                  </a:lnTo>
                  <a:lnTo>
                    <a:pt x="210294" y="1637534"/>
                  </a:lnTo>
                  <a:lnTo>
                    <a:pt x="206309" y="1632935"/>
                  </a:lnTo>
                  <a:lnTo>
                    <a:pt x="202312" y="1628335"/>
                  </a:lnTo>
                  <a:lnTo>
                    <a:pt x="198299" y="1623735"/>
                  </a:lnTo>
                  <a:lnTo>
                    <a:pt x="194271" y="1619135"/>
                  </a:lnTo>
                  <a:lnTo>
                    <a:pt x="190235" y="1614535"/>
                  </a:lnTo>
                  <a:lnTo>
                    <a:pt x="186185" y="1609935"/>
                  </a:lnTo>
                  <a:lnTo>
                    <a:pt x="182131" y="1605336"/>
                  </a:lnTo>
                  <a:lnTo>
                    <a:pt x="178069" y="1600736"/>
                  </a:lnTo>
                  <a:lnTo>
                    <a:pt x="174005" y="1596136"/>
                  </a:lnTo>
                  <a:lnTo>
                    <a:pt x="169938" y="1591536"/>
                  </a:lnTo>
                  <a:lnTo>
                    <a:pt x="165873" y="1586936"/>
                  </a:lnTo>
                  <a:lnTo>
                    <a:pt x="161808" y="1582337"/>
                  </a:lnTo>
                  <a:lnTo>
                    <a:pt x="157752" y="1577737"/>
                  </a:lnTo>
                  <a:lnTo>
                    <a:pt x="153699" y="1573137"/>
                  </a:lnTo>
                  <a:lnTo>
                    <a:pt x="149659" y="1568537"/>
                  </a:lnTo>
                  <a:lnTo>
                    <a:pt x="145628" y="1563937"/>
                  </a:lnTo>
                  <a:lnTo>
                    <a:pt x="141609" y="1559337"/>
                  </a:lnTo>
                  <a:lnTo>
                    <a:pt x="137611" y="1554738"/>
                  </a:lnTo>
                  <a:lnTo>
                    <a:pt x="133621" y="1550138"/>
                  </a:lnTo>
                  <a:lnTo>
                    <a:pt x="129665" y="1545538"/>
                  </a:lnTo>
                  <a:lnTo>
                    <a:pt x="125720" y="1540938"/>
                  </a:lnTo>
                  <a:lnTo>
                    <a:pt x="121809" y="1536338"/>
                  </a:lnTo>
                  <a:lnTo>
                    <a:pt x="117920" y="1531739"/>
                  </a:lnTo>
                  <a:lnTo>
                    <a:pt x="114059" y="1527139"/>
                  </a:lnTo>
                  <a:lnTo>
                    <a:pt x="110237" y="1522539"/>
                  </a:lnTo>
                  <a:lnTo>
                    <a:pt x="106434" y="1517939"/>
                  </a:lnTo>
                  <a:lnTo>
                    <a:pt x="102689" y="1513339"/>
                  </a:lnTo>
                  <a:lnTo>
                    <a:pt x="98962" y="1508739"/>
                  </a:lnTo>
                  <a:lnTo>
                    <a:pt x="95293" y="1504140"/>
                  </a:lnTo>
                  <a:lnTo>
                    <a:pt x="91657" y="1499540"/>
                  </a:lnTo>
                  <a:lnTo>
                    <a:pt x="88066" y="1494940"/>
                  </a:lnTo>
                  <a:lnTo>
                    <a:pt x="84532" y="1490340"/>
                  </a:lnTo>
                  <a:lnTo>
                    <a:pt x="81025" y="1485740"/>
                  </a:lnTo>
                  <a:lnTo>
                    <a:pt x="77603" y="1481141"/>
                  </a:lnTo>
                  <a:lnTo>
                    <a:pt x="74204" y="1476541"/>
                  </a:lnTo>
                  <a:lnTo>
                    <a:pt x="70886" y="1471941"/>
                  </a:lnTo>
                  <a:lnTo>
                    <a:pt x="67611" y="1467341"/>
                  </a:lnTo>
                  <a:lnTo>
                    <a:pt x="64397" y="1462741"/>
                  </a:lnTo>
                  <a:lnTo>
                    <a:pt x="61256" y="1458142"/>
                  </a:lnTo>
                  <a:lnTo>
                    <a:pt x="58151" y="1453542"/>
                  </a:lnTo>
                  <a:lnTo>
                    <a:pt x="55153" y="1448942"/>
                  </a:lnTo>
                  <a:lnTo>
                    <a:pt x="52184" y="1444342"/>
                  </a:lnTo>
                  <a:lnTo>
                    <a:pt x="49315" y="1439742"/>
                  </a:lnTo>
                  <a:lnTo>
                    <a:pt x="46499" y="1435142"/>
                  </a:lnTo>
                  <a:lnTo>
                    <a:pt x="43757" y="1430543"/>
                  </a:lnTo>
                  <a:lnTo>
                    <a:pt x="41101" y="1425943"/>
                  </a:lnTo>
                  <a:lnTo>
                    <a:pt x="38489" y="1421343"/>
                  </a:lnTo>
                  <a:lnTo>
                    <a:pt x="36001" y="1416743"/>
                  </a:lnTo>
                  <a:lnTo>
                    <a:pt x="33547" y="1412143"/>
                  </a:lnTo>
                  <a:lnTo>
                    <a:pt x="31209" y="1407544"/>
                  </a:lnTo>
                  <a:lnTo>
                    <a:pt x="28931" y="1402944"/>
                  </a:lnTo>
                  <a:lnTo>
                    <a:pt x="26736" y="1398344"/>
                  </a:lnTo>
                  <a:lnTo>
                    <a:pt x="24637" y="1393744"/>
                  </a:lnTo>
                  <a:lnTo>
                    <a:pt x="22589" y="1389144"/>
                  </a:lnTo>
                  <a:lnTo>
                    <a:pt x="20675" y="1384544"/>
                  </a:lnTo>
                  <a:lnTo>
                    <a:pt x="18798" y="1379945"/>
                  </a:lnTo>
                  <a:lnTo>
                    <a:pt x="17049" y="1375345"/>
                  </a:lnTo>
                  <a:lnTo>
                    <a:pt x="15362" y="1370745"/>
                  </a:lnTo>
                  <a:lnTo>
                    <a:pt x="13765" y="1366145"/>
                  </a:lnTo>
                  <a:lnTo>
                    <a:pt x="12269" y="1361545"/>
                  </a:lnTo>
                  <a:lnTo>
                    <a:pt x="10826" y="1356946"/>
                  </a:lnTo>
                  <a:lnTo>
                    <a:pt x="9523" y="1352346"/>
                  </a:lnTo>
                  <a:lnTo>
                    <a:pt x="8258" y="1347746"/>
                  </a:lnTo>
                  <a:lnTo>
                    <a:pt x="7125" y="1343146"/>
                  </a:lnTo>
                  <a:lnTo>
                    <a:pt x="6054" y="1338546"/>
                  </a:lnTo>
                  <a:lnTo>
                    <a:pt x="5075" y="1333946"/>
                  </a:lnTo>
                  <a:lnTo>
                    <a:pt x="4196" y="1329347"/>
                  </a:lnTo>
                  <a:lnTo>
                    <a:pt x="3371" y="1324747"/>
                  </a:lnTo>
                  <a:lnTo>
                    <a:pt x="2683" y="1320147"/>
                  </a:lnTo>
                  <a:lnTo>
                    <a:pt x="2033" y="1315547"/>
                  </a:lnTo>
                  <a:lnTo>
                    <a:pt x="1511" y="1310947"/>
                  </a:lnTo>
                  <a:lnTo>
                    <a:pt x="1048" y="1306348"/>
                  </a:lnTo>
                  <a:lnTo>
                    <a:pt x="674" y="1301748"/>
                  </a:lnTo>
                  <a:lnTo>
                    <a:pt x="394" y="1297148"/>
                  </a:lnTo>
                  <a:lnTo>
                    <a:pt x="167" y="1292548"/>
                  </a:lnTo>
                  <a:lnTo>
                    <a:pt x="66" y="1287948"/>
                  </a:lnTo>
                  <a:lnTo>
                    <a:pt x="0" y="1283348"/>
                  </a:lnTo>
                  <a:lnTo>
                    <a:pt x="52" y="1278749"/>
                  </a:lnTo>
                  <a:lnTo>
                    <a:pt x="157" y="1274149"/>
                  </a:lnTo>
                  <a:lnTo>
                    <a:pt x="345" y="1269549"/>
                  </a:lnTo>
                  <a:lnTo>
                    <a:pt x="614" y="1264949"/>
                  </a:lnTo>
                  <a:lnTo>
                    <a:pt x="931" y="1260349"/>
                  </a:lnTo>
                  <a:lnTo>
                    <a:pt x="1359" y="1255750"/>
                  </a:lnTo>
                  <a:lnTo>
                    <a:pt x="1816" y="1251150"/>
                  </a:lnTo>
                  <a:lnTo>
                    <a:pt x="2377" y="1246550"/>
                  </a:lnTo>
                  <a:lnTo>
                    <a:pt x="2981" y="1241950"/>
                  </a:lnTo>
                  <a:lnTo>
                    <a:pt x="3655" y="1237350"/>
                  </a:lnTo>
                  <a:lnTo>
                    <a:pt x="4397" y="1232750"/>
                  </a:lnTo>
                  <a:lnTo>
                    <a:pt x="5179" y="1228151"/>
                  </a:lnTo>
                  <a:lnTo>
                    <a:pt x="6050" y="1223551"/>
                  </a:lnTo>
                  <a:lnTo>
                    <a:pt x="6945" y="1218951"/>
                  </a:lnTo>
                  <a:lnTo>
                    <a:pt x="7922" y="1214351"/>
                  </a:lnTo>
                  <a:lnTo>
                    <a:pt x="8932" y="1209751"/>
                  </a:lnTo>
                  <a:lnTo>
                    <a:pt x="9997" y="1205152"/>
                  </a:lnTo>
                  <a:lnTo>
                    <a:pt x="11113" y="1200552"/>
                  </a:lnTo>
                  <a:lnTo>
                    <a:pt x="12259" y="1195952"/>
                  </a:lnTo>
                  <a:lnTo>
                    <a:pt x="13469" y="1191352"/>
                  </a:lnTo>
                  <a:lnTo>
                    <a:pt x="14697" y="1186752"/>
                  </a:lnTo>
                  <a:lnTo>
                    <a:pt x="15982" y="1182152"/>
                  </a:lnTo>
                  <a:lnTo>
                    <a:pt x="17290" y="1177553"/>
                  </a:lnTo>
                  <a:lnTo>
                    <a:pt x="18635" y="1172953"/>
                  </a:lnTo>
                  <a:lnTo>
                    <a:pt x="20013" y="1168353"/>
                  </a:lnTo>
                  <a:lnTo>
                    <a:pt x="21410" y="1163753"/>
                  </a:lnTo>
                  <a:lnTo>
                    <a:pt x="22846" y="1159153"/>
                  </a:lnTo>
                  <a:lnTo>
                    <a:pt x="24292" y="1154554"/>
                  </a:lnTo>
                  <a:lnTo>
                    <a:pt x="25771" y="1149954"/>
                  </a:lnTo>
                  <a:lnTo>
                    <a:pt x="27262" y="1145354"/>
                  </a:lnTo>
                  <a:lnTo>
                    <a:pt x="28771" y="1140754"/>
                  </a:lnTo>
                  <a:lnTo>
                    <a:pt x="30295" y="1136154"/>
                  </a:lnTo>
                  <a:lnTo>
                    <a:pt x="31829" y="1131554"/>
                  </a:lnTo>
                  <a:lnTo>
                    <a:pt x="33377" y="1126955"/>
                  </a:lnTo>
                  <a:lnTo>
                    <a:pt x="34928" y="1122355"/>
                  </a:lnTo>
                  <a:lnTo>
                    <a:pt x="36488" y="1117755"/>
                  </a:lnTo>
                  <a:lnTo>
                    <a:pt x="38050" y="1113155"/>
                  </a:lnTo>
                  <a:lnTo>
                    <a:pt x="39615" y="1108555"/>
                  </a:lnTo>
                  <a:lnTo>
                    <a:pt x="41178" y="1103956"/>
                  </a:lnTo>
                  <a:lnTo>
                    <a:pt x="42741" y="1099356"/>
                  </a:lnTo>
                  <a:lnTo>
                    <a:pt x="44297" y="1094756"/>
                  </a:lnTo>
                  <a:lnTo>
                    <a:pt x="45851" y="1090156"/>
                  </a:lnTo>
                  <a:lnTo>
                    <a:pt x="47393" y="1085556"/>
                  </a:lnTo>
                  <a:lnTo>
                    <a:pt x="48929" y="1080957"/>
                  </a:lnTo>
                  <a:lnTo>
                    <a:pt x="50454" y="1076357"/>
                  </a:lnTo>
                  <a:lnTo>
                    <a:pt x="51966" y="1071757"/>
                  </a:lnTo>
                  <a:lnTo>
                    <a:pt x="53469" y="1067157"/>
                  </a:lnTo>
                  <a:lnTo>
                    <a:pt x="54949" y="1062557"/>
                  </a:lnTo>
                  <a:lnTo>
                    <a:pt x="56423" y="1057957"/>
                  </a:lnTo>
                  <a:lnTo>
                    <a:pt x="57870" y="1053358"/>
                  </a:lnTo>
                  <a:lnTo>
                    <a:pt x="59306" y="1048758"/>
                  </a:lnTo>
                  <a:lnTo>
                    <a:pt x="60721" y="1044158"/>
                  </a:lnTo>
                  <a:lnTo>
                    <a:pt x="62114" y="1039558"/>
                  </a:lnTo>
                  <a:lnTo>
                    <a:pt x="63493" y="1034958"/>
                  </a:lnTo>
                  <a:lnTo>
                    <a:pt x="64841" y="1030359"/>
                  </a:lnTo>
                  <a:lnTo>
                    <a:pt x="66179" y="1025759"/>
                  </a:lnTo>
                  <a:lnTo>
                    <a:pt x="67483" y="1021159"/>
                  </a:lnTo>
                  <a:lnTo>
                    <a:pt x="68772" y="1016559"/>
                  </a:lnTo>
                  <a:lnTo>
                    <a:pt x="70035" y="1011959"/>
                  </a:lnTo>
                  <a:lnTo>
                    <a:pt x="71275" y="1007359"/>
                  </a:lnTo>
                  <a:lnTo>
                    <a:pt x="72498" y="1002760"/>
                  </a:lnTo>
                  <a:lnTo>
                    <a:pt x="73686" y="998160"/>
                  </a:lnTo>
                  <a:lnTo>
                    <a:pt x="74865" y="993560"/>
                  </a:lnTo>
                  <a:lnTo>
                    <a:pt x="76008" y="988960"/>
                  </a:lnTo>
                  <a:lnTo>
                    <a:pt x="77137" y="984360"/>
                  </a:lnTo>
                  <a:lnTo>
                    <a:pt x="78241" y="979761"/>
                  </a:lnTo>
                  <a:lnTo>
                    <a:pt x="79323" y="975161"/>
                  </a:lnTo>
                  <a:lnTo>
                    <a:pt x="80389" y="970561"/>
                  </a:lnTo>
                  <a:lnTo>
                    <a:pt x="81426" y="965961"/>
                  </a:lnTo>
                  <a:lnTo>
                    <a:pt x="82454" y="961361"/>
                  </a:lnTo>
                  <a:lnTo>
                    <a:pt x="83452" y="956761"/>
                  </a:lnTo>
                  <a:lnTo>
                    <a:pt x="84439" y="952162"/>
                  </a:lnTo>
                  <a:lnTo>
                    <a:pt x="85407" y="947562"/>
                  </a:lnTo>
                  <a:lnTo>
                    <a:pt x="86359" y="942962"/>
                  </a:lnTo>
                  <a:lnTo>
                    <a:pt x="87300" y="938362"/>
                  </a:lnTo>
                  <a:lnTo>
                    <a:pt x="88221" y="933762"/>
                  </a:lnTo>
                  <a:lnTo>
                    <a:pt x="89137" y="929163"/>
                  </a:lnTo>
                  <a:lnTo>
                    <a:pt x="90035" y="924563"/>
                  </a:lnTo>
                  <a:lnTo>
                    <a:pt x="90928" y="919963"/>
                  </a:lnTo>
                  <a:lnTo>
                    <a:pt x="91811" y="915363"/>
                  </a:lnTo>
                  <a:lnTo>
                    <a:pt x="92688" y="910763"/>
                  </a:lnTo>
                  <a:lnTo>
                    <a:pt x="93560" y="906163"/>
                  </a:lnTo>
                  <a:lnTo>
                    <a:pt x="94428" y="901564"/>
                  </a:lnTo>
                  <a:lnTo>
                    <a:pt x="95294" y="896964"/>
                  </a:lnTo>
                  <a:lnTo>
                    <a:pt x="96160" y="892364"/>
                  </a:lnTo>
                  <a:lnTo>
                    <a:pt x="97027" y="887764"/>
                  </a:lnTo>
                  <a:lnTo>
                    <a:pt x="97897" y="883164"/>
                  </a:lnTo>
                  <a:lnTo>
                    <a:pt x="98773" y="878565"/>
                  </a:lnTo>
                  <a:lnTo>
                    <a:pt x="99653" y="873965"/>
                  </a:lnTo>
                  <a:lnTo>
                    <a:pt x="100545" y="869365"/>
                  </a:lnTo>
                  <a:lnTo>
                    <a:pt x="101441" y="864765"/>
                  </a:lnTo>
                  <a:lnTo>
                    <a:pt x="102356" y="860165"/>
                  </a:lnTo>
                  <a:lnTo>
                    <a:pt x="103279" y="855565"/>
                  </a:lnTo>
                  <a:lnTo>
                    <a:pt x="104220" y="850966"/>
                  </a:lnTo>
                  <a:lnTo>
                    <a:pt x="105178" y="846366"/>
                  </a:lnTo>
                  <a:lnTo>
                    <a:pt x="106149" y="841766"/>
                  </a:lnTo>
                  <a:lnTo>
                    <a:pt x="107150" y="837166"/>
                  </a:lnTo>
                  <a:lnTo>
                    <a:pt x="108161" y="832566"/>
                  </a:lnTo>
                  <a:lnTo>
                    <a:pt x="109209" y="827967"/>
                  </a:lnTo>
                  <a:lnTo>
                    <a:pt x="110273" y="823367"/>
                  </a:lnTo>
                  <a:lnTo>
                    <a:pt x="111367" y="818767"/>
                  </a:lnTo>
                  <a:lnTo>
                    <a:pt x="112491" y="814167"/>
                  </a:lnTo>
                  <a:lnTo>
                    <a:pt x="113636" y="809567"/>
                  </a:lnTo>
                  <a:lnTo>
                    <a:pt x="114827" y="804967"/>
                  </a:lnTo>
                  <a:lnTo>
                    <a:pt x="116031" y="800368"/>
                  </a:lnTo>
                  <a:lnTo>
                    <a:pt x="117291" y="795768"/>
                  </a:lnTo>
                  <a:lnTo>
                    <a:pt x="118570" y="791168"/>
                  </a:lnTo>
                  <a:lnTo>
                    <a:pt x="119893" y="786568"/>
                  </a:lnTo>
                  <a:lnTo>
                    <a:pt x="121253" y="781968"/>
                  </a:lnTo>
                  <a:lnTo>
                    <a:pt x="122643" y="777369"/>
                  </a:lnTo>
                  <a:lnTo>
                    <a:pt x="124088" y="772769"/>
                  </a:lnTo>
                  <a:lnTo>
                    <a:pt x="125552" y="768169"/>
                  </a:lnTo>
                  <a:lnTo>
                    <a:pt x="127083" y="763569"/>
                  </a:lnTo>
                  <a:lnTo>
                    <a:pt x="128637" y="758969"/>
                  </a:lnTo>
                  <a:lnTo>
                    <a:pt x="130243" y="754369"/>
                  </a:lnTo>
                  <a:lnTo>
                    <a:pt x="131891" y="749770"/>
                  </a:lnTo>
                  <a:lnTo>
                    <a:pt x="133573" y="745170"/>
                  </a:lnTo>
                  <a:lnTo>
                    <a:pt x="135318" y="740570"/>
                  </a:lnTo>
                  <a:lnTo>
                    <a:pt x="137082" y="735970"/>
                  </a:lnTo>
                  <a:lnTo>
                    <a:pt x="138921" y="731370"/>
                  </a:lnTo>
                  <a:lnTo>
                    <a:pt x="140783" y="726771"/>
                  </a:lnTo>
                  <a:lnTo>
                    <a:pt x="142701" y="722171"/>
                  </a:lnTo>
                  <a:lnTo>
                    <a:pt x="144662" y="717571"/>
                  </a:lnTo>
                  <a:lnTo>
                    <a:pt x="146658" y="712971"/>
                  </a:lnTo>
                  <a:lnTo>
                    <a:pt x="148717" y="708371"/>
                  </a:lnTo>
                  <a:lnTo>
                    <a:pt x="150796" y="703772"/>
                  </a:lnTo>
                  <a:lnTo>
                    <a:pt x="152948" y="699172"/>
                  </a:lnTo>
                  <a:lnTo>
                    <a:pt x="155123" y="694572"/>
                  </a:lnTo>
                  <a:lnTo>
                    <a:pt x="157351" y="689972"/>
                  </a:lnTo>
                  <a:lnTo>
                    <a:pt x="159620" y="685372"/>
                  </a:lnTo>
                  <a:lnTo>
                    <a:pt x="161921" y="680772"/>
                  </a:lnTo>
                  <a:lnTo>
                    <a:pt x="164280" y="676173"/>
                  </a:lnTo>
                  <a:lnTo>
                    <a:pt x="166657" y="671573"/>
                  </a:lnTo>
                  <a:lnTo>
                    <a:pt x="169098" y="666973"/>
                  </a:lnTo>
                  <a:lnTo>
                    <a:pt x="171559" y="662373"/>
                  </a:lnTo>
                  <a:lnTo>
                    <a:pt x="174066" y="657773"/>
                  </a:lnTo>
                  <a:lnTo>
                    <a:pt x="176606" y="653174"/>
                  </a:lnTo>
                  <a:lnTo>
                    <a:pt x="179175" y="648574"/>
                  </a:lnTo>
                  <a:lnTo>
                    <a:pt x="181788" y="643974"/>
                  </a:lnTo>
                  <a:lnTo>
                    <a:pt x="184416" y="639374"/>
                  </a:lnTo>
                  <a:lnTo>
                    <a:pt x="187095" y="634774"/>
                  </a:lnTo>
                  <a:lnTo>
                    <a:pt x="189787" y="630174"/>
                  </a:lnTo>
                  <a:lnTo>
                    <a:pt x="192514" y="625575"/>
                  </a:lnTo>
                  <a:lnTo>
                    <a:pt x="195264" y="620975"/>
                  </a:lnTo>
                  <a:lnTo>
                    <a:pt x="198034" y="616375"/>
                  </a:lnTo>
                  <a:lnTo>
                    <a:pt x="200833" y="611775"/>
                  </a:lnTo>
                  <a:lnTo>
                    <a:pt x="203641" y="607175"/>
                  </a:lnTo>
                  <a:lnTo>
                    <a:pt x="206481" y="602576"/>
                  </a:lnTo>
                  <a:lnTo>
                    <a:pt x="209328" y="597976"/>
                  </a:lnTo>
                  <a:lnTo>
                    <a:pt x="212193" y="593376"/>
                  </a:lnTo>
                  <a:lnTo>
                    <a:pt x="215070" y="588776"/>
                  </a:lnTo>
                  <a:lnTo>
                    <a:pt x="217955" y="584176"/>
                  </a:lnTo>
                  <a:lnTo>
                    <a:pt x="220852" y="579576"/>
                  </a:lnTo>
                  <a:lnTo>
                    <a:pt x="223753" y="574977"/>
                  </a:lnTo>
                  <a:lnTo>
                    <a:pt x="226661" y="570377"/>
                  </a:lnTo>
                  <a:lnTo>
                    <a:pt x="229569" y="565777"/>
                  </a:lnTo>
                  <a:lnTo>
                    <a:pt x="232479" y="561177"/>
                  </a:lnTo>
                  <a:lnTo>
                    <a:pt x="235386" y="556577"/>
                  </a:lnTo>
                  <a:lnTo>
                    <a:pt x="238291" y="551978"/>
                  </a:lnTo>
                  <a:lnTo>
                    <a:pt x="241188" y="547378"/>
                  </a:lnTo>
                  <a:lnTo>
                    <a:pt x="244082" y="542778"/>
                  </a:lnTo>
                  <a:lnTo>
                    <a:pt x="246959" y="538178"/>
                  </a:lnTo>
                  <a:lnTo>
                    <a:pt x="249830" y="533578"/>
                  </a:lnTo>
                  <a:lnTo>
                    <a:pt x="252684" y="528978"/>
                  </a:lnTo>
                  <a:lnTo>
                    <a:pt x="255523" y="524379"/>
                  </a:lnTo>
                  <a:lnTo>
                    <a:pt x="258348" y="519779"/>
                  </a:lnTo>
                  <a:lnTo>
                    <a:pt x="261145" y="515179"/>
                  </a:lnTo>
                  <a:lnTo>
                    <a:pt x="263935" y="510579"/>
                  </a:lnTo>
                  <a:lnTo>
                    <a:pt x="266684" y="505979"/>
                  </a:lnTo>
                  <a:lnTo>
                    <a:pt x="269421" y="501380"/>
                  </a:lnTo>
                  <a:lnTo>
                    <a:pt x="272124" y="496780"/>
                  </a:lnTo>
                  <a:lnTo>
                    <a:pt x="274800" y="492180"/>
                  </a:lnTo>
                  <a:lnTo>
                    <a:pt x="277452" y="487580"/>
                  </a:lnTo>
                  <a:lnTo>
                    <a:pt x="280061" y="482980"/>
                  </a:lnTo>
                  <a:lnTo>
                    <a:pt x="282655" y="478380"/>
                  </a:lnTo>
                  <a:lnTo>
                    <a:pt x="285190" y="473781"/>
                  </a:lnTo>
                  <a:lnTo>
                    <a:pt x="287707" y="469181"/>
                  </a:lnTo>
                  <a:lnTo>
                    <a:pt x="290177" y="464581"/>
                  </a:lnTo>
                  <a:lnTo>
                    <a:pt x="292611" y="459981"/>
                  </a:lnTo>
                  <a:lnTo>
                    <a:pt x="295011" y="455381"/>
                  </a:lnTo>
                  <a:lnTo>
                    <a:pt x="297355" y="450782"/>
                  </a:lnTo>
                  <a:lnTo>
                    <a:pt x="299682" y="446182"/>
                  </a:lnTo>
                  <a:lnTo>
                    <a:pt x="301933" y="441582"/>
                  </a:lnTo>
                  <a:lnTo>
                    <a:pt x="304163" y="436982"/>
                  </a:lnTo>
                  <a:lnTo>
                    <a:pt x="306335" y="432382"/>
                  </a:lnTo>
                  <a:lnTo>
                    <a:pt x="308465" y="427782"/>
                  </a:lnTo>
                  <a:lnTo>
                    <a:pt x="310556" y="423183"/>
                  </a:lnTo>
                  <a:lnTo>
                    <a:pt x="312583" y="418583"/>
                  </a:lnTo>
                  <a:lnTo>
                    <a:pt x="314589" y="413983"/>
                  </a:lnTo>
                  <a:lnTo>
                    <a:pt x="316510" y="409383"/>
                  </a:lnTo>
                  <a:lnTo>
                    <a:pt x="318409" y="404783"/>
                  </a:lnTo>
                  <a:lnTo>
                    <a:pt x="320243" y="400184"/>
                  </a:lnTo>
                  <a:lnTo>
                    <a:pt x="322033" y="395584"/>
                  </a:lnTo>
                  <a:lnTo>
                    <a:pt x="323780" y="390984"/>
                  </a:lnTo>
                  <a:lnTo>
                    <a:pt x="325460" y="386384"/>
                  </a:lnTo>
                  <a:lnTo>
                    <a:pt x="327118" y="381784"/>
                  </a:lnTo>
                  <a:lnTo>
                    <a:pt x="328688" y="377184"/>
                  </a:lnTo>
                  <a:lnTo>
                    <a:pt x="330236" y="372585"/>
                  </a:lnTo>
                  <a:lnTo>
                    <a:pt x="331718" y="367985"/>
                  </a:lnTo>
                  <a:lnTo>
                    <a:pt x="333156" y="363385"/>
                  </a:lnTo>
                  <a:lnTo>
                    <a:pt x="334551" y="358785"/>
                  </a:lnTo>
                  <a:lnTo>
                    <a:pt x="335881" y="354185"/>
                  </a:lnTo>
                  <a:lnTo>
                    <a:pt x="337189" y="349586"/>
                  </a:lnTo>
                  <a:lnTo>
                    <a:pt x="338412" y="344986"/>
                  </a:lnTo>
                  <a:lnTo>
                    <a:pt x="339615" y="340386"/>
                  </a:lnTo>
                  <a:lnTo>
                    <a:pt x="340755" y="335786"/>
                  </a:lnTo>
                  <a:lnTo>
                    <a:pt x="341854" y="331186"/>
                  </a:lnTo>
                  <a:lnTo>
                    <a:pt x="342913" y="326587"/>
                  </a:lnTo>
                  <a:lnTo>
                    <a:pt x="343913" y="321987"/>
                  </a:lnTo>
                  <a:lnTo>
                    <a:pt x="344892" y="317387"/>
                  </a:lnTo>
                  <a:lnTo>
                    <a:pt x="345797" y="312787"/>
                  </a:lnTo>
                  <a:lnTo>
                    <a:pt x="346682" y="308187"/>
                  </a:lnTo>
                  <a:lnTo>
                    <a:pt x="347513" y="303587"/>
                  </a:lnTo>
                  <a:lnTo>
                    <a:pt x="348308" y="298988"/>
                  </a:lnTo>
                  <a:lnTo>
                    <a:pt x="349069" y="294388"/>
                  </a:lnTo>
                  <a:lnTo>
                    <a:pt x="349779" y="289788"/>
                  </a:lnTo>
                  <a:lnTo>
                    <a:pt x="350473" y="285188"/>
                  </a:lnTo>
                  <a:lnTo>
                    <a:pt x="351104" y="280588"/>
                  </a:lnTo>
                  <a:lnTo>
                    <a:pt x="351720" y="275989"/>
                  </a:lnTo>
                  <a:lnTo>
                    <a:pt x="352292" y="271389"/>
                  </a:lnTo>
                  <a:lnTo>
                    <a:pt x="352836" y="266789"/>
                  </a:lnTo>
                  <a:lnTo>
                    <a:pt x="353352" y="262189"/>
                  </a:lnTo>
                  <a:lnTo>
                    <a:pt x="353830" y="257589"/>
                  </a:lnTo>
                  <a:lnTo>
                    <a:pt x="354295" y="252989"/>
                  </a:lnTo>
                  <a:lnTo>
                    <a:pt x="354714" y="248390"/>
                  </a:lnTo>
                  <a:lnTo>
                    <a:pt x="355122" y="243790"/>
                  </a:lnTo>
                  <a:lnTo>
                    <a:pt x="355497" y="239190"/>
                  </a:lnTo>
                  <a:lnTo>
                    <a:pt x="355854" y="234590"/>
                  </a:lnTo>
                  <a:lnTo>
                    <a:pt x="356191" y="229990"/>
                  </a:lnTo>
                  <a:lnTo>
                    <a:pt x="356503" y="225391"/>
                  </a:lnTo>
                  <a:lnTo>
                    <a:pt x="356806" y="220791"/>
                  </a:lnTo>
                  <a:lnTo>
                    <a:pt x="357081" y="216191"/>
                  </a:lnTo>
                  <a:lnTo>
                    <a:pt x="357349" y="211591"/>
                  </a:lnTo>
                  <a:lnTo>
                    <a:pt x="357598" y="206991"/>
                  </a:lnTo>
                  <a:lnTo>
                    <a:pt x="357837" y="202391"/>
                  </a:lnTo>
                  <a:lnTo>
                    <a:pt x="358066" y="197792"/>
                  </a:lnTo>
                  <a:lnTo>
                    <a:pt x="358282" y="193192"/>
                  </a:lnTo>
                  <a:lnTo>
                    <a:pt x="358495" y="188592"/>
                  </a:lnTo>
                  <a:lnTo>
                    <a:pt x="358695" y="183992"/>
                  </a:lnTo>
                  <a:lnTo>
                    <a:pt x="358894" y="179392"/>
                  </a:lnTo>
                  <a:lnTo>
                    <a:pt x="359087" y="174793"/>
                  </a:lnTo>
                  <a:lnTo>
                    <a:pt x="359278" y="170193"/>
                  </a:lnTo>
                  <a:lnTo>
                    <a:pt x="359468" y="165593"/>
                  </a:lnTo>
                  <a:lnTo>
                    <a:pt x="359658" y="160993"/>
                  </a:lnTo>
                  <a:lnTo>
                    <a:pt x="359847" y="156393"/>
                  </a:lnTo>
                  <a:lnTo>
                    <a:pt x="360042" y="151793"/>
                  </a:lnTo>
                  <a:lnTo>
                    <a:pt x="360237" y="147194"/>
                  </a:lnTo>
                  <a:lnTo>
                    <a:pt x="360440" y="142594"/>
                  </a:lnTo>
                  <a:lnTo>
                    <a:pt x="360647" y="137994"/>
                  </a:lnTo>
                  <a:lnTo>
                    <a:pt x="360861" y="133394"/>
                  </a:lnTo>
                  <a:lnTo>
                    <a:pt x="361085" y="128794"/>
                  </a:lnTo>
                  <a:lnTo>
                    <a:pt x="361314" y="124195"/>
                  </a:lnTo>
                  <a:lnTo>
                    <a:pt x="361559" y="119595"/>
                  </a:lnTo>
                  <a:lnTo>
                    <a:pt x="361810" y="114995"/>
                  </a:lnTo>
                  <a:lnTo>
                    <a:pt x="362077" y="110395"/>
                  </a:lnTo>
                  <a:lnTo>
                    <a:pt x="362356" y="105795"/>
                  </a:lnTo>
                  <a:lnTo>
                    <a:pt x="362646" y="101195"/>
                  </a:lnTo>
                  <a:lnTo>
                    <a:pt x="362955" y="96596"/>
                  </a:lnTo>
                  <a:lnTo>
                    <a:pt x="363272" y="91996"/>
                  </a:lnTo>
                  <a:lnTo>
                    <a:pt x="363616" y="87396"/>
                  </a:lnTo>
                  <a:lnTo>
                    <a:pt x="363967" y="82796"/>
                  </a:lnTo>
                  <a:lnTo>
                    <a:pt x="364342" y="78196"/>
                  </a:lnTo>
                  <a:lnTo>
                    <a:pt x="364731" y="73597"/>
                  </a:lnTo>
                  <a:lnTo>
                    <a:pt x="365138" y="68997"/>
                  </a:lnTo>
                  <a:lnTo>
                    <a:pt x="365569" y="64397"/>
                  </a:lnTo>
                  <a:lnTo>
                    <a:pt x="366009" y="59797"/>
                  </a:lnTo>
                  <a:lnTo>
                    <a:pt x="366482" y="55197"/>
                  </a:lnTo>
                  <a:lnTo>
                    <a:pt x="366964" y="50597"/>
                  </a:lnTo>
                  <a:lnTo>
                    <a:pt x="367474" y="45998"/>
                  </a:lnTo>
                  <a:lnTo>
                    <a:pt x="368001" y="41398"/>
                  </a:lnTo>
                  <a:lnTo>
                    <a:pt x="368547" y="36798"/>
                  </a:lnTo>
                  <a:lnTo>
                    <a:pt x="369120" y="32198"/>
                  </a:lnTo>
                  <a:lnTo>
                    <a:pt x="369703" y="27598"/>
                  </a:lnTo>
                  <a:lnTo>
                    <a:pt x="370322" y="22999"/>
                  </a:lnTo>
                  <a:lnTo>
                    <a:pt x="370949" y="18399"/>
                  </a:lnTo>
                  <a:lnTo>
                    <a:pt x="371607" y="13799"/>
                  </a:lnTo>
                  <a:lnTo>
                    <a:pt x="372280" y="9199"/>
                  </a:lnTo>
                  <a:lnTo>
                    <a:pt x="372974" y="4599"/>
                  </a:lnTo>
                  <a:lnTo>
                    <a:pt x="373694" y="0"/>
                  </a:lnTo>
                  <a:lnTo>
                    <a:pt x="555645" y="0"/>
                  </a:lnTo>
                  <a:lnTo>
                    <a:pt x="556365" y="4599"/>
                  </a:lnTo>
                  <a:lnTo>
                    <a:pt x="557059" y="9199"/>
                  </a:lnTo>
                  <a:lnTo>
                    <a:pt x="557733" y="13799"/>
                  </a:lnTo>
                  <a:lnTo>
                    <a:pt x="558390" y="18399"/>
                  </a:lnTo>
                  <a:lnTo>
                    <a:pt x="559018" y="22999"/>
                  </a:lnTo>
                  <a:lnTo>
                    <a:pt x="559636" y="27598"/>
                  </a:lnTo>
                  <a:lnTo>
                    <a:pt x="560220" y="32198"/>
                  </a:lnTo>
                  <a:lnTo>
                    <a:pt x="560792" y="36798"/>
                  </a:lnTo>
                  <a:lnTo>
                    <a:pt x="561338" y="41398"/>
                  </a:lnTo>
                  <a:lnTo>
                    <a:pt x="561865" y="45998"/>
                  </a:lnTo>
                  <a:lnTo>
                    <a:pt x="562375" y="50597"/>
                  </a:lnTo>
                  <a:lnTo>
                    <a:pt x="562857" y="55197"/>
                  </a:lnTo>
                  <a:lnTo>
                    <a:pt x="563331" y="59797"/>
                  </a:lnTo>
                  <a:lnTo>
                    <a:pt x="563771" y="64397"/>
                  </a:lnTo>
                  <a:lnTo>
                    <a:pt x="564201" y="68997"/>
                  </a:lnTo>
                  <a:lnTo>
                    <a:pt x="564608" y="73597"/>
                  </a:lnTo>
                  <a:lnTo>
                    <a:pt x="564997" y="78196"/>
                  </a:lnTo>
                  <a:lnTo>
                    <a:pt x="565372" y="82796"/>
                  </a:lnTo>
                  <a:lnTo>
                    <a:pt x="565724" y="87396"/>
                  </a:lnTo>
                  <a:lnTo>
                    <a:pt x="566067" y="91996"/>
                  </a:lnTo>
                  <a:lnTo>
                    <a:pt x="566384" y="96596"/>
                  </a:lnTo>
                  <a:lnTo>
                    <a:pt x="566693" y="101195"/>
                  </a:lnTo>
                  <a:lnTo>
                    <a:pt x="566984" y="105795"/>
                  </a:lnTo>
                  <a:lnTo>
                    <a:pt x="567262" y="110395"/>
                  </a:lnTo>
                  <a:lnTo>
                    <a:pt x="567529" y="114995"/>
                  </a:lnTo>
                  <a:lnTo>
                    <a:pt x="567780" y="119595"/>
                  </a:lnTo>
                  <a:lnTo>
                    <a:pt x="568026" y="124195"/>
                  </a:lnTo>
                  <a:lnTo>
                    <a:pt x="568254" y="128794"/>
                  </a:lnTo>
                  <a:lnTo>
                    <a:pt x="568478" y="133394"/>
                  </a:lnTo>
                  <a:lnTo>
                    <a:pt x="568692" y="137994"/>
                  </a:lnTo>
                  <a:lnTo>
                    <a:pt x="568900" y="142594"/>
                  </a:lnTo>
                  <a:lnTo>
                    <a:pt x="569102" y="147194"/>
                  </a:lnTo>
                  <a:lnTo>
                    <a:pt x="569298" y="151793"/>
                  </a:lnTo>
                  <a:lnTo>
                    <a:pt x="569492" y="156393"/>
                  </a:lnTo>
                  <a:lnTo>
                    <a:pt x="569682" y="160993"/>
                  </a:lnTo>
                  <a:lnTo>
                    <a:pt x="569871" y="165593"/>
                  </a:lnTo>
                  <a:lnTo>
                    <a:pt x="570061" y="170193"/>
                  </a:lnTo>
                  <a:lnTo>
                    <a:pt x="570252" y="174793"/>
                  </a:lnTo>
                  <a:lnTo>
                    <a:pt x="570445" y="179392"/>
                  </a:lnTo>
                  <a:lnTo>
                    <a:pt x="570644" y="183992"/>
                  </a:lnTo>
                  <a:lnTo>
                    <a:pt x="570845" y="188592"/>
                  </a:lnTo>
                  <a:lnTo>
                    <a:pt x="571057" y="193192"/>
                  </a:lnTo>
                  <a:lnTo>
                    <a:pt x="571274" y="197792"/>
                  </a:lnTo>
                  <a:lnTo>
                    <a:pt x="571502" y="202391"/>
                  </a:lnTo>
                  <a:lnTo>
                    <a:pt x="571741" y="206991"/>
                  </a:lnTo>
                  <a:lnTo>
                    <a:pt x="571990" y="211591"/>
                  </a:lnTo>
                  <a:lnTo>
                    <a:pt x="572259" y="216191"/>
                  </a:lnTo>
                  <a:lnTo>
                    <a:pt x="572533" y="220791"/>
                  </a:lnTo>
                  <a:lnTo>
                    <a:pt x="572836" y="225391"/>
                  </a:lnTo>
                  <a:lnTo>
                    <a:pt x="573149" y="229990"/>
                  </a:lnTo>
                  <a:lnTo>
                    <a:pt x="573486" y="234590"/>
                  </a:lnTo>
                  <a:lnTo>
                    <a:pt x="573842" y="239190"/>
                  </a:lnTo>
                  <a:lnTo>
                    <a:pt x="574218" y="243790"/>
                  </a:lnTo>
                  <a:lnTo>
                    <a:pt x="574626" y="248390"/>
                  </a:lnTo>
                  <a:lnTo>
                    <a:pt x="575044" y="252989"/>
                  </a:lnTo>
                  <a:lnTo>
                    <a:pt x="575509" y="257589"/>
                  </a:lnTo>
                  <a:lnTo>
                    <a:pt x="575987" y="262189"/>
                  </a:lnTo>
                  <a:lnTo>
                    <a:pt x="576503" y="266789"/>
                  </a:lnTo>
                  <a:lnTo>
                    <a:pt x="577048" y="271389"/>
                  </a:lnTo>
                  <a:lnTo>
                    <a:pt x="577619" y="275989"/>
                  </a:lnTo>
                  <a:lnTo>
                    <a:pt x="578235" y="280588"/>
                  </a:lnTo>
                  <a:lnTo>
                    <a:pt x="578866" y="285188"/>
                  </a:lnTo>
                  <a:lnTo>
                    <a:pt x="579560" y="289788"/>
                  </a:lnTo>
                  <a:lnTo>
                    <a:pt x="580271" y="294388"/>
                  </a:lnTo>
                  <a:lnTo>
                    <a:pt x="581031" y="298988"/>
                  </a:lnTo>
                  <a:lnTo>
                    <a:pt x="581827" y="303587"/>
                  </a:lnTo>
                  <a:lnTo>
                    <a:pt x="582657" y="308187"/>
                  </a:lnTo>
                  <a:lnTo>
                    <a:pt x="583543" y="312787"/>
                  </a:lnTo>
                  <a:lnTo>
                    <a:pt x="584447" y="317387"/>
                  </a:lnTo>
                  <a:lnTo>
                    <a:pt x="585427" y="321987"/>
                  </a:lnTo>
                  <a:lnTo>
                    <a:pt x="586426" y="326587"/>
                  </a:lnTo>
                  <a:lnTo>
                    <a:pt x="587485" y="331186"/>
                  </a:lnTo>
                  <a:lnTo>
                    <a:pt x="588585" y="335786"/>
                  </a:lnTo>
                  <a:lnTo>
                    <a:pt x="589725" y="340386"/>
                  </a:lnTo>
                  <a:lnTo>
                    <a:pt x="590927" y="344986"/>
                  </a:lnTo>
                  <a:lnTo>
                    <a:pt x="592150" y="349586"/>
                  </a:lnTo>
                  <a:lnTo>
                    <a:pt x="593459" y="354185"/>
                  </a:lnTo>
                  <a:lnTo>
                    <a:pt x="594788" y="358785"/>
                  </a:lnTo>
                  <a:lnTo>
                    <a:pt x="596183" y="363385"/>
                  </a:lnTo>
                  <a:lnTo>
                    <a:pt x="597621" y="367985"/>
                  </a:lnTo>
                  <a:lnTo>
                    <a:pt x="599103" y="372585"/>
                  </a:lnTo>
                  <a:lnTo>
                    <a:pt x="600651" y="377184"/>
                  </a:lnTo>
                  <a:lnTo>
                    <a:pt x="602221" y="381784"/>
                  </a:lnTo>
                  <a:lnTo>
                    <a:pt x="603879" y="386384"/>
                  </a:lnTo>
                  <a:lnTo>
                    <a:pt x="605560" y="390984"/>
                  </a:lnTo>
                  <a:lnTo>
                    <a:pt x="607306" y="395584"/>
                  </a:lnTo>
                  <a:lnTo>
                    <a:pt x="609096" y="400184"/>
                  </a:lnTo>
                  <a:lnTo>
                    <a:pt x="610931" y="404783"/>
                  </a:lnTo>
                  <a:lnTo>
                    <a:pt x="612829" y="409383"/>
                  </a:lnTo>
                  <a:lnTo>
                    <a:pt x="614751" y="413983"/>
                  </a:lnTo>
                  <a:lnTo>
                    <a:pt x="616757" y="418583"/>
                  </a:lnTo>
                  <a:lnTo>
                    <a:pt x="618783" y="423183"/>
                  </a:lnTo>
                  <a:lnTo>
                    <a:pt x="620874" y="427782"/>
                  </a:lnTo>
                  <a:lnTo>
                    <a:pt x="623004" y="432382"/>
                  </a:lnTo>
                  <a:lnTo>
                    <a:pt x="625176" y="436982"/>
                  </a:lnTo>
                  <a:lnTo>
                    <a:pt x="627407" y="441582"/>
                  </a:lnTo>
                  <a:lnTo>
                    <a:pt x="629658" y="446182"/>
                  </a:lnTo>
                  <a:lnTo>
                    <a:pt x="631984" y="450782"/>
                  </a:lnTo>
                  <a:lnTo>
                    <a:pt x="634328" y="455381"/>
                  </a:lnTo>
                  <a:lnTo>
                    <a:pt x="636729" y="459981"/>
                  </a:lnTo>
                  <a:lnTo>
                    <a:pt x="639162" y="464581"/>
                  </a:lnTo>
                  <a:lnTo>
                    <a:pt x="641632" y="469181"/>
                  </a:lnTo>
                  <a:lnTo>
                    <a:pt x="644149" y="473781"/>
                  </a:lnTo>
                  <a:lnTo>
                    <a:pt x="646684" y="478380"/>
                  </a:lnTo>
                  <a:lnTo>
                    <a:pt x="649278" y="482980"/>
                  </a:lnTo>
                  <a:lnTo>
                    <a:pt x="651887" y="487580"/>
                  </a:lnTo>
                  <a:lnTo>
                    <a:pt x="654539" y="492180"/>
                  </a:lnTo>
                  <a:lnTo>
                    <a:pt x="657215" y="496780"/>
                  </a:lnTo>
                  <a:lnTo>
                    <a:pt x="659919" y="501380"/>
                  </a:lnTo>
                  <a:lnTo>
                    <a:pt x="662655" y="505979"/>
                  </a:lnTo>
                  <a:lnTo>
                    <a:pt x="665405" y="510579"/>
                  </a:lnTo>
                  <a:lnTo>
                    <a:pt x="668194" y="515179"/>
                  </a:lnTo>
                  <a:lnTo>
                    <a:pt x="670992" y="519779"/>
                  </a:lnTo>
                  <a:lnTo>
                    <a:pt x="673817" y="524379"/>
                  </a:lnTo>
                  <a:lnTo>
                    <a:pt x="676655" y="528978"/>
                  </a:lnTo>
                  <a:lnTo>
                    <a:pt x="679510" y="533578"/>
                  </a:lnTo>
                  <a:lnTo>
                    <a:pt x="682380" y="538178"/>
                  </a:lnTo>
                  <a:lnTo>
                    <a:pt x="685258" y="542778"/>
                  </a:lnTo>
                  <a:lnTo>
                    <a:pt x="688152" y="547378"/>
                  </a:lnTo>
                  <a:lnTo>
                    <a:pt x="691048" y="551978"/>
                  </a:lnTo>
                  <a:lnTo>
                    <a:pt x="693953" y="556577"/>
                  </a:lnTo>
                  <a:lnTo>
                    <a:pt x="696861" y="561177"/>
                  </a:lnTo>
                  <a:lnTo>
                    <a:pt x="699770" y="565777"/>
                  </a:lnTo>
                  <a:lnTo>
                    <a:pt x="702679" y="570377"/>
                  </a:lnTo>
                  <a:lnTo>
                    <a:pt x="705587" y="574977"/>
                  </a:lnTo>
                  <a:lnTo>
                    <a:pt x="708487" y="579576"/>
                  </a:lnTo>
                  <a:lnTo>
                    <a:pt x="711384" y="584176"/>
                  </a:lnTo>
                  <a:lnTo>
                    <a:pt x="714270" y="588776"/>
                  </a:lnTo>
                  <a:lnTo>
                    <a:pt x="717146" y="593376"/>
                  </a:lnTo>
                  <a:lnTo>
                    <a:pt x="720012" y="597976"/>
                  </a:lnTo>
                  <a:lnTo>
                    <a:pt x="722858" y="602576"/>
                  </a:lnTo>
                  <a:lnTo>
                    <a:pt x="725698" y="607175"/>
                  </a:lnTo>
                  <a:lnTo>
                    <a:pt x="728506" y="611775"/>
                  </a:lnTo>
                  <a:lnTo>
                    <a:pt x="731306" y="616375"/>
                  </a:lnTo>
                  <a:lnTo>
                    <a:pt x="734075" y="620975"/>
                  </a:lnTo>
                  <a:lnTo>
                    <a:pt x="736825" y="625575"/>
                  </a:lnTo>
                  <a:lnTo>
                    <a:pt x="739552" y="630174"/>
                  </a:lnTo>
                  <a:lnTo>
                    <a:pt x="742244" y="634774"/>
                  </a:lnTo>
                  <a:lnTo>
                    <a:pt x="744923" y="639374"/>
                  </a:lnTo>
                  <a:lnTo>
                    <a:pt x="747551" y="643974"/>
                  </a:lnTo>
                  <a:lnTo>
                    <a:pt x="750165" y="648574"/>
                  </a:lnTo>
                  <a:lnTo>
                    <a:pt x="752733" y="653174"/>
                  </a:lnTo>
                  <a:lnTo>
                    <a:pt x="755273" y="657773"/>
                  </a:lnTo>
                  <a:lnTo>
                    <a:pt x="757780" y="662373"/>
                  </a:lnTo>
                  <a:lnTo>
                    <a:pt x="760241" y="666973"/>
                  </a:lnTo>
                  <a:lnTo>
                    <a:pt x="762683" y="671573"/>
                  </a:lnTo>
                  <a:lnTo>
                    <a:pt x="765059" y="676173"/>
                  </a:lnTo>
                  <a:lnTo>
                    <a:pt x="767418" y="680772"/>
                  </a:lnTo>
                  <a:lnTo>
                    <a:pt x="769720" y="685372"/>
                  </a:lnTo>
                  <a:lnTo>
                    <a:pt x="771988" y="689972"/>
                  </a:lnTo>
                  <a:lnTo>
                    <a:pt x="774216" y="694572"/>
                  </a:lnTo>
                  <a:lnTo>
                    <a:pt x="776391" y="699172"/>
                  </a:lnTo>
                  <a:lnTo>
                    <a:pt x="778543" y="703772"/>
                  </a:lnTo>
                  <a:lnTo>
                    <a:pt x="780622" y="708371"/>
                  </a:lnTo>
                  <a:lnTo>
                    <a:pt x="782681" y="712971"/>
                  </a:lnTo>
                  <a:lnTo>
                    <a:pt x="784677" y="717571"/>
                  </a:lnTo>
                  <a:lnTo>
                    <a:pt x="786639" y="722171"/>
                  </a:lnTo>
                  <a:lnTo>
                    <a:pt x="788556" y="726771"/>
                  </a:lnTo>
                  <a:lnTo>
                    <a:pt x="790418" y="731370"/>
                  </a:lnTo>
                  <a:lnTo>
                    <a:pt x="792257" y="735970"/>
                  </a:lnTo>
                  <a:lnTo>
                    <a:pt x="794021" y="740570"/>
                  </a:lnTo>
                  <a:lnTo>
                    <a:pt x="795766" y="745170"/>
                  </a:lnTo>
                  <a:lnTo>
                    <a:pt x="797448" y="749770"/>
                  </a:lnTo>
                  <a:lnTo>
                    <a:pt x="799096" y="754369"/>
                  </a:lnTo>
                  <a:lnTo>
                    <a:pt x="800702" y="758969"/>
                  </a:lnTo>
                  <a:lnTo>
                    <a:pt x="802256" y="763569"/>
                  </a:lnTo>
                  <a:lnTo>
                    <a:pt x="803787" y="768169"/>
                  </a:lnTo>
                  <a:lnTo>
                    <a:pt x="805251" y="772769"/>
                  </a:lnTo>
                  <a:lnTo>
                    <a:pt x="806697" y="777369"/>
                  </a:lnTo>
                  <a:lnTo>
                    <a:pt x="808086" y="781968"/>
                  </a:lnTo>
                  <a:lnTo>
                    <a:pt x="809446" y="786568"/>
                  </a:lnTo>
                  <a:lnTo>
                    <a:pt x="810769" y="791168"/>
                  </a:lnTo>
                  <a:lnTo>
                    <a:pt x="812048" y="795768"/>
                  </a:lnTo>
                  <a:lnTo>
                    <a:pt x="813308" y="800368"/>
                  </a:lnTo>
                  <a:lnTo>
                    <a:pt x="814513" y="804967"/>
                  </a:lnTo>
                  <a:lnTo>
                    <a:pt x="815703" y="809567"/>
                  </a:lnTo>
                  <a:lnTo>
                    <a:pt x="816848" y="814167"/>
                  </a:lnTo>
                  <a:lnTo>
                    <a:pt x="817972" y="818767"/>
                  </a:lnTo>
                  <a:lnTo>
                    <a:pt x="819066" y="823367"/>
                  </a:lnTo>
                  <a:lnTo>
                    <a:pt x="820130" y="827967"/>
                  </a:lnTo>
                  <a:lnTo>
                    <a:pt x="821178" y="832566"/>
                  </a:lnTo>
                  <a:lnTo>
                    <a:pt x="822189" y="837166"/>
                  </a:lnTo>
                  <a:lnTo>
                    <a:pt x="823190" y="841766"/>
                  </a:lnTo>
                  <a:lnTo>
                    <a:pt x="824161" y="846366"/>
                  </a:lnTo>
                  <a:lnTo>
                    <a:pt x="825120" y="850966"/>
                  </a:lnTo>
                  <a:lnTo>
                    <a:pt x="826060" y="855565"/>
                  </a:lnTo>
                  <a:lnTo>
                    <a:pt x="826983" y="860165"/>
                  </a:lnTo>
                  <a:lnTo>
                    <a:pt x="827898" y="864765"/>
                  </a:lnTo>
                  <a:lnTo>
                    <a:pt x="828794" y="869365"/>
                  </a:lnTo>
                  <a:lnTo>
                    <a:pt x="829686" y="873965"/>
                  </a:lnTo>
                  <a:lnTo>
                    <a:pt x="830566" y="878565"/>
                  </a:lnTo>
                  <a:lnTo>
                    <a:pt x="831442" y="883164"/>
                  </a:lnTo>
                  <a:lnTo>
                    <a:pt x="832312" y="887764"/>
                  </a:lnTo>
                  <a:lnTo>
                    <a:pt x="833179" y="892364"/>
                  </a:lnTo>
                  <a:lnTo>
                    <a:pt x="834045" y="896964"/>
                  </a:lnTo>
                  <a:lnTo>
                    <a:pt x="834912" y="901564"/>
                  </a:lnTo>
                  <a:lnTo>
                    <a:pt x="835779" y="906163"/>
                  </a:lnTo>
                  <a:lnTo>
                    <a:pt x="836652" y="910763"/>
                  </a:lnTo>
                  <a:lnTo>
                    <a:pt x="837528" y="915363"/>
                  </a:lnTo>
                  <a:lnTo>
                    <a:pt x="838411" y="919963"/>
                  </a:lnTo>
                  <a:lnTo>
                    <a:pt x="839304" y="924563"/>
                  </a:lnTo>
                  <a:lnTo>
                    <a:pt x="840203" y="929163"/>
                  </a:lnTo>
                  <a:lnTo>
                    <a:pt x="841118" y="933762"/>
                  </a:lnTo>
                  <a:lnTo>
                    <a:pt x="842040" y="938362"/>
                  </a:lnTo>
                  <a:lnTo>
                    <a:pt x="842980" y="942962"/>
                  </a:lnTo>
                  <a:lnTo>
                    <a:pt x="843932" y="947562"/>
                  </a:lnTo>
                  <a:lnTo>
                    <a:pt x="844900" y="952162"/>
                  </a:lnTo>
                  <a:lnTo>
                    <a:pt x="845888" y="956761"/>
                  </a:lnTo>
                  <a:lnTo>
                    <a:pt x="846886" y="961361"/>
                  </a:lnTo>
                  <a:lnTo>
                    <a:pt x="847914" y="965961"/>
                  </a:lnTo>
                  <a:lnTo>
                    <a:pt x="848950" y="970561"/>
                  </a:lnTo>
                  <a:lnTo>
                    <a:pt x="850017" y="975161"/>
                  </a:lnTo>
                  <a:lnTo>
                    <a:pt x="851098" y="979761"/>
                  </a:lnTo>
                  <a:lnTo>
                    <a:pt x="852202" y="984360"/>
                  </a:lnTo>
                  <a:lnTo>
                    <a:pt x="853331" y="988960"/>
                  </a:lnTo>
                  <a:lnTo>
                    <a:pt x="854474" y="993560"/>
                  </a:lnTo>
                  <a:lnTo>
                    <a:pt x="855653" y="998160"/>
                  </a:lnTo>
                  <a:lnTo>
                    <a:pt x="856842" y="1002760"/>
                  </a:lnTo>
                  <a:lnTo>
                    <a:pt x="858065" y="1007359"/>
                  </a:lnTo>
                  <a:lnTo>
                    <a:pt x="859304" y="1011959"/>
                  </a:lnTo>
                  <a:lnTo>
                    <a:pt x="860567" y="1016559"/>
                  </a:lnTo>
                  <a:lnTo>
                    <a:pt x="861857" y="1021159"/>
                  </a:lnTo>
                  <a:lnTo>
                    <a:pt x="863160" y="1025759"/>
                  </a:lnTo>
                  <a:lnTo>
                    <a:pt x="864498" y="1030359"/>
                  </a:lnTo>
                  <a:lnTo>
                    <a:pt x="865846" y="1034958"/>
                  </a:lnTo>
                  <a:lnTo>
                    <a:pt x="867225" y="1039558"/>
                  </a:lnTo>
                  <a:lnTo>
                    <a:pt x="868619" y="1044158"/>
                  </a:lnTo>
                  <a:lnTo>
                    <a:pt x="870033" y="1048758"/>
                  </a:lnTo>
                  <a:lnTo>
                    <a:pt x="871469" y="1053358"/>
                  </a:lnTo>
                  <a:lnTo>
                    <a:pt x="872916" y="1057957"/>
                  </a:lnTo>
                  <a:lnTo>
                    <a:pt x="874390" y="1062557"/>
                  </a:lnTo>
                  <a:lnTo>
                    <a:pt x="875871" y="1067157"/>
                  </a:lnTo>
                  <a:lnTo>
                    <a:pt x="877374" y="1071757"/>
                  </a:lnTo>
                  <a:lnTo>
                    <a:pt x="878885" y="1076357"/>
                  </a:lnTo>
                  <a:lnTo>
                    <a:pt x="880410" y="1080957"/>
                  </a:lnTo>
                  <a:lnTo>
                    <a:pt x="881946" y="1085556"/>
                  </a:lnTo>
                  <a:lnTo>
                    <a:pt x="883489" y="1090156"/>
                  </a:lnTo>
                  <a:lnTo>
                    <a:pt x="885042" y="1094756"/>
                  </a:lnTo>
                  <a:lnTo>
                    <a:pt x="886599" y="1099356"/>
                  </a:lnTo>
                  <a:lnTo>
                    <a:pt x="888161" y="1103956"/>
                  </a:lnTo>
                  <a:lnTo>
                    <a:pt x="889725" y="1108555"/>
                  </a:lnTo>
                  <a:lnTo>
                    <a:pt x="891289" y="1113155"/>
                  </a:lnTo>
                  <a:lnTo>
                    <a:pt x="892851" y="1117755"/>
                  </a:lnTo>
                  <a:lnTo>
                    <a:pt x="894411" y="1122355"/>
                  </a:lnTo>
                  <a:lnTo>
                    <a:pt x="895963" y="1126955"/>
                  </a:lnTo>
                  <a:lnTo>
                    <a:pt x="897511" y="1131554"/>
                  </a:lnTo>
                  <a:lnTo>
                    <a:pt x="899044" y="1136154"/>
                  </a:lnTo>
                  <a:lnTo>
                    <a:pt x="900568" y="1140754"/>
                  </a:lnTo>
                  <a:lnTo>
                    <a:pt x="902078" y="1145354"/>
                  </a:lnTo>
                  <a:lnTo>
                    <a:pt x="903568" y="1149954"/>
                  </a:lnTo>
                  <a:lnTo>
                    <a:pt x="905047" y="1154554"/>
                  </a:lnTo>
                  <a:lnTo>
                    <a:pt x="906494" y="1159153"/>
                  </a:lnTo>
                  <a:lnTo>
                    <a:pt x="907930" y="1163753"/>
                  </a:lnTo>
                  <a:lnTo>
                    <a:pt x="909326" y="1168353"/>
                  </a:lnTo>
                  <a:lnTo>
                    <a:pt x="910704" y="1172953"/>
                  </a:lnTo>
                  <a:lnTo>
                    <a:pt x="912049" y="1177553"/>
                  </a:lnTo>
                  <a:lnTo>
                    <a:pt x="913357" y="1182152"/>
                  </a:lnTo>
                  <a:lnTo>
                    <a:pt x="914643" y="1186752"/>
                  </a:lnTo>
                  <a:lnTo>
                    <a:pt x="915870" y="1191352"/>
                  </a:lnTo>
                  <a:lnTo>
                    <a:pt x="917081" y="1195952"/>
                  </a:lnTo>
                  <a:lnTo>
                    <a:pt x="918226" y="1200552"/>
                  </a:lnTo>
                  <a:lnTo>
                    <a:pt x="919342" y="1205152"/>
                  </a:lnTo>
                  <a:lnTo>
                    <a:pt x="920407" y="1209751"/>
                  </a:lnTo>
                  <a:lnTo>
                    <a:pt x="921417" y="1214351"/>
                  </a:lnTo>
                  <a:lnTo>
                    <a:pt x="922395" y="1218951"/>
                  </a:lnTo>
                  <a:lnTo>
                    <a:pt x="923290" y="1223551"/>
                  </a:lnTo>
                  <a:lnTo>
                    <a:pt x="924160" y="1228151"/>
                  </a:lnTo>
                  <a:lnTo>
                    <a:pt x="924942" y="1232750"/>
                  </a:lnTo>
                  <a:lnTo>
                    <a:pt x="925684" y="1237350"/>
                  </a:lnTo>
                  <a:lnTo>
                    <a:pt x="926358" y="1241950"/>
                  </a:lnTo>
                  <a:lnTo>
                    <a:pt x="926962" y="1246550"/>
                  </a:lnTo>
                  <a:lnTo>
                    <a:pt x="927523" y="1251150"/>
                  </a:lnTo>
                  <a:lnTo>
                    <a:pt x="927981" y="1255750"/>
                  </a:lnTo>
                  <a:lnTo>
                    <a:pt x="928408" y="1260349"/>
                  </a:lnTo>
                  <a:lnTo>
                    <a:pt x="928725" y="1264949"/>
                  </a:lnTo>
                  <a:lnTo>
                    <a:pt x="928995" y="1269549"/>
                  </a:lnTo>
                  <a:lnTo>
                    <a:pt x="929182" y="1274149"/>
                  </a:lnTo>
                  <a:lnTo>
                    <a:pt x="929287" y="1278749"/>
                  </a:lnTo>
                  <a:lnTo>
                    <a:pt x="929340" y="1283348"/>
                  </a:lnTo>
                  <a:lnTo>
                    <a:pt x="929274" y="1287948"/>
                  </a:lnTo>
                  <a:lnTo>
                    <a:pt x="929173" y="1292548"/>
                  </a:lnTo>
                  <a:lnTo>
                    <a:pt x="928945" y="1297148"/>
                  </a:lnTo>
                  <a:lnTo>
                    <a:pt x="928665" y="1301748"/>
                  </a:lnTo>
                  <a:lnTo>
                    <a:pt x="928292" y="1306348"/>
                  </a:lnTo>
                  <a:lnTo>
                    <a:pt x="927828" y="1310947"/>
                  </a:lnTo>
                  <a:lnTo>
                    <a:pt x="927307" y="1315547"/>
                  </a:lnTo>
                  <a:lnTo>
                    <a:pt x="926656" y="1320147"/>
                  </a:lnTo>
                  <a:lnTo>
                    <a:pt x="925968" y="1324747"/>
                  </a:lnTo>
                  <a:lnTo>
                    <a:pt x="925143" y="1329347"/>
                  </a:lnTo>
                  <a:lnTo>
                    <a:pt x="924264" y="1333946"/>
                  </a:lnTo>
                  <a:lnTo>
                    <a:pt x="923286" y="1338546"/>
                  </a:lnTo>
                  <a:lnTo>
                    <a:pt x="922214" y="1343146"/>
                  </a:lnTo>
                  <a:lnTo>
                    <a:pt x="921081" y="1347746"/>
                  </a:lnTo>
                  <a:lnTo>
                    <a:pt x="919816" y="1352346"/>
                  </a:lnTo>
                  <a:lnTo>
                    <a:pt x="918513" y="1356946"/>
                  </a:lnTo>
                  <a:lnTo>
                    <a:pt x="917070" y="1361545"/>
                  </a:lnTo>
                  <a:lnTo>
                    <a:pt x="915574" y="1366145"/>
                  </a:lnTo>
                  <a:lnTo>
                    <a:pt x="913978" y="1370745"/>
                  </a:lnTo>
                  <a:lnTo>
                    <a:pt x="912290" y="1375345"/>
                  </a:lnTo>
                  <a:lnTo>
                    <a:pt x="910541" y="1379945"/>
                  </a:lnTo>
                  <a:lnTo>
                    <a:pt x="908664" y="1384544"/>
                  </a:lnTo>
                  <a:lnTo>
                    <a:pt x="906751" y="1389144"/>
                  </a:lnTo>
                  <a:lnTo>
                    <a:pt x="904702" y="1393744"/>
                  </a:lnTo>
                  <a:lnTo>
                    <a:pt x="902603" y="1398344"/>
                  </a:lnTo>
                  <a:lnTo>
                    <a:pt x="900409" y="1402944"/>
                  </a:lnTo>
                  <a:lnTo>
                    <a:pt x="898130" y="1407544"/>
                  </a:lnTo>
                  <a:lnTo>
                    <a:pt x="895792" y="1412143"/>
                  </a:lnTo>
                  <a:lnTo>
                    <a:pt x="893338" y="1416743"/>
                  </a:lnTo>
                  <a:lnTo>
                    <a:pt x="890850" y="1421343"/>
                  </a:lnTo>
                  <a:lnTo>
                    <a:pt x="888238" y="1425943"/>
                  </a:lnTo>
                  <a:lnTo>
                    <a:pt x="885583" y="1430543"/>
                  </a:lnTo>
                  <a:lnTo>
                    <a:pt x="882840" y="1435142"/>
                  </a:lnTo>
                  <a:lnTo>
                    <a:pt x="880024" y="1439742"/>
                  </a:lnTo>
                  <a:lnTo>
                    <a:pt x="877156" y="1444342"/>
                  </a:lnTo>
                  <a:lnTo>
                    <a:pt x="874187" y="1448942"/>
                  </a:lnTo>
                  <a:lnTo>
                    <a:pt x="871188" y="1453542"/>
                  </a:lnTo>
                  <a:lnTo>
                    <a:pt x="868083" y="1458142"/>
                  </a:lnTo>
                  <a:lnTo>
                    <a:pt x="864942" y="1462741"/>
                  </a:lnTo>
                  <a:lnTo>
                    <a:pt x="861728" y="1467341"/>
                  </a:lnTo>
                  <a:lnTo>
                    <a:pt x="858453" y="1471941"/>
                  </a:lnTo>
                  <a:lnTo>
                    <a:pt x="855135" y="1476541"/>
                  </a:lnTo>
                  <a:lnTo>
                    <a:pt x="851736" y="1481141"/>
                  </a:lnTo>
                  <a:lnTo>
                    <a:pt x="848314" y="1485740"/>
                  </a:lnTo>
                  <a:lnTo>
                    <a:pt x="844807" y="1490340"/>
                  </a:lnTo>
                  <a:lnTo>
                    <a:pt x="841273" y="1494940"/>
                  </a:lnTo>
                  <a:lnTo>
                    <a:pt x="837682" y="1499540"/>
                  </a:lnTo>
                  <a:lnTo>
                    <a:pt x="834046" y="1504140"/>
                  </a:lnTo>
                  <a:lnTo>
                    <a:pt x="830377" y="1508739"/>
                  </a:lnTo>
                  <a:lnTo>
                    <a:pt x="826650" y="1513339"/>
                  </a:lnTo>
                  <a:lnTo>
                    <a:pt x="822906" y="1517939"/>
                  </a:lnTo>
                  <a:lnTo>
                    <a:pt x="819102" y="1522539"/>
                  </a:lnTo>
                  <a:lnTo>
                    <a:pt x="815280" y="1527139"/>
                  </a:lnTo>
                  <a:lnTo>
                    <a:pt x="811419" y="1531739"/>
                  </a:lnTo>
                  <a:lnTo>
                    <a:pt x="807530" y="1536338"/>
                  </a:lnTo>
                  <a:lnTo>
                    <a:pt x="803620" y="1540938"/>
                  </a:lnTo>
                  <a:lnTo>
                    <a:pt x="799674" y="1545538"/>
                  </a:lnTo>
                  <a:lnTo>
                    <a:pt x="795718" y="1550138"/>
                  </a:lnTo>
                  <a:lnTo>
                    <a:pt x="791728" y="1554738"/>
                  </a:lnTo>
                  <a:lnTo>
                    <a:pt x="787730" y="1559337"/>
                  </a:lnTo>
                  <a:lnTo>
                    <a:pt x="783711" y="1563937"/>
                  </a:lnTo>
                  <a:lnTo>
                    <a:pt x="779681" y="1568537"/>
                  </a:lnTo>
                  <a:lnTo>
                    <a:pt x="775640" y="1573137"/>
                  </a:lnTo>
                  <a:lnTo>
                    <a:pt x="771587" y="1577737"/>
                  </a:lnTo>
                  <a:lnTo>
                    <a:pt x="767531" y="1582337"/>
                  </a:lnTo>
                  <a:lnTo>
                    <a:pt x="763466" y="1586936"/>
                  </a:lnTo>
                  <a:lnTo>
                    <a:pt x="759401" y="1591536"/>
                  </a:lnTo>
                  <a:lnTo>
                    <a:pt x="755335" y="1596136"/>
                  </a:lnTo>
                  <a:lnTo>
                    <a:pt x="751271" y="1600736"/>
                  </a:lnTo>
                  <a:lnTo>
                    <a:pt x="747208" y="1605336"/>
                  </a:lnTo>
                  <a:lnTo>
                    <a:pt x="743155" y="1609935"/>
                  </a:lnTo>
                  <a:lnTo>
                    <a:pt x="739104" y="1614535"/>
                  </a:lnTo>
                  <a:lnTo>
                    <a:pt x="735069" y="1619135"/>
                  </a:lnTo>
                  <a:lnTo>
                    <a:pt x="731040" y="1623735"/>
                  </a:lnTo>
                  <a:lnTo>
                    <a:pt x="727027" y="1628335"/>
                  </a:lnTo>
                  <a:lnTo>
                    <a:pt x="723030" y="1632935"/>
                  </a:lnTo>
                  <a:lnTo>
                    <a:pt x="719045" y="1637534"/>
                  </a:lnTo>
                  <a:lnTo>
                    <a:pt x="715087" y="1642134"/>
                  </a:lnTo>
                  <a:lnTo>
                    <a:pt x="711138" y="1646734"/>
                  </a:lnTo>
                  <a:lnTo>
                    <a:pt x="707225" y="1651334"/>
                  </a:lnTo>
                  <a:lnTo>
                    <a:pt x="703325" y="1655934"/>
                  </a:lnTo>
                  <a:lnTo>
                    <a:pt x="699456" y="1660533"/>
                  </a:lnTo>
                  <a:lnTo>
                    <a:pt x="695613" y="1665133"/>
                  </a:lnTo>
                  <a:lnTo>
                    <a:pt x="691792" y="1669733"/>
                  </a:lnTo>
                  <a:lnTo>
                    <a:pt x="688014" y="1674333"/>
                  </a:lnTo>
                  <a:lnTo>
                    <a:pt x="684248" y="1678933"/>
                  </a:lnTo>
                  <a:lnTo>
                    <a:pt x="680537" y="1683533"/>
                  </a:lnTo>
                  <a:lnTo>
                    <a:pt x="676844" y="1688132"/>
                  </a:lnTo>
                  <a:lnTo>
                    <a:pt x="673194" y="1692732"/>
                  </a:lnTo>
                  <a:lnTo>
                    <a:pt x="669580" y="1697332"/>
                  </a:lnTo>
                  <a:lnTo>
                    <a:pt x="665994" y="1701932"/>
                  </a:lnTo>
                  <a:lnTo>
                    <a:pt x="662463" y="1706532"/>
                  </a:lnTo>
                  <a:lnTo>
                    <a:pt x="658949" y="1711131"/>
                  </a:lnTo>
                  <a:lnTo>
                    <a:pt x="655504" y="1715731"/>
                  </a:lnTo>
                  <a:lnTo>
                    <a:pt x="652081" y="1720331"/>
                  </a:lnTo>
                  <a:lnTo>
                    <a:pt x="648710" y="1724931"/>
                  </a:lnTo>
                  <a:lnTo>
                    <a:pt x="645381" y="1729531"/>
                  </a:lnTo>
                  <a:lnTo>
                    <a:pt x="642088" y="1734131"/>
                  </a:lnTo>
                  <a:lnTo>
                    <a:pt x="638857" y="1738730"/>
                  </a:lnTo>
                  <a:lnTo>
                    <a:pt x="635647" y="1743330"/>
                  </a:lnTo>
                  <a:lnTo>
                    <a:pt x="632516" y="1747930"/>
                  </a:lnTo>
                  <a:lnTo>
                    <a:pt x="629409" y="1752530"/>
                  </a:lnTo>
                  <a:lnTo>
                    <a:pt x="626362" y="1757130"/>
                  </a:lnTo>
                  <a:lnTo>
                    <a:pt x="623362" y="1761729"/>
                  </a:lnTo>
                  <a:lnTo>
                    <a:pt x="620401" y="1766329"/>
                  </a:lnTo>
                  <a:lnTo>
                    <a:pt x="617510" y="1770929"/>
                  </a:lnTo>
                  <a:lnTo>
                    <a:pt x="614640" y="1775529"/>
                  </a:lnTo>
                  <a:lnTo>
                    <a:pt x="611857" y="1780129"/>
                  </a:lnTo>
                  <a:lnTo>
                    <a:pt x="609099" y="1784729"/>
                  </a:lnTo>
                  <a:lnTo>
                    <a:pt x="606406" y="1789328"/>
                  </a:lnTo>
                  <a:lnTo>
                    <a:pt x="603762" y="1793928"/>
                  </a:lnTo>
                  <a:lnTo>
                    <a:pt x="601160" y="1798528"/>
                  </a:lnTo>
                  <a:lnTo>
                    <a:pt x="598631" y="1803128"/>
                  </a:lnTo>
                  <a:lnTo>
                    <a:pt x="596124" y="1807728"/>
                  </a:lnTo>
                  <a:lnTo>
                    <a:pt x="593708" y="1812327"/>
                  </a:lnTo>
                  <a:lnTo>
                    <a:pt x="591318" y="1816927"/>
                  </a:lnTo>
                  <a:lnTo>
                    <a:pt x="588995" y="1821527"/>
                  </a:lnTo>
                  <a:lnTo>
                    <a:pt x="586721" y="1826127"/>
                  </a:lnTo>
                  <a:lnTo>
                    <a:pt x="584492" y="1830727"/>
                  </a:lnTo>
                  <a:lnTo>
                    <a:pt x="582335" y="1835327"/>
                  </a:lnTo>
                  <a:lnTo>
                    <a:pt x="580201" y="1839926"/>
                  </a:lnTo>
                  <a:lnTo>
                    <a:pt x="578159" y="1844526"/>
                  </a:lnTo>
                  <a:lnTo>
                    <a:pt x="576142" y="1849126"/>
                  </a:lnTo>
                  <a:lnTo>
                    <a:pt x="574193" y="1853726"/>
                  </a:lnTo>
                  <a:lnTo>
                    <a:pt x="572291" y="1858326"/>
                  </a:lnTo>
                  <a:lnTo>
                    <a:pt x="570435" y="1862925"/>
                  </a:lnTo>
                  <a:lnTo>
                    <a:pt x="568648" y="1867525"/>
                  </a:lnTo>
                  <a:lnTo>
                    <a:pt x="566885" y="1872125"/>
                  </a:lnTo>
                  <a:lnTo>
                    <a:pt x="565211" y="1876725"/>
                  </a:lnTo>
                  <a:lnTo>
                    <a:pt x="563561" y="1881325"/>
                  </a:lnTo>
                  <a:lnTo>
                    <a:pt x="561977" y="1885924"/>
                  </a:lnTo>
                  <a:lnTo>
                    <a:pt x="560439" y="1890524"/>
                  </a:lnTo>
                  <a:lnTo>
                    <a:pt x="558943" y="1895124"/>
                  </a:lnTo>
                  <a:lnTo>
                    <a:pt x="557515" y="1899724"/>
                  </a:lnTo>
                  <a:lnTo>
                    <a:pt x="556108" y="1904324"/>
                  </a:lnTo>
                  <a:lnTo>
                    <a:pt x="554786" y="1908924"/>
                  </a:lnTo>
                  <a:lnTo>
                    <a:pt x="553486" y="1913523"/>
                  </a:lnTo>
                  <a:lnTo>
                    <a:pt x="552248" y="1918123"/>
                  </a:lnTo>
                  <a:lnTo>
                    <a:pt x="551053" y="1922723"/>
                  </a:lnTo>
                  <a:lnTo>
                    <a:pt x="549897" y="1927323"/>
                  </a:lnTo>
                  <a:lnTo>
                    <a:pt x="548803" y="1931923"/>
                  </a:lnTo>
                  <a:lnTo>
                    <a:pt x="547729" y="1936522"/>
                  </a:lnTo>
                  <a:lnTo>
                    <a:pt x="546733" y="1941122"/>
                  </a:lnTo>
                  <a:lnTo>
                    <a:pt x="545756" y="1945722"/>
                  </a:lnTo>
                  <a:lnTo>
                    <a:pt x="544836" y="1950322"/>
                  </a:lnTo>
                  <a:lnTo>
                    <a:pt x="543953" y="1954922"/>
                  </a:lnTo>
                  <a:lnTo>
                    <a:pt x="543106" y="1959522"/>
                  </a:lnTo>
                  <a:lnTo>
                    <a:pt x="542314" y="1964121"/>
                  </a:lnTo>
                  <a:lnTo>
                    <a:pt x="541539" y="1968721"/>
                  </a:lnTo>
                  <a:lnTo>
                    <a:pt x="540833" y="1973321"/>
                  </a:lnTo>
                  <a:lnTo>
                    <a:pt x="540144" y="1977921"/>
                  </a:lnTo>
                  <a:lnTo>
                    <a:pt x="539504" y="1982521"/>
                  </a:lnTo>
                  <a:lnTo>
                    <a:pt x="538895" y="1987120"/>
                  </a:lnTo>
                  <a:lnTo>
                    <a:pt x="538319" y="1991720"/>
                  </a:lnTo>
                  <a:lnTo>
                    <a:pt x="537787" y="1996320"/>
                  </a:lnTo>
                  <a:lnTo>
                    <a:pt x="537271" y="2000920"/>
                  </a:lnTo>
                  <a:lnTo>
                    <a:pt x="536812" y="2005520"/>
                  </a:lnTo>
                  <a:lnTo>
                    <a:pt x="536367" y="2010120"/>
                  </a:lnTo>
                  <a:lnTo>
                    <a:pt x="535963" y="2014719"/>
                  </a:lnTo>
                  <a:lnTo>
                    <a:pt x="535584" y="2019319"/>
                  </a:lnTo>
                  <a:lnTo>
                    <a:pt x="535231" y="2023919"/>
                  </a:lnTo>
                  <a:lnTo>
                    <a:pt x="534914" y="2028519"/>
                  </a:lnTo>
                  <a:lnTo>
                    <a:pt x="534609" y="2033119"/>
                  </a:lnTo>
                  <a:lnTo>
                    <a:pt x="534349" y="2037718"/>
                  </a:lnTo>
                  <a:lnTo>
                    <a:pt x="534099" y="2042318"/>
                  </a:lnTo>
                  <a:lnTo>
                    <a:pt x="533881" y="2046918"/>
                  </a:lnTo>
                  <a:lnTo>
                    <a:pt x="533681" y="2051518"/>
                  </a:lnTo>
                  <a:lnTo>
                    <a:pt x="533501" y="2056118"/>
                  </a:lnTo>
                  <a:lnTo>
                    <a:pt x="533347" y="2060718"/>
                  </a:lnTo>
                  <a:lnTo>
                    <a:pt x="533203" y="2065317"/>
                  </a:lnTo>
                  <a:lnTo>
                    <a:pt x="533089" y="2069917"/>
                  </a:lnTo>
                  <a:lnTo>
                    <a:pt x="532983" y="2074517"/>
                  </a:lnTo>
                  <a:lnTo>
                    <a:pt x="532898" y="2079117"/>
                  </a:lnTo>
                  <a:lnTo>
                    <a:pt x="532825" y="2083717"/>
                  </a:lnTo>
                  <a:lnTo>
                    <a:pt x="532766" y="2088316"/>
                  </a:lnTo>
                  <a:lnTo>
                    <a:pt x="532722" y="2092916"/>
                  </a:lnTo>
                  <a:lnTo>
                    <a:pt x="532684" y="2097516"/>
                  </a:lnTo>
                  <a:lnTo>
                    <a:pt x="532665" y="2102116"/>
                  </a:lnTo>
                  <a:lnTo>
                    <a:pt x="532649" y="2106716"/>
                  </a:lnTo>
                  <a:lnTo>
                    <a:pt x="532645" y="2111316"/>
                  </a:lnTo>
                  <a:lnTo>
                    <a:pt x="532647" y="2115915"/>
                  </a:lnTo>
                  <a:lnTo>
                    <a:pt x="532655" y="2120515"/>
                  </a:lnTo>
                  <a:lnTo>
                    <a:pt x="532670" y="2125115"/>
                  </a:lnTo>
                  <a:lnTo>
                    <a:pt x="532687" y="2129715"/>
                  </a:lnTo>
                  <a:lnTo>
                    <a:pt x="532710" y="2134315"/>
                  </a:lnTo>
                  <a:lnTo>
                    <a:pt x="532734" y="2138914"/>
                  </a:lnTo>
                  <a:lnTo>
                    <a:pt x="532760" y="2143514"/>
                  </a:lnTo>
                  <a:lnTo>
                    <a:pt x="532787" y="2148114"/>
                  </a:lnTo>
                  <a:lnTo>
                    <a:pt x="532813" y="2152714"/>
                  </a:lnTo>
                  <a:lnTo>
                    <a:pt x="532838" y="2157314"/>
                  </a:lnTo>
                  <a:lnTo>
                    <a:pt x="532862" y="2161914"/>
                  </a:lnTo>
                  <a:lnTo>
                    <a:pt x="532881" y="2166513"/>
                  </a:lnTo>
                  <a:lnTo>
                    <a:pt x="532898" y="2171113"/>
                  </a:lnTo>
                  <a:lnTo>
                    <a:pt x="532910" y="2175713"/>
                  </a:lnTo>
                  <a:lnTo>
                    <a:pt x="532916" y="2180313"/>
                  </a:lnTo>
                  <a:lnTo>
                    <a:pt x="532917" y="2184913"/>
                  </a:lnTo>
                  <a:lnTo>
                    <a:pt x="532910" y="2189512"/>
                  </a:lnTo>
                  <a:lnTo>
                    <a:pt x="532899" y="2194112"/>
                  </a:lnTo>
                  <a:lnTo>
                    <a:pt x="532874" y="2198712"/>
                  </a:lnTo>
                  <a:lnTo>
                    <a:pt x="532844" y="2203312"/>
                  </a:lnTo>
                  <a:lnTo>
                    <a:pt x="532802" y="2207912"/>
                  </a:lnTo>
                  <a:lnTo>
                    <a:pt x="532752" y="2212512"/>
                  </a:lnTo>
                  <a:lnTo>
                    <a:pt x="532692" y="2217111"/>
                  </a:lnTo>
                  <a:lnTo>
                    <a:pt x="532617" y="2221711"/>
                  </a:lnTo>
                  <a:lnTo>
                    <a:pt x="532537" y="2226311"/>
                  </a:lnTo>
                  <a:lnTo>
                    <a:pt x="532436" y="2230911"/>
                  </a:lnTo>
                  <a:lnTo>
                    <a:pt x="532330" y="2235511"/>
                  </a:lnTo>
                  <a:lnTo>
                    <a:pt x="532205" y="2240110"/>
                  </a:lnTo>
                  <a:lnTo>
                    <a:pt x="532070" y="2244710"/>
                  </a:lnTo>
                  <a:lnTo>
                    <a:pt x="531921" y="2249310"/>
                  </a:lnTo>
                  <a:lnTo>
                    <a:pt x="531755" y="2253910"/>
                  </a:lnTo>
                  <a:lnTo>
                    <a:pt x="531582" y="2258510"/>
                  </a:lnTo>
                  <a:lnTo>
                    <a:pt x="531383" y="2263109"/>
                  </a:lnTo>
                  <a:lnTo>
                    <a:pt x="531178" y="2267709"/>
                  </a:lnTo>
                  <a:lnTo>
                    <a:pt x="530952" y="2272309"/>
                  </a:lnTo>
                  <a:lnTo>
                    <a:pt x="530714" y="2276909"/>
                  </a:lnTo>
                  <a:lnTo>
                    <a:pt x="530460" y="2281509"/>
                  </a:lnTo>
                  <a:lnTo>
                    <a:pt x="530188" y="2286109"/>
                  </a:lnTo>
                  <a:lnTo>
                    <a:pt x="529907" y="2290708"/>
                  </a:lnTo>
                  <a:lnTo>
                    <a:pt x="529599" y="2295308"/>
                  </a:lnTo>
                  <a:lnTo>
                    <a:pt x="529285" y="2299908"/>
                  </a:lnTo>
                  <a:lnTo>
                    <a:pt x="528948" y="2304508"/>
                  </a:lnTo>
                  <a:lnTo>
                    <a:pt x="528599" y="2309108"/>
                  </a:lnTo>
                  <a:lnTo>
                    <a:pt x="528234" y="2313707"/>
                  </a:lnTo>
                  <a:lnTo>
                    <a:pt x="527850" y="2318307"/>
                  </a:lnTo>
                  <a:lnTo>
                    <a:pt x="527458" y="2322907"/>
                  </a:lnTo>
                  <a:lnTo>
                    <a:pt x="527039" y="2327507"/>
                  </a:lnTo>
                  <a:lnTo>
                    <a:pt x="526614" y="2332107"/>
                  </a:lnTo>
                  <a:lnTo>
                    <a:pt x="526168" y="2336707"/>
                  </a:lnTo>
                  <a:lnTo>
                    <a:pt x="525710" y="2341306"/>
                  </a:lnTo>
                  <a:lnTo>
                    <a:pt x="525237" y="2345906"/>
                  </a:lnTo>
                  <a:lnTo>
                    <a:pt x="524746" y="2350506"/>
                  </a:lnTo>
                  <a:close/>
                </a:path>
              </a:pathLst>
            </a:custGeom>
            <a:solidFill>
              <a:srgbClr val="FDE725">
                <a:alpha val="29803"/>
              </a:srgbClr>
            </a:solidFill>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05" name="pt8">
              <a:extLst>
                <a:ext uri="{FF2B5EF4-FFF2-40B4-BE49-F238E27FC236}">
                  <a16:creationId xmlns:a16="http://schemas.microsoft.com/office/drawing/2014/main" id="{215A5B94-B8EF-5D73-AF9E-51C16D819BAF}"/>
                </a:ext>
              </a:extLst>
            </p:cNvPr>
            <p:cNvSpPr/>
            <p:nvPr/>
          </p:nvSpPr>
          <p:spPr>
            <a:xfrm>
              <a:off x="940120" y="234579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506" name="pt9">
              <a:extLst>
                <a:ext uri="{FF2B5EF4-FFF2-40B4-BE49-F238E27FC236}">
                  <a16:creationId xmlns:a16="http://schemas.microsoft.com/office/drawing/2014/main" id="{96FD34E6-030A-19F4-638B-6287846C8B0C}"/>
                </a:ext>
              </a:extLst>
            </p:cNvPr>
            <p:cNvSpPr/>
            <p:nvPr/>
          </p:nvSpPr>
          <p:spPr>
            <a:xfrm>
              <a:off x="940120" y="2214699"/>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507" name="pl10">
              <a:extLst>
                <a:ext uri="{FF2B5EF4-FFF2-40B4-BE49-F238E27FC236}">
                  <a16:creationId xmlns:a16="http://schemas.microsoft.com/office/drawing/2014/main" id="{7BE2A611-27F4-08FF-6D2B-FE01362C1669}"/>
                </a:ext>
              </a:extLst>
            </p:cNvPr>
            <p:cNvSpPr/>
            <p:nvPr/>
          </p:nvSpPr>
          <p:spPr>
            <a:xfrm>
              <a:off x="948428" y="1354484"/>
              <a:ext cx="0" cy="278583"/>
            </a:xfrm>
            <a:custGeom>
              <a:avLst/>
              <a:gdLst/>
              <a:ahLst/>
              <a:cxnLst/>
              <a:rect l="0" t="0" r="0" b="0"/>
              <a:pathLst>
                <a:path h="832471">
                  <a:moveTo>
                    <a:pt x="0" y="832471"/>
                  </a:moveTo>
                  <a:lnTo>
                    <a:pt x="0" y="0"/>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08" name="pl11">
              <a:extLst>
                <a:ext uri="{FF2B5EF4-FFF2-40B4-BE49-F238E27FC236}">
                  <a16:creationId xmlns:a16="http://schemas.microsoft.com/office/drawing/2014/main" id="{9EFDB136-E931-204F-AAF9-CDC0A3F4AC9E}"/>
                </a:ext>
              </a:extLst>
            </p:cNvPr>
            <p:cNvSpPr/>
            <p:nvPr/>
          </p:nvSpPr>
          <p:spPr>
            <a:xfrm>
              <a:off x="948428" y="1854294"/>
              <a:ext cx="0" cy="237614"/>
            </a:xfrm>
            <a:custGeom>
              <a:avLst/>
              <a:gdLst/>
              <a:ahLst/>
              <a:cxnLst/>
              <a:rect l="0" t="0" r="0" b="0"/>
              <a:pathLst>
                <a:path h="710048">
                  <a:moveTo>
                    <a:pt x="0" y="0"/>
                  </a:moveTo>
                  <a:lnTo>
                    <a:pt x="0" y="710048"/>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09" name="pg12">
              <a:extLst>
                <a:ext uri="{FF2B5EF4-FFF2-40B4-BE49-F238E27FC236}">
                  <a16:creationId xmlns:a16="http://schemas.microsoft.com/office/drawing/2014/main" id="{8D4AC2A2-9A5B-CBD6-A8A6-DE7DB6ACC37B}"/>
                </a:ext>
              </a:extLst>
            </p:cNvPr>
            <p:cNvSpPr/>
            <p:nvPr/>
          </p:nvSpPr>
          <p:spPr>
            <a:xfrm>
              <a:off x="881671" y="1633067"/>
              <a:ext cx="133514" cy="221227"/>
            </a:xfrm>
            <a:custGeom>
              <a:avLst/>
              <a:gdLst/>
              <a:ahLst/>
              <a:cxnLst/>
              <a:rect l="0" t="0" r="0" b="0"/>
              <a:pathLst>
                <a:path w="398970" h="661079">
                  <a:moveTo>
                    <a:pt x="0" y="0"/>
                  </a:moveTo>
                  <a:lnTo>
                    <a:pt x="0" y="661079"/>
                  </a:lnTo>
                  <a:lnTo>
                    <a:pt x="398970" y="661079"/>
                  </a:lnTo>
                  <a:lnTo>
                    <a:pt x="398970" y="0"/>
                  </a:lnTo>
                  <a:close/>
                </a:path>
              </a:pathLst>
            </a:custGeom>
            <a:solidFill>
              <a:srgbClr val="FFFFFF">
                <a:alpha val="100000"/>
              </a:srgbClr>
            </a:solidFill>
            <a:ln w="13550"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510" name="pl13">
              <a:extLst>
                <a:ext uri="{FF2B5EF4-FFF2-40B4-BE49-F238E27FC236}">
                  <a16:creationId xmlns:a16="http://schemas.microsoft.com/office/drawing/2014/main" id="{1B826E47-D4EC-8303-31C3-E9209B37EE75}"/>
                </a:ext>
              </a:extLst>
            </p:cNvPr>
            <p:cNvSpPr/>
            <p:nvPr/>
          </p:nvSpPr>
          <p:spPr>
            <a:xfrm>
              <a:off x="881671" y="1764164"/>
              <a:ext cx="133514" cy="0"/>
            </a:xfrm>
            <a:custGeom>
              <a:avLst/>
              <a:gdLst/>
              <a:ahLst/>
              <a:cxnLst/>
              <a:rect l="0" t="0" r="0" b="0"/>
              <a:pathLst>
                <a:path w="398970">
                  <a:moveTo>
                    <a:pt x="0" y="0"/>
                  </a:moveTo>
                  <a:lnTo>
                    <a:pt x="398970" y="0"/>
                  </a:lnTo>
                </a:path>
              </a:pathLst>
            </a:custGeom>
            <a:ln w="27101"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511" name="pl14">
              <a:extLst>
                <a:ext uri="{FF2B5EF4-FFF2-40B4-BE49-F238E27FC236}">
                  <a16:creationId xmlns:a16="http://schemas.microsoft.com/office/drawing/2014/main" id="{F5447E04-CD9E-AECE-42EF-8B18B48B8CE1}"/>
                </a:ext>
              </a:extLst>
            </p:cNvPr>
            <p:cNvSpPr/>
            <p:nvPr/>
          </p:nvSpPr>
          <p:spPr>
            <a:xfrm>
              <a:off x="1482482" y="1370871"/>
              <a:ext cx="0" cy="254002"/>
            </a:xfrm>
            <a:custGeom>
              <a:avLst/>
              <a:gdLst/>
              <a:ahLst/>
              <a:cxnLst/>
              <a:rect l="0" t="0" r="0" b="0"/>
              <a:pathLst>
                <a:path h="759017">
                  <a:moveTo>
                    <a:pt x="0" y="759017"/>
                  </a:moveTo>
                  <a:lnTo>
                    <a:pt x="0" y="0"/>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12" name="pl15">
              <a:extLst>
                <a:ext uri="{FF2B5EF4-FFF2-40B4-BE49-F238E27FC236}">
                  <a16:creationId xmlns:a16="http://schemas.microsoft.com/office/drawing/2014/main" id="{B3C1A9F6-B2EE-30E4-FFA0-EA82C7F94ECE}"/>
                </a:ext>
              </a:extLst>
            </p:cNvPr>
            <p:cNvSpPr/>
            <p:nvPr/>
          </p:nvSpPr>
          <p:spPr>
            <a:xfrm>
              <a:off x="1482482" y="1842004"/>
              <a:ext cx="0" cy="315454"/>
            </a:xfrm>
            <a:custGeom>
              <a:avLst/>
              <a:gdLst/>
              <a:ahLst/>
              <a:cxnLst/>
              <a:rect l="0" t="0" r="0" b="0"/>
              <a:pathLst>
                <a:path h="942651">
                  <a:moveTo>
                    <a:pt x="0" y="0"/>
                  </a:moveTo>
                  <a:lnTo>
                    <a:pt x="0" y="942651"/>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13" name="pg16">
              <a:extLst>
                <a:ext uri="{FF2B5EF4-FFF2-40B4-BE49-F238E27FC236}">
                  <a16:creationId xmlns:a16="http://schemas.microsoft.com/office/drawing/2014/main" id="{AD020BB7-6EB5-DE73-89BF-66B4F89DD869}"/>
                </a:ext>
              </a:extLst>
            </p:cNvPr>
            <p:cNvSpPr/>
            <p:nvPr/>
          </p:nvSpPr>
          <p:spPr>
            <a:xfrm>
              <a:off x="1415726" y="1624873"/>
              <a:ext cx="133514" cy="217130"/>
            </a:xfrm>
            <a:custGeom>
              <a:avLst/>
              <a:gdLst/>
              <a:ahLst/>
              <a:cxnLst/>
              <a:rect l="0" t="0" r="0" b="0"/>
              <a:pathLst>
                <a:path w="398970" h="648837">
                  <a:moveTo>
                    <a:pt x="0" y="0"/>
                  </a:moveTo>
                  <a:lnTo>
                    <a:pt x="0" y="648837"/>
                  </a:lnTo>
                  <a:lnTo>
                    <a:pt x="398970" y="648837"/>
                  </a:lnTo>
                  <a:lnTo>
                    <a:pt x="398970" y="0"/>
                  </a:lnTo>
                  <a:close/>
                </a:path>
              </a:pathLst>
            </a:custGeom>
            <a:solidFill>
              <a:srgbClr val="FFFFFF">
                <a:alpha val="100000"/>
              </a:srgbClr>
            </a:solidFill>
            <a:ln w="13550"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514" name="pl17">
              <a:extLst>
                <a:ext uri="{FF2B5EF4-FFF2-40B4-BE49-F238E27FC236}">
                  <a16:creationId xmlns:a16="http://schemas.microsoft.com/office/drawing/2014/main" id="{4A0476AD-F17F-72B3-F622-5AE9E07744E9}"/>
                </a:ext>
              </a:extLst>
            </p:cNvPr>
            <p:cNvSpPr/>
            <p:nvPr/>
          </p:nvSpPr>
          <p:spPr>
            <a:xfrm>
              <a:off x="1415726" y="1755971"/>
              <a:ext cx="133514" cy="0"/>
            </a:xfrm>
            <a:custGeom>
              <a:avLst/>
              <a:gdLst/>
              <a:ahLst/>
              <a:cxnLst/>
              <a:rect l="0" t="0" r="0" b="0"/>
              <a:pathLst>
                <a:path w="398970">
                  <a:moveTo>
                    <a:pt x="0" y="0"/>
                  </a:moveTo>
                  <a:lnTo>
                    <a:pt x="398970" y="0"/>
                  </a:lnTo>
                </a:path>
              </a:pathLst>
            </a:custGeom>
            <a:ln w="27101"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515" name="pt18">
              <a:extLst>
                <a:ext uri="{FF2B5EF4-FFF2-40B4-BE49-F238E27FC236}">
                  <a16:creationId xmlns:a16="http://schemas.microsoft.com/office/drawing/2014/main" id="{4BEBAFD6-9261-83C5-2B40-F0B387D2CDD2}"/>
                </a:ext>
              </a:extLst>
            </p:cNvPr>
            <p:cNvSpPr/>
            <p:nvPr/>
          </p:nvSpPr>
          <p:spPr>
            <a:xfrm>
              <a:off x="948418" y="180620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16" name="pt19">
              <a:extLst>
                <a:ext uri="{FF2B5EF4-FFF2-40B4-BE49-F238E27FC236}">
                  <a16:creationId xmlns:a16="http://schemas.microsoft.com/office/drawing/2014/main" id="{232C72BD-224F-BE05-62E4-F5B25AC30630}"/>
                </a:ext>
              </a:extLst>
            </p:cNvPr>
            <p:cNvSpPr/>
            <p:nvPr/>
          </p:nvSpPr>
          <p:spPr>
            <a:xfrm>
              <a:off x="1527021" y="176147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17" name="pt20">
              <a:extLst>
                <a:ext uri="{FF2B5EF4-FFF2-40B4-BE49-F238E27FC236}">
                  <a16:creationId xmlns:a16="http://schemas.microsoft.com/office/drawing/2014/main" id="{0F20FC89-3A59-1582-B61E-9C986FA7C138}"/>
                </a:ext>
              </a:extLst>
            </p:cNvPr>
            <p:cNvSpPr/>
            <p:nvPr/>
          </p:nvSpPr>
          <p:spPr>
            <a:xfrm>
              <a:off x="901159" y="174327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18" name="pt21">
              <a:extLst>
                <a:ext uri="{FF2B5EF4-FFF2-40B4-BE49-F238E27FC236}">
                  <a16:creationId xmlns:a16="http://schemas.microsoft.com/office/drawing/2014/main" id="{D23DB107-A813-5ABC-96CB-0EA820512ED4}"/>
                </a:ext>
              </a:extLst>
            </p:cNvPr>
            <p:cNvSpPr/>
            <p:nvPr/>
          </p:nvSpPr>
          <p:spPr>
            <a:xfrm>
              <a:off x="945128" y="188434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19" name="pt22">
              <a:extLst>
                <a:ext uri="{FF2B5EF4-FFF2-40B4-BE49-F238E27FC236}">
                  <a16:creationId xmlns:a16="http://schemas.microsoft.com/office/drawing/2014/main" id="{EEE40A92-D7C7-FD57-7B70-FF7F6E44E85C}"/>
                </a:ext>
              </a:extLst>
            </p:cNvPr>
            <p:cNvSpPr/>
            <p:nvPr/>
          </p:nvSpPr>
          <p:spPr>
            <a:xfrm>
              <a:off x="971628" y="177863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0" name="pt23">
              <a:extLst>
                <a:ext uri="{FF2B5EF4-FFF2-40B4-BE49-F238E27FC236}">
                  <a16:creationId xmlns:a16="http://schemas.microsoft.com/office/drawing/2014/main" id="{2AA0C7ED-ED9B-153B-309C-45D8649C88EE}"/>
                </a:ext>
              </a:extLst>
            </p:cNvPr>
            <p:cNvSpPr/>
            <p:nvPr/>
          </p:nvSpPr>
          <p:spPr>
            <a:xfrm>
              <a:off x="910828" y="175605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1" name="pt24">
              <a:extLst>
                <a:ext uri="{FF2B5EF4-FFF2-40B4-BE49-F238E27FC236}">
                  <a16:creationId xmlns:a16="http://schemas.microsoft.com/office/drawing/2014/main" id="{8F0916FE-89EC-D0DB-FDCA-5C7D5AFF71AC}"/>
                </a:ext>
              </a:extLst>
            </p:cNvPr>
            <p:cNvSpPr/>
            <p:nvPr/>
          </p:nvSpPr>
          <p:spPr>
            <a:xfrm>
              <a:off x="915846" y="167573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2" name="pt25">
              <a:extLst>
                <a:ext uri="{FF2B5EF4-FFF2-40B4-BE49-F238E27FC236}">
                  <a16:creationId xmlns:a16="http://schemas.microsoft.com/office/drawing/2014/main" id="{D2BF8CEB-090E-D545-1B41-5E77541089FF}"/>
                </a:ext>
              </a:extLst>
            </p:cNvPr>
            <p:cNvSpPr/>
            <p:nvPr/>
          </p:nvSpPr>
          <p:spPr>
            <a:xfrm>
              <a:off x="972674" y="170478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3" name="pt26">
              <a:extLst>
                <a:ext uri="{FF2B5EF4-FFF2-40B4-BE49-F238E27FC236}">
                  <a16:creationId xmlns:a16="http://schemas.microsoft.com/office/drawing/2014/main" id="{B4B6F3FA-B944-1BF8-67F0-C87C42FD5DA2}"/>
                </a:ext>
              </a:extLst>
            </p:cNvPr>
            <p:cNvSpPr/>
            <p:nvPr/>
          </p:nvSpPr>
          <p:spPr>
            <a:xfrm>
              <a:off x="928885" y="1513790"/>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4" name="pt27">
              <a:extLst>
                <a:ext uri="{FF2B5EF4-FFF2-40B4-BE49-F238E27FC236}">
                  <a16:creationId xmlns:a16="http://schemas.microsoft.com/office/drawing/2014/main" id="{AF783AF3-F7AE-F5AA-15BB-258813820F25}"/>
                </a:ext>
              </a:extLst>
            </p:cNvPr>
            <p:cNvSpPr/>
            <p:nvPr/>
          </p:nvSpPr>
          <p:spPr>
            <a:xfrm>
              <a:off x="986852" y="1907902"/>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5" name="pt28">
              <a:extLst>
                <a:ext uri="{FF2B5EF4-FFF2-40B4-BE49-F238E27FC236}">
                  <a16:creationId xmlns:a16="http://schemas.microsoft.com/office/drawing/2014/main" id="{D7AA4F09-282A-8BF2-C3D5-3CFFDDBD249C}"/>
                </a:ext>
              </a:extLst>
            </p:cNvPr>
            <p:cNvSpPr/>
            <p:nvPr/>
          </p:nvSpPr>
          <p:spPr>
            <a:xfrm>
              <a:off x="1490053" y="1646898"/>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6" name="pt29">
              <a:extLst>
                <a:ext uri="{FF2B5EF4-FFF2-40B4-BE49-F238E27FC236}">
                  <a16:creationId xmlns:a16="http://schemas.microsoft.com/office/drawing/2014/main" id="{5CA53544-9945-CBEF-59D1-629CC17E24F6}"/>
                </a:ext>
              </a:extLst>
            </p:cNvPr>
            <p:cNvSpPr/>
            <p:nvPr/>
          </p:nvSpPr>
          <p:spPr>
            <a:xfrm>
              <a:off x="1474052" y="160878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7" name="pt30">
              <a:extLst>
                <a:ext uri="{FF2B5EF4-FFF2-40B4-BE49-F238E27FC236}">
                  <a16:creationId xmlns:a16="http://schemas.microsoft.com/office/drawing/2014/main" id="{3B695906-4BF6-BBDB-6D8E-ADF4DD592751}"/>
                </a:ext>
              </a:extLst>
            </p:cNvPr>
            <p:cNvSpPr/>
            <p:nvPr/>
          </p:nvSpPr>
          <p:spPr>
            <a:xfrm>
              <a:off x="1492626" y="157238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8" name="pt31">
              <a:extLst>
                <a:ext uri="{FF2B5EF4-FFF2-40B4-BE49-F238E27FC236}">
                  <a16:creationId xmlns:a16="http://schemas.microsoft.com/office/drawing/2014/main" id="{E73C22A4-E25C-4193-550F-BD22B26C8635}"/>
                </a:ext>
              </a:extLst>
            </p:cNvPr>
            <p:cNvSpPr/>
            <p:nvPr/>
          </p:nvSpPr>
          <p:spPr>
            <a:xfrm>
              <a:off x="890631" y="174489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29" name="pt32">
              <a:extLst>
                <a:ext uri="{FF2B5EF4-FFF2-40B4-BE49-F238E27FC236}">
                  <a16:creationId xmlns:a16="http://schemas.microsoft.com/office/drawing/2014/main" id="{C968345D-781D-285F-F6F8-29BD9C06A10B}"/>
                </a:ext>
              </a:extLst>
            </p:cNvPr>
            <p:cNvSpPr/>
            <p:nvPr/>
          </p:nvSpPr>
          <p:spPr>
            <a:xfrm>
              <a:off x="925352" y="1352609"/>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0" name="pt33">
              <a:extLst>
                <a:ext uri="{FF2B5EF4-FFF2-40B4-BE49-F238E27FC236}">
                  <a16:creationId xmlns:a16="http://schemas.microsoft.com/office/drawing/2014/main" id="{BFB1BDA8-3994-76E3-4845-BDD799A14164}"/>
                </a:ext>
              </a:extLst>
            </p:cNvPr>
            <p:cNvSpPr/>
            <p:nvPr/>
          </p:nvSpPr>
          <p:spPr>
            <a:xfrm>
              <a:off x="932265" y="178683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1" name="pt34">
              <a:extLst>
                <a:ext uri="{FF2B5EF4-FFF2-40B4-BE49-F238E27FC236}">
                  <a16:creationId xmlns:a16="http://schemas.microsoft.com/office/drawing/2014/main" id="{25E9051A-5F53-89B0-3729-A735572C036F}"/>
                </a:ext>
              </a:extLst>
            </p:cNvPr>
            <p:cNvSpPr/>
            <p:nvPr/>
          </p:nvSpPr>
          <p:spPr>
            <a:xfrm>
              <a:off x="902186" y="178689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2" name="pt35">
              <a:extLst>
                <a:ext uri="{FF2B5EF4-FFF2-40B4-BE49-F238E27FC236}">
                  <a16:creationId xmlns:a16="http://schemas.microsoft.com/office/drawing/2014/main" id="{8D743FBF-9C82-B9BE-DC5B-EBAE073F4089}"/>
                </a:ext>
              </a:extLst>
            </p:cNvPr>
            <p:cNvSpPr/>
            <p:nvPr/>
          </p:nvSpPr>
          <p:spPr>
            <a:xfrm>
              <a:off x="896727" y="153783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3" name="pt36">
              <a:extLst>
                <a:ext uri="{FF2B5EF4-FFF2-40B4-BE49-F238E27FC236}">
                  <a16:creationId xmlns:a16="http://schemas.microsoft.com/office/drawing/2014/main" id="{B07F72A1-EC7D-0C61-2B5C-A75F5A772641}"/>
                </a:ext>
              </a:extLst>
            </p:cNvPr>
            <p:cNvSpPr/>
            <p:nvPr/>
          </p:nvSpPr>
          <p:spPr>
            <a:xfrm>
              <a:off x="905631" y="1560670"/>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4" name="pt37">
              <a:extLst>
                <a:ext uri="{FF2B5EF4-FFF2-40B4-BE49-F238E27FC236}">
                  <a16:creationId xmlns:a16="http://schemas.microsoft.com/office/drawing/2014/main" id="{B2EC8EE9-840E-5BC8-9662-0DFD5A957330}"/>
                </a:ext>
              </a:extLst>
            </p:cNvPr>
            <p:cNvSpPr/>
            <p:nvPr/>
          </p:nvSpPr>
          <p:spPr>
            <a:xfrm>
              <a:off x="1519991" y="1918969"/>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5" name="pt38">
              <a:extLst>
                <a:ext uri="{FF2B5EF4-FFF2-40B4-BE49-F238E27FC236}">
                  <a16:creationId xmlns:a16="http://schemas.microsoft.com/office/drawing/2014/main" id="{8C6AEEB5-A96C-E063-6F2C-80C8C0BE57E5}"/>
                </a:ext>
              </a:extLst>
            </p:cNvPr>
            <p:cNvSpPr/>
            <p:nvPr/>
          </p:nvSpPr>
          <p:spPr>
            <a:xfrm>
              <a:off x="1492647" y="1818788"/>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6" name="pt39">
              <a:extLst>
                <a:ext uri="{FF2B5EF4-FFF2-40B4-BE49-F238E27FC236}">
                  <a16:creationId xmlns:a16="http://schemas.microsoft.com/office/drawing/2014/main" id="{E81BF7D4-B288-749C-32A6-E6DABA12A641}"/>
                </a:ext>
              </a:extLst>
            </p:cNvPr>
            <p:cNvSpPr/>
            <p:nvPr/>
          </p:nvSpPr>
          <p:spPr>
            <a:xfrm>
              <a:off x="948462" y="208750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7" name="pt40">
              <a:extLst>
                <a:ext uri="{FF2B5EF4-FFF2-40B4-BE49-F238E27FC236}">
                  <a16:creationId xmlns:a16="http://schemas.microsoft.com/office/drawing/2014/main" id="{DA0191AF-0249-8343-9AA3-AE081F92CCEA}"/>
                </a:ext>
              </a:extLst>
            </p:cNvPr>
            <p:cNvSpPr/>
            <p:nvPr/>
          </p:nvSpPr>
          <p:spPr>
            <a:xfrm>
              <a:off x="957871" y="147356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8" name="pt41">
              <a:extLst>
                <a:ext uri="{FF2B5EF4-FFF2-40B4-BE49-F238E27FC236}">
                  <a16:creationId xmlns:a16="http://schemas.microsoft.com/office/drawing/2014/main" id="{ABD7CBB4-D305-B929-EDFD-65A5CAD5EFA1}"/>
                </a:ext>
              </a:extLst>
            </p:cNvPr>
            <p:cNvSpPr/>
            <p:nvPr/>
          </p:nvSpPr>
          <p:spPr>
            <a:xfrm>
              <a:off x="1499603" y="173917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39" name="pt42">
              <a:extLst>
                <a:ext uri="{FF2B5EF4-FFF2-40B4-BE49-F238E27FC236}">
                  <a16:creationId xmlns:a16="http://schemas.microsoft.com/office/drawing/2014/main" id="{EFFA490A-77C1-23E9-87EC-C6009873DD1B}"/>
                </a:ext>
              </a:extLst>
            </p:cNvPr>
            <p:cNvSpPr/>
            <p:nvPr/>
          </p:nvSpPr>
          <p:spPr>
            <a:xfrm>
              <a:off x="947848" y="1914557"/>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0" name="pt43">
              <a:extLst>
                <a:ext uri="{FF2B5EF4-FFF2-40B4-BE49-F238E27FC236}">
                  <a16:creationId xmlns:a16="http://schemas.microsoft.com/office/drawing/2014/main" id="{BE61D021-0388-6B6A-D094-822D6F1EC1FA}"/>
                </a:ext>
              </a:extLst>
            </p:cNvPr>
            <p:cNvSpPr/>
            <p:nvPr/>
          </p:nvSpPr>
          <p:spPr>
            <a:xfrm>
              <a:off x="1497722" y="178330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1" name="pt44">
              <a:extLst>
                <a:ext uri="{FF2B5EF4-FFF2-40B4-BE49-F238E27FC236}">
                  <a16:creationId xmlns:a16="http://schemas.microsoft.com/office/drawing/2014/main" id="{6A586741-229B-7C2D-ED9A-388F965F5AED}"/>
                </a:ext>
              </a:extLst>
            </p:cNvPr>
            <p:cNvSpPr/>
            <p:nvPr/>
          </p:nvSpPr>
          <p:spPr>
            <a:xfrm>
              <a:off x="1506596" y="2083236"/>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2" name="pt45">
              <a:extLst>
                <a:ext uri="{FF2B5EF4-FFF2-40B4-BE49-F238E27FC236}">
                  <a16:creationId xmlns:a16="http://schemas.microsoft.com/office/drawing/2014/main" id="{642A7208-5B53-4C3D-FA8B-DB430A439614}"/>
                </a:ext>
              </a:extLst>
            </p:cNvPr>
            <p:cNvSpPr/>
            <p:nvPr/>
          </p:nvSpPr>
          <p:spPr>
            <a:xfrm>
              <a:off x="983896" y="187555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3" name="pt46">
              <a:extLst>
                <a:ext uri="{FF2B5EF4-FFF2-40B4-BE49-F238E27FC236}">
                  <a16:creationId xmlns:a16="http://schemas.microsoft.com/office/drawing/2014/main" id="{B5919977-4CE0-5E45-F919-762D1B184B77}"/>
                </a:ext>
              </a:extLst>
            </p:cNvPr>
            <p:cNvSpPr/>
            <p:nvPr/>
          </p:nvSpPr>
          <p:spPr>
            <a:xfrm>
              <a:off x="922177" y="149547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4" name="pt47">
              <a:extLst>
                <a:ext uri="{FF2B5EF4-FFF2-40B4-BE49-F238E27FC236}">
                  <a16:creationId xmlns:a16="http://schemas.microsoft.com/office/drawing/2014/main" id="{1983A542-980A-C90A-D3C3-0218CF6B8E77}"/>
                </a:ext>
              </a:extLst>
            </p:cNvPr>
            <p:cNvSpPr/>
            <p:nvPr/>
          </p:nvSpPr>
          <p:spPr>
            <a:xfrm>
              <a:off x="988394" y="171176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5" name="pt48">
              <a:extLst>
                <a:ext uri="{FF2B5EF4-FFF2-40B4-BE49-F238E27FC236}">
                  <a16:creationId xmlns:a16="http://schemas.microsoft.com/office/drawing/2014/main" id="{BA347ED6-F6B3-D648-4092-020EE6BAA931}"/>
                </a:ext>
              </a:extLst>
            </p:cNvPr>
            <p:cNvSpPr/>
            <p:nvPr/>
          </p:nvSpPr>
          <p:spPr>
            <a:xfrm>
              <a:off x="958963" y="178769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6" name="pt49">
              <a:extLst>
                <a:ext uri="{FF2B5EF4-FFF2-40B4-BE49-F238E27FC236}">
                  <a16:creationId xmlns:a16="http://schemas.microsoft.com/office/drawing/2014/main" id="{BAA3B733-A83F-F23E-1E3F-7B666ED9EB5D}"/>
                </a:ext>
              </a:extLst>
            </p:cNvPr>
            <p:cNvSpPr/>
            <p:nvPr/>
          </p:nvSpPr>
          <p:spPr>
            <a:xfrm>
              <a:off x="927196" y="1607838"/>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7" name="pt50">
              <a:extLst>
                <a:ext uri="{FF2B5EF4-FFF2-40B4-BE49-F238E27FC236}">
                  <a16:creationId xmlns:a16="http://schemas.microsoft.com/office/drawing/2014/main" id="{43C1EDC8-4F22-ADD5-AAA1-729315E616EF}"/>
                </a:ext>
              </a:extLst>
            </p:cNvPr>
            <p:cNvSpPr/>
            <p:nvPr/>
          </p:nvSpPr>
          <p:spPr>
            <a:xfrm>
              <a:off x="905272" y="151046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8" name="pt51">
              <a:extLst>
                <a:ext uri="{FF2B5EF4-FFF2-40B4-BE49-F238E27FC236}">
                  <a16:creationId xmlns:a16="http://schemas.microsoft.com/office/drawing/2014/main" id="{F827ED5D-B737-1A7F-B3BD-D8EC4CB4409E}"/>
                </a:ext>
              </a:extLst>
            </p:cNvPr>
            <p:cNvSpPr/>
            <p:nvPr/>
          </p:nvSpPr>
          <p:spPr>
            <a:xfrm>
              <a:off x="959626" y="1840958"/>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49" name="pt52">
              <a:extLst>
                <a:ext uri="{FF2B5EF4-FFF2-40B4-BE49-F238E27FC236}">
                  <a16:creationId xmlns:a16="http://schemas.microsoft.com/office/drawing/2014/main" id="{3A78A79E-CCEB-BC23-5BE1-638C4CD5FE8F}"/>
                </a:ext>
              </a:extLst>
            </p:cNvPr>
            <p:cNvSpPr/>
            <p:nvPr/>
          </p:nvSpPr>
          <p:spPr>
            <a:xfrm>
              <a:off x="1501240" y="166052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0" name="pt53">
              <a:extLst>
                <a:ext uri="{FF2B5EF4-FFF2-40B4-BE49-F238E27FC236}">
                  <a16:creationId xmlns:a16="http://schemas.microsoft.com/office/drawing/2014/main" id="{32BC6E26-3265-0C4C-24B7-5DF83FD008FB}"/>
                </a:ext>
              </a:extLst>
            </p:cNvPr>
            <p:cNvSpPr/>
            <p:nvPr/>
          </p:nvSpPr>
          <p:spPr>
            <a:xfrm>
              <a:off x="1464584" y="1383358"/>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1" name="pt54">
              <a:extLst>
                <a:ext uri="{FF2B5EF4-FFF2-40B4-BE49-F238E27FC236}">
                  <a16:creationId xmlns:a16="http://schemas.microsoft.com/office/drawing/2014/main" id="{A679259D-4B36-A2DC-06F8-B950A99BFE6A}"/>
                </a:ext>
              </a:extLst>
            </p:cNvPr>
            <p:cNvSpPr/>
            <p:nvPr/>
          </p:nvSpPr>
          <p:spPr>
            <a:xfrm>
              <a:off x="950856" y="177214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2" name="pt55">
              <a:extLst>
                <a:ext uri="{FF2B5EF4-FFF2-40B4-BE49-F238E27FC236}">
                  <a16:creationId xmlns:a16="http://schemas.microsoft.com/office/drawing/2014/main" id="{A51A965B-A721-E3BD-0DAE-7950AC2146E9}"/>
                </a:ext>
              </a:extLst>
            </p:cNvPr>
            <p:cNvSpPr/>
            <p:nvPr/>
          </p:nvSpPr>
          <p:spPr>
            <a:xfrm>
              <a:off x="1460031" y="174117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3" name="pt56">
              <a:extLst>
                <a:ext uri="{FF2B5EF4-FFF2-40B4-BE49-F238E27FC236}">
                  <a16:creationId xmlns:a16="http://schemas.microsoft.com/office/drawing/2014/main" id="{87162B55-1148-629A-9685-EBA95173EAAE}"/>
                </a:ext>
              </a:extLst>
            </p:cNvPr>
            <p:cNvSpPr/>
            <p:nvPr/>
          </p:nvSpPr>
          <p:spPr>
            <a:xfrm>
              <a:off x="1512981" y="164335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4" name="pt57">
              <a:extLst>
                <a:ext uri="{FF2B5EF4-FFF2-40B4-BE49-F238E27FC236}">
                  <a16:creationId xmlns:a16="http://schemas.microsoft.com/office/drawing/2014/main" id="{C485C1E1-9494-3F59-C0CB-56F49FA157C3}"/>
                </a:ext>
              </a:extLst>
            </p:cNvPr>
            <p:cNvSpPr/>
            <p:nvPr/>
          </p:nvSpPr>
          <p:spPr>
            <a:xfrm>
              <a:off x="1447891" y="178631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5" name="pt58">
              <a:extLst>
                <a:ext uri="{FF2B5EF4-FFF2-40B4-BE49-F238E27FC236}">
                  <a16:creationId xmlns:a16="http://schemas.microsoft.com/office/drawing/2014/main" id="{5FD736DC-5EEF-A0D7-993F-BE5D315C2EAC}"/>
                </a:ext>
              </a:extLst>
            </p:cNvPr>
            <p:cNvSpPr/>
            <p:nvPr/>
          </p:nvSpPr>
          <p:spPr>
            <a:xfrm>
              <a:off x="933171" y="1398468"/>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6" name="pt59">
              <a:extLst>
                <a:ext uri="{FF2B5EF4-FFF2-40B4-BE49-F238E27FC236}">
                  <a16:creationId xmlns:a16="http://schemas.microsoft.com/office/drawing/2014/main" id="{2665717B-B38B-D697-CB27-4E29E3AAB02C}"/>
                </a:ext>
              </a:extLst>
            </p:cNvPr>
            <p:cNvSpPr/>
            <p:nvPr/>
          </p:nvSpPr>
          <p:spPr>
            <a:xfrm>
              <a:off x="1516188" y="1820727"/>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7" name="pt60">
              <a:extLst>
                <a:ext uri="{FF2B5EF4-FFF2-40B4-BE49-F238E27FC236}">
                  <a16:creationId xmlns:a16="http://schemas.microsoft.com/office/drawing/2014/main" id="{C5A7A7DD-6AD5-543C-32D9-713DCD6179B2}"/>
                </a:ext>
              </a:extLst>
            </p:cNvPr>
            <p:cNvSpPr/>
            <p:nvPr/>
          </p:nvSpPr>
          <p:spPr>
            <a:xfrm>
              <a:off x="891122" y="1870079"/>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8" name="pt61">
              <a:extLst>
                <a:ext uri="{FF2B5EF4-FFF2-40B4-BE49-F238E27FC236}">
                  <a16:creationId xmlns:a16="http://schemas.microsoft.com/office/drawing/2014/main" id="{2F205258-D82E-78FC-76FB-D850D1759B4A}"/>
                </a:ext>
              </a:extLst>
            </p:cNvPr>
            <p:cNvSpPr/>
            <p:nvPr/>
          </p:nvSpPr>
          <p:spPr>
            <a:xfrm>
              <a:off x="1448200" y="214817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59" name="pt62">
              <a:extLst>
                <a:ext uri="{FF2B5EF4-FFF2-40B4-BE49-F238E27FC236}">
                  <a16:creationId xmlns:a16="http://schemas.microsoft.com/office/drawing/2014/main" id="{683EEED0-BE04-7F25-F638-D50CF035EEED}"/>
                </a:ext>
              </a:extLst>
            </p:cNvPr>
            <p:cNvSpPr/>
            <p:nvPr/>
          </p:nvSpPr>
          <p:spPr>
            <a:xfrm>
              <a:off x="1435423" y="184218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0" name="pt63">
              <a:extLst>
                <a:ext uri="{FF2B5EF4-FFF2-40B4-BE49-F238E27FC236}">
                  <a16:creationId xmlns:a16="http://schemas.microsoft.com/office/drawing/2014/main" id="{45284D73-B675-7DF0-F391-8104D5974E4D}"/>
                </a:ext>
              </a:extLst>
            </p:cNvPr>
            <p:cNvSpPr/>
            <p:nvPr/>
          </p:nvSpPr>
          <p:spPr>
            <a:xfrm>
              <a:off x="1468777" y="157248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1" name="pt64">
              <a:extLst>
                <a:ext uri="{FF2B5EF4-FFF2-40B4-BE49-F238E27FC236}">
                  <a16:creationId xmlns:a16="http://schemas.microsoft.com/office/drawing/2014/main" id="{BBFE61F0-6A85-982A-6660-D4D143DA05B5}"/>
                </a:ext>
              </a:extLst>
            </p:cNvPr>
            <p:cNvSpPr/>
            <p:nvPr/>
          </p:nvSpPr>
          <p:spPr>
            <a:xfrm>
              <a:off x="1499041" y="185779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2" name="pt65">
              <a:extLst>
                <a:ext uri="{FF2B5EF4-FFF2-40B4-BE49-F238E27FC236}">
                  <a16:creationId xmlns:a16="http://schemas.microsoft.com/office/drawing/2014/main" id="{7FE71FDE-B532-374F-DE66-FFA9103FA68E}"/>
                </a:ext>
              </a:extLst>
            </p:cNvPr>
            <p:cNvSpPr/>
            <p:nvPr/>
          </p:nvSpPr>
          <p:spPr>
            <a:xfrm>
              <a:off x="1444679" y="1848559"/>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3" name="pt66">
              <a:extLst>
                <a:ext uri="{FF2B5EF4-FFF2-40B4-BE49-F238E27FC236}">
                  <a16:creationId xmlns:a16="http://schemas.microsoft.com/office/drawing/2014/main" id="{7D4F83EA-5214-802F-5766-2A1A36636D83}"/>
                </a:ext>
              </a:extLst>
            </p:cNvPr>
            <p:cNvSpPr/>
            <p:nvPr/>
          </p:nvSpPr>
          <p:spPr>
            <a:xfrm>
              <a:off x="1430636" y="183734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4" name="pt67">
              <a:extLst>
                <a:ext uri="{FF2B5EF4-FFF2-40B4-BE49-F238E27FC236}">
                  <a16:creationId xmlns:a16="http://schemas.microsoft.com/office/drawing/2014/main" id="{35456C03-E78F-BAC6-B0F5-E474E62BC5A7}"/>
                </a:ext>
              </a:extLst>
            </p:cNvPr>
            <p:cNvSpPr/>
            <p:nvPr/>
          </p:nvSpPr>
          <p:spPr>
            <a:xfrm>
              <a:off x="959811" y="184065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5" name="pt68">
              <a:extLst>
                <a:ext uri="{FF2B5EF4-FFF2-40B4-BE49-F238E27FC236}">
                  <a16:creationId xmlns:a16="http://schemas.microsoft.com/office/drawing/2014/main" id="{3E1549E8-1AF9-AA5D-7CA9-37C2C136C6F5}"/>
                </a:ext>
              </a:extLst>
            </p:cNvPr>
            <p:cNvSpPr/>
            <p:nvPr/>
          </p:nvSpPr>
          <p:spPr>
            <a:xfrm>
              <a:off x="928703" y="169414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6" name="pt69">
              <a:extLst>
                <a:ext uri="{FF2B5EF4-FFF2-40B4-BE49-F238E27FC236}">
                  <a16:creationId xmlns:a16="http://schemas.microsoft.com/office/drawing/2014/main" id="{E8042F6D-172A-4791-EFAB-2BB7F6D8B9E9}"/>
                </a:ext>
              </a:extLst>
            </p:cNvPr>
            <p:cNvSpPr/>
            <p:nvPr/>
          </p:nvSpPr>
          <p:spPr>
            <a:xfrm>
              <a:off x="963744" y="1854239"/>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7" name="pt70">
              <a:extLst>
                <a:ext uri="{FF2B5EF4-FFF2-40B4-BE49-F238E27FC236}">
                  <a16:creationId xmlns:a16="http://schemas.microsoft.com/office/drawing/2014/main" id="{34D7FFF6-E878-4BDC-E66E-84BBE7CED9A3}"/>
                </a:ext>
              </a:extLst>
            </p:cNvPr>
            <p:cNvSpPr/>
            <p:nvPr/>
          </p:nvSpPr>
          <p:spPr>
            <a:xfrm>
              <a:off x="1488007" y="1930906"/>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8" name="pt71">
              <a:extLst>
                <a:ext uri="{FF2B5EF4-FFF2-40B4-BE49-F238E27FC236}">
                  <a16:creationId xmlns:a16="http://schemas.microsoft.com/office/drawing/2014/main" id="{72A1E46F-7077-225D-FA54-C36CC1E38232}"/>
                </a:ext>
              </a:extLst>
            </p:cNvPr>
            <p:cNvSpPr/>
            <p:nvPr/>
          </p:nvSpPr>
          <p:spPr>
            <a:xfrm>
              <a:off x="932459" y="166127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69" name="pt72">
              <a:extLst>
                <a:ext uri="{FF2B5EF4-FFF2-40B4-BE49-F238E27FC236}">
                  <a16:creationId xmlns:a16="http://schemas.microsoft.com/office/drawing/2014/main" id="{0600AF1D-E6CC-3CF8-D184-83E22EB743F0}"/>
                </a:ext>
              </a:extLst>
            </p:cNvPr>
            <p:cNvSpPr/>
            <p:nvPr/>
          </p:nvSpPr>
          <p:spPr>
            <a:xfrm>
              <a:off x="974508" y="160783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0" name="pt73">
              <a:extLst>
                <a:ext uri="{FF2B5EF4-FFF2-40B4-BE49-F238E27FC236}">
                  <a16:creationId xmlns:a16="http://schemas.microsoft.com/office/drawing/2014/main" id="{EB014F20-5EEC-21F7-15FB-527242A845C6}"/>
                </a:ext>
              </a:extLst>
            </p:cNvPr>
            <p:cNvSpPr/>
            <p:nvPr/>
          </p:nvSpPr>
          <p:spPr>
            <a:xfrm>
              <a:off x="907340" y="175968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1" name="pt74">
              <a:extLst>
                <a:ext uri="{FF2B5EF4-FFF2-40B4-BE49-F238E27FC236}">
                  <a16:creationId xmlns:a16="http://schemas.microsoft.com/office/drawing/2014/main" id="{5049608F-08F9-4ADD-FBF7-6C3987AB39B5}"/>
                </a:ext>
              </a:extLst>
            </p:cNvPr>
            <p:cNvSpPr/>
            <p:nvPr/>
          </p:nvSpPr>
          <p:spPr>
            <a:xfrm>
              <a:off x="1440745" y="1652027"/>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2" name="pt75">
              <a:extLst>
                <a:ext uri="{FF2B5EF4-FFF2-40B4-BE49-F238E27FC236}">
                  <a16:creationId xmlns:a16="http://schemas.microsoft.com/office/drawing/2014/main" id="{C30AC8E6-09D0-78BF-9519-BC793470F84C}"/>
                </a:ext>
              </a:extLst>
            </p:cNvPr>
            <p:cNvSpPr/>
            <p:nvPr/>
          </p:nvSpPr>
          <p:spPr>
            <a:xfrm>
              <a:off x="914745" y="190134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3" name="pt76">
              <a:extLst>
                <a:ext uri="{FF2B5EF4-FFF2-40B4-BE49-F238E27FC236}">
                  <a16:creationId xmlns:a16="http://schemas.microsoft.com/office/drawing/2014/main" id="{CCC7DD25-723D-D8B5-C695-4BCCA5428E62}"/>
                </a:ext>
              </a:extLst>
            </p:cNvPr>
            <p:cNvSpPr/>
            <p:nvPr/>
          </p:nvSpPr>
          <p:spPr>
            <a:xfrm>
              <a:off x="1497316" y="1825915"/>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4" name="pt77">
              <a:extLst>
                <a:ext uri="{FF2B5EF4-FFF2-40B4-BE49-F238E27FC236}">
                  <a16:creationId xmlns:a16="http://schemas.microsoft.com/office/drawing/2014/main" id="{B09B24DB-0329-73E1-2C1A-B95B33ACABAE}"/>
                </a:ext>
              </a:extLst>
            </p:cNvPr>
            <p:cNvSpPr/>
            <p:nvPr/>
          </p:nvSpPr>
          <p:spPr>
            <a:xfrm>
              <a:off x="962885" y="193733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5" name="pt78">
              <a:extLst>
                <a:ext uri="{FF2B5EF4-FFF2-40B4-BE49-F238E27FC236}">
                  <a16:creationId xmlns:a16="http://schemas.microsoft.com/office/drawing/2014/main" id="{7E54C9BA-71A3-4DBC-AAA1-85C406FC3C70}"/>
                </a:ext>
              </a:extLst>
            </p:cNvPr>
            <p:cNvSpPr/>
            <p:nvPr/>
          </p:nvSpPr>
          <p:spPr>
            <a:xfrm>
              <a:off x="939809" y="1717305"/>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6" name="pt79">
              <a:extLst>
                <a:ext uri="{FF2B5EF4-FFF2-40B4-BE49-F238E27FC236}">
                  <a16:creationId xmlns:a16="http://schemas.microsoft.com/office/drawing/2014/main" id="{89751592-10C6-8098-1F44-92C1EBA4A6D9}"/>
                </a:ext>
              </a:extLst>
            </p:cNvPr>
            <p:cNvSpPr/>
            <p:nvPr/>
          </p:nvSpPr>
          <p:spPr>
            <a:xfrm>
              <a:off x="908767" y="175974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7" name="pt80">
              <a:extLst>
                <a:ext uri="{FF2B5EF4-FFF2-40B4-BE49-F238E27FC236}">
                  <a16:creationId xmlns:a16="http://schemas.microsoft.com/office/drawing/2014/main" id="{C9611169-CDE5-C2D8-1604-8D54FA26E844}"/>
                </a:ext>
              </a:extLst>
            </p:cNvPr>
            <p:cNvSpPr/>
            <p:nvPr/>
          </p:nvSpPr>
          <p:spPr>
            <a:xfrm>
              <a:off x="1473172" y="157407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8" name="pt81">
              <a:extLst>
                <a:ext uri="{FF2B5EF4-FFF2-40B4-BE49-F238E27FC236}">
                  <a16:creationId xmlns:a16="http://schemas.microsoft.com/office/drawing/2014/main" id="{DA85CE14-05B2-B3FE-1B48-BA96A031188E}"/>
                </a:ext>
              </a:extLst>
            </p:cNvPr>
            <p:cNvSpPr/>
            <p:nvPr/>
          </p:nvSpPr>
          <p:spPr>
            <a:xfrm>
              <a:off x="1464683" y="160743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79" name="pt82">
              <a:extLst>
                <a:ext uri="{FF2B5EF4-FFF2-40B4-BE49-F238E27FC236}">
                  <a16:creationId xmlns:a16="http://schemas.microsoft.com/office/drawing/2014/main" id="{2341C792-0C99-5689-4409-C716F0B0D90E}"/>
                </a:ext>
              </a:extLst>
            </p:cNvPr>
            <p:cNvSpPr/>
            <p:nvPr/>
          </p:nvSpPr>
          <p:spPr>
            <a:xfrm>
              <a:off x="1456388" y="136911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0" name="pt83">
              <a:extLst>
                <a:ext uri="{FF2B5EF4-FFF2-40B4-BE49-F238E27FC236}">
                  <a16:creationId xmlns:a16="http://schemas.microsoft.com/office/drawing/2014/main" id="{A6F75175-FB67-D20C-DA92-44404E4100E8}"/>
                </a:ext>
              </a:extLst>
            </p:cNvPr>
            <p:cNvSpPr/>
            <p:nvPr/>
          </p:nvSpPr>
          <p:spPr>
            <a:xfrm>
              <a:off x="973154" y="1790842"/>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1" name="pt84">
              <a:extLst>
                <a:ext uri="{FF2B5EF4-FFF2-40B4-BE49-F238E27FC236}">
                  <a16:creationId xmlns:a16="http://schemas.microsoft.com/office/drawing/2014/main" id="{0ABEA7F6-4998-AF5A-C886-E7D4A46B5CDE}"/>
                </a:ext>
              </a:extLst>
            </p:cNvPr>
            <p:cNvSpPr/>
            <p:nvPr/>
          </p:nvSpPr>
          <p:spPr>
            <a:xfrm>
              <a:off x="990945" y="1625402"/>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2" name="pt85">
              <a:extLst>
                <a:ext uri="{FF2B5EF4-FFF2-40B4-BE49-F238E27FC236}">
                  <a16:creationId xmlns:a16="http://schemas.microsoft.com/office/drawing/2014/main" id="{6CBD240E-FFA7-141C-4170-13A1D88D370B}"/>
                </a:ext>
              </a:extLst>
            </p:cNvPr>
            <p:cNvSpPr/>
            <p:nvPr/>
          </p:nvSpPr>
          <p:spPr>
            <a:xfrm>
              <a:off x="932006" y="162531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3" name="pt86">
              <a:extLst>
                <a:ext uri="{FF2B5EF4-FFF2-40B4-BE49-F238E27FC236}">
                  <a16:creationId xmlns:a16="http://schemas.microsoft.com/office/drawing/2014/main" id="{FBC4494B-9E52-56BD-7952-1945E7C7ACED}"/>
                </a:ext>
              </a:extLst>
            </p:cNvPr>
            <p:cNvSpPr/>
            <p:nvPr/>
          </p:nvSpPr>
          <p:spPr>
            <a:xfrm>
              <a:off x="1482721" y="1771935"/>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4" name="pt87">
              <a:extLst>
                <a:ext uri="{FF2B5EF4-FFF2-40B4-BE49-F238E27FC236}">
                  <a16:creationId xmlns:a16="http://schemas.microsoft.com/office/drawing/2014/main" id="{F2F975FB-7850-7CBD-116C-AEDA73A163DD}"/>
                </a:ext>
              </a:extLst>
            </p:cNvPr>
            <p:cNvSpPr/>
            <p:nvPr/>
          </p:nvSpPr>
          <p:spPr>
            <a:xfrm>
              <a:off x="1507694" y="174179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5" name="pt88">
              <a:extLst>
                <a:ext uri="{FF2B5EF4-FFF2-40B4-BE49-F238E27FC236}">
                  <a16:creationId xmlns:a16="http://schemas.microsoft.com/office/drawing/2014/main" id="{8FBC89BC-0DF8-3426-2F31-EE4B29FD4DEB}"/>
                </a:ext>
              </a:extLst>
            </p:cNvPr>
            <p:cNvSpPr/>
            <p:nvPr/>
          </p:nvSpPr>
          <p:spPr>
            <a:xfrm>
              <a:off x="915135" y="234296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6" name="pt89">
              <a:extLst>
                <a:ext uri="{FF2B5EF4-FFF2-40B4-BE49-F238E27FC236}">
                  <a16:creationId xmlns:a16="http://schemas.microsoft.com/office/drawing/2014/main" id="{B0996229-72FD-F238-1243-5AD16C5C5BBB}"/>
                </a:ext>
              </a:extLst>
            </p:cNvPr>
            <p:cNvSpPr/>
            <p:nvPr/>
          </p:nvSpPr>
          <p:spPr>
            <a:xfrm>
              <a:off x="951453" y="221801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7" name="pt90">
              <a:extLst>
                <a:ext uri="{FF2B5EF4-FFF2-40B4-BE49-F238E27FC236}">
                  <a16:creationId xmlns:a16="http://schemas.microsoft.com/office/drawing/2014/main" id="{1398D90E-BFBC-92F7-4281-1398601E27E7}"/>
                </a:ext>
              </a:extLst>
            </p:cNvPr>
            <p:cNvSpPr/>
            <p:nvPr/>
          </p:nvSpPr>
          <p:spPr>
            <a:xfrm>
              <a:off x="1480669" y="144407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589" name="pl92">
              <a:extLst>
                <a:ext uri="{FF2B5EF4-FFF2-40B4-BE49-F238E27FC236}">
                  <a16:creationId xmlns:a16="http://schemas.microsoft.com/office/drawing/2014/main" id="{51CAE034-8788-4069-BF24-0DAAEBD7F579}"/>
                </a:ext>
              </a:extLst>
            </p:cNvPr>
            <p:cNvSpPr/>
            <p:nvPr/>
          </p:nvSpPr>
          <p:spPr>
            <a:xfrm>
              <a:off x="631170" y="977578"/>
              <a:ext cx="21600" cy="1638722"/>
            </a:xfrm>
            <a:custGeom>
              <a:avLst/>
              <a:gdLst/>
              <a:ahLst/>
              <a:cxnLst/>
              <a:rect l="0" t="0" r="0" b="0"/>
              <a:pathLst>
                <a:path h="4896888">
                  <a:moveTo>
                    <a:pt x="0" y="4896888"/>
                  </a:moveTo>
                  <a:lnTo>
                    <a:pt x="0"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90" name="tx93">
              <a:extLst>
                <a:ext uri="{FF2B5EF4-FFF2-40B4-BE49-F238E27FC236}">
                  <a16:creationId xmlns:a16="http://schemas.microsoft.com/office/drawing/2014/main" id="{276ABC79-6AD4-05E0-9570-5CF2A5720037}"/>
                </a:ext>
              </a:extLst>
            </p:cNvPr>
            <p:cNvSpPr/>
            <p:nvPr/>
          </p:nvSpPr>
          <p:spPr>
            <a:xfrm>
              <a:off x="537717" y="2592518"/>
              <a:ext cx="35455" cy="46598"/>
            </a:xfrm>
            <a:prstGeom prst="rect">
              <a:avLst/>
            </a:prstGeom>
            <a:noFill/>
            <a:ln w="6350">
              <a:noFill/>
            </a:ln>
          </p:spPr>
          <p:txBody>
            <a:bodyPr wrap="none" lIns="0" tIns="0" rIns="0" bIns="0" anchor="ctr" anchorCtr="1"/>
            <a:lstStyle/>
            <a:p>
              <a:pPr marL="0" marR="0" indent="0" algn="l">
                <a:lnSpc>
                  <a:spcPts val="1500"/>
                </a:lnSpc>
                <a:spcBef>
                  <a:spcPts val="0"/>
                </a:spcBef>
                <a:spcAft>
                  <a:spcPts val="0"/>
                </a:spcAft>
              </a:pPr>
              <a:r>
                <a:rPr lang="en-US" altLang="zh-CN" sz="700" dirty="0">
                  <a:solidFill>
                    <a:srgbClr val="000000">
                      <a:alpha val="100000"/>
                    </a:srgbClr>
                  </a:solidFill>
                  <a:latin typeface="Arial" panose="020B0604020202020204" pitchFamily="34" charset="0"/>
                  <a:cs typeface="Arial" panose="020B0604020202020204" pitchFamily="34" charset="0"/>
                </a:rPr>
                <a:t>0</a:t>
              </a:r>
              <a:endParaRPr sz="700" dirty="0">
                <a:solidFill>
                  <a:srgbClr val="000000">
                    <a:alpha val="100000"/>
                  </a:srgbClr>
                </a:solidFill>
                <a:latin typeface="Arial" panose="020B0604020202020204" pitchFamily="34" charset="0"/>
                <a:cs typeface="Arial" panose="020B0604020202020204" pitchFamily="34" charset="0"/>
              </a:endParaRPr>
            </a:p>
          </p:txBody>
        </p:sp>
        <p:sp>
          <p:nvSpPr>
            <p:cNvPr id="2591" name="tx94">
              <a:extLst>
                <a:ext uri="{FF2B5EF4-FFF2-40B4-BE49-F238E27FC236}">
                  <a16:creationId xmlns:a16="http://schemas.microsoft.com/office/drawing/2014/main" id="{612B85B4-332B-9CDE-22CF-307E7BC5E29D}"/>
                </a:ext>
              </a:extLst>
            </p:cNvPr>
            <p:cNvSpPr/>
            <p:nvPr/>
          </p:nvSpPr>
          <p:spPr>
            <a:xfrm>
              <a:off x="502263" y="2182838"/>
              <a:ext cx="70909"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25</a:t>
              </a:r>
            </a:p>
          </p:txBody>
        </p:sp>
        <p:sp>
          <p:nvSpPr>
            <p:cNvPr id="2592" name="tx95">
              <a:extLst>
                <a:ext uri="{FF2B5EF4-FFF2-40B4-BE49-F238E27FC236}">
                  <a16:creationId xmlns:a16="http://schemas.microsoft.com/office/drawing/2014/main" id="{BFD58D64-F7CB-88E7-86F6-EB56DC13983A}"/>
                </a:ext>
              </a:extLst>
            </p:cNvPr>
            <p:cNvSpPr/>
            <p:nvPr/>
          </p:nvSpPr>
          <p:spPr>
            <a:xfrm>
              <a:off x="502263" y="1773157"/>
              <a:ext cx="70909"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50</a:t>
              </a:r>
            </a:p>
          </p:txBody>
        </p:sp>
        <p:sp>
          <p:nvSpPr>
            <p:cNvPr id="2593" name="tx96">
              <a:extLst>
                <a:ext uri="{FF2B5EF4-FFF2-40B4-BE49-F238E27FC236}">
                  <a16:creationId xmlns:a16="http://schemas.microsoft.com/office/drawing/2014/main" id="{830946BB-A3D5-35C5-30EE-D7D0F46D5CBF}"/>
                </a:ext>
              </a:extLst>
            </p:cNvPr>
            <p:cNvSpPr/>
            <p:nvPr/>
          </p:nvSpPr>
          <p:spPr>
            <a:xfrm>
              <a:off x="502263" y="1364255"/>
              <a:ext cx="70909" cy="4582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75</a:t>
              </a:r>
            </a:p>
          </p:txBody>
        </p:sp>
        <p:sp>
          <p:nvSpPr>
            <p:cNvPr id="2594" name="tx97">
              <a:extLst>
                <a:ext uri="{FF2B5EF4-FFF2-40B4-BE49-F238E27FC236}">
                  <a16:creationId xmlns:a16="http://schemas.microsoft.com/office/drawing/2014/main" id="{2D0455E8-D111-723A-558D-BC5CCE7664B3}"/>
                </a:ext>
              </a:extLst>
            </p:cNvPr>
            <p:cNvSpPr/>
            <p:nvPr/>
          </p:nvSpPr>
          <p:spPr>
            <a:xfrm>
              <a:off x="466808" y="953796"/>
              <a:ext cx="106364"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100</a:t>
              </a:r>
            </a:p>
          </p:txBody>
        </p:sp>
        <p:sp>
          <p:nvSpPr>
            <p:cNvPr id="2595" name="pl98">
              <a:extLst>
                <a:ext uri="{FF2B5EF4-FFF2-40B4-BE49-F238E27FC236}">
                  <a16:creationId xmlns:a16="http://schemas.microsoft.com/office/drawing/2014/main" id="{04321C70-2DC8-430D-6010-2FDF42FB0721}"/>
                </a:ext>
              </a:extLst>
            </p:cNvPr>
            <p:cNvSpPr/>
            <p:nvPr/>
          </p:nvSpPr>
          <p:spPr>
            <a:xfrm>
              <a:off x="605768" y="2616300"/>
              <a:ext cx="288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96" name="pl99">
              <a:extLst>
                <a:ext uri="{FF2B5EF4-FFF2-40B4-BE49-F238E27FC236}">
                  <a16:creationId xmlns:a16="http://schemas.microsoft.com/office/drawing/2014/main" id="{A6161543-0614-95F9-4E03-045DB56FB437}"/>
                </a:ext>
              </a:extLst>
            </p:cNvPr>
            <p:cNvSpPr/>
            <p:nvPr/>
          </p:nvSpPr>
          <p:spPr>
            <a:xfrm>
              <a:off x="605768" y="2206619"/>
              <a:ext cx="288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97" name="pl100">
              <a:extLst>
                <a:ext uri="{FF2B5EF4-FFF2-40B4-BE49-F238E27FC236}">
                  <a16:creationId xmlns:a16="http://schemas.microsoft.com/office/drawing/2014/main" id="{A4B1B02A-85F0-AA96-97DD-3E75813B5897}"/>
                </a:ext>
              </a:extLst>
            </p:cNvPr>
            <p:cNvSpPr/>
            <p:nvPr/>
          </p:nvSpPr>
          <p:spPr>
            <a:xfrm>
              <a:off x="605768" y="1796939"/>
              <a:ext cx="288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98" name="pl101">
              <a:extLst>
                <a:ext uri="{FF2B5EF4-FFF2-40B4-BE49-F238E27FC236}">
                  <a16:creationId xmlns:a16="http://schemas.microsoft.com/office/drawing/2014/main" id="{FEC383F0-BB60-B408-1441-38AFB6DC4C93}"/>
                </a:ext>
              </a:extLst>
            </p:cNvPr>
            <p:cNvSpPr/>
            <p:nvPr/>
          </p:nvSpPr>
          <p:spPr>
            <a:xfrm>
              <a:off x="605768" y="1387258"/>
              <a:ext cx="288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599" name="pl102">
              <a:extLst>
                <a:ext uri="{FF2B5EF4-FFF2-40B4-BE49-F238E27FC236}">
                  <a16:creationId xmlns:a16="http://schemas.microsoft.com/office/drawing/2014/main" id="{A971FFA0-6C90-E318-F243-402A050F35BC}"/>
                </a:ext>
              </a:extLst>
            </p:cNvPr>
            <p:cNvSpPr/>
            <p:nvPr/>
          </p:nvSpPr>
          <p:spPr>
            <a:xfrm>
              <a:off x="610001" y="977578"/>
              <a:ext cx="288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00" name="pl103">
              <a:extLst>
                <a:ext uri="{FF2B5EF4-FFF2-40B4-BE49-F238E27FC236}">
                  <a16:creationId xmlns:a16="http://schemas.microsoft.com/office/drawing/2014/main" id="{66E1D7DB-6122-93B6-C740-5A417A9A12F2}"/>
                </a:ext>
              </a:extLst>
            </p:cNvPr>
            <p:cNvSpPr/>
            <p:nvPr/>
          </p:nvSpPr>
          <p:spPr>
            <a:xfrm>
              <a:off x="627995" y="2616300"/>
              <a:ext cx="1174920" cy="0"/>
            </a:xfrm>
            <a:custGeom>
              <a:avLst/>
              <a:gdLst/>
              <a:ahLst/>
              <a:cxnLst/>
              <a:rect l="0" t="0" r="0" b="0"/>
              <a:pathLst>
                <a:path w="3510937">
                  <a:moveTo>
                    <a:pt x="0" y="0"/>
                  </a:moveTo>
                  <a:lnTo>
                    <a:pt x="3510937"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01" name="pl104">
              <a:extLst>
                <a:ext uri="{FF2B5EF4-FFF2-40B4-BE49-F238E27FC236}">
                  <a16:creationId xmlns:a16="http://schemas.microsoft.com/office/drawing/2014/main" id="{92963191-A312-4115-19A8-4EF69F693EA9}"/>
                </a:ext>
              </a:extLst>
            </p:cNvPr>
            <p:cNvSpPr/>
            <p:nvPr/>
          </p:nvSpPr>
          <p:spPr>
            <a:xfrm>
              <a:off x="948428" y="2616300"/>
              <a:ext cx="0" cy="21600"/>
            </a:xfrm>
            <a:custGeom>
              <a:avLst/>
              <a:gdLst/>
              <a:ahLst/>
              <a:cxnLst/>
              <a:rect l="0" t="0" r="0" b="0"/>
              <a:pathLst>
                <a:path h="34794">
                  <a:moveTo>
                    <a:pt x="0" y="34794"/>
                  </a:moveTo>
                  <a:lnTo>
                    <a:pt x="0" y="0"/>
                  </a:lnTo>
                </a:path>
              </a:pathLst>
            </a:custGeom>
            <a:ln w="9525"/>
          </p:spPr>
          <p:style>
            <a:lnRef idx="1">
              <a:schemeClr val="dk1"/>
            </a:lnRef>
            <a:fillRef idx="0">
              <a:schemeClr val="dk1"/>
            </a:fillRef>
            <a:effectRef idx="0">
              <a:schemeClr val="dk1"/>
            </a:effectRef>
            <a:fontRef idx="minor">
              <a:schemeClr val="tx1"/>
            </a:fontRef>
          </p:style>
          <p:txBody>
            <a:bodyPr/>
            <a:lstStyle/>
            <a:p>
              <a:endParaRPr sz="700">
                <a:latin typeface="Arial" panose="020B0604020202020204" pitchFamily="34" charset="0"/>
                <a:cs typeface="Arial" panose="020B0604020202020204" pitchFamily="34" charset="0"/>
              </a:endParaRPr>
            </a:p>
          </p:txBody>
        </p:sp>
        <p:sp>
          <p:nvSpPr>
            <p:cNvPr id="2602" name="pl105">
              <a:extLst>
                <a:ext uri="{FF2B5EF4-FFF2-40B4-BE49-F238E27FC236}">
                  <a16:creationId xmlns:a16="http://schemas.microsoft.com/office/drawing/2014/main" id="{42829D24-61F1-1540-A896-7AB7F741CC92}"/>
                </a:ext>
              </a:extLst>
            </p:cNvPr>
            <p:cNvSpPr/>
            <p:nvPr/>
          </p:nvSpPr>
          <p:spPr>
            <a:xfrm>
              <a:off x="1482482" y="2616300"/>
              <a:ext cx="0" cy="21600"/>
            </a:xfrm>
            <a:custGeom>
              <a:avLst/>
              <a:gdLst/>
              <a:ahLst/>
              <a:cxnLst/>
              <a:rect l="0" t="0" r="0" b="0"/>
              <a:pathLst>
                <a:path h="34794">
                  <a:moveTo>
                    <a:pt x="0" y="34794"/>
                  </a:moveTo>
                  <a:lnTo>
                    <a:pt x="0" y="0"/>
                  </a:lnTo>
                </a:path>
              </a:pathLst>
            </a:custGeom>
            <a:ln w="9525"/>
          </p:spPr>
          <p:style>
            <a:lnRef idx="1">
              <a:schemeClr val="dk1"/>
            </a:lnRef>
            <a:fillRef idx="0">
              <a:schemeClr val="dk1"/>
            </a:fillRef>
            <a:effectRef idx="0">
              <a:schemeClr val="dk1"/>
            </a:effectRef>
            <a:fontRef idx="minor">
              <a:schemeClr val="tx1"/>
            </a:fontRef>
          </p:style>
          <p:txBody>
            <a:bodyPr/>
            <a:lstStyle/>
            <a:p>
              <a:endParaRPr sz="700">
                <a:latin typeface="Arial" panose="020B0604020202020204" pitchFamily="34" charset="0"/>
                <a:cs typeface="Arial" panose="020B0604020202020204" pitchFamily="34" charset="0"/>
              </a:endParaRPr>
            </a:p>
          </p:txBody>
        </p:sp>
        <p:sp>
          <p:nvSpPr>
            <p:cNvPr id="2603" name="tx106">
              <a:extLst>
                <a:ext uri="{FF2B5EF4-FFF2-40B4-BE49-F238E27FC236}">
                  <a16:creationId xmlns:a16="http://schemas.microsoft.com/office/drawing/2014/main" id="{EEAEAC1D-2EF5-036A-6F32-608C8D245760}"/>
                </a:ext>
              </a:extLst>
            </p:cNvPr>
            <p:cNvSpPr/>
            <p:nvPr/>
          </p:nvSpPr>
          <p:spPr>
            <a:xfrm>
              <a:off x="755294" y="2624590"/>
              <a:ext cx="386266" cy="58302"/>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No Response</a:t>
              </a:r>
            </a:p>
          </p:txBody>
        </p:sp>
        <p:sp>
          <p:nvSpPr>
            <p:cNvPr id="2604" name="tx107">
              <a:extLst>
                <a:ext uri="{FF2B5EF4-FFF2-40B4-BE49-F238E27FC236}">
                  <a16:creationId xmlns:a16="http://schemas.microsoft.com/office/drawing/2014/main" id="{EA9F59B1-4237-51FE-A43D-DB641983B8A3}"/>
                </a:ext>
              </a:extLst>
            </p:cNvPr>
            <p:cNvSpPr/>
            <p:nvPr/>
          </p:nvSpPr>
          <p:spPr>
            <a:xfrm>
              <a:off x="1351356" y="2636419"/>
              <a:ext cx="262253" cy="46474"/>
            </a:xfrm>
            <a:prstGeom prst="rect">
              <a:avLst/>
            </a:prstGeom>
            <a:noFill/>
          </p:spPr>
          <p:txBody>
            <a:bodyPr wrap="none" lIns="0" tIns="0" rIns="0" bIns="0" anchor="ctr" anchorCtr="1"/>
            <a:lstStyle/>
            <a:p>
              <a:pPr marL="0" marR="0" indent="0" algn="l">
                <a:lnSpc>
                  <a:spcPts val="1500"/>
                </a:lnSpc>
                <a:spcBef>
                  <a:spcPts val="0"/>
                </a:spcBef>
                <a:spcAft>
                  <a:spcPts val="0"/>
                </a:spcAft>
              </a:pPr>
              <a:r>
                <a:rPr lang="en-US" sz="700" dirty="0">
                  <a:solidFill>
                    <a:srgbClr val="000000">
                      <a:alpha val="100000"/>
                    </a:srgbClr>
                  </a:solidFill>
                  <a:latin typeface="Arial" panose="020B0604020202020204" pitchFamily="34" charset="0"/>
                  <a:cs typeface="Arial" panose="020B0604020202020204" pitchFamily="34" charset="0"/>
                </a:rPr>
                <a:t>R</a:t>
              </a:r>
              <a:r>
                <a:rPr sz="700" dirty="0">
                  <a:solidFill>
                    <a:srgbClr val="000000">
                      <a:alpha val="100000"/>
                    </a:srgbClr>
                  </a:solidFill>
                  <a:latin typeface="Arial" panose="020B0604020202020204" pitchFamily="34" charset="0"/>
                  <a:cs typeface="Arial" panose="020B0604020202020204" pitchFamily="34" charset="0"/>
                </a:rPr>
                <a:t>esponse</a:t>
              </a:r>
            </a:p>
          </p:txBody>
        </p:sp>
        <p:sp>
          <p:nvSpPr>
            <p:cNvPr id="2605" name="tx109">
              <a:extLst>
                <a:ext uri="{FF2B5EF4-FFF2-40B4-BE49-F238E27FC236}">
                  <a16:creationId xmlns:a16="http://schemas.microsoft.com/office/drawing/2014/main" id="{ABA9EDED-4E9F-6301-D16C-465C73A32D8F}"/>
                </a:ext>
              </a:extLst>
            </p:cNvPr>
            <p:cNvSpPr/>
            <p:nvPr/>
          </p:nvSpPr>
          <p:spPr>
            <a:xfrm rot="16200000">
              <a:off x="338576" y="1767414"/>
              <a:ext cx="113430" cy="59050"/>
            </a:xfrm>
            <a:prstGeom prst="rect">
              <a:avLst/>
            </a:prstGeom>
            <a:noFill/>
          </p:spPr>
          <p:txBody>
            <a:bodyPr wrap="none" lIns="0" tIns="0" rIns="0" bIns="0" anchor="ctr" anchorCtr="1"/>
            <a:lstStyle/>
            <a:p>
              <a:pPr marL="0" marR="0" indent="0" algn="l">
                <a:lnSpc>
                  <a:spcPts val="1500"/>
                </a:lnSpc>
                <a:spcBef>
                  <a:spcPts val="0"/>
                </a:spcBef>
                <a:spcAft>
                  <a:spcPts val="0"/>
                </a:spcAft>
              </a:pPr>
              <a:r>
                <a:rPr lang="en-US" sz="700" dirty="0">
                  <a:solidFill>
                    <a:srgbClr val="000000">
                      <a:alpha val="100000"/>
                    </a:srgbClr>
                  </a:solidFill>
                  <a:latin typeface="Arial" panose="020B0604020202020204" pitchFamily="34" charset="0"/>
                  <a:cs typeface="Arial" panose="020B0604020202020204" pitchFamily="34" charset="0"/>
                </a:rPr>
                <a:t>A</a:t>
              </a:r>
              <a:r>
                <a:rPr sz="700" dirty="0">
                  <a:solidFill>
                    <a:srgbClr val="000000">
                      <a:alpha val="100000"/>
                    </a:srgbClr>
                  </a:solidFill>
                  <a:latin typeface="Arial" panose="020B0604020202020204" pitchFamily="34" charset="0"/>
                  <a:cs typeface="Arial" panose="020B0604020202020204" pitchFamily="34" charset="0"/>
                </a:rPr>
                <a:t>ge</a:t>
              </a:r>
              <a:r>
                <a:rPr lang="en-US" sz="700" dirty="0">
                  <a:solidFill>
                    <a:srgbClr val="000000">
                      <a:alpha val="100000"/>
                    </a:srgbClr>
                  </a:solidFill>
                  <a:latin typeface="Arial" panose="020B0604020202020204" pitchFamily="34" charset="0"/>
                  <a:cs typeface="Arial" panose="020B0604020202020204" pitchFamily="34" charset="0"/>
                </a:rPr>
                <a:t>(years)</a:t>
              </a:r>
              <a:endParaRPr sz="700" dirty="0">
                <a:solidFill>
                  <a:srgbClr val="000000">
                    <a:alpha val="100000"/>
                  </a:srgbClr>
                </a:solidFill>
                <a:latin typeface="Arial" panose="020B0604020202020204" pitchFamily="34" charset="0"/>
                <a:cs typeface="Arial" panose="020B0604020202020204" pitchFamily="34" charset="0"/>
              </a:endParaRPr>
            </a:p>
          </p:txBody>
        </p:sp>
        <p:grpSp>
          <p:nvGrpSpPr>
            <p:cNvPr id="113" name="组合 112">
              <a:extLst>
                <a:ext uri="{FF2B5EF4-FFF2-40B4-BE49-F238E27FC236}">
                  <a16:creationId xmlns:a16="http://schemas.microsoft.com/office/drawing/2014/main" id="{F3F115E7-1ED6-47EA-BAA0-5DC54F3B6B26}"/>
                </a:ext>
              </a:extLst>
            </p:cNvPr>
            <p:cNvGrpSpPr/>
            <p:nvPr/>
          </p:nvGrpSpPr>
          <p:grpSpPr>
            <a:xfrm>
              <a:off x="841456" y="1049065"/>
              <a:ext cx="849772" cy="114259"/>
              <a:chOff x="841456" y="552471"/>
              <a:chExt cx="849772" cy="114259"/>
            </a:xfrm>
          </p:grpSpPr>
          <p:sp>
            <p:nvSpPr>
              <p:cNvPr id="2588" name="tx91">
                <a:extLst>
                  <a:ext uri="{FF2B5EF4-FFF2-40B4-BE49-F238E27FC236}">
                    <a16:creationId xmlns:a16="http://schemas.microsoft.com/office/drawing/2014/main" id="{F55512EC-C7DC-1879-7D8D-F88FF1B39FBB}"/>
                  </a:ext>
                </a:extLst>
              </p:cNvPr>
              <p:cNvSpPr/>
              <p:nvPr/>
            </p:nvSpPr>
            <p:spPr>
              <a:xfrm>
                <a:off x="1016803" y="552471"/>
                <a:ext cx="499078" cy="55473"/>
              </a:xfrm>
              <a:prstGeom prst="rect">
                <a:avLst/>
              </a:prstGeom>
              <a:noFill/>
            </p:spPr>
            <p:txBody>
              <a:bodyPr wrap="none" lIns="0" tIns="0" rIns="0" bIns="0" anchor="ctr" anchorCtr="1"/>
              <a:lstStyle/>
              <a:p>
                <a:pPr marL="0" marR="0" indent="0" algn="l">
                  <a:lnSpc>
                    <a:spcPts val="1422"/>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Wilcoxon, </a:t>
                </a:r>
                <a:r>
                  <a:rPr sz="700" i="1" dirty="0">
                    <a:solidFill>
                      <a:srgbClr val="000000">
                        <a:alpha val="100000"/>
                      </a:srgbClr>
                    </a:solidFill>
                    <a:latin typeface="Arial" panose="020B0604020202020204" pitchFamily="34" charset="0"/>
                    <a:cs typeface="Arial" panose="020B0604020202020204" pitchFamily="34" charset="0"/>
                  </a:rPr>
                  <a:t>p</a:t>
                </a:r>
                <a:r>
                  <a:rPr sz="700" dirty="0">
                    <a:solidFill>
                      <a:srgbClr val="000000">
                        <a:alpha val="100000"/>
                      </a:srgbClr>
                    </a:solidFill>
                    <a:latin typeface="Arial" panose="020B0604020202020204" pitchFamily="34" charset="0"/>
                    <a:cs typeface="Arial" panose="020B0604020202020204" pitchFamily="34" charset="0"/>
                  </a:rPr>
                  <a:t> = 0.85</a:t>
                </a:r>
              </a:p>
            </p:txBody>
          </p:sp>
          <p:cxnSp>
            <p:nvCxnSpPr>
              <p:cNvPr id="114" name="直接连接符 113">
                <a:extLst>
                  <a:ext uri="{FF2B5EF4-FFF2-40B4-BE49-F238E27FC236}">
                    <a16:creationId xmlns:a16="http://schemas.microsoft.com/office/drawing/2014/main" id="{3EB8E0D2-9689-4D30-ED77-26A506D7ED16}"/>
                  </a:ext>
                </a:extLst>
              </p:cNvPr>
              <p:cNvCxnSpPr>
                <a:cxnSpLocks/>
              </p:cNvCxnSpPr>
              <p:nvPr/>
            </p:nvCxnSpPr>
            <p:spPr>
              <a:xfrm>
                <a:off x="841456" y="666730"/>
                <a:ext cx="84977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2898" name="组合 2897">
            <a:extLst>
              <a:ext uri="{FF2B5EF4-FFF2-40B4-BE49-F238E27FC236}">
                <a16:creationId xmlns:a16="http://schemas.microsoft.com/office/drawing/2014/main" id="{CED745D9-73B5-B715-8B35-E8426919B506}"/>
              </a:ext>
            </a:extLst>
          </p:cNvPr>
          <p:cNvGrpSpPr/>
          <p:nvPr/>
        </p:nvGrpSpPr>
        <p:grpSpPr>
          <a:xfrm>
            <a:off x="2152372" y="1009885"/>
            <a:ext cx="2285903" cy="1712134"/>
            <a:chOff x="2146065" y="969423"/>
            <a:chExt cx="2285903" cy="1712134"/>
          </a:xfrm>
        </p:grpSpPr>
        <p:sp>
          <p:nvSpPr>
            <p:cNvPr id="505" name="rc6">
              <a:extLst>
                <a:ext uri="{FF2B5EF4-FFF2-40B4-BE49-F238E27FC236}">
                  <a16:creationId xmlns:a16="http://schemas.microsoft.com/office/drawing/2014/main" id="{EEA188B6-5DFD-325B-5810-54435B91BFAA}"/>
                </a:ext>
              </a:extLst>
            </p:cNvPr>
            <p:cNvSpPr/>
            <p:nvPr/>
          </p:nvSpPr>
          <p:spPr>
            <a:xfrm>
              <a:off x="2571235" y="1346014"/>
              <a:ext cx="228569" cy="1250942"/>
            </a:xfrm>
            <a:prstGeom prst="rect">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506" name="rc7">
              <a:extLst>
                <a:ext uri="{FF2B5EF4-FFF2-40B4-BE49-F238E27FC236}">
                  <a16:creationId xmlns:a16="http://schemas.microsoft.com/office/drawing/2014/main" id="{6EC0F690-AF09-0119-C056-DAAF20A3E0D2}"/>
                </a:ext>
              </a:extLst>
            </p:cNvPr>
            <p:cNvSpPr/>
            <p:nvPr/>
          </p:nvSpPr>
          <p:spPr>
            <a:xfrm>
              <a:off x="3333132" y="2112720"/>
              <a:ext cx="228569" cy="484236"/>
            </a:xfrm>
            <a:prstGeom prst="rect">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507" name="rc8">
              <a:extLst>
                <a:ext uri="{FF2B5EF4-FFF2-40B4-BE49-F238E27FC236}">
                  <a16:creationId xmlns:a16="http://schemas.microsoft.com/office/drawing/2014/main" id="{60099D94-0F58-CD94-7ACC-9E74AAFD5734}"/>
                </a:ext>
              </a:extLst>
            </p:cNvPr>
            <p:cNvSpPr/>
            <p:nvPr/>
          </p:nvSpPr>
          <p:spPr>
            <a:xfrm>
              <a:off x="2875994" y="1547778"/>
              <a:ext cx="228569" cy="1049177"/>
            </a:xfrm>
            <a:prstGeom prst="rect">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508" name="rc9">
              <a:extLst>
                <a:ext uri="{FF2B5EF4-FFF2-40B4-BE49-F238E27FC236}">
                  <a16:creationId xmlns:a16="http://schemas.microsoft.com/office/drawing/2014/main" id="{6D0C6697-FC1F-B60C-C5F1-D017F1FF7F5F}"/>
                </a:ext>
              </a:extLst>
            </p:cNvPr>
            <p:cNvSpPr/>
            <p:nvPr/>
          </p:nvSpPr>
          <p:spPr>
            <a:xfrm>
              <a:off x="3637892" y="2435544"/>
              <a:ext cx="228569" cy="161411"/>
            </a:xfrm>
            <a:prstGeom prst="rect">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509" name="tx10">
              <a:extLst>
                <a:ext uri="{FF2B5EF4-FFF2-40B4-BE49-F238E27FC236}">
                  <a16:creationId xmlns:a16="http://schemas.microsoft.com/office/drawing/2014/main" id="{4C685CA4-1CAF-C9C4-87D2-4D01BC00BF9C}"/>
                </a:ext>
              </a:extLst>
            </p:cNvPr>
            <p:cNvSpPr/>
            <p:nvPr/>
          </p:nvSpPr>
          <p:spPr>
            <a:xfrm>
              <a:off x="2647336" y="1240208"/>
              <a:ext cx="69678" cy="32994"/>
            </a:xfrm>
            <a:prstGeom prst="rect">
              <a:avLst/>
            </a:prstGeom>
            <a:noFill/>
          </p:spPr>
          <p:txBody>
            <a:bodyPr wrap="none" lIns="0" tIns="0" rIns="0" bIns="0" anchor="ctr" anchorCtr="1"/>
            <a:lstStyle/>
            <a:p>
              <a:pPr marL="0" marR="0" indent="0" algn="l">
                <a:lnSpc>
                  <a:spcPts val="1103"/>
                </a:lnSpc>
                <a:spcBef>
                  <a:spcPts val="0"/>
                </a:spcBef>
                <a:spcAft>
                  <a:spcPts val="0"/>
                </a:spcAft>
              </a:pPr>
              <a:r>
                <a:rPr sz="700">
                  <a:latin typeface="Arial" panose="020B0604020202020204" pitchFamily="34" charset="0"/>
                  <a:cs typeface="Arial" panose="020B0604020202020204" pitchFamily="34" charset="0"/>
                </a:rPr>
                <a:t>31</a:t>
              </a:r>
            </a:p>
          </p:txBody>
        </p:sp>
        <p:sp>
          <p:nvSpPr>
            <p:cNvPr id="510" name="tx11">
              <a:extLst>
                <a:ext uri="{FF2B5EF4-FFF2-40B4-BE49-F238E27FC236}">
                  <a16:creationId xmlns:a16="http://schemas.microsoft.com/office/drawing/2014/main" id="{791C7DA4-B3BF-B731-6510-D6B0802E1DA0}"/>
                </a:ext>
              </a:extLst>
            </p:cNvPr>
            <p:cNvSpPr/>
            <p:nvPr/>
          </p:nvSpPr>
          <p:spPr>
            <a:xfrm>
              <a:off x="3409233" y="2007488"/>
              <a:ext cx="69678" cy="32422"/>
            </a:xfrm>
            <a:prstGeom prst="rect">
              <a:avLst/>
            </a:prstGeom>
            <a:noFill/>
          </p:spPr>
          <p:txBody>
            <a:bodyPr wrap="none" lIns="0" tIns="0" rIns="0" bIns="0" anchor="ctr" anchorCtr="1"/>
            <a:lstStyle/>
            <a:p>
              <a:pPr marL="0" marR="0" indent="0" algn="l">
                <a:lnSpc>
                  <a:spcPts val="1103"/>
                </a:lnSpc>
                <a:spcBef>
                  <a:spcPts val="0"/>
                </a:spcBef>
                <a:spcAft>
                  <a:spcPts val="0"/>
                </a:spcAft>
              </a:pPr>
              <a:r>
                <a:rPr sz="700" dirty="0">
                  <a:latin typeface="Arial" panose="020B0604020202020204" pitchFamily="34" charset="0"/>
                  <a:cs typeface="Arial" panose="020B0604020202020204" pitchFamily="34" charset="0"/>
                </a:rPr>
                <a:t>12</a:t>
              </a:r>
            </a:p>
          </p:txBody>
        </p:sp>
        <p:sp>
          <p:nvSpPr>
            <p:cNvPr id="511" name="tx12">
              <a:extLst>
                <a:ext uri="{FF2B5EF4-FFF2-40B4-BE49-F238E27FC236}">
                  <a16:creationId xmlns:a16="http://schemas.microsoft.com/office/drawing/2014/main" id="{C79EB235-7EFF-2626-CE73-A6D6E29777A1}"/>
                </a:ext>
              </a:extLst>
            </p:cNvPr>
            <p:cNvSpPr/>
            <p:nvPr/>
          </p:nvSpPr>
          <p:spPr>
            <a:xfrm>
              <a:off x="2952095" y="1441995"/>
              <a:ext cx="69678" cy="32972"/>
            </a:xfrm>
            <a:prstGeom prst="rect">
              <a:avLst/>
            </a:prstGeom>
            <a:noFill/>
          </p:spPr>
          <p:txBody>
            <a:bodyPr wrap="none" lIns="0" tIns="0" rIns="0" bIns="0" anchor="ctr" anchorCtr="1"/>
            <a:lstStyle/>
            <a:p>
              <a:pPr marL="0" marR="0" indent="0" algn="l">
                <a:lnSpc>
                  <a:spcPts val="1103"/>
                </a:lnSpc>
                <a:spcBef>
                  <a:spcPts val="0"/>
                </a:spcBef>
                <a:spcAft>
                  <a:spcPts val="0"/>
                </a:spcAft>
              </a:pPr>
              <a:r>
                <a:rPr sz="700">
                  <a:latin typeface="Arial" panose="020B0604020202020204" pitchFamily="34" charset="0"/>
                  <a:cs typeface="Arial" panose="020B0604020202020204" pitchFamily="34" charset="0"/>
                </a:rPr>
                <a:t>26</a:t>
              </a:r>
            </a:p>
          </p:txBody>
        </p:sp>
        <p:sp>
          <p:nvSpPr>
            <p:cNvPr id="512" name="tx13">
              <a:extLst>
                <a:ext uri="{FF2B5EF4-FFF2-40B4-BE49-F238E27FC236}">
                  <a16:creationId xmlns:a16="http://schemas.microsoft.com/office/drawing/2014/main" id="{190F340E-E76E-9884-1B27-3595C595FF34}"/>
                </a:ext>
              </a:extLst>
            </p:cNvPr>
            <p:cNvSpPr/>
            <p:nvPr/>
          </p:nvSpPr>
          <p:spPr>
            <a:xfrm>
              <a:off x="3731412" y="2330444"/>
              <a:ext cx="34839" cy="32290"/>
            </a:xfrm>
            <a:prstGeom prst="rect">
              <a:avLst/>
            </a:prstGeom>
            <a:noFill/>
          </p:spPr>
          <p:txBody>
            <a:bodyPr wrap="none" lIns="0" tIns="0" rIns="0" bIns="0" anchor="ctr" anchorCtr="1"/>
            <a:lstStyle/>
            <a:p>
              <a:pPr marL="0" marR="0" indent="0" algn="l">
                <a:lnSpc>
                  <a:spcPts val="1103"/>
                </a:lnSpc>
                <a:spcBef>
                  <a:spcPts val="0"/>
                </a:spcBef>
                <a:spcAft>
                  <a:spcPts val="0"/>
                </a:spcAft>
              </a:pPr>
              <a:r>
                <a:rPr sz="700" dirty="0">
                  <a:latin typeface="Arial" panose="020B0604020202020204" pitchFamily="34" charset="0"/>
                  <a:cs typeface="Arial" panose="020B0604020202020204" pitchFamily="34" charset="0"/>
                </a:rPr>
                <a:t>4</a:t>
              </a:r>
            </a:p>
          </p:txBody>
        </p:sp>
        <p:sp>
          <p:nvSpPr>
            <p:cNvPr id="513" name="pl14">
              <a:extLst>
                <a:ext uri="{FF2B5EF4-FFF2-40B4-BE49-F238E27FC236}">
                  <a16:creationId xmlns:a16="http://schemas.microsoft.com/office/drawing/2014/main" id="{CF05BF7A-29F2-9B13-2992-85FF71092E25}"/>
                </a:ext>
              </a:extLst>
            </p:cNvPr>
            <p:cNvSpPr/>
            <p:nvPr/>
          </p:nvSpPr>
          <p:spPr>
            <a:xfrm>
              <a:off x="2380760" y="982837"/>
              <a:ext cx="0" cy="1614119"/>
            </a:xfrm>
            <a:custGeom>
              <a:avLst/>
              <a:gdLst/>
              <a:ahLst/>
              <a:cxnLst/>
              <a:rect l="0" t="0" r="0" b="0"/>
              <a:pathLst>
                <a:path h="5016877">
                  <a:moveTo>
                    <a:pt x="0" y="5016877"/>
                  </a:moveTo>
                  <a:lnTo>
                    <a:pt x="0"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14" name="tx15">
              <a:extLst>
                <a:ext uri="{FF2B5EF4-FFF2-40B4-BE49-F238E27FC236}">
                  <a16:creationId xmlns:a16="http://schemas.microsoft.com/office/drawing/2014/main" id="{F02F2724-00F0-0935-E8C0-2EEBF3A2F2A3}"/>
                </a:ext>
              </a:extLst>
            </p:cNvPr>
            <p:cNvSpPr/>
            <p:nvPr/>
          </p:nvSpPr>
          <p:spPr>
            <a:xfrm>
              <a:off x="2289448" y="2583542"/>
              <a:ext cx="27771" cy="26284"/>
            </a:xfrm>
            <a:prstGeom prst="rect">
              <a:avLst/>
            </a:prstGeom>
            <a:noFill/>
          </p:spPr>
          <p:txBody>
            <a:bodyPr wrap="none" lIns="0" tIns="0" rIns="0" bIns="0" anchor="ctr" anchorCtr="1"/>
            <a:lstStyle/>
            <a:p>
              <a:pPr marL="0" marR="0" indent="0" algn="l">
                <a:lnSpc>
                  <a:spcPts val="880"/>
                </a:lnSpc>
                <a:spcBef>
                  <a:spcPts val="0"/>
                </a:spcBef>
                <a:spcAft>
                  <a:spcPts val="0"/>
                </a:spcAft>
              </a:pPr>
              <a:r>
                <a:rPr sz="700">
                  <a:latin typeface="Arial" panose="020B0604020202020204" pitchFamily="34" charset="0"/>
                  <a:cs typeface="Arial" panose="020B0604020202020204" pitchFamily="34" charset="0"/>
                </a:rPr>
                <a:t>0</a:t>
              </a:r>
            </a:p>
          </p:txBody>
        </p:sp>
        <p:sp>
          <p:nvSpPr>
            <p:cNvPr id="515" name="tx16">
              <a:extLst>
                <a:ext uri="{FF2B5EF4-FFF2-40B4-BE49-F238E27FC236}">
                  <a16:creationId xmlns:a16="http://schemas.microsoft.com/office/drawing/2014/main" id="{F6C74C5A-5299-732E-A38E-A7FE113E19FE}"/>
                </a:ext>
              </a:extLst>
            </p:cNvPr>
            <p:cNvSpPr/>
            <p:nvPr/>
          </p:nvSpPr>
          <p:spPr>
            <a:xfrm>
              <a:off x="2261675" y="1776482"/>
              <a:ext cx="55542" cy="26284"/>
            </a:xfrm>
            <a:prstGeom prst="rect">
              <a:avLst/>
            </a:prstGeom>
            <a:noFill/>
          </p:spPr>
          <p:txBody>
            <a:bodyPr wrap="none" lIns="0" tIns="0" rIns="0" bIns="0" anchor="ctr" anchorCtr="1"/>
            <a:lstStyle/>
            <a:p>
              <a:pPr marL="0" marR="0" indent="0" algn="l">
                <a:lnSpc>
                  <a:spcPts val="880"/>
                </a:lnSpc>
                <a:spcBef>
                  <a:spcPts val="0"/>
                </a:spcBef>
                <a:spcAft>
                  <a:spcPts val="0"/>
                </a:spcAft>
              </a:pPr>
              <a:r>
                <a:rPr sz="700" dirty="0">
                  <a:latin typeface="Arial" panose="020B0604020202020204" pitchFamily="34" charset="0"/>
                  <a:cs typeface="Arial" panose="020B0604020202020204" pitchFamily="34" charset="0"/>
                </a:rPr>
                <a:t>20</a:t>
              </a:r>
            </a:p>
          </p:txBody>
        </p:sp>
        <p:sp>
          <p:nvSpPr>
            <p:cNvPr id="516" name="tx17">
              <a:extLst>
                <a:ext uri="{FF2B5EF4-FFF2-40B4-BE49-F238E27FC236}">
                  <a16:creationId xmlns:a16="http://schemas.microsoft.com/office/drawing/2014/main" id="{677C198F-5735-4CA4-4216-2B6F06E38951}"/>
                </a:ext>
              </a:extLst>
            </p:cNvPr>
            <p:cNvSpPr/>
            <p:nvPr/>
          </p:nvSpPr>
          <p:spPr>
            <a:xfrm>
              <a:off x="2261675" y="969423"/>
              <a:ext cx="55542" cy="26284"/>
            </a:xfrm>
            <a:prstGeom prst="rect">
              <a:avLst/>
            </a:prstGeom>
            <a:noFill/>
          </p:spPr>
          <p:txBody>
            <a:bodyPr wrap="none" lIns="0" tIns="0" rIns="0" bIns="0" anchor="ctr" anchorCtr="1"/>
            <a:lstStyle/>
            <a:p>
              <a:pPr marL="0" marR="0" indent="0" algn="l">
                <a:lnSpc>
                  <a:spcPts val="880"/>
                </a:lnSpc>
                <a:spcBef>
                  <a:spcPts val="0"/>
                </a:spcBef>
                <a:spcAft>
                  <a:spcPts val="0"/>
                </a:spcAft>
              </a:pPr>
              <a:r>
                <a:rPr sz="700" dirty="0">
                  <a:latin typeface="Arial" panose="020B0604020202020204" pitchFamily="34" charset="0"/>
                  <a:cs typeface="Arial" panose="020B0604020202020204" pitchFamily="34" charset="0"/>
                </a:rPr>
                <a:t>40</a:t>
              </a:r>
            </a:p>
          </p:txBody>
        </p:sp>
        <p:sp>
          <p:nvSpPr>
            <p:cNvPr id="517" name="pl18">
              <a:extLst>
                <a:ext uri="{FF2B5EF4-FFF2-40B4-BE49-F238E27FC236}">
                  <a16:creationId xmlns:a16="http://schemas.microsoft.com/office/drawing/2014/main" id="{050FE82C-C90E-1B85-17D8-18C20F3F903F}"/>
                </a:ext>
              </a:extLst>
            </p:cNvPr>
            <p:cNvSpPr/>
            <p:nvPr/>
          </p:nvSpPr>
          <p:spPr>
            <a:xfrm>
              <a:off x="2358865" y="2596956"/>
              <a:ext cx="21600" cy="0"/>
            </a:xfrm>
            <a:custGeom>
              <a:avLst/>
              <a:gdLst/>
              <a:ahLst/>
              <a:cxnLst/>
              <a:rect l="0" t="0" r="0" b="0"/>
              <a:pathLst>
                <a:path w="34794">
                  <a:moveTo>
                    <a:pt x="0" y="0"/>
                  </a:moveTo>
                  <a:lnTo>
                    <a:pt x="34794"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18" name="pl19">
              <a:extLst>
                <a:ext uri="{FF2B5EF4-FFF2-40B4-BE49-F238E27FC236}">
                  <a16:creationId xmlns:a16="http://schemas.microsoft.com/office/drawing/2014/main" id="{2C1219FA-D202-B381-1285-59A9393E3F25}"/>
                </a:ext>
              </a:extLst>
            </p:cNvPr>
            <p:cNvSpPr/>
            <p:nvPr/>
          </p:nvSpPr>
          <p:spPr>
            <a:xfrm>
              <a:off x="2358865" y="1789896"/>
              <a:ext cx="21600" cy="0"/>
            </a:xfrm>
            <a:custGeom>
              <a:avLst/>
              <a:gdLst/>
              <a:ahLst/>
              <a:cxnLst/>
              <a:rect l="0" t="0" r="0" b="0"/>
              <a:pathLst>
                <a:path w="34794">
                  <a:moveTo>
                    <a:pt x="0" y="0"/>
                  </a:moveTo>
                  <a:lnTo>
                    <a:pt x="34794"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19" name="pl20">
              <a:extLst>
                <a:ext uri="{FF2B5EF4-FFF2-40B4-BE49-F238E27FC236}">
                  <a16:creationId xmlns:a16="http://schemas.microsoft.com/office/drawing/2014/main" id="{A5C1C6DC-BDD4-D1EB-54B6-95240234E7BE}"/>
                </a:ext>
              </a:extLst>
            </p:cNvPr>
            <p:cNvSpPr/>
            <p:nvPr/>
          </p:nvSpPr>
          <p:spPr>
            <a:xfrm>
              <a:off x="2358865" y="982837"/>
              <a:ext cx="21600" cy="0"/>
            </a:xfrm>
            <a:custGeom>
              <a:avLst/>
              <a:gdLst/>
              <a:ahLst/>
              <a:cxnLst/>
              <a:rect l="0" t="0" r="0" b="0"/>
              <a:pathLst>
                <a:path w="34794">
                  <a:moveTo>
                    <a:pt x="0" y="0"/>
                  </a:moveTo>
                  <a:lnTo>
                    <a:pt x="34794"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20" name="pl21">
              <a:extLst>
                <a:ext uri="{FF2B5EF4-FFF2-40B4-BE49-F238E27FC236}">
                  <a16:creationId xmlns:a16="http://schemas.microsoft.com/office/drawing/2014/main" id="{B5717901-2450-71ED-7F69-AB5A8CC54383}"/>
                </a:ext>
              </a:extLst>
            </p:cNvPr>
            <p:cNvSpPr/>
            <p:nvPr/>
          </p:nvSpPr>
          <p:spPr>
            <a:xfrm>
              <a:off x="2380760" y="2596956"/>
              <a:ext cx="1676175" cy="0"/>
            </a:xfrm>
            <a:custGeom>
              <a:avLst/>
              <a:gdLst/>
              <a:ahLst/>
              <a:cxnLst/>
              <a:rect l="0" t="0" r="0" b="0"/>
              <a:pathLst>
                <a:path w="3751522">
                  <a:moveTo>
                    <a:pt x="0" y="0"/>
                  </a:moveTo>
                  <a:lnTo>
                    <a:pt x="3751522"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21" name="pl22">
              <a:extLst>
                <a:ext uri="{FF2B5EF4-FFF2-40B4-BE49-F238E27FC236}">
                  <a16:creationId xmlns:a16="http://schemas.microsoft.com/office/drawing/2014/main" id="{F98EAEB3-ADBF-C2FA-DB05-FC7A14782960}"/>
                </a:ext>
              </a:extLst>
            </p:cNvPr>
            <p:cNvSpPr/>
            <p:nvPr/>
          </p:nvSpPr>
          <p:spPr>
            <a:xfrm>
              <a:off x="2837900" y="2596955"/>
              <a:ext cx="0" cy="21600"/>
            </a:xfrm>
            <a:custGeom>
              <a:avLst/>
              <a:gdLst/>
              <a:ahLst/>
              <a:cxnLst/>
              <a:rect l="0" t="0" r="0" b="0"/>
              <a:pathLst>
                <a:path h="34794">
                  <a:moveTo>
                    <a:pt x="0" y="34794"/>
                  </a:moveTo>
                  <a:lnTo>
                    <a:pt x="0"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22" name="pl23">
              <a:extLst>
                <a:ext uri="{FF2B5EF4-FFF2-40B4-BE49-F238E27FC236}">
                  <a16:creationId xmlns:a16="http://schemas.microsoft.com/office/drawing/2014/main" id="{FCFEB5FC-9BB0-5D78-16DC-091BE5F171C8}"/>
                </a:ext>
              </a:extLst>
            </p:cNvPr>
            <p:cNvSpPr/>
            <p:nvPr/>
          </p:nvSpPr>
          <p:spPr>
            <a:xfrm>
              <a:off x="3599797" y="2596955"/>
              <a:ext cx="0" cy="21600"/>
            </a:xfrm>
            <a:custGeom>
              <a:avLst/>
              <a:gdLst/>
              <a:ahLst/>
              <a:cxnLst/>
              <a:rect l="0" t="0" r="0" b="0"/>
              <a:pathLst>
                <a:path h="34794">
                  <a:moveTo>
                    <a:pt x="0" y="34794"/>
                  </a:moveTo>
                  <a:lnTo>
                    <a:pt x="0"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523" name="tx24">
              <a:extLst>
                <a:ext uri="{FF2B5EF4-FFF2-40B4-BE49-F238E27FC236}">
                  <a16:creationId xmlns:a16="http://schemas.microsoft.com/office/drawing/2014/main" id="{4A15E0FE-A027-F9B0-A009-51A3D5FE77A5}"/>
                </a:ext>
              </a:extLst>
            </p:cNvPr>
            <p:cNvSpPr/>
            <p:nvPr/>
          </p:nvSpPr>
          <p:spPr>
            <a:xfrm>
              <a:off x="2754647" y="2655397"/>
              <a:ext cx="166504" cy="26160"/>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altLang="zh-CN" sz="700" dirty="0">
                  <a:latin typeface="Arial" panose="020B0604020202020204" pitchFamily="34" charset="0"/>
                  <a:cs typeface="Arial" panose="020B0604020202020204" pitchFamily="34" charset="0"/>
                </a:rPr>
                <a:t>F</a:t>
              </a:r>
              <a:r>
                <a:rPr sz="700" dirty="0">
                  <a:latin typeface="Arial" panose="020B0604020202020204" pitchFamily="34" charset="0"/>
                  <a:cs typeface="Arial" panose="020B0604020202020204" pitchFamily="34" charset="0"/>
                </a:rPr>
                <a:t>emale</a:t>
              </a:r>
            </a:p>
          </p:txBody>
        </p:sp>
        <p:sp>
          <p:nvSpPr>
            <p:cNvPr id="524" name="tx25">
              <a:extLst>
                <a:ext uri="{FF2B5EF4-FFF2-40B4-BE49-F238E27FC236}">
                  <a16:creationId xmlns:a16="http://schemas.microsoft.com/office/drawing/2014/main" id="{08875991-FC76-38CA-BF1A-7CD9955226A5}"/>
                </a:ext>
              </a:extLst>
            </p:cNvPr>
            <p:cNvSpPr/>
            <p:nvPr/>
          </p:nvSpPr>
          <p:spPr>
            <a:xfrm>
              <a:off x="3545681" y="2655397"/>
              <a:ext cx="108232" cy="26160"/>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sz="700" dirty="0">
                  <a:latin typeface="Arial" panose="020B0604020202020204" pitchFamily="34" charset="0"/>
                  <a:cs typeface="Arial" panose="020B0604020202020204" pitchFamily="34" charset="0"/>
                </a:rPr>
                <a:t>M</a:t>
              </a:r>
              <a:r>
                <a:rPr sz="700" dirty="0">
                  <a:latin typeface="Arial" panose="020B0604020202020204" pitchFamily="34" charset="0"/>
                  <a:cs typeface="Arial" panose="020B0604020202020204" pitchFamily="34" charset="0"/>
                </a:rPr>
                <a:t>ale</a:t>
              </a:r>
            </a:p>
          </p:txBody>
        </p:sp>
        <p:sp>
          <p:nvSpPr>
            <p:cNvPr id="525" name="tx27">
              <a:extLst>
                <a:ext uri="{FF2B5EF4-FFF2-40B4-BE49-F238E27FC236}">
                  <a16:creationId xmlns:a16="http://schemas.microsoft.com/office/drawing/2014/main" id="{52ECAC7F-0AD6-58ED-0B38-52DCDAFBDB41}"/>
                </a:ext>
              </a:extLst>
            </p:cNvPr>
            <p:cNvSpPr/>
            <p:nvPr/>
          </p:nvSpPr>
          <p:spPr>
            <a:xfrm rot="16200000">
              <a:off x="2128398" y="1761354"/>
              <a:ext cx="92417" cy="57084"/>
            </a:xfrm>
            <a:prstGeom prst="rect">
              <a:avLst/>
            </a:prstGeom>
            <a:noFill/>
          </p:spPr>
          <p:txBody>
            <a:bodyPr wrap="none" lIns="0" tIns="0" rIns="0" bIns="0" anchor="ctr" anchorCtr="1"/>
            <a:lstStyle/>
            <a:p>
              <a:pPr marL="0" marR="0" indent="0" algn="l">
                <a:lnSpc>
                  <a:spcPts val="1100"/>
                </a:lnSpc>
                <a:spcBef>
                  <a:spcPts val="0"/>
                </a:spcBef>
                <a:spcAft>
                  <a:spcPts val="0"/>
                </a:spcAft>
              </a:pPr>
              <a:r>
                <a:rPr lang="en-US" altLang="zh-CN" sz="700" dirty="0">
                  <a:latin typeface="Arial" panose="020B0604020202020204" pitchFamily="34" charset="0"/>
                  <a:cs typeface="Arial" panose="020B0604020202020204" pitchFamily="34" charset="0"/>
                </a:rPr>
                <a:t>Number of samples</a:t>
              </a:r>
              <a:endParaRPr sz="700" dirty="0">
                <a:latin typeface="Arial" panose="020B0604020202020204" pitchFamily="34" charset="0"/>
                <a:cs typeface="Arial" panose="020B0604020202020204" pitchFamily="34" charset="0"/>
              </a:endParaRPr>
            </a:p>
          </p:txBody>
        </p:sp>
        <p:grpSp>
          <p:nvGrpSpPr>
            <p:cNvPr id="115" name="组合 114">
              <a:extLst>
                <a:ext uri="{FF2B5EF4-FFF2-40B4-BE49-F238E27FC236}">
                  <a16:creationId xmlns:a16="http://schemas.microsoft.com/office/drawing/2014/main" id="{DFC854A5-2D75-4158-55F6-C74967646209}"/>
                </a:ext>
              </a:extLst>
            </p:cNvPr>
            <p:cNvGrpSpPr/>
            <p:nvPr/>
          </p:nvGrpSpPr>
          <p:grpSpPr>
            <a:xfrm>
              <a:off x="2624424" y="1006167"/>
              <a:ext cx="1222879" cy="200055"/>
              <a:chOff x="2624424" y="465509"/>
              <a:chExt cx="1222879" cy="200055"/>
            </a:xfrm>
          </p:grpSpPr>
          <p:sp>
            <p:nvSpPr>
              <p:cNvPr id="502" name="文本框 501">
                <a:extLst>
                  <a:ext uri="{FF2B5EF4-FFF2-40B4-BE49-F238E27FC236}">
                    <a16:creationId xmlns:a16="http://schemas.microsoft.com/office/drawing/2014/main" id="{9A829810-8B87-80B4-4928-0117A7670FCB}"/>
                  </a:ext>
                </a:extLst>
              </p:cNvPr>
              <p:cNvSpPr txBox="1"/>
              <p:nvPr/>
            </p:nvSpPr>
            <p:spPr>
              <a:xfrm>
                <a:off x="2741176" y="465509"/>
                <a:ext cx="989373" cy="200055"/>
              </a:xfrm>
              <a:prstGeom prst="rect">
                <a:avLst/>
              </a:prstGeom>
              <a:noFill/>
            </p:spPr>
            <p:txBody>
              <a:bodyPr wrap="none" rtlCol="0">
                <a:spAutoFit/>
              </a:bodyPr>
              <a:lstStyle/>
              <a:p>
                <a:r>
                  <a:rPr lang="en-US" altLang="zh-CN" sz="700" dirty="0">
                    <a:latin typeface="Arial" panose="020B0604020202020204" pitchFamily="34" charset="0"/>
                    <a:cs typeface="Arial" panose="020B0604020202020204" pitchFamily="34" charset="0"/>
                  </a:rPr>
                  <a:t>Chi-squared test,</a:t>
                </a:r>
                <a:r>
                  <a:rPr lang="zh-CN" altLang="en-US" sz="700"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ns</a:t>
                </a:r>
                <a:endParaRPr lang="zh-CN" altLang="en-US" sz="700" dirty="0">
                  <a:latin typeface="Arial" panose="020B0604020202020204" pitchFamily="34" charset="0"/>
                  <a:cs typeface="Arial" panose="020B0604020202020204" pitchFamily="34" charset="0"/>
                </a:endParaRPr>
              </a:p>
            </p:txBody>
          </p:sp>
          <p:cxnSp>
            <p:nvCxnSpPr>
              <p:cNvPr id="503" name="直接连接符 502">
                <a:extLst>
                  <a:ext uri="{FF2B5EF4-FFF2-40B4-BE49-F238E27FC236}">
                    <a16:creationId xmlns:a16="http://schemas.microsoft.com/office/drawing/2014/main" id="{3AF37EA8-CBE5-FD24-6C96-67C7F3369B94}"/>
                  </a:ext>
                </a:extLst>
              </p:cNvPr>
              <p:cNvCxnSpPr>
                <a:cxnSpLocks/>
              </p:cNvCxnSpPr>
              <p:nvPr/>
            </p:nvCxnSpPr>
            <p:spPr>
              <a:xfrm>
                <a:off x="2624424" y="626515"/>
                <a:ext cx="122287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16" name="组合 115">
              <a:extLst>
                <a:ext uri="{FF2B5EF4-FFF2-40B4-BE49-F238E27FC236}">
                  <a16:creationId xmlns:a16="http://schemas.microsoft.com/office/drawing/2014/main" id="{98FC70D8-4DA5-F088-4FCC-E60FC5B94ABB}"/>
                </a:ext>
              </a:extLst>
            </p:cNvPr>
            <p:cNvGrpSpPr/>
            <p:nvPr/>
          </p:nvGrpSpPr>
          <p:grpSpPr>
            <a:xfrm>
              <a:off x="3136584" y="1265421"/>
              <a:ext cx="1295384" cy="266094"/>
              <a:chOff x="4088099" y="4206123"/>
              <a:chExt cx="1049210" cy="266094"/>
            </a:xfrm>
          </p:grpSpPr>
          <p:sp>
            <p:nvSpPr>
              <p:cNvPr id="117" name="rc28">
                <a:extLst>
                  <a:ext uri="{FF2B5EF4-FFF2-40B4-BE49-F238E27FC236}">
                    <a16:creationId xmlns:a16="http://schemas.microsoft.com/office/drawing/2014/main" id="{B7C0B5E9-7065-ED77-EDD7-481E462A32D9}"/>
                  </a:ext>
                </a:extLst>
              </p:cNvPr>
              <p:cNvSpPr/>
              <p:nvPr/>
            </p:nvSpPr>
            <p:spPr>
              <a:xfrm>
                <a:off x="4104665" y="4206123"/>
                <a:ext cx="1032644" cy="186606"/>
              </a:xfrm>
              <a:prstGeom prst="rect">
                <a:avLst/>
              </a:prstGeom>
              <a:solidFill>
                <a:srgbClr val="FFFFFF">
                  <a:alpha val="100000"/>
                </a:srgbClr>
              </a:solidFill>
            </p:spPr>
            <p:txBody>
              <a:bodyPr/>
              <a:lstStyle/>
              <a:p>
                <a:r>
                  <a:rPr lang="en-US" sz="700" dirty="0">
                    <a:latin typeface="Arial" panose="020B0604020202020204" pitchFamily="34" charset="0"/>
                    <a:cs typeface="Arial" panose="020B0604020202020204" pitchFamily="34" charset="0"/>
                  </a:rPr>
                  <a:t>No response (n=43)</a:t>
                </a:r>
                <a:endParaRPr sz="700" dirty="0">
                  <a:latin typeface="Arial" panose="020B0604020202020204" pitchFamily="34" charset="0"/>
                  <a:cs typeface="Arial" panose="020B0604020202020204" pitchFamily="34" charset="0"/>
                </a:endParaRPr>
              </a:p>
            </p:txBody>
          </p:sp>
          <p:sp>
            <p:nvSpPr>
              <p:cNvPr id="118" name="rc30">
                <a:extLst>
                  <a:ext uri="{FF2B5EF4-FFF2-40B4-BE49-F238E27FC236}">
                    <a16:creationId xmlns:a16="http://schemas.microsoft.com/office/drawing/2014/main" id="{475871C0-840D-DFD0-D465-EF6A3588EA50}"/>
                  </a:ext>
                </a:extLst>
              </p:cNvPr>
              <p:cNvSpPr/>
              <p:nvPr/>
            </p:nvSpPr>
            <p:spPr>
              <a:xfrm>
                <a:off x="4088099" y="4272068"/>
                <a:ext cx="67416" cy="67416"/>
              </a:xfrm>
              <a:prstGeom prst="rect">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119" name="rc31">
                <a:extLst>
                  <a:ext uri="{FF2B5EF4-FFF2-40B4-BE49-F238E27FC236}">
                    <a16:creationId xmlns:a16="http://schemas.microsoft.com/office/drawing/2014/main" id="{59E15C82-B75A-84BA-CD1B-45ADB7FE9902}"/>
                  </a:ext>
                </a:extLst>
              </p:cNvPr>
              <p:cNvSpPr/>
              <p:nvPr/>
            </p:nvSpPr>
            <p:spPr>
              <a:xfrm>
                <a:off x="4088099" y="4355636"/>
                <a:ext cx="67416" cy="67416"/>
              </a:xfrm>
              <a:prstGeom prst="rect">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120" name="rc28">
                <a:extLst>
                  <a:ext uri="{FF2B5EF4-FFF2-40B4-BE49-F238E27FC236}">
                    <a16:creationId xmlns:a16="http://schemas.microsoft.com/office/drawing/2014/main" id="{787F748D-C75C-5185-618F-66E6C3435956}"/>
                  </a:ext>
                </a:extLst>
              </p:cNvPr>
              <p:cNvSpPr/>
              <p:nvPr/>
            </p:nvSpPr>
            <p:spPr>
              <a:xfrm>
                <a:off x="4104667" y="4285611"/>
                <a:ext cx="784785" cy="186606"/>
              </a:xfrm>
              <a:prstGeom prst="rect">
                <a:avLst/>
              </a:prstGeom>
              <a:noFill/>
            </p:spPr>
            <p:txBody>
              <a:bodyPr/>
              <a:lstStyle/>
              <a:p>
                <a:r>
                  <a:rPr lang="en-US" sz="700" dirty="0">
                    <a:latin typeface="Arial" panose="020B0604020202020204" pitchFamily="34" charset="0"/>
                    <a:cs typeface="Arial" panose="020B0604020202020204" pitchFamily="34" charset="0"/>
                  </a:rPr>
                  <a:t>Response (n=30)</a:t>
                </a:r>
              </a:p>
            </p:txBody>
          </p:sp>
        </p:grpSp>
      </p:grpSp>
      <p:sp>
        <p:nvSpPr>
          <p:cNvPr id="2612" name="pt41">
            <a:extLst>
              <a:ext uri="{FF2B5EF4-FFF2-40B4-BE49-F238E27FC236}">
                <a16:creationId xmlns:a16="http://schemas.microsoft.com/office/drawing/2014/main" id="{76A768A6-2453-4D21-45FD-0B77EE931B97}"/>
              </a:ext>
            </a:extLst>
          </p:cNvPr>
          <p:cNvSpPr/>
          <p:nvPr/>
        </p:nvSpPr>
        <p:spPr>
          <a:xfrm>
            <a:off x="6240940" y="3231852"/>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grpSp>
        <p:nvGrpSpPr>
          <p:cNvPr id="121" name="组合 120">
            <a:extLst>
              <a:ext uri="{FF2B5EF4-FFF2-40B4-BE49-F238E27FC236}">
                <a16:creationId xmlns:a16="http://schemas.microsoft.com/office/drawing/2014/main" id="{5FC0C478-C2A5-8809-9395-98F8CEFFEE9F}"/>
              </a:ext>
            </a:extLst>
          </p:cNvPr>
          <p:cNvGrpSpPr/>
          <p:nvPr/>
        </p:nvGrpSpPr>
        <p:grpSpPr>
          <a:xfrm>
            <a:off x="4437006" y="3309740"/>
            <a:ext cx="1848363" cy="1705314"/>
            <a:chOff x="4430699" y="3276415"/>
            <a:chExt cx="1848363" cy="1705314"/>
          </a:xfrm>
        </p:grpSpPr>
        <p:sp>
          <p:nvSpPr>
            <p:cNvPr id="2649" name="pl6">
              <a:extLst>
                <a:ext uri="{FF2B5EF4-FFF2-40B4-BE49-F238E27FC236}">
                  <a16:creationId xmlns:a16="http://schemas.microsoft.com/office/drawing/2014/main" id="{73E4A39A-C511-5288-04EF-D2ABEF111CA3}"/>
                </a:ext>
              </a:extLst>
            </p:cNvPr>
            <p:cNvSpPr/>
            <p:nvPr/>
          </p:nvSpPr>
          <p:spPr>
            <a:xfrm>
              <a:off x="4804036" y="4112641"/>
              <a:ext cx="0" cy="224831"/>
            </a:xfrm>
            <a:custGeom>
              <a:avLst/>
              <a:gdLst/>
              <a:ahLst/>
              <a:cxnLst/>
              <a:rect l="0" t="0" r="0" b="0"/>
              <a:pathLst>
                <a:path h="671848">
                  <a:moveTo>
                    <a:pt x="0" y="671848"/>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50" name="pl7">
              <a:extLst>
                <a:ext uri="{FF2B5EF4-FFF2-40B4-BE49-F238E27FC236}">
                  <a16:creationId xmlns:a16="http://schemas.microsoft.com/office/drawing/2014/main" id="{605214EA-D13F-C5A1-6CF5-CD783E4E266D}"/>
                </a:ext>
              </a:extLst>
            </p:cNvPr>
            <p:cNvSpPr/>
            <p:nvPr/>
          </p:nvSpPr>
          <p:spPr>
            <a:xfrm>
              <a:off x="4804036" y="4562303"/>
              <a:ext cx="0" cy="149887"/>
            </a:xfrm>
            <a:custGeom>
              <a:avLst/>
              <a:gdLst/>
              <a:ahLst/>
              <a:cxnLst/>
              <a:rect l="0" t="0" r="0" b="0"/>
              <a:pathLst>
                <a:path h="447898">
                  <a:moveTo>
                    <a:pt x="0" y="0"/>
                  </a:moveTo>
                  <a:lnTo>
                    <a:pt x="0" y="447898"/>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51" name="pg8">
              <a:extLst>
                <a:ext uri="{FF2B5EF4-FFF2-40B4-BE49-F238E27FC236}">
                  <a16:creationId xmlns:a16="http://schemas.microsoft.com/office/drawing/2014/main" id="{0FF4579A-3B34-43F6-32B9-FB7F452E4A18}"/>
                </a:ext>
              </a:extLst>
            </p:cNvPr>
            <p:cNvSpPr/>
            <p:nvPr/>
          </p:nvSpPr>
          <p:spPr>
            <a:xfrm>
              <a:off x="4755194" y="4337472"/>
              <a:ext cx="97684" cy="224831"/>
            </a:xfrm>
            <a:custGeom>
              <a:avLst/>
              <a:gdLst/>
              <a:ahLst/>
              <a:cxnLst/>
              <a:rect l="0" t="0" r="0" b="0"/>
              <a:pathLst>
                <a:path w="291902" h="671848">
                  <a:moveTo>
                    <a:pt x="0" y="0"/>
                  </a:moveTo>
                  <a:lnTo>
                    <a:pt x="0" y="671848"/>
                  </a:lnTo>
                  <a:lnTo>
                    <a:pt x="291902" y="671848"/>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52" name="pl9">
              <a:extLst>
                <a:ext uri="{FF2B5EF4-FFF2-40B4-BE49-F238E27FC236}">
                  <a16:creationId xmlns:a16="http://schemas.microsoft.com/office/drawing/2014/main" id="{47A3D7B1-4F3B-97F4-6A58-4BBC143D584C}"/>
                </a:ext>
              </a:extLst>
            </p:cNvPr>
            <p:cNvSpPr/>
            <p:nvPr/>
          </p:nvSpPr>
          <p:spPr>
            <a:xfrm>
              <a:off x="4755194" y="4487359"/>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53" name="pl10">
              <a:extLst>
                <a:ext uri="{FF2B5EF4-FFF2-40B4-BE49-F238E27FC236}">
                  <a16:creationId xmlns:a16="http://schemas.microsoft.com/office/drawing/2014/main" id="{4D89F949-5420-E7B7-B409-C4BDE3E3CF45}"/>
                </a:ext>
              </a:extLst>
            </p:cNvPr>
            <p:cNvSpPr/>
            <p:nvPr/>
          </p:nvSpPr>
          <p:spPr>
            <a:xfrm>
              <a:off x="4940794" y="3962754"/>
              <a:ext cx="0" cy="177991"/>
            </a:xfrm>
            <a:custGeom>
              <a:avLst/>
              <a:gdLst/>
              <a:ahLst/>
              <a:cxnLst/>
              <a:rect l="0" t="0" r="0" b="0"/>
              <a:pathLst>
                <a:path h="531879">
                  <a:moveTo>
                    <a:pt x="0" y="531879"/>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54" name="pl11">
              <a:extLst>
                <a:ext uri="{FF2B5EF4-FFF2-40B4-BE49-F238E27FC236}">
                  <a16:creationId xmlns:a16="http://schemas.microsoft.com/office/drawing/2014/main" id="{7EC7DFFB-4503-84A5-04C6-057EC7B35873}"/>
                </a:ext>
              </a:extLst>
            </p:cNvPr>
            <p:cNvSpPr/>
            <p:nvPr/>
          </p:nvSpPr>
          <p:spPr>
            <a:xfrm>
              <a:off x="4940794" y="4337472"/>
              <a:ext cx="0" cy="262303"/>
            </a:xfrm>
            <a:custGeom>
              <a:avLst/>
              <a:gdLst/>
              <a:ahLst/>
              <a:cxnLst/>
              <a:rect l="0" t="0" r="0" b="0"/>
              <a:pathLst>
                <a:path h="783822">
                  <a:moveTo>
                    <a:pt x="0" y="0"/>
                  </a:moveTo>
                  <a:lnTo>
                    <a:pt x="0" y="783822"/>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55" name="pg12">
              <a:extLst>
                <a:ext uri="{FF2B5EF4-FFF2-40B4-BE49-F238E27FC236}">
                  <a16:creationId xmlns:a16="http://schemas.microsoft.com/office/drawing/2014/main" id="{4158F5E9-69DE-78E3-52BA-C9D9966FB455}"/>
                </a:ext>
              </a:extLst>
            </p:cNvPr>
            <p:cNvSpPr/>
            <p:nvPr/>
          </p:nvSpPr>
          <p:spPr>
            <a:xfrm>
              <a:off x="4891952" y="4140745"/>
              <a:ext cx="97684" cy="196727"/>
            </a:xfrm>
            <a:custGeom>
              <a:avLst/>
              <a:gdLst/>
              <a:ahLst/>
              <a:cxnLst/>
              <a:rect l="0" t="0" r="0" b="0"/>
              <a:pathLst>
                <a:path w="291902" h="587867">
                  <a:moveTo>
                    <a:pt x="0" y="0"/>
                  </a:moveTo>
                  <a:lnTo>
                    <a:pt x="0" y="587867"/>
                  </a:lnTo>
                  <a:lnTo>
                    <a:pt x="291902" y="587867"/>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56" name="pl13">
              <a:extLst>
                <a:ext uri="{FF2B5EF4-FFF2-40B4-BE49-F238E27FC236}">
                  <a16:creationId xmlns:a16="http://schemas.microsoft.com/office/drawing/2014/main" id="{ACF93A6C-3173-10CB-08C2-0E05A7DF49D6}"/>
                </a:ext>
              </a:extLst>
            </p:cNvPr>
            <p:cNvSpPr/>
            <p:nvPr/>
          </p:nvSpPr>
          <p:spPr>
            <a:xfrm>
              <a:off x="4891952" y="4225057"/>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57" name="pt14">
              <a:extLst>
                <a:ext uri="{FF2B5EF4-FFF2-40B4-BE49-F238E27FC236}">
                  <a16:creationId xmlns:a16="http://schemas.microsoft.com/office/drawing/2014/main" id="{D306E060-1675-AC4F-BF35-075FD1043E8C}"/>
                </a:ext>
              </a:extLst>
            </p:cNvPr>
            <p:cNvSpPr/>
            <p:nvPr/>
          </p:nvSpPr>
          <p:spPr>
            <a:xfrm>
              <a:off x="5186464" y="4087334"/>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58" name="pl15">
              <a:extLst>
                <a:ext uri="{FF2B5EF4-FFF2-40B4-BE49-F238E27FC236}">
                  <a16:creationId xmlns:a16="http://schemas.microsoft.com/office/drawing/2014/main" id="{7AEB0BB1-E457-7EDD-CDF8-69E929206411}"/>
                </a:ext>
              </a:extLst>
            </p:cNvPr>
            <p:cNvSpPr/>
            <p:nvPr/>
          </p:nvSpPr>
          <p:spPr>
            <a:xfrm>
              <a:off x="5194772" y="4222425"/>
              <a:ext cx="0" cy="164817"/>
            </a:xfrm>
            <a:custGeom>
              <a:avLst/>
              <a:gdLst/>
              <a:ahLst/>
              <a:cxnLst/>
              <a:rect l="0" t="0" r="0" b="0"/>
              <a:pathLst>
                <a:path h="492513">
                  <a:moveTo>
                    <a:pt x="0" y="492513"/>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59" name="pl16">
              <a:extLst>
                <a:ext uri="{FF2B5EF4-FFF2-40B4-BE49-F238E27FC236}">
                  <a16:creationId xmlns:a16="http://schemas.microsoft.com/office/drawing/2014/main" id="{3C37A307-3E95-D60F-6230-C922992D0AC5}"/>
                </a:ext>
              </a:extLst>
            </p:cNvPr>
            <p:cNvSpPr/>
            <p:nvPr/>
          </p:nvSpPr>
          <p:spPr>
            <a:xfrm>
              <a:off x="5194772" y="4514025"/>
              <a:ext cx="0" cy="12678"/>
            </a:xfrm>
            <a:custGeom>
              <a:avLst/>
              <a:gdLst/>
              <a:ahLst/>
              <a:cxnLst/>
              <a:rect l="0" t="0" r="0" b="0"/>
              <a:pathLst>
                <a:path h="37885">
                  <a:moveTo>
                    <a:pt x="0" y="0"/>
                  </a:moveTo>
                  <a:lnTo>
                    <a:pt x="0" y="37885"/>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60" name="pg17">
              <a:extLst>
                <a:ext uri="{FF2B5EF4-FFF2-40B4-BE49-F238E27FC236}">
                  <a16:creationId xmlns:a16="http://schemas.microsoft.com/office/drawing/2014/main" id="{12851E6F-9105-8C42-DFE3-AC228BA54B86}"/>
                </a:ext>
              </a:extLst>
            </p:cNvPr>
            <p:cNvSpPr/>
            <p:nvPr/>
          </p:nvSpPr>
          <p:spPr>
            <a:xfrm>
              <a:off x="5145930" y="4387242"/>
              <a:ext cx="97684" cy="126783"/>
            </a:xfrm>
            <a:custGeom>
              <a:avLst/>
              <a:gdLst/>
              <a:ahLst/>
              <a:cxnLst/>
              <a:rect l="0" t="0" r="0" b="0"/>
              <a:pathLst>
                <a:path w="291902" h="378856">
                  <a:moveTo>
                    <a:pt x="0" y="0"/>
                  </a:moveTo>
                  <a:lnTo>
                    <a:pt x="0" y="378856"/>
                  </a:lnTo>
                  <a:lnTo>
                    <a:pt x="291902" y="378856"/>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61" name="pl18">
              <a:extLst>
                <a:ext uri="{FF2B5EF4-FFF2-40B4-BE49-F238E27FC236}">
                  <a16:creationId xmlns:a16="http://schemas.microsoft.com/office/drawing/2014/main" id="{D3BCD668-C238-7E2E-C923-F356BCF92645}"/>
                </a:ext>
              </a:extLst>
            </p:cNvPr>
            <p:cNvSpPr/>
            <p:nvPr/>
          </p:nvSpPr>
          <p:spPr>
            <a:xfrm>
              <a:off x="5145930" y="4475990"/>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62" name="pl19">
              <a:extLst>
                <a:ext uri="{FF2B5EF4-FFF2-40B4-BE49-F238E27FC236}">
                  <a16:creationId xmlns:a16="http://schemas.microsoft.com/office/drawing/2014/main" id="{2A18A889-D3B1-EFD0-E2D7-69062E38D369}"/>
                </a:ext>
              </a:extLst>
            </p:cNvPr>
            <p:cNvSpPr/>
            <p:nvPr/>
          </p:nvSpPr>
          <p:spPr>
            <a:xfrm>
              <a:off x="5331529" y="3816720"/>
              <a:ext cx="0" cy="266244"/>
            </a:xfrm>
            <a:custGeom>
              <a:avLst/>
              <a:gdLst/>
              <a:ahLst/>
              <a:cxnLst/>
              <a:rect l="0" t="0" r="0" b="0"/>
              <a:pathLst>
                <a:path h="795599">
                  <a:moveTo>
                    <a:pt x="0" y="795599"/>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63" name="pl20">
              <a:extLst>
                <a:ext uri="{FF2B5EF4-FFF2-40B4-BE49-F238E27FC236}">
                  <a16:creationId xmlns:a16="http://schemas.microsoft.com/office/drawing/2014/main" id="{159E6E7A-835B-AB44-46A6-3F83FC3A356C}"/>
                </a:ext>
              </a:extLst>
            </p:cNvPr>
            <p:cNvSpPr/>
            <p:nvPr/>
          </p:nvSpPr>
          <p:spPr>
            <a:xfrm>
              <a:off x="5331529" y="4463312"/>
              <a:ext cx="0" cy="63391"/>
            </a:xfrm>
            <a:custGeom>
              <a:avLst/>
              <a:gdLst/>
              <a:ahLst/>
              <a:cxnLst/>
              <a:rect l="0" t="0" r="0" b="0"/>
              <a:pathLst>
                <a:path h="189428">
                  <a:moveTo>
                    <a:pt x="0" y="0"/>
                  </a:moveTo>
                  <a:lnTo>
                    <a:pt x="0" y="189428"/>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64" name="pg21">
              <a:extLst>
                <a:ext uri="{FF2B5EF4-FFF2-40B4-BE49-F238E27FC236}">
                  <a16:creationId xmlns:a16="http://schemas.microsoft.com/office/drawing/2014/main" id="{630E3F88-158F-3B06-486D-CD2FA2797C3D}"/>
                </a:ext>
              </a:extLst>
            </p:cNvPr>
            <p:cNvSpPr/>
            <p:nvPr/>
          </p:nvSpPr>
          <p:spPr>
            <a:xfrm>
              <a:off x="5282687" y="4082964"/>
              <a:ext cx="97684" cy="380348"/>
            </a:xfrm>
            <a:custGeom>
              <a:avLst/>
              <a:gdLst/>
              <a:ahLst/>
              <a:cxnLst/>
              <a:rect l="0" t="0" r="0" b="0"/>
              <a:pathLst>
                <a:path w="291902" h="1136570">
                  <a:moveTo>
                    <a:pt x="0" y="0"/>
                  </a:moveTo>
                  <a:lnTo>
                    <a:pt x="0" y="1136570"/>
                  </a:lnTo>
                  <a:lnTo>
                    <a:pt x="291902" y="1136570"/>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65" name="pl22">
              <a:extLst>
                <a:ext uri="{FF2B5EF4-FFF2-40B4-BE49-F238E27FC236}">
                  <a16:creationId xmlns:a16="http://schemas.microsoft.com/office/drawing/2014/main" id="{59B7D127-C9DF-46F6-2628-8C56A561103E}"/>
                </a:ext>
              </a:extLst>
            </p:cNvPr>
            <p:cNvSpPr/>
            <p:nvPr/>
          </p:nvSpPr>
          <p:spPr>
            <a:xfrm>
              <a:off x="5282687" y="4387242"/>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66" name="pt23">
              <a:extLst>
                <a:ext uri="{FF2B5EF4-FFF2-40B4-BE49-F238E27FC236}">
                  <a16:creationId xmlns:a16="http://schemas.microsoft.com/office/drawing/2014/main" id="{C1D38896-D6D2-D66E-F882-2FE1624AD8B6}"/>
                </a:ext>
              </a:extLst>
            </p:cNvPr>
            <p:cNvSpPr/>
            <p:nvPr/>
          </p:nvSpPr>
          <p:spPr>
            <a:xfrm>
              <a:off x="5577199" y="4067724"/>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67" name="pt24">
              <a:extLst>
                <a:ext uri="{FF2B5EF4-FFF2-40B4-BE49-F238E27FC236}">
                  <a16:creationId xmlns:a16="http://schemas.microsoft.com/office/drawing/2014/main" id="{AD93FE2E-6320-B7ED-AAA8-D6D7E02E178D}"/>
                </a:ext>
              </a:extLst>
            </p:cNvPr>
            <p:cNvSpPr/>
            <p:nvPr/>
          </p:nvSpPr>
          <p:spPr>
            <a:xfrm>
              <a:off x="5577199" y="4067724"/>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68" name="pt25">
              <a:extLst>
                <a:ext uri="{FF2B5EF4-FFF2-40B4-BE49-F238E27FC236}">
                  <a16:creationId xmlns:a16="http://schemas.microsoft.com/office/drawing/2014/main" id="{50AC3462-B999-DA26-432C-5BCD81A590CE}"/>
                </a:ext>
              </a:extLst>
            </p:cNvPr>
            <p:cNvSpPr/>
            <p:nvPr/>
          </p:nvSpPr>
          <p:spPr>
            <a:xfrm>
              <a:off x="5577199" y="4138006"/>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69" name="pt26">
              <a:extLst>
                <a:ext uri="{FF2B5EF4-FFF2-40B4-BE49-F238E27FC236}">
                  <a16:creationId xmlns:a16="http://schemas.microsoft.com/office/drawing/2014/main" id="{1B1C4E92-EDB3-806B-213B-4A46135DD2E9}"/>
                </a:ext>
              </a:extLst>
            </p:cNvPr>
            <p:cNvSpPr/>
            <p:nvPr/>
          </p:nvSpPr>
          <p:spPr>
            <a:xfrm>
              <a:off x="5577199" y="4208287"/>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70" name="pl27">
              <a:extLst>
                <a:ext uri="{FF2B5EF4-FFF2-40B4-BE49-F238E27FC236}">
                  <a16:creationId xmlns:a16="http://schemas.microsoft.com/office/drawing/2014/main" id="{14EADEE0-8B45-6222-2F8B-2431841DDFA3}"/>
                </a:ext>
              </a:extLst>
            </p:cNvPr>
            <p:cNvSpPr/>
            <p:nvPr/>
          </p:nvSpPr>
          <p:spPr>
            <a:xfrm>
              <a:off x="5585507" y="4286877"/>
              <a:ext cx="0" cy="105423"/>
            </a:xfrm>
            <a:custGeom>
              <a:avLst/>
              <a:gdLst/>
              <a:ahLst/>
              <a:cxnLst/>
              <a:rect l="0" t="0" r="0" b="0"/>
              <a:pathLst>
                <a:path h="315028">
                  <a:moveTo>
                    <a:pt x="0" y="315028"/>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71" name="pl28">
              <a:extLst>
                <a:ext uri="{FF2B5EF4-FFF2-40B4-BE49-F238E27FC236}">
                  <a16:creationId xmlns:a16="http://schemas.microsoft.com/office/drawing/2014/main" id="{62A5D7C9-65C8-F7CE-7182-09A2DEBB87C4}"/>
                </a:ext>
              </a:extLst>
            </p:cNvPr>
            <p:cNvSpPr/>
            <p:nvPr/>
          </p:nvSpPr>
          <p:spPr>
            <a:xfrm>
              <a:off x="5585507" y="4497723"/>
              <a:ext cx="0" cy="0"/>
            </a:xfrm>
            <a:custGeom>
              <a:avLst/>
              <a:gdLst/>
              <a:ahLst/>
              <a:cxnLst/>
              <a:rect l="0" t="0" r="0" b="0"/>
              <a:pathLst>
                <a:path>
                  <a:moveTo>
                    <a:pt x="0" y="0"/>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72" name="pg29">
              <a:extLst>
                <a:ext uri="{FF2B5EF4-FFF2-40B4-BE49-F238E27FC236}">
                  <a16:creationId xmlns:a16="http://schemas.microsoft.com/office/drawing/2014/main" id="{0DEBE811-4FA5-6A20-7073-BFCFA40F0BEE}"/>
                </a:ext>
              </a:extLst>
            </p:cNvPr>
            <p:cNvSpPr/>
            <p:nvPr/>
          </p:nvSpPr>
          <p:spPr>
            <a:xfrm>
              <a:off x="5536665" y="4392300"/>
              <a:ext cx="97684" cy="105423"/>
            </a:xfrm>
            <a:custGeom>
              <a:avLst/>
              <a:gdLst/>
              <a:ahLst/>
              <a:cxnLst/>
              <a:rect l="0" t="0" r="0" b="0"/>
              <a:pathLst>
                <a:path w="291902" h="315028">
                  <a:moveTo>
                    <a:pt x="0" y="0"/>
                  </a:moveTo>
                  <a:lnTo>
                    <a:pt x="0" y="315028"/>
                  </a:lnTo>
                  <a:lnTo>
                    <a:pt x="291902" y="315028"/>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73" name="pl30">
              <a:extLst>
                <a:ext uri="{FF2B5EF4-FFF2-40B4-BE49-F238E27FC236}">
                  <a16:creationId xmlns:a16="http://schemas.microsoft.com/office/drawing/2014/main" id="{613115DB-EA8B-C895-1EB8-EBD232C6B63E}"/>
                </a:ext>
              </a:extLst>
            </p:cNvPr>
            <p:cNvSpPr/>
            <p:nvPr/>
          </p:nvSpPr>
          <p:spPr>
            <a:xfrm>
              <a:off x="5536665" y="4497723"/>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74" name="pt31">
              <a:extLst>
                <a:ext uri="{FF2B5EF4-FFF2-40B4-BE49-F238E27FC236}">
                  <a16:creationId xmlns:a16="http://schemas.microsoft.com/office/drawing/2014/main" id="{8F5F5C75-9EDC-2AAD-7FB2-2A894D3F0C81}"/>
                </a:ext>
              </a:extLst>
            </p:cNvPr>
            <p:cNvSpPr/>
            <p:nvPr/>
          </p:nvSpPr>
          <p:spPr>
            <a:xfrm>
              <a:off x="5713957" y="3786596"/>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75" name="pl32">
              <a:extLst>
                <a:ext uri="{FF2B5EF4-FFF2-40B4-BE49-F238E27FC236}">
                  <a16:creationId xmlns:a16="http://schemas.microsoft.com/office/drawing/2014/main" id="{B581B02E-001F-19DA-966F-BD63D5D6383E}"/>
                </a:ext>
              </a:extLst>
            </p:cNvPr>
            <p:cNvSpPr/>
            <p:nvPr/>
          </p:nvSpPr>
          <p:spPr>
            <a:xfrm>
              <a:off x="5722264" y="3935468"/>
              <a:ext cx="0" cy="316268"/>
            </a:xfrm>
            <a:custGeom>
              <a:avLst/>
              <a:gdLst/>
              <a:ahLst/>
              <a:cxnLst/>
              <a:rect l="0" t="0" r="0" b="0"/>
              <a:pathLst>
                <a:path h="945084">
                  <a:moveTo>
                    <a:pt x="0" y="945084"/>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76" name="pl33">
              <a:extLst>
                <a:ext uri="{FF2B5EF4-FFF2-40B4-BE49-F238E27FC236}">
                  <a16:creationId xmlns:a16="http://schemas.microsoft.com/office/drawing/2014/main" id="{CAEB8B0E-2814-E680-659C-3FDD74C924FC}"/>
                </a:ext>
              </a:extLst>
            </p:cNvPr>
            <p:cNvSpPr/>
            <p:nvPr/>
          </p:nvSpPr>
          <p:spPr>
            <a:xfrm>
              <a:off x="5722264" y="4497723"/>
              <a:ext cx="0" cy="0"/>
            </a:xfrm>
            <a:custGeom>
              <a:avLst/>
              <a:gdLst/>
              <a:ahLst/>
              <a:cxnLst/>
              <a:rect l="0" t="0" r="0" b="0"/>
              <a:pathLst>
                <a:path>
                  <a:moveTo>
                    <a:pt x="0" y="0"/>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77" name="pg34">
              <a:extLst>
                <a:ext uri="{FF2B5EF4-FFF2-40B4-BE49-F238E27FC236}">
                  <a16:creationId xmlns:a16="http://schemas.microsoft.com/office/drawing/2014/main" id="{585397FF-27F3-7173-CBBE-B25857AC1CC5}"/>
                </a:ext>
              </a:extLst>
            </p:cNvPr>
            <p:cNvSpPr/>
            <p:nvPr/>
          </p:nvSpPr>
          <p:spPr>
            <a:xfrm>
              <a:off x="5673422" y="4251736"/>
              <a:ext cx="97684" cy="245986"/>
            </a:xfrm>
            <a:custGeom>
              <a:avLst/>
              <a:gdLst/>
              <a:ahLst/>
              <a:cxnLst/>
              <a:rect l="0" t="0" r="0" b="0"/>
              <a:pathLst>
                <a:path w="291902" h="735065">
                  <a:moveTo>
                    <a:pt x="0" y="0"/>
                  </a:moveTo>
                  <a:lnTo>
                    <a:pt x="0" y="735065"/>
                  </a:lnTo>
                  <a:lnTo>
                    <a:pt x="291902" y="735065"/>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78" name="pl35">
              <a:extLst>
                <a:ext uri="{FF2B5EF4-FFF2-40B4-BE49-F238E27FC236}">
                  <a16:creationId xmlns:a16="http://schemas.microsoft.com/office/drawing/2014/main" id="{549C1537-BD4F-A665-DFC6-91F0362BB897}"/>
                </a:ext>
              </a:extLst>
            </p:cNvPr>
            <p:cNvSpPr/>
            <p:nvPr/>
          </p:nvSpPr>
          <p:spPr>
            <a:xfrm>
              <a:off x="5673422" y="4392300"/>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79" name="pt36">
              <a:extLst>
                <a:ext uri="{FF2B5EF4-FFF2-40B4-BE49-F238E27FC236}">
                  <a16:creationId xmlns:a16="http://schemas.microsoft.com/office/drawing/2014/main" id="{F359B504-959F-D915-FF64-5CFB2BA04E7A}"/>
                </a:ext>
              </a:extLst>
            </p:cNvPr>
            <p:cNvSpPr/>
            <p:nvPr/>
          </p:nvSpPr>
          <p:spPr>
            <a:xfrm>
              <a:off x="5967935" y="4096785"/>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80" name="pl37">
              <a:extLst>
                <a:ext uri="{FF2B5EF4-FFF2-40B4-BE49-F238E27FC236}">
                  <a16:creationId xmlns:a16="http://schemas.microsoft.com/office/drawing/2014/main" id="{DDA23CC9-49A4-C8B7-A907-A60935C80169}"/>
                </a:ext>
              </a:extLst>
            </p:cNvPr>
            <p:cNvSpPr/>
            <p:nvPr/>
          </p:nvSpPr>
          <p:spPr>
            <a:xfrm>
              <a:off x="5976242" y="4283161"/>
              <a:ext cx="0" cy="98255"/>
            </a:xfrm>
            <a:custGeom>
              <a:avLst/>
              <a:gdLst/>
              <a:ahLst/>
              <a:cxnLst/>
              <a:rect l="0" t="0" r="0" b="0"/>
              <a:pathLst>
                <a:path h="293609">
                  <a:moveTo>
                    <a:pt x="0" y="293609"/>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81" name="pl38">
              <a:extLst>
                <a:ext uri="{FF2B5EF4-FFF2-40B4-BE49-F238E27FC236}">
                  <a16:creationId xmlns:a16="http://schemas.microsoft.com/office/drawing/2014/main" id="{1ACE85E2-E292-2E70-F951-1919CCA79C90}"/>
                </a:ext>
              </a:extLst>
            </p:cNvPr>
            <p:cNvSpPr/>
            <p:nvPr/>
          </p:nvSpPr>
          <p:spPr>
            <a:xfrm>
              <a:off x="5976242" y="4448350"/>
              <a:ext cx="0" cy="12878"/>
            </a:xfrm>
            <a:custGeom>
              <a:avLst/>
              <a:gdLst/>
              <a:ahLst/>
              <a:cxnLst/>
              <a:rect l="0" t="0" r="0" b="0"/>
              <a:pathLst>
                <a:path h="38482">
                  <a:moveTo>
                    <a:pt x="0" y="0"/>
                  </a:moveTo>
                  <a:lnTo>
                    <a:pt x="0" y="38482"/>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82" name="pg39">
              <a:extLst>
                <a:ext uri="{FF2B5EF4-FFF2-40B4-BE49-F238E27FC236}">
                  <a16:creationId xmlns:a16="http://schemas.microsoft.com/office/drawing/2014/main" id="{7C03DF4D-28A3-4E48-9232-3A25FE307848}"/>
                </a:ext>
              </a:extLst>
            </p:cNvPr>
            <p:cNvSpPr/>
            <p:nvPr/>
          </p:nvSpPr>
          <p:spPr>
            <a:xfrm>
              <a:off x="5927400" y="4381416"/>
              <a:ext cx="97684" cy="66934"/>
            </a:xfrm>
            <a:custGeom>
              <a:avLst/>
              <a:gdLst/>
              <a:ahLst/>
              <a:cxnLst/>
              <a:rect l="0" t="0" r="0" b="0"/>
              <a:pathLst>
                <a:path w="291902" h="200015">
                  <a:moveTo>
                    <a:pt x="0" y="0"/>
                  </a:moveTo>
                  <a:lnTo>
                    <a:pt x="0" y="200015"/>
                  </a:lnTo>
                  <a:lnTo>
                    <a:pt x="291902" y="200015"/>
                  </a:lnTo>
                  <a:lnTo>
                    <a:pt x="291902" y="0"/>
                  </a:lnTo>
                  <a:close/>
                </a:path>
              </a:pathLst>
            </a:custGeom>
            <a:solidFill>
              <a:srgbClr val="21908C">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83" name="pl40">
              <a:extLst>
                <a:ext uri="{FF2B5EF4-FFF2-40B4-BE49-F238E27FC236}">
                  <a16:creationId xmlns:a16="http://schemas.microsoft.com/office/drawing/2014/main" id="{146EED14-AC4F-D51C-083B-9E10666D5F38}"/>
                </a:ext>
              </a:extLst>
            </p:cNvPr>
            <p:cNvSpPr/>
            <p:nvPr/>
          </p:nvSpPr>
          <p:spPr>
            <a:xfrm>
              <a:off x="5927400" y="4429430"/>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84" name="pt42">
              <a:extLst>
                <a:ext uri="{FF2B5EF4-FFF2-40B4-BE49-F238E27FC236}">
                  <a16:creationId xmlns:a16="http://schemas.microsoft.com/office/drawing/2014/main" id="{D8DF10B3-6A4B-43FB-57DA-FA66C9419E79}"/>
                </a:ext>
              </a:extLst>
            </p:cNvPr>
            <p:cNvSpPr/>
            <p:nvPr/>
          </p:nvSpPr>
          <p:spPr>
            <a:xfrm>
              <a:off x="6104692" y="4236695"/>
              <a:ext cx="16615" cy="16615"/>
            </a:xfrm>
            <a:prstGeom prst="ellipse">
              <a:avLst/>
            </a:prstGeom>
          </p:spPr>
          <p:txBody>
            <a:bodyPr/>
            <a:lstStyle/>
            <a:p>
              <a:endParaRPr sz="700">
                <a:latin typeface="Arial" panose="020B0604020202020204" pitchFamily="34" charset="0"/>
                <a:cs typeface="Arial" panose="020B0604020202020204" pitchFamily="34" charset="0"/>
              </a:endParaRPr>
            </a:p>
          </p:txBody>
        </p:sp>
        <p:sp>
          <p:nvSpPr>
            <p:cNvPr id="2685" name="pl43">
              <a:extLst>
                <a:ext uri="{FF2B5EF4-FFF2-40B4-BE49-F238E27FC236}">
                  <a16:creationId xmlns:a16="http://schemas.microsoft.com/office/drawing/2014/main" id="{73672675-3FBA-0995-37C6-DD4051CE06A9}"/>
                </a:ext>
              </a:extLst>
            </p:cNvPr>
            <p:cNvSpPr/>
            <p:nvPr/>
          </p:nvSpPr>
          <p:spPr>
            <a:xfrm>
              <a:off x="6113000" y="4314958"/>
              <a:ext cx="0" cy="55646"/>
            </a:xfrm>
            <a:custGeom>
              <a:avLst/>
              <a:gdLst/>
              <a:ahLst/>
              <a:cxnLst/>
              <a:rect l="0" t="0" r="0" b="0"/>
              <a:pathLst>
                <a:path h="166283">
                  <a:moveTo>
                    <a:pt x="0" y="166283"/>
                  </a:moveTo>
                  <a:lnTo>
                    <a:pt x="0"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86" name="pl44">
              <a:extLst>
                <a:ext uri="{FF2B5EF4-FFF2-40B4-BE49-F238E27FC236}">
                  <a16:creationId xmlns:a16="http://schemas.microsoft.com/office/drawing/2014/main" id="{E3B6DF34-A916-920D-BDCA-E8B8EA567B59}"/>
                </a:ext>
              </a:extLst>
            </p:cNvPr>
            <p:cNvSpPr/>
            <p:nvPr/>
          </p:nvSpPr>
          <p:spPr>
            <a:xfrm>
              <a:off x="6113000" y="4449399"/>
              <a:ext cx="0" cy="11829"/>
            </a:xfrm>
            <a:custGeom>
              <a:avLst/>
              <a:gdLst/>
              <a:ahLst/>
              <a:cxnLst/>
              <a:rect l="0" t="0" r="0" b="0"/>
              <a:pathLst>
                <a:path h="35347">
                  <a:moveTo>
                    <a:pt x="0" y="0"/>
                  </a:moveTo>
                  <a:lnTo>
                    <a:pt x="0" y="35347"/>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87" name="pg45">
              <a:extLst>
                <a:ext uri="{FF2B5EF4-FFF2-40B4-BE49-F238E27FC236}">
                  <a16:creationId xmlns:a16="http://schemas.microsoft.com/office/drawing/2014/main" id="{BF8C5EB2-1780-07F0-1D28-9F97580BB2CC}"/>
                </a:ext>
              </a:extLst>
            </p:cNvPr>
            <p:cNvSpPr/>
            <p:nvPr/>
          </p:nvSpPr>
          <p:spPr>
            <a:xfrm>
              <a:off x="6064158" y="4370605"/>
              <a:ext cx="97684" cy="78795"/>
            </a:xfrm>
            <a:custGeom>
              <a:avLst/>
              <a:gdLst/>
              <a:ahLst/>
              <a:cxnLst/>
              <a:rect l="0" t="0" r="0" b="0"/>
              <a:pathLst>
                <a:path w="291902" h="235457">
                  <a:moveTo>
                    <a:pt x="0" y="0"/>
                  </a:moveTo>
                  <a:lnTo>
                    <a:pt x="0" y="235457"/>
                  </a:lnTo>
                  <a:lnTo>
                    <a:pt x="291902" y="235457"/>
                  </a:lnTo>
                  <a:lnTo>
                    <a:pt x="291902" y="0"/>
                  </a:lnTo>
                  <a:close/>
                </a:path>
              </a:pathLst>
            </a:custGeom>
            <a:solidFill>
              <a:srgbClr val="FDE725">
                <a:alpha val="1176"/>
              </a:srgbClr>
            </a:solidFill>
            <a:ln w="13550"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88" name="pl46">
              <a:extLst>
                <a:ext uri="{FF2B5EF4-FFF2-40B4-BE49-F238E27FC236}">
                  <a16:creationId xmlns:a16="http://schemas.microsoft.com/office/drawing/2014/main" id="{E9434279-3BBB-EF80-DEBA-18E7053D3607}"/>
                </a:ext>
              </a:extLst>
            </p:cNvPr>
            <p:cNvSpPr/>
            <p:nvPr/>
          </p:nvSpPr>
          <p:spPr>
            <a:xfrm>
              <a:off x="6064158" y="4420050"/>
              <a:ext cx="97684" cy="0"/>
            </a:xfrm>
            <a:custGeom>
              <a:avLst/>
              <a:gdLst/>
              <a:ahLst/>
              <a:cxnLst/>
              <a:rect l="0" t="0" r="0" b="0"/>
              <a:pathLst>
                <a:path w="291902">
                  <a:moveTo>
                    <a:pt x="0" y="0"/>
                  </a:moveTo>
                  <a:lnTo>
                    <a:pt x="291902" y="0"/>
                  </a:lnTo>
                </a:path>
              </a:pathLst>
            </a:custGeom>
            <a:ln w="27101" cap="flat">
              <a:solidFill>
                <a:srgbClr val="000000">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689" name="pt47">
              <a:extLst>
                <a:ext uri="{FF2B5EF4-FFF2-40B4-BE49-F238E27FC236}">
                  <a16:creationId xmlns:a16="http://schemas.microsoft.com/office/drawing/2014/main" id="{F67C0836-D025-9E93-995B-613F3E54D667}"/>
                </a:ext>
              </a:extLst>
            </p:cNvPr>
            <p:cNvSpPr/>
            <p:nvPr/>
          </p:nvSpPr>
          <p:spPr>
            <a:xfrm>
              <a:off x="4936160" y="432916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0" name="pt48">
              <a:extLst>
                <a:ext uri="{FF2B5EF4-FFF2-40B4-BE49-F238E27FC236}">
                  <a16:creationId xmlns:a16="http://schemas.microsoft.com/office/drawing/2014/main" id="{A1A5C156-CADC-8691-BF16-9694E344E5C5}"/>
                </a:ext>
              </a:extLst>
            </p:cNvPr>
            <p:cNvSpPr/>
            <p:nvPr/>
          </p:nvSpPr>
          <p:spPr>
            <a:xfrm>
              <a:off x="4779334"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1" name="pt49">
              <a:extLst>
                <a:ext uri="{FF2B5EF4-FFF2-40B4-BE49-F238E27FC236}">
                  <a16:creationId xmlns:a16="http://schemas.microsoft.com/office/drawing/2014/main" id="{9CBAE791-D436-A170-5AC7-E8E827199DA6}"/>
                </a:ext>
              </a:extLst>
            </p:cNvPr>
            <p:cNvSpPr/>
            <p:nvPr/>
          </p:nvSpPr>
          <p:spPr>
            <a:xfrm>
              <a:off x="4809081" y="456149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2" name="pt50">
              <a:extLst>
                <a:ext uri="{FF2B5EF4-FFF2-40B4-BE49-F238E27FC236}">
                  <a16:creationId xmlns:a16="http://schemas.microsoft.com/office/drawing/2014/main" id="{7C434D53-BB3C-8AE8-E49F-8C6D7DC3D8FE}"/>
                </a:ext>
              </a:extLst>
            </p:cNvPr>
            <p:cNvSpPr/>
            <p:nvPr/>
          </p:nvSpPr>
          <p:spPr>
            <a:xfrm>
              <a:off x="4937104" y="425422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3" name="pt51">
              <a:extLst>
                <a:ext uri="{FF2B5EF4-FFF2-40B4-BE49-F238E27FC236}">
                  <a16:creationId xmlns:a16="http://schemas.microsoft.com/office/drawing/2014/main" id="{12BDA4F1-005E-72DC-EF65-7F18CC1C3C88}"/>
                </a:ext>
              </a:extLst>
            </p:cNvPr>
            <p:cNvSpPr/>
            <p:nvPr/>
          </p:nvSpPr>
          <p:spPr>
            <a:xfrm>
              <a:off x="4775783" y="447905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4" name="pt52">
              <a:extLst>
                <a:ext uri="{FF2B5EF4-FFF2-40B4-BE49-F238E27FC236}">
                  <a16:creationId xmlns:a16="http://schemas.microsoft.com/office/drawing/2014/main" id="{C40B9765-E1DA-7C06-6E02-6A484C3C3AA4}"/>
                </a:ext>
              </a:extLst>
            </p:cNvPr>
            <p:cNvSpPr/>
            <p:nvPr/>
          </p:nvSpPr>
          <p:spPr>
            <a:xfrm>
              <a:off x="4817426"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5" name="pt53">
              <a:extLst>
                <a:ext uri="{FF2B5EF4-FFF2-40B4-BE49-F238E27FC236}">
                  <a16:creationId xmlns:a16="http://schemas.microsoft.com/office/drawing/2014/main" id="{D94D1D1F-967A-E0FD-23C3-3CE4637556C3}"/>
                </a:ext>
              </a:extLst>
            </p:cNvPr>
            <p:cNvSpPr/>
            <p:nvPr/>
          </p:nvSpPr>
          <p:spPr>
            <a:xfrm>
              <a:off x="4776317"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6" name="pt54">
              <a:extLst>
                <a:ext uri="{FF2B5EF4-FFF2-40B4-BE49-F238E27FC236}">
                  <a16:creationId xmlns:a16="http://schemas.microsoft.com/office/drawing/2014/main" id="{44551A6D-223B-2E9E-3093-EB6937B3511E}"/>
                </a:ext>
              </a:extLst>
            </p:cNvPr>
            <p:cNvSpPr/>
            <p:nvPr/>
          </p:nvSpPr>
          <p:spPr>
            <a:xfrm>
              <a:off x="4945999" y="414180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7" name="pt55">
              <a:extLst>
                <a:ext uri="{FF2B5EF4-FFF2-40B4-BE49-F238E27FC236}">
                  <a16:creationId xmlns:a16="http://schemas.microsoft.com/office/drawing/2014/main" id="{203E6BA0-FFF2-26C3-5A6D-253F9F54F718}"/>
                </a:ext>
              </a:extLst>
            </p:cNvPr>
            <p:cNvSpPr/>
            <p:nvPr/>
          </p:nvSpPr>
          <p:spPr>
            <a:xfrm>
              <a:off x="4780894" y="455399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8" name="pt56">
              <a:extLst>
                <a:ext uri="{FF2B5EF4-FFF2-40B4-BE49-F238E27FC236}">
                  <a16:creationId xmlns:a16="http://schemas.microsoft.com/office/drawing/2014/main" id="{8782015C-AC08-4E54-962F-B1A5B3089039}"/>
                </a:ext>
              </a:extLst>
            </p:cNvPr>
            <p:cNvSpPr/>
            <p:nvPr/>
          </p:nvSpPr>
          <p:spPr>
            <a:xfrm>
              <a:off x="4802228"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99" name="pt57">
              <a:extLst>
                <a:ext uri="{FF2B5EF4-FFF2-40B4-BE49-F238E27FC236}">
                  <a16:creationId xmlns:a16="http://schemas.microsoft.com/office/drawing/2014/main" id="{0854ACEA-6F67-D461-81FF-A9FCC61B5D95}"/>
                </a:ext>
              </a:extLst>
            </p:cNvPr>
            <p:cNvSpPr/>
            <p:nvPr/>
          </p:nvSpPr>
          <p:spPr>
            <a:xfrm>
              <a:off x="4919307" y="421674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0" name="pt58">
              <a:extLst>
                <a:ext uri="{FF2B5EF4-FFF2-40B4-BE49-F238E27FC236}">
                  <a16:creationId xmlns:a16="http://schemas.microsoft.com/office/drawing/2014/main" id="{6BB76A60-4DFB-C693-0F81-3956F25617DF}"/>
                </a:ext>
              </a:extLst>
            </p:cNvPr>
            <p:cNvSpPr/>
            <p:nvPr/>
          </p:nvSpPr>
          <p:spPr>
            <a:xfrm>
              <a:off x="4782037" y="4628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1" name="pt59">
              <a:extLst>
                <a:ext uri="{FF2B5EF4-FFF2-40B4-BE49-F238E27FC236}">
                  <a16:creationId xmlns:a16="http://schemas.microsoft.com/office/drawing/2014/main" id="{FA967BDB-1B79-98BD-6638-BA792D8A437F}"/>
                </a:ext>
              </a:extLst>
            </p:cNvPr>
            <p:cNvSpPr/>
            <p:nvPr/>
          </p:nvSpPr>
          <p:spPr>
            <a:xfrm>
              <a:off x="4946343" y="440410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2" name="pt60">
              <a:extLst>
                <a:ext uri="{FF2B5EF4-FFF2-40B4-BE49-F238E27FC236}">
                  <a16:creationId xmlns:a16="http://schemas.microsoft.com/office/drawing/2014/main" id="{54EBE2F1-ECC7-3309-E42C-E1A638B6D13E}"/>
                </a:ext>
              </a:extLst>
            </p:cNvPr>
            <p:cNvSpPr/>
            <p:nvPr/>
          </p:nvSpPr>
          <p:spPr>
            <a:xfrm>
              <a:off x="4952171" y="432916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3" name="pt61">
              <a:extLst>
                <a:ext uri="{FF2B5EF4-FFF2-40B4-BE49-F238E27FC236}">
                  <a16:creationId xmlns:a16="http://schemas.microsoft.com/office/drawing/2014/main" id="{97E178A6-9ECC-217E-1402-D71DA46B632D}"/>
                </a:ext>
              </a:extLst>
            </p:cNvPr>
            <p:cNvSpPr/>
            <p:nvPr/>
          </p:nvSpPr>
          <p:spPr>
            <a:xfrm>
              <a:off x="4934742" y="410433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4" name="pt62">
              <a:extLst>
                <a:ext uri="{FF2B5EF4-FFF2-40B4-BE49-F238E27FC236}">
                  <a16:creationId xmlns:a16="http://schemas.microsoft.com/office/drawing/2014/main" id="{6D91FC3A-9E22-2429-8C75-EC595764A360}"/>
                </a:ext>
              </a:extLst>
            </p:cNvPr>
            <p:cNvSpPr/>
            <p:nvPr/>
          </p:nvSpPr>
          <p:spPr>
            <a:xfrm>
              <a:off x="4813733" y="425422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5" name="pt63">
              <a:extLst>
                <a:ext uri="{FF2B5EF4-FFF2-40B4-BE49-F238E27FC236}">
                  <a16:creationId xmlns:a16="http://schemas.microsoft.com/office/drawing/2014/main" id="{B63FC0AE-364E-ABF8-E619-A5060FC15D01}"/>
                </a:ext>
              </a:extLst>
            </p:cNvPr>
            <p:cNvSpPr/>
            <p:nvPr/>
          </p:nvSpPr>
          <p:spPr>
            <a:xfrm>
              <a:off x="4797184" y="46289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6" name="pt64">
              <a:extLst>
                <a:ext uri="{FF2B5EF4-FFF2-40B4-BE49-F238E27FC236}">
                  <a16:creationId xmlns:a16="http://schemas.microsoft.com/office/drawing/2014/main" id="{D939D092-4A56-A54B-2E1C-FD85898FB556}"/>
                </a:ext>
              </a:extLst>
            </p:cNvPr>
            <p:cNvSpPr/>
            <p:nvPr/>
          </p:nvSpPr>
          <p:spPr>
            <a:xfrm>
              <a:off x="4928602" y="410433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7" name="pt65">
              <a:extLst>
                <a:ext uri="{FF2B5EF4-FFF2-40B4-BE49-F238E27FC236}">
                  <a16:creationId xmlns:a16="http://schemas.microsoft.com/office/drawing/2014/main" id="{58CDD5A8-7A2A-811E-C92F-3F648479B6D4}"/>
                </a:ext>
              </a:extLst>
            </p:cNvPr>
            <p:cNvSpPr/>
            <p:nvPr/>
          </p:nvSpPr>
          <p:spPr>
            <a:xfrm>
              <a:off x="4794142" y="410433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8" name="pt66">
              <a:extLst>
                <a:ext uri="{FF2B5EF4-FFF2-40B4-BE49-F238E27FC236}">
                  <a16:creationId xmlns:a16="http://schemas.microsoft.com/office/drawing/2014/main" id="{F10044FA-3372-9562-D249-EDF07F015BF0}"/>
                </a:ext>
              </a:extLst>
            </p:cNvPr>
            <p:cNvSpPr/>
            <p:nvPr/>
          </p:nvSpPr>
          <p:spPr>
            <a:xfrm>
              <a:off x="4815636" y="447905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09" name="pt67">
              <a:extLst>
                <a:ext uri="{FF2B5EF4-FFF2-40B4-BE49-F238E27FC236}">
                  <a16:creationId xmlns:a16="http://schemas.microsoft.com/office/drawing/2014/main" id="{2D9896CB-8684-2351-221A-09E41053F17B}"/>
                </a:ext>
              </a:extLst>
            </p:cNvPr>
            <p:cNvSpPr/>
            <p:nvPr/>
          </p:nvSpPr>
          <p:spPr>
            <a:xfrm>
              <a:off x="4806612" y="470388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0" name="pt68">
              <a:extLst>
                <a:ext uri="{FF2B5EF4-FFF2-40B4-BE49-F238E27FC236}">
                  <a16:creationId xmlns:a16="http://schemas.microsoft.com/office/drawing/2014/main" id="{64C4A605-B1AD-C6A5-A7EA-8813FDCD5BF6}"/>
                </a:ext>
              </a:extLst>
            </p:cNvPr>
            <p:cNvSpPr/>
            <p:nvPr/>
          </p:nvSpPr>
          <p:spPr>
            <a:xfrm>
              <a:off x="4915829" y="421674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1" name="pt69">
              <a:extLst>
                <a:ext uri="{FF2B5EF4-FFF2-40B4-BE49-F238E27FC236}">
                  <a16:creationId xmlns:a16="http://schemas.microsoft.com/office/drawing/2014/main" id="{F62AF20B-4580-5CBE-5DC2-95C9BBCC4FC5}"/>
                </a:ext>
              </a:extLst>
            </p:cNvPr>
            <p:cNvSpPr/>
            <p:nvPr/>
          </p:nvSpPr>
          <p:spPr>
            <a:xfrm>
              <a:off x="4800669" y="440410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2" name="pt70">
              <a:extLst>
                <a:ext uri="{FF2B5EF4-FFF2-40B4-BE49-F238E27FC236}">
                  <a16:creationId xmlns:a16="http://schemas.microsoft.com/office/drawing/2014/main" id="{54A8EEB0-C793-3BDF-D387-C48C6780A454}"/>
                </a:ext>
              </a:extLst>
            </p:cNvPr>
            <p:cNvSpPr/>
            <p:nvPr/>
          </p:nvSpPr>
          <p:spPr>
            <a:xfrm>
              <a:off x="4915568" y="410433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3" name="pt71">
              <a:extLst>
                <a:ext uri="{FF2B5EF4-FFF2-40B4-BE49-F238E27FC236}">
                  <a16:creationId xmlns:a16="http://schemas.microsoft.com/office/drawing/2014/main" id="{0A5E4E4A-B302-D4A3-D74A-FEE499559C30}"/>
                </a:ext>
              </a:extLst>
            </p:cNvPr>
            <p:cNvSpPr/>
            <p:nvPr/>
          </p:nvSpPr>
          <p:spPr>
            <a:xfrm>
              <a:off x="4946119" y="432916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4" name="pt72">
              <a:extLst>
                <a:ext uri="{FF2B5EF4-FFF2-40B4-BE49-F238E27FC236}">
                  <a16:creationId xmlns:a16="http://schemas.microsoft.com/office/drawing/2014/main" id="{BFEA737F-CBEE-FE8D-0F3C-1168D9DF818E}"/>
                </a:ext>
              </a:extLst>
            </p:cNvPr>
            <p:cNvSpPr/>
            <p:nvPr/>
          </p:nvSpPr>
          <p:spPr>
            <a:xfrm>
              <a:off x="4795208" y="455399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5" name="pt73">
              <a:extLst>
                <a:ext uri="{FF2B5EF4-FFF2-40B4-BE49-F238E27FC236}">
                  <a16:creationId xmlns:a16="http://schemas.microsoft.com/office/drawing/2014/main" id="{3A0B2579-AFB5-1FB6-1127-27480F612EBF}"/>
                </a:ext>
              </a:extLst>
            </p:cNvPr>
            <p:cNvSpPr/>
            <p:nvPr/>
          </p:nvSpPr>
          <p:spPr>
            <a:xfrm>
              <a:off x="4929915" y="455399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6" name="pt74">
              <a:extLst>
                <a:ext uri="{FF2B5EF4-FFF2-40B4-BE49-F238E27FC236}">
                  <a16:creationId xmlns:a16="http://schemas.microsoft.com/office/drawing/2014/main" id="{0945C1CA-C0BC-67BB-F403-87567EE695A0}"/>
                </a:ext>
              </a:extLst>
            </p:cNvPr>
            <p:cNvSpPr/>
            <p:nvPr/>
          </p:nvSpPr>
          <p:spPr>
            <a:xfrm>
              <a:off x="4784507" y="447905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7" name="pt75">
              <a:extLst>
                <a:ext uri="{FF2B5EF4-FFF2-40B4-BE49-F238E27FC236}">
                  <a16:creationId xmlns:a16="http://schemas.microsoft.com/office/drawing/2014/main" id="{62FE00C8-0C84-D8A8-4A19-DD3AA1FA42CC}"/>
                </a:ext>
              </a:extLst>
            </p:cNvPr>
            <p:cNvSpPr/>
            <p:nvPr/>
          </p:nvSpPr>
          <p:spPr>
            <a:xfrm>
              <a:off x="4904564" y="417927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8" name="pt76">
              <a:extLst>
                <a:ext uri="{FF2B5EF4-FFF2-40B4-BE49-F238E27FC236}">
                  <a16:creationId xmlns:a16="http://schemas.microsoft.com/office/drawing/2014/main" id="{9E553930-BAEA-3D3F-1819-FEC1846048F3}"/>
                </a:ext>
              </a:extLst>
            </p:cNvPr>
            <p:cNvSpPr/>
            <p:nvPr/>
          </p:nvSpPr>
          <p:spPr>
            <a:xfrm>
              <a:off x="4771686" y="447905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19" name="pt77">
              <a:extLst>
                <a:ext uri="{FF2B5EF4-FFF2-40B4-BE49-F238E27FC236}">
                  <a16:creationId xmlns:a16="http://schemas.microsoft.com/office/drawing/2014/main" id="{D1DDD31D-A349-D322-1A26-C229EFE3B8D3}"/>
                </a:ext>
              </a:extLst>
            </p:cNvPr>
            <p:cNvSpPr/>
            <p:nvPr/>
          </p:nvSpPr>
          <p:spPr>
            <a:xfrm>
              <a:off x="4820409" y="470388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0" name="pt78">
              <a:extLst>
                <a:ext uri="{FF2B5EF4-FFF2-40B4-BE49-F238E27FC236}">
                  <a16:creationId xmlns:a16="http://schemas.microsoft.com/office/drawing/2014/main" id="{10566F16-65DD-A065-8842-304FD72C5DB3}"/>
                </a:ext>
              </a:extLst>
            </p:cNvPr>
            <p:cNvSpPr/>
            <p:nvPr/>
          </p:nvSpPr>
          <p:spPr>
            <a:xfrm>
              <a:off x="4945954" y="414180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1" name="pt79">
              <a:extLst>
                <a:ext uri="{FF2B5EF4-FFF2-40B4-BE49-F238E27FC236}">
                  <a16:creationId xmlns:a16="http://schemas.microsoft.com/office/drawing/2014/main" id="{3CF57A81-C0A8-55C9-9FA3-6C9120AED931}"/>
                </a:ext>
              </a:extLst>
            </p:cNvPr>
            <p:cNvSpPr/>
            <p:nvPr/>
          </p:nvSpPr>
          <p:spPr>
            <a:xfrm>
              <a:off x="4919385" y="455399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2" name="pt80">
              <a:extLst>
                <a:ext uri="{FF2B5EF4-FFF2-40B4-BE49-F238E27FC236}">
                  <a16:creationId xmlns:a16="http://schemas.microsoft.com/office/drawing/2014/main" id="{C8D7163D-73AE-C47A-44CF-C67EF37EDC0E}"/>
                </a:ext>
              </a:extLst>
            </p:cNvPr>
            <p:cNvSpPr/>
            <p:nvPr/>
          </p:nvSpPr>
          <p:spPr>
            <a:xfrm>
              <a:off x="4792249" y="425422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3" name="pt81">
              <a:extLst>
                <a:ext uri="{FF2B5EF4-FFF2-40B4-BE49-F238E27FC236}">
                  <a16:creationId xmlns:a16="http://schemas.microsoft.com/office/drawing/2014/main" id="{24314B7C-C2AA-88B9-260C-64178CDDD465}"/>
                </a:ext>
              </a:extLst>
            </p:cNvPr>
            <p:cNvSpPr/>
            <p:nvPr/>
          </p:nvSpPr>
          <p:spPr>
            <a:xfrm>
              <a:off x="4800179" y="440410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4" name="pt82">
              <a:extLst>
                <a:ext uri="{FF2B5EF4-FFF2-40B4-BE49-F238E27FC236}">
                  <a16:creationId xmlns:a16="http://schemas.microsoft.com/office/drawing/2014/main" id="{E414C8BA-4F95-C8E8-5D9B-C9F4E6F4225E}"/>
                </a:ext>
              </a:extLst>
            </p:cNvPr>
            <p:cNvSpPr/>
            <p:nvPr/>
          </p:nvSpPr>
          <p:spPr>
            <a:xfrm>
              <a:off x="4910055" y="410433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5" name="pt83">
              <a:extLst>
                <a:ext uri="{FF2B5EF4-FFF2-40B4-BE49-F238E27FC236}">
                  <a16:creationId xmlns:a16="http://schemas.microsoft.com/office/drawing/2014/main" id="{E6291155-F0B1-6AC7-7EB9-B7960F842CC5}"/>
                </a:ext>
              </a:extLst>
            </p:cNvPr>
            <p:cNvSpPr/>
            <p:nvPr/>
          </p:nvSpPr>
          <p:spPr>
            <a:xfrm>
              <a:off x="4815097"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6" name="pt84">
              <a:extLst>
                <a:ext uri="{FF2B5EF4-FFF2-40B4-BE49-F238E27FC236}">
                  <a16:creationId xmlns:a16="http://schemas.microsoft.com/office/drawing/2014/main" id="{FAAAF8F7-0454-EDDC-75DF-267814294AF2}"/>
                </a:ext>
              </a:extLst>
            </p:cNvPr>
            <p:cNvSpPr/>
            <p:nvPr/>
          </p:nvSpPr>
          <p:spPr>
            <a:xfrm>
              <a:off x="4800342"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7" name="pt85">
              <a:extLst>
                <a:ext uri="{FF2B5EF4-FFF2-40B4-BE49-F238E27FC236}">
                  <a16:creationId xmlns:a16="http://schemas.microsoft.com/office/drawing/2014/main" id="{CA2AC7CB-C7AC-C938-E261-6F554C58249D}"/>
                </a:ext>
              </a:extLst>
            </p:cNvPr>
            <p:cNvSpPr/>
            <p:nvPr/>
          </p:nvSpPr>
          <p:spPr>
            <a:xfrm>
              <a:off x="4942549" y="459146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8" name="pt86">
              <a:extLst>
                <a:ext uri="{FF2B5EF4-FFF2-40B4-BE49-F238E27FC236}">
                  <a16:creationId xmlns:a16="http://schemas.microsoft.com/office/drawing/2014/main" id="{2ADF12F2-F926-4138-1628-2FAB373768F4}"/>
                </a:ext>
              </a:extLst>
            </p:cNvPr>
            <p:cNvSpPr/>
            <p:nvPr/>
          </p:nvSpPr>
          <p:spPr>
            <a:xfrm>
              <a:off x="4912335" y="432916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29" name="pt87">
              <a:extLst>
                <a:ext uri="{FF2B5EF4-FFF2-40B4-BE49-F238E27FC236}">
                  <a16:creationId xmlns:a16="http://schemas.microsoft.com/office/drawing/2014/main" id="{A8B15156-326E-A8CA-C5AA-7EFAFE3A17B9}"/>
                </a:ext>
              </a:extLst>
            </p:cNvPr>
            <p:cNvSpPr/>
            <p:nvPr/>
          </p:nvSpPr>
          <p:spPr>
            <a:xfrm>
              <a:off x="4770735" y="455399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0" name="pt88">
              <a:extLst>
                <a:ext uri="{FF2B5EF4-FFF2-40B4-BE49-F238E27FC236}">
                  <a16:creationId xmlns:a16="http://schemas.microsoft.com/office/drawing/2014/main" id="{052D5FD5-2DBA-3F51-D989-72FA3CFB9633}"/>
                </a:ext>
              </a:extLst>
            </p:cNvPr>
            <p:cNvSpPr/>
            <p:nvPr/>
          </p:nvSpPr>
          <p:spPr>
            <a:xfrm>
              <a:off x="4930692" y="395444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1" name="pt89">
              <a:extLst>
                <a:ext uri="{FF2B5EF4-FFF2-40B4-BE49-F238E27FC236}">
                  <a16:creationId xmlns:a16="http://schemas.microsoft.com/office/drawing/2014/main" id="{8FBE32D0-CB8A-C075-9D58-038F91F5524E}"/>
                </a:ext>
              </a:extLst>
            </p:cNvPr>
            <p:cNvSpPr/>
            <p:nvPr/>
          </p:nvSpPr>
          <p:spPr>
            <a:xfrm>
              <a:off x="4958480" y="417927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2" name="pt90">
              <a:extLst>
                <a:ext uri="{FF2B5EF4-FFF2-40B4-BE49-F238E27FC236}">
                  <a16:creationId xmlns:a16="http://schemas.microsoft.com/office/drawing/2014/main" id="{68B15FBF-8ED7-334D-2188-C57911531FF0}"/>
                </a:ext>
              </a:extLst>
            </p:cNvPr>
            <p:cNvSpPr/>
            <p:nvPr/>
          </p:nvSpPr>
          <p:spPr>
            <a:xfrm>
              <a:off x="4783698" y="470388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3" name="pt91">
              <a:extLst>
                <a:ext uri="{FF2B5EF4-FFF2-40B4-BE49-F238E27FC236}">
                  <a16:creationId xmlns:a16="http://schemas.microsoft.com/office/drawing/2014/main" id="{3CFCFF9D-488A-1B80-D020-8E00E74908D1}"/>
                </a:ext>
              </a:extLst>
            </p:cNvPr>
            <p:cNvSpPr/>
            <p:nvPr/>
          </p:nvSpPr>
          <p:spPr>
            <a:xfrm>
              <a:off x="4807515" y="447905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4" name="pt92">
              <a:extLst>
                <a:ext uri="{FF2B5EF4-FFF2-40B4-BE49-F238E27FC236}">
                  <a16:creationId xmlns:a16="http://schemas.microsoft.com/office/drawing/2014/main" id="{B5C4A3CF-B910-900E-2B49-EC94E33362E8}"/>
                </a:ext>
              </a:extLst>
            </p:cNvPr>
            <p:cNvSpPr/>
            <p:nvPr/>
          </p:nvSpPr>
          <p:spPr>
            <a:xfrm>
              <a:off x="4780803" y="440410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5" name="pt93">
              <a:extLst>
                <a:ext uri="{FF2B5EF4-FFF2-40B4-BE49-F238E27FC236}">
                  <a16:creationId xmlns:a16="http://schemas.microsoft.com/office/drawing/2014/main" id="{5244B141-F562-EB4E-B4E4-69F70F432028}"/>
                </a:ext>
              </a:extLst>
            </p:cNvPr>
            <p:cNvSpPr/>
            <p:nvPr/>
          </p:nvSpPr>
          <p:spPr>
            <a:xfrm>
              <a:off x="4798827" y="432916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6" name="pt94">
              <a:extLst>
                <a:ext uri="{FF2B5EF4-FFF2-40B4-BE49-F238E27FC236}">
                  <a16:creationId xmlns:a16="http://schemas.microsoft.com/office/drawing/2014/main" id="{B7DB120F-3DA7-B58B-E963-4372857DD860}"/>
                </a:ext>
              </a:extLst>
            </p:cNvPr>
            <p:cNvSpPr/>
            <p:nvPr/>
          </p:nvSpPr>
          <p:spPr>
            <a:xfrm>
              <a:off x="5323745" y="439161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7" name="pt95">
              <a:extLst>
                <a:ext uri="{FF2B5EF4-FFF2-40B4-BE49-F238E27FC236}">
                  <a16:creationId xmlns:a16="http://schemas.microsoft.com/office/drawing/2014/main" id="{BE44561F-2A9C-A258-2E4B-FFB598D357E0}"/>
                </a:ext>
              </a:extLst>
            </p:cNvPr>
            <p:cNvSpPr/>
            <p:nvPr/>
          </p:nvSpPr>
          <p:spPr>
            <a:xfrm>
              <a:off x="5210601" y="446768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8" name="pt96">
              <a:extLst>
                <a:ext uri="{FF2B5EF4-FFF2-40B4-BE49-F238E27FC236}">
                  <a16:creationId xmlns:a16="http://schemas.microsoft.com/office/drawing/2014/main" id="{63162090-C5F5-FBE7-AFD1-1F1AE84A9A85}"/>
                </a:ext>
              </a:extLst>
            </p:cNvPr>
            <p:cNvSpPr/>
            <p:nvPr/>
          </p:nvSpPr>
          <p:spPr>
            <a:xfrm>
              <a:off x="5183505" y="446768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39" name="pt97">
              <a:extLst>
                <a:ext uri="{FF2B5EF4-FFF2-40B4-BE49-F238E27FC236}">
                  <a16:creationId xmlns:a16="http://schemas.microsoft.com/office/drawing/2014/main" id="{0027CC5A-5AF0-4E07-C03E-755187AD49A9}"/>
                </a:ext>
              </a:extLst>
            </p:cNvPr>
            <p:cNvSpPr/>
            <p:nvPr/>
          </p:nvSpPr>
          <p:spPr>
            <a:xfrm>
              <a:off x="5341561" y="411269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0" name="pt98">
              <a:extLst>
                <a:ext uri="{FF2B5EF4-FFF2-40B4-BE49-F238E27FC236}">
                  <a16:creationId xmlns:a16="http://schemas.microsoft.com/office/drawing/2014/main" id="{39F6D489-1787-64F8-57EB-49C349310488}"/>
                </a:ext>
              </a:extLst>
            </p:cNvPr>
            <p:cNvSpPr/>
            <p:nvPr/>
          </p:nvSpPr>
          <p:spPr>
            <a:xfrm>
              <a:off x="5214206" y="44930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1" name="pt99">
              <a:extLst>
                <a:ext uri="{FF2B5EF4-FFF2-40B4-BE49-F238E27FC236}">
                  <a16:creationId xmlns:a16="http://schemas.microsoft.com/office/drawing/2014/main" id="{97299EA1-7091-6BC1-91E9-B5517214D3CE}"/>
                </a:ext>
              </a:extLst>
            </p:cNvPr>
            <p:cNvSpPr/>
            <p:nvPr/>
          </p:nvSpPr>
          <p:spPr>
            <a:xfrm>
              <a:off x="5197661" y="436625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2" name="pt100">
              <a:extLst>
                <a:ext uri="{FF2B5EF4-FFF2-40B4-BE49-F238E27FC236}">
                  <a16:creationId xmlns:a16="http://schemas.microsoft.com/office/drawing/2014/main" id="{CFE160B4-FEE2-DF3F-78E5-01107ECC49A6}"/>
                </a:ext>
              </a:extLst>
            </p:cNvPr>
            <p:cNvSpPr/>
            <p:nvPr/>
          </p:nvSpPr>
          <p:spPr>
            <a:xfrm>
              <a:off x="5188947"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3" name="pt101">
              <a:extLst>
                <a:ext uri="{FF2B5EF4-FFF2-40B4-BE49-F238E27FC236}">
                  <a16:creationId xmlns:a16="http://schemas.microsoft.com/office/drawing/2014/main" id="{34AFB24A-23E4-C9AF-178A-DAA023FCC347}"/>
                </a:ext>
              </a:extLst>
            </p:cNvPr>
            <p:cNvSpPr/>
            <p:nvPr/>
          </p:nvSpPr>
          <p:spPr>
            <a:xfrm>
              <a:off x="5310195" y="396055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4" name="pt102">
              <a:extLst>
                <a:ext uri="{FF2B5EF4-FFF2-40B4-BE49-F238E27FC236}">
                  <a16:creationId xmlns:a16="http://schemas.microsoft.com/office/drawing/2014/main" id="{E1BD597E-C42F-8880-FB8C-60FAEAB64705}"/>
                </a:ext>
              </a:extLst>
            </p:cNvPr>
            <p:cNvSpPr/>
            <p:nvPr/>
          </p:nvSpPr>
          <p:spPr>
            <a:xfrm>
              <a:off x="5187268" y="446768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5" name="pt103">
              <a:extLst>
                <a:ext uri="{FF2B5EF4-FFF2-40B4-BE49-F238E27FC236}">
                  <a16:creationId xmlns:a16="http://schemas.microsoft.com/office/drawing/2014/main" id="{9A34B301-37EE-27FC-FF3E-4C135480101D}"/>
                </a:ext>
              </a:extLst>
            </p:cNvPr>
            <p:cNvSpPr/>
            <p:nvPr/>
          </p:nvSpPr>
          <p:spPr>
            <a:xfrm>
              <a:off x="5179641"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6" name="pt104">
              <a:extLst>
                <a:ext uri="{FF2B5EF4-FFF2-40B4-BE49-F238E27FC236}">
                  <a16:creationId xmlns:a16="http://schemas.microsoft.com/office/drawing/2014/main" id="{8DCCCDEE-AF02-B146-B720-15FC465448A0}"/>
                </a:ext>
              </a:extLst>
            </p:cNvPr>
            <p:cNvSpPr/>
            <p:nvPr/>
          </p:nvSpPr>
          <p:spPr>
            <a:xfrm>
              <a:off x="5305451" y="444232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7" name="pt105">
              <a:extLst>
                <a:ext uri="{FF2B5EF4-FFF2-40B4-BE49-F238E27FC236}">
                  <a16:creationId xmlns:a16="http://schemas.microsoft.com/office/drawing/2014/main" id="{920AC460-ABF8-B657-FF54-A5182645B15F}"/>
                </a:ext>
              </a:extLst>
            </p:cNvPr>
            <p:cNvSpPr/>
            <p:nvPr/>
          </p:nvSpPr>
          <p:spPr>
            <a:xfrm>
              <a:off x="5171475"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8" name="pt106">
              <a:extLst>
                <a:ext uri="{FF2B5EF4-FFF2-40B4-BE49-F238E27FC236}">
                  <a16:creationId xmlns:a16="http://schemas.microsoft.com/office/drawing/2014/main" id="{5B3CC9DE-AE27-5D68-BE78-9E0DE8AF203F}"/>
                </a:ext>
              </a:extLst>
            </p:cNvPr>
            <p:cNvSpPr/>
            <p:nvPr/>
          </p:nvSpPr>
          <p:spPr>
            <a:xfrm>
              <a:off x="5351732" y="441696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49" name="pt107">
              <a:extLst>
                <a:ext uri="{FF2B5EF4-FFF2-40B4-BE49-F238E27FC236}">
                  <a16:creationId xmlns:a16="http://schemas.microsoft.com/office/drawing/2014/main" id="{3728FC0A-D8F6-D281-EBAE-0A5809D5243D}"/>
                </a:ext>
              </a:extLst>
            </p:cNvPr>
            <p:cNvSpPr/>
            <p:nvPr/>
          </p:nvSpPr>
          <p:spPr>
            <a:xfrm>
              <a:off x="5334486" y="434089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0" name="pt108">
              <a:extLst>
                <a:ext uri="{FF2B5EF4-FFF2-40B4-BE49-F238E27FC236}">
                  <a16:creationId xmlns:a16="http://schemas.microsoft.com/office/drawing/2014/main" id="{0C501AA1-8575-1424-CD0F-C57B6C1E6688}"/>
                </a:ext>
              </a:extLst>
            </p:cNvPr>
            <p:cNvSpPr/>
            <p:nvPr/>
          </p:nvSpPr>
          <p:spPr>
            <a:xfrm>
              <a:off x="5342640" y="436625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1" name="pt109">
              <a:extLst>
                <a:ext uri="{FF2B5EF4-FFF2-40B4-BE49-F238E27FC236}">
                  <a16:creationId xmlns:a16="http://schemas.microsoft.com/office/drawing/2014/main" id="{8CAB332B-D38B-A2B4-3597-EF9537A79498}"/>
                </a:ext>
              </a:extLst>
            </p:cNvPr>
            <p:cNvSpPr/>
            <p:nvPr/>
          </p:nvSpPr>
          <p:spPr>
            <a:xfrm>
              <a:off x="5206730" y="444232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2" name="pt110">
              <a:extLst>
                <a:ext uri="{FF2B5EF4-FFF2-40B4-BE49-F238E27FC236}">
                  <a16:creationId xmlns:a16="http://schemas.microsoft.com/office/drawing/2014/main" id="{8676BD3A-CC20-1131-95B7-D1EA8D53C4AF}"/>
                </a:ext>
              </a:extLst>
            </p:cNvPr>
            <p:cNvSpPr/>
            <p:nvPr/>
          </p:nvSpPr>
          <p:spPr>
            <a:xfrm>
              <a:off x="5190802" y="444232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3" name="pt111">
              <a:extLst>
                <a:ext uri="{FF2B5EF4-FFF2-40B4-BE49-F238E27FC236}">
                  <a16:creationId xmlns:a16="http://schemas.microsoft.com/office/drawing/2014/main" id="{67F5A0FF-28D9-1A42-65FB-CEA300C4D0B5}"/>
                </a:ext>
              </a:extLst>
            </p:cNvPr>
            <p:cNvSpPr/>
            <p:nvPr/>
          </p:nvSpPr>
          <p:spPr>
            <a:xfrm>
              <a:off x="5303272" y="451839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4" name="pt112">
              <a:extLst>
                <a:ext uri="{FF2B5EF4-FFF2-40B4-BE49-F238E27FC236}">
                  <a16:creationId xmlns:a16="http://schemas.microsoft.com/office/drawing/2014/main" id="{FD324FD1-AB5F-E15B-9F53-60E988694FCF}"/>
                </a:ext>
              </a:extLst>
            </p:cNvPr>
            <p:cNvSpPr/>
            <p:nvPr/>
          </p:nvSpPr>
          <p:spPr>
            <a:xfrm>
              <a:off x="5201090" y="439161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5" name="pt113">
              <a:extLst>
                <a:ext uri="{FF2B5EF4-FFF2-40B4-BE49-F238E27FC236}">
                  <a16:creationId xmlns:a16="http://schemas.microsoft.com/office/drawing/2014/main" id="{9821B8DA-F74E-5E64-433A-6C0AFEA40ECB}"/>
                </a:ext>
              </a:extLst>
            </p:cNvPr>
            <p:cNvSpPr/>
            <p:nvPr/>
          </p:nvSpPr>
          <p:spPr>
            <a:xfrm>
              <a:off x="5215490"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6" name="pt114">
              <a:extLst>
                <a:ext uri="{FF2B5EF4-FFF2-40B4-BE49-F238E27FC236}">
                  <a16:creationId xmlns:a16="http://schemas.microsoft.com/office/drawing/2014/main" id="{57E85ECF-F02F-097C-539B-02EBDAE72073}"/>
                </a:ext>
              </a:extLst>
            </p:cNvPr>
            <p:cNvSpPr/>
            <p:nvPr/>
          </p:nvSpPr>
          <p:spPr>
            <a:xfrm>
              <a:off x="5185314"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7" name="pt115">
              <a:extLst>
                <a:ext uri="{FF2B5EF4-FFF2-40B4-BE49-F238E27FC236}">
                  <a16:creationId xmlns:a16="http://schemas.microsoft.com/office/drawing/2014/main" id="{6C256217-D331-32F7-BB86-AEA82255ED19}"/>
                </a:ext>
              </a:extLst>
            </p:cNvPr>
            <p:cNvSpPr/>
            <p:nvPr/>
          </p:nvSpPr>
          <p:spPr>
            <a:xfrm>
              <a:off x="5337028" y="44930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8" name="pt116">
              <a:extLst>
                <a:ext uri="{FF2B5EF4-FFF2-40B4-BE49-F238E27FC236}">
                  <a16:creationId xmlns:a16="http://schemas.microsoft.com/office/drawing/2014/main" id="{0622C3CB-B2C3-CEC8-137D-4F054DD23F9B}"/>
                </a:ext>
              </a:extLst>
            </p:cNvPr>
            <p:cNvSpPr/>
            <p:nvPr/>
          </p:nvSpPr>
          <p:spPr>
            <a:xfrm>
              <a:off x="5183600"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59" name="pt117">
              <a:extLst>
                <a:ext uri="{FF2B5EF4-FFF2-40B4-BE49-F238E27FC236}">
                  <a16:creationId xmlns:a16="http://schemas.microsoft.com/office/drawing/2014/main" id="{5F7A016F-5E9C-4E1C-96B1-F9CE83C83F42}"/>
                </a:ext>
              </a:extLst>
            </p:cNvPr>
            <p:cNvSpPr/>
            <p:nvPr/>
          </p:nvSpPr>
          <p:spPr>
            <a:xfrm>
              <a:off x="5345602" y="396055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0" name="pt118">
              <a:extLst>
                <a:ext uri="{FF2B5EF4-FFF2-40B4-BE49-F238E27FC236}">
                  <a16:creationId xmlns:a16="http://schemas.microsoft.com/office/drawing/2014/main" id="{189BF7F1-96EB-BFB4-4CC2-F2254C77A92E}"/>
                </a:ext>
              </a:extLst>
            </p:cNvPr>
            <p:cNvSpPr/>
            <p:nvPr/>
          </p:nvSpPr>
          <p:spPr>
            <a:xfrm>
              <a:off x="5297488" y="439161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1" name="pt119">
              <a:extLst>
                <a:ext uri="{FF2B5EF4-FFF2-40B4-BE49-F238E27FC236}">
                  <a16:creationId xmlns:a16="http://schemas.microsoft.com/office/drawing/2014/main" id="{6490F6CE-FDAF-ED97-B6E4-C39F2E3531E2}"/>
                </a:ext>
              </a:extLst>
            </p:cNvPr>
            <p:cNvSpPr/>
            <p:nvPr/>
          </p:nvSpPr>
          <p:spPr>
            <a:xfrm>
              <a:off x="5157336" y="451839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2" name="pt120">
              <a:extLst>
                <a:ext uri="{FF2B5EF4-FFF2-40B4-BE49-F238E27FC236}">
                  <a16:creationId xmlns:a16="http://schemas.microsoft.com/office/drawing/2014/main" id="{DECFD731-3DD5-01B1-2575-D14292680A45}"/>
                </a:ext>
              </a:extLst>
            </p:cNvPr>
            <p:cNvSpPr/>
            <p:nvPr/>
          </p:nvSpPr>
          <p:spPr>
            <a:xfrm>
              <a:off x="5329419" y="431554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3" name="pt121">
              <a:extLst>
                <a:ext uri="{FF2B5EF4-FFF2-40B4-BE49-F238E27FC236}">
                  <a16:creationId xmlns:a16="http://schemas.microsoft.com/office/drawing/2014/main" id="{B00C35B8-A96F-1B6D-8D96-E8A1FCBECF4A}"/>
                </a:ext>
              </a:extLst>
            </p:cNvPr>
            <p:cNvSpPr/>
            <p:nvPr/>
          </p:nvSpPr>
          <p:spPr>
            <a:xfrm>
              <a:off x="5186833" y="441696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4" name="pt122">
              <a:extLst>
                <a:ext uri="{FF2B5EF4-FFF2-40B4-BE49-F238E27FC236}">
                  <a16:creationId xmlns:a16="http://schemas.microsoft.com/office/drawing/2014/main" id="{C7C2058C-7EF6-AD3F-7FBC-48B186CB6876}"/>
                </a:ext>
              </a:extLst>
            </p:cNvPr>
            <p:cNvSpPr/>
            <p:nvPr/>
          </p:nvSpPr>
          <p:spPr>
            <a:xfrm>
              <a:off x="5301130" y="393519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5" name="pt123">
              <a:extLst>
                <a:ext uri="{FF2B5EF4-FFF2-40B4-BE49-F238E27FC236}">
                  <a16:creationId xmlns:a16="http://schemas.microsoft.com/office/drawing/2014/main" id="{675D5F2D-A953-3115-2DAC-486809397C91}"/>
                </a:ext>
              </a:extLst>
            </p:cNvPr>
            <p:cNvSpPr/>
            <p:nvPr/>
          </p:nvSpPr>
          <p:spPr>
            <a:xfrm>
              <a:off x="5199371" y="434089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6" name="pt124">
              <a:extLst>
                <a:ext uri="{FF2B5EF4-FFF2-40B4-BE49-F238E27FC236}">
                  <a16:creationId xmlns:a16="http://schemas.microsoft.com/office/drawing/2014/main" id="{897ABA70-9E5C-5A3C-C111-14FFFF01510D}"/>
                </a:ext>
              </a:extLst>
            </p:cNvPr>
            <p:cNvSpPr/>
            <p:nvPr/>
          </p:nvSpPr>
          <p:spPr>
            <a:xfrm>
              <a:off x="5176589" y="436625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7" name="pt125">
              <a:extLst>
                <a:ext uri="{FF2B5EF4-FFF2-40B4-BE49-F238E27FC236}">
                  <a16:creationId xmlns:a16="http://schemas.microsoft.com/office/drawing/2014/main" id="{D9B1CB5F-195F-6BBE-029D-D3E5705756E7}"/>
                </a:ext>
              </a:extLst>
            </p:cNvPr>
            <p:cNvSpPr/>
            <p:nvPr/>
          </p:nvSpPr>
          <p:spPr>
            <a:xfrm>
              <a:off x="5335369" y="3909838"/>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8" name="pt126">
              <a:extLst>
                <a:ext uri="{FF2B5EF4-FFF2-40B4-BE49-F238E27FC236}">
                  <a16:creationId xmlns:a16="http://schemas.microsoft.com/office/drawing/2014/main" id="{C5B0039D-0C3E-4785-BE06-6F1233CC732D}"/>
                </a:ext>
              </a:extLst>
            </p:cNvPr>
            <p:cNvSpPr/>
            <p:nvPr/>
          </p:nvSpPr>
          <p:spPr>
            <a:xfrm>
              <a:off x="5313949" y="44930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69" name="pt127">
              <a:extLst>
                <a:ext uri="{FF2B5EF4-FFF2-40B4-BE49-F238E27FC236}">
                  <a16:creationId xmlns:a16="http://schemas.microsoft.com/office/drawing/2014/main" id="{EFA9D531-9121-B38A-FC27-5645E7BBD6FA}"/>
                </a:ext>
              </a:extLst>
            </p:cNvPr>
            <p:cNvSpPr/>
            <p:nvPr/>
          </p:nvSpPr>
          <p:spPr>
            <a:xfrm>
              <a:off x="5202715" y="421411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0" name="pt128">
              <a:extLst>
                <a:ext uri="{FF2B5EF4-FFF2-40B4-BE49-F238E27FC236}">
                  <a16:creationId xmlns:a16="http://schemas.microsoft.com/office/drawing/2014/main" id="{74BEB0D1-2D52-4ABB-42D3-8699B00EA6DA}"/>
                </a:ext>
              </a:extLst>
            </p:cNvPr>
            <p:cNvSpPr/>
            <p:nvPr/>
          </p:nvSpPr>
          <p:spPr>
            <a:xfrm>
              <a:off x="5171616" y="436625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1" name="pt129">
              <a:extLst>
                <a:ext uri="{FF2B5EF4-FFF2-40B4-BE49-F238E27FC236}">
                  <a16:creationId xmlns:a16="http://schemas.microsoft.com/office/drawing/2014/main" id="{DB376EE6-DB01-9A10-B297-49217DE20508}"/>
                </a:ext>
              </a:extLst>
            </p:cNvPr>
            <p:cNvSpPr/>
            <p:nvPr/>
          </p:nvSpPr>
          <p:spPr>
            <a:xfrm>
              <a:off x="5351526" y="380841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2" name="pt130">
              <a:extLst>
                <a:ext uri="{FF2B5EF4-FFF2-40B4-BE49-F238E27FC236}">
                  <a16:creationId xmlns:a16="http://schemas.microsoft.com/office/drawing/2014/main" id="{B770660C-F4CA-44A2-C06F-E329BCB54B3D}"/>
                </a:ext>
              </a:extLst>
            </p:cNvPr>
            <p:cNvSpPr/>
            <p:nvPr/>
          </p:nvSpPr>
          <p:spPr>
            <a:xfrm>
              <a:off x="5185403" y="446768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3" name="pt131">
              <a:extLst>
                <a:ext uri="{FF2B5EF4-FFF2-40B4-BE49-F238E27FC236}">
                  <a16:creationId xmlns:a16="http://schemas.microsoft.com/office/drawing/2014/main" id="{D7151B0D-F15F-5B86-C8EB-FB3AE22B4D26}"/>
                </a:ext>
              </a:extLst>
            </p:cNvPr>
            <p:cNvSpPr/>
            <p:nvPr/>
          </p:nvSpPr>
          <p:spPr>
            <a:xfrm>
              <a:off x="5159685" y="44930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4" name="pt132">
              <a:extLst>
                <a:ext uri="{FF2B5EF4-FFF2-40B4-BE49-F238E27FC236}">
                  <a16:creationId xmlns:a16="http://schemas.microsoft.com/office/drawing/2014/main" id="{779CF03A-A77A-1671-7E26-1629507A1285}"/>
                </a:ext>
              </a:extLst>
            </p:cNvPr>
            <p:cNvSpPr/>
            <p:nvPr/>
          </p:nvSpPr>
          <p:spPr>
            <a:xfrm>
              <a:off x="5351905" y="449303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5" name="pt133">
              <a:extLst>
                <a:ext uri="{FF2B5EF4-FFF2-40B4-BE49-F238E27FC236}">
                  <a16:creationId xmlns:a16="http://schemas.microsoft.com/office/drawing/2014/main" id="{5831B14B-D673-AC61-42A9-8DD547B4C40A}"/>
                </a:ext>
              </a:extLst>
            </p:cNvPr>
            <p:cNvSpPr/>
            <p:nvPr/>
          </p:nvSpPr>
          <p:spPr>
            <a:xfrm>
              <a:off x="5332055" y="441696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6" name="pt134">
              <a:extLst>
                <a:ext uri="{FF2B5EF4-FFF2-40B4-BE49-F238E27FC236}">
                  <a16:creationId xmlns:a16="http://schemas.microsoft.com/office/drawing/2014/main" id="{01D65EF4-2A2F-2556-E9D2-AD9B24DBDF03}"/>
                </a:ext>
              </a:extLst>
            </p:cNvPr>
            <p:cNvSpPr/>
            <p:nvPr/>
          </p:nvSpPr>
          <p:spPr>
            <a:xfrm>
              <a:off x="5163235" y="44930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7" name="pt135">
              <a:extLst>
                <a:ext uri="{FF2B5EF4-FFF2-40B4-BE49-F238E27FC236}">
                  <a16:creationId xmlns:a16="http://schemas.microsoft.com/office/drawing/2014/main" id="{3BEE3D9E-68C4-E5C1-2F3E-F7DEABE1DE63}"/>
                </a:ext>
              </a:extLst>
            </p:cNvPr>
            <p:cNvSpPr/>
            <p:nvPr/>
          </p:nvSpPr>
          <p:spPr>
            <a:xfrm>
              <a:off x="5326633" y="436625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8" name="pt136">
              <a:extLst>
                <a:ext uri="{FF2B5EF4-FFF2-40B4-BE49-F238E27FC236}">
                  <a16:creationId xmlns:a16="http://schemas.microsoft.com/office/drawing/2014/main" id="{54128AEE-2F13-7FA4-864A-207ED1F3DBF2}"/>
                </a:ext>
              </a:extLst>
            </p:cNvPr>
            <p:cNvSpPr/>
            <p:nvPr/>
          </p:nvSpPr>
          <p:spPr>
            <a:xfrm>
              <a:off x="5327102" y="451839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79" name="pt137">
              <a:extLst>
                <a:ext uri="{FF2B5EF4-FFF2-40B4-BE49-F238E27FC236}">
                  <a16:creationId xmlns:a16="http://schemas.microsoft.com/office/drawing/2014/main" id="{ACB78D8D-3006-3F15-AC1A-3BB53921FEA1}"/>
                </a:ext>
              </a:extLst>
            </p:cNvPr>
            <p:cNvSpPr/>
            <p:nvPr/>
          </p:nvSpPr>
          <p:spPr>
            <a:xfrm>
              <a:off x="5173165" y="441696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0" name="pt138">
              <a:extLst>
                <a:ext uri="{FF2B5EF4-FFF2-40B4-BE49-F238E27FC236}">
                  <a16:creationId xmlns:a16="http://schemas.microsoft.com/office/drawing/2014/main" id="{3E857A0E-130C-8A2E-F989-817A718582F6}"/>
                </a:ext>
              </a:extLst>
            </p:cNvPr>
            <p:cNvSpPr/>
            <p:nvPr/>
          </p:nvSpPr>
          <p:spPr>
            <a:xfrm>
              <a:off x="5165232" y="42901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1" name="pt139">
              <a:extLst>
                <a:ext uri="{FF2B5EF4-FFF2-40B4-BE49-F238E27FC236}">
                  <a16:creationId xmlns:a16="http://schemas.microsoft.com/office/drawing/2014/main" id="{33A514BB-E7DB-7C0D-D2E4-AEE71E99493B}"/>
                </a:ext>
              </a:extLst>
            </p:cNvPr>
            <p:cNvSpPr/>
            <p:nvPr/>
          </p:nvSpPr>
          <p:spPr>
            <a:xfrm>
              <a:off x="5193731" y="408733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2" name="pt140">
              <a:extLst>
                <a:ext uri="{FF2B5EF4-FFF2-40B4-BE49-F238E27FC236}">
                  <a16:creationId xmlns:a16="http://schemas.microsoft.com/office/drawing/2014/main" id="{3B50B67C-41F2-076D-CC88-53AE311728BC}"/>
                </a:ext>
              </a:extLst>
            </p:cNvPr>
            <p:cNvSpPr/>
            <p:nvPr/>
          </p:nvSpPr>
          <p:spPr>
            <a:xfrm>
              <a:off x="5175023" y="446768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3" name="pt141">
              <a:extLst>
                <a:ext uri="{FF2B5EF4-FFF2-40B4-BE49-F238E27FC236}">
                  <a16:creationId xmlns:a16="http://schemas.microsoft.com/office/drawing/2014/main" id="{E99305C6-F324-2F99-9693-6A3B652B9AE1}"/>
                </a:ext>
              </a:extLst>
            </p:cNvPr>
            <p:cNvSpPr/>
            <p:nvPr/>
          </p:nvSpPr>
          <p:spPr>
            <a:xfrm>
              <a:off x="5693859" y="434885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4" name="pt142">
              <a:extLst>
                <a:ext uri="{FF2B5EF4-FFF2-40B4-BE49-F238E27FC236}">
                  <a16:creationId xmlns:a16="http://schemas.microsoft.com/office/drawing/2014/main" id="{FE5AFE4D-867F-F7D8-9DD5-5F250F80631E}"/>
                </a:ext>
              </a:extLst>
            </p:cNvPr>
            <p:cNvSpPr/>
            <p:nvPr/>
          </p:nvSpPr>
          <p:spPr>
            <a:xfrm>
              <a:off x="5605422"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5" name="pt143">
              <a:extLst>
                <a:ext uri="{FF2B5EF4-FFF2-40B4-BE49-F238E27FC236}">
                  <a16:creationId xmlns:a16="http://schemas.microsoft.com/office/drawing/2014/main" id="{14E82E2C-EC8D-B4D6-CD9C-BA8E5D45A159}"/>
                </a:ext>
              </a:extLst>
            </p:cNvPr>
            <p:cNvSpPr/>
            <p:nvPr/>
          </p:nvSpPr>
          <p:spPr>
            <a:xfrm>
              <a:off x="5588021"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6" name="pt144">
              <a:extLst>
                <a:ext uri="{FF2B5EF4-FFF2-40B4-BE49-F238E27FC236}">
                  <a16:creationId xmlns:a16="http://schemas.microsoft.com/office/drawing/2014/main" id="{AF5A1435-DBE8-9DEE-DA11-40F535E8A420}"/>
                </a:ext>
              </a:extLst>
            </p:cNvPr>
            <p:cNvSpPr/>
            <p:nvPr/>
          </p:nvSpPr>
          <p:spPr>
            <a:xfrm>
              <a:off x="5698557" y="399744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7" name="pt145">
              <a:extLst>
                <a:ext uri="{FF2B5EF4-FFF2-40B4-BE49-F238E27FC236}">
                  <a16:creationId xmlns:a16="http://schemas.microsoft.com/office/drawing/2014/main" id="{841585D2-9440-FF32-B98C-186C370A05E2}"/>
                </a:ext>
              </a:extLst>
            </p:cNvPr>
            <p:cNvSpPr/>
            <p:nvPr/>
          </p:nvSpPr>
          <p:spPr>
            <a:xfrm>
              <a:off x="5585931"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8" name="pt146">
              <a:extLst>
                <a:ext uri="{FF2B5EF4-FFF2-40B4-BE49-F238E27FC236}">
                  <a16:creationId xmlns:a16="http://schemas.microsoft.com/office/drawing/2014/main" id="{A1B31D32-CD1A-7CFA-2F58-310EF2400041}"/>
                </a:ext>
              </a:extLst>
            </p:cNvPr>
            <p:cNvSpPr/>
            <p:nvPr/>
          </p:nvSpPr>
          <p:spPr>
            <a:xfrm>
              <a:off x="5572815"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89" name="pt147">
              <a:extLst>
                <a:ext uri="{FF2B5EF4-FFF2-40B4-BE49-F238E27FC236}">
                  <a16:creationId xmlns:a16="http://schemas.microsoft.com/office/drawing/2014/main" id="{9B4F305A-A7AF-3353-C569-7C9C2C516594}"/>
                </a:ext>
              </a:extLst>
            </p:cNvPr>
            <p:cNvSpPr/>
            <p:nvPr/>
          </p:nvSpPr>
          <p:spPr>
            <a:xfrm>
              <a:off x="5568822" y="406772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0" name="pt148">
              <a:extLst>
                <a:ext uri="{FF2B5EF4-FFF2-40B4-BE49-F238E27FC236}">
                  <a16:creationId xmlns:a16="http://schemas.microsoft.com/office/drawing/2014/main" id="{20C30407-011F-1993-AD2A-84D62297CC2A}"/>
                </a:ext>
              </a:extLst>
            </p:cNvPr>
            <p:cNvSpPr/>
            <p:nvPr/>
          </p:nvSpPr>
          <p:spPr>
            <a:xfrm>
              <a:off x="5692837" y="392716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1" name="pt149">
              <a:extLst>
                <a:ext uri="{FF2B5EF4-FFF2-40B4-BE49-F238E27FC236}">
                  <a16:creationId xmlns:a16="http://schemas.microsoft.com/office/drawing/2014/main" id="{0944762A-9439-A55D-C777-A2D2D19B987E}"/>
                </a:ext>
              </a:extLst>
            </p:cNvPr>
            <p:cNvSpPr/>
            <p:nvPr/>
          </p:nvSpPr>
          <p:spPr>
            <a:xfrm>
              <a:off x="5594317"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2" name="pt150">
              <a:extLst>
                <a:ext uri="{FF2B5EF4-FFF2-40B4-BE49-F238E27FC236}">
                  <a16:creationId xmlns:a16="http://schemas.microsoft.com/office/drawing/2014/main" id="{41FA87B8-011D-2CBA-E798-0B22B362D0D3}"/>
                </a:ext>
              </a:extLst>
            </p:cNvPr>
            <p:cNvSpPr/>
            <p:nvPr/>
          </p:nvSpPr>
          <p:spPr>
            <a:xfrm>
              <a:off x="5555997"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3" name="pt151">
              <a:extLst>
                <a:ext uri="{FF2B5EF4-FFF2-40B4-BE49-F238E27FC236}">
                  <a16:creationId xmlns:a16="http://schemas.microsoft.com/office/drawing/2014/main" id="{71EA5620-C97A-C9CA-50C4-39E9CF200AF3}"/>
                </a:ext>
              </a:extLst>
            </p:cNvPr>
            <p:cNvSpPr/>
            <p:nvPr/>
          </p:nvSpPr>
          <p:spPr>
            <a:xfrm>
              <a:off x="5691904" y="427856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4" name="pt152">
              <a:extLst>
                <a:ext uri="{FF2B5EF4-FFF2-40B4-BE49-F238E27FC236}">
                  <a16:creationId xmlns:a16="http://schemas.microsoft.com/office/drawing/2014/main" id="{4711726E-8307-FC6E-9FC6-043B35B0980C}"/>
                </a:ext>
              </a:extLst>
            </p:cNvPr>
            <p:cNvSpPr/>
            <p:nvPr/>
          </p:nvSpPr>
          <p:spPr>
            <a:xfrm>
              <a:off x="5591083" y="406772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5" name="pt153">
              <a:extLst>
                <a:ext uri="{FF2B5EF4-FFF2-40B4-BE49-F238E27FC236}">
                  <a16:creationId xmlns:a16="http://schemas.microsoft.com/office/drawing/2014/main" id="{8E127147-1380-F02A-C3C4-CAC93BBC0E92}"/>
                </a:ext>
              </a:extLst>
            </p:cNvPr>
            <p:cNvSpPr/>
            <p:nvPr/>
          </p:nvSpPr>
          <p:spPr>
            <a:xfrm>
              <a:off x="5727298"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6" name="pt154">
              <a:extLst>
                <a:ext uri="{FF2B5EF4-FFF2-40B4-BE49-F238E27FC236}">
                  <a16:creationId xmlns:a16="http://schemas.microsoft.com/office/drawing/2014/main" id="{717D5BCB-2552-90C9-D39C-814DA7D8A19B}"/>
                </a:ext>
              </a:extLst>
            </p:cNvPr>
            <p:cNvSpPr/>
            <p:nvPr/>
          </p:nvSpPr>
          <p:spPr>
            <a:xfrm>
              <a:off x="5726360" y="413800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7" name="pt155">
              <a:extLst>
                <a:ext uri="{FF2B5EF4-FFF2-40B4-BE49-F238E27FC236}">
                  <a16:creationId xmlns:a16="http://schemas.microsoft.com/office/drawing/2014/main" id="{E1FF0450-B938-4F92-2191-04152CC54C83}"/>
                </a:ext>
              </a:extLst>
            </p:cNvPr>
            <p:cNvSpPr/>
            <p:nvPr/>
          </p:nvSpPr>
          <p:spPr>
            <a:xfrm>
              <a:off x="5712905"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8" name="pt156">
              <a:extLst>
                <a:ext uri="{FF2B5EF4-FFF2-40B4-BE49-F238E27FC236}">
                  <a16:creationId xmlns:a16="http://schemas.microsoft.com/office/drawing/2014/main" id="{1B4021C2-2941-45E3-56FA-A9219A56CEB2}"/>
                </a:ext>
              </a:extLst>
            </p:cNvPr>
            <p:cNvSpPr/>
            <p:nvPr/>
          </p:nvSpPr>
          <p:spPr>
            <a:xfrm>
              <a:off x="5556933"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799" name="pt157">
              <a:extLst>
                <a:ext uri="{FF2B5EF4-FFF2-40B4-BE49-F238E27FC236}">
                  <a16:creationId xmlns:a16="http://schemas.microsoft.com/office/drawing/2014/main" id="{C91AB680-8748-E709-CFAA-DE179AE7AC2D}"/>
                </a:ext>
              </a:extLst>
            </p:cNvPr>
            <p:cNvSpPr/>
            <p:nvPr/>
          </p:nvSpPr>
          <p:spPr>
            <a:xfrm>
              <a:off x="5562165"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0" name="pt158">
              <a:extLst>
                <a:ext uri="{FF2B5EF4-FFF2-40B4-BE49-F238E27FC236}">
                  <a16:creationId xmlns:a16="http://schemas.microsoft.com/office/drawing/2014/main" id="{C51113C1-EE18-2218-3C34-D859EA5012A1}"/>
                </a:ext>
              </a:extLst>
            </p:cNvPr>
            <p:cNvSpPr/>
            <p:nvPr/>
          </p:nvSpPr>
          <p:spPr>
            <a:xfrm>
              <a:off x="5704634"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1" name="pt159">
              <a:extLst>
                <a:ext uri="{FF2B5EF4-FFF2-40B4-BE49-F238E27FC236}">
                  <a16:creationId xmlns:a16="http://schemas.microsoft.com/office/drawing/2014/main" id="{28653F5E-E11B-C91D-E999-1A2C92755B82}"/>
                </a:ext>
              </a:extLst>
            </p:cNvPr>
            <p:cNvSpPr/>
            <p:nvPr/>
          </p:nvSpPr>
          <p:spPr>
            <a:xfrm>
              <a:off x="5562133"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2" name="pt160">
              <a:extLst>
                <a:ext uri="{FF2B5EF4-FFF2-40B4-BE49-F238E27FC236}">
                  <a16:creationId xmlns:a16="http://schemas.microsoft.com/office/drawing/2014/main" id="{AF017F21-6E5A-8E7F-24CB-EC1E9F955CD1}"/>
                </a:ext>
              </a:extLst>
            </p:cNvPr>
            <p:cNvSpPr/>
            <p:nvPr/>
          </p:nvSpPr>
          <p:spPr>
            <a:xfrm>
              <a:off x="5571372"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3" name="pt161">
              <a:extLst>
                <a:ext uri="{FF2B5EF4-FFF2-40B4-BE49-F238E27FC236}">
                  <a16:creationId xmlns:a16="http://schemas.microsoft.com/office/drawing/2014/main" id="{C57B5313-540A-1108-BC30-0877719863DD}"/>
                </a:ext>
              </a:extLst>
            </p:cNvPr>
            <p:cNvSpPr/>
            <p:nvPr/>
          </p:nvSpPr>
          <p:spPr>
            <a:xfrm>
              <a:off x="5605259"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4" name="pt162">
              <a:extLst>
                <a:ext uri="{FF2B5EF4-FFF2-40B4-BE49-F238E27FC236}">
                  <a16:creationId xmlns:a16="http://schemas.microsoft.com/office/drawing/2014/main" id="{001781D6-7179-E423-8CA7-9C6F8E78A045}"/>
                </a:ext>
              </a:extLst>
            </p:cNvPr>
            <p:cNvSpPr/>
            <p:nvPr/>
          </p:nvSpPr>
          <p:spPr>
            <a:xfrm>
              <a:off x="5726837" y="441913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5" name="pt163">
              <a:extLst>
                <a:ext uri="{FF2B5EF4-FFF2-40B4-BE49-F238E27FC236}">
                  <a16:creationId xmlns:a16="http://schemas.microsoft.com/office/drawing/2014/main" id="{DF71FE2A-F6F2-D1FA-F5AF-A50DCFD45A32}"/>
                </a:ext>
              </a:extLst>
            </p:cNvPr>
            <p:cNvSpPr/>
            <p:nvPr/>
          </p:nvSpPr>
          <p:spPr>
            <a:xfrm>
              <a:off x="5593147"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6" name="pt164">
              <a:extLst>
                <a:ext uri="{FF2B5EF4-FFF2-40B4-BE49-F238E27FC236}">
                  <a16:creationId xmlns:a16="http://schemas.microsoft.com/office/drawing/2014/main" id="{9006CEFA-091E-C18E-6B59-EF4BC62E5D7F}"/>
                </a:ext>
              </a:extLst>
            </p:cNvPr>
            <p:cNvSpPr/>
            <p:nvPr/>
          </p:nvSpPr>
          <p:spPr>
            <a:xfrm>
              <a:off x="5729984" y="378659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7" name="pt165">
              <a:extLst>
                <a:ext uri="{FF2B5EF4-FFF2-40B4-BE49-F238E27FC236}">
                  <a16:creationId xmlns:a16="http://schemas.microsoft.com/office/drawing/2014/main" id="{EFA275E5-8514-B445-9F2E-B7B08A6467EE}"/>
                </a:ext>
              </a:extLst>
            </p:cNvPr>
            <p:cNvSpPr/>
            <p:nvPr/>
          </p:nvSpPr>
          <p:spPr>
            <a:xfrm>
              <a:off x="5700357" y="427856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8" name="pt166">
              <a:extLst>
                <a:ext uri="{FF2B5EF4-FFF2-40B4-BE49-F238E27FC236}">
                  <a16:creationId xmlns:a16="http://schemas.microsoft.com/office/drawing/2014/main" id="{906A880D-9E7B-BA4F-55C8-DE1E39244AE2}"/>
                </a:ext>
              </a:extLst>
            </p:cNvPr>
            <p:cNvSpPr/>
            <p:nvPr/>
          </p:nvSpPr>
          <p:spPr>
            <a:xfrm>
              <a:off x="5577469"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09" name="pt167">
              <a:extLst>
                <a:ext uri="{FF2B5EF4-FFF2-40B4-BE49-F238E27FC236}">
                  <a16:creationId xmlns:a16="http://schemas.microsoft.com/office/drawing/2014/main" id="{46B6D307-9B43-3B6E-5580-B85E238451A4}"/>
                </a:ext>
              </a:extLst>
            </p:cNvPr>
            <p:cNvSpPr/>
            <p:nvPr/>
          </p:nvSpPr>
          <p:spPr>
            <a:xfrm>
              <a:off x="5723136"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0" name="pt168">
              <a:extLst>
                <a:ext uri="{FF2B5EF4-FFF2-40B4-BE49-F238E27FC236}">
                  <a16:creationId xmlns:a16="http://schemas.microsoft.com/office/drawing/2014/main" id="{14B36CD8-A9F2-0C65-CB64-142ACC291C4E}"/>
                </a:ext>
              </a:extLst>
            </p:cNvPr>
            <p:cNvSpPr/>
            <p:nvPr/>
          </p:nvSpPr>
          <p:spPr>
            <a:xfrm>
              <a:off x="5586288" y="434885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1" name="pt169">
              <a:extLst>
                <a:ext uri="{FF2B5EF4-FFF2-40B4-BE49-F238E27FC236}">
                  <a16:creationId xmlns:a16="http://schemas.microsoft.com/office/drawing/2014/main" id="{94A09CB2-C542-8C7D-3712-F2346509EC7F}"/>
                </a:ext>
              </a:extLst>
            </p:cNvPr>
            <p:cNvSpPr/>
            <p:nvPr/>
          </p:nvSpPr>
          <p:spPr>
            <a:xfrm>
              <a:off x="5693874" y="392716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2" name="pt170">
              <a:extLst>
                <a:ext uri="{FF2B5EF4-FFF2-40B4-BE49-F238E27FC236}">
                  <a16:creationId xmlns:a16="http://schemas.microsoft.com/office/drawing/2014/main" id="{E42D451E-A328-9BDA-9D11-F9A1FDC83784}"/>
                </a:ext>
              </a:extLst>
            </p:cNvPr>
            <p:cNvSpPr/>
            <p:nvPr/>
          </p:nvSpPr>
          <p:spPr>
            <a:xfrm>
              <a:off x="5598122" y="427856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3" name="pt171">
              <a:extLst>
                <a:ext uri="{FF2B5EF4-FFF2-40B4-BE49-F238E27FC236}">
                  <a16:creationId xmlns:a16="http://schemas.microsoft.com/office/drawing/2014/main" id="{C9724B69-B839-CB51-3D02-B3E832E51ECD}"/>
                </a:ext>
              </a:extLst>
            </p:cNvPr>
            <p:cNvSpPr/>
            <p:nvPr/>
          </p:nvSpPr>
          <p:spPr>
            <a:xfrm>
              <a:off x="5587401" y="413800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4" name="pt172">
              <a:extLst>
                <a:ext uri="{FF2B5EF4-FFF2-40B4-BE49-F238E27FC236}">
                  <a16:creationId xmlns:a16="http://schemas.microsoft.com/office/drawing/2014/main" id="{C9291666-2BC1-DFBA-0B76-BB5A2AE0268F}"/>
                </a:ext>
              </a:extLst>
            </p:cNvPr>
            <p:cNvSpPr/>
            <p:nvPr/>
          </p:nvSpPr>
          <p:spPr>
            <a:xfrm>
              <a:off x="5738103" y="434885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5" name="pt173">
              <a:extLst>
                <a:ext uri="{FF2B5EF4-FFF2-40B4-BE49-F238E27FC236}">
                  <a16:creationId xmlns:a16="http://schemas.microsoft.com/office/drawing/2014/main" id="{60084515-5F87-EED9-05C0-5A632E7C5254}"/>
                </a:ext>
              </a:extLst>
            </p:cNvPr>
            <p:cNvSpPr/>
            <p:nvPr/>
          </p:nvSpPr>
          <p:spPr>
            <a:xfrm>
              <a:off x="5698903" y="441913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6" name="pt174">
              <a:extLst>
                <a:ext uri="{FF2B5EF4-FFF2-40B4-BE49-F238E27FC236}">
                  <a16:creationId xmlns:a16="http://schemas.microsoft.com/office/drawing/2014/main" id="{48CB885C-EFF6-B93E-1504-C4D072B67DF2}"/>
                </a:ext>
              </a:extLst>
            </p:cNvPr>
            <p:cNvSpPr/>
            <p:nvPr/>
          </p:nvSpPr>
          <p:spPr>
            <a:xfrm>
              <a:off x="5550246" y="4208287"/>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7" name="pt175">
              <a:extLst>
                <a:ext uri="{FF2B5EF4-FFF2-40B4-BE49-F238E27FC236}">
                  <a16:creationId xmlns:a16="http://schemas.microsoft.com/office/drawing/2014/main" id="{DF7E46D3-9DB7-6A26-340F-FA07A76A4864}"/>
                </a:ext>
              </a:extLst>
            </p:cNvPr>
            <p:cNvSpPr/>
            <p:nvPr/>
          </p:nvSpPr>
          <p:spPr>
            <a:xfrm>
              <a:off x="5576279"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8" name="pt176">
              <a:extLst>
                <a:ext uri="{FF2B5EF4-FFF2-40B4-BE49-F238E27FC236}">
                  <a16:creationId xmlns:a16="http://schemas.microsoft.com/office/drawing/2014/main" id="{05BA2A01-11DC-A87C-8E0B-D60D0EF01F6B}"/>
                </a:ext>
              </a:extLst>
            </p:cNvPr>
            <p:cNvSpPr/>
            <p:nvPr/>
          </p:nvSpPr>
          <p:spPr>
            <a:xfrm>
              <a:off x="5707810"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19" name="pt177">
              <a:extLst>
                <a:ext uri="{FF2B5EF4-FFF2-40B4-BE49-F238E27FC236}">
                  <a16:creationId xmlns:a16="http://schemas.microsoft.com/office/drawing/2014/main" id="{AA1FA4FF-E55E-3B7D-D568-C682A65783D0}"/>
                </a:ext>
              </a:extLst>
            </p:cNvPr>
            <p:cNvSpPr/>
            <p:nvPr/>
          </p:nvSpPr>
          <p:spPr>
            <a:xfrm>
              <a:off x="5599370" y="434885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0" name="pt178">
              <a:extLst>
                <a:ext uri="{FF2B5EF4-FFF2-40B4-BE49-F238E27FC236}">
                  <a16:creationId xmlns:a16="http://schemas.microsoft.com/office/drawing/2014/main" id="{0659BE77-7F40-4B56-3CE2-06B471ED2AFE}"/>
                </a:ext>
              </a:extLst>
            </p:cNvPr>
            <p:cNvSpPr/>
            <p:nvPr/>
          </p:nvSpPr>
          <p:spPr>
            <a:xfrm>
              <a:off x="5552610"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1" name="pt179">
              <a:extLst>
                <a:ext uri="{FF2B5EF4-FFF2-40B4-BE49-F238E27FC236}">
                  <a16:creationId xmlns:a16="http://schemas.microsoft.com/office/drawing/2014/main" id="{65FA4393-9A56-6E39-B9F0-DF824D5DA9B5}"/>
                </a:ext>
              </a:extLst>
            </p:cNvPr>
            <p:cNvSpPr/>
            <p:nvPr/>
          </p:nvSpPr>
          <p:spPr>
            <a:xfrm>
              <a:off x="5725857"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2" name="pt180">
              <a:extLst>
                <a:ext uri="{FF2B5EF4-FFF2-40B4-BE49-F238E27FC236}">
                  <a16:creationId xmlns:a16="http://schemas.microsoft.com/office/drawing/2014/main" id="{686FFBA0-4466-EE53-5825-11F458C1ECBE}"/>
                </a:ext>
              </a:extLst>
            </p:cNvPr>
            <p:cNvSpPr/>
            <p:nvPr/>
          </p:nvSpPr>
          <p:spPr>
            <a:xfrm>
              <a:off x="5742715"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3" name="pt181">
              <a:extLst>
                <a:ext uri="{FF2B5EF4-FFF2-40B4-BE49-F238E27FC236}">
                  <a16:creationId xmlns:a16="http://schemas.microsoft.com/office/drawing/2014/main" id="{549FD94B-B538-A20A-46E4-1B2352A70740}"/>
                </a:ext>
              </a:extLst>
            </p:cNvPr>
            <p:cNvSpPr/>
            <p:nvPr/>
          </p:nvSpPr>
          <p:spPr>
            <a:xfrm>
              <a:off x="5556962" y="441913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4" name="pt182">
              <a:extLst>
                <a:ext uri="{FF2B5EF4-FFF2-40B4-BE49-F238E27FC236}">
                  <a16:creationId xmlns:a16="http://schemas.microsoft.com/office/drawing/2014/main" id="{4573CB4E-1D0B-A062-D987-6A7217E54F4A}"/>
                </a:ext>
              </a:extLst>
            </p:cNvPr>
            <p:cNvSpPr/>
            <p:nvPr/>
          </p:nvSpPr>
          <p:spPr>
            <a:xfrm>
              <a:off x="5694920" y="448941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5" name="pt183">
              <a:extLst>
                <a:ext uri="{FF2B5EF4-FFF2-40B4-BE49-F238E27FC236}">
                  <a16:creationId xmlns:a16="http://schemas.microsoft.com/office/drawing/2014/main" id="{7C898C9F-4286-13E7-4164-384A0D267E6B}"/>
                </a:ext>
              </a:extLst>
            </p:cNvPr>
            <p:cNvSpPr/>
            <p:nvPr/>
          </p:nvSpPr>
          <p:spPr>
            <a:xfrm>
              <a:off x="5692932" y="434885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6" name="pt184">
              <a:extLst>
                <a:ext uri="{FF2B5EF4-FFF2-40B4-BE49-F238E27FC236}">
                  <a16:creationId xmlns:a16="http://schemas.microsoft.com/office/drawing/2014/main" id="{121A9D2F-F29C-8972-1255-2F015EDF0358}"/>
                </a:ext>
              </a:extLst>
            </p:cNvPr>
            <p:cNvSpPr/>
            <p:nvPr/>
          </p:nvSpPr>
          <p:spPr>
            <a:xfrm>
              <a:off x="5558888" y="441913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7" name="pt185">
              <a:extLst>
                <a:ext uri="{FF2B5EF4-FFF2-40B4-BE49-F238E27FC236}">
                  <a16:creationId xmlns:a16="http://schemas.microsoft.com/office/drawing/2014/main" id="{3CB17B7F-15CC-AA58-A611-126E1ECD1F70}"/>
                </a:ext>
              </a:extLst>
            </p:cNvPr>
            <p:cNvSpPr/>
            <p:nvPr/>
          </p:nvSpPr>
          <p:spPr>
            <a:xfrm>
              <a:off x="5576250"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8" name="pt186">
              <a:extLst>
                <a:ext uri="{FF2B5EF4-FFF2-40B4-BE49-F238E27FC236}">
                  <a16:creationId xmlns:a16="http://schemas.microsoft.com/office/drawing/2014/main" id="{778CEF3B-B683-0813-09F5-29D96DA68CAA}"/>
                </a:ext>
              </a:extLst>
            </p:cNvPr>
            <p:cNvSpPr/>
            <p:nvPr/>
          </p:nvSpPr>
          <p:spPr>
            <a:xfrm>
              <a:off x="5549195"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29" name="pt187">
              <a:extLst>
                <a:ext uri="{FF2B5EF4-FFF2-40B4-BE49-F238E27FC236}">
                  <a16:creationId xmlns:a16="http://schemas.microsoft.com/office/drawing/2014/main" id="{D1D39D2A-B843-4F33-7111-3177D3AC4B1C}"/>
                </a:ext>
              </a:extLst>
            </p:cNvPr>
            <p:cNvSpPr/>
            <p:nvPr/>
          </p:nvSpPr>
          <p:spPr>
            <a:xfrm>
              <a:off x="5603829" y="448941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0" name="pt188">
              <a:extLst>
                <a:ext uri="{FF2B5EF4-FFF2-40B4-BE49-F238E27FC236}">
                  <a16:creationId xmlns:a16="http://schemas.microsoft.com/office/drawing/2014/main" id="{C4FAA901-E7EF-7A3F-AEF6-004AF9427760}"/>
                </a:ext>
              </a:extLst>
            </p:cNvPr>
            <p:cNvSpPr/>
            <p:nvPr/>
          </p:nvSpPr>
          <p:spPr>
            <a:xfrm>
              <a:off x="6117665" y="430665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1" name="pt189">
              <a:extLst>
                <a:ext uri="{FF2B5EF4-FFF2-40B4-BE49-F238E27FC236}">
                  <a16:creationId xmlns:a16="http://schemas.microsoft.com/office/drawing/2014/main" id="{CB2CE952-64FD-50FF-7949-F569100577CF}"/>
                </a:ext>
              </a:extLst>
            </p:cNvPr>
            <p:cNvSpPr/>
            <p:nvPr/>
          </p:nvSpPr>
          <p:spPr>
            <a:xfrm>
              <a:off x="5946100" y="441476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2" name="pt190">
              <a:extLst>
                <a:ext uri="{FF2B5EF4-FFF2-40B4-BE49-F238E27FC236}">
                  <a16:creationId xmlns:a16="http://schemas.microsoft.com/office/drawing/2014/main" id="{FAE9BB70-5AC7-A176-959C-B8524B29DAC1}"/>
                </a:ext>
              </a:extLst>
            </p:cNvPr>
            <p:cNvSpPr/>
            <p:nvPr/>
          </p:nvSpPr>
          <p:spPr>
            <a:xfrm>
              <a:off x="5969881" y="438932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3" name="pt191">
              <a:extLst>
                <a:ext uri="{FF2B5EF4-FFF2-40B4-BE49-F238E27FC236}">
                  <a16:creationId xmlns:a16="http://schemas.microsoft.com/office/drawing/2014/main" id="{6099AB76-C048-AD17-C95E-3309D1767751}"/>
                </a:ext>
              </a:extLst>
            </p:cNvPr>
            <p:cNvSpPr/>
            <p:nvPr/>
          </p:nvSpPr>
          <p:spPr>
            <a:xfrm>
              <a:off x="6089425" y="442748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4" name="pt192">
              <a:extLst>
                <a:ext uri="{FF2B5EF4-FFF2-40B4-BE49-F238E27FC236}">
                  <a16:creationId xmlns:a16="http://schemas.microsoft.com/office/drawing/2014/main" id="{B9018DCD-7AD2-2A87-847B-B45A756218F5}"/>
                </a:ext>
              </a:extLst>
            </p:cNvPr>
            <p:cNvSpPr/>
            <p:nvPr/>
          </p:nvSpPr>
          <p:spPr>
            <a:xfrm>
              <a:off x="5954815" y="409678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5" name="pt193">
              <a:extLst>
                <a:ext uri="{FF2B5EF4-FFF2-40B4-BE49-F238E27FC236}">
                  <a16:creationId xmlns:a16="http://schemas.microsoft.com/office/drawing/2014/main" id="{D4BE5CBB-6585-4AC2-E11B-9F19B36B5BAB}"/>
                </a:ext>
              </a:extLst>
            </p:cNvPr>
            <p:cNvSpPr/>
            <p:nvPr/>
          </p:nvSpPr>
          <p:spPr>
            <a:xfrm>
              <a:off x="5962711" y="428757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6" name="pt194">
              <a:extLst>
                <a:ext uri="{FF2B5EF4-FFF2-40B4-BE49-F238E27FC236}">
                  <a16:creationId xmlns:a16="http://schemas.microsoft.com/office/drawing/2014/main" id="{61239F58-F47B-3729-4531-8414FB8604E0}"/>
                </a:ext>
              </a:extLst>
            </p:cNvPr>
            <p:cNvSpPr/>
            <p:nvPr/>
          </p:nvSpPr>
          <p:spPr>
            <a:xfrm>
              <a:off x="5977851" y="443384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7" name="pt195">
              <a:extLst>
                <a:ext uri="{FF2B5EF4-FFF2-40B4-BE49-F238E27FC236}">
                  <a16:creationId xmlns:a16="http://schemas.microsoft.com/office/drawing/2014/main" id="{E291DCFB-3393-F3F2-FE3B-49A603A2A69A}"/>
                </a:ext>
              </a:extLst>
            </p:cNvPr>
            <p:cNvSpPr/>
            <p:nvPr/>
          </p:nvSpPr>
          <p:spPr>
            <a:xfrm>
              <a:off x="6116035" y="442112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8" name="pt196">
              <a:extLst>
                <a:ext uri="{FF2B5EF4-FFF2-40B4-BE49-F238E27FC236}">
                  <a16:creationId xmlns:a16="http://schemas.microsoft.com/office/drawing/2014/main" id="{831B7D7A-8A12-3344-7C58-C00BA9A4A7E9}"/>
                </a:ext>
              </a:extLst>
            </p:cNvPr>
            <p:cNvSpPr/>
            <p:nvPr/>
          </p:nvSpPr>
          <p:spPr>
            <a:xfrm>
              <a:off x="5966394" y="445292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39" name="pt197">
              <a:extLst>
                <a:ext uri="{FF2B5EF4-FFF2-40B4-BE49-F238E27FC236}">
                  <a16:creationId xmlns:a16="http://schemas.microsoft.com/office/drawing/2014/main" id="{2D47F891-517B-806E-92EF-754DE4E1962B}"/>
                </a:ext>
              </a:extLst>
            </p:cNvPr>
            <p:cNvSpPr/>
            <p:nvPr/>
          </p:nvSpPr>
          <p:spPr>
            <a:xfrm>
              <a:off x="5993939" y="4382965"/>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0" name="pt198">
              <a:extLst>
                <a:ext uri="{FF2B5EF4-FFF2-40B4-BE49-F238E27FC236}">
                  <a16:creationId xmlns:a16="http://schemas.microsoft.com/office/drawing/2014/main" id="{67AF51DB-6C33-1D4F-4742-C0387CE049B8}"/>
                </a:ext>
              </a:extLst>
            </p:cNvPr>
            <p:cNvSpPr/>
            <p:nvPr/>
          </p:nvSpPr>
          <p:spPr>
            <a:xfrm>
              <a:off x="6077052" y="444656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1" name="pt199">
              <a:extLst>
                <a:ext uri="{FF2B5EF4-FFF2-40B4-BE49-F238E27FC236}">
                  <a16:creationId xmlns:a16="http://schemas.microsoft.com/office/drawing/2014/main" id="{25613038-2C0B-9156-DE90-0E2662AAE310}"/>
                </a:ext>
              </a:extLst>
            </p:cNvPr>
            <p:cNvSpPr/>
            <p:nvPr/>
          </p:nvSpPr>
          <p:spPr>
            <a:xfrm>
              <a:off x="5990269" y="427485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2" name="pt200">
              <a:extLst>
                <a:ext uri="{FF2B5EF4-FFF2-40B4-BE49-F238E27FC236}">
                  <a16:creationId xmlns:a16="http://schemas.microsoft.com/office/drawing/2014/main" id="{A0E55468-F128-BEA1-7543-0BADBDB52F65}"/>
                </a:ext>
              </a:extLst>
            </p:cNvPr>
            <p:cNvSpPr/>
            <p:nvPr/>
          </p:nvSpPr>
          <p:spPr>
            <a:xfrm>
              <a:off x="6092424" y="4440646"/>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3" name="pt201">
              <a:extLst>
                <a:ext uri="{FF2B5EF4-FFF2-40B4-BE49-F238E27FC236}">
                  <a16:creationId xmlns:a16="http://schemas.microsoft.com/office/drawing/2014/main" id="{52650070-7E17-EA8F-EA98-03CD2C36D54C}"/>
                </a:ext>
              </a:extLst>
            </p:cNvPr>
            <p:cNvSpPr/>
            <p:nvPr/>
          </p:nvSpPr>
          <p:spPr>
            <a:xfrm>
              <a:off x="6095792" y="4427482"/>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4" name="pt202">
              <a:extLst>
                <a:ext uri="{FF2B5EF4-FFF2-40B4-BE49-F238E27FC236}">
                  <a16:creationId xmlns:a16="http://schemas.microsoft.com/office/drawing/2014/main" id="{153CBCC8-82DA-EF49-FC23-22B3ADF50EE2}"/>
                </a:ext>
              </a:extLst>
            </p:cNvPr>
            <p:cNvSpPr/>
            <p:nvPr/>
          </p:nvSpPr>
          <p:spPr>
            <a:xfrm>
              <a:off x="6110869" y="4452920"/>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5" name="pt203">
              <a:extLst>
                <a:ext uri="{FF2B5EF4-FFF2-40B4-BE49-F238E27FC236}">
                  <a16:creationId xmlns:a16="http://schemas.microsoft.com/office/drawing/2014/main" id="{AFB916E0-775D-0C9E-A056-BB102642FCEB}"/>
                </a:ext>
              </a:extLst>
            </p:cNvPr>
            <p:cNvSpPr/>
            <p:nvPr/>
          </p:nvSpPr>
          <p:spPr>
            <a:xfrm>
              <a:off x="5988413" y="442512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6" name="pt204">
              <a:extLst>
                <a:ext uri="{FF2B5EF4-FFF2-40B4-BE49-F238E27FC236}">
                  <a16:creationId xmlns:a16="http://schemas.microsoft.com/office/drawing/2014/main" id="{4E5770BA-347F-71F3-1989-827CF36686E5}"/>
                </a:ext>
              </a:extLst>
            </p:cNvPr>
            <p:cNvSpPr/>
            <p:nvPr/>
          </p:nvSpPr>
          <p:spPr>
            <a:xfrm>
              <a:off x="5959133" y="439568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7" name="pt206">
              <a:extLst>
                <a:ext uri="{FF2B5EF4-FFF2-40B4-BE49-F238E27FC236}">
                  <a16:creationId xmlns:a16="http://schemas.microsoft.com/office/drawing/2014/main" id="{2D65549E-95B8-FEB9-D865-17CA85B74ED5}"/>
                </a:ext>
              </a:extLst>
            </p:cNvPr>
            <p:cNvSpPr/>
            <p:nvPr/>
          </p:nvSpPr>
          <p:spPr>
            <a:xfrm>
              <a:off x="5942863" y="442112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8" name="pt207">
              <a:extLst>
                <a:ext uri="{FF2B5EF4-FFF2-40B4-BE49-F238E27FC236}">
                  <a16:creationId xmlns:a16="http://schemas.microsoft.com/office/drawing/2014/main" id="{CEF7F783-F851-C8E5-7F59-DC1AB623673B}"/>
                </a:ext>
              </a:extLst>
            </p:cNvPr>
            <p:cNvSpPr/>
            <p:nvPr/>
          </p:nvSpPr>
          <p:spPr>
            <a:xfrm>
              <a:off x="5942071" y="443384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49" name="pt208">
              <a:extLst>
                <a:ext uri="{FF2B5EF4-FFF2-40B4-BE49-F238E27FC236}">
                  <a16:creationId xmlns:a16="http://schemas.microsoft.com/office/drawing/2014/main" id="{DECFD6E6-0B59-6835-E0D7-FBCA43C9723D}"/>
                </a:ext>
              </a:extLst>
            </p:cNvPr>
            <p:cNvSpPr/>
            <p:nvPr/>
          </p:nvSpPr>
          <p:spPr>
            <a:xfrm>
              <a:off x="5950403" y="4338448"/>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0" name="pt209">
              <a:extLst>
                <a:ext uri="{FF2B5EF4-FFF2-40B4-BE49-F238E27FC236}">
                  <a16:creationId xmlns:a16="http://schemas.microsoft.com/office/drawing/2014/main" id="{AE7F7CC8-786E-BE84-C1A7-B66A05032253}"/>
                </a:ext>
              </a:extLst>
            </p:cNvPr>
            <p:cNvSpPr/>
            <p:nvPr/>
          </p:nvSpPr>
          <p:spPr>
            <a:xfrm>
              <a:off x="6086541" y="4452793"/>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1" name="pt210">
              <a:extLst>
                <a:ext uri="{FF2B5EF4-FFF2-40B4-BE49-F238E27FC236}">
                  <a16:creationId xmlns:a16="http://schemas.microsoft.com/office/drawing/2014/main" id="{805446ED-6558-0416-4745-B0596BAD1A99}"/>
                </a:ext>
              </a:extLst>
            </p:cNvPr>
            <p:cNvSpPr/>
            <p:nvPr/>
          </p:nvSpPr>
          <p:spPr>
            <a:xfrm>
              <a:off x="5990342" y="430029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2" name="pt211">
              <a:extLst>
                <a:ext uri="{FF2B5EF4-FFF2-40B4-BE49-F238E27FC236}">
                  <a16:creationId xmlns:a16="http://schemas.microsoft.com/office/drawing/2014/main" id="{7EE8C56C-C3F1-055C-B90E-019D4B6DEE88}"/>
                </a:ext>
              </a:extLst>
            </p:cNvPr>
            <p:cNvSpPr/>
            <p:nvPr/>
          </p:nvSpPr>
          <p:spPr>
            <a:xfrm>
              <a:off x="6107320" y="436388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3" name="pt212">
              <a:extLst>
                <a:ext uri="{FF2B5EF4-FFF2-40B4-BE49-F238E27FC236}">
                  <a16:creationId xmlns:a16="http://schemas.microsoft.com/office/drawing/2014/main" id="{BECA64EF-EEBE-8E54-7B80-F768FB0309F9}"/>
                </a:ext>
              </a:extLst>
            </p:cNvPr>
            <p:cNvSpPr/>
            <p:nvPr/>
          </p:nvSpPr>
          <p:spPr>
            <a:xfrm>
              <a:off x="6093987" y="435752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4" name="pt213">
              <a:extLst>
                <a:ext uri="{FF2B5EF4-FFF2-40B4-BE49-F238E27FC236}">
                  <a16:creationId xmlns:a16="http://schemas.microsoft.com/office/drawing/2014/main" id="{BB26D74E-6A30-2F9A-83C3-BDE79AED8F49}"/>
                </a:ext>
              </a:extLst>
            </p:cNvPr>
            <p:cNvSpPr/>
            <p:nvPr/>
          </p:nvSpPr>
          <p:spPr>
            <a:xfrm>
              <a:off x="5978679" y="4439883"/>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5" name="pt214">
              <a:extLst>
                <a:ext uri="{FF2B5EF4-FFF2-40B4-BE49-F238E27FC236}">
                  <a16:creationId xmlns:a16="http://schemas.microsoft.com/office/drawing/2014/main" id="{8DD7A1B0-AC78-C841-0CB6-80B94AC95B51}"/>
                </a:ext>
              </a:extLst>
            </p:cNvPr>
            <p:cNvSpPr/>
            <p:nvPr/>
          </p:nvSpPr>
          <p:spPr>
            <a:xfrm>
              <a:off x="6133339" y="440439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6" name="pt215">
              <a:extLst>
                <a:ext uri="{FF2B5EF4-FFF2-40B4-BE49-F238E27FC236}">
                  <a16:creationId xmlns:a16="http://schemas.microsoft.com/office/drawing/2014/main" id="{71F84EBD-B694-CEB8-17D8-66235CE7EB5F}"/>
                </a:ext>
              </a:extLst>
            </p:cNvPr>
            <p:cNvSpPr/>
            <p:nvPr/>
          </p:nvSpPr>
          <p:spPr>
            <a:xfrm>
              <a:off x="5952097" y="4370246"/>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7" name="pt216">
              <a:extLst>
                <a:ext uri="{FF2B5EF4-FFF2-40B4-BE49-F238E27FC236}">
                  <a16:creationId xmlns:a16="http://schemas.microsoft.com/office/drawing/2014/main" id="{E9F6CD4E-C0D9-B299-B774-67E3712E209E}"/>
                </a:ext>
              </a:extLst>
            </p:cNvPr>
            <p:cNvSpPr/>
            <p:nvPr/>
          </p:nvSpPr>
          <p:spPr>
            <a:xfrm>
              <a:off x="6109689" y="435752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8" name="pt217">
              <a:extLst>
                <a:ext uri="{FF2B5EF4-FFF2-40B4-BE49-F238E27FC236}">
                  <a16:creationId xmlns:a16="http://schemas.microsoft.com/office/drawing/2014/main" id="{D739C134-45C9-41B0-2833-535CCAD41F82}"/>
                </a:ext>
              </a:extLst>
            </p:cNvPr>
            <p:cNvSpPr/>
            <p:nvPr/>
          </p:nvSpPr>
          <p:spPr>
            <a:xfrm>
              <a:off x="5970680" y="444656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59" name="pt218">
              <a:extLst>
                <a:ext uri="{FF2B5EF4-FFF2-40B4-BE49-F238E27FC236}">
                  <a16:creationId xmlns:a16="http://schemas.microsoft.com/office/drawing/2014/main" id="{4A22C625-99DE-E999-F3FA-50FAC29C948D}"/>
                </a:ext>
              </a:extLst>
            </p:cNvPr>
            <p:cNvSpPr/>
            <p:nvPr/>
          </p:nvSpPr>
          <p:spPr>
            <a:xfrm>
              <a:off x="5946096" y="444020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0" name="pt219">
              <a:extLst>
                <a:ext uri="{FF2B5EF4-FFF2-40B4-BE49-F238E27FC236}">
                  <a16:creationId xmlns:a16="http://schemas.microsoft.com/office/drawing/2014/main" id="{3C872D3A-6115-56D5-58C3-D9B726C1499F}"/>
                </a:ext>
              </a:extLst>
            </p:cNvPr>
            <p:cNvSpPr/>
            <p:nvPr/>
          </p:nvSpPr>
          <p:spPr>
            <a:xfrm>
              <a:off x="6131902" y="4446561"/>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1" name="pt220">
              <a:extLst>
                <a:ext uri="{FF2B5EF4-FFF2-40B4-BE49-F238E27FC236}">
                  <a16:creationId xmlns:a16="http://schemas.microsoft.com/office/drawing/2014/main" id="{92BD1789-EBF9-2517-B445-22168706FDD6}"/>
                </a:ext>
              </a:extLst>
            </p:cNvPr>
            <p:cNvSpPr/>
            <p:nvPr/>
          </p:nvSpPr>
          <p:spPr>
            <a:xfrm>
              <a:off x="6085504" y="436388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2" name="pt221">
              <a:extLst>
                <a:ext uri="{FF2B5EF4-FFF2-40B4-BE49-F238E27FC236}">
                  <a16:creationId xmlns:a16="http://schemas.microsoft.com/office/drawing/2014/main" id="{D55AE42A-F45C-7465-27A1-551CEBDD1C74}"/>
                </a:ext>
              </a:extLst>
            </p:cNvPr>
            <p:cNvSpPr/>
            <p:nvPr/>
          </p:nvSpPr>
          <p:spPr>
            <a:xfrm>
              <a:off x="5943061" y="444656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3" name="pt222">
              <a:extLst>
                <a:ext uri="{FF2B5EF4-FFF2-40B4-BE49-F238E27FC236}">
                  <a16:creationId xmlns:a16="http://schemas.microsoft.com/office/drawing/2014/main" id="{CD4BDC53-29B1-1CBA-905B-EE95B85FF4A9}"/>
                </a:ext>
              </a:extLst>
            </p:cNvPr>
            <p:cNvSpPr/>
            <p:nvPr/>
          </p:nvSpPr>
          <p:spPr>
            <a:xfrm>
              <a:off x="5970394" y="444020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4" name="pt223">
              <a:extLst>
                <a:ext uri="{FF2B5EF4-FFF2-40B4-BE49-F238E27FC236}">
                  <a16:creationId xmlns:a16="http://schemas.microsoft.com/office/drawing/2014/main" id="{C2E9E644-4698-D906-EB27-1B8AB53738B4}"/>
                </a:ext>
              </a:extLst>
            </p:cNvPr>
            <p:cNvSpPr/>
            <p:nvPr/>
          </p:nvSpPr>
          <p:spPr>
            <a:xfrm>
              <a:off x="6111694" y="4236695"/>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5" name="pt224">
              <a:extLst>
                <a:ext uri="{FF2B5EF4-FFF2-40B4-BE49-F238E27FC236}">
                  <a16:creationId xmlns:a16="http://schemas.microsoft.com/office/drawing/2014/main" id="{D5E951D1-14A1-19F1-C7E4-EF4652D02178}"/>
                </a:ext>
              </a:extLst>
            </p:cNvPr>
            <p:cNvSpPr/>
            <p:nvPr/>
          </p:nvSpPr>
          <p:spPr>
            <a:xfrm>
              <a:off x="5952786" y="442748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6" name="pt225">
              <a:extLst>
                <a:ext uri="{FF2B5EF4-FFF2-40B4-BE49-F238E27FC236}">
                  <a16:creationId xmlns:a16="http://schemas.microsoft.com/office/drawing/2014/main" id="{15BEFCE5-232A-8B6A-FD87-9889AE8F3F3D}"/>
                </a:ext>
              </a:extLst>
            </p:cNvPr>
            <p:cNvSpPr/>
            <p:nvPr/>
          </p:nvSpPr>
          <p:spPr>
            <a:xfrm>
              <a:off x="5942323" y="4446561"/>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7" name="pt226">
              <a:extLst>
                <a:ext uri="{FF2B5EF4-FFF2-40B4-BE49-F238E27FC236}">
                  <a16:creationId xmlns:a16="http://schemas.microsoft.com/office/drawing/2014/main" id="{DA190A04-7DA0-77A9-E7A3-5DA13D4AC72D}"/>
                </a:ext>
              </a:extLst>
            </p:cNvPr>
            <p:cNvSpPr/>
            <p:nvPr/>
          </p:nvSpPr>
          <p:spPr>
            <a:xfrm>
              <a:off x="6104426" y="4395684"/>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8" name="pt227">
              <a:extLst>
                <a:ext uri="{FF2B5EF4-FFF2-40B4-BE49-F238E27FC236}">
                  <a16:creationId xmlns:a16="http://schemas.microsoft.com/office/drawing/2014/main" id="{FA876227-6614-0662-D68F-C1CFA021C312}"/>
                </a:ext>
              </a:extLst>
            </p:cNvPr>
            <p:cNvSpPr/>
            <p:nvPr/>
          </p:nvSpPr>
          <p:spPr>
            <a:xfrm>
              <a:off x="6107087" y="4400899"/>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69" name="pt228">
              <a:extLst>
                <a:ext uri="{FF2B5EF4-FFF2-40B4-BE49-F238E27FC236}">
                  <a16:creationId xmlns:a16="http://schemas.microsoft.com/office/drawing/2014/main" id="{847A7F0E-DDF3-95EC-327F-668C1991594B}"/>
                </a:ext>
              </a:extLst>
            </p:cNvPr>
            <p:cNvSpPr/>
            <p:nvPr/>
          </p:nvSpPr>
          <p:spPr>
            <a:xfrm>
              <a:off x="5943256" y="4451139"/>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0" name="pt229">
              <a:extLst>
                <a:ext uri="{FF2B5EF4-FFF2-40B4-BE49-F238E27FC236}">
                  <a16:creationId xmlns:a16="http://schemas.microsoft.com/office/drawing/2014/main" id="{75A2D0A8-B650-ADBA-87AA-F60C0BA8A16E}"/>
                </a:ext>
              </a:extLst>
            </p:cNvPr>
            <p:cNvSpPr/>
            <p:nvPr/>
          </p:nvSpPr>
          <p:spPr>
            <a:xfrm>
              <a:off x="6133210" y="444242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1" name="pt230">
              <a:extLst>
                <a:ext uri="{FF2B5EF4-FFF2-40B4-BE49-F238E27FC236}">
                  <a16:creationId xmlns:a16="http://schemas.microsoft.com/office/drawing/2014/main" id="{4B3DB73D-B404-3531-84A8-20293DD7E47A}"/>
                </a:ext>
              </a:extLst>
            </p:cNvPr>
            <p:cNvSpPr/>
            <p:nvPr/>
          </p:nvSpPr>
          <p:spPr>
            <a:xfrm>
              <a:off x="6086962" y="4419087"/>
              <a:ext cx="16615" cy="16615"/>
            </a:xfrm>
            <a:prstGeom prst="ellipse">
              <a:avLst/>
            </a:prstGeom>
            <a:solidFill>
              <a:srgbClr val="FDE725">
                <a:alpha val="100000"/>
              </a:srgbClr>
            </a:solidFill>
            <a:ln w="9000" cap="rnd">
              <a:solidFill>
                <a:srgbClr val="FDE725">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2" name="pt231">
              <a:extLst>
                <a:ext uri="{FF2B5EF4-FFF2-40B4-BE49-F238E27FC236}">
                  <a16:creationId xmlns:a16="http://schemas.microsoft.com/office/drawing/2014/main" id="{66CA21EB-5E32-1714-1EB7-94688678FD53}"/>
                </a:ext>
              </a:extLst>
            </p:cNvPr>
            <p:cNvSpPr/>
            <p:nvPr/>
          </p:nvSpPr>
          <p:spPr>
            <a:xfrm>
              <a:off x="5977568" y="4312374"/>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3" name="pt232">
              <a:extLst>
                <a:ext uri="{FF2B5EF4-FFF2-40B4-BE49-F238E27FC236}">
                  <a16:creationId xmlns:a16="http://schemas.microsoft.com/office/drawing/2014/main" id="{596AA07E-5B4C-4394-A71E-1030C6C1A027}"/>
                </a:ext>
              </a:extLst>
            </p:cNvPr>
            <p:cNvSpPr/>
            <p:nvPr/>
          </p:nvSpPr>
          <p:spPr>
            <a:xfrm>
              <a:off x="5966305" y="440287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4" name="pt233">
              <a:extLst>
                <a:ext uri="{FF2B5EF4-FFF2-40B4-BE49-F238E27FC236}">
                  <a16:creationId xmlns:a16="http://schemas.microsoft.com/office/drawing/2014/main" id="{DBB08D12-905F-CDDB-30D9-38534F9A44D9}"/>
                </a:ext>
              </a:extLst>
            </p:cNvPr>
            <p:cNvSpPr/>
            <p:nvPr/>
          </p:nvSpPr>
          <p:spPr>
            <a:xfrm>
              <a:off x="5938800" y="4375970"/>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5" name="pt234">
              <a:extLst>
                <a:ext uri="{FF2B5EF4-FFF2-40B4-BE49-F238E27FC236}">
                  <a16:creationId xmlns:a16="http://schemas.microsoft.com/office/drawing/2014/main" id="{A78D5FF3-49A7-D404-4991-8FE7C058D207}"/>
                </a:ext>
              </a:extLst>
            </p:cNvPr>
            <p:cNvSpPr/>
            <p:nvPr/>
          </p:nvSpPr>
          <p:spPr>
            <a:xfrm>
              <a:off x="5961467" y="4421122"/>
              <a:ext cx="16615" cy="16615"/>
            </a:xfrm>
            <a:prstGeom prst="ellipse">
              <a:avLst/>
            </a:prstGeom>
            <a:solidFill>
              <a:srgbClr val="21908C">
                <a:alpha val="100000"/>
              </a:srgbClr>
            </a:solidFill>
            <a:ln w="9000" cap="rnd">
              <a:solidFill>
                <a:srgbClr val="21908C">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76" name="tx235">
              <a:extLst>
                <a:ext uri="{FF2B5EF4-FFF2-40B4-BE49-F238E27FC236}">
                  <a16:creationId xmlns:a16="http://schemas.microsoft.com/office/drawing/2014/main" id="{7157CA95-7EB2-C966-4325-120E0558BE44}"/>
                </a:ext>
              </a:extLst>
            </p:cNvPr>
            <p:cNvSpPr/>
            <p:nvPr/>
          </p:nvSpPr>
          <p:spPr>
            <a:xfrm>
              <a:off x="4837121" y="3388345"/>
              <a:ext cx="70588" cy="18422"/>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a:t>
              </a:r>
            </a:p>
          </p:txBody>
        </p:sp>
        <p:sp>
          <p:nvSpPr>
            <p:cNvPr id="2877" name="tx236">
              <a:extLst>
                <a:ext uri="{FF2B5EF4-FFF2-40B4-BE49-F238E27FC236}">
                  <a16:creationId xmlns:a16="http://schemas.microsoft.com/office/drawing/2014/main" id="{F7A5410A-B8F8-484D-17F9-766622E19B1F}"/>
                </a:ext>
              </a:extLst>
            </p:cNvPr>
            <p:cNvSpPr/>
            <p:nvPr/>
          </p:nvSpPr>
          <p:spPr>
            <a:xfrm>
              <a:off x="5251386" y="3388345"/>
              <a:ext cx="23529" cy="18422"/>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a:t>
              </a:r>
            </a:p>
          </p:txBody>
        </p:sp>
        <p:sp>
          <p:nvSpPr>
            <p:cNvPr id="2878" name="tx237">
              <a:extLst>
                <a:ext uri="{FF2B5EF4-FFF2-40B4-BE49-F238E27FC236}">
                  <a16:creationId xmlns:a16="http://schemas.microsoft.com/office/drawing/2014/main" id="{5F1AC0E7-4E17-49C9-E795-EA41BE14035F}"/>
                </a:ext>
              </a:extLst>
            </p:cNvPr>
            <p:cNvSpPr/>
            <p:nvPr/>
          </p:nvSpPr>
          <p:spPr>
            <a:xfrm>
              <a:off x="5621957" y="3373997"/>
              <a:ext cx="63857" cy="32770"/>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ns</a:t>
              </a:r>
            </a:p>
          </p:txBody>
        </p:sp>
        <p:sp>
          <p:nvSpPr>
            <p:cNvPr id="2879" name="tx238">
              <a:extLst>
                <a:ext uri="{FF2B5EF4-FFF2-40B4-BE49-F238E27FC236}">
                  <a16:creationId xmlns:a16="http://schemas.microsoft.com/office/drawing/2014/main" id="{7D29C6E1-3069-8792-3A45-51BA7CE60D34}"/>
                </a:ext>
              </a:extLst>
            </p:cNvPr>
            <p:cNvSpPr/>
            <p:nvPr/>
          </p:nvSpPr>
          <p:spPr>
            <a:xfrm>
              <a:off x="6012692" y="3373997"/>
              <a:ext cx="63857" cy="32770"/>
            </a:xfrm>
            <a:prstGeom prst="rect">
              <a:avLst/>
            </a:prstGeom>
            <a:noFill/>
          </p:spPr>
          <p:txBody>
            <a:bodyPr wrap="none" lIns="0" tIns="0" rIns="0" bIns="0" anchor="ctr" anchorCtr="1"/>
            <a:lstStyle/>
            <a:p>
              <a:pPr marL="0" marR="0" indent="0" algn="l">
                <a:lnSpc>
                  <a:spcPts val="1422"/>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ns</a:t>
              </a:r>
            </a:p>
          </p:txBody>
        </p:sp>
        <p:sp>
          <p:nvSpPr>
            <p:cNvPr id="2880" name="pl239">
              <a:extLst>
                <a:ext uri="{FF2B5EF4-FFF2-40B4-BE49-F238E27FC236}">
                  <a16:creationId xmlns:a16="http://schemas.microsoft.com/office/drawing/2014/main" id="{E29F556B-9072-6866-3784-2F70B9A0758A}"/>
                </a:ext>
              </a:extLst>
            </p:cNvPr>
            <p:cNvSpPr/>
            <p:nvPr/>
          </p:nvSpPr>
          <p:spPr>
            <a:xfrm>
              <a:off x="4637974" y="3276415"/>
              <a:ext cx="0" cy="1638722"/>
            </a:xfrm>
            <a:custGeom>
              <a:avLst/>
              <a:gdLst/>
              <a:ahLst/>
              <a:cxnLst/>
              <a:rect l="0" t="0" r="0" b="0"/>
              <a:pathLst>
                <a:path h="4896888">
                  <a:moveTo>
                    <a:pt x="0" y="4896888"/>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81" name="tx240">
              <a:extLst>
                <a:ext uri="{FF2B5EF4-FFF2-40B4-BE49-F238E27FC236}">
                  <a16:creationId xmlns:a16="http://schemas.microsoft.com/office/drawing/2014/main" id="{42884872-76E9-0356-549D-6E9C74574659}"/>
                </a:ext>
              </a:extLst>
            </p:cNvPr>
            <p:cNvSpPr/>
            <p:nvPr/>
          </p:nvSpPr>
          <p:spPr>
            <a:xfrm>
              <a:off x="4542144" y="4689612"/>
              <a:ext cx="56684" cy="4582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2</a:t>
              </a:r>
            </a:p>
          </p:txBody>
        </p:sp>
        <p:sp>
          <p:nvSpPr>
            <p:cNvPr id="2882" name="tx241">
              <a:extLst>
                <a:ext uri="{FF2B5EF4-FFF2-40B4-BE49-F238E27FC236}">
                  <a16:creationId xmlns:a16="http://schemas.microsoft.com/office/drawing/2014/main" id="{A08502E6-0052-843F-6DDC-ECAB3321A36E}"/>
                </a:ext>
              </a:extLst>
            </p:cNvPr>
            <p:cNvSpPr/>
            <p:nvPr/>
          </p:nvSpPr>
          <p:spPr>
            <a:xfrm>
              <a:off x="4563373" y="4316397"/>
              <a:ext cx="35455"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0</a:t>
              </a:r>
            </a:p>
          </p:txBody>
        </p:sp>
        <p:sp>
          <p:nvSpPr>
            <p:cNvPr id="2883" name="tx242">
              <a:extLst>
                <a:ext uri="{FF2B5EF4-FFF2-40B4-BE49-F238E27FC236}">
                  <a16:creationId xmlns:a16="http://schemas.microsoft.com/office/drawing/2014/main" id="{C3B609C2-6649-FD39-C39E-9B1F35BDC41A}"/>
                </a:ext>
              </a:extLst>
            </p:cNvPr>
            <p:cNvSpPr/>
            <p:nvPr/>
          </p:nvSpPr>
          <p:spPr>
            <a:xfrm>
              <a:off x="4563373" y="3944738"/>
              <a:ext cx="35455" cy="4582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2</a:t>
              </a:r>
            </a:p>
          </p:txBody>
        </p:sp>
        <p:sp>
          <p:nvSpPr>
            <p:cNvPr id="2884" name="tx243">
              <a:extLst>
                <a:ext uri="{FF2B5EF4-FFF2-40B4-BE49-F238E27FC236}">
                  <a16:creationId xmlns:a16="http://schemas.microsoft.com/office/drawing/2014/main" id="{D0AFEBD3-9EC0-C686-44AE-42E197B17F8D}"/>
                </a:ext>
              </a:extLst>
            </p:cNvPr>
            <p:cNvSpPr/>
            <p:nvPr/>
          </p:nvSpPr>
          <p:spPr>
            <a:xfrm>
              <a:off x="4563373" y="3572488"/>
              <a:ext cx="35455" cy="45633"/>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4</a:t>
              </a:r>
            </a:p>
          </p:txBody>
        </p:sp>
        <p:sp>
          <p:nvSpPr>
            <p:cNvPr id="2885" name="pl244">
              <a:extLst>
                <a:ext uri="{FF2B5EF4-FFF2-40B4-BE49-F238E27FC236}">
                  <a16:creationId xmlns:a16="http://schemas.microsoft.com/office/drawing/2014/main" id="{379CC7AA-2692-EEBC-DFB3-B49A8CC79848}"/>
                </a:ext>
              </a:extLst>
            </p:cNvPr>
            <p:cNvSpPr/>
            <p:nvPr/>
          </p:nvSpPr>
          <p:spPr>
            <a:xfrm>
              <a:off x="4618390" y="4747540"/>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86" name="pl245">
              <a:extLst>
                <a:ext uri="{FF2B5EF4-FFF2-40B4-BE49-F238E27FC236}">
                  <a16:creationId xmlns:a16="http://schemas.microsoft.com/office/drawing/2014/main" id="{A80DC79B-1C77-9F83-BFBE-DD9FE72027B8}"/>
                </a:ext>
              </a:extLst>
            </p:cNvPr>
            <p:cNvSpPr/>
            <p:nvPr/>
          </p:nvSpPr>
          <p:spPr>
            <a:xfrm>
              <a:off x="4618390" y="4375104"/>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87" name="pl246">
              <a:extLst>
                <a:ext uri="{FF2B5EF4-FFF2-40B4-BE49-F238E27FC236}">
                  <a16:creationId xmlns:a16="http://schemas.microsoft.com/office/drawing/2014/main" id="{2F11A5ED-8758-25D5-6632-452E192BB36A}"/>
                </a:ext>
              </a:extLst>
            </p:cNvPr>
            <p:cNvSpPr/>
            <p:nvPr/>
          </p:nvSpPr>
          <p:spPr>
            <a:xfrm>
              <a:off x="4618390" y="4002667"/>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88" name="pl247">
              <a:extLst>
                <a:ext uri="{FF2B5EF4-FFF2-40B4-BE49-F238E27FC236}">
                  <a16:creationId xmlns:a16="http://schemas.microsoft.com/office/drawing/2014/main" id="{901F43EC-34F9-E2E8-356D-C38A7F8D5B67}"/>
                </a:ext>
              </a:extLst>
            </p:cNvPr>
            <p:cNvSpPr/>
            <p:nvPr/>
          </p:nvSpPr>
          <p:spPr>
            <a:xfrm>
              <a:off x="4618390" y="3630230"/>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89" name="pl248">
              <a:extLst>
                <a:ext uri="{FF2B5EF4-FFF2-40B4-BE49-F238E27FC236}">
                  <a16:creationId xmlns:a16="http://schemas.microsoft.com/office/drawing/2014/main" id="{2BBB7B3F-0271-7A48-5D6E-230C9EF4CE9D}"/>
                </a:ext>
              </a:extLst>
            </p:cNvPr>
            <p:cNvSpPr/>
            <p:nvPr/>
          </p:nvSpPr>
          <p:spPr>
            <a:xfrm>
              <a:off x="4637974" y="4915137"/>
              <a:ext cx="1641088" cy="0"/>
            </a:xfrm>
            <a:custGeom>
              <a:avLst/>
              <a:gdLst/>
              <a:ahLst/>
              <a:cxnLst/>
              <a:rect l="0" t="0" r="0" b="0"/>
              <a:pathLst>
                <a:path w="4903957">
                  <a:moveTo>
                    <a:pt x="0" y="0"/>
                  </a:moveTo>
                  <a:lnTo>
                    <a:pt x="4903957"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90" name="pl249">
              <a:extLst>
                <a:ext uri="{FF2B5EF4-FFF2-40B4-BE49-F238E27FC236}">
                  <a16:creationId xmlns:a16="http://schemas.microsoft.com/office/drawing/2014/main" id="{EAFD5389-E02C-72BC-42B7-8552B03E2E8A}"/>
                </a:ext>
              </a:extLst>
            </p:cNvPr>
            <p:cNvSpPr/>
            <p:nvPr/>
          </p:nvSpPr>
          <p:spPr>
            <a:xfrm>
              <a:off x="4872415" y="4915137"/>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91" name="pl250">
              <a:extLst>
                <a:ext uri="{FF2B5EF4-FFF2-40B4-BE49-F238E27FC236}">
                  <a16:creationId xmlns:a16="http://schemas.microsoft.com/office/drawing/2014/main" id="{35915F28-2DAC-AC50-CCAF-E4B78D7DBE88}"/>
                </a:ext>
              </a:extLst>
            </p:cNvPr>
            <p:cNvSpPr/>
            <p:nvPr/>
          </p:nvSpPr>
          <p:spPr>
            <a:xfrm>
              <a:off x="5263150" y="4915137"/>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92" name="pl251">
              <a:extLst>
                <a:ext uri="{FF2B5EF4-FFF2-40B4-BE49-F238E27FC236}">
                  <a16:creationId xmlns:a16="http://schemas.microsoft.com/office/drawing/2014/main" id="{B868B345-D8A2-E696-58B9-047C53F43BB8}"/>
                </a:ext>
              </a:extLst>
            </p:cNvPr>
            <p:cNvSpPr/>
            <p:nvPr/>
          </p:nvSpPr>
          <p:spPr>
            <a:xfrm>
              <a:off x="5653886" y="4915137"/>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93" name="pl252">
              <a:extLst>
                <a:ext uri="{FF2B5EF4-FFF2-40B4-BE49-F238E27FC236}">
                  <a16:creationId xmlns:a16="http://schemas.microsoft.com/office/drawing/2014/main" id="{4528CB75-EC50-4CFF-57FA-9215FF6C8B82}"/>
                </a:ext>
              </a:extLst>
            </p:cNvPr>
            <p:cNvSpPr/>
            <p:nvPr/>
          </p:nvSpPr>
          <p:spPr>
            <a:xfrm>
              <a:off x="6044621" y="4915137"/>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894" name="tx253">
              <a:extLst>
                <a:ext uri="{FF2B5EF4-FFF2-40B4-BE49-F238E27FC236}">
                  <a16:creationId xmlns:a16="http://schemas.microsoft.com/office/drawing/2014/main" id="{F159ECF7-5C5B-C867-D5CE-4A0D346BDDCD}"/>
                </a:ext>
              </a:extLst>
            </p:cNvPr>
            <p:cNvSpPr/>
            <p:nvPr/>
          </p:nvSpPr>
          <p:spPr>
            <a:xfrm>
              <a:off x="4808634" y="4934539"/>
              <a:ext cx="127562"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VAS</a:t>
              </a:r>
            </a:p>
          </p:txBody>
        </p:sp>
        <p:sp>
          <p:nvSpPr>
            <p:cNvPr id="2895" name="tx254">
              <a:extLst>
                <a:ext uri="{FF2B5EF4-FFF2-40B4-BE49-F238E27FC236}">
                  <a16:creationId xmlns:a16="http://schemas.microsoft.com/office/drawing/2014/main" id="{95CF6455-E3B0-ACFF-9E29-41AB381F24CF}"/>
                </a:ext>
              </a:extLst>
            </p:cNvPr>
            <p:cNvSpPr/>
            <p:nvPr/>
          </p:nvSpPr>
          <p:spPr>
            <a:xfrm>
              <a:off x="5204723" y="4934539"/>
              <a:ext cx="116854"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TJC</a:t>
              </a:r>
            </a:p>
          </p:txBody>
        </p:sp>
        <p:sp>
          <p:nvSpPr>
            <p:cNvPr id="2896" name="tx255">
              <a:extLst>
                <a:ext uri="{FF2B5EF4-FFF2-40B4-BE49-F238E27FC236}">
                  <a16:creationId xmlns:a16="http://schemas.microsoft.com/office/drawing/2014/main" id="{2BD28B17-0196-E7D3-D349-B19FD11F7703}"/>
                </a:ext>
              </a:extLst>
            </p:cNvPr>
            <p:cNvSpPr/>
            <p:nvPr/>
          </p:nvSpPr>
          <p:spPr>
            <a:xfrm>
              <a:off x="5593669" y="4934539"/>
              <a:ext cx="120434"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SJC</a:t>
              </a:r>
            </a:p>
          </p:txBody>
        </p:sp>
        <p:sp>
          <p:nvSpPr>
            <p:cNvPr id="2897" name="tx256">
              <a:extLst>
                <a:ext uri="{FF2B5EF4-FFF2-40B4-BE49-F238E27FC236}">
                  <a16:creationId xmlns:a16="http://schemas.microsoft.com/office/drawing/2014/main" id="{A3AE109E-9237-568B-2D3C-1A0C11DEF229}"/>
                </a:ext>
              </a:extLst>
            </p:cNvPr>
            <p:cNvSpPr/>
            <p:nvPr/>
          </p:nvSpPr>
          <p:spPr>
            <a:xfrm>
              <a:off x="5977322" y="4934539"/>
              <a:ext cx="134597"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CRP</a:t>
              </a:r>
            </a:p>
          </p:txBody>
        </p:sp>
        <p:sp>
          <p:nvSpPr>
            <p:cNvPr id="2615" name="tx257">
              <a:extLst>
                <a:ext uri="{FF2B5EF4-FFF2-40B4-BE49-F238E27FC236}">
                  <a16:creationId xmlns:a16="http://schemas.microsoft.com/office/drawing/2014/main" id="{E47CE70D-4600-2CAC-F612-FBC1D91FB7DE}"/>
                </a:ext>
              </a:extLst>
            </p:cNvPr>
            <p:cNvSpPr/>
            <p:nvPr/>
          </p:nvSpPr>
          <p:spPr>
            <a:xfrm rot="16200000">
              <a:off x="4271775" y="4075378"/>
              <a:ext cx="365037" cy="47190"/>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Scaled value</a:t>
              </a:r>
            </a:p>
          </p:txBody>
        </p:sp>
      </p:grpSp>
      <p:grpSp>
        <p:nvGrpSpPr>
          <p:cNvPr id="122" name="组合 121">
            <a:extLst>
              <a:ext uri="{FF2B5EF4-FFF2-40B4-BE49-F238E27FC236}">
                <a16:creationId xmlns:a16="http://schemas.microsoft.com/office/drawing/2014/main" id="{B2316992-E89F-092B-724B-38EF1E0D7BF1}"/>
              </a:ext>
            </a:extLst>
          </p:cNvPr>
          <p:cNvGrpSpPr/>
          <p:nvPr/>
        </p:nvGrpSpPr>
        <p:grpSpPr>
          <a:xfrm>
            <a:off x="383686" y="3280382"/>
            <a:ext cx="1437149" cy="1729097"/>
            <a:chOff x="377379" y="3264524"/>
            <a:chExt cx="1437149" cy="1729097"/>
          </a:xfrm>
        </p:grpSpPr>
        <p:sp>
          <p:nvSpPr>
            <p:cNvPr id="2899" name="pg6">
              <a:extLst>
                <a:ext uri="{FF2B5EF4-FFF2-40B4-BE49-F238E27FC236}">
                  <a16:creationId xmlns:a16="http://schemas.microsoft.com/office/drawing/2014/main" id="{DA1B07B9-D0E4-FA40-2261-F2D1FD4021CC}"/>
                </a:ext>
              </a:extLst>
            </p:cNvPr>
            <p:cNvSpPr/>
            <p:nvPr/>
          </p:nvSpPr>
          <p:spPr>
            <a:xfrm>
              <a:off x="799824" y="3697986"/>
              <a:ext cx="320433" cy="770199"/>
            </a:xfrm>
            <a:custGeom>
              <a:avLst/>
              <a:gdLst/>
              <a:ahLst/>
              <a:cxnLst/>
              <a:rect l="0" t="0" r="0" b="0"/>
              <a:pathLst>
                <a:path w="957528" h="2301537">
                  <a:moveTo>
                    <a:pt x="405054" y="2301537"/>
                  </a:moveTo>
                  <a:lnTo>
                    <a:pt x="404215" y="2297033"/>
                  </a:lnTo>
                  <a:lnTo>
                    <a:pt x="403377" y="2292529"/>
                  </a:lnTo>
                  <a:lnTo>
                    <a:pt x="402544" y="2288025"/>
                  </a:lnTo>
                  <a:lnTo>
                    <a:pt x="401710" y="2283521"/>
                  </a:lnTo>
                  <a:lnTo>
                    <a:pt x="400881" y="2279017"/>
                  </a:lnTo>
                  <a:lnTo>
                    <a:pt x="400053" y="2274513"/>
                  </a:lnTo>
                  <a:lnTo>
                    <a:pt x="399229" y="2270009"/>
                  </a:lnTo>
                  <a:lnTo>
                    <a:pt x="398406" y="2265505"/>
                  </a:lnTo>
                  <a:lnTo>
                    <a:pt x="397587" y="2261001"/>
                  </a:lnTo>
                  <a:lnTo>
                    <a:pt x="396770" y="2256497"/>
                  </a:lnTo>
                  <a:lnTo>
                    <a:pt x="395955" y="2251993"/>
                  </a:lnTo>
                  <a:lnTo>
                    <a:pt x="395145" y="2247489"/>
                  </a:lnTo>
                  <a:lnTo>
                    <a:pt x="394335" y="2242985"/>
                  </a:lnTo>
                  <a:lnTo>
                    <a:pt x="393531" y="2238481"/>
                  </a:lnTo>
                  <a:lnTo>
                    <a:pt x="392727" y="2233977"/>
                  </a:lnTo>
                  <a:lnTo>
                    <a:pt x="391928" y="2229473"/>
                  </a:lnTo>
                  <a:lnTo>
                    <a:pt x="391130" y="2224969"/>
                  </a:lnTo>
                  <a:lnTo>
                    <a:pt x="390336" y="2220465"/>
                  </a:lnTo>
                  <a:lnTo>
                    <a:pt x="389543" y="2215961"/>
                  </a:lnTo>
                  <a:lnTo>
                    <a:pt x="388754" y="2211457"/>
                  </a:lnTo>
                  <a:lnTo>
                    <a:pt x="387967" y="2206953"/>
                  </a:lnTo>
                  <a:lnTo>
                    <a:pt x="387183" y="2202449"/>
                  </a:lnTo>
                  <a:lnTo>
                    <a:pt x="386401" y="2197945"/>
                  </a:lnTo>
                  <a:lnTo>
                    <a:pt x="385620" y="2193441"/>
                  </a:lnTo>
                  <a:lnTo>
                    <a:pt x="384843" y="2188937"/>
                  </a:lnTo>
                  <a:lnTo>
                    <a:pt x="384066" y="2184433"/>
                  </a:lnTo>
                  <a:lnTo>
                    <a:pt x="383292" y="2179929"/>
                  </a:lnTo>
                  <a:lnTo>
                    <a:pt x="382519" y="2175425"/>
                  </a:lnTo>
                  <a:lnTo>
                    <a:pt x="381748" y="2170921"/>
                  </a:lnTo>
                  <a:lnTo>
                    <a:pt x="380978" y="2166418"/>
                  </a:lnTo>
                  <a:lnTo>
                    <a:pt x="380209" y="2161914"/>
                  </a:lnTo>
                  <a:lnTo>
                    <a:pt x="379440" y="2157410"/>
                  </a:lnTo>
                  <a:lnTo>
                    <a:pt x="378672" y="2152906"/>
                  </a:lnTo>
                  <a:lnTo>
                    <a:pt x="377904" y="2148402"/>
                  </a:lnTo>
                  <a:lnTo>
                    <a:pt x="377137" y="2143898"/>
                  </a:lnTo>
                  <a:lnTo>
                    <a:pt x="376368" y="2139394"/>
                  </a:lnTo>
                  <a:lnTo>
                    <a:pt x="375600" y="2134890"/>
                  </a:lnTo>
                  <a:lnTo>
                    <a:pt x="374830" y="2130386"/>
                  </a:lnTo>
                  <a:lnTo>
                    <a:pt x="374059" y="2125882"/>
                  </a:lnTo>
                  <a:lnTo>
                    <a:pt x="373286" y="2121378"/>
                  </a:lnTo>
                  <a:lnTo>
                    <a:pt x="372512" y="2116874"/>
                  </a:lnTo>
                  <a:lnTo>
                    <a:pt x="371734" y="2112370"/>
                  </a:lnTo>
                  <a:lnTo>
                    <a:pt x="370955" y="2107866"/>
                  </a:lnTo>
                  <a:lnTo>
                    <a:pt x="370171" y="2103362"/>
                  </a:lnTo>
                  <a:lnTo>
                    <a:pt x="369385" y="2098858"/>
                  </a:lnTo>
                  <a:lnTo>
                    <a:pt x="368594" y="2094354"/>
                  </a:lnTo>
                  <a:lnTo>
                    <a:pt x="367799" y="2089850"/>
                  </a:lnTo>
                  <a:lnTo>
                    <a:pt x="366999" y="2085346"/>
                  </a:lnTo>
                  <a:lnTo>
                    <a:pt x="366192" y="2080842"/>
                  </a:lnTo>
                  <a:lnTo>
                    <a:pt x="365382" y="2076338"/>
                  </a:lnTo>
                  <a:lnTo>
                    <a:pt x="364562" y="2071834"/>
                  </a:lnTo>
                  <a:lnTo>
                    <a:pt x="363739" y="2067330"/>
                  </a:lnTo>
                  <a:lnTo>
                    <a:pt x="362904" y="2062826"/>
                  </a:lnTo>
                  <a:lnTo>
                    <a:pt x="362066" y="2058322"/>
                  </a:lnTo>
                  <a:lnTo>
                    <a:pt x="361213" y="2053818"/>
                  </a:lnTo>
                  <a:lnTo>
                    <a:pt x="360356" y="2049314"/>
                  </a:lnTo>
                  <a:lnTo>
                    <a:pt x="359485" y="2044810"/>
                  </a:lnTo>
                  <a:lnTo>
                    <a:pt x="358607" y="2040306"/>
                  </a:lnTo>
                  <a:lnTo>
                    <a:pt x="357715" y="2035802"/>
                  </a:lnTo>
                  <a:lnTo>
                    <a:pt x="356813" y="2031298"/>
                  </a:lnTo>
                  <a:lnTo>
                    <a:pt x="355899" y="2026794"/>
                  </a:lnTo>
                  <a:lnTo>
                    <a:pt x="354970" y="2022290"/>
                  </a:lnTo>
                  <a:lnTo>
                    <a:pt x="354031" y="2017786"/>
                  </a:lnTo>
                  <a:lnTo>
                    <a:pt x="353072" y="2013282"/>
                  </a:lnTo>
                  <a:lnTo>
                    <a:pt x="352106" y="2008778"/>
                  </a:lnTo>
                  <a:lnTo>
                    <a:pt x="351114" y="2004274"/>
                  </a:lnTo>
                  <a:lnTo>
                    <a:pt x="350117" y="1999770"/>
                  </a:lnTo>
                  <a:lnTo>
                    <a:pt x="349090" y="1995266"/>
                  </a:lnTo>
                  <a:lnTo>
                    <a:pt x="348056" y="1990762"/>
                  </a:lnTo>
                  <a:lnTo>
                    <a:pt x="346994" y="1986258"/>
                  </a:lnTo>
                  <a:lnTo>
                    <a:pt x="345921" y="1981754"/>
                  </a:lnTo>
                  <a:lnTo>
                    <a:pt x="344822" y="1977250"/>
                  </a:lnTo>
                  <a:lnTo>
                    <a:pt x="343705" y="1972746"/>
                  </a:lnTo>
                  <a:lnTo>
                    <a:pt x="342567" y="1968242"/>
                  </a:lnTo>
                  <a:lnTo>
                    <a:pt x="341403" y="1963738"/>
                  </a:lnTo>
                  <a:lnTo>
                    <a:pt x="340223" y="1959234"/>
                  </a:lnTo>
                  <a:lnTo>
                    <a:pt x="339009" y="1954730"/>
                  </a:lnTo>
                  <a:lnTo>
                    <a:pt x="337784" y="1950226"/>
                  </a:lnTo>
                  <a:lnTo>
                    <a:pt x="336518" y="1945722"/>
                  </a:lnTo>
                  <a:lnTo>
                    <a:pt x="335244" y="1941218"/>
                  </a:lnTo>
                  <a:lnTo>
                    <a:pt x="333922" y="1936714"/>
                  </a:lnTo>
                  <a:lnTo>
                    <a:pt x="332591" y="1932210"/>
                  </a:lnTo>
                  <a:lnTo>
                    <a:pt x="331217" y="1927706"/>
                  </a:lnTo>
                  <a:lnTo>
                    <a:pt x="329826" y="1923202"/>
                  </a:lnTo>
                  <a:lnTo>
                    <a:pt x="328397" y="1918698"/>
                  </a:lnTo>
                  <a:lnTo>
                    <a:pt x="326942" y="1914194"/>
                  </a:lnTo>
                  <a:lnTo>
                    <a:pt x="325456" y="1909690"/>
                  </a:lnTo>
                  <a:lnTo>
                    <a:pt x="323935" y="1905186"/>
                  </a:lnTo>
                  <a:lnTo>
                    <a:pt x="322389" y="1900682"/>
                  </a:lnTo>
                  <a:lnTo>
                    <a:pt x="320798" y="1896178"/>
                  </a:lnTo>
                  <a:lnTo>
                    <a:pt x="319191" y="1891674"/>
                  </a:lnTo>
                  <a:lnTo>
                    <a:pt x="317527" y="1887170"/>
                  </a:lnTo>
                  <a:lnTo>
                    <a:pt x="315854" y="1882666"/>
                  </a:lnTo>
                  <a:lnTo>
                    <a:pt x="314118" y="1878162"/>
                  </a:lnTo>
                  <a:lnTo>
                    <a:pt x="312369" y="1873658"/>
                  </a:lnTo>
                  <a:lnTo>
                    <a:pt x="310564" y="1869154"/>
                  </a:lnTo>
                  <a:lnTo>
                    <a:pt x="308738" y="1864650"/>
                  </a:lnTo>
                  <a:lnTo>
                    <a:pt x="306864" y="1860146"/>
                  </a:lnTo>
                  <a:lnTo>
                    <a:pt x="304957" y="1855642"/>
                  </a:lnTo>
                  <a:lnTo>
                    <a:pt x="303011" y="1851138"/>
                  </a:lnTo>
                  <a:lnTo>
                    <a:pt x="301022" y="1846634"/>
                  </a:lnTo>
                  <a:lnTo>
                    <a:pt x="299004" y="1842130"/>
                  </a:lnTo>
                  <a:lnTo>
                    <a:pt x="296931" y="1837626"/>
                  </a:lnTo>
                  <a:lnTo>
                    <a:pt x="294839" y="1833122"/>
                  </a:lnTo>
                  <a:lnTo>
                    <a:pt x="292681" y="1828618"/>
                  </a:lnTo>
                  <a:lnTo>
                    <a:pt x="290512" y="1824114"/>
                  </a:lnTo>
                  <a:lnTo>
                    <a:pt x="288269" y="1819610"/>
                  </a:lnTo>
                  <a:lnTo>
                    <a:pt x="286014" y="1815106"/>
                  </a:lnTo>
                  <a:lnTo>
                    <a:pt x="283695" y="1810602"/>
                  </a:lnTo>
                  <a:lnTo>
                    <a:pt x="281352" y="1806098"/>
                  </a:lnTo>
                  <a:lnTo>
                    <a:pt x="278956" y="1801595"/>
                  </a:lnTo>
                  <a:lnTo>
                    <a:pt x="276525" y="1797091"/>
                  </a:lnTo>
                  <a:lnTo>
                    <a:pt x="274053" y="1792587"/>
                  </a:lnTo>
                  <a:lnTo>
                    <a:pt x="271535" y="1788083"/>
                  </a:lnTo>
                  <a:lnTo>
                    <a:pt x="268985" y="1783579"/>
                  </a:lnTo>
                  <a:lnTo>
                    <a:pt x="266380" y="1779075"/>
                  </a:lnTo>
                  <a:lnTo>
                    <a:pt x="263755" y="1774571"/>
                  </a:lnTo>
                  <a:lnTo>
                    <a:pt x="261063" y="1770067"/>
                  </a:lnTo>
                  <a:lnTo>
                    <a:pt x="258360" y="1765563"/>
                  </a:lnTo>
                  <a:lnTo>
                    <a:pt x="255585" y="1761059"/>
                  </a:lnTo>
                  <a:lnTo>
                    <a:pt x="252798" y="1756555"/>
                  </a:lnTo>
                  <a:lnTo>
                    <a:pt x="249950" y="1752051"/>
                  </a:lnTo>
                  <a:lnTo>
                    <a:pt x="247079" y="1747547"/>
                  </a:lnTo>
                  <a:lnTo>
                    <a:pt x="244160" y="1743043"/>
                  </a:lnTo>
                  <a:lnTo>
                    <a:pt x="241209" y="1738539"/>
                  </a:lnTo>
                  <a:lnTo>
                    <a:pt x="238220" y="1734035"/>
                  </a:lnTo>
                  <a:lnTo>
                    <a:pt x="235191" y="1729531"/>
                  </a:lnTo>
                  <a:lnTo>
                    <a:pt x="232135" y="1725027"/>
                  </a:lnTo>
                  <a:lnTo>
                    <a:pt x="229031" y="1720523"/>
                  </a:lnTo>
                  <a:lnTo>
                    <a:pt x="225910" y="1716019"/>
                  </a:lnTo>
                  <a:lnTo>
                    <a:pt x="222736" y="1711515"/>
                  </a:lnTo>
                  <a:lnTo>
                    <a:pt x="219552" y="1707011"/>
                  </a:lnTo>
                  <a:lnTo>
                    <a:pt x="216311" y="1702507"/>
                  </a:lnTo>
                  <a:lnTo>
                    <a:pt x="213062" y="1698003"/>
                  </a:lnTo>
                  <a:lnTo>
                    <a:pt x="209766" y="1693499"/>
                  </a:lnTo>
                  <a:lnTo>
                    <a:pt x="206456" y="1688995"/>
                  </a:lnTo>
                  <a:lnTo>
                    <a:pt x="203109" y="1684491"/>
                  </a:lnTo>
                  <a:lnTo>
                    <a:pt x="199742" y="1679987"/>
                  </a:lnTo>
                  <a:lnTo>
                    <a:pt x="196349" y="1675483"/>
                  </a:lnTo>
                  <a:lnTo>
                    <a:pt x="192931" y="1670979"/>
                  </a:lnTo>
                  <a:lnTo>
                    <a:pt x="189496" y="1666475"/>
                  </a:lnTo>
                  <a:lnTo>
                    <a:pt x="186034" y="1661971"/>
                  </a:lnTo>
                  <a:lnTo>
                    <a:pt x="182562" y="1657467"/>
                  </a:lnTo>
                  <a:lnTo>
                    <a:pt x="179061" y="1652963"/>
                  </a:lnTo>
                  <a:lnTo>
                    <a:pt x="175556" y="1648459"/>
                  </a:lnTo>
                  <a:lnTo>
                    <a:pt x="172024" y="1643955"/>
                  </a:lnTo>
                  <a:lnTo>
                    <a:pt x="168489" y="1639451"/>
                  </a:lnTo>
                  <a:lnTo>
                    <a:pt x="164937" y="1634947"/>
                  </a:lnTo>
                  <a:lnTo>
                    <a:pt x="161379" y="1630443"/>
                  </a:lnTo>
                  <a:lnTo>
                    <a:pt x="157811" y="1625939"/>
                  </a:lnTo>
                  <a:lnTo>
                    <a:pt x="154238" y="1621435"/>
                  </a:lnTo>
                  <a:lnTo>
                    <a:pt x="150661" y="1616931"/>
                  </a:lnTo>
                  <a:lnTo>
                    <a:pt x="147081" y="1612427"/>
                  </a:lnTo>
                  <a:lnTo>
                    <a:pt x="143501" y="1607923"/>
                  </a:lnTo>
                  <a:lnTo>
                    <a:pt x="139923" y="1603419"/>
                  </a:lnTo>
                  <a:lnTo>
                    <a:pt x="136345" y="1598915"/>
                  </a:lnTo>
                  <a:lnTo>
                    <a:pt x="132777" y="1594411"/>
                  </a:lnTo>
                  <a:lnTo>
                    <a:pt x="129210" y="1589907"/>
                  </a:lnTo>
                  <a:lnTo>
                    <a:pt x="125660" y="1585403"/>
                  </a:lnTo>
                  <a:lnTo>
                    <a:pt x="122113" y="1580899"/>
                  </a:lnTo>
                  <a:lnTo>
                    <a:pt x="118587" y="1576395"/>
                  </a:lnTo>
                  <a:lnTo>
                    <a:pt x="115070" y="1571891"/>
                  </a:lnTo>
                  <a:lnTo>
                    <a:pt x="111574" y="1567387"/>
                  </a:lnTo>
                  <a:lnTo>
                    <a:pt x="108096" y="1562883"/>
                  </a:lnTo>
                  <a:lnTo>
                    <a:pt x="104638" y="1558379"/>
                  </a:lnTo>
                  <a:lnTo>
                    <a:pt x="101207" y="1553875"/>
                  </a:lnTo>
                  <a:lnTo>
                    <a:pt x="97794" y="1549371"/>
                  </a:lnTo>
                  <a:lnTo>
                    <a:pt x="94420" y="1544867"/>
                  </a:lnTo>
                  <a:lnTo>
                    <a:pt x="91059" y="1540363"/>
                  </a:lnTo>
                  <a:lnTo>
                    <a:pt x="87751" y="1535859"/>
                  </a:lnTo>
                  <a:lnTo>
                    <a:pt x="84451" y="1531355"/>
                  </a:lnTo>
                  <a:lnTo>
                    <a:pt x="81216" y="1526851"/>
                  </a:lnTo>
                  <a:lnTo>
                    <a:pt x="77994" y="1522347"/>
                  </a:lnTo>
                  <a:lnTo>
                    <a:pt x="74833" y="1517843"/>
                  </a:lnTo>
                  <a:lnTo>
                    <a:pt x="71696" y="1513339"/>
                  </a:lnTo>
                  <a:lnTo>
                    <a:pt x="68616" y="1508835"/>
                  </a:lnTo>
                  <a:lnTo>
                    <a:pt x="65574" y="1504331"/>
                  </a:lnTo>
                  <a:lnTo>
                    <a:pt x="62582" y="1499827"/>
                  </a:lnTo>
                  <a:lnTo>
                    <a:pt x="59644" y="1495323"/>
                  </a:lnTo>
                  <a:lnTo>
                    <a:pt x="56746" y="1490819"/>
                  </a:lnTo>
                  <a:lnTo>
                    <a:pt x="53920" y="1486315"/>
                  </a:lnTo>
                  <a:lnTo>
                    <a:pt x="51123" y="1481811"/>
                  </a:lnTo>
                  <a:lnTo>
                    <a:pt x="48418" y="1477307"/>
                  </a:lnTo>
                  <a:lnTo>
                    <a:pt x="45729" y="1472803"/>
                  </a:lnTo>
                  <a:lnTo>
                    <a:pt x="43151" y="1468299"/>
                  </a:lnTo>
                  <a:lnTo>
                    <a:pt x="40593" y="1463795"/>
                  </a:lnTo>
                  <a:lnTo>
                    <a:pt x="38134" y="1459291"/>
                  </a:lnTo>
                  <a:lnTo>
                    <a:pt x="35713" y="1454787"/>
                  </a:lnTo>
                  <a:lnTo>
                    <a:pt x="33380" y="1450283"/>
                  </a:lnTo>
                  <a:lnTo>
                    <a:pt x="31104" y="1445779"/>
                  </a:lnTo>
                  <a:lnTo>
                    <a:pt x="28900" y="1441276"/>
                  </a:lnTo>
                  <a:lnTo>
                    <a:pt x="26776" y="1436772"/>
                  </a:lnTo>
                  <a:lnTo>
                    <a:pt x="24708" y="1432268"/>
                  </a:lnTo>
                  <a:lnTo>
                    <a:pt x="22741" y="1427764"/>
                  </a:lnTo>
                  <a:lnTo>
                    <a:pt x="20812" y="1423260"/>
                  </a:lnTo>
                  <a:lnTo>
                    <a:pt x="19009" y="1418756"/>
                  </a:lnTo>
                  <a:lnTo>
                    <a:pt x="17226" y="1414252"/>
                  </a:lnTo>
                  <a:lnTo>
                    <a:pt x="15590" y="1409748"/>
                  </a:lnTo>
                  <a:lnTo>
                    <a:pt x="13977" y="1405244"/>
                  </a:lnTo>
                  <a:lnTo>
                    <a:pt x="12492" y="1400740"/>
                  </a:lnTo>
                  <a:lnTo>
                    <a:pt x="11053" y="1396236"/>
                  </a:lnTo>
                  <a:lnTo>
                    <a:pt x="9723" y="1391732"/>
                  </a:lnTo>
                  <a:lnTo>
                    <a:pt x="8462" y="1387228"/>
                  </a:lnTo>
                  <a:lnTo>
                    <a:pt x="7289" y="1382724"/>
                  </a:lnTo>
                  <a:lnTo>
                    <a:pt x="6209" y="1378220"/>
                  </a:lnTo>
                  <a:lnTo>
                    <a:pt x="5196" y="1373716"/>
                  </a:lnTo>
                  <a:lnTo>
                    <a:pt x="4300" y="1369212"/>
                  </a:lnTo>
                  <a:lnTo>
                    <a:pt x="3449" y="1364708"/>
                  </a:lnTo>
                  <a:lnTo>
                    <a:pt x="2738" y="1360204"/>
                  </a:lnTo>
                  <a:lnTo>
                    <a:pt x="2051" y="1355700"/>
                  </a:lnTo>
                  <a:lnTo>
                    <a:pt x="1526" y="1351196"/>
                  </a:lnTo>
                  <a:lnTo>
                    <a:pt x="1026" y="1346692"/>
                  </a:lnTo>
                  <a:lnTo>
                    <a:pt x="666" y="1342188"/>
                  </a:lnTo>
                  <a:lnTo>
                    <a:pt x="353" y="1337684"/>
                  </a:lnTo>
                  <a:lnTo>
                    <a:pt x="157" y="1333180"/>
                  </a:lnTo>
                  <a:lnTo>
                    <a:pt x="32" y="1328676"/>
                  </a:lnTo>
                  <a:lnTo>
                    <a:pt x="0" y="1324172"/>
                  </a:lnTo>
                  <a:lnTo>
                    <a:pt x="61" y="1319668"/>
                  </a:lnTo>
                  <a:lnTo>
                    <a:pt x="192" y="1315164"/>
                  </a:lnTo>
                  <a:lnTo>
                    <a:pt x="438" y="1310660"/>
                  </a:lnTo>
                  <a:lnTo>
                    <a:pt x="730" y="1306156"/>
                  </a:lnTo>
                  <a:lnTo>
                    <a:pt x="1160" y="1301652"/>
                  </a:lnTo>
                  <a:lnTo>
                    <a:pt x="1613" y="1297148"/>
                  </a:lnTo>
                  <a:lnTo>
                    <a:pt x="2222" y="1292644"/>
                  </a:lnTo>
                  <a:lnTo>
                    <a:pt x="2854" y="1288140"/>
                  </a:lnTo>
                  <a:lnTo>
                    <a:pt x="3617" y="1283636"/>
                  </a:lnTo>
                  <a:lnTo>
                    <a:pt x="4425" y="1279132"/>
                  </a:lnTo>
                  <a:lnTo>
                    <a:pt x="5340" y="1274628"/>
                  </a:lnTo>
                  <a:lnTo>
                    <a:pt x="6320" y="1270124"/>
                  </a:lnTo>
                  <a:lnTo>
                    <a:pt x="7383" y="1265620"/>
                  </a:lnTo>
                  <a:lnTo>
                    <a:pt x="8530" y="1261116"/>
                  </a:lnTo>
                  <a:lnTo>
                    <a:pt x="9737" y="1256612"/>
                  </a:lnTo>
                  <a:lnTo>
                    <a:pt x="11045" y="1252108"/>
                  </a:lnTo>
                  <a:lnTo>
                    <a:pt x="12393" y="1247604"/>
                  </a:lnTo>
                  <a:lnTo>
                    <a:pt x="13857" y="1243100"/>
                  </a:lnTo>
                  <a:lnTo>
                    <a:pt x="15340" y="1238596"/>
                  </a:lnTo>
                  <a:lnTo>
                    <a:pt x="16953" y="1234092"/>
                  </a:lnTo>
                  <a:lnTo>
                    <a:pt x="18584" y="1229588"/>
                  </a:lnTo>
                  <a:lnTo>
                    <a:pt x="20322" y="1225084"/>
                  </a:lnTo>
                  <a:lnTo>
                    <a:pt x="22095" y="1220580"/>
                  </a:lnTo>
                  <a:lnTo>
                    <a:pt x="23952" y="1216076"/>
                  </a:lnTo>
                  <a:lnTo>
                    <a:pt x="25859" y="1211572"/>
                  </a:lnTo>
                  <a:lnTo>
                    <a:pt x="27830" y="1207068"/>
                  </a:lnTo>
                  <a:lnTo>
                    <a:pt x="29863" y="1202564"/>
                  </a:lnTo>
                  <a:lnTo>
                    <a:pt x="31942" y="1198060"/>
                  </a:lnTo>
                  <a:lnTo>
                    <a:pt x="34094" y="1193556"/>
                  </a:lnTo>
                  <a:lnTo>
                    <a:pt x="36274" y="1189052"/>
                  </a:lnTo>
                  <a:lnTo>
                    <a:pt x="38536" y="1184548"/>
                  </a:lnTo>
                  <a:lnTo>
                    <a:pt x="40811" y="1180044"/>
                  </a:lnTo>
                  <a:lnTo>
                    <a:pt x="43175" y="1175540"/>
                  </a:lnTo>
                  <a:lnTo>
                    <a:pt x="45550" y="1171036"/>
                  </a:lnTo>
                  <a:lnTo>
                    <a:pt x="47995" y="1166532"/>
                  </a:lnTo>
                  <a:lnTo>
                    <a:pt x="50461" y="1162028"/>
                  </a:lnTo>
                  <a:lnTo>
                    <a:pt x="52981" y="1157524"/>
                  </a:lnTo>
                  <a:lnTo>
                    <a:pt x="55530" y="1153020"/>
                  </a:lnTo>
                  <a:lnTo>
                    <a:pt x="58117" y="1148516"/>
                  </a:lnTo>
                  <a:lnTo>
                    <a:pt x="60739" y="1144012"/>
                  </a:lnTo>
                  <a:lnTo>
                    <a:pt x="63387" y="1139508"/>
                  </a:lnTo>
                  <a:lnTo>
                    <a:pt x="66074" y="1135004"/>
                  </a:lnTo>
                  <a:lnTo>
                    <a:pt x="68776" y="1130500"/>
                  </a:lnTo>
                  <a:lnTo>
                    <a:pt x="71518" y="1125996"/>
                  </a:lnTo>
                  <a:lnTo>
                    <a:pt x="74267" y="1121492"/>
                  </a:lnTo>
                  <a:lnTo>
                    <a:pt x="77055" y="1116988"/>
                  </a:lnTo>
                  <a:lnTo>
                    <a:pt x="79848" y="1112484"/>
                  </a:lnTo>
                  <a:lnTo>
                    <a:pt x="82669" y="1107980"/>
                  </a:lnTo>
                  <a:lnTo>
                    <a:pt x="85498" y="1103476"/>
                  </a:lnTo>
                  <a:lnTo>
                    <a:pt x="88346" y="1098972"/>
                  </a:lnTo>
                  <a:lnTo>
                    <a:pt x="91201" y="1094468"/>
                  </a:lnTo>
                  <a:lnTo>
                    <a:pt x="94068" y="1089964"/>
                  </a:lnTo>
                  <a:lnTo>
                    <a:pt x="96942" y="1085460"/>
                  </a:lnTo>
                  <a:lnTo>
                    <a:pt x="99821" y="1080957"/>
                  </a:lnTo>
                  <a:lnTo>
                    <a:pt x="102705" y="1076453"/>
                  </a:lnTo>
                  <a:lnTo>
                    <a:pt x="105590" y="1071949"/>
                  </a:lnTo>
                  <a:lnTo>
                    <a:pt x="108476" y="1067445"/>
                  </a:lnTo>
                  <a:lnTo>
                    <a:pt x="111361" y="1062941"/>
                  </a:lnTo>
                  <a:lnTo>
                    <a:pt x="114241" y="1058437"/>
                  </a:lnTo>
                  <a:lnTo>
                    <a:pt x="117118" y="1053933"/>
                  </a:lnTo>
                  <a:lnTo>
                    <a:pt x="119985" y="1049429"/>
                  </a:lnTo>
                  <a:lnTo>
                    <a:pt x="122848" y="1044925"/>
                  </a:lnTo>
                  <a:lnTo>
                    <a:pt x="125697" y="1040421"/>
                  </a:lnTo>
                  <a:lnTo>
                    <a:pt x="128537" y="1035917"/>
                  </a:lnTo>
                  <a:lnTo>
                    <a:pt x="131363" y="1031413"/>
                  </a:lnTo>
                  <a:lnTo>
                    <a:pt x="134174" y="1026909"/>
                  </a:lnTo>
                  <a:lnTo>
                    <a:pt x="136972" y="1022405"/>
                  </a:lnTo>
                  <a:lnTo>
                    <a:pt x="139746" y="1017901"/>
                  </a:lnTo>
                  <a:lnTo>
                    <a:pt x="142511" y="1013397"/>
                  </a:lnTo>
                  <a:lnTo>
                    <a:pt x="145244" y="1008893"/>
                  </a:lnTo>
                  <a:lnTo>
                    <a:pt x="147971" y="1004389"/>
                  </a:lnTo>
                  <a:lnTo>
                    <a:pt x="150656" y="999885"/>
                  </a:lnTo>
                  <a:lnTo>
                    <a:pt x="153334" y="995381"/>
                  </a:lnTo>
                  <a:lnTo>
                    <a:pt x="155973" y="990877"/>
                  </a:lnTo>
                  <a:lnTo>
                    <a:pt x="158597" y="986373"/>
                  </a:lnTo>
                  <a:lnTo>
                    <a:pt x="161186" y="981869"/>
                  </a:lnTo>
                  <a:lnTo>
                    <a:pt x="163752" y="977365"/>
                  </a:lnTo>
                  <a:lnTo>
                    <a:pt x="166287" y="972861"/>
                  </a:lnTo>
                  <a:lnTo>
                    <a:pt x="168790" y="968357"/>
                  </a:lnTo>
                  <a:lnTo>
                    <a:pt x="171268" y="963853"/>
                  </a:lnTo>
                  <a:lnTo>
                    <a:pt x="173704" y="959349"/>
                  </a:lnTo>
                  <a:lnTo>
                    <a:pt x="176123" y="954845"/>
                  </a:lnTo>
                  <a:lnTo>
                    <a:pt x="178490" y="950341"/>
                  </a:lnTo>
                  <a:lnTo>
                    <a:pt x="180846" y="945837"/>
                  </a:lnTo>
                  <a:lnTo>
                    <a:pt x="183139" y="941333"/>
                  </a:lnTo>
                  <a:lnTo>
                    <a:pt x="185423" y="936829"/>
                  </a:lnTo>
                  <a:lnTo>
                    <a:pt x="187649" y="932325"/>
                  </a:lnTo>
                  <a:lnTo>
                    <a:pt x="189857" y="927821"/>
                  </a:lnTo>
                  <a:lnTo>
                    <a:pt x="192015" y="923317"/>
                  </a:lnTo>
                  <a:lnTo>
                    <a:pt x="194145" y="918813"/>
                  </a:lnTo>
                  <a:lnTo>
                    <a:pt x="196234" y="914309"/>
                  </a:lnTo>
                  <a:lnTo>
                    <a:pt x="198283" y="909805"/>
                  </a:lnTo>
                  <a:lnTo>
                    <a:pt x="200302" y="905301"/>
                  </a:lnTo>
                  <a:lnTo>
                    <a:pt x="202271" y="900797"/>
                  </a:lnTo>
                  <a:lnTo>
                    <a:pt x="204218" y="896293"/>
                  </a:lnTo>
                  <a:lnTo>
                    <a:pt x="206105" y="891789"/>
                  </a:lnTo>
                  <a:lnTo>
                    <a:pt x="207981" y="887285"/>
                  </a:lnTo>
                  <a:lnTo>
                    <a:pt x="209785" y="882781"/>
                  </a:lnTo>
                  <a:lnTo>
                    <a:pt x="211579" y="878277"/>
                  </a:lnTo>
                  <a:lnTo>
                    <a:pt x="213311" y="873773"/>
                  </a:lnTo>
                  <a:lnTo>
                    <a:pt x="215022" y="869269"/>
                  </a:lnTo>
                  <a:lnTo>
                    <a:pt x="216682" y="864765"/>
                  </a:lnTo>
                  <a:lnTo>
                    <a:pt x="218311" y="860261"/>
                  </a:lnTo>
                  <a:lnTo>
                    <a:pt x="219899" y="855757"/>
                  </a:lnTo>
                  <a:lnTo>
                    <a:pt x="221447" y="851253"/>
                  </a:lnTo>
                  <a:lnTo>
                    <a:pt x="222963" y="846749"/>
                  </a:lnTo>
                  <a:lnTo>
                    <a:pt x="224430" y="842245"/>
                  </a:lnTo>
                  <a:lnTo>
                    <a:pt x="225876" y="837741"/>
                  </a:lnTo>
                  <a:lnTo>
                    <a:pt x="227263" y="833237"/>
                  </a:lnTo>
                  <a:lnTo>
                    <a:pt x="228639" y="828733"/>
                  </a:lnTo>
                  <a:lnTo>
                    <a:pt x="229948" y="824229"/>
                  </a:lnTo>
                  <a:lnTo>
                    <a:pt x="231247" y="819725"/>
                  </a:lnTo>
                  <a:lnTo>
                    <a:pt x="232488" y="815221"/>
                  </a:lnTo>
                  <a:lnTo>
                    <a:pt x="233711" y="810717"/>
                  </a:lnTo>
                  <a:lnTo>
                    <a:pt x="234885" y="806213"/>
                  </a:lnTo>
                  <a:lnTo>
                    <a:pt x="236033" y="801709"/>
                  </a:lnTo>
                  <a:lnTo>
                    <a:pt x="237143" y="797205"/>
                  </a:lnTo>
                  <a:lnTo>
                    <a:pt x="238219" y="792701"/>
                  </a:lnTo>
                  <a:lnTo>
                    <a:pt x="239266" y="788197"/>
                  </a:lnTo>
                  <a:lnTo>
                    <a:pt x="240270" y="783693"/>
                  </a:lnTo>
                  <a:lnTo>
                    <a:pt x="241256" y="779189"/>
                  </a:lnTo>
                  <a:lnTo>
                    <a:pt x="242192" y="774685"/>
                  </a:lnTo>
                  <a:lnTo>
                    <a:pt x="243118" y="770181"/>
                  </a:lnTo>
                  <a:lnTo>
                    <a:pt x="243988" y="765677"/>
                  </a:lnTo>
                  <a:lnTo>
                    <a:pt x="244849" y="761173"/>
                  </a:lnTo>
                  <a:lnTo>
                    <a:pt x="245662" y="756669"/>
                  </a:lnTo>
                  <a:lnTo>
                    <a:pt x="246460" y="752165"/>
                  </a:lnTo>
                  <a:lnTo>
                    <a:pt x="247219" y="747661"/>
                  </a:lnTo>
                  <a:lnTo>
                    <a:pt x="247956" y="743157"/>
                  </a:lnTo>
                  <a:lnTo>
                    <a:pt x="248663" y="738653"/>
                  </a:lnTo>
                  <a:lnTo>
                    <a:pt x="249342" y="734149"/>
                  </a:lnTo>
                  <a:lnTo>
                    <a:pt x="249999" y="729645"/>
                  </a:lnTo>
                  <a:lnTo>
                    <a:pt x="250622" y="725141"/>
                  </a:lnTo>
                  <a:lnTo>
                    <a:pt x="251231" y="720638"/>
                  </a:lnTo>
                  <a:lnTo>
                    <a:pt x="251801" y="716134"/>
                  </a:lnTo>
                  <a:lnTo>
                    <a:pt x="252363" y="711630"/>
                  </a:lnTo>
                  <a:lnTo>
                    <a:pt x="252883" y="707126"/>
                  </a:lnTo>
                  <a:lnTo>
                    <a:pt x="253396" y="702622"/>
                  </a:lnTo>
                  <a:lnTo>
                    <a:pt x="253873" y="698118"/>
                  </a:lnTo>
                  <a:lnTo>
                    <a:pt x="254338" y="693614"/>
                  </a:lnTo>
                  <a:lnTo>
                    <a:pt x="254775" y="689110"/>
                  </a:lnTo>
                  <a:lnTo>
                    <a:pt x="255196" y="684606"/>
                  </a:lnTo>
                  <a:lnTo>
                    <a:pt x="255595" y="680102"/>
                  </a:lnTo>
                  <a:lnTo>
                    <a:pt x="255974" y="675598"/>
                  </a:lnTo>
                  <a:lnTo>
                    <a:pt x="256336" y="671094"/>
                  </a:lnTo>
                  <a:lnTo>
                    <a:pt x="256675" y="666590"/>
                  </a:lnTo>
                  <a:lnTo>
                    <a:pt x="257004" y="662086"/>
                  </a:lnTo>
                  <a:lnTo>
                    <a:pt x="257306" y="657582"/>
                  </a:lnTo>
                  <a:lnTo>
                    <a:pt x="257603" y="653078"/>
                  </a:lnTo>
                  <a:lnTo>
                    <a:pt x="257870" y="648574"/>
                  </a:lnTo>
                  <a:lnTo>
                    <a:pt x="258134" y="644070"/>
                  </a:lnTo>
                  <a:lnTo>
                    <a:pt x="258372" y="639566"/>
                  </a:lnTo>
                  <a:lnTo>
                    <a:pt x="258604" y="635062"/>
                  </a:lnTo>
                  <a:lnTo>
                    <a:pt x="258816" y="630558"/>
                  </a:lnTo>
                  <a:lnTo>
                    <a:pt x="259019" y="626054"/>
                  </a:lnTo>
                  <a:lnTo>
                    <a:pt x="259207" y="621550"/>
                  </a:lnTo>
                  <a:lnTo>
                    <a:pt x="259382" y="617046"/>
                  </a:lnTo>
                  <a:lnTo>
                    <a:pt x="259548" y="612542"/>
                  </a:lnTo>
                  <a:lnTo>
                    <a:pt x="259699" y="608038"/>
                  </a:lnTo>
                  <a:lnTo>
                    <a:pt x="259845" y="603534"/>
                  </a:lnTo>
                  <a:lnTo>
                    <a:pt x="259974" y="599030"/>
                  </a:lnTo>
                  <a:lnTo>
                    <a:pt x="260100" y="594526"/>
                  </a:lnTo>
                  <a:lnTo>
                    <a:pt x="260210" y="590022"/>
                  </a:lnTo>
                  <a:lnTo>
                    <a:pt x="260318" y="585518"/>
                  </a:lnTo>
                  <a:lnTo>
                    <a:pt x="260412" y="581014"/>
                  </a:lnTo>
                  <a:lnTo>
                    <a:pt x="260503" y="576510"/>
                  </a:lnTo>
                  <a:lnTo>
                    <a:pt x="260584" y="572006"/>
                  </a:lnTo>
                  <a:lnTo>
                    <a:pt x="260660" y="567502"/>
                  </a:lnTo>
                  <a:lnTo>
                    <a:pt x="260730" y="562998"/>
                  </a:lnTo>
                  <a:lnTo>
                    <a:pt x="260794" y="558494"/>
                  </a:lnTo>
                  <a:lnTo>
                    <a:pt x="260854" y="553990"/>
                  </a:lnTo>
                  <a:lnTo>
                    <a:pt x="260908" y="549486"/>
                  </a:lnTo>
                  <a:lnTo>
                    <a:pt x="260960" y="544982"/>
                  </a:lnTo>
                  <a:lnTo>
                    <a:pt x="261007" y="540478"/>
                  </a:lnTo>
                  <a:lnTo>
                    <a:pt x="261052" y="535974"/>
                  </a:lnTo>
                  <a:lnTo>
                    <a:pt x="261094" y="531470"/>
                  </a:lnTo>
                  <a:lnTo>
                    <a:pt x="261135" y="526966"/>
                  </a:lnTo>
                  <a:lnTo>
                    <a:pt x="261173" y="522462"/>
                  </a:lnTo>
                  <a:lnTo>
                    <a:pt x="261211" y="517958"/>
                  </a:lnTo>
                  <a:lnTo>
                    <a:pt x="261249" y="513454"/>
                  </a:lnTo>
                  <a:lnTo>
                    <a:pt x="261287" y="508950"/>
                  </a:lnTo>
                  <a:lnTo>
                    <a:pt x="261325" y="504446"/>
                  </a:lnTo>
                  <a:lnTo>
                    <a:pt x="261365" y="499942"/>
                  </a:lnTo>
                  <a:lnTo>
                    <a:pt x="261405" y="495438"/>
                  </a:lnTo>
                  <a:lnTo>
                    <a:pt x="261449" y="490934"/>
                  </a:lnTo>
                  <a:lnTo>
                    <a:pt x="261494" y="486430"/>
                  </a:lnTo>
                  <a:lnTo>
                    <a:pt x="261544" y="481926"/>
                  </a:lnTo>
                  <a:lnTo>
                    <a:pt x="261595" y="477422"/>
                  </a:lnTo>
                  <a:lnTo>
                    <a:pt x="261654" y="472918"/>
                  </a:lnTo>
                  <a:lnTo>
                    <a:pt x="261714" y="468414"/>
                  </a:lnTo>
                  <a:lnTo>
                    <a:pt x="261782" y="463910"/>
                  </a:lnTo>
                  <a:lnTo>
                    <a:pt x="261853" y="459406"/>
                  </a:lnTo>
                  <a:lnTo>
                    <a:pt x="261932" y="454902"/>
                  </a:lnTo>
                  <a:lnTo>
                    <a:pt x="262017" y="450398"/>
                  </a:lnTo>
                  <a:lnTo>
                    <a:pt x="262109" y="445894"/>
                  </a:lnTo>
                  <a:lnTo>
                    <a:pt x="262209" y="441390"/>
                  </a:lnTo>
                  <a:lnTo>
                    <a:pt x="262316" y="436886"/>
                  </a:lnTo>
                  <a:lnTo>
                    <a:pt x="262434" y="432382"/>
                  </a:lnTo>
                  <a:lnTo>
                    <a:pt x="262557" y="427878"/>
                  </a:lnTo>
                  <a:lnTo>
                    <a:pt x="262695" y="423374"/>
                  </a:lnTo>
                  <a:lnTo>
                    <a:pt x="262835" y="418870"/>
                  </a:lnTo>
                  <a:lnTo>
                    <a:pt x="262995" y="414366"/>
                  </a:lnTo>
                  <a:lnTo>
                    <a:pt x="263158" y="409862"/>
                  </a:lnTo>
                  <a:lnTo>
                    <a:pt x="263339" y="405358"/>
                  </a:lnTo>
                  <a:lnTo>
                    <a:pt x="263526" y="400854"/>
                  </a:lnTo>
                  <a:lnTo>
                    <a:pt x="263731" y="396350"/>
                  </a:lnTo>
                  <a:lnTo>
                    <a:pt x="263944" y="391846"/>
                  </a:lnTo>
                  <a:lnTo>
                    <a:pt x="264173" y="387342"/>
                  </a:lnTo>
                  <a:lnTo>
                    <a:pt x="264415" y="382838"/>
                  </a:lnTo>
                  <a:lnTo>
                    <a:pt x="264669" y="378334"/>
                  </a:lnTo>
                  <a:lnTo>
                    <a:pt x="264941" y="373830"/>
                  </a:lnTo>
                  <a:lnTo>
                    <a:pt x="265223" y="369326"/>
                  </a:lnTo>
                  <a:lnTo>
                    <a:pt x="265527" y="364822"/>
                  </a:lnTo>
                  <a:lnTo>
                    <a:pt x="265837" y="360319"/>
                  </a:lnTo>
                  <a:lnTo>
                    <a:pt x="266176" y="355815"/>
                  </a:lnTo>
                  <a:lnTo>
                    <a:pt x="266519" y="351311"/>
                  </a:lnTo>
                  <a:lnTo>
                    <a:pt x="266890" y="346807"/>
                  </a:lnTo>
                  <a:lnTo>
                    <a:pt x="267270" y="342303"/>
                  </a:lnTo>
                  <a:lnTo>
                    <a:pt x="267673" y="337799"/>
                  </a:lnTo>
                  <a:lnTo>
                    <a:pt x="268090" y="333295"/>
                  </a:lnTo>
                  <a:lnTo>
                    <a:pt x="268527" y="328791"/>
                  </a:lnTo>
                  <a:lnTo>
                    <a:pt x="268983" y="324287"/>
                  </a:lnTo>
                  <a:lnTo>
                    <a:pt x="269455" y="319783"/>
                  </a:lnTo>
                  <a:lnTo>
                    <a:pt x="269952" y="315279"/>
                  </a:lnTo>
                  <a:lnTo>
                    <a:pt x="270460" y="310775"/>
                  </a:lnTo>
                  <a:lnTo>
                    <a:pt x="270998" y="306271"/>
                  </a:lnTo>
                  <a:lnTo>
                    <a:pt x="271542" y="301767"/>
                  </a:lnTo>
                  <a:lnTo>
                    <a:pt x="272123" y="297263"/>
                  </a:lnTo>
                  <a:lnTo>
                    <a:pt x="272710" y="292759"/>
                  </a:lnTo>
                  <a:lnTo>
                    <a:pt x="273331" y="288255"/>
                  </a:lnTo>
                  <a:lnTo>
                    <a:pt x="273961" y="283751"/>
                  </a:lnTo>
                  <a:lnTo>
                    <a:pt x="274621" y="279247"/>
                  </a:lnTo>
                  <a:lnTo>
                    <a:pt x="275296" y="274743"/>
                  </a:lnTo>
                  <a:lnTo>
                    <a:pt x="275996" y="270239"/>
                  </a:lnTo>
                  <a:lnTo>
                    <a:pt x="276717" y="265735"/>
                  </a:lnTo>
                  <a:lnTo>
                    <a:pt x="277457" y="261231"/>
                  </a:lnTo>
                  <a:lnTo>
                    <a:pt x="278224" y="256727"/>
                  </a:lnTo>
                  <a:lnTo>
                    <a:pt x="279004" y="252223"/>
                  </a:lnTo>
                  <a:lnTo>
                    <a:pt x="279818" y="247719"/>
                  </a:lnTo>
                  <a:lnTo>
                    <a:pt x="280639" y="243215"/>
                  </a:lnTo>
                  <a:lnTo>
                    <a:pt x="281500" y="238711"/>
                  </a:lnTo>
                  <a:lnTo>
                    <a:pt x="282366" y="234207"/>
                  </a:lnTo>
                  <a:lnTo>
                    <a:pt x="283270" y="229703"/>
                  </a:lnTo>
                  <a:lnTo>
                    <a:pt x="284183" y="225199"/>
                  </a:lnTo>
                  <a:lnTo>
                    <a:pt x="285128" y="220695"/>
                  </a:lnTo>
                  <a:lnTo>
                    <a:pt x="286088" y="216191"/>
                  </a:lnTo>
                  <a:lnTo>
                    <a:pt x="287073" y="211687"/>
                  </a:lnTo>
                  <a:lnTo>
                    <a:pt x="288080" y="207183"/>
                  </a:lnTo>
                  <a:lnTo>
                    <a:pt x="289106" y="202679"/>
                  </a:lnTo>
                  <a:lnTo>
                    <a:pt x="290160" y="198175"/>
                  </a:lnTo>
                  <a:lnTo>
                    <a:pt x="291226" y="193671"/>
                  </a:lnTo>
                  <a:lnTo>
                    <a:pt x="292325" y="189167"/>
                  </a:lnTo>
                  <a:lnTo>
                    <a:pt x="293431" y="184663"/>
                  </a:lnTo>
                  <a:lnTo>
                    <a:pt x="294575" y="180159"/>
                  </a:lnTo>
                  <a:lnTo>
                    <a:pt x="295724" y="175655"/>
                  </a:lnTo>
                  <a:lnTo>
                    <a:pt x="296908" y="171151"/>
                  </a:lnTo>
                  <a:lnTo>
                    <a:pt x="298101" y="166647"/>
                  </a:lnTo>
                  <a:lnTo>
                    <a:pt x="299323" y="162143"/>
                  </a:lnTo>
                  <a:lnTo>
                    <a:pt x="300559" y="157639"/>
                  </a:lnTo>
                  <a:lnTo>
                    <a:pt x="301818" y="153135"/>
                  </a:lnTo>
                  <a:lnTo>
                    <a:pt x="303095" y="148631"/>
                  </a:lnTo>
                  <a:lnTo>
                    <a:pt x="304389" y="144127"/>
                  </a:lnTo>
                  <a:lnTo>
                    <a:pt x="305707" y="139623"/>
                  </a:lnTo>
                  <a:lnTo>
                    <a:pt x="307036" y="135119"/>
                  </a:lnTo>
                  <a:lnTo>
                    <a:pt x="308393" y="130615"/>
                  </a:lnTo>
                  <a:lnTo>
                    <a:pt x="309755" y="126111"/>
                  </a:lnTo>
                  <a:lnTo>
                    <a:pt x="311149" y="121607"/>
                  </a:lnTo>
                  <a:lnTo>
                    <a:pt x="312547" y="117103"/>
                  </a:lnTo>
                  <a:lnTo>
                    <a:pt x="313972" y="112599"/>
                  </a:lnTo>
                  <a:lnTo>
                    <a:pt x="315405" y="108095"/>
                  </a:lnTo>
                  <a:lnTo>
                    <a:pt x="316860" y="103591"/>
                  </a:lnTo>
                  <a:lnTo>
                    <a:pt x="318326" y="99087"/>
                  </a:lnTo>
                  <a:lnTo>
                    <a:pt x="319809" y="94583"/>
                  </a:lnTo>
                  <a:lnTo>
                    <a:pt x="321306" y="90079"/>
                  </a:lnTo>
                  <a:lnTo>
                    <a:pt x="322815" y="85575"/>
                  </a:lnTo>
                  <a:lnTo>
                    <a:pt x="324341" y="81071"/>
                  </a:lnTo>
                  <a:lnTo>
                    <a:pt x="325875" y="76567"/>
                  </a:lnTo>
                  <a:lnTo>
                    <a:pt x="327427" y="72063"/>
                  </a:lnTo>
                  <a:lnTo>
                    <a:pt x="328984" y="67559"/>
                  </a:lnTo>
                  <a:lnTo>
                    <a:pt x="330561" y="63055"/>
                  </a:lnTo>
                  <a:lnTo>
                    <a:pt x="332140" y="58551"/>
                  </a:lnTo>
                  <a:lnTo>
                    <a:pt x="333737" y="54047"/>
                  </a:lnTo>
                  <a:lnTo>
                    <a:pt x="335338" y="49543"/>
                  </a:lnTo>
                  <a:lnTo>
                    <a:pt x="336953" y="45039"/>
                  </a:lnTo>
                  <a:lnTo>
                    <a:pt x="338573" y="40535"/>
                  </a:lnTo>
                  <a:lnTo>
                    <a:pt x="340202" y="36031"/>
                  </a:lnTo>
                  <a:lnTo>
                    <a:pt x="341839" y="31527"/>
                  </a:lnTo>
                  <a:lnTo>
                    <a:pt x="343482" y="27023"/>
                  </a:lnTo>
                  <a:lnTo>
                    <a:pt x="345133" y="22519"/>
                  </a:lnTo>
                  <a:lnTo>
                    <a:pt x="346787" y="18015"/>
                  </a:lnTo>
                  <a:lnTo>
                    <a:pt x="348449" y="13511"/>
                  </a:lnTo>
                  <a:lnTo>
                    <a:pt x="350113" y="9007"/>
                  </a:lnTo>
                  <a:lnTo>
                    <a:pt x="351784" y="4503"/>
                  </a:lnTo>
                  <a:lnTo>
                    <a:pt x="353456" y="0"/>
                  </a:lnTo>
                  <a:lnTo>
                    <a:pt x="604071" y="0"/>
                  </a:lnTo>
                  <a:lnTo>
                    <a:pt x="605743" y="4503"/>
                  </a:lnTo>
                  <a:lnTo>
                    <a:pt x="607414" y="9007"/>
                  </a:lnTo>
                  <a:lnTo>
                    <a:pt x="609078" y="13511"/>
                  </a:lnTo>
                  <a:lnTo>
                    <a:pt x="610740" y="18015"/>
                  </a:lnTo>
                  <a:lnTo>
                    <a:pt x="612395" y="22519"/>
                  </a:lnTo>
                  <a:lnTo>
                    <a:pt x="614045" y="27023"/>
                  </a:lnTo>
                  <a:lnTo>
                    <a:pt x="615688" y="31527"/>
                  </a:lnTo>
                  <a:lnTo>
                    <a:pt x="617325" y="36031"/>
                  </a:lnTo>
                  <a:lnTo>
                    <a:pt x="618955" y="40535"/>
                  </a:lnTo>
                  <a:lnTo>
                    <a:pt x="620575" y="45039"/>
                  </a:lnTo>
                  <a:lnTo>
                    <a:pt x="622189" y="49543"/>
                  </a:lnTo>
                  <a:lnTo>
                    <a:pt x="623790" y="54047"/>
                  </a:lnTo>
                  <a:lnTo>
                    <a:pt x="625387" y="58551"/>
                  </a:lnTo>
                  <a:lnTo>
                    <a:pt x="626967" y="63055"/>
                  </a:lnTo>
                  <a:lnTo>
                    <a:pt x="628544" y="67559"/>
                  </a:lnTo>
                  <a:lnTo>
                    <a:pt x="630100" y="72063"/>
                  </a:lnTo>
                  <a:lnTo>
                    <a:pt x="631653" y="76567"/>
                  </a:lnTo>
                  <a:lnTo>
                    <a:pt x="633186" y="81071"/>
                  </a:lnTo>
                  <a:lnTo>
                    <a:pt x="634712" y="85575"/>
                  </a:lnTo>
                  <a:lnTo>
                    <a:pt x="636221" y="90079"/>
                  </a:lnTo>
                  <a:lnTo>
                    <a:pt x="637718" y="94583"/>
                  </a:lnTo>
                  <a:lnTo>
                    <a:pt x="639201" y="99087"/>
                  </a:lnTo>
                  <a:lnTo>
                    <a:pt x="640667" y="103591"/>
                  </a:lnTo>
                  <a:lnTo>
                    <a:pt x="642122" y="108095"/>
                  </a:lnTo>
                  <a:lnTo>
                    <a:pt x="643555" y="112599"/>
                  </a:lnTo>
                  <a:lnTo>
                    <a:pt x="644981" y="117103"/>
                  </a:lnTo>
                  <a:lnTo>
                    <a:pt x="646379" y="121607"/>
                  </a:lnTo>
                  <a:lnTo>
                    <a:pt x="647772" y="126111"/>
                  </a:lnTo>
                  <a:lnTo>
                    <a:pt x="649135" y="130615"/>
                  </a:lnTo>
                  <a:lnTo>
                    <a:pt x="650491" y="135119"/>
                  </a:lnTo>
                  <a:lnTo>
                    <a:pt x="651820" y="139623"/>
                  </a:lnTo>
                  <a:lnTo>
                    <a:pt x="653138" y="144127"/>
                  </a:lnTo>
                  <a:lnTo>
                    <a:pt x="654432" y="148631"/>
                  </a:lnTo>
                  <a:lnTo>
                    <a:pt x="655710" y="153135"/>
                  </a:lnTo>
                  <a:lnTo>
                    <a:pt x="656968" y="157639"/>
                  </a:lnTo>
                  <a:lnTo>
                    <a:pt x="658204" y="162143"/>
                  </a:lnTo>
                  <a:lnTo>
                    <a:pt x="659426" y="166647"/>
                  </a:lnTo>
                  <a:lnTo>
                    <a:pt x="660619" y="171151"/>
                  </a:lnTo>
                  <a:lnTo>
                    <a:pt x="661803" y="175655"/>
                  </a:lnTo>
                  <a:lnTo>
                    <a:pt x="662952" y="180159"/>
                  </a:lnTo>
                  <a:lnTo>
                    <a:pt x="664096" y="184663"/>
                  </a:lnTo>
                  <a:lnTo>
                    <a:pt x="665202" y="189167"/>
                  </a:lnTo>
                  <a:lnTo>
                    <a:pt x="666301" y="193671"/>
                  </a:lnTo>
                  <a:lnTo>
                    <a:pt x="667368" y="198175"/>
                  </a:lnTo>
                  <a:lnTo>
                    <a:pt x="668421" y="202679"/>
                  </a:lnTo>
                  <a:lnTo>
                    <a:pt x="669447" y="207183"/>
                  </a:lnTo>
                  <a:lnTo>
                    <a:pt x="670454" y="211687"/>
                  </a:lnTo>
                  <a:lnTo>
                    <a:pt x="671439" y="216191"/>
                  </a:lnTo>
                  <a:lnTo>
                    <a:pt x="672400" y="220695"/>
                  </a:lnTo>
                  <a:lnTo>
                    <a:pt x="673344" y="225199"/>
                  </a:lnTo>
                  <a:lnTo>
                    <a:pt x="674258" y="229703"/>
                  </a:lnTo>
                  <a:lnTo>
                    <a:pt x="675161" y="234207"/>
                  </a:lnTo>
                  <a:lnTo>
                    <a:pt x="676028" y="238711"/>
                  </a:lnTo>
                  <a:lnTo>
                    <a:pt x="676888" y="243215"/>
                  </a:lnTo>
                  <a:lnTo>
                    <a:pt x="677709" y="247719"/>
                  </a:lnTo>
                  <a:lnTo>
                    <a:pt x="678523" y="252223"/>
                  </a:lnTo>
                  <a:lnTo>
                    <a:pt x="679304" y="256727"/>
                  </a:lnTo>
                  <a:lnTo>
                    <a:pt x="680071" y="261231"/>
                  </a:lnTo>
                  <a:lnTo>
                    <a:pt x="680811" y="265735"/>
                  </a:lnTo>
                  <a:lnTo>
                    <a:pt x="681532" y="270239"/>
                  </a:lnTo>
                  <a:lnTo>
                    <a:pt x="682231" y="274743"/>
                  </a:lnTo>
                  <a:lnTo>
                    <a:pt x="682907" y="279247"/>
                  </a:lnTo>
                  <a:lnTo>
                    <a:pt x="683566" y="283751"/>
                  </a:lnTo>
                  <a:lnTo>
                    <a:pt x="684197" y="288255"/>
                  </a:lnTo>
                  <a:lnTo>
                    <a:pt x="684818" y="292759"/>
                  </a:lnTo>
                  <a:lnTo>
                    <a:pt x="685404" y="297263"/>
                  </a:lnTo>
                  <a:lnTo>
                    <a:pt x="685985" y="301767"/>
                  </a:lnTo>
                  <a:lnTo>
                    <a:pt x="686530" y="306271"/>
                  </a:lnTo>
                  <a:lnTo>
                    <a:pt x="687068" y="310775"/>
                  </a:lnTo>
                  <a:lnTo>
                    <a:pt x="687576" y="315279"/>
                  </a:lnTo>
                  <a:lnTo>
                    <a:pt x="688072" y="319783"/>
                  </a:lnTo>
                  <a:lnTo>
                    <a:pt x="688544" y="324287"/>
                  </a:lnTo>
                  <a:lnTo>
                    <a:pt x="689000" y="328791"/>
                  </a:lnTo>
                  <a:lnTo>
                    <a:pt x="689437" y="333295"/>
                  </a:lnTo>
                  <a:lnTo>
                    <a:pt x="689854" y="337799"/>
                  </a:lnTo>
                  <a:lnTo>
                    <a:pt x="690258" y="342303"/>
                  </a:lnTo>
                  <a:lnTo>
                    <a:pt x="690637" y="346807"/>
                  </a:lnTo>
                  <a:lnTo>
                    <a:pt x="691008" y="351311"/>
                  </a:lnTo>
                  <a:lnTo>
                    <a:pt x="691351" y="355815"/>
                  </a:lnTo>
                  <a:lnTo>
                    <a:pt x="691690" y="360319"/>
                  </a:lnTo>
                  <a:lnTo>
                    <a:pt x="692000" y="364822"/>
                  </a:lnTo>
                  <a:lnTo>
                    <a:pt x="692305" y="369326"/>
                  </a:lnTo>
                  <a:lnTo>
                    <a:pt x="692586" y="373830"/>
                  </a:lnTo>
                  <a:lnTo>
                    <a:pt x="692859" y="378334"/>
                  </a:lnTo>
                  <a:lnTo>
                    <a:pt x="693113" y="382838"/>
                  </a:lnTo>
                  <a:lnTo>
                    <a:pt x="693355" y="387342"/>
                  </a:lnTo>
                  <a:lnTo>
                    <a:pt x="693583" y="391846"/>
                  </a:lnTo>
                  <a:lnTo>
                    <a:pt x="693797" y="396350"/>
                  </a:lnTo>
                  <a:lnTo>
                    <a:pt x="694001" y="400854"/>
                  </a:lnTo>
                  <a:lnTo>
                    <a:pt x="694188" y="405358"/>
                  </a:lnTo>
                  <a:lnTo>
                    <a:pt x="694370" y="409862"/>
                  </a:lnTo>
                  <a:lnTo>
                    <a:pt x="694532" y="414366"/>
                  </a:lnTo>
                  <a:lnTo>
                    <a:pt x="694692" y="418870"/>
                  </a:lnTo>
                  <a:lnTo>
                    <a:pt x="694833" y="423374"/>
                  </a:lnTo>
                  <a:lnTo>
                    <a:pt x="694971" y="427878"/>
                  </a:lnTo>
                  <a:lnTo>
                    <a:pt x="695094" y="432382"/>
                  </a:lnTo>
                  <a:lnTo>
                    <a:pt x="695211" y="436886"/>
                  </a:lnTo>
                  <a:lnTo>
                    <a:pt x="695318" y="441390"/>
                  </a:lnTo>
                  <a:lnTo>
                    <a:pt x="695418" y="445894"/>
                  </a:lnTo>
                  <a:lnTo>
                    <a:pt x="695510" y="450398"/>
                  </a:lnTo>
                  <a:lnTo>
                    <a:pt x="695595" y="454902"/>
                  </a:lnTo>
                  <a:lnTo>
                    <a:pt x="695674" y="459406"/>
                  </a:lnTo>
                  <a:lnTo>
                    <a:pt x="695745" y="463910"/>
                  </a:lnTo>
                  <a:lnTo>
                    <a:pt x="695814" y="468414"/>
                  </a:lnTo>
                  <a:lnTo>
                    <a:pt x="695874" y="472918"/>
                  </a:lnTo>
                  <a:lnTo>
                    <a:pt x="695932" y="477422"/>
                  </a:lnTo>
                  <a:lnTo>
                    <a:pt x="695983" y="481926"/>
                  </a:lnTo>
                  <a:lnTo>
                    <a:pt x="696033" y="486430"/>
                  </a:lnTo>
                  <a:lnTo>
                    <a:pt x="696078" y="490934"/>
                  </a:lnTo>
                  <a:lnTo>
                    <a:pt x="696122" y="495438"/>
                  </a:lnTo>
                  <a:lnTo>
                    <a:pt x="696163" y="499942"/>
                  </a:lnTo>
                  <a:lnTo>
                    <a:pt x="696203" y="504446"/>
                  </a:lnTo>
                  <a:lnTo>
                    <a:pt x="696241" y="508950"/>
                  </a:lnTo>
                  <a:lnTo>
                    <a:pt x="696279" y="513454"/>
                  </a:lnTo>
                  <a:lnTo>
                    <a:pt x="696316" y="517958"/>
                  </a:lnTo>
                  <a:lnTo>
                    <a:pt x="696354" y="522462"/>
                  </a:lnTo>
                  <a:lnTo>
                    <a:pt x="696393" y="526966"/>
                  </a:lnTo>
                  <a:lnTo>
                    <a:pt x="696434" y="531470"/>
                  </a:lnTo>
                  <a:lnTo>
                    <a:pt x="696475" y="535974"/>
                  </a:lnTo>
                  <a:lnTo>
                    <a:pt x="696521" y="540478"/>
                  </a:lnTo>
                  <a:lnTo>
                    <a:pt x="696567" y="544982"/>
                  </a:lnTo>
                  <a:lnTo>
                    <a:pt x="696619" y="549486"/>
                  </a:lnTo>
                  <a:lnTo>
                    <a:pt x="696673" y="553990"/>
                  </a:lnTo>
                  <a:lnTo>
                    <a:pt x="696733" y="558494"/>
                  </a:lnTo>
                  <a:lnTo>
                    <a:pt x="696797" y="562998"/>
                  </a:lnTo>
                  <a:lnTo>
                    <a:pt x="696867" y="567502"/>
                  </a:lnTo>
                  <a:lnTo>
                    <a:pt x="696943" y="572006"/>
                  </a:lnTo>
                  <a:lnTo>
                    <a:pt x="697024" y="576510"/>
                  </a:lnTo>
                  <a:lnTo>
                    <a:pt x="697115" y="581014"/>
                  </a:lnTo>
                  <a:lnTo>
                    <a:pt x="697210" y="585518"/>
                  </a:lnTo>
                  <a:lnTo>
                    <a:pt x="697317" y="590022"/>
                  </a:lnTo>
                  <a:lnTo>
                    <a:pt x="697427" y="594526"/>
                  </a:lnTo>
                  <a:lnTo>
                    <a:pt x="697553" y="599030"/>
                  </a:lnTo>
                  <a:lnTo>
                    <a:pt x="697683" y="603534"/>
                  </a:lnTo>
                  <a:lnTo>
                    <a:pt x="697828" y="608038"/>
                  </a:lnTo>
                  <a:lnTo>
                    <a:pt x="697979" y="612542"/>
                  </a:lnTo>
                  <a:lnTo>
                    <a:pt x="698145" y="617046"/>
                  </a:lnTo>
                  <a:lnTo>
                    <a:pt x="698321" y="621550"/>
                  </a:lnTo>
                  <a:lnTo>
                    <a:pt x="698509" y="626054"/>
                  </a:lnTo>
                  <a:lnTo>
                    <a:pt x="698711" y="630558"/>
                  </a:lnTo>
                  <a:lnTo>
                    <a:pt x="698924" y="635062"/>
                  </a:lnTo>
                  <a:lnTo>
                    <a:pt x="699155" y="639566"/>
                  </a:lnTo>
                  <a:lnTo>
                    <a:pt x="699394" y="644070"/>
                  </a:lnTo>
                  <a:lnTo>
                    <a:pt x="699657" y="648574"/>
                  </a:lnTo>
                  <a:lnTo>
                    <a:pt x="699925" y="653078"/>
                  </a:lnTo>
                  <a:lnTo>
                    <a:pt x="700221" y="657582"/>
                  </a:lnTo>
                  <a:lnTo>
                    <a:pt x="700523" y="662086"/>
                  </a:lnTo>
                  <a:lnTo>
                    <a:pt x="700852" y="666590"/>
                  </a:lnTo>
                  <a:lnTo>
                    <a:pt x="701191" y="671094"/>
                  </a:lnTo>
                  <a:lnTo>
                    <a:pt x="701554" y="675598"/>
                  </a:lnTo>
                  <a:lnTo>
                    <a:pt x="701933" y="680102"/>
                  </a:lnTo>
                  <a:lnTo>
                    <a:pt x="702331" y="684606"/>
                  </a:lnTo>
                  <a:lnTo>
                    <a:pt x="702752" y="689110"/>
                  </a:lnTo>
                  <a:lnTo>
                    <a:pt x="703189" y="693614"/>
                  </a:lnTo>
                  <a:lnTo>
                    <a:pt x="703655" y="698118"/>
                  </a:lnTo>
                  <a:lnTo>
                    <a:pt x="704132" y="702622"/>
                  </a:lnTo>
                  <a:lnTo>
                    <a:pt x="704645" y="707126"/>
                  </a:lnTo>
                  <a:lnTo>
                    <a:pt x="705164" y="711630"/>
                  </a:lnTo>
                  <a:lnTo>
                    <a:pt x="705727" y="716134"/>
                  </a:lnTo>
                  <a:lnTo>
                    <a:pt x="706297" y="720638"/>
                  </a:lnTo>
                  <a:lnTo>
                    <a:pt x="706906" y="725141"/>
                  </a:lnTo>
                  <a:lnTo>
                    <a:pt x="707529" y="729645"/>
                  </a:lnTo>
                  <a:lnTo>
                    <a:pt x="708185" y="734149"/>
                  </a:lnTo>
                  <a:lnTo>
                    <a:pt x="708864" y="738653"/>
                  </a:lnTo>
                  <a:lnTo>
                    <a:pt x="709571" y="743157"/>
                  </a:lnTo>
                  <a:lnTo>
                    <a:pt x="710308" y="747661"/>
                  </a:lnTo>
                  <a:lnTo>
                    <a:pt x="711067" y="752165"/>
                  </a:lnTo>
                  <a:lnTo>
                    <a:pt x="711865" y="756669"/>
                  </a:lnTo>
                  <a:lnTo>
                    <a:pt x="712678" y="761173"/>
                  </a:lnTo>
                  <a:lnTo>
                    <a:pt x="713540" y="765677"/>
                  </a:lnTo>
                  <a:lnTo>
                    <a:pt x="714409" y="770181"/>
                  </a:lnTo>
                  <a:lnTo>
                    <a:pt x="715336" y="774685"/>
                  </a:lnTo>
                  <a:lnTo>
                    <a:pt x="716271" y="779189"/>
                  </a:lnTo>
                  <a:lnTo>
                    <a:pt x="717257" y="783693"/>
                  </a:lnTo>
                  <a:lnTo>
                    <a:pt x="718262" y="788197"/>
                  </a:lnTo>
                  <a:lnTo>
                    <a:pt x="719309" y="792701"/>
                  </a:lnTo>
                  <a:lnTo>
                    <a:pt x="720384" y="797205"/>
                  </a:lnTo>
                  <a:lnTo>
                    <a:pt x="721494" y="801709"/>
                  </a:lnTo>
                  <a:lnTo>
                    <a:pt x="722642" y="806213"/>
                  </a:lnTo>
                  <a:lnTo>
                    <a:pt x="723817" y="810717"/>
                  </a:lnTo>
                  <a:lnTo>
                    <a:pt x="725039" y="815221"/>
                  </a:lnTo>
                  <a:lnTo>
                    <a:pt x="726280" y="819725"/>
                  </a:lnTo>
                  <a:lnTo>
                    <a:pt x="727579" y="824229"/>
                  </a:lnTo>
                  <a:lnTo>
                    <a:pt x="728888" y="828733"/>
                  </a:lnTo>
                  <a:lnTo>
                    <a:pt x="730264" y="833237"/>
                  </a:lnTo>
                  <a:lnTo>
                    <a:pt x="731652" y="837741"/>
                  </a:lnTo>
                  <a:lnTo>
                    <a:pt x="733098" y="842245"/>
                  </a:lnTo>
                  <a:lnTo>
                    <a:pt x="734564" y="846749"/>
                  </a:lnTo>
                  <a:lnTo>
                    <a:pt x="736081" y="851253"/>
                  </a:lnTo>
                  <a:lnTo>
                    <a:pt x="737629" y="855757"/>
                  </a:lnTo>
                  <a:lnTo>
                    <a:pt x="739216" y="860261"/>
                  </a:lnTo>
                  <a:lnTo>
                    <a:pt x="740846" y="864765"/>
                  </a:lnTo>
                  <a:lnTo>
                    <a:pt x="742505" y="869269"/>
                  </a:lnTo>
                  <a:lnTo>
                    <a:pt x="744217" y="873773"/>
                  </a:lnTo>
                  <a:lnTo>
                    <a:pt x="745948" y="878277"/>
                  </a:lnTo>
                  <a:lnTo>
                    <a:pt x="747742" y="882781"/>
                  </a:lnTo>
                  <a:lnTo>
                    <a:pt x="749547" y="887285"/>
                  </a:lnTo>
                  <a:lnTo>
                    <a:pt x="751422" y="891789"/>
                  </a:lnTo>
                  <a:lnTo>
                    <a:pt x="753309" y="896293"/>
                  </a:lnTo>
                  <a:lnTo>
                    <a:pt x="755257" y="900797"/>
                  </a:lnTo>
                  <a:lnTo>
                    <a:pt x="757225" y="905301"/>
                  </a:lnTo>
                  <a:lnTo>
                    <a:pt x="759244" y="909805"/>
                  </a:lnTo>
                  <a:lnTo>
                    <a:pt x="761294" y="914309"/>
                  </a:lnTo>
                  <a:lnTo>
                    <a:pt x="763383" y="918813"/>
                  </a:lnTo>
                  <a:lnTo>
                    <a:pt x="765512" y="923317"/>
                  </a:lnTo>
                  <a:lnTo>
                    <a:pt x="767670" y="927821"/>
                  </a:lnTo>
                  <a:lnTo>
                    <a:pt x="769878" y="932325"/>
                  </a:lnTo>
                  <a:lnTo>
                    <a:pt x="772104" y="936829"/>
                  </a:lnTo>
                  <a:lnTo>
                    <a:pt x="774388" y="941333"/>
                  </a:lnTo>
                  <a:lnTo>
                    <a:pt x="776681" y="945837"/>
                  </a:lnTo>
                  <a:lnTo>
                    <a:pt x="779038" y="950341"/>
                  </a:lnTo>
                  <a:lnTo>
                    <a:pt x="781404" y="954845"/>
                  </a:lnTo>
                  <a:lnTo>
                    <a:pt x="783823" y="959349"/>
                  </a:lnTo>
                  <a:lnTo>
                    <a:pt x="786259" y="963853"/>
                  </a:lnTo>
                  <a:lnTo>
                    <a:pt x="788738" y="968357"/>
                  </a:lnTo>
                  <a:lnTo>
                    <a:pt x="791241" y="972861"/>
                  </a:lnTo>
                  <a:lnTo>
                    <a:pt x="793776" y="977365"/>
                  </a:lnTo>
                  <a:lnTo>
                    <a:pt x="796342" y="981869"/>
                  </a:lnTo>
                  <a:lnTo>
                    <a:pt x="798930" y="986373"/>
                  </a:lnTo>
                  <a:lnTo>
                    <a:pt x="801555" y="990877"/>
                  </a:lnTo>
                  <a:lnTo>
                    <a:pt x="804193" y="995381"/>
                  </a:lnTo>
                  <a:lnTo>
                    <a:pt x="806872" y="999885"/>
                  </a:lnTo>
                  <a:lnTo>
                    <a:pt x="809557" y="1004389"/>
                  </a:lnTo>
                  <a:lnTo>
                    <a:pt x="812284" y="1008893"/>
                  </a:lnTo>
                  <a:lnTo>
                    <a:pt x="815016" y="1013397"/>
                  </a:lnTo>
                  <a:lnTo>
                    <a:pt x="817781" y="1017901"/>
                  </a:lnTo>
                  <a:lnTo>
                    <a:pt x="820556" y="1022405"/>
                  </a:lnTo>
                  <a:lnTo>
                    <a:pt x="823354" y="1026909"/>
                  </a:lnTo>
                  <a:lnTo>
                    <a:pt x="826164" y="1031413"/>
                  </a:lnTo>
                  <a:lnTo>
                    <a:pt x="828990" y="1035917"/>
                  </a:lnTo>
                  <a:lnTo>
                    <a:pt x="831830" y="1040421"/>
                  </a:lnTo>
                  <a:lnTo>
                    <a:pt x="834680" y="1044925"/>
                  </a:lnTo>
                  <a:lnTo>
                    <a:pt x="837542" y="1049429"/>
                  </a:lnTo>
                  <a:lnTo>
                    <a:pt x="840409" y="1053933"/>
                  </a:lnTo>
                  <a:lnTo>
                    <a:pt x="843287" y="1058437"/>
                  </a:lnTo>
                  <a:lnTo>
                    <a:pt x="846166" y="1062941"/>
                  </a:lnTo>
                  <a:lnTo>
                    <a:pt x="849052" y="1067445"/>
                  </a:lnTo>
                  <a:lnTo>
                    <a:pt x="851937" y="1071949"/>
                  </a:lnTo>
                  <a:lnTo>
                    <a:pt x="854823" y="1076453"/>
                  </a:lnTo>
                  <a:lnTo>
                    <a:pt x="857706" y="1080957"/>
                  </a:lnTo>
                  <a:lnTo>
                    <a:pt x="860586" y="1085460"/>
                  </a:lnTo>
                  <a:lnTo>
                    <a:pt x="863460" y="1089964"/>
                  </a:lnTo>
                  <a:lnTo>
                    <a:pt x="866326" y="1094468"/>
                  </a:lnTo>
                  <a:lnTo>
                    <a:pt x="869182" y="1098972"/>
                  </a:lnTo>
                  <a:lnTo>
                    <a:pt x="872029" y="1103476"/>
                  </a:lnTo>
                  <a:lnTo>
                    <a:pt x="874858" y="1107980"/>
                  </a:lnTo>
                  <a:lnTo>
                    <a:pt x="877679" y="1112484"/>
                  </a:lnTo>
                  <a:lnTo>
                    <a:pt x="880472" y="1116988"/>
                  </a:lnTo>
                  <a:lnTo>
                    <a:pt x="883261" y="1121492"/>
                  </a:lnTo>
                  <a:lnTo>
                    <a:pt x="886010" y="1125996"/>
                  </a:lnTo>
                  <a:lnTo>
                    <a:pt x="888752" y="1130500"/>
                  </a:lnTo>
                  <a:lnTo>
                    <a:pt x="891454" y="1135004"/>
                  </a:lnTo>
                  <a:lnTo>
                    <a:pt x="894140" y="1139508"/>
                  </a:lnTo>
                  <a:lnTo>
                    <a:pt x="896788" y="1144012"/>
                  </a:lnTo>
                  <a:lnTo>
                    <a:pt x="899410" y="1148516"/>
                  </a:lnTo>
                  <a:lnTo>
                    <a:pt x="901998" y="1153020"/>
                  </a:lnTo>
                  <a:lnTo>
                    <a:pt x="904547" y="1157524"/>
                  </a:lnTo>
                  <a:lnTo>
                    <a:pt x="907066" y="1162028"/>
                  </a:lnTo>
                  <a:lnTo>
                    <a:pt x="909533" y="1166532"/>
                  </a:lnTo>
                  <a:lnTo>
                    <a:pt x="911978" y="1171036"/>
                  </a:lnTo>
                  <a:lnTo>
                    <a:pt x="914353" y="1175540"/>
                  </a:lnTo>
                  <a:lnTo>
                    <a:pt x="916716" y="1180044"/>
                  </a:lnTo>
                  <a:lnTo>
                    <a:pt x="918992" y="1184548"/>
                  </a:lnTo>
                  <a:lnTo>
                    <a:pt x="921253" y="1189052"/>
                  </a:lnTo>
                  <a:lnTo>
                    <a:pt x="923434" y="1193556"/>
                  </a:lnTo>
                  <a:lnTo>
                    <a:pt x="925585" y="1198060"/>
                  </a:lnTo>
                  <a:lnTo>
                    <a:pt x="927664" y="1202564"/>
                  </a:lnTo>
                  <a:lnTo>
                    <a:pt x="929697" y="1207068"/>
                  </a:lnTo>
                  <a:lnTo>
                    <a:pt x="931668" y="1211572"/>
                  </a:lnTo>
                  <a:lnTo>
                    <a:pt x="933575" y="1216076"/>
                  </a:lnTo>
                  <a:lnTo>
                    <a:pt x="935433" y="1220580"/>
                  </a:lnTo>
                  <a:lnTo>
                    <a:pt x="937205" y="1225084"/>
                  </a:lnTo>
                  <a:lnTo>
                    <a:pt x="938943" y="1229588"/>
                  </a:lnTo>
                  <a:lnTo>
                    <a:pt x="940575" y="1234092"/>
                  </a:lnTo>
                  <a:lnTo>
                    <a:pt x="942188" y="1238596"/>
                  </a:lnTo>
                  <a:lnTo>
                    <a:pt x="943671" y="1243100"/>
                  </a:lnTo>
                  <a:lnTo>
                    <a:pt x="945135" y="1247604"/>
                  </a:lnTo>
                  <a:lnTo>
                    <a:pt x="946482" y="1252108"/>
                  </a:lnTo>
                  <a:lnTo>
                    <a:pt x="947790" y="1256612"/>
                  </a:lnTo>
                  <a:lnTo>
                    <a:pt x="948998" y="1261116"/>
                  </a:lnTo>
                  <a:lnTo>
                    <a:pt x="950144" y="1265620"/>
                  </a:lnTo>
                  <a:lnTo>
                    <a:pt x="951208" y="1270124"/>
                  </a:lnTo>
                  <a:lnTo>
                    <a:pt x="952187" y="1274628"/>
                  </a:lnTo>
                  <a:lnTo>
                    <a:pt x="953102" y="1279132"/>
                  </a:lnTo>
                  <a:lnTo>
                    <a:pt x="953910" y="1283636"/>
                  </a:lnTo>
                  <a:lnTo>
                    <a:pt x="954674" y="1288140"/>
                  </a:lnTo>
                  <a:lnTo>
                    <a:pt x="955306" y="1292644"/>
                  </a:lnTo>
                  <a:lnTo>
                    <a:pt x="955915" y="1297148"/>
                  </a:lnTo>
                  <a:lnTo>
                    <a:pt x="956367" y="1301652"/>
                  </a:lnTo>
                  <a:lnTo>
                    <a:pt x="956797" y="1306156"/>
                  </a:lnTo>
                  <a:lnTo>
                    <a:pt x="957089" y="1310660"/>
                  </a:lnTo>
                  <a:lnTo>
                    <a:pt x="957336" y="1315164"/>
                  </a:lnTo>
                  <a:lnTo>
                    <a:pt x="957466" y="1319668"/>
                  </a:lnTo>
                  <a:lnTo>
                    <a:pt x="957528" y="1324172"/>
                  </a:lnTo>
                  <a:lnTo>
                    <a:pt x="957495" y="1328676"/>
                  </a:lnTo>
                  <a:lnTo>
                    <a:pt x="957371" y="1333180"/>
                  </a:lnTo>
                  <a:lnTo>
                    <a:pt x="957174" y="1337684"/>
                  </a:lnTo>
                  <a:lnTo>
                    <a:pt x="956862" y="1342188"/>
                  </a:lnTo>
                  <a:lnTo>
                    <a:pt x="956501" y="1346692"/>
                  </a:lnTo>
                  <a:lnTo>
                    <a:pt x="956001" y="1351196"/>
                  </a:lnTo>
                  <a:lnTo>
                    <a:pt x="955477" y="1355700"/>
                  </a:lnTo>
                  <a:lnTo>
                    <a:pt x="954789" y="1360204"/>
                  </a:lnTo>
                  <a:lnTo>
                    <a:pt x="954079" y="1364708"/>
                  </a:lnTo>
                  <a:lnTo>
                    <a:pt x="953227" y="1369212"/>
                  </a:lnTo>
                  <a:lnTo>
                    <a:pt x="952331" y="1373716"/>
                  </a:lnTo>
                  <a:lnTo>
                    <a:pt x="951318" y="1378220"/>
                  </a:lnTo>
                  <a:lnTo>
                    <a:pt x="950238" y="1382724"/>
                  </a:lnTo>
                  <a:lnTo>
                    <a:pt x="949066" y="1387228"/>
                  </a:lnTo>
                  <a:lnTo>
                    <a:pt x="947805" y="1391732"/>
                  </a:lnTo>
                  <a:lnTo>
                    <a:pt x="946474" y="1396236"/>
                  </a:lnTo>
                  <a:lnTo>
                    <a:pt x="945035" y="1400740"/>
                  </a:lnTo>
                  <a:lnTo>
                    <a:pt x="943551" y="1405244"/>
                  </a:lnTo>
                  <a:lnTo>
                    <a:pt x="941938" y="1409748"/>
                  </a:lnTo>
                  <a:lnTo>
                    <a:pt x="940301" y="1414252"/>
                  </a:lnTo>
                  <a:lnTo>
                    <a:pt x="938518" y="1418756"/>
                  </a:lnTo>
                  <a:lnTo>
                    <a:pt x="936715" y="1423260"/>
                  </a:lnTo>
                  <a:lnTo>
                    <a:pt x="934787" y="1427764"/>
                  </a:lnTo>
                  <a:lnTo>
                    <a:pt x="932820" y="1432268"/>
                  </a:lnTo>
                  <a:lnTo>
                    <a:pt x="930752" y="1436772"/>
                  </a:lnTo>
                  <a:lnTo>
                    <a:pt x="928627" y="1441276"/>
                  </a:lnTo>
                  <a:lnTo>
                    <a:pt x="926424" y="1445779"/>
                  </a:lnTo>
                  <a:lnTo>
                    <a:pt x="924148" y="1450283"/>
                  </a:lnTo>
                  <a:lnTo>
                    <a:pt x="921814" y="1454787"/>
                  </a:lnTo>
                  <a:lnTo>
                    <a:pt x="919393" y="1459291"/>
                  </a:lnTo>
                  <a:lnTo>
                    <a:pt x="916935" y="1463795"/>
                  </a:lnTo>
                  <a:lnTo>
                    <a:pt x="914376" y="1468299"/>
                  </a:lnTo>
                  <a:lnTo>
                    <a:pt x="911799" y="1472803"/>
                  </a:lnTo>
                  <a:lnTo>
                    <a:pt x="909109" y="1477307"/>
                  </a:lnTo>
                  <a:lnTo>
                    <a:pt x="906405" y="1481811"/>
                  </a:lnTo>
                  <a:lnTo>
                    <a:pt x="903607" y="1486315"/>
                  </a:lnTo>
                  <a:lnTo>
                    <a:pt x="900782" y="1490819"/>
                  </a:lnTo>
                  <a:lnTo>
                    <a:pt x="897883" y="1495323"/>
                  </a:lnTo>
                  <a:lnTo>
                    <a:pt x="894946" y="1499827"/>
                  </a:lnTo>
                  <a:lnTo>
                    <a:pt x="891953" y="1504331"/>
                  </a:lnTo>
                  <a:lnTo>
                    <a:pt x="888912" y="1508835"/>
                  </a:lnTo>
                  <a:lnTo>
                    <a:pt x="885831" y="1513339"/>
                  </a:lnTo>
                  <a:lnTo>
                    <a:pt x="882695" y="1517843"/>
                  </a:lnTo>
                  <a:lnTo>
                    <a:pt x="879534" y="1522347"/>
                  </a:lnTo>
                  <a:lnTo>
                    <a:pt x="876311" y="1526851"/>
                  </a:lnTo>
                  <a:lnTo>
                    <a:pt x="873077" y="1531355"/>
                  </a:lnTo>
                  <a:lnTo>
                    <a:pt x="869777" y="1535859"/>
                  </a:lnTo>
                  <a:lnTo>
                    <a:pt x="866468" y="1540363"/>
                  </a:lnTo>
                  <a:lnTo>
                    <a:pt x="863108" y="1544867"/>
                  </a:lnTo>
                  <a:lnTo>
                    <a:pt x="859733" y="1549371"/>
                  </a:lnTo>
                  <a:lnTo>
                    <a:pt x="856321" y="1553875"/>
                  </a:lnTo>
                  <a:lnTo>
                    <a:pt x="852890" y="1558379"/>
                  </a:lnTo>
                  <a:lnTo>
                    <a:pt x="849432" y="1562883"/>
                  </a:lnTo>
                  <a:lnTo>
                    <a:pt x="845953" y="1567387"/>
                  </a:lnTo>
                  <a:lnTo>
                    <a:pt x="842458" y="1571891"/>
                  </a:lnTo>
                  <a:lnTo>
                    <a:pt x="838940" y="1576395"/>
                  </a:lnTo>
                  <a:lnTo>
                    <a:pt x="835414" y="1580899"/>
                  </a:lnTo>
                  <a:lnTo>
                    <a:pt x="831868" y="1585403"/>
                  </a:lnTo>
                  <a:lnTo>
                    <a:pt x="828317" y="1589907"/>
                  </a:lnTo>
                  <a:lnTo>
                    <a:pt x="824751" y="1594411"/>
                  </a:lnTo>
                  <a:lnTo>
                    <a:pt x="821182" y="1598915"/>
                  </a:lnTo>
                  <a:lnTo>
                    <a:pt x="817605" y="1603419"/>
                  </a:lnTo>
                  <a:lnTo>
                    <a:pt x="814027" y="1607923"/>
                  </a:lnTo>
                  <a:lnTo>
                    <a:pt x="810446" y="1612427"/>
                  </a:lnTo>
                  <a:lnTo>
                    <a:pt x="806867" y="1616931"/>
                  </a:lnTo>
                  <a:lnTo>
                    <a:pt x="803289" y="1621435"/>
                  </a:lnTo>
                  <a:lnTo>
                    <a:pt x="799717" y="1625939"/>
                  </a:lnTo>
                  <a:lnTo>
                    <a:pt x="796148" y="1630443"/>
                  </a:lnTo>
                  <a:lnTo>
                    <a:pt x="792591" y="1634947"/>
                  </a:lnTo>
                  <a:lnTo>
                    <a:pt x="789038" y="1639451"/>
                  </a:lnTo>
                  <a:lnTo>
                    <a:pt x="785503" y="1643955"/>
                  </a:lnTo>
                  <a:lnTo>
                    <a:pt x="781972" y="1648459"/>
                  </a:lnTo>
                  <a:lnTo>
                    <a:pt x="778466" y="1652963"/>
                  </a:lnTo>
                  <a:lnTo>
                    <a:pt x="774966" y="1657467"/>
                  </a:lnTo>
                  <a:lnTo>
                    <a:pt x="771493" y="1661971"/>
                  </a:lnTo>
                  <a:lnTo>
                    <a:pt x="768031" y="1666475"/>
                  </a:lnTo>
                  <a:lnTo>
                    <a:pt x="764596" y="1670979"/>
                  </a:lnTo>
                  <a:lnTo>
                    <a:pt x="761178" y="1675483"/>
                  </a:lnTo>
                  <a:lnTo>
                    <a:pt x="757785" y="1679987"/>
                  </a:lnTo>
                  <a:lnTo>
                    <a:pt x="754418" y="1684491"/>
                  </a:lnTo>
                  <a:lnTo>
                    <a:pt x="751072" y="1688995"/>
                  </a:lnTo>
                  <a:lnTo>
                    <a:pt x="747761" y="1693499"/>
                  </a:lnTo>
                  <a:lnTo>
                    <a:pt x="744466" y="1698003"/>
                  </a:lnTo>
                  <a:lnTo>
                    <a:pt x="741216" y="1702507"/>
                  </a:lnTo>
                  <a:lnTo>
                    <a:pt x="737975" y="1707011"/>
                  </a:lnTo>
                  <a:lnTo>
                    <a:pt x="734792" y="1711515"/>
                  </a:lnTo>
                  <a:lnTo>
                    <a:pt x="731617" y="1716019"/>
                  </a:lnTo>
                  <a:lnTo>
                    <a:pt x="728496" y="1720523"/>
                  </a:lnTo>
                  <a:lnTo>
                    <a:pt x="725393" y="1725027"/>
                  </a:lnTo>
                  <a:lnTo>
                    <a:pt x="722337" y="1729531"/>
                  </a:lnTo>
                  <a:lnTo>
                    <a:pt x="719308" y="1734035"/>
                  </a:lnTo>
                  <a:lnTo>
                    <a:pt x="716319" y="1738539"/>
                  </a:lnTo>
                  <a:lnTo>
                    <a:pt x="713368" y="1743043"/>
                  </a:lnTo>
                  <a:lnTo>
                    <a:pt x="710448" y="1747547"/>
                  </a:lnTo>
                  <a:lnTo>
                    <a:pt x="707578" y="1752051"/>
                  </a:lnTo>
                  <a:lnTo>
                    <a:pt x="704730" y="1756555"/>
                  </a:lnTo>
                  <a:lnTo>
                    <a:pt x="701942" y="1761059"/>
                  </a:lnTo>
                  <a:lnTo>
                    <a:pt x="699167" y="1765563"/>
                  </a:lnTo>
                  <a:lnTo>
                    <a:pt x="696465" y="1770067"/>
                  </a:lnTo>
                  <a:lnTo>
                    <a:pt x="693773" y="1774571"/>
                  </a:lnTo>
                  <a:lnTo>
                    <a:pt x="691147" y="1779075"/>
                  </a:lnTo>
                  <a:lnTo>
                    <a:pt x="688542" y="1783579"/>
                  </a:lnTo>
                  <a:lnTo>
                    <a:pt x="685993" y="1788083"/>
                  </a:lnTo>
                  <a:lnTo>
                    <a:pt x="683475" y="1792587"/>
                  </a:lnTo>
                  <a:lnTo>
                    <a:pt x="681002" y="1797091"/>
                  </a:lnTo>
                  <a:lnTo>
                    <a:pt x="678571" y="1801595"/>
                  </a:lnTo>
                  <a:lnTo>
                    <a:pt x="676176" y="1806098"/>
                  </a:lnTo>
                  <a:lnTo>
                    <a:pt x="673833" y="1810602"/>
                  </a:lnTo>
                  <a:lnTo>
                    <a:pt x="671514" y="1815106"/>
                  </a:lnTo>
                  <a:lnTo>
                    <a:pt x="669258" y="1819610"/>
                  </a:lnTo>
                  <a:lnTo>
                    <a:pt x="667015" y="1824114"/>
                  </a:lnTo>
                  <a:lnTo>
                    <a:pt x="664846" y="1828618"/>
                  </a:lnTo>
                  <a:lnTo>
                    <a:pt x="662688" y="1833122"/>
                  </a:lnTo>
                  <a:lnTo>
                    <a:pt x="660596" y="1837626"/>
                  </a:lnTo>
                  <a:lnTo>
                    <a:pt x="658523" y="1842130"/>
                  </a:lnTo>
                  <a:lnTo>
                    <a:pt x="656505" y="1846634"/>
                  </a:lnTo>
                  <a:lnTo>
                    <a:pt x="654516" y="1851138"/>
                  </a:lnTo>
                  <a:lnTo>
                    <a:pt x="652571" y="1855642"/>
                  </a:lnTo>
                  <a:lnTo>
                    <a:pt x="650664" y="1860146"/>
                  </a:lnTo>
                  <a:lnTo>
                    <a:pt x="648790" y="1864650"/>
                  </a:lnTo>
                  <a:lnTo>
                    <a:pt x="646963" y="1869154"/>
                  </a:lnTo>
                  <a:lnTo>
                    <a:pt x="645158" y="1873658"/>
                  </a:lnTo>
                  <a:lnTo>
                    <a:pt x="643410" y="1878162"/>
                  </a:lnTo>
                  <a:lnTo>
                    <a:pt x="641673" y="1882666"/>
                  </a:lnTo>
                  <a:lnTo>
                    <a:pt x="640000" y="1887170"/>
                  </a:lnTo>
                  <a:lnTo>
                    <a:pt x="638337" y="1891674"/>
                  </a:lnTo>
                  <a:lnTo>
                    <a:pt x="636729" y="1896178"/>
                  </a:lnTo>
                  <a:lnTo>
                    <a:pt x="635138" y="1900682"/>
                  </a:lnTo>
                  <a:lnTo>
                    <a:pt x="633593" y="1905186"/>
                  </a:lnTo>
                  <a:lnTo>
                    <a:pt x="632071" y="1909690"/>
                  </a:lnTo>
                  <a:lnTo>
                    <a:pt x="630585" y="1914194"/>
                  </a:lnTo>
                  <a:lnTo>
                    <a:pt x="629130" y="1918698"/>
                  </a:lnTo>
                  <a:lnTo>
                    <a:pt x="627702" y="1923202"/>
                  </a:lnTo>
                  <a:lnTo>
                    <a:pt x="626310" y="1927706"/>
                  </a:lnTo>
                  <a:lnTo>
                    <a:pt x="624936" y="1932210"/>
                  </a:lnTo>
                  <a:lnTo>
                    <a:pt x="623605" y="1936714"/>
                  </a:lnTo>
                  <a:lnTo>
                    <a:pt x="622284" y="1941218"/>
                  </a:lnTo>
                  <a:lnTo>
                    <a:pt x="621010" y="1945722"/>
                  </a:lnTo>
                  <a:lnTo>
                    <a:pt x="619743" y="1950226"/>
                  </a:lnTo>
                  <a:lnTo>
                    <a:pt x="618518" y="1954730"/>
                  </a:lnTo>
                  <a:lnTo>
                    <a:pt x="617305" y="1959234"/>
                  </a:lnTo>
                  <a:lnTo>
                    <a:pt x="616124" y="1963738"/>
                  </a:lnTo>
                  <a:lnTo>
                    <a:pt x="614961" y="1968242"/>
                  </a:lnTo>
                  <a:lnTo>
                    <a:pt x="613822" y="1972746"/>
                  </a:lnTo>
                  <a:lnTo>
                    <a:pt x="612705" y="1977250"/>
                  </a:lnTo>
                  <a:lnTo>
                    <a:pt x="611607" y="1981754"/>
                  </a:lnTo>
                  <a:lnTo>
                    <a:pt x="610533" y="1986258"/>
                  </a:lnTo>
                  <a:lnTo>
                    <a:pt x="609471" y="1990762"/>
                  </a:lnTo>
                  <a:lnTo>
                    <a:pt x="608438" y="1995266"/>
                  </a:lnTo>
                  <a:lnTo>
                    <a:pt x="607410" y="1999770"/>
                  </a:lnTo>
                  <a:lnTo>
                    <a:pt x="606414" y="2004274"/>
                  </a:lnTo>
                  <a:lnTo>
                    <a:pt x="605421" y="2008778"/>
                  </a:lnTo>
                  <a:lnTo>
                    <a:pt x="604455" y="2013282"/>
                  </a:lnTo>
                  <a:lnTo>
                    <a:pt x="603496" y="2017786"/>
                  </a:lnTo>
                  <a:lnTo>
                    <a:pt x="602557" y="2022290"/>
                  </a:lnTo>
                  <a:lnTo>
                    <a:pt x="601628" y="2026794"/>
                  </a:lnTo>
                  <a:lnTo>
                    <a:pt x="600714" y="2031298"/>
                  </a:lnTo>
                  <a:lnTo>
                    <a:pt x="599812" y="2035802"/>
                  </a:lnTo>
                  <a:lnTo>
                    <a:pt x="598920" y="2040306"/>
                  </a:lnTo>
                  <a:lnTo>
                    <a:pt x="598042" y="2044810"/>
                  </a:lnTo>
                  <a:lnTo>
                    <a:pt x="597171" y="2049314"/>
                  </a:lnTo>
                  <a:lnTo>
                    <a:pt x="596315" y="2053818"/>
                  </a:lnTo>
                  <a:lnTo>
                    <a:pt x="595461" y="2058322"/>
                  </a:lnTo>
                  <a:lnTo>
                    <a:pt x="594624" y="2062826"/>
                  </a:lnTo>
                  <a:lnTo>
                    <a:pt x="593788" y="2067330"/>
                  </a:lnTo>
                  <a:lnTo>
                    <a:pt x="592965" y="2071834"/>
                  </a:lnTo>
                  <a:lnTo>
                    <a:pt x="592146" y="2076338"/>
                  </a:lnTo>
                  <a:lnTo>
                    <a:pt x="591335" y="2080842"/>
                  </a:lnTo>
                  <a:lnTo>
                    <a:pt x="590529" y="2085346"/>
                  </a:lnTo>
                  <a:lnTo>
                    <a:pt x="589729" y="2089850"/>
                  </a:lnTo>
                  <a:lnTo>
                    <a:pt x="588933" y="2094354"/>
                  </a:lnTo>
                  <a:lnTo>
                    <a:pt x="588142" y="2098858"/>
                  </a:lnTo>
                  <a:lnTo>
                    <a:pt x="587356" y="2103362"/>
                  </a:lnTo>
                  <a:lnTo>
                    <a:pt x="586572" y="2107866"/>
                  </a:lnTo>
                  <a:lnTo>
                    <a:pt x="585793" y="2112370"/>
                  </a:lnTo>
                  <a:lnTo>
                    <a:pt x="585015" y="2116874"/>
                  </a:lnTo>
                  <a:lnTo>
                    <a:pt x="584241" y="2121378"/>
                  </a:lnTo>
                  <a:lnTo>
                    <a:pt x="583468" y="2125882"/>
                  </a:lnTo>
                  <a:lnTo>
                    <a:pt x="582698" y="2130386"/>
                  </a:lnTo>
                  <a:lnTo>
                    <a:pt x="581928" y="2134890"/>
                  </a:lnTo>
                  <a:lnTo>
                    <a:pt x="581159" y="2139394"/>
                  </a:lnTo>
                  <a:lnTo>
                    <a:pt x="580391" y="2143898"/>
                  </a:lnTo>
                  <a:lnTo>
                    <a:pt x="579623" y="2148402"/>
                  </a:lnTo>
                  <a:lnTo>
                    <a:pt x="578855" y="2152906"/>
                  </a:lnTo>
                  <a:lnTo>
                    <a:pt x="578087" y="2157410"/>
                  </a:lnTo>
                  <a:lnTo>
                    <a:pt x="577319" y="2161914"/>
                  </a:lnTo>
                  <a:lnTo>
                    <a:pt x="576550" y="2166418"/>
                  </a:lnTo>
                  <a:lnTo>
                    <a:pt x="575779" y="2170921"/>
                  </a:lnTo>
                  <a:lnTo>
                    <a:pt x="575008" y="2175425"/>
                  </a:lnTo>
                  <a:lnTo>
                    <a:pt x="574235" y="2179929"/>
                  </a:lnTo>
                  <a:lnTo>
                    <a:pt x="573461" y="2184433"/>
                  </a:lnTo>
                  <a:lnTo>
                    <a:pt x="572685" y="2188937"/>
                  </a:lnTo>
                  <a:lnTo>
                    <a:pt x="571907" y="2193441"/>
                  </a:lnTo>
                  <a:lnTo>
                    <a:pt x="571127" y="2197945"/>
                  </a:lnTo>
                  <a:lnTo>
                    <a:pt x="570345" y="2202449"/>
                  </a:lnTo>
                  <a:lnTo>
                    <a:pt x="569560" y="2206953"/>
                  </a:lnTo>
                  <a:lnTo>
                    <a:pt x="568773" y="2211457"/>
                  </a:lnTo>
                  <a:lnTo>
                    <a:pt x="567984" y="2215961"/>
                  </a:lnTo>
                  <a:lnTo>
                    <a:pt x="567192" y="2220465"/>
                  </a:lnTo>
                  <a:lnTo>
                    <a:pt x="566398" y="2224969"/>
                  </a:lnTo>
                  <a:lnTo>
                    <a:pt x="565600" y="2229473"/>
                  </a:lnTo>
                  <a:lnTo>
                    <a:pt x="564801" y="2233977"/>
                  </a:lnTo>
                  <a:lnTo>
                    <a:pt x="563997" y="2238481"/>
                  </a:lnTo>
                  <a:lnTo>
                    <a:pt x="563192" y="2242985"/>
                  </a:lnTo>
                  <a:lnTo>
                    <a:pt x="562383" y="2247489"/>
                  </a:lnTo>
                  <a:lnTo>
                    <a:pt x="561572" y="2251993"/>
                  </a:lnTo>
                  <a:lnTo>
                    <a:pt x="560757" y="2256497"/>
                  </a:lnTo>
                  <a:lnTo>
                    <a:pt x="559941" y="2261001"/>
                  </a:lnTo>
                  <a:lnTo>
                    <a:pt x="559121" y="2265505"/>
                  </a:lnTo>
                  <a:lnTo>
                    <a:pt x="558299" y="2270009"/>
                  </a:lnTo>
                  <a:lnTo>
                    <a:pt x="557474" y="2274513"/>
                  </a:lnTo>
                  <a:lnTo>
                    <a:pt x="556646" y="2279017"/>
                  </a:lnTo>
                  <a:lnTo>
                    <a:pt x="555817" y="2283521"/>
                  </a:lnTo>
                  <a:lnTo>
                    <a:pt x="554984" y="2288025"/>
                  </a:lnTo>
                  <a:lnTo>
                    <a:pt x="554150" y="2292529"/>
                  </a:lnTo>
                  <a:lnTo>
                    <a:pt x="553312" y="2297033"/>
                  </a:lnTo>
                  <a:lnTo>
                    <a:pt x="552474" y="2301537"/>
                  </a:lnTo>
                  <a:close/>
                </a:path>
              </a:pathLst>
            </a:custGeom>
            <a:solidFill>
              <a:srgbClr val="21908C">
                <a:alpha val="29803"/>
              </a:srgbClr>
            </a:solidFill>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00" name="pg7">
              <a:extLst>
                <a:ext uri="{FF2B5EF4-FFF2-40B4-BE49-F238E27FC236}">
                  <a16:creationId xmlns:a16="http://schemas.microsoft.com/office/drawing/2014/main" id="{A8015633-B27C-97E5-B51C-3FC31C527AF7}"/>
                </a:ext>
              </a:extLst>
            </p:cNvPr>
            <p:cNvSpPr/>
            <p:nvPr/>
          </p:nvSpPr>
          <p:spPr>
            <a:xfrm>
              <a:off x="1356213" y="3861859"/>
              <a:ext cx="275764" cy="753812"/>
            </a:xfrm>
            <a:custGeom>
              <a:avLst/>
              <a:gdLst/>
              <a:ahLst/>
              <a:cxnLst/>
              <a:rect l="0" t="0" r="0" b="0"/>
              <a:pathLst>
                <a:path w="824049" h="2252568">
                  <a:moveTo>
                    <a:pt x="344506" y="2252568"/>
                  </a:moveTo>
                  <a:lnTo>
                    <a:pt x="344111" y="2248160"/>
                  </a:lnTo>
                  <a:lnTo>
                    <a:pt x="343721" y="2243752"/>
                  </a:lnTo>
                  <a:lnTo>
                    <a:pt x="343340" y="2239344"/>
                  </a:lnTo>
                  <a:lnTo>
                    <a:pt x="342963" y="2234936"/>
                  </a:lnTo>
                  <a:lnTo>
                    <a:pt x="342597" y="2230527"/>
                  </a:lnTo>
                  <a:lnTo>
                    <a:pt x="342233" y="2226119"/>
                  </a:lnTo>
                  <a:lnTo>
                    <a:pt x="341881" y="2221711"/>
                  </a:lnTo>
                  <a:lnTo>
                    <a:pt x="341530" y="2217303"/>
                  </a:lnTo>
                  <a:lnTo>
                    <a:pt x="341194" y="2212895"/>
                  </a:lnTo>
                  <a:lnTo>
                    <a:pt x="340857" y="2208487"/>
                  </a:lnTo>
                  <a:lnTo>
                    <a:pt x="340535" y="2204079"/>
                  </a:lnTo>
                  <a:lnTo>
                    <a:pt x="340213" y="2199670"/>
                  </a:lnTo>
                  <a:lnTo>
                    <a:pt x="339905" y="2195262"/>
                  </a:lnTo>
                  <a:lnTo>
                    <a:pt x="339598" y="2190854"/>
                  </a:lnTo>
                  <a:lnTo>
                    <a:pt x="339303" y="2186446"/>
                  </a:lnTo>
                  <a:lnTo>
                    <a:pt x="339012" y="2182038"/>
                  </a:lnTo>
                  <a:lnTo>
                    <a:pt x="338730" y="2177630"/>
                  </a:lnTo>
                  <a:lnTo>
                    <a:pt x="338455" y="2173221"/>
                  </a:lnTo>
                  <a:lnTo>
                    <a:pt x="338187" y="2168813"/>
                  </a:lnTo>
                  <a:lnTo>
                    <a:pt x="337926" y="2164405"/>
                  </a:lnTo>
                  <a:lnTo>
                    <a:pt x="337671" y="2159997"/>
                  </a:lnTo>
                  <a:lnTo>
                    <a:pt x="337426" y="2155589"/>
                  </a:lnTo>
                  <a:lnTo>
                    <a:pt x="337184" y="2151181"/>
                  </a:lnTo>
                  <a:lnTo>
                    <a:pt x="336954" y="2146772"/>
                  </a:lnTo>
                  <a:lnTo>
                    <a:pt x="336726" y="2142364"/>
                  </a:lnTo>
                  <a:lnTo>
                    <a:pt x="336509" y="2137956"/>
                  </a:lnTo>
                  <a:lnTo>
                    <a:pt x="336294" y="2133548"/>
                  </a:lnTo>
                  <a:lnTo>
                    <a:pt x="336092" y="2129140"/>
                  </a:lnTo>
                  <a:lnTo>
                    <a:pt x="335890" y="2124732"/>
                  </a:lnTo>
                  <a:lnTo>
                    <a:pt x="335702" y="2120324"/>
                  </a:lnTo>
                  <a:lnTo>
                    <a:pt x="335514" y="2115915"/>
                  </a:lnTo>
                  <a:lnTo>
                    <a:pt x="335337" y="2111507"/>
                  </a:lnTo>
                  <a:lnTo>
                    <a:pt x="335163" y="2107099"/>
                  </a:lnTo>
                  <a:lnTo>
                    <a:pt x="334998" y="2102691"/>
                  </a:lnTo>
                  <a:lnTo>
                    <a:pt x="334836" y="2098283"/>
                  </a:lnTo>
                  <a:lnTo>
                    <a:pt x="334682" y="2093875"/>
                  </a:lnTo>
                  <a:lnTo>
                    <a:pt x="334533" y="2089466"/>
                  </a:lnTo>
                  <a:lnTo>
                    <a:pt x="334390" y="2085058"/>
                  </a:lnTo>
                  <a:lnTo>
                    <a:pt x="334252" y="2080650"/>
                  </a:lnTo>
                  <a:lnTo>
                    <a:pt x="334120" y="2076242"/>
                  </a:lnTo>
                  <a:lnTo>
                    <a:pt x="333993" y="2071834"/>
                  </a:lnTo>
                  <a:lnTo>
                    <a:pt x="333870" y="2067426"/>
                  </a:lnTo>
                  <a:lnTo>
                    <a:pt x="333754" y="2063017"/>
                  </a:lnTo>
                  <a:lnTo>
                    <a:pt x="333639" y="2058609"/>
                  </a:lnTo>
                  <a:lnTo>
                    <a:pt x="333533" y="2054201"/>
                  </a:lnTo>
                  <a:lnTo>
                    <a:pt x="333427" y="2049793"/>
                  </a:lnTo>
                  <a:lnTo>
                    <a:pt x="333329" y="2045385"/>
                  </a:lnTo>
                  <a:lnTo>
                    <a:pt x="333231" y="2040977"/>
                  </a:lnTo>
                  <a:lnTo>
                    <a:pt x="333141" y="2036568"/>
                  </a:lnTo>
                  <a:lnTo>
                    <a:pt x="333050" y="2032160"/>
                  </a:lnTo>
                  <a:lnTo>
                    <a:pt x="332966" y="2027752"/>
                  </a:lnTo>
                  <a:lnTo>
                    <a:pt x="332882" y="2023344"/>
                  </a:lnTo>
                  <a:lnTo>
                    <a:pt x="332804" y="2018936"/>
                  </a:lnTo>
                  <a:lnTo>
                    <a:pt x="332726" y="2014528"/>
                  </a:lnTo>
                  <a:lnTo>
                    <a:pt x="332651" y="2010120"/>
                  </a:lnTo>
                  <a:lnTo>
                    <a:pt x="332578" y="2005711"/>
                  </a:lnTo>
                  <a:lnTo>
                    <a:pt x="332507" y="2001303"/>
                  </a:lnTo>
                  <a:lnTo>
                    <a:pt x="332438" y="1996895"/>
                  </a:lnTo>
                  <a:lnTo>
                    <a:pt x="332369" y="1992487"/>
                  </a:lnTo>
                  <a:lnTo>
                    <a:pt x="332302" y="1988079"/>
                  </a:lnTo>
                  <a:lnTo>
                    <a:pt x="332236" y="1983671"/>
                  </a:lnTo>
                  <a:lnTo>
                    <a:pt x="332170" y="1979262"/>
                  </a:lnTo>
                  <a:lnTo>
                    <a:pt x="332104" y="1974854"/>
                  </a:lnTo>
                  <a:lnTo>
                    <a:pt x="332039" y="1970446"/>
                  </a:lnTo>
                  <a:lnTo>
                    <a:pt x="331973" y="1966038"/>
                  </a:lnTo>
                  <a:lnTo>
                    <a:pt x="331906" y="1961630"/>
                  </a:lnTo>
                  <a:lnTo>
                    <a:pt x="331839" y="1957222"/>
                  </a:lnTo>
                  <a:lnTo>
                    <a:pt x="331769" y="1952813"/>
                  </a:lnTo>
                  <a:lnTo>
                    <a:pt x="331700" y="1948405"/>
                  </a:lnTo>
                  <a:lnTo>
                    <a:pt x="331627" y="1943997"/>
                  </a:lnTo>
                  <a:lnTo>
                    <a:pt x="331554" y="1939589"/>
                  </a:lnTo>
                  <a:lnTo>
                    <a:pt x="331476" y="1935181"/>
                  </a:lnTo>
                  <a:lnTo>
                    <a:pt x="331398" y="1930773"/>
                  </a:lnTo>
                  <a:lnTo>
                    <a:pt x="331315" y="1926365"/>
                  </a:lnTo>
                  <a:lnTo>
                    <a:pt x="331230" y="1921956"/>
                  </a:lnTo>
                  <a:lnTo>
                    <a:pt x="331140" y="1917548"/>
                  </a:lnTo>
                  <a:lnTo>
                    <a:pt x="331047" y="1913140"/>
                  </a:lnTo>
                  <a:lnTo>
                    <a:pt x="330950" y="1908732"/>
                  </a:lnTo>
                  <a:lnTo>
                    <a:pt x="330848" y="1904324"/>
                  </a:lnTo>
                  <a:lnTo>
                    <a:pt x="330741" y="1899916"/>
                  </a:lnTo>
                  <a:lnTo>
                    <a:pt x="330629" y="1895507"/>
                  </a:lnTo>
                  <a:lnTo>
                    <a:pt x="330512" y="1891099"/>
                  </a:lnTo>
                  <a:lnTo>
                    <a:pt x="330388" y="1886691"/>
                  </a:lnTo>
                  <a:lnTo>
                    <a:pt x="330260" y="1882283"/>
                  </a:lnTo>
                  <a:lnTo>
                    <a:pt x="330122" y="1877875"/>
                  </a:lnTo>
                  <a:lnTo>
                    <a:pt x="329983" y="1873467"/>
                  </a:lnTo>
                  <a:lnTo>
                    <a:pt x="329830" y="1869058"/>
                  </a:lnTo>
                  <a:lnTo>
                    <a:pt x="329677" y="1864650"/>
                  </a:lnTo>
                  <a:lnTo>
                    <a:pt x="329509" y="1860242"/>
                  </a:lnTo>
                  <a:lnTo>
                    <a:pt x="329340" y="1855834"/>
                  </a:lnTo>
                  <a:lnTo>
                    <a:pt x="329156" y="1851426"/>
                  </a:lnTo>
                  <a:lnTo>
                    <a:pt x="328969" y="1847018"/>
                  </a:lnTo>
                  <a:lnTo>
                    <a:pt x="328768" y="1842610"/>
                  </a:lnTo>
                  <a:lnTo>
                    <a:pt x="328563" y="1838201"/>
                  </a:lnTo>
                  <a:lnTo>
                    <a:pt x="328345" y="1833793"/>
                  </a:lnTo>
                  <a:lnTo>
                    <a:pt x="328120" y="1829385"/>
                  </a:lnTo>
                  <a:lnTo>
                    <a:pt x="327883" y="1824977"/>
                  </a:lnTo>
                  <a:lnTo>
                    <a:pt x="327636" y="1820569"/>
                  </a:lnTo>
                  <a:lnTo>
                    <a:pt x="327380" y="1816161"/>
                  </a:lnTo>
                  <a:lnTo>
                    <a:pt x="327111" y="1811752"/>
                  </a:lnTo>
                  <a:lnTo>
                    <a:pt x="326834" y="1807344"/>
                  </a:lnTo>
                  <a:lnTo>
                    <a:pt x="326541" y="1802936"/>
                  </a:lnTo>
                  <a:lnTo>
                    <a:pt x="326243" y="1798528"/>
                  </a:lnTo>
                  <a:lnTo>
                    <a:pt x="325925" y="1794120"/>
                  </a:lnTo>
                  <a:lnTo>
                    <a:pt x="325604" y="1789712"/>
                  </a:lnTo>
                  <a:lnTo>
                    <a:pt x="325261" y="1785303"/>
                  </a:lnTo>
                  <a:lnTo>
                    <a:pt x="324917" y="1780895"/>
                  </a:lnTo>
                  <a:lnTo>
                    <a:pt x="324547" y="1776487"/>
                  </a:lnTo>
                  <a:lnTo>
                    <a:pt x="324177" y="1772079"/>
                  </a:lnTo>
                  <a:lnTo>
                    <a:pt x="323781" y="1767671"/>
                  </a:lnTo>
                  <a:lnTo>
                    <a:pt x="323383" y="1763263"/>
                  </a:lnTo>
                  <a:lnTo>
                    <a:pt x="322961" y="1758855"/>
                  </a:lnTo>
                  <a:lnTo>
                    <a:pt x="322535" y="1754446"/>
                  </a:lnTo>
                  <a:lnTo>
                    <a:pt x="322087" y="1750038"/>
                  </a:lnTo>
                  <a:lnTo>
                    <a:pt x="321630" y="1745630"/>
                  </a:lnTo>
                  <a:lnTo>
                    <a:pt x="321156" y="1741222"/>
                  </a:lnTo>
                  <a:lnTo>
                    <a:pt x="320669" y="1736814"/>
                  </a:lnTo>
                  <a:lnTo>
                    <a:pt x="320167" y="1732406"/>
                  </a:lnTo>
                  <a:lnTo>
                    <a:pt x="319649" y="1727997"/>
                  </a:lnTo>
                  <a:lnTo>
                    <a:pt x="319119" y="1723589"/>
                  </a:lnTo>
                  <a:lnTo>
                    <a:pt x="318569" y="1719181"/>
                  </a:lnTo>
                  <a:lnTo>
                    <a:pt x="318011" y="1714773"/>
                  </a:lnTo>
                  <a:lnTo>
                    <a:pt x="317429" y="1710365"/>
                  </a:lnTo>
                  <a:lnTo>
                    <a:pt x="316842" y="1705957"/>
                  </a:lnTo>
                  <a:lnTo>
                    <a:pt x="316227" y="1701548"/>
                  </a:lnTo>
                  <a:lnTo>
                    <a:pt x="315611" y="1697140"/>
                  </a:lnTo>
                  <a:lnTo>
                    <a:pt x="314963" y="1692732"/>
                  </a:lnTo>
                  <a:lnTo>
                    <a:pt x="314316" y="1688324"/>
                  </a:lnTo>
                  <a:lnTo>
                    <a:pt x="313637" y="1683916"/>
                  </a:lnTo>
                  <a:lnTo>
                    <a:pt x="312956" y="1679508"/>
                  </a:lnTo>
                  <a:lnTo>
                    <a:pt x="312247" y="1675100"/>
                  </a:lnTo>
                  <a:lnTo>
                    <a:pt x="311532" y="1670691"/>
                  </a:lnTo>
                  <a:lnTo>
                    <a:pt x="310793" y="1666283"/>
                  </a:lnTo>
                  <a:lnTo>
                    <a:pt x="310045" y="1661875"/>
                  </a:lnTo>
                  <a:lnTo>
                    <a:pt x="309276" y="1657467"/>
                  </a:lnTo>
                  <a:lnTo>
                    <a:pt x="308495" y="1653059"/>
                  </a:lnTo>
                  <a:lnTo>
                    <a:pt x="307695" y="1648651"/>
                  </a:lnTo>
                  <a:lnTo>
                    <a:pt x="306880" y="1644242"/>
                  </a:lnTo>
                  <a:lnTo>
                    <a:pt x="306051" y="1639834"/>
                  </a:lnTo>
                  <a:lnTo>
                    <a:pt x="305203" y="1635426"/>
                  </a:lnTo>
                  <a:lnTo>
                    <a:pt x="304344" y="1631018"/>
                  </a:lnTo>
                  <a:lnTo>
                    <a:pt x="303463" y="1626610"/>
                  </a:lnTo>
                  <a:lnTo>
                    <a:pt x="302575" y="1622202"/>
                  </a:lnTo>
                  <a:lnTo>
                    <a:pt x="301660" y="1617793"/>
                  </a:lnTo>
                  <a:lnTo>
                    <a:pt x="300743" y="1613385"/>
                  </a:lnTo>
                  <a:lnTo>
                    <a:pt x="299797" y="1608977"/>
                  </a:lnTo>
                  <a:lnTo>
                    <a:pt x="298850" y="1604569"/>
                  </a:lnTo>
                  <a:lnTo>
                    <a:pt x="297872" y="1600161"/>
                  </a:lnTo>
                  <a:lnTo>
                    <a:pt x="296894" y="1595753"/>
                  </a:lnTo>
                  <a:lnTo>
                    <a:pt x="295888" y="1591345"/>
                  </a:lnTo>
                  <a:lnTo>
                    <a:pt x="294879" y="1586936"/>
                  </a:lnTo>
                  <a:lnTo>
                    <a:pt x="293846" y="1582528"/>
                  </a:lnTo>
                  <a:lnTo>
                    <a:pt x="292807" y="1578120"/>
                  </a:lnTo>
                  <a:lnTo>
                    <a:pt x="291747" y="1573712"/>
                  </a:lnTo>
                  <a:lnTo>
                    <a:pt x="290678" y="1569304"/>
                  </a:lnTo>
                  <a:lnTo>
                    <a:pt x="289593" y="1564896"/>
                  </a:lnTo>
                  <a:lnTo>
                    <a:pt x="288495" y="1560487"/>
                  </a:lnTo>
                  <a:lnTo>
                    <a:pt x="287384" y="1556079"/>
                  </a:lnTo>
                  <a:lnTo>
                    <a:pt x="286259" y="1551671"/>
                  </a:lnTo>
                  <a:lnTo>
                    <a:pt x="285124" y="1547263"/>
                  </a:lnTo>
                  <a:lnTo>
                    <a:pt x="283972" y="1542855"/>
                  </a:lnTo>
                  <a:lnTo>
                    <a:pt x="282813" y="1538447"/>
                  </a:lnTo>
                  <a:lnTo>
                    <a:pt x="281636" y="1534038"/>
                  </a:lnTo>
                  <a:lnTo>
                    <a:pt x="280455" y="1529630"/>
                  </a:lnTo>
                  <a:lnTo>
                    <a:pt x="279253" y="1525222"/>
                  </a:lnTo>
                  <a:lnTo>
                    <a:pt x="278050" y="1520814"/>
                  </a:lnTo>
                  <a:lnTo>
                    <a:pt x="276825" y="1516406"/>
                  </a:lnTo>
                  <a:lnTo>
                    <a:pt x="275600" y="1511998"/>
                  </a:lnTo>
                  <a:lnTo>
                    <a:pt x="274355" y="1507590"/>
                  </a:lnTo>
                  <a:lnTo>
                    <a:pt x="273108" y="1503181"/>
                  </a:lnTo>
                  <a:lnTo>
                    <a:pt x="271845" y="1498773"/>
                  </a:lnTo>
                  <a:lnTo>
                    <a:pt x="270578" y="1494365"/>
                  </a:lnTo>
                  <a:lnTo>
                    <a:pt x="269298" y="1489957"/>
                  </a:lnTo>
                  <a:lnTo>
                    <a:pt x="268012" y="1485549"/>
                  </a:lnTo>
                  <a:lnTo>
                    <a:pt x="266716" y="1481141"/>
                  </a:lnTo>
                  <a:lnTo>
                    <a:pt x="265412" y="1476732"/>
                  </a:lnTo>
                  <a:lnTo>
                    <a:pt x="264101" y="1472324"/>
                  </a:lnTo>
                  <a:lnTo>
                    <a:pt x="262783" y="1467916"/>
                  </a:lnTo>
                  <a:lnTo>
                    <a:pt x="261458" y="1463508"/>
                  </a:lnTo>
                  <a:lnTo>
                    <a:pt x="260125" y="1459100"/>
                  </a:lnTo>
                  <a:lnTo>
                    <a:pt x="258788" y="1454692"/>
                  </a:lnTo>
                  <a:lnTo>
                    <a:pt x="257442" y="1450283"/>
                  </a:lnTo>
                  <a:lnTo>
                    <a:pt x="256095" y="1445875"/>
                  </a:lnTo>
                  <a:lnTo>
                    <a:pt x="254738" y="1441467"/>
                  </a:lnTo>
                  <a:lnTo>
                    <a:pt x="253381" y="1437059"/>
                  </a:lnTo>
                  <a:lnTo>
                    <a:pt x="252015" y="1432651"/>
                  </a:lnTo>
                  <a:lnTo>
                    <a:pt x="250649" y="1428243"/>
                  </a:lnTo>
                  <a:lnTo>
                    <a:pt x="249276" y="1423835"/>
                  </a:lnTo>
                  <a:lnTo>
                    <a:pt x="247903" y="1419426"/>
                  </a:lnTo>
                  <a:lnTo>
                    <a:pt x="246524" y="1415018"/>
                  </a:lnTo>
                  <a:lnTo>
                    <a:pt x="245145" y="1410610"/>
                  </a:lnTo>
                  <a:lnTo>
                    <a:pt x="243763" y="1406202"/>
                  </a:lnTo>
                  <a:lnTo>
                    <a:pt x="242379" y="1401794"/>
                  </a:lnTo>
                  <a:lnTo>
                    <a:pt x="240994" y="1397386"/>
                  </a:lnTo>
                  <a:lnTo>
                    <a:pt x="239609" y="1392977"/>
                  </a:lnTo>
                  <a:lnTo>
                    <a:pt x="238222" y="1388569"/>
                  </a:lnTo>
                  <a:lnTo>
                    <a:pt x="236836" y="1384161"/>
                  </a:lnTo>
                  <a:lnTo>
                    <a:pt x="235450" y="1379753"/>
                  </a:lnTo>
                  <a:lnTo>
                    <a:pt x="234065" y="1375345"/>
                  </a:lnTo>
                  <a:lnTo>
                    <a:pt x="232680" y="1370937"/>
                  </a:lnTo>
                  <a:lnTo>
                    <a:pt x="231297" y="1366528"/>
                  </a:lnTo>
                  <a:lnTo>
                    <a:pt x="229916" y="1362120"/>
                  </a:lnTo>
                  <a:lnTo>
                    <a:pt x="228537" y="1357712"/>
                  </a:lnTo>
                  <a:lnTo>
                    <a:pt x="227160" y="1353304"/>
                  </a:lnTo>
                  <a:lnTo>
                    <a:pt x="225787" y="1348896"/>
                  </a:lnTo>
                  <a:lnTo>
                    <a:pt x="224415" y="1344488"/>
                  </a:lnTo>
                  <a:lnTo>
                    <a:pt x="223050" y="1340080"/>
                  </a:lnTo>
                  <a:lnTo>
                    <a:pt x="221686" y="1335671"/>
                  </a:lnTo>
                  <a:lnTo>
                    <a:pt x="220329" y="1331263"/>
                  </a:lnTo>
                  <a:lnTo>
                    <a:pt x="218973" y="1326855"/>
                  </a:lnTo>
                  <a:lnTo>
                    <a:pt x="217626" y="1322447"/>
                  </a:lnTo>
                  <a:lnTo>
                    <a:pt x="216281" y="1318039"/>
                  </a:lnTo>
                  <a:lnTo>
                    <a:pt x="214945" y="1313631"/>
                  </a:lnTo>
                  <a:lnTo>
                    <a:pt x="213612" y="1309222"/>
                  </a:lnTo>
                  <a:lnTo>
                    <a:pt x="212287" y="1304814"/>
                  </a:lnTo>
                  <a:lnTo>
                    <a:pt x="210967" y="1300406"/>
                  </a:lnTo>
                  <a:lnTo>
                    <a:pt x="209655" y="1295998"/>
                  </a:lnTo>
                  <a:lnTo>
                    <a:pt x="208351" y="1291590"/>
                  </a:lnTo>
                  <a:lnTo>
                    <a:pt x="207052" y="1287182"/>
                  </a:lnTo>
                  <a:lnTo>
                    <a:pt x="205764" y="1282773"/>
                  </a:lnTo>
                  <a:lnTo>
                    <a:pt x="204480" y="1278365"/>
                  </a:lnTo>
                  <a:lnTo>
                    <a:pt x="203208" y="1273957"/>
                  </a:lnTo>
                  <a:lnTo>
                    <a:pt x="201940" y="1269549"/>
                  </a:lnTo>
                  <a:lnTo>
                    <a:pt x="200687" y="1265141"/>
                  </a:lnTo>
                  <a:lnTo>
                    <a:pt x="199436" y="1260733"/>
                  </a:lnTo>
                  <a:lnTo>
                    <a:pt x="198202" y="1256325"/>
                  </a:lnTo>
                  <a:lnTo>
                    <a:pt x="196969" y="1251916"/>
                  </a:lnTo>
                  <a:lnTo>
                    <a:pt x="195755" y="1247508"/>
                  </a:lnTo>
                  <a:lnTo>
                    <a:pt x="194542" y="1243100"/>
                  </a:lnTo>
                  <a:lnTo>
                    <a:pt x="193347" y="1238692"/>
                  </a:lnTo>
                  <a:lnTo>
                    <a:pt x="192155" y="1234284"/>
                  </a:lnTo>
                  <a:lnTo>
                    <a:pt x="190979" y="1229876"/>
                  </a:lnTo>
                  <a:lnTo>
                    <a:pt x="189810" y="1225467"/>
                  </a:lnTo>
                  <a:lnTo>
                    <a:pt x="188654" y="1221059"/>
                  </a:lnTo>
                  <a:lnTo>
                    <a:pt x="187507" y="1216651"/>
                  </a:lnTo>
                  <a:lnTo>
                    <a:pt x="186372" y="1212243"/>
                  </a:lnTo>
                  <a:lnTo>
                    <a:pt x="185248" y="1207835"/>
                  </a:lnTo>
                  <a:lnTo>
                    <a:pt x="184134" y="1203427"/>
                  </a:lnTo>
                  <a:lnTo>
                    <a:pt x="183034" y="1199018"/>
                  </a:lnTo>
                  <a:lnTo>
                    <a:pt x="181941" y="1194610"/>
                  </a:lnTo>
                  <a:lnTo>
                    <a:pt x="180865" y="1190202"/>
                  </a:lnTo>
                  <a:lnTo>
                    <a:pt x="179794" y="1185794"/>
                  </a:lnTo>
                  <a:lnTo>
                    <a:pt x="178742" y="1181386"/>
                  </a:lnTo>
                  <a:lnTo>
                    <a:pt x="177692" y="1176978"/>
                  </a:lnTo>
                  <a:lnTo>
                    <a:pt x="176665" y="1172570"/>
                  </a:lnTo>
                  <a:lnTo>
                    <a:pt x="175638" y="1168161"/>
                  </a:lnTo>
                  <a:lnTo>
                    <a:pt x="174634" y="1163753"/>
                  </a:lnTo>
                  <a:lnTo>
                    <a:pt x="173632" y="1159345"/>
                  </a:lnTo>
                  <a:lnTo>
                    <a:pt x="172650" y="1154937"/>
                  </a:lnTo>
                  <a:lnTo>
                    <a:pt x="171672" y="1150529"/>
                  </a:lnTo>
                  <a:lnTo>
                    <a:pt x="170712" y="1146121"/>
                  </a:lnTo>
                  <a:lnTo>
                    <a:pt x="169758" y="1141712"/>
                  </a:lnTo>
                  <a:lnTo>
                    <a:pt x="168820" y="1137304"/>
                  </a:lnTo>
                  <a:lnTo>
                    <a:pt x="167890" y="1132896"/>
                  </a:lnTo>
                  <a:lnTo>
                    <a:pt x="166973" y="1128488"/>
                  </a:lnTo>
                  <a:lnTo>
                    <a:pt x="166067" y="1124080"/>
                  </a:lnTo>
                  <a:lnTo>
                    <a:pt x="165171" y="1119672"/>
                  </a:lnTo>
                  <a:lnTo>
                    <a:pt x="164288" y="1115263"/>
                  </a:lnTo>
                  <a:lnTo>
                    <a:pt x="163412" y="1110855"/>
                  </a:lnTo>
                  <a:lnTo>
                    <a:pt x="162551" y="1106447"/>
                  </a:lnTo>
                  <a:lnTo>
                    <a:pt x="161696" y="1102039"/>
                  </a:lnTo>
                  <a:lnTo>
                    <a:pt x="160857" y="1097631"/>
                  </a:lnTo>
                  <a:lnTo>
                    <a:pt x="160021" y="1093223"/>
                  </a:lnTo>
                  <a:lnTo>
                    <a:pt x="159203" y="1088815"/>
                  </a:lnTo>
                  <a:lnTo>
                    <a:pt x="158386" y="1084406"/>
                  </a:lnTo>
                  <a:lnTo>
                    <a:pt x="157588" y="1079998"/>
                  </a:lnTo>
                  <a:lnTo>
                    <a:pt x="156791" y="1075590"/>
                  </a:lnTo>
                  <a:lnTo>
                    <a:pt x="156011" y="1071182"/>
                  </a:lnTo>
                  <a:lnTo>
                    <a:pt x="155232" y="1066774"/>
                  </a:lnTo>
                  <a:lnTo>
                    <a:pt x="154469" y="1062366"/>
                  </a:lnTo>
                  <a:lnTo>
                    <a:pt x="153708" y="1057957"/>
                  </a:lnTo>
                  <a:lnTo>
                    <a:pt x="152960" y="1053549"/>
                  </a:lnTo>
                  <a:lnTo>
                    <a:pt x="152217" y="1049141"/>
                  </a:lnTo>
                  <a:lnTo>
                    <a:pt x="151483" y="1044733"/>
                  </a:lnTo>
                  <a:lnTo>
                    <a:pt x="150756" y="1040325"/>
                  </a:lnTo>
                  <a:lnTo>
                    <a:pt x="150036" y="1035917"/>
                  </a:lnTo>
                  <a:lnTo>
                    <a:pt x="149323" y="1031508"/>
                  </a:lnTo>
                  <a:lnTo>
                    <a:pt x="148615" y="1027100"/>
                  </a:lnTo>
                  <a:lnTo>
                    <a:pt x="147915" y="1022692"/>
                  </a:lnTo>
                  <a:lnTo>
                    <a:pt x="147218" y="1018284"/>
                  </a:lnTo>
                  <a:lnTo>
                    <a:pt x="146530" y="1013876"/>
                  </a:lnTo>
                  <a:lnTo>
                    <a:pt x="145844" y="1009468"/>
                  </a:lnTo>
                  <a:lnTo>
                    <a:pt x="145166" y="1005060"/>
                  </a:lnTo>
                  <a:lnTo>
                    <a:pt x="144489" y="1000651"/>
                  </a:lnTo>
                  <a:lnTo>
                    <a:pt x="143820" y="996243"/>
                  </a:lnTo>
                  <a:lnTo>
                    <a:pt x="143151" y="991835"/>
                  </a:lnTo>
                  <a:lnTo>
                    <a:pt x="142488" y="987427"/>
                  </a:lnTo>
                  <a:lnTo>
                    <a:pt x="141826" y="983019"/>
                  </a:lnTo>
                  <a:lnTo>
                    <a:pt x="141169" y="978611"/>
                  </a:lnTo>
                  <a:lnTo>
                    <a:pt x="140512" y="974202"/>
                  </a:lnTo>
                  <a:lnTo>
                    <a:pt x="139858" y="969794"/>
                  </a:lnTo>
                  <a:lnTo>
                    <a:pt x="139206" y="965386"/>
                  </a:lnTo>
                  <a:lnTo>
                    <a:pt x="138554" y="960978"/>
                  </a:lnTo>
                  <a:lnTo>
                    <a:pt x="137904" y="956570"/>
                  </a:lnTo>
                  <a:lnTo>
                    <a:pt x="137253" y="952162"/>
                  </a:lnTo>
                  <a:lnTo>
                    <a:pt x="136603" y="947753"/>
                  </a:lnTo>
                  <a:lnTo>
                    <a:pt x="135953" y="943345"/>
                  </a:lnTo>
                  <a:lnTo>
                    <a:pt x="135301" y="938937"/>
                  </a:lnTo>
                  <a:lnTo>
                    <a:pt x="134649" y="934529"/>
                  </a:lnTo>
                  <a:lnTo>
                    <a:pt x="133995" y="930121"/>
                  </a:lnTo>
                  <a:lnTo>
                    <a:pt x="133340" y="925713"/>
                  </a:lnTo>
                  <a:lnTo>
                    <a:pt x="132681" y="921305"/>
                  </a:lnTo>
                  <a:lnTo>
                    <a:pt x="132021" y="916896"/>
                  </a:lnTo>
                  <a:lnTo>
                    <a:pt x="131356" y="912488"/>
                  </a:lnTo>
                  <a:lnTo>
                    <a:pt x="130691" y="908080"/>
                  </a:lnTo>
                  <a:lnTo>
                    <a:pt x="130018" y="903672"/>
                  </a:lnTo>
                  <a:lnTo>
                    <a:pt x="129345" y="899264"/>
                  </a:lnTo>
                  <a:lnTo>
                    <a:pt x="128663" y="894856"/>
                  </a:lnTo>
                  <a:lnTo>
                    <a:pt x="127981" y="890447"/>
                  </a:lnTo>
                  <a:lnTo>
                    <a:pt x="127290" y="886039"/>
                  </a:lnTo>
                  <a:lnTo>
                    <a:pt x="126596" y="881631"/>
                  </a:lnTo>
                  <a:lnTo>
                    <a:pt x="125894" y="877223"/>
                  </a:lnTo>
                  <a:lnTo>
                    <a:pt x="125187" y="872815"/>
                  </a:lnTo>
                  <a:lnTo>
                    <a:pt x="124473" y="868407"/>
                  </a:lnTo>
                  <a:lnTo>
                    <a:pt x="123752" y="863998"/>
                  </a:lnTo>
                  <a:lnTo>
                    <a:pt x="123025" y="859590"/>
                  </a:lnTo>
                  <a:lnTo>
                    <a:pt x="122289" y="855182"/>
                  </a:lnTo>
                  <a:lnTo>
                    <a:pt x="121547" y="850774"/>
                  </a:lnTo>
                  <a:lnTo>
                    <a:pt x="120794" y="846366"/>
                  </a:lnTo>
                  <a:lnTo>
                    <a:pt x="120037" y="841958"/>
                  </a:lnTo>
                  <a:lnTo>
                    <a:pt x="119266" y="837550"/>
                  </a:lnTo>
                  <a:lnTo>
                    <a:pt x="118492" y="833141"/>
                  </a:lnTo>
                  <a:lnTo>
                    <a:pt x="117702" y="828733"/>
                  </a:lnTo>
                  <a:lnTo>
                    <a:pt x="116911" y="824325"/>
                  </a:lnTo>
                  <a:lnTo>
                    <a:pt x="116100" y="819917"/>
                  </a:lnTo>
                  <a:lnTo>
                    <a:pt x="115289" y="815509"/>
                  </a:lnTo>
                  <a:lnTo>
                    <a:pt x="114458" y="811101"/>
                  </a:lnTo>
                  <a:lnTo>
                    <a:pt x="113626" y="806692"/>
                  </a:lnTo>
                  <a:lnTo>
                    <a:pt x="112776" y="802284"/>
                  </a:lnTo>
                  <a:lnTo>
                    <a:pt x="111921" y="797876"/>
                  </a:lnTo>
                  <a:lnTo>
                    <a:pt x="111050" y="793468"/>
                  </a:lnTo>
                  <a:lnTo>
                    <a:pt x="110173" y="789060"/>
                  </a:lnTo>
                  <a:lnTo>
                    <a:pt x="109281" y="784652"/>
                  </a:lnTo>
                  <a:lnTo>
                    <a:pt x="108379" y="780243"/>
                  </a:lnTo>
                  <a:lnTo>
                    <a:pt x="107466" y="775835"/>
                  </a:lnTo>
                  <a:lnTo>
                    <a:pt x="106540" y="771427"/>
                  </a:lnTo>
                  <a:lnTo>
                    <a:pt x="105605" y="767019"/>
                  </a:lnTo>
                  <a:lnTo>
                    <a:pt x="104655" y="762611"/>
                  </a:lnTo>
                  <a:lnTo>
                    <a:pt x="103697" y="758203"/>
                  </a:lnTo>
                  <a:lnTo>
                    <a:pt x="102722" y="753795"/>
                  </a:lnTo>
                  <a:lnTo>
                    <a:pt x="101742" y="749386"/>
                  </a:lnTo>
                  <a:lnTo>
                    <a:pt x="100742" y="744978"/>
                  </a:lnTo>
                  <a:lnTo>
                    <a:pt x="99739" y="740570"/>
                  </a:lnTo>
                  <a:lnTo>
                    <a:pt x="98714" y="736162"/>
                  </a:lnTo>
                  <a:lnTo>
                    <a:pt x="97688" y="731754"/>
                  </a:lnTo>
                  <a:lnTo>
                    <a:pt x="96638" y="727346"/>
                  </a:lnTo>
                  <a:lnTo>
                    <a:pt x="95588" y="722937"/>
                  </a:lnTo>
                  <a:lnTo>
                    <a:pt x="94516" y="718529"/>
                  </a:lnTo>
                  <a:lnTo>
                    <a:pt x="93440" y="714121"/>
                  </a:lnTo>
                  <a:lnTo>
                    <a:pt x="92347" y="709713"/>
                  </a:lnTo>
                  <a:lnTo>
                    <a:pt x="91247" y="705305"/>
                  </a:lnTo>
                  <a:lnTo>
                    <a:pt x="90132" y="700897"/>
                  </a:lnTo>
                  <a:lnTo>
                    <a:pt x="89009" y="696488"/>
                  </a:lnTo>
                  <a:lnTo>
                    <a:pt x="87873" y="692080"/>
                  </a:lnTo>
                  <a:lnTo>
                    <a:pt x="86726" y="687672"/>
                  </a:lnTo>
                  <a:lnTo>
                    <a:pt x="85570" y="683264"/>
                  </a:lnTo>
                  <a:lnTo>
                    <a:pt x="84401" y="678856"/>
                  </a:lnTo>
                  <a:lnTo>
                    <a:pt x="83226" y="674448"/>
                  </a:lnTo>
                  <a:lnTo>
                    <a:pt x="82036" y="670040"/>
                  </a:lnTo>
                  <a:lnTo>
                    <a:pt x="80842" y="665631"/>
                  </a:lnTo>
                  <a:lnTo>
                    <a:pt x="79632" y="661223"/>
                  </a:lnTo>
                  <a:lnTo>
                    <a:pt x="78420" y="656815"/>
                  </a:lnTo>
                  <a:lnTo>
                    <a:pt x="77192" y="652407"/>
                  </a:lnTo>
                  <a:lnTo>
                    <a:pt x="75963" y="647999"/>
                  </a:lnTo>
                  <a:lnTo>
                    <a:pt x="74718" y="643591"/>
                  </a:lnTo>
                  <a:lnTo>
                    <a:pt x="73472" y="639182"/>
                  </a:lnTo>
                  <a:lnTo>
                    <a:pt x="72213" y="634774"/>
                  </a:lnTo>
                  <a:lnTo>
                    <a:pt x="70951" y="630366"/>
                  </a:lnTo>
                  <a:lnTo>
                    <a:pt x="69679" y="625958"/>
                  </a:lnTo>
                  <a:lnTo>
                    <a:pt x="68404" y="621550"/>
                  </a:lnTo>
                  <a:lnTo>
                    <a:pt x="67121" y="617142"/>
                  </a:lnTo>
                  <a:lnTo>
                    <a:pt x="65835" y="612733"/>
                  </a:lnTo>
                  <a:lnTo>
                    <a:pt x="64542" y="608325"/>
                  </a:lnTo>
                  <a:lnTo>
                    <a:pt x="63245" y="603917"/>
                  </a:lnTo>
                  <a:lnTo>
                    <a:pt x="61945" y="599509"/>
                  </a:lnTo>
                  <a:lnTo>
                    <a:pt x="60641" y="595101"/>
                  </a:lnTo>
                  <a:lnTo>
                    <a:pt x="59335" y="590693"/>
                  </a:lnTo>
                  <a:lnTo>
                    <a:pt x="58025" y="586285"/>
                  </a:lnTo>
                  <a:lnTo>
                    <a:pt x="56714" y="581876"/>
                  </a:lnTo>
                  <a:lnTo>
                    <a:pt x="55402" y="577468"/>
                  </a:lnTo>
                  <a:lnTo>
                    <a:pt x="54089" y="573060"/>
                  </a:lnTo>
                  <a:lnTo>
                    <a:pt x="52776" y="568652"/>
                  </a:lnTo>
                  <a:lnTo>
                    <a:pt x="51463" y="564244"/>
                  </a:lnTo>
                  <a:lnTo>
                    <a:pt x="50152" y="559836"/>
                  </a:lnTo>
                  <a:lnTo>
                    <a:pt x="48842" y="555427"/>
                  </a:lnTo>
                  <a:lnTo>
                    <a:pt x="47536" y="551019"/>
                  </a:lnTo>
                  <a:lnTo>
                    <a:pt x="46230" y="546611"/>
                  </a:lnTo>
                  <a:lnTo>
                    <a:pt x="44931" y="542203"/>
                  </a:lnTo>
                  <a:lnTo>
                    <a:pt x="43633" y="537795"/>
                  </a:lnTo>
                  <a:lnTo>
                    <a:pt x="42343" y="533387"/>
                  </a:lnTo>
                  <a:lnTo>
                    <a:pt x="41056" y="528978"/>
                  </a:lnTo>
                  <a:lnTo>
                    <a:pt x="39778" y="524570"/>
                  </a:lnTo>
                  <a:lnTo>
                    <a:pt x="38505" y="520162"/>
                  </a:lnTo>
                  <a:lnTo>
                    <a:pt x="37240" y="515754"/>
                  </a:lnTo>
                  <a:lnTo>
                    <a:pt x="35984" y="511346"/>
                  </a:lnTo>
                  <a:lnTo>
                    <a:pt x="34737" y="506938"/>
                  </a:lnTo>
                  <a:lnTo>
                    <a:pt x="33501" y="502530"/>
                  </a:lnTo>
                  <a:lnTo>
                    <a:pt x="32272" y="498121"/>
                  </a:lnTo>
                  <a:lnTo>
                    <a:pt x="31059" y="493713"/>
                  </a:lnTo>
                  <a:lnTo>
                    <a:pt x="29852" y="489305"/>
                  </a:lnTo>
                  <a:lnTo>
                    <a:pt x="28666" y="484897"/>
                  </a:lnTo>
                  <a:lnTo>
                    <a:pt x="27483" y="480489"/>
                  </a:lnTo>
                  <a:lnTo>
                    <a:pt x="26327" y="476081"/>
                  </a:lnTo>
                  <a:lnTo>
                    <a:pt x="25172" y="471672"/>
                  </a:lnTo>
                  <a:lnTo>
                    <a:pt x="24049" y="467264"/>
                  </a:lnTo>
                  <a:lnTo>
                    <a:pt x="22926" y="462856"/>
                  </a:lnTo>
                  <a:lnTo>
                    <a:pt x="21836" y="458448"/>
                  </a:lnTo>
                  <a:lnTo>
                    <a:pt x="20750" y="454040"/>
                  </a:lnTo>
                  <a:lnTo>
                    <a:pt x="19695" y="449632"/>
                  </a:lnTo>
                  <a:lnTo>
                    <a:pt x="18650" y="445223"/>
                  </a:lnTo>
                  <a:lnTo>
                    <a:pt x="17633" y="440815"/>
                  </a:lnTo>
                  <a:lnTo>
                    <a:pt x="16631" y="436407"/>
                  </a:lnTo>
                  <a:lnTo>
                    <a:pt x="15654" y="431999"/>
                  </a:lnTo>
                  <a:lnTo>
                    <a:pt x="14699" y="427591"/>
                  </a:lnTo>
                  <a:lnTo>
                    <a:pt x="13766" y="423183"/>
                  </a:lnTo>
                  <a:lnTo>
                    <a:pt x="12861" y="418775"/>
                  </a:lnTo>
                  <a:lnTo>
                    <a:pt x="11974" y="414366"/>
                  </a:lnTo>
                  <a:lnTo>
                    <a:pt x="11122" y="409958"/>
                  </a:lnTo>
                  <a:lnTo>
                    <a:pt x="10283" y="405550"/>
                  </a:lnTo>
                  <a:lnTo>
                    <a:pt x="9489" y="401142"/>
                  </a:lnTo>
                  <a:lnTo>
                    <a:pt x="8701" y="396734"/>
                  </a:lnTo>
                  <a:lnTo>
                    <a:pt x="7966" y="392326"/>
                  </a:lnTo>
                  <a:lnTo>
                    <a:pt x="7232" y="387917"/>
                  </a:lnTo>
                  <a:lnTo>
                    <a:pt x="6560" y="383509"/>
                  </a:lnTo>
                  <a:lnTo>
                    <a:pt x="5888" y="379101"/>
                  </a:lnTo>
                  <a:lnTo>
                    <a:pt x="5276" y="374693"/>
                  </a:lnTo>
                  <a:lnTo>
                    <a:pt x="4670" y="370285"/>
                  </a:lnTo>
                  <a:lnTo>
                    <a:pt x="4119" y="365877"/>
                  </a:lnTo>
                  <a:lnTo>
                    <a:pt x="3582" y="361468"/>
                  </a:lnTo>
                  <a:lnTo>
                    <a:pt x="3095" y="357060"/>
                  </a:lnTo>
                  <a:lnTo>
                    <a:pt x="2629" y="352652"/>
                  </a:lnTo>
                  <a:lnTo>
                    <a:pt x="2208" y="348244"/>
                  </a:lnTo>
                  <a:lnTo>
                    <a:pt x="1817" y="343836"/>
                  </a:lnTo>
                  <a:lnTo>
                    <a:pt x="1464" y="339428"/>
                  </a:lnTo>
                  <a:lnTo>
                    <a:pt x="1150" y="335020"/>
                  </a:lnTo>
                  <a:lnTo>
                    <a:pt x="866" y="330611"/>
                  </a:lnTo>
                  <a:lnTo>
                    <a:pt x="633" y="326203"/>
                  </a:lnTo>
                  <a:lnTo>
                    <a:pt x="421" y="321795"/>
                  </a:lnTo>
                  <a:lnTo>
                    <a:pt x="269" y="317387"/>
                  </a:lnTo>
                  <a:lnTo>
                    <a:pt x="130" y="312979"/>
                  </a:lnTo>
                  <a:lnTo>
                    <a:pt x="63" y="308571"/>
                  </a:lnTo>
                  <a:lnTo>
                    <a:pt x="0" y="304162"/>
                  </a:lnTo>
                  <a:lnTo>
                    <a:pt x="18" y="299754"/>
                  </a:lnTo>
                  <a:lnTo>
                    <a:pt x="37" y="295346"/>
                  </a:lnTo>
                  <a:lnTo>
                    <a:pt x="139" y="290938"/>
                  </a:lnTo>
                  <a:lnTo>
                    <a:pt x="245" y="286530"/>
                  </a:lnTo>
                  <a:lnTo>
                    <a:pt x="427" y="282122"/>
                  </a:lnTo>
                  <a:lnTo>
                    <a:pt x="624" y="277713"/>
                  </a:lnTo>
                  <a:lnTo>
                    <a:pt x="887" y="273305"/>
                  </a:lnTo>
                  <a:lnTo>
                    <a:pt x="1175" y="268897"/>
                  </a:lnTo>
                  <a:lnTo>
                    <a:pt x="1520" y="264489"/>
                  </a:lnTo>
                  <a:lnTo>
                    <a:pt x="1901" y="260081"/>
                  </a:lnTo>
                  <a:lnTo>
                    <a:pt x="2330" y="255673"/>
                  </a:lnTo>
                  <a:lnTo>
                    <a:pt x="2804" y="251265"/>
                  </a:lnTo>
                  <a:lnTo>
                    <a:pt x="3317" y="246856"/>
                  </a:lnTo>
                  <a:lnTo>
                    <a:pt x="3886" y="242448"/>
                  </a:lnTo>
                  <a:lnTo>
                    <a:pt x="4484" y="238040"/>
                  </a:lnTo>
                  <a:lnTo>
                    <a:pt x="5148" y="233632"/>
                  </a:lnTo>
                  <a:lnTo>
                    <a:pt x="5831" y="229224"/>
                  </a:lnTo>
                  <a:lnTo>
                    <a:pt x="6591" y="224816"/>
                  </a:lnTo>
                  <a:lnTo>
                    <a:pt x="7360" y="220407"/>
                  </a:lnTo>
                  <a:lnTo>
                    <a:pt x="8217" y="215999"/>
                  </a:lnTo>
                  <a:lnTo>
                    <a:pt x="9073" y="211591"/>
                  </a:lnTo>
                  <a:lnTo>
                    <a:pt x="10025" y="207183"/>
                  </a:lnTo>
                  <a:lnTo>
                    <a:pt x="10978" y="202775"/>
                  </a:lnTo>
                  <a:lnTo>
                    <a:pt x="12015" y="198367"/>
                  </a:lnTo>
                  <a:lnTo>
                    <a:pt x="13064" y="193958"/>
                  </a:lnTo>
                  <a:lnTo>
                    <a:pt x="14187" y="189550"/>
                  </a:lnTo>
                  <a:lnTo>
                    <a:pt x="15332" y="185142"/>
                  </a:lnTo>
                  <a:lnTo>
                    <a:pt x="16541" y="180734"/>
                  </a:lnTo>
                  <a:lnTo>
                    <a:pt x="17781" y="176326"/>
                  </a:lnTo>
                  <a:lnTo>
                    <a:pt x="19075" y="171918"/>
                  </a:lnTo>
                  <a:lnTo>
                    <a:pt x="20410" y="167510"/>
                  </a:lnTo>
                  <a:lnTo>
                    <a:pt x="21787" y="163101"/>
                  </a:lnTo>
                  <a:lnTo>
                    <a:pt x="23216" y="158693"/>
                  </a:lnTo>
                  <a:lnTo>
                    <a:pt x="24677" y="154285"/>
                  </a:lnTo>
                  <a:lnTo>
                    <a:pt x="26199" y="149877"/>
                  </a:lnTo>
                  <a:lnTo>
                    <a:pt x="27742" y="145469"/>
                  </a:lnTo>
                  <a:lnTo>
                    <a:pt x="29355" y="141061"/>
                  </a:lnTo>
                  <a:lnTo>
                    <a:pt x="30979" y="136652"/>
                  </a:lnTo>
                  <a:lnTo>
                    <a:pt x="32681" y="132244"/>
                  </a:lnTo>
                  <a:lnTo>
                    <a:pt x="34386" y="127836"/>
                  </a:lnTo>
                  <a:lnTo>
                    <a:pt x="36176" y="123428"/>
                  </a:lnTo>
                  <a:lnTo>
                    <a:pt x="37966" y="119020"/>
                  </a:lnTo>
                  <a:lnTo>
                    <a:pt x="39834" y="114612"/>
                  </a:lnTo>
                  <a:lnTo>
                    <a:pt x="41710" y="110203"/>
                  </a:lnTo>
                  <a:lnTo>
                    <a:pt x="43654" y="105795"/>
                  </a:lnTo>
                  <a:lnTo>
                    <a:pt x="45614" y="101387"/>
                  </a:lnTo>
                  <a:lnTo>
                    <a:pt x="47630" y="96979"/>
                  </a:lnTo>
                  <a:lnTo>
                    <a:pt x="49671" y="92571"/>
                  </a:lnTo>
                  <a:lnTo>
                    <a:pt x="51759" y="88163"/>
                  </a:lnTo>
                  <a:lnTo>
                    <a:pt x="53879" y="83755"/>
                  </a:lnTo>
                  <a:lnTo>
                    <a:pt x="56036" y="79346"/>
                  </a:lnTo>
                  <a:lnTo>
                    <a:pt x="58232" y="74938"/>
                  </a:lnTo>
                  <a:lnTo>
                    <a:pt x="60455" y="70530"/>
                  </a:lnTo>
                  <a:lnTo>
                    <a:pt x="62724" y="66122"/>
                  </a:lnTo>
                  <a:lnTo>
                    <a:pt x="65013" y="61714"/>
                  </a:lnTo>
                  <a:lnTo>
                    <a:pt x="67352" y="57306"/>
                  </a:lnTo>
                  <a:lnTo>
                    <a:pt x="69703" y="52897"/>
                  </a:lnTo>
                  <a:lnTo>
                    <a:pt x="72109" y="48489"/>
                  </a:lnTo>
                  <a:lnTo>
                    <a:pt x="74520" y="44081"/>
                  </a:lnTo>
                  <a:lnTo>
                    <a:pt x="76990" y="39673"/>
                  </a:lnTo>
                  <a:lnTo>
                    <a:pt x="79460" y="35265"/>
                  </a:lnTo>
                  <a:lnTo>
                    <a:pt x="81988" y="30857"/>
                  </a:lnTo>
                  <a:lnTo>
                    <a:pt x="84519" y="26448"/>
                  </a:lnTo>
                  <a:lnTo>
                    <a:pt x="87098" y="22040"/>
                  </a:lnTo>
                  <a:lnTo>
                    <a:pt x="89686" y="17632"/>
                  </a:lnTo>
                  <a:lnTo>
                    <a:pt x="92313" y="13224"/>
                  </a:lnTo>
                  <a:lnTo>
                    <a:pt x="94954" y="8816"/>
                  </a:lnTo>
                  <a:lnTo>
                    <a:pt x="97627" y="4408"/>
                  </a:lnTo>
                  <a:lnTo>
                    <a:pt x="100317" y="0"/>
                  </a:lnTo>
                  <a:lnTo>
                    <a:pt x="723732" y="0"/>
                  </a:lnTo>
                  <a:lnTo>
                    <a:pt x="726422" y="4408"/>
                  </a:lnTo>
                  <a:lnTo>
                    <a:pt x="729095" y="8816"/>
                  </a:lnTo>
                  <a:lnTo>
                    <a:pt x="731736" y="13224"/>
                  </a:lnTo>
                  <a:lnTo>
                    <a:pt x="734363" y="17632"/>
                  </a:lnTo>
                  <a:lnTo>
                    <a:pt x="736951" y="22040"/>
                  </a:lnTo>
                  <a:lnTo>
                    <a:pt x="739530" y="26448"/>
                  </a:lnTo>
                  <a:lnTo>
                    <a:pt x="742061" y="30857"/>
                  </a:lnTo>
                  <a:lnTo>
                    <a:pt x="744589" y="35265"/>
                  </a:lnTo>
                  <a:lnTo>
                    <a:pt x="747059" y="39673"/>
                  </a:lnTo>
                  <a:lnTo>
                    <a:pt x="749529" y="44081"/>
                  </a:lnTo>
                  <a:lnTo>
                    <a:pt x="751940" y="48489"/>
                  </a:lnTo>
                  <a:lnTo>
                    <a:pt x="754346" y="52897"/>
                  </a:lnTo>
                  <a:lnTo>
                    <a:pt x="756697" y="57306"/>
                  </a:lnTo>
                  <a:lnTo>
                    <a:pt x="759036" y="61714"/>
                  </a:lnTo>
                  <a:lnTo>
                    <a:pt x="761324" y="66122"/>
                  </a:lnTo>
                  <a:lnTo>
                    <a:pt x="763593" y="70530"/>
                  </a:lnTo>
                  <a:lnTo>
                    <a:pt x="765817" y="74938"/>
                  </a:lnTo>
                  <a:lnTo>
                    <a:pt x="768013" y="79346"/>
                  </a:lnTo>
                  <a:lnTo>
                    <a:pt x="770170" y="83755"/>
                  </a:lnTo>
                  <a:lnTo>
                    <a:pt x="772290" y="88163"/>
                  </a:lnTo>
                  <a:lnTo>
                    <a:pt x="774378" y="92571"/>
                  </a:lnTo>
                  <a:lnTo>
                    <a:pt x="776418" y="96979"/>
                  </a:lnTo>
                  <a:lnTo>
                    <a:pt x="778435" y="101387"/>
                  </a:lnTo>
                  <a:lnTo>
                    <a:pt x="780395" y="105795"/>
                  </a:lnTo>
                  <a:lnTo>
                    <a:pt x="782338" y="110203"/>
                  </a:lnTo>
                  <a:lnTo>
                    <a:pt x="784214" y="114612"/>
                  </a:lnTo>
                  <a:lnTo>
                    <a:pt x="786083" y="119020"/>
                  </a:lnTo>
                  <a:lnTo>
                    <a:pt x="787873" y="123428"/>
                  </a:lnTo>
                  <a:lnTo>
                    <a:pt x="789663" y="127836"/>
                  </a:lnTo>
                  <a:lnTo>
                    <a:pt x="791368" y="132244"/>
                  </a:lnTo>
                  <a:lnTo>
                    <a:pt x="793070" y="136652"/>
                  </a:lnTo>
                  <a:lnTo>
                    <a:pt x="794694" y="141061"/>
                  </a:lnTo>
                  <a:lnTo>
                    <a:pt x="796307" y="145469"/>
                  </a:lnTo>
                  <a:lnTo>
                    <a:pt x="797850" y="149877"/>
                  </a:lnTo>
                  <a:lnTo>
                    <a:pt x="799372" y="154285"/>
                  </a:lnTo>
                  <a:lnTo>
                    <a:pt x="800832" y="158693"/>
                  </a:lnTo>
                  <a:lnTo>
                    <a:pt x="802261" y="163101"/>
                  </a:lnTo>
                  <a:lnTo>
                    <a:pt x="803639" y="167510"/>
                  </a:lnTo>
                  <a:lnTo>
                    <a:pt x="804974" y="171918"/>
                  </a:lnTo>
                  <a:lnTo>
                    <a:pt x="806267" y="176326"/>
                  </a:lnTo>
                  <a:lnTo>
                    <a:pt x="807508" y="180734"/>
                  </a:lnTo>
                  <a:lnTo>
                    <a:pt x="808716" y="185142"/>
                  </a:lnTo>
                  <a:lnTo>
                    <a:pt x="809862" y="189550"/>
                  </a:lnTo>
                  <a:lnTo>
                    <a:pt x="810985" y="193958"/>
                  </a:lnTo>
                  <a:lnTo>
                    <a:pt x="812034" y="198367"/>
                  </a:lnTo>
                  <a:lnTo>
                    <a:pt x="813071" y="202775"/>
                  </a:lnTo>
                  <a:lnTo>
                    <a:pt x="814024" y="207183"/>
                  </a:lnTo>
                  <a:lnTo>
                    <a:pt x="814976" y="211591"/>
                  </a:lnTo>
                  <a:lnTo>
                    <a:pt x="815832" y="215999"/>
                  </a:lnTo>
                  <a:lnTo>
                    <a:pt x="816689" y="220407"/>
                  </a:lnTo>
                  <a:lnTo>
                    <a:pt x="817458" y="224816"/>
                  </a:lnTo>
                  <a:lnTo>
                    <a:pt x="818218" y="229224"/>
                  </a:lnTo>
                  <a:lnTo>
                    <a:pt x="818901" y="233632"/>
                  </a:lnTo>
                  <a:lnTo>
                    <a:pt x="819565" y="238040"/>
                  </a:lnTo>
                  <a:lnTo>
                    <a:pt x="820163" y="242448"/>
                  </a:lnTo>
                  <a:lnTo>
                    <a:pt x="820732" y="246856"/>
                  </a:lnTo>
                  <a:lnTo>
                    <a:pt x="821245" y="251265"/>
                  </a:lnTo>
                  <a:lnTo>
                    <a:pt x="821719" y="255673"/>
                  </a:lnTo>
                  <a:lnTo>
                    <a:pt x="822148" y="260081"/>
                  </a:lnTo>
                  <a:lnTo>
                    <a:pt x="822529" y="264489"/>
                  </a:lnTo>
                  <a:lnTo>
                    <a:pt x="822874" y="268897"/>
                  </a:lnTo>
                  <a:lnTo>
                    <a:pt x="823162" y="273305"/>
                  </a:lnTo>
                  <a:lnTo>
                    <a:pt x="823425" y="277713"/>
                  </a:lnTo>
                  <a:lnTo>
                    <a:pt x="823622" y="282122"/>
                  </a:lnTo>
                  <a:lnTo>
                    <a:pt x="823804" y="286530"/>
                  </a:lnTo>
                  <a:lnTo>
                    <a:pt x="823910" y="290938"/>
                  </a:lnTo>
                  <a:lnTo>
                    <a:pt x="824012" y="295346"/>
                  </a:lnTo>
                  <a:lnTo>
                    <a:pt x="824031" y="299754"/>
                  </a:lnTo>
                  <a:lnTo>
                    <a:pt x="824049" y="304162"/>
                  </a:lnTo>
                  <a:lnTo>
                    <a:pt x="823986" y="308571"/>
                  </a:lnTo>
                  <a:lnTo>
                    <a:pt x="823919" y="312979"/>
                  </a:lnTo>
                  <a:lnTo>
                    <a:pt x="823780" y="317387"/>
                  </a:lnTo>
                  <a:lnTo>
                    <a:pt x="823628" y="321795"/>
                  </a:lnTo>
                  <a:lnTo>
                    <a:pt x="823416" y="326203"/>
                  </a:lnTo>
                  <a:lnTo>
                    <a:pt x="823183" y="330611"/>
                  </a:lnTo>
                  <a:lnTo>
                    <a:pt x="822899" y="335020"/>
                  </a:lnTo>
                  <a:lnTo>
                    <a:pt x="822585" y="339428"/>
                  </a:lnTo>
                  <a:lnTo>
                    <a:pt x="822232" y="343836"/>
                  </a:lnTo>
                  <a:lnTo>
                    <a:pt x="821841" y="348244"/>
                  </a:lnTo>
                  <a:lnTo>
                    <a:pt x="821419" y="352652"/>
                  </a:lnTo>
                  <a:lnTo>
                    <a:pt x="820954" y="357060"/>
                  </a:lnTo>
                  <a:lnTo>
                    <a:pt x="820467" y="361468"/>
                  </a:lnTo>
                  <a:lnTo>
                    <a:pt x="819930" y="365877"/>
                  </a:lnTo>
                  <a:lnTo>
                    <a:pt x="819379" y="370285"/>
                  </a:lnTo>
                  <a:lnTo>
                    <a:pt x="818773" y="374693"/>
                  </a:lnTo>
                  <a:lnTo>
                    <a:pt x="818161" y="379101"/>
                  </a:lnTo>
                  <a:lnTo>
                    <a:pt x="817489" y="383509"/>
                  </a:lnTo>
                  <a:lnTo>
                    <a:pt x="816817" y="387917"/>
                  </a:lnTo>
                  <a:lnTo>
                    <a:pt x="816083" y="392326"/>
                  </a:lnTo>
                  <a:lnTo>
                    <a:pt x="815348" y="396734"/>
                  </a:lnTo>
                  <a:lnTo>
                    <a:pt x="814560" y="401142"/>
                  </a:lnTo>
                  <a:lnTo>
                    <a:pt x="813765" y="405550"/>
                  </a:lnTo>
                  <a:lnTo>
                    <a:pt x="812927" y="409958"/>
                  </a:lnTo>
                  <a:lnTo>
                    <a:pt x="812075" y="414366"/>
                  </a:lnTo>
                  <a:lnTo>
                    <a:pt x="811188" y="418775"/>
                  </a:lnTo>
                  <a:lnTo>
                    <a:pt x="810283" y="423183"/>
                  </a:lnTo>
                  <a:lnTo>
                    <a:pt x="809350" y="427591"/>
                  </a:lnTo>
                  <a:lnTo>
                    <a:pt x="808395" y="431999"/>
                  </a:lnTo>
                  <a:lnTo>
                    <a:pt x="807418" y="436407"/>
                  </a:lnTo>
                  <a:lnTo>
                    <a:pt x="806416" y="440815"/>
                  </a:lnTo>
                  <a:lnTo>
                    <a:pt x="805399" y="445223"/>
                  </a:lnTo>
                  <a:lnTo>
                    <a:pt x="804354" y="449632"/>
                  </a:lnTo>
                  <a:lnTo>
                    <a:pt x="803299" y="454040"/>
                  </a:lnTo>
                  <a:lnTo>
                    <a:pt x="802213" y="458448"/>
                  </a:lnTo>
                  <a:lnTo>
                    <a:pt x="801123" y="462856"/>
                  </a:lnTo>
                  <a:lnTo>
                    <a:pt x="800000" y="467264"/>
                  </a:lnTo>
                  <a:lnTo>
                    <a:pt x="798877" y="471672"/>
                  </a:lnTo>
                  <a:lnTo>
                    <a:pt x="797722" y="476081"/>
                  </a:lnTo>
                  <a:lnTo>
                    <a:pt x="796566" y="480489"/>
                  </a:lnTo>
                  <a:lnTo>
                    <a:pt x="795383" y="484897"/>
                  </a:lnTo>
                  <a:lnTo>
                    <a:pt x="794197" y="489305"/>
                  </a:lnTo>
                  <a:lnTo>
                    <a:pt x="792989" y="493713"/>
                  </a:lnTo>
                  <a:lnTo>
                    <a:pt x="791777" y="498121"/>
                  </a:lnTo>
                  <a:lnTo>
                    <a:pt x="790548" y="502530"/>
                  </a:lnTo>
                  <a:lnTo>
                    <a:pt x="789312" y="506938"/>
                  </a:lnTo>
                  <a:lnTo>
                    <a:pt x="788064" y="511346"/>
                  </a:lnTo>
                  <a:lnTo>
                    <a:pt x="786808" y="515754"/>
                  </a:lnTo>
                  <a:lnTo>
                    <a:pt x="785544" y="520162"/>
                  </a:lnTo>
                  <a:lnTo>
                    <a:pt x="784271" y="524570"/>
                  </a:lnTo>
                  <a:lnTo>
                    <a:pt x="782993" y="528978"/>
                  </a:lnTo>
                  <a:lnTo>
                    <a:pt x="781706" y="533387"/>
                  </a:lnTo>
                  <a:lnTo>
                    <a:pt x="780416" y="537795"/>
                  </a:lnTo>
                  <a:lnTo>
                    <a:pt x="779118" y="542203"/>
                  </a:lnTo>
                  <a:lnTo>
                    <a:pt x="777819" y="546611"/>
                  </a:lnTo>
                  <a:lnTo>
                    <a:pt x="776513" y="551019"/>
                  </a:lnTo>
                  <a:lnTo>
                    <a:pt x="775207" y="555427"/>
                  </a:lnTo>
                  <a:lnTo>
                    <a:pt x="773896" y="559836"/>
                  </a:lnTo>
                  <a:lnTo>
                    <a:pt x="772586" y="564244"/>
                  </a:lnTo>
                  <a:lnTo>
                    <a:pt x="771273" y="568652"/>
                  </a:lnTo>
                  <a:lnTo>
                    <a:pt x="769960" y="573060"/>
                  </a:lnTo>
                  <a:lnTo>
                    <a:pt x="768647" y="577468"/>
                  </a:lnTo>
                  <a:lnTo>
                    <a:pt x="767334" y="581876"/>
                  </a:lnTo>
                  <a:lnTo>
                    <a:pt x="766024" y="586285"/>
                  </a:lnTo>
                  <a:lnTo>
                    <a:pt x="764714" y="590693"/>
                  </a:lnTo>
                  <a:lnTo>
                    <a:pt x="763408" y="595101"/>
                  </a:lnTo>
                  <a:lnTo>
                    <a:pt x="762104" y="599509"/>
                  </a:lnTo>
                  <a:lnTo>
                    <a:pt x="760803" y="603917"/>
                  </a:lnTo>
                  <a:lnTo>
                    <a:pt x="759507" y="608325"/>
                  </a:lnTo>
                  <a:lnTo>
                    <a:pt x="758214" y="612733"/>
                  </a:lnTo>
                  <a:lnTo>
                    <a:pt x="756928" y="617142"/>
                  </a:lnTo>
                  <a:lnTo>
                    <a:pt x="755644" y="621550"/>
                  </a:lnTo>
                  <a:lnTo>
                    <a:pt x="754369" y="625958"/>
                  </a:lnTo>
                  <a:lnTo>
                    <a:pt x="753097" y="630366"/>
                  </a:lnTo>
                  <a:lnTo>
                    <a:pt x="751836" y="634774"/>
                  </a:lnTo>
                  <a:lnTo>
                    <a:pt x="750577" y="639182"/>
                  </a:lnTo>
                  <a:lnTo>
                    <a:pt x="749331" y="643591"/>
                  </a:lnTo>
                  <a:lnTo>
                    <a:pt x="748086" y="647999"/>
                  </a:lnTo>
                  <a:lnTo>
                    <a:pt x="746857" y="652407"/>
                  </a:lnTo>
                  <a:lnTo>
                    <a:pt x="745629" y="656815"/>
                  </a:lnTo>
                  <a:lnTo>
                    <a:pt x="744417" y="661223"/>
                  </a:lnTo>
                  <a:lnTo>
                    <a:pt x="743207" y="665631"/>
                  </a:lnTo>
                  <a:lnTo>
                    <a:pt x="742013" y="670040"/>
                  </a:lnTo>
                  <a:lnTo>
                    <a:pt x="740823" y="674448"/>
                  </a:lnTo>
                  <a:lnTo>
                    <a:pt x="739647" y="678856"/>
                  </a:lnTo>
                  <a:lnTo>
                    <a:pt x="738479" y="683264"/>
                  </a:lnTo>
                  <a:lnTo>
                    <a:pt x="737323" y="687672"/>
                  </a:lnTo>
                  <a:lnTo>
                    <a:pt x="736176" y="692080"/>
                  </a:lnTo>
                  <a:lnTo>
                    <a:pt x="735040" y="696488"/>
                  </a:lnTo>
                  <a:lnTo>
                    <a:pt x="733917" y="700897"/>
                  </a:lnTo>
                  <a:lnTo>
                    <a:pt x="732802" y="705305"/>
                  </a:lnTo>
                  <a:lnTo>
                    <a:pt x="731702" y="709713"/>
                  </a:lnTo>
                  <a:lnTo>
                    <a:pt x="730608" y="714121"/>
                  </a:lnTo>
                  <a:lnTo>
                    <a:pt x="729533" y="718529"/>
                  </a:lnTo>
                  <a:lnTo>
                    <a:pt x="728461" y="722937"/>
                  </a:lnTo>
                  <a:lnTo>
                    <a:pt x="727410" y="727346"/>
                  </a:lnTo>
                  <a:lnTo>
                    <a:pt x="726361" y="731754"/>
                  </a:lnTo>
                  <a:lnTo>
                    <a:pt x="725335" y="736162"/>
                  </a:lnTo>
                  <a:lnTo>
                    <a:pt x="724309" y="740570"/>
                  </a:lnTo>
                  <a:lnTo>
                    <a:pt x="723307" y="744978"/>
                  </a:lnTo>
                  <a:lnTo>
                    <a:pt x="722307" y="749386"/>
                  </a:lnTo>
                  <a:lnTo>
                    <a:pt x="721327" y="753795"/>
                  </a:lnTo>
                  <a:lnTo>
                    <a:pt x="720352" y="758203"/>
                  </a:lnTo>
                  <a:lnTo>
                    <a:pt x="719394" y="762611"/>
                  </a:lnTo>
                  <a:lnTo>
                    <a:pt x="718444" y="767019"/>
                  </a:lnTo>
                  <a:lnTo>
                    <a:pt x="717509" y="771427"/>
                  </a:lnTo>
                  <a:lnTo>
                    <a:pt x="716583" y="775835"/>
                  </a:lnTo>
                  <a:lnTo>
                    <a:pt x="715669" y="780243"/>
                  </a:lnTo>
                  <a:lnTo>
                    <a:pt x="714768" y="784652"/>
                  </a:lnTo>
                  <a:lnTo>
                    <a:pt x="713876" y="789060"/>
                  </a:lnTo>
                  <a:lnTo>
                    <a:pt x="712999" y="793468"/>
                  </a:lnTo>
                  <a:lnTo>
                    <a:pt x="712128" y="797876"/>
                  </a:lnTo>
                  <a:lnTo>
                    <a:pt x="711273" y="802284"/>
                  </a:lnTo>
                  <a:lnTo>
                    <a:pt x="710423" y="806692"/>
                  </a:lnTo>
                  <a:lnTo>
                    <a:pt x="709590" y="811101"/>
                  </a:lnTo>
                  <a:lnTo>
                    <a:pt x="708760" y="815509"/>
                  </a:lnTo>
                  <a:lnTo>
                    <a:pt x="707949" y="819917"/>
                  </a:lnTo>
                  <a:lnTo>
                    <a:pt x="707138" y="824325"/>
                  </a:lnTo>
                  <a:lnTo>
                    <a:pt x="706347" y="828733"/>
                  </a:lnTo>
                  <a:lnTo>
                    <a:pt x="705557" y="833141"/>
                  </a:lnTo>
                  <a:lnTo>
                    <a:pt x="704783" y="837550"/>
                  </a:lnTo>
                  <a:lnTo>
                    <a:pt x="704012" y="841958"/>
                  </a:lnTo>
                  <a:lnTo>
                    <a:pt x="703255" y="846366"/>
                  </a:lnTo>
                  <a:lnTo>
                    <a:pt x="702502" y="850774"/>
                  </a:lnTo>
                  <a:lnTo>
                    <a:pt x="701760" y="855182"/>
                  </a:lnTo>
                  <a:lnTo>
                    <a:pt x="701024" y="859590"/>
                  </a:lnTo>
                  <a:lnTo>
                    <a:pt x="700296" y="863998"/>
                  </a:lnTo>
                  <a:lnTo>
                    <a:pt x="699576" y="868407"/>
                  </a:lnTo>
                  <a:lnTo>
                    <a:pt x="698862" y="872815"/>
                  </a:lnTo>
                  <a:lnTo>
                    <a:pt x="698155" y="877223"/>
                  </a:lnTo>
                  <a:lnTo>
                    <a:pt x="697453" y="881631"/>
                  </a:lnTo>
                  <a:lnTo>
                    <a:pt x="696759" y="886039"/>
                  </a:lnTo>
                  <a:lnTo>
                    <a:pt x="696068" y="890447"/>
                  </a:lnTo>
                  <a:lnTo>
                    <a:pt x="695385" y="894856"/>
                  </a:lnTo>
                  <a:lnTo>
                    <a:pt x="694704" y="899264"/>
                  </a:lnTo>
                  <a:lnTo>
                    <a:pt x="694031" y="903672"/>
                  </a:lnTo>
                  <a:lnTo>
                    <a:pt x="693358" y="908080"/>
                  </a:lnTo>
                  <a:lnTo>
                    <a:pt x="692693" y="912488"/>
                  </a:lnTo>
                  <a:lnTo>
                    <a:pt x="692028" y="916896"/>
                  </a:lnTo>
                  <a:lnTo>
                    <a:pt x="691368" y="921305"/>
                  </a:lnTo>
                  <a:lnTo>
                    <a:pt x="690709" y="925713"/>
                  </a:lnTo>
                  <a:lnTo>
                    <a:pt x="690054" y="930121"/>
                  </a:lnTo>
                  <a:lnTo>
                    <a:pt x="689400" y="934529"/>
                  </a:lnTo>
                  <a:lnTo>
                    <a:pt x="688748" y="938937"/>
                  </a:lnTo>
                  <a:lnTo>
                    <a:pt x="688096" y="943345"/>
                  </a:lnTo>
                  <a:lnTo>
                    <a:pt x="687446" y="947753"/>
                  </a:lnTo>
                  <a:lnTo>
                    <a:pt x="686796" y="952162"/>
                  </a:lnTo>
                  <a:lnTo>
                    <a:pt x="686145" y="956570"/>
                  </a:lnTo>
                  <a:lnTo>
                    <a:pt x="685495" y="960978"/>
                  </a:lnTo>
                  <a:lnTo>
                    <a:pt x="684843" y="965386"/>
                  </a:lnTo>
                  <a:lnTo>
                    <a:pt x="684190" y="969794"/>
                  </a:lnTo>
                  <a:lnTo>
                    <a:pt x="683537" y="974202"/>
                  </a:lnTo>
                  <a:lnTo>
                    <a:pt x="682880" y="978611"/>
                  </a:lnTo>
                  <a:lnTo>
                    <a:pt x="682223" y="983019"/>
                  </a:lnTo>
                  <a:lnTo>
                    <a:pt x="681561" y="987427"/>
                  </a:lnTo>
                  <a:lnTo>
                    <a:pt x="680898" y="991835"/>
                  </a:lnTo>
                  <a:lnTo>
                    <a:pt x="680229" y="996243"/>
                  </a:lnTo>
                  <a:lnTo>
                    <a:pt x="679560" y="1000651"/>
                  </a:lnTo>
                  <a:lnTo>
                    <a:pt x="678883" y="1005060"/>
                  </a:lnTo>
                  <a:lnTo>
                    <a:pt x="678205" y="1009468"/>
                  </a:lnTo>
                  <a:lnTo>
                    <a:pt x="677518" y="1013876"/>
                  </a:lnTo>
                  <a:lnTo>
                    <a:pt x="676830" y="1018284"/>
                  </a:lnTo>
                  <a:lnTo>
                    <a:pt x="676134" y="1022692"/>
                  </a:lnTo>
                  <a:lnTo>
                    <a:pt x="675434" y="1027100"/>
                  </a:lnTo>
                  <a:lnTo>
                    <a:pt x="674726" y="1031508"/>
                  </a:lnTo>
                  <a:lnTo>
                    <a:pt x="674013" y="1035917"/>
                  </a:lnTo>
                  <a:lnTo>
                    <a:pt x="673293" y="1040325"/>
                  </a:lnTo>
                  <a:lnTo>
                    <a:pt x="672566" y="1044733"/>
                  </a:lnTo>
                  <a:lnTo>
                    <a:pt x="671832" y="1049141"/>
                  </a:lnTo>
                  <a:lnTo>
                    <a:pt x="671089" y="1053549"/>
                  </a:lnTo>
                  <a:lnTo>
                    <a:pt x="670340" y="1057957"/>
                  </a:lnTo>
                  <a:lnTo>
                    <a:pt x="669580" y="1062366"/>
                  </a:lnTo>
                  <a:lnTo>
                    <a:pt x="668817" y="1066774"/>
                  </a:lnTo>
                  <a:lnTo>
                    <a:pt x="668038" y="1071182"/>
                  </a:lnTo>
                  <a:lnTo>
                    <a:pt x="667258" y="1075590"/>
                  </a:lnTo>
                  <a:lnTo>
                    <a:pt x="666461" y="1079998"/>
                  </a:lnTo>
                  <a:lnTo>
                    <a:pt x="665663" y="1084406"/>
                  </a:lnTo>
                  <a:lnTo>
                    <a:pt x="664846" y="1088815"/>
                  </a:lnTo>
                  <a:lnTo>
                    <a:pt x="664028" y="1093223"/>
                  </a:lnTo>
                  <a:lnTo>
                    <a:pt x="663192" y="1097631"/>
                  </a:lnTo>
                  <a:lnTo>
                    <a:pt x="662353" y="1102039"/>
                  </a:lnTo>
                  <a:lnTo>
                    <a:pt x="661498" y="1106447"/>
                  </a:lnTo>
                  <a:lnTo>
                    <a:pt x="660637" y="1110855"/>
                  </a:lnTo>
                  <a:lnTo>
                    <a:pt x="659761" y="1115263"/>
                  </a:lnTo>
                  <a:lnTo>
                    <a:pt x="658878" y="1119672"/>
                  </a:lnTo>
                  <a:lnTo>
                    <a:pt x="657982" y="1124080"/>
                  </a:lnTo>
                  <a:lnTo>
                    <a:pt x="657076" y="1128488"/>
                  </a:lnTo>
                  <a:lnTo>
                    <a:pt x="656159" y="1132896"/>
                  </a:lnTo>
                  <a:lnTo>
                    <a:pt x="655229" y="1137304"/>
                  </a:lnTo>
                  <a:lnTo>
                    <a:pt x="654291" y="1141712"/>
                  </a:lnTo>
                  <a:lnTo>
                    <a:pt x="653337" y="1146121"/>
                  </a:lnTo>
                  <a:lnTo>
                    <a:pt x="652377" y="1150529"/>
                  </a:lnTo>
                  <a:lnTo>
                    <a:pt x="651399" y="1154937"/>
                  </a:lnTo>
                  <a:lnTo>
                    <a:pt x="650417" y="1159345"/>
                  </a:lnTo>
                  <a:lnTo>
                    <a:pt x="649414" y="1163753"/>
                  </a:lnTo>
                  <a:lnTo>
                    <a:pt x="648411" y="1168161"/>
                  </a:lnTo>
                  <a:lnTo>
                    <a:pt x="647384" y="1172570"/>
                  </a:lnTo>
                  <a:lnTo>
                    <a:pt x="646357" y="1176978"/>
                  </a:lnTo>
                  <a:lnTo>
                    <a:pt x="645307" y="1181386"/>
                  </a:lnTo>
                  <a:lnTo>
                    <a:pt x="644255" y="1185794"/>
                  </a:lnTo>
                  <a:lnTo>
                    <a:pt x="643184" y="1190202"/>
                  </a:lnTo>
                  <a:lnTo>
                    <a:pt x="642108" y="1194610"/>
                  </a:lnTo>
                  <a:lnTo>
                    <a:pt x="641015" y="1199018"/>
                  </a:lnTo>
                  <a:lnTo>
                    <a:pt x="639915" y="1203427"/>
                  </a:lnTo>
                  <a:lnTo>
                    <a:pt x="638801" y="1207835"/>
                  </a:lnTo>
                  <a:lnTo>
                    <a:pt x="637677" y="1212243"/>
                  </a:lnTo>
                  <a:lnTo>
                    <a:pt x="636542" y="1216651"/>
                  </a:lnTo>
                  <a:lnTo>
                    <a:pt x="635395" y="1221059"/>
                  </a:lnTo>
                  <a:lnTo>
                    <a:pt x="634239" y="1225467"/>
                  </a:lnTo>
                  <a:lnTo>
                    <a:pt x="633070" y="1229876"/>
                  </a:lnTo>
                  <a:lnTo>
                    <a:pt x="631894" y="1234284"/>
                  </a:lnTo>
                  <a:lnTo>
                    <a:pt x="630702" y="1238692"/>
                  </a:lnTo>
                  <a:lnTo>
                    <a:pt x="629507" y="1243100"/>
                  </a:lnTo>
                  <a:lnTo>
                    <a:pt x="628294" y="1247508"/>
                  </a:lnTo>
                  <a:lnTo>
                    <a:pt x="627080" y="1251916"/>
                  </a:lnTo>
                  <a:lnTo>
                    <a:pt x="625847" y="1256325"/>
                  </a:lnTo>
                  <a:lnTo>
                    <a:pt x="624613" y="1260733"/>
                  </a:lnTo>
                  <a:lnTo>
                    <a:pt x="623361" y="1265141"/>
                  </a:lnTo>
                  <a:lnTo>
                    <a:pt x="622109" y="1269549"/>
                  </a:lnTo>
                  <a:lnTo>
                    <a:pt x="620840" y="1273957"/>
                  </a:lnTo>
                  <a:lnTo>
                    <a:pt x="619569" y="1278365"/>
                  </a:lnTo>
                  <a:lnTo>
                    <a:pt x="618285" y="1282773"/>
                  </a:lnTo>
                  <a:lnTo>
                    <a:pt x="616997" y="1287182"/>
                  </a:lnTo>
                  <a:lnTo>
                    <a:pt x="615698" y="1291590"/>
                  </a:lnTo>
                  <a:lnTo>
                    <a:pt x="614394" y="1295998"/>
                  </a:lnTo>
                  <a:lnTo>
                    <a:pt x="613081" y="1300406"/>
                  </a:lnTo>
                  <a:lnTo>
                    <a:pt x="611762" y="1304814"/>
                  </a:lnTo>
                  <a:lnTo>
                    <a:pt x="610437" y="1309222"/>
                  </a:lnTo>
                  <a:lnTo>
                    <a:pt x="609104" y="1313631"/>
                  </a:lnTo>
                  <a:lnTo>
                    <a:pt x="607768" y="1318039"/>
                  </a:lnTo>
                  <a:lnTo>
                    <a:pt x="606423" y="1322447"/>
                  </a:lnTo>
                  <a:lnTo>
                    <a:pt x="605075" y="1326855"/>
                  </a:lnTo>
                  <a:lnTo>
                    <a:pt x="603720" y="1331263"/>
                  </a:lnTo>
                  <a:lnTo>
                    <a:pt x="602363" y="1335671"/>
                  </a:lnTo>
                  <a:lnTo>
                    <a:pt x="600999" y="1340080"/>
                  </a:lnTo>
                  <a:lnTo>
                    <a:pt x="599634" y="1344488"/>
                  </a:lnTo>
                  <a:lnTo>
                    <a:pt x="598262" y="1348896"/>
                  </a:lnTo>
                  <a:lnTo>
                    <a:pt x="596889" y="1353304"/>
                  </a:lnTo>
                  <a:lnTo>
                    <a:pt x="595512" y="1357712"/>
                  </a:lnTo>
                  <a:lnTo>
                    <a:pt x="594133" y="1362120"/>
                  </a:lnTo>
                  <a:lnTo>
                    <a:pt x="592751" y="1366528"/>
                  </a:lnTo>
                  <a:lnTo>
                    <a:pt x="591369" y="1370937"/>
                  </a:lnTo>
                  <a:lnTo>
                    <a:pt x="589984" y="1375345"/>
                  </a:lnTo>
                  <a:lnTo>
                    <a:pt x="588599" y="1379753"/>
                  </a:lnTo>
                  <a:lnTo>
                    <a:pt x="587213" y="1384161"/>
                  </a:lnTo>
                  <a:lnTo>
                    <a:pt x="585826" y="1388569"/>
                  </a:lnTo>
                  <a:lnTo>
                    <a:pt x="584440" y="1392977"/>
                  </a:lnTo>
                  <a:lnTo>
                    <a:pt x="583055" y="1397386"/>
                  </a:lnTo>
                  <a:lnTo>
                    <a:pt x="581670" y="1401794"/>
                  </a:lnTo>
                  <a:lnTo>
                    <a:pt x="580286" y="1406202"/>
                  </a:lnTo>
                  <a:lnTo>
                    <a:pt x="578904" y="1410610"/>
                  </a:lnTo>
                  <a:lnTo>
                    <a:pt x="577525" y="1415018"/>
                  </a:lnTo>
                  <a:lnTo>
                    <a:pt x="576146" y="1419426"/>
                  </a:lnTo>
                  <a:lnTo>
                    <a:pt x="574773" y="1423835"/>
                  </a:lnTo>
                  <a:lnTo>
                    <a:pt x="573400" y="1428243"/>
                  </a:lnTo>
                  <a:lnTo>
                    <a:pt x="572034" y="1432651"/>
                  </a:lnTo>
                  <a:lnTo>
                    <a:pt x="570668" y="1437059"/>
                  </a:lnTo>
                  <a:lnTo>
                    <a:pt x="569311" y="1441467"/>
                  </a:lnTo>
                  <a:lnTo>
                    <a:pt x="567954" y="1445875"/>
                  </a:lnTo>
                  <a:lnTo>
                    <a:pt x="566606" y="1450283"/>
                  </a:lnTo>
                  <a:lnTo>
                    <a:pt x="565261" y="1454692"/>
                  </a:lnTo>
                  <a:lnTo>
                    <a:pt x="563924" y="1459100"/>
                  </a:lnTo>
                  <a:lnTo>
                    <a:pt x="562591" y="1463508"/>
                  </a:lnTo>
                  <a:lnTo>
                    <a:pt x="561266" y="1467916"/>
                  </a:lnTo>
                  <a:lnTo>
                    <a:pt x="559947" y="1472324"/>
                  </a:lnTo>
                  <a:lnTo>
                    <a:pt x="558636" y="1476732"/>
                  </a:lnTo>
                  <a:lnTo>
                    <a:pt x="557333" y="1481141"/>
                  </a:lnTo>
                  <a:lnTo>
                    <a:pt x="556037" y="1485549"/>
                  </a:lnTo>
                  <a:lnTo>
                    <a:pt x="554751" y="1489957"/>
                  </a:lnTo>
                  <a:lnTo>
                    <a:pt x="553471" y="1494365"/>
                  </a:lnTo>
                  <a:lnTo>
                    <a:pt x="552204" y="1498773"/>
                  </a:lnTo>
                  <a:lnTo>
                    <a:pt x="550940" y="1503181"/>
                  </a:lnTo>
                  <a:lnTo>
                    <a:pt x="549694" y="1507590"/>
                  </a:lnTo>
                  <a:lnTo>
                    <a:pt x="548449" y="1511998"/>
                  </a:lnTo>
                  <a:lnTo>
                    <a:pt x="547224" y="1516406"/>
                  </a:lnTo>
                  <a:lnTo>
                    <a:pt x="545999" y="1520814"/>
                  </a:lnTo>
                  <a:lnTo>
                    <a:pt x="544796" y="1525222"/>
                  </a:lnTo>
                  <a:lnTo>
                    <a:pt x="543594" y="1529630"/>
                  </a:lnTo>
                  <a:lnTo>
                    <a:pt x="542413" y="1534038"/>
                  </a:lnTo>
                  <a:lnTo>
                    <a:pt x="541236" y="1538447"/>
                  </a:lnTo>
                  <a:lnTo>
                    <a:pt x="540077" y="1542855"/>
                  </a:lnTo>
                  <a:lnTo>
                    <a:pt x="538925" y="1547263"/>
                  </a:lnTo>
                  <a:lnTo>
                    <a:pt x="537790" y="1551671"/>
                  </a:lnTo>
                  <a:lnTo>
                    <a:pt x="536665" y="1556079"/>
                  </a:lnTo>
                  <a:lnTo>
                    <a:pt x="535554" y="1560487"/>
                  </a:lnTo>
                  <a:lnTo>
                    <a:pt x="534456" y="1564896"/>
                  </a:lnTo>
                  <a:lnTo>
                    <a:pt x="533371" y="1569304"/>
                  </a:lnTo>
                  <a:lnTo>
                    <a:pt x="532302" y="1573712"/>
                  </a:lnTo>
                  <a:lnTo>
                    <a:pt x="531242" y="1578120"/>
                  </a:lnTo>
                  <a:lnTo>
                    <a:pt x="530203" y="1582528"/>
                  </a:lnTo>
                  <a:lnTo>
                    <a:pt x="529170" y="1586936"/>
                  </a:lnTo>
                  <a:lnTo>
                    <a:pt x="528160" y="1591345"/>
                  </a:lnTo>
                  <a:lnTo>
                    <a:pt x="527155" y="1595753"/>
                  </a:lnTo>
                  <a:lnTo>
                    <a:pt x="526177" y="1600161"/>
                  </a:lnTo>
                  <a:lnTo>
                    <a:pt x="525199" y="1604569"/>
                  </a:lnTo>
                  <a:lnTo>
                    <a:pt x="524252" y="1608977"/>
                  </a:lnTo>
                  <a:lnTo>
                    <a:pt x="523306" y="1613385"/>
                  </a:lnTo>
                  <a:lnTo>
                    <a:pt x="522388" y="1617793"/>
                  </a:lnTo>
                  <a:lnTo>
                    <a:pt x="521474" y="1622202"/>
                  </a:lnTo>
                  <a:lnTo>
                    <a:pt x="520586" y="1626610"/>
                  </a:lnTo>
                  <a:lnTo>
                    <a:pt x="519705" y="1631018"/>
                  </a:lnTo>
                  <a:lnTo>
                    <a:pt x="518846" y="1635426"/>
                  </a:lnTo>
                  <a:lnTo>
                    <a:pt x="517998" y="1639834"/>
                  </a:lnTo>
                  <a:lnTo>
                    <a:pt x="517168" y="1644242"/>
                  </a:lnTo>
                  <a:lnTo>
                    <a:pt x="516353" y="1648651"/>
                  </a:lnTo>
                  <a:lnTo>
                    <a:pt x="515554" y="1653059"/>
                  </a:lnTo>
                  <a:lnTo>
                    <a:pt x="514773" y="1657467"/>
                  </a:lnTo>
                  <a:lnTo>
                    <a:pt x="514004" y="1661875"/>
                  </a:lnTo>
                  <a:lnTo>
                    <a:pt x="513256" y="1666283"/>
                  </a:lnTo>
                  <a:lnTo>
                    <a:pt x="512516" y="1670691"/>
                  </a:lnTo>
                  <a:lnTo>
                    <a:pt x="511802" y="1675100"/>
                  </a:lnTo>
                  <a:lnTo>
                    <a:pt x="511093" y="1679508"/>
                  </a:lnTo>
                  <a:lnTo>
                    <a:pt x="510412" y="1683916"/>
                  </a:lnTo>
                  <a:lnTo>
                    <a:pt x="509733" y="1688324"/>
                  </a:lnTo>
                  <a:lnTo>
                    <a:pt x="509085" y="1692732"/>
                  </a:lnTo>
                  <a:lnTo>
                    <a:pt x="508438" y="1697140"/>
                  </a:lnTo>
                  <a:lnTo>
                    <a:pt x="507821" y="1701548"/>
                  </a:lnTo>
                  <a:lnTo>
                    <a:pt x="507207" y="1705957"/>
                  </a:lnTo>
                  <a:lnTo>
                    <a:pt x="506620" y="1710365"/>
                  </a:lnTo>
                  <a:lnTo>
                    <a:pt x="506038" y="1714773"/>
                  </a:lnTo>
                  <a:lnTo>
                    <a:pt x="505479" y="1719181"/>
                  </a:lnTo>
                  <a:lnTo>
                    <a:pt x="504930" y="1723589"/>
                  </a:lnTo>
                  <a:lnTo>
                    <a:pt x="504400" y="1727997"/>
                  </a:lnTo>
                  <a:lnTo>
                    <a:pt x="503882" y="1732406"/>
                  </a:lnTo>
                  <a:lnTo>
                    <a:pt x="503380" y="1736814"/>
                  </a:lnTo>
                  <a:lnTo>
                    <a:pt x="502893" y="1741222"/>
                  </a:lnTo>
                  <a:lnTo>
                    <a:pt x="502418" y="1745630"/>
                  </a:lnTo>
                  <a:lnTo>
                    <a:pt x="501962" y="1750038"/>
                  </a:lnTo>
                  <a:lnTo>
                    <a:pt x="501514" y="1754446"/>
                  </a:lnTo>
                  <a:lnTo>
                    <a:pt x="501087" y="1758855"/>
                  </a:lnTo>
                  <a:lnTo>
                    <a:pt x="500666" y="1763263"/>
                  </a:lnTo>
                  <a:lnTo>
                    <a:pt x="500268" y="1767671"/>
                  </a:lnTo>
                  <a:lnTo>
                    <a:pt x="499872" y="1772079"/>
                  </a:lnTo>
                  <a:lnTo>
                    <a:pt x="499502" y="1776487"/>
                  </a:lnTo>
                  <a:lnTo>
                    <a:pt x="499132" y="1780895"/>
                  </a:lnTo>
                  <a:lnTo>
                    <a:pt x="498788" y="1785303"/>
                  </a:lnTo>
                  <a:lnTo>
                    <a:pt x="498444" y="1789712"/>
                  </a:lnTo>
                  <a:lnTo>
                    <a:pt x="498124" y="1794120"/>
                  </a:lnTo>
                  <a:lnTo>
                    <a:pt x="497806" y="1798528"/>
                  </a:lnTo>
                  <a:lnTo>
                    <a:pt x="497508" y="1802936"/>
                  </a:lnTo>
                  <a:lnTo>
                    <a:pt x="497215" y="1807344"/>
                  </a:lnTo>
                  <a:lnTo>
                    <a:pt x="496938" y="1811752"/>
                  </a:lnTo>
                  <a:lnTo>
                    <a:pt x="496669" y="1816161"/>
                  </a:lnTo>
                  <a:lnTo>
                    <a:pt x="496412" y="1820569"/>
                  </a:lnTo>
                  <a:lnTo>
                    <a:pt x="496166" y="1824977"/>
                  </a:lnTo>
                  <a:lnTo>
                    <a:pt x="495929" y="1829385"/>
                  </a:lnTo>
                  <a:lnTo>
                    <a:pt x="495704" y="1833793"/>
                  </a:lnTo>
                  <a:lnTo>
                    <a:pt x="495486" y="1838201"/>
                  </a:lnTo>
                  <a:lnTo>
                    <a:pt x="495280" y="1842610"/>
                  </a:lnTo>
                  <a:lnTo>
                    <a:pt x="495080" y="1847018"/>
                  </a:lnTo>
                  <a:lnTo>
                    <a:pt x="494893" y="1851426"/>
                  </a:lnTo>
                  <a:lnTo>
                    <a:pt x="494709" y="1855834"/>
                  </a:lnTo>
                  <a:lnTo>
                    <a:pt x="494540" y="1860242"/>
                  </a:lnTo>
                  <a:lnTo>
                    <a:pt x="494372" y="1864650"/>
                  </a:lnTo>
                  <a:lnTo>
                    <a:pt x="494219" y="1869058"/>
                  </a:lnTo>
                  <a:lnTo>
                    <a:pt x="494066" y="1873467"/>
                  </a:lnTo>
                  <a:lnTo>
                    <a:pt x="493927" y="1877875"/>
                  </a:lnTo>
                  <a:lnTo>
                    <a:pt x="493789" y="1882283"/>
                  </a:lnTo>
                  <a:lnTo>
                    <a:pt x="493661" y="1886691"/>
                  </a:lnTo>
                  <a:lnTo>
                    <a:pt x="493537" y="1891099"/>
                  </a:lnTo>
                  <a:lnTo>
                    <a:pt x="493420" y="1895507"/>
                  </a:lnTo>
                  <a:lnTo>
                    <a:pt x="493308" y="1899916"/>
                  </a:lnTo>
                  <a:lnTo>
                    <a:pt x="493201" y="1904324"/>
                  </a:lnTo>
                  <a:lnTo>
                    <a:pt x="493099" y="1908732"/>
                  </a:lnTo>
                  <a:lnTo>
                    <a:pt x="493002" y="1913140"/>
                  </a:lnTo>
                  <a:lnTo>
                    <a:pt x="492909" y="1917548"/>
                  </a:lnTo>
                  <a:lnTo>
                    <a:pt x="492819" y="1921956"/>
                  </a:lnTo>
                  <a:lnTo>
                    <a:pt x="492734" y="1926365"/>
                  </a:lnTo>
                  <a:lnTo>
                    <a:pt x="492651" y="1930773"/>
                  </a:lnTo>
                  <a:lnTo>
                    <a:pt x="492573" y="1935181"/>
                  </a:lnTo>
                  <a:lnTo>
                    <a:pt x="492495" y="1939589"/>
                  </a:lnTo>
                  <a:lnTo>
                    <a:pt x="492422" y="1943997"/>
                  </a:lnTo>
                  <a:lnTo>
                    <a:pt x="492349" y="1948405"/>
                  </a:lnTo>
                  <a:lnTo>
                    <a:pt x="492279" y="1952813"/>
                  </a:lnTo>
                  <a:lnTo>
                    <a:pt x="492210" y="1957222"/>
                  </a:lnTo>
                  <a:lnTo>
                    <a:pt x="492143" y="1961630"/>
                  </a:lnTo>
                  <a:lnTo>
                    <a:pt x="492076" y="1966038"/>
                  </a:lnTo>
                  <a:lnTo>
                    <a:pt x="492010" y="1970446"/>
                  </a:lnTo>
                  <a:lnTo>
                    <a:pt x="491944" y="1974854"/>
                  </a:lnTo>
                  <a:lnTo>
                    <a:pt x="491879" y="1979262"/>
                  </a:lnTo>
                  <a:lnTo>
                    <a:pt x="491813" y="1983671"/>
                  </a:lnTo>
                  <a:lnTo>
                    <a:pt x="491746" y="1988079"/>
                  </a:lnTo>
                  <a:lnTo>
                    <a:pt x="491679" y="1992487"/>
                  </a:lnTo>
                  <a:lnTo>
                    <a:pt x="491611" y="1996895"/>
                  </a:lnTo>
                  <a:lnTo>
                    <a:pt x="491542" y="2001303"/>
                  </a:lnTo>
                  <a:lnTo>
                    <a:pt x="491471" y="2005711"/>
                  </a:lnTo>
                  <a:lnTo>
                    <a:pt x="491398" y="2010120"/>
                  </a:lnTo>
                  <a:lnTo>
                    <a:pt x="491323" y="2014528"/>
                  </a:lnTo>
                  <a:lnTo>
                    <a:pt x="491245" y="2018936"/>
                  </a:lnTo>
                  <a:lnTo>
                    <a:pt x="491166" y="2023344"/>
                  </a:lnTo>
                  <a:lnTo>
                    <a:pt x="491083" y="2027752"/>
                  </a:lnTo>
                  <a:lnTo>
                    <a:pt x="490999" y="2032160"/>
                  </a:lnTo>
                  <a:lnTo>
                    <a:pt x="490908" y="2036568"/>
                  </a:lnTo>
                  <a:lnTo>
                    <a:pt x="490818" y="2040977"/>
                  </a:lnTo>
                  <a:lnTo>
                    <a:pt x="490720" y="2045385"/>
                  </a:lnTo>
                  <a:lnTo>
                    <a:pt x="490622" y="2049793"/>
                  </a:lnTo>
                  <a:lnTo>
                    <a:pt x="490516" y="2054201"/>
                  </a:lnTo>
                  <a:lnTo>
                    <a:pt x="490409" y="2058609"/>
                  </a:lnTo>
                  <a:lnTo>
                    <a:pt x="490295" y="2063017"/>
                  </a:lnTo>
                  <a:lnTo>
                    <a:pt x="490179" y="2067426"/>
                  </a:lnTo>
                  <a:lnTo>
                    <a:pt x="490056" y="2071834"/>
                  </a:lnTo>
                  <a:lnTo>
                    <a:pt x="489929" y="2076242"/>
                  </a:lnTo>
                  <a:lnTo>
                    <a:pt x="489797" y="2080650"/>
                  </a:lnTo>
                  <a:lnTo>
                    <a:pt x="489659" y="2085058"/>
                  </a:lnTo>
                  <a:lnTo>
                    <a:pt x="489516" y="2089466"/>
                  </a:lnTo>
                  <a:lnTo>
                    <a:pt x="489367" y="2093875"/>
                  </a:lnTo>
                  <a:lnTo>
                    <a:pt x="489213" y="2098283"/>
                  </a:lnTo>
                  <a:lnTo>
                    <a:pt x="489051" y="2102691"/>
                  </a:lnTo>
                  <a:lnTo>
                    <a:pt x="488886" y="2107099"/>
                  </a:lnTo>
                  <a:lnTo>
                    <a:pt x="488712" y="2111507"/>
                  </a:lnTo>
                  <a:lnTo>
                    <a:pt x="488535" y="2115915"/>
                  </a:lnTo>
                  <a:lnTo>
                    <a:pt x="488347" y="2120324"/>
                  </a:lnTo>
                  <a:lnTo>
                    <a:pt x="488159" y="2124732"/>
                  </a:lnTo>
                  <a:lnTo>
                    <a:pt x="487957" y="2129140"/>
                  </a:lnTo>
                  <a:lnTo>
                    <a:pt x="487755" y="2133548"/>
                  </a:lnTo>
                  <a:lnTo>
                    <a:pt x="487540" y="2137956"/>
                  </a:lnTo>
                  <a:lnTo>
                    <a:pt x="487323" y="2142364"/>
                  </a:lnTo>
                  <a:lnTo>
                    <a:pt x="487095" y="2146772"/>
                  </a:lnTo>
                  <a:lnTo>
                    <a:pt x="486864" y="2151181"/>
                  </a:lnTo>
                  <a:lnTo>
                    <a:pt x="486623" y="2155589"/>
                  </a:lnTo>
                  <a:lnTo>
                    <a:pt x="486378" y="2159997"/>
                  </a:lnTo>
                  <a:lnTo>
                    <a:pt x="486123" y="2164405"/>
                  </a:lnTo>
                  <a:lnTo>
                    <a:pt x="485862" y="2168813"/>
                  </a:lnTo>
                  <a:lnTo>
                    <a:pt x="485594" y="2173221"/>
                  </a:lnTo>
                  <a:lnTo>
                    <a:pt x="485318" y="2177630"/>
                  </a:lnTo>
                  <a:lnTo>
                    <a:pt x="485037" y="2182038"/>
                  </a:lnTo>
                  <a:lnTo>
                    <a:pt x="484746" y="2186446"/>
                  </a:lnTo>
                  <a:lnTo>
                    <a:pt x="484451" y="2190854"/>
                  </a:lnTo>
                  <a:lnTo>
                    <a:pt x="484144" y="2195262"/>
                  </a:lnTo>
                  <a:lnTo>
                    <a:pt x="483835" y="2199670"/>
                  </a:lnTo>
                  <a:lnTo>
                    <a:pt x="483514" y="2204079"/>
                  </a:lnTo>
                  <a:lnTo>
                    <a:pt x="483192" y="2208487"/>
                  </a:lnTo>
                  <a:lnTo>
                    <a:pt x="482855" y="2212895"/>
                  </a:lnTo>
                  <a:lnTo>
                    <a:pt x="482518" y="2217303"/>
                  </a:lnTo>
                  <a:lnTo>
                    <a:pt x="482168" y="2221711"/>
                  </a:lnTo>
                  <a:lnTo>
                    <a:pt x="481816" y="2226119"/>
                  </a:lnTo>
                  <a:lnTo>
                    <a:pt x="481452" y="2230527"/>
                  </a:lnTo>
                  <a:lnTo>
                    <a:pt x="481086" y="2234936"/>
                  </a:lnTo>
                  <a:lnTo>
                    <a:pt x="480709" y="2239344"/>
                  </a:lnTo>
                  <a:lnTo>
                    <a:pt x="480328" y="2243752"/>
                  </a:lnTo>
                  <a:lnTo>
                    <a:pt x="479938" y="2248160"/>
                  </a:lnTo>
                  <a:lnTo>
                    <a:pt x="479543" y="2252568"/>
                  </a:lnTo>
                  <a:close/>
                </a:path>
              </a:pathLst>
            </a:custGeom>
            <a:solidFill>
              <a:srgbClr val="FDE725">
                <a:alpha val="29803"/>
              </a:srgbClr>
            </a:solidFill>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01" name="pl8">
              <a:extLst>
                <a:ext uri="{FF2B5EF4-FFF2-40B4-BE49-F238E27FC236}">
                  <a16:creationId xmlns:a16="http://schemas.microsoft.com/office/drawing/2014/main" id="{91337E50-F345-CA48-D956-93199517D868}"/>
                </a:ext>
              </a:extLst>
            </p:cNvPr>
            <p:cNvSpPr/>
            <p:nvPr/>
          </p:nvSpPr>
          <p:spPr>
            <a:xfrm>
              <a:off x="960041" y="3697986"/>
              <a:ext cx="0" cy="245808"/>
            </a:xfrm>
            <a:custGeom>
              <a:avLst/>
              <a:gdLst/>
              <a:ahLst/>
              <a:cxnLst/>
              <a:rect l="0" t="0" r="0" b="0"/>
              <a:pathLst>
                <a:path h="734533">
                  <a:moveTo>
                    <a:pt x="0" y="734533"/>
                  </a:moveTo>
                  <a:lnTo>
                    <a:pt x="0" y="0"/>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02" name="pl9">
              <a:extLst>
                <a:ext uri="{FF2B5EF4-FFF2-40B4-BE49-F238E27FC236}">
                  <a16:creationId xmlns:a16="http://schemas.microsoft.com/office/drawing/2014/main" id="{998F6E8C-D825-8CAE-6774-1241F24C80B7}"/>
                </a:ext>
              </a:extLst>
            </p:cNvPr>
            <p:cNvSpPr/>
            <p:nvPr/>
          </p:nvSpPr>
          <p:spPr>
            <a:xfrm>
              <a:off x="960041" y="4181409"/>
              <a:ext cx="0" cy="286776"/>
            </a:xfrm>
            <a:custGeom>
              <a:avLst/>
              <a:gdLst/>
              <a:ahLst/>
              <a:cxnLst/>
              <a:rect l="0" t="0" r="0" b="0"/>
              <a:pathLst>
                <a:path h="856955">
                  <a:moveTo>
                    <a:pt x="0" y="0"/>
                  </a:moveTo>
                  <a:lnTo>
                    <a:pt x="0" y="856955"/>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03" name="pg10">
              <a:extLst>
                <a:ext uri="{FF2B5EF4-FFF2-40B4-BE49-F238E27FC236}">
                  <a16:creationId xmlns:a16="http://schemas.microsoft.com/office/drawing/2014/main" id="{236E0E51-67CF-9F05-5897-6F29EAFE3585}"/>
                </a:ext>
              </a:extLst>
            </p:cNvPr>
            <p:cNvSpPr/>
            <p:nvPr/>
          </p:nvSpPr>
          <p:spPr>
            <a:xfrm>
              <a:off x="893284" y="3943795"/>
              <a:ext cx="133514" cy="237614"/>
            </a:xfrm>
            <a:custGeom>
              <a:avLst/>
              <a:gdLst/>
              <a:ahLst/>
              <a:cxnLst/>
              <a:rect l="0" t="0" r="0" b="0"/>
              <a:pathLst>
                <a:path w="398970" h="710048">
                  <a:moveTo>
                    <a:pt x="0" y="0"/>
                  </a:moveTo>
                  <a:lnTo>
                    <a:pt x="0" y="710048"/>
                  </a:lnTo>
                  <a:lnTo>
                    <a:pt x="398970" y="710048"/>
                  </a:lnTo>
                  <a:lnTo>
                    <a:pt x="398970" y="0"/>
                  </a:lnTo>
                  <a:close/>
                </a:path>
              </a:pathLst>
            </a:custGeom>
            <a:solidFill>
              <a:srgbClr val="FFFFFF">
                <a:alpha val="100000"/>
              </a:srgbClr>
            </a:solidFill>
            <a:ln w="13550"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904" name="pl11">
              <a:extLst>
                <a:ext uri="{FF2B5EF4-FFF2-40B4-BE49-F238E27FC236}">
                  <a16:creationId xmlns:a16="http://schemas.microsoft.com/office/drawing/2014/main" id="{FE77A015-212C-60F6-BD89-19603FAE7B52}"/>
                </a:ext>
              </a:extLst>
            </p:cNvPr>
            <p:cNvSpPr/>
            <p:nvPr/>
          </p:nvSpPr>
          <p:spPr>
            <a:xfrm>
              <a:off x="893284" y="4107667"/>
              <a:ext cx="133514" cy="0"/>
            </a:xfrm>
            <a:custGeom>
              <a:avLst/>
              <a:gdLst/>
              <a:ahLst/>
              <a:cxnLst/>
              <a:rect l="0" t="0" r="0" b="0"/>
              <a:pathLst>
                <a:path w="398970">
                  <a:moveTo>
                    <a:pt x="0" y="0"/>
                  </a:moveTo>
                  <a:lnTo>
                    <a:pt x="398970" y="0"/>
                  </a:lnTo>
                </a:path>
              </a:pathLst>
            </a:custGeom>
            <a:ln w="27101"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905" name="pl12">
              <a:extLst>
                <a:ext uri="{FF2B5EF4-FFF2-40B4-BE49-F238E27FC236}">
                  <a16:creationId xmlns:a16="http://schemas.microsoft.com/office/drawing/2014/main" id="{1CE6507A-65DA-1E88-49E2-47C54D098B51}"/>
                </a:ext>
              </a:extLst>
            </p:cNvPr>
            <p:cNvSpPr/>
            <p:nvPr/>
          </p:nvSpPr>
          <p:spPr>
            <a:xfrm>
              <a:off x="1494095" y="3861859"/>
              <a:ext cx="0" cy="77839"/>
            </a:xfrm>
            <a:custGeom>
              <a:avLst/>
              <a:gdLst/>
              <a:ahLst/>
              <a:cxnLst/>
              <a:rect l="0" t="0" r="0" b="0"/>
              <a:pathLst>
                <a:path h="232602">
                  <a:moveTo>
                    <a:pt x="0" y="232602"/>
                  </a:moveTo>
                  <a:lnTo>
                    <a:pt x="0" y="0"/>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06" name="pl13">
              <a:extLst>
                <a:ext uri="{FF2B5EF4-FFF2-40B4-BE49-F238E27FC236}">
                  <a16:creationId xmlns:a16="http://schemas.microsoft.com/office/drawing/2014/main" id="{051E7BB1-E4E9-9029-C984-5A89D1ED93AB}"/>
                </a:ext>
              </a:extLst>
            </p:cNvPr>
            <p:cNvSpPr/>
            <p:nvPr/>
          </p:nvSpPr>
          <p:spPr>
            <a:xfrm>
              <a:off x="1494095" y="4222377"/>
              <a:ext cx="0" cy="393293"/>
            </a:xfrm>
            <a:custGeom>
              <a:avLst/>
              <a:gdLst/>
              <a:ahLst/>
              <a:cxnLst/>
              <a:rect l="0" t="0" r="0" b="0"/>
              <a:pathLst>
                <a:path h="1175253">
                  <a:moveTo>
                    <a:pt x="0" y="0"/>
                  </a:moveTo>
                  <a:lnTo>
                    <a:pt x="0" y="1175253"/>
                  </a:lnTo>
                </a:path>
              </a:pathLst>
            </a:custGeom>
            <a:ln w="13550"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07" name="pg14">
              <a:extLst>
                <a:ext uri="{FF2B5EF4-FFF2-40B4-BE49-F238E27FC236}">
                  <a16:creationId xmlns:a16="http://schemas.microsoft.com/office/drawing/2014/main" id="{EBFC3CBD-940D-AFD2-2780-73C0578C29F5}"/>
                </a:ext>
              </a:extLst>
            </p:cNvPr>
            <p:cNvSpPr/>
            <p:nvPr/>
          </p:nvSpPr>
          <p:spPr>
            <a:xfrm>
              <a:off x="1427339" y="3939698"/>
              <a:ext cx="133514" cy="282680"/>
            </a:xfrm>
            <a:custGeom>
              <a:avLst/>
              <a:gdLst/>
              <a:ahLst/>
              <a:cxnLst/>
              <a:rect l="0" t="0" r="0" b="0"/>
              <a:pathLst>
                <a:path w="398970" h="844713">
                  <a:moveTo>
                    <a:pt x="0" y="0"/>
                  </a:moveTo>
                  <a:lnTo>
                    <a:pt x="0" y="844713"/>
                  </a:lnTo>
                  <a:lnTo>
                    <a:pt x="398970" y="844713"/>
                  </a:lnTo>
                  <a:lnTo>
                    <a:pt x="398970" y="0"/>
                  </a:lnTo>
                  <a:close/>
                </a:path>
              </a:pathLst>
            </a:custGeom>
            <a:solidFill>
              <a:srgbClr val="FFFFFF">
                <a:alpha val="100000"/>
              </a:srgbClr>
            </a:solidFill>
            <a:ln w="13550"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908" name="pl15">
              <a:extLst>
                <a:ext uri="{FF2B5EF4-FFF2-40B4-BE49-F238E27FC236}">
                  <a16:creationId xmlns:a16="http://schemas.microsoft.com/office/drawing/2014/main" id="{DE13DBE9-C648-DDB4-9CC2-06931DBBED6F}"/>
                </a:ext>
              </a:extLst>
            </p:cNvPr>
            <p:cNvSpPr/>
            <p:nvPr/>
          </p:nvSpPr>
          <p:spPr>
            <a:xfrm>
              <a:off x="1427339" y="4050312"/>
              <a:ext cx="133514" cy="0"/>
            </a:xfrm>
            <a:custGeom>
              <a:avLst/>
              <a:gdLst/>
              <a:ahLst/>
              <a:cxnLst/>
              <a:rect l="0" t="0" r="0" b="0"/>
              <a:pathLst>
                <a:path w="398970">
                  <a:moveTo>
                    <a:pt x="0" y="0"/>
                  </a:moveTo>
                  <a:lnTo>
                    <a:pt x="398970" y="0"/>
                  </a:lnTo>
                </a:path>
              </a:pathLst>
            </a:custGeom>
            <a:ln w="27101" cap="flat">
              <a:solidFill>
                <a:srgbClr val="333333">
                  <a:alpha val="100000"/>
                </a:srgbClr>
              </a:solidFill>
              <a:prstDash val="solid"/>
              <a:miter/>
            </a:ln>
          </p:spPr>
          <p:txBody>
            <a:bodyPr/>
            <a:lstStyle/>
            <a:p>
              <a:endParaRPr sz="700">
                <a:latin typeface="Arial" panose="020B0604020202020204" pitchFamily="34" charset="0"/>
                <a:cs typeface="Arial" panose="020B0604020202020204" pitchFamily="34" charset="0"/>
              </a:endParaRPr>
            </a:p>
          </p:txBody>
        </p:sp>
        <p:sp>
          <p:nvSpPr>
            <p:cNvPr id="2909" name="pt16">
              <a:extLst>
                <a:ext uri="{FF2B5EF4-FFF2-40B4-BE49-F238E27FC236}">
                  <a16:creationId xmlns:a16="http://schemas.microsoft.com/office/drawing/2014/main" id="{8F92CB1A-37E1-92E1-EFDA-D32BD7597D9C}"/>
                </a:ext>
              </a:extLst>
            </p:cNvPr>
            <p:cNvSpPr/>
            <p:nvPr/>
          </p:nvSpPr>
          <p:spPr>
            <a:xfrm>
              <a:off x="1455025" y="3874635"/>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0" name="pt17">
              <a:extLst>
                <a:ext uri="{FF2B5EF4-FFF2-40B4-BE49-F238E27FC236}">
                  <a16:creationId xmlns:a16="http://schemas.microsoft.com/office/drawing/2014/main" id="{F96F77A9-5525-D5DA-1FDE-0404A8C4AC69}"/>
                </a:ext>
              </a:extLst>
            </p:cNvPr>
            <p:cNvSpPr/>
            <p:nvPr/>
          </p:nvSpPr>
          <p:spPr>
            <a:xfrm>
              <a:off x="984576" y="419806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1" name="pt18">
              <a:extLst>
                <a:ext uri="{FF2B5EF4-FFF2-40B4-BE49-F238E27FC236}">
                  <a16:creationId xmlns:a16="http://schemas.microsoft.com/office/drawing/2014/main" id="{ACF093D6-8253-7380-B959-1AB1ABD0145D}"/>
                </a:ext>
              </a:extLst>
            </p:cNvPr>
            <p:cNvSpPr/>
            <p:nvPr/>
          </p:nvSpPr>
          <p:spPr>
            <a:xfrm>
              <a:off x="980893" y="413040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2" name="pt19">
              <a:extLst>
                <a:ext uri="{FF2B5EF4-FFF2-40B4-BE49-F238E27FC236}">
                  <a16:creationId xmlns:a16="http://schemas.microsoft.com/office/drawing/2014/main" id="{25BEA313-BBF0-E3B2-6C09-7F10F7F98A53}"/>
                </a:ext>
              </a:extLst>
            </p:cNvPr>
            <p:cNvSpPr/>
            <p:nvPr/>
          </p:nvSpPr>
          <p:spPr>
            <a:xfrm>
              <a:off x="1498201" y="403285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3" name="pt20">
              <a:extLst>
                <a:ext uri="{FF2B5EF4-FFF2-40B4-BE49-F238E27FC236}">
                  <a16:creationId xmlns:a16="http://schemas.microsoft.com/office/drawing/2014/main" id="{E2AC4BD4-477B-E7D5-AA5B-3D921B1A375A}"/>
                </a:ext>
              </a:extLst>
            </p:cNvPr>
            <p:cNvSpPr/>
            <p:nvPr/>
          </p:nvSpPr>
          <p:spPr>
            <a:xfrm>
              <a:off x="986859" y="4166816"/>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4" name="pt21">
              <a:extLst>
                <a:ext uri="{FF2B5EF4-FFF2-40B4-BE49-F238E27FC236}">
                  <a16:creationId xmlns:a16="http://schemas.microsoft.com/office/drawing/2014/main" id="{813008EC-02B4-475A-6127-459FDC762503}"/>
                </a:ext>
              </a:extLst>
            </p:cNvPr>
            <p:cNvSpPr/>
            <p:nvPr/>
          </p:nvSpPr>
          <p:spPr>
            <a:xfrm>
              <a:off x="982472" y="408294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5" name="pt22">
              <a:extLst>
                <a:ext uri="{FF2B5EF4-FFF2-40B4-BE49-F238E27FC236}">
                  <a16:creationId xmlns:a16="http://schemas.microsoft.com/office/drawing/2014/main" id="{B9D0197F-E0F1-3B3B-5F76-9CCF4ACB142E}"/>
                </a:ext>
              </a:extLst>
            </p:cNvPr>
            <p:cNvSpPr/>
            <p:nvPr/>
          </p:nvSpPr>
          <p:spPr>
            <a:xfrm>
              <a:off x="964996" y="3773895"/>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6" name="pt23">
              <a:extLst>
                <a:ext uri="{FF2B5EF4-FFF2-40B4-BE49-F238E27FC236}">
                  <a16:creationId xmlns:a16="http://schemas.microsoft.com/office/drawing/2014/main" id="{9CE06AD0-EEF0-695F-C0C8-A0687E84788E}"/>
                </a:ext>
              </a:extLst>
            </p:cNvPr>
            <p:cNvSpPr/>
            <p:nvPr/>
          </p:nvSpPr>
          <p:spPr>
            <a:xfrm>
              <a:off x="1499230" y="4289847"/>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7" name="pt24">
              <a:extLst>
                <a:ext uri="{FF2B5EF4-FFF2-40B4-BE49-F238E27FC236}">
                  <a16:creationId xmlns:a16="http://schemas.microsoft.com/office/drawing/2014/main" id="{32809B41-2B6E-2D0D-576C-760B8CAB9DBC}"/>
                </a:ext>
              </a:extLst>
            </p:cNvPr>
            <p:cNvSpPr/>
            <p:nvPr/>
          </p:nvSpPr>
          <p:spPr>
            <a:xfrm>
              <a:off x="917376" y="383194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8" name="pt25">
              <a:extLst>
                <a:ext uri="{FF2B5EF4-FFF2-40B4-BE49-F238E27FC236}">
                  <a16:creationId xmlns:a16="http://schemas.microsoft.com/office/drawing/2014/main" id="{93068E1E-BF1C-A070-7A90-4F9CF1FF006F}"/>
                </a:ext>
              </a:extLst>
            </p:cNvPr>
            <p:cNvSpPr/>
            <p:nvPr/>
          </p:nvSpPr>
          <p:spPr>
            <a:xfrm>
              <a:off x="971842" y="3951168"/>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19" name="pt26">
              <a:extLst>
                <a:ext uri="{FF2B5EF4-FFF2-40B4-BE49-F238E27FC236}">
                  <a16:creationId xmlns:a16="http://schemas.microsoft.com/office/drawing/2014/main" id="{CCAA24FD-F97C-26AD-CB02-3BCC4F328933}"/>
                </a:ext>
              </a:extLst>
            </p:cNvPr>
            <p:cNvSpPr/>
            <p:nvPr/>
          </p:nvSpPr>
          <p:spPr>
            <a:xfrm>
              <a:off x="1455334" y="4203879"/>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0" name="pt27">
              <a:extLst>
                <a:ext uri="{FF2B5EF4-FFF2-40B4-BE49-F238E27FC236}">
                  <a16:creationId xmlns:a16="http://schemas.microsoft.com/office/drawing/2014/main" id="{C4CDE72F-8892-8902-1478-474042C85503}"/>
                </a:ext>
              </a:extLst>
            </p:cNvPr>
            <p:cNvSpPr/>
            <p:nvPr/>
          </p:nvSpPr>
          <p:spPr>
            <a:xfrm>
              <a:off x="905332" y="391784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1" name="pt28">
              <a:extLst>
                <a:ext uri="{FF2B5EF4-FFF2-40B4-BE49-F238E27FC236}">
                  <a16:creationId xmlns:a16="http://schemas.microsoft.com/office/drawing/2014/main" id="{4E510D0F-9EE2-581E-BB74-860E86F792FC}"/>
                </a:ext>
              </a:extLst>
            </p:cNvPr>
            <p:cNvSpPr/>
            <p:nvPr/>
          </p:nvSpPr>
          <p:spPr>
            <a:xfrm>
              <a:off x="1513382" y="387217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2" name="pt29">
              <a:extLst>
                <a:ext uri="{FF2B5EF4-FFF2-40B4-BE49-F238E27FC236}">
                  <a16:creationId xmlns:a16="http://schemas.microsoft.com/office/drawing/2014/main" id="{52BF5A06-6800-0B21-A758-87F9768E2FE9}"/>
                </a:ext>
              </a:extLst>
            </p:cNvPr>
            <p:cNvSpPr/>
            <p:nvPr/>
          </p:nvSpPr>
          <p:spPr>
            <a:xfrm>
              <a:off x="1513978" y="4213847"/>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3" name="pt30">
              <a:extLst>
                <a:ext uri="{FF2B5EF4-FFF2-40B4-BE49-F238E27FC236}">
                  <a16:creationId xmlns:a16="http://schemas.microsoft.com/office/drawing/2014/main" id="{4CAF7C5C-540D-869B-0B6C-9374376594FF}"/>
                </a:ext>
              </a:extLst>
            </p:cNvPr>
            <p:cNvSpPr/>
            <p:nvPr/>
          </p:nvSpPr>
          <p:spPr>
            <a:xfrm>
              <a:off x="1489786" y="4046653"/>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4" name="pt31">
              <a:extLst>
                <a:ext uri="{FF2B5EF4-FFF2-40B4-BE49-F238E27FC236}">
                  <a16:creationId xmlns:a16="http://schemas.microsoft.com/office/drawing/2014/main" id="{64C280F1-D37F-AFC1-EBDC-834F61A54D16}"/>
                </a:ext>
              </a:extLst>
            </p:cNvPr>
            <p:cNvSpPr/>
            <p:nvPr/>
          </p:nvSpPr>
          <p:spPr>
            <a:xfrm>
              <a:off x="925404" y="413446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5" name="pt32">
              <a:extLst>
                <a:ext uri="{FF2B5EF4-FFF2-40B4-BE49-F238E27FC236}">
                  <a16:creationId xmlns:a16="http://schemas.microsoft.com/office/drawing/2014/main" id="{E898FCC7-827D-42AF-C409-FE009C15C1C1}"/>
                </a:ext>
              </a:extLst>
            </p:cNvPr>
            <p:cNvSpPr/>
            <p:nvPr/>
          </p:nvSpPr>
          <p:spPr>
            <a:xfrm>
              <a:off x="953604" y="419979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6" name="pt33">
              <a:extLst>
                <a:ext uri="{FF2B5EF4-FFF2-40B4-BE49-F238E27FC236}">
                  <a16:creationId xmlns:a16="http://schemas.microsoft.com/office/drawing/2014/main" id="{517BA487-F312-FB92-4A5A-0E3CE0C276DF}"/>
                </a:ext>
              </a:extLst>
            </p:cNvPr>
            <p:cNvSpPr/>
            <p:nvPr/>
          </p:nvSpPr>
          <p:spPr>
            <a:xfrm>
              <a:off x="1533226" y="3935592"/>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7" name="pt34">
              <a:extLst>
                <a:ext uri="{FF2B5EF4-FFF2-40B4-BE49-F238E27FC236}">
                  <a16:creationId xmlns:a16="http://schemas.microsoft.com/office/drawing/2014/main" id="{BBA94810-F289-30E9-E421-A8173867E937}"/>
                </a:ext>
              </a:extLst>
            </p:cNvPr>
            <p:cNvSpPr/>
            <p:nvPr/>
          </p:nvSpPr>
          <p:spPr>
            <a:xfrm>
              <a:off x="942635" y="4178598"/>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8" name="pt35">
              <a:extLst>
                <a:ext uri="{FF2B5EF4-FFF2-40B4-BE49-F238E27FC236}">
                  <a16:creationId xmlns:a16="http://schemas.microsoft.com/office/drawing/2014/main" id="{1C40A5AB-F5E0-C2A5-D167-08FA14A14F56}"/>
                </a:ext>
              </a:extLst>
            </p:cNvPr>
            <p:cNvSpPr/>
            <p:nvPr/>
          </p:nvSpPr>
          <p:spPr>
            <a:xfrm>
              <a:off x="911689" y="4148955"/>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29" name="pt36">
              <a:extLst>
                <a:ext uri="{FF2B5EF4-FFF2-40B4-BE49-F238E27FC236}">
                  <a16:creationId xmlns:a16="http://schemas.microsoft.com/office/drawing/2014/main" id="{C7372102-ED5C-4FF2-5DD6-8558B07F76FE}"/>
                </a:ext>
              </a:extLst>
            </p:cNvPr>
            <p:cNvSpPr/>
            <p:nvPr/>
          </p:nvSpPr>
          <p:spPr>
            <a:xfrm>
              <a:off x="955829" y="385828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0" name="pt37">
              <a:extLst>
                <a:ext uri="{FF2B5EF4-FFF2-40B4-BE49-F238E27FC236}">
                  <a16:creationId xmlns:a16="http://schemas.microsoft.com/office/drawing/2014/main" id="{079DBCFA-44A0-410B-CC97-374BF2E56207}"/>
                </a:ext>
              </a:extLst>
            </p:cNvPr>
            <p:cNvSpPr/>
            <p:nvPr/>
          </p:nvSpPr>
          <p:spPr>
            <a:xfrm>
              <a:off x="1456524" y="460688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1" name="pt38">
              <a:extLst>
                <a:ext uri="{FF2B5EF4-FFF2-40B4-BE49-F238E27FC236}">
                  <a16:creationId xmlns:a16="http://schemas.microsoft.com/office/drawing/2014/main" id="{A8AA781F-8B8F-0E23-8F53-6F869094C193}"/>
                </a:ext>
              </a:extLst>
            </p:cNvPr>
            <p:cNvSpPr/>
            <p:nvPr/>
          </p:nvSpPr>
          <p:spPr>
            <a:xfrm>
              <a:off x="913446" y="4087390"/>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2" name="pt39">
              <a:extLst>
                <a:ext uri="{FF2B5EF4-FFF2-40B4-BE49-F238E27FC236}">
                  <a16:creationId xmlns:a16="http://schemas.microsoft.com/office/drawing/2014/main" id="{46C27F88-E096-11DB-6E71-3D98503DCF7F}"/>
                </a:ext>
              </a:extLst>
            </p:cNvPr>
            <p:cNvSpPr/>
            <p:nvPr/>
          </p:nvSpPr>
          <p:spPr>
            <a:xfrm>
              <a:off x="1441609" y="3918648"/>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3" name="pt40">
              <a:extLst>
                <a:ext uri="{FF2B5EF4-FFF2-40B4-BE49-F238E27FC236}">
                  <a16:creationId xmlns:a16="http://schemas.microsoft.com/office/drawing/2014/main" id="{4D9CB2A6-1483-73B2-D662-AE2AB172B0C6}"/>
                </a:ext>
              </a:extLst>
            </p:cNvPr>
            <p:cNvSpPr/>
            <p:nvPr/>
          </p:nvSpPr>
          <p:spPr>
            <a:xfrm>
              <a:off x="1436041" y="394014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4" name="pt41">
              <a:extLst>
                <a:ext uri="{FF2B5EF4-FFF2-40B4-BE49-F238E27FC236}">
                  <a16:creationId xmlns:a16="http://schemas.microsoft.com/office/drawing/2014/main" id="{D192DB1F-6F91-CE58-7280-40942835D519}"/>
                </a:ext>
              </a:extLst>
            </p:cNvPr>
            <p:cNvSpPr/>
            <p:nvPr/>
          </p:nvSpPr>
          <p:spPr>
            <a:xfrm>
              <a:off x="965135" y="4039638"/>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5" name="pt42">
              <a:extLst>
                <a:ext uri="{FF2B5EF4-FFF2-40B4-BE49-F238E27FC236}">
                  <a16:creationId xmlns:a16="http://schemas.microsoft.com/office/drawing/2014/main" id="{90B6748D-375F-26D6-D921-725454D21C69}"/>
                </a:ext>
              </a:extLst>
            </p:cNvPr>
            <p:cNvSpPr/>
            <p:nvPr/>
          </p:nvSpPr>
          <p:spPr>
            <a:xfrm>
              <a:off x="1505425" y="407143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6" name="pt43">
              <a:extLst>
                <a:ext uri="{FF2B5EF4-FFF2-40B4-BE49-F238E27FC236}">
                  <a16:creationId xmlns:a16="http://schemas.microsoft.com/office/drawing/2014/main" id="{2032AD90-1864-0207-CAEF-0FFFAD098FCA}"/>
                </a:ext>
              </a:extLst>
            </p:cNvPr>
            <p:cNvSpPr/>
            <p:nvPr/>
          </p:nvSpPr>
          <p:spPr>
            <a:xfrm>
              <a:off x="929823" y="3684610"/>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7" name="pt44">
              <a:extLst>
                <a:ext uri="{FF2B5EF4-FFF2-40B4-BE49-F238E27FC236}">
                  <a16:creationId xmlns:a16="http://schemas.microsoft.com/office/drawing/2014/main" id="{F533E886-2355-71B7-17BD-0132D3DDB251}"/>
                </a:ext>
              </a:extLst>
            </p:cNvPr>
            <p:cNvSpPr/>
            <p:nvPr/>
          </p:nvSpPr>
          <p:spPr>
            <a:xfrm>
              <a:off x="1432802" y="392541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8" name="pt45">
              <a:extLst>
                <a:ext uri="{FF2B5EF4-FFF2-40B4-BE49-F238E27FC236}">
                  <a16:creationId xmlns:a16="http://schemas.microsoft.com/office/drawing/2014/main" id="{9E42374A-7D32-049D-8FA9-5AEC3F23AE93}"/>
                </a:ext>
              </a:extLst>
            </p:cNvPr>
            <p:cNvSpPr/>
            <p:nvPr/>
          </p:nvSpPr>
          <p:spPr>
            <a:xfrm>
              <a:off x="993145" y="4101295"/>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39" name="pt46">
              <a:extLst>
                <a:ext uri="{FF2B5EF4-FFF2-40B4-BE49-F238E27FC236}">
                  <a16:creationId xmlns:a16="http://schemas.microsoft.com/office/drawing/2014/main" id="{CEADF223-8DBA-03FD-C2B2-76ADA4B7A8B8}"/>
                </a:ext>
              </a:extLst>
            </p:cNvPr>
            <p:cNvSpPr/>
            <p:nvPr/>
          </p:nvSpPr>
          <p:spPr>
            <a:xfrm>
              <a:off x="917162" y="4326112"/>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0" name="pt47">
              <a:extLst>
                <a:ext uri="{FF2B5EF4-FFF2-40B4-BE49-F238E27FC236}">
                  <a16:creationId xmlns:a16="http://schemas.microsoft.com/office/drawing/2014/main" id="{AC2FF2FD-CDF7-8AE4-99AD-280AF8879A1E}"/>
                </a:ext>
              </a:extLst>
            </p:cNvPr>
            <p:cNvSpPr/>
            <p:nvPr/>
          </p:nvSpPr>
          <p:spPr>
            <a:xfrm>
              <a:off x="1447173" y="4217257"/>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1" name="pt48">
              <a:extLst>
                <a:ext uri="{FF2B5EF4-FFF2-40B4-BE49-F238E27FC236}">
                  <a16:creationId xmlns:a16="http://schemas.microsoft.com/office/drawing/2014/main" id="{9DA13B0C-A3DC-EDF8-9E3D-29F3CCBD0964}"/>
                </a:ext>
              </a:extLst>
            </p:cNvPr>
            <p:cNvSpPr/>
            <p:nvPr/>
          </p:nvSpPr>
          <p:spPr>
            <a:xfrm>
              <a:off x="1526356" y="3859444"/>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2" name="pt49">
              <a:extLst>
                <a:ext uri="{FF2B5EF4-FFF2-40B4-BE49-F238E27FC236}">
                  <a16:creationId xmlns:a16="http://schemas.microsoft.com/office/drawing/2014/main" id="{8B777977-7B1D-FEBA-1C28-2E3464460A19}"/>
                </a:ext>
              </a:extLst>
            </p:cNvPr>
            <p:cNvSpPr/>
            <p:nvPr/>
          </p:nvSpPr>
          <p:spPr>
            <a:xfrm>
              <a:off x="989672" y="4125605"/>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3" name="pt50">
              <a:extLst>
                <a:ext uri="{FF2B5EF4-FFF2-40B4-BE49-F238E27FC236}">
                  <a16:creationId xmlns:a16="http://schemas.microsoft.com/office/drawing/2014/main" id="{3FD8785C-C8C0-4A90-1810-451A08D44B85}"/>
                </a:ext>
              </a:extLst>
            </p:cNvPr>
            <p:cNvSpPr/>
            <p:nvPr/>
          </p:nvSpPr>
          <p:spPr>
            <a:xfrm>
              <a:off x="997554" y="4062631"/>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4" name="pt51">
              <a:extLst>
                <a:ext uri="{FF2B5EF4-FFF2-40B4-BE49-F238E27FC236}">
                  <a16:creationId xmlns:a16="http://schemas.microsoft.com/office/drawing/2014/main" id="{BF102776-4941-A7F8-34D2-FFDB2E550EB5}"/>
                </a:ext>
              </a:extLst>
            </p:cNvPr>
            <p:cNvSpPr/>
            <p:nvPr/>
          </p:nvSpPr>
          <p:spPr>
            <a:xfrm>
              <a:off x="1454779" y="3973491"/>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5" name="pt52">
              <a:extLst>
                <a:ext uri="{FF2B5EF4-FFF2-40B4-BE49-F238E27FC236}">
                  <a16:creationId xmlns:a16="http://schemas.microsoft.com/office/drawing/2014/main" id="{7C5019FD-95EA-B8B6-B74E-775713E92AFC}"/>
                </a:ext>
              </a:extLst>
            </p:cNvPr>
            <p:cNvSpPr/>
            <p:nvPr/>
          </p:nvSpPr>
          <p:spPr>
            <a:xfrm>
              <a:off x="952308" y="3793350"/>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6" name="pt53">
              <a:extLst>
                <a:ext uri="{FF2B5EF4-FFF2-40B4-BE49-F238E27FC236}">
                  <a16:creationId xmlns:a16="http://schemas.microsoft.com/office/drawing/2014/main" id="{BD527A9C-37D7-CF55-9D23-4387703F20F3}"/>
                </a:ext>
              </a:extLst>
            </p:cNvPr>
            <p:cNvSpPr/>
            <p:nvPr/>
          </p:nvSpPr>
          <p:spPr>
            <a:xfrm>
              <a:off x="968320" y="415450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7" name="pt54">
              <a:extLst>
                <a:ext uri="{FF2B5EF4-FFF2-40B4-BE49-F238E27FC236}">
                  <a16:creationId xmlns:a16="http://schemas.microsoft.com/office/drawing/2014/main" id="{CFB41F5E-337B-CB0C-11F8-D8FD620F9E4D}"/>
                </a:ext>
              </a:extLst>
            </p:cNvPr>
            <p:cNvSpPr/>
            <p:nvPr/>
          </p:nvSpPr>
          <p:spPr>
            <a:xfrm>
              <a:off x="1518343" y="396850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8" name="pt55">
              <a:extLst>
                <a:ext uri="{FF2B5EF4-FFF2-40B4-BE49-F238E27FC236}">
                  <a16:creationId xmlns:a16="http://schemas.microsoft.com/office/drawing/2014/main" id="{242AA8F4-7114-0A0F-369A-DBFBB4B136F8}"/>
                </a:ext>
              </a:extLst>
            </p:cNvPr>
            <p:cNvSpPr/>
            <p:nvPr/>
          </p:nvSpPr>
          <p:spPr>
            <a:xfrm>
              <a:off x="1492244" y="4310278"/>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49" name="pt56">
              <a:extLst>
                <a:ext uri="{FF2B5EF4-FFF2-40B4-BE49-F238E27FC236}">
                  <a16:creationId xmlns:a16="http://schemas.microsoft.com/office/drawing/2014/main" id="{0D7DE646-BEF3-3245-600C-57E33F627524}"/>
                </a:ext>
              </a:extLst>
            </p:cNvPr>
            <p:cNvSpPr/>
            <p:nvPr/>
          </p:nvSpPr>
          <p:spPr>
            <a:xfrm>
              <a:off x="994812" y="4453543"/>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0" name="pt57">
              <a:extLst>
                <a:ext uri="{FF2B5EF4-FFF2-40B4-BE49-F238E27FC236}">
                  <a16:creationId xmlns:a16="http://schemas.microsoft.com/office/drawing/2014/main" id="{3E09009A-5A12-EA99-0176-58AB76BA60A0}"/>
                </a:ext>
              </a:extLst>
            </p:cNvPr>
            <p:cNvSpPr/>
            <p:nvPr/>
          </p:nvSpPr>
          <p:spPr>
            <a:xfrm>
              <a:off x="1495135" y="4149930"/>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1" name="pt58">
              <a:extLst>
                <a:ext uri="{FF2B5EF4-FFF2-40B4-BE49-F238E27FC236}">
                  <a16:creationId xmlns:a16="http://schemas.microsoft.com/office/drawing/2014/main" id="{1EA57311-0EA7-755E-5BF9-8258E8D3ED0C}"/>
                </a:ext>
              </a:extLst>
            </p:cNvPr>
            <p:cNvSpPr/>
            <p:nvPr/>
          </p:nvSpPr>
          <p:spPr>
            <a:xfrm>
              <a:off x="1469904" y="4511188"/>
              <a:ext cx="16615" cy="16615"/>
            </a:xfrm>
            <a:prstGeom prst="ellipse">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2" name="pt59">
              <a:extLst>
                <a:ext uri="{FF2B5EF4-FFF2-40B4-BE49-F238E27FC236}">
                  <a16:creationId xmlns:a16="http://schemas.microsoft.com/office/drawing/2014/main" id="{ADE5F8E3-D722-EEFF-26D1-3746523EC6BE}"/>
                </a:ext>
              </a:extLst>
            </p:cNvPr>
            <p:cNvSpPr/>
            <p:nvPr/>
          </p:nvSpPr>
          <p:spPr>
            <a:xfrm>
              <a:off x="991404" y="3741120"/>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3" name="pt60">
              <a:extLst>
                <a:ext uri="{FF2B5EF4-FFF2-40B4-BE49-F238E27FC236}">
                  <a16:creationId xmlns:a16="http://schemas.microsoft.com/office/drawing/2014/main" id="{EC7AD637-88C3-4F1D-43E7-8F442D86E052}"/>
                </a:ext>
              </a:extLst>
            </p:cNvPr>
            <p:cNvSpPr/>
            <p:nvPr/>
          </p:nvSpPr>
          <p:spPr>
            <a:xfrm>
              <a:off x="900207" y="4373029"/>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4" name="pt61">
              <a:extLst>
                <a:ext uri="{FF2B5EF4-FFF2-40B4-BE49-F238E27FC236}">
                  <a16:creationId xmlns:a16="http://schemas.microsoft.com/office/drawing/2014/main" id="{2F632723-119E-A4D3-1949-5E80E4F1E1A7}"/>
                </a:ext>
              </a:extLst>
            </p:cNvPr>
            <p:cNvSpPr/>
            <p:nvPr/>
          </p:nvSpPr>
          <p:spPr>
            <a:xfrm>
              <a:off x="920467" y="4247412"/>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5" name="pt62">
              <a:extLst>
                <a:ext uri="{FF2B5EF4-FFF2-40B4-BE49-F238E27FC236}">
                  <a16:creationId xmlns:a16="http://schemas.microsoft.com/office/drawing/2014/main" id="{22774597-1787-5519-57CF-54BBEBA168CF}"/>
                </a:ext>
              </a:extLst>
            </p:cNvPr>
            <p:cNvSpPr/>
            <p:nvPr/>
          </p:nvSpPr>
          <p:spPr>
            <a:xfrm>
              <a:off x="990012" y="3953964"/>
              <a:ext cx="16615" cy="16615"/>
            </a:xfrm>
            <a:prstGeom prst="ellipse">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957" name="pl64">
              <a:extLst>
                <a:ext uri="{FF2B5EF4-FFF2-40B4-BE49-F238E27FC236}">
                  <a16:creationId xmlns:a16="http://schemas.microsoft.com/office/drawing/2014/main" id="{5BAEF0DE-7B15-C219-7EEE-D8F424707FDF}"/>
                </a:ext>
              </a:extLst>
            </p:cNvPr>
            <p:cNvSpPr/>
            <p:nvPr/>
          </p:nvSpPr>
          <p:spPr>
            <a:xfrm>
              <a:off x="639608" y="3288306"/>
              <a:ext cx="0" cy="1638722"/>
            </a:xfrm>
            <a:custGeom>
              <a:avLst/>
              <a:gdLst/>
              <a:ahLst/>
              <a:cxnLst/>
              <a:rect l="0" t="0" r="0" b="0"/>
              <a:pathLst>
                <a:path h="4896888">
                  <a:moveTo>
                    <a:pt x="0" y="4896888"/>
                  </a:moveTo>
                  <a:lnTo>
                    <a:pt x="0"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58" name="tx65">
              <a:extLst>
                <a:ext uri="{FF2B5EF4-FFF2-40B4-BE49-F238E27FC236}">
                  <a16:creationId xmlns:a16="http://schemas.microsoft.com/office/drawing/2014/main" id="{DB80FCE0-DEC5-950D-59A1-9B7194F8876E}"/>
                </a:ext>
              </a:extLst>
            </p:cNvPr>
            <p:cNvSpPr/>
            <p:nvPr/>
          </p:nvSpPr>
          <p:spPr>
            <a:xfrm>
              <a:off x="549330" y="4903246"/>
              <a:ext cx="35455"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0</a:t>
              </a:r>
            </a:p>
          </p:txBody>
        </p:sp>
        <p:sp>
          <p:nvSpPr>
            <p:cNvPr id="2959" name="tx66">
              <a:extLst>
                <a:ext uri="{FF2B5EF4-FFF2-40B4-BE49-F238E27FC236}">
                  <a16:creationId xmlns:a16="http://schemas.microsoft.com/office/drawing/2014/main" id="{351F4426-E92F-4B84-0457-6D88636F6A5D}"/>
                </a:ext>
              </a:extLst>
            </p:cNvPr>
            <p:cNvSpPr/>
            <p:nvPr/>
          </p:nvSpPr>
          <p:spPr>
            <a:xfrm>
              <a:off x="513876" y="4493566"/>
              <a:ext cx="70909"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25</a:t>
              </a:r>
            </a:p>
          </p:txBody>
        </p:sp>
        <p:sp>
          <p:nvSpPr>
            <p:cNvPr id="2960" name="tx67">
              <a:extLst>
                <a:ext uri="{FF2B5EF4-FFF2-40B4-BE49-F238E27FC236}">
                  <a16:creationId xmlns:a16="http://schemas.microsoft.com/office/drawing/2014/main" id="{F0303479-3681-E482-43AD-2D9763782C59}"/>
                </a:ext>
              </a:extLst>
            </p:cNvPr>
            <p:cNvSpPr/>
            <p:nvPr/>
          </p:nvSpPr>
          <p:spPr>
            <a:xfrm>
              <a:off x="513876" y="4083885"/>
              <a:ext cx="70909"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50</a:t>
              </a:r>
            </a:p>
          </p:txBody>
        </p:sp>
        <p:sp>
          <p:nvSpPr>
            <p:cNvPr id="2961" name="tx68">
              <a:extLst>
                <a:ext uri="{FF2B5EF4-FFF2-40B4-BE49-F238E27FC236}">
                  <a16:creationId xmlns:a16="http://schemas.microsoft.com/office/drawing/2014/main" id="{7A97620B-0955-06B5-BCCA-EC3A0276A74D}"/>
                </a:ext>
              </a:extLst>
            </p:cNvPr>
            <p:cNvSpPr/>
            <p:nvPr/>
          </p:nvSpPr>
          <p:spPr>
            <a:xfrm>
              <a:off x="513876" y="3674983"/>
              <a:ext cx="70909" cy="45820"/>
            </a:xfrm>
            <a:prstGeom prst="rect">
              <a:avLst/>
            </a:prstGeom>
            <a:noFill/>
          </p:spPr>
          <p:txBody>
            <a:bodyPr wrap="none" lIns="0" tIns="0" rIns="0" bIns="0" anchor="ctr" anchorCtr="1"/>
            <a:lstStyle/>
            <a:p>
              <a:pPr marL="0" marR="0" indent="0" algn="l">
                <a:lnSpc>
                  <a:spcPts val="1500"/>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75</a:t>
              </a:r>
            </a:p>
          </p:txBody>
        </p:sp>
        <p:sp>
          <p:nvSpPr>
            <p:cNvPr id="2962" name="tx69">
              <a:extLst>
                <a:ext uri="{FF2B5EF4-FFF2-40B4-BE49-F238E27FC236}">
                  <a16:creationId xmlns:a16="http://schemas.microsoft.com/office/drawing/2014/main" id="{C57CD46A-B146-F2B0-5F3F-E6633791CE04}"/>
                </a:ext>
              </a:extLst>
            </p:cNvPr>
            <p:cNvSpPr/>
            <p:nvPr/>
          </p:nvSpPr>
          <p:spPr>
            <a:xfrm>
              <a:off x="478421" y="3264524"/>
              <a:ext cx="106364" cy="46598"/>
            </a:xfrm>
            <a:prstGeom prst="rect">
              <a:avLst/>
            </a:prstGeom>
            <a:noFill/>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100</a:t>
              </a:r>
            </a:p>
          </p:txBody>
        </p:sp>
        <p:sp>
          <p:nvSpPr>
            <p:cNvPr id="2963" name="pl70">
              <a:extLst>
                <a:ext uri="{FF2B5EF4-FFF2-40B4-BE49-F238E27FC236}">
                  <a16:creationId xmlns:a16="http://schemas.microsoft.com/office/drawing/2014/main" id="{2420BFF4-AD2C-83B0-2B26-C4F43CF8174B}"/>
                </a:ext>
              </a:extLst>
            </p:cNvPr>
            <p:cNvSpPr/>
            <p:nvPr/>
          </p:nvSpPr>
          <p:spPr>
            <a:xfrm>
              <a:off x="621614" y="4927028"/>
              <a:ext cx="21600" cy="0"/>
            </a:xfrm>
            <a:custGeom>
              <a:avLst/>
              <a:gdLst/>
              <a:ahLst/>
              <a:cxnLst/>
              <a:rect l="0" t="0" r="0" b="0"/>
              <a:pathLst>
                <a:path w="34794">
                  <a:moveTo>
                    <a:pt x="0" y="0"/>
                  </a:moveTo>
                  <a:lnTo>
                    <a:pt x="34794" y="0"/>
                  </a:lnTo>
                </a:path>
              </a:pathLst>
            </a:custGeom>
            <a:ln w="13550"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64" name="pl71">
              <a:extLst>
                <a:ext uri="{FF2B5EF4-FFF2-40B4-BE49-F238E27FC236}">
                  <a16:creationId xmlns:a16="http://schemas.microsoft.com/office/drawing/2014/main" id="{F21B4F7C-164B-1047-9935-FB11EFDCD4EC}"/>
                </a:ext>
              </a:extLst>
            </p:cNvPr>
            <p:cNvSpPr/>
            <p:nvPr/>
          </p:nvSpPr>
          <p:spPr>
            <a:xfrm>
              <a:off x="621614" y="4517347"/>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65" name="pl72">
              <a:extLst>
                <a:ext uri="{FF2B5EF4-FFF2-40B4-BE49-F238E27FC236}">
                  <a16:creationId xmlns:a16="http://schemas.microsoft.com/office/drawing/2014/main" id="{8FDE93B3-1C83-36F4-F4DA-D6F68E0EF238}"/>
                </a:ext>
              </a:extLst>
            </p:cNvPr>
            <p:cNvSpPr/>
            <p:nvPr/>
          </p:nvSpPr>
          <p:spPr>
            <a:xfrm>
              <a:off x="621614" y="4107667"/>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66" name="pl73">
              <a:extLst>
                <a:ext uri="{FF2B5EF4-FFF2-40B4-BE49-F238E27FC236}">
                  <a16:creationId xmlns:a16="http://schemas.microsoft.com/office/drawing/2014/main" id="{C46129E5-FC37-9477-9EAD-764F15365F0A}"/>
                </a:ext>
              </a:extLst>
            </p:cNvPr>
            <p:cNvSpPr/>
            <p:nvPr/>
          </p:nvSpPr>
          <p:spPr>
            <a:xfrm>
              <a:off x="621614" y="3697986"/>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67" name="pl74">
              <a:extLst>
                <a:ext uri="{FF2B5EF4-FFF2-40B4-BE49-F238E27FC236}">
                  <a16:creationId xmlns:a16="http://schemas.microsoft.com/office/drawing/2014/main" id="{B79BFE32-F4B3-FCCF-D7AF-15F75D7471F2}"/>
                </a:ext>
              </a:extLst>
            </p:cNvPr>
            <p:cNvSpPr/>
            <p:nvPr/>
          </p:nvSpPr>
          <p:spPr>
            <a:xfrm>
              <a:off x="621614" y="3288306"/>
              <a:ext cx="21600" cy="0"/>
            </a:xfrm>
            <a:custGeom>
              <a:avLst/>
              <a:gdLst/>
              <a:ahLst/>
              <a:cxnLst/>
              <a:rect l="0" t="0" r="0" b="0"/>
              <a:pathLst>
                <a:path w="34794">
                  <a:moveTo>
                    <a:pt x="0" y="0"/>
                  </a:moveTo>
                  <a:lnTo>
                    <a:pt x="34794"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68" name="pl75">
              <a:extLst>
                <a:ext uri="{FF2B5EF4-FFF2-40B4-BE49-F238E27FC236}">
                  <a16:creationId xmlns:a16="http://schemas.microsoft.com/office/drawing/2014/main" id="{69118E13-3847-9433-286C-395A37116ADA}"/>
                </a:ext>
              </a:extLst>
            </p:cNvPr>
            <p:cNvSpPr/>
            <p:nvPr/>
          </p:nvSpPr>
          <p:spPr>
            <a:xfrm>
              <a:off x="639608" y="4927028"/>
              <a:ext cx="1174920" cy="0"/>
            </a:xfrm>
            <a:custGeom>
              <a:avLst/>
              <a:gdLst/>
              <a:ahLst/>
              <a:cxnLst/>
              <a:rect l="0" t="0" r="0" b="0"/>
              <a:pathLst>
                <a:path w="3510937">
                  <a:moveTo>
                    <a:pt x="0" y="0"/>
                  </a:moveTo>
                  <a:lnTo>
                    <a:pt x="3510937"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69" name="pl76">
              <a:extLst>
                <a:ext uri="{FF2B5EF4-FFF2-40B4-BE49-F238E27FC236}">
                  <a16:creationId xmlns:a16="http://schemas.microsoft.com/office/drawing/2014/main" id="{0D2CA297-D1BA-3CA4-00AC-8F816FDFD314}"/>
                </a:ext>
              </a:extLst>
            </p:cNvPr>
            <p:cNvSpPr/>
            <p:nvPr/>
          </p:nvSpPr>
          <p:spPr>
            <a:xfrm>
              <a:off x="960041" y="4927028"/>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70" name="pl77">
              <a:extLst>
                <a:ext uri="{FF2B5EF4-FFF2-40B4-BE49-F238E27FC236}">
                  <a16:creationId xmlns:a16="http://schemas.microsoft.com/office/drawing/2014/main" id="{9B5E1D47-5E62-4533-9847-F512BA2E2C3D}"/>
                </a:ext>
              </a:extLst>
            </p:cNvPr>
            <p:cNvSpPr/>
            <p:nvPr/>
          </p:nvSpPr>
          <p:spPr>
            <a:xfrm>
              <a:off x="1494095" y="4927028"/>
              <a:ext cx="0" cy="21600"/>
            </a:xfrm>
            <a:custGeom>
              <a:avLst/>
              <a:gdLst/>
              <a:ahLst/>
              <a:cxnLst/>
              <a:rect l="0" t="0" r="0" b="0"/>
              <a:pathLst>
                <a:path h="34794">
                  <a:moveTo>
                    <a:pt x="0" y="34794"/>
                  </a:moveTo>
                  <a:lnTo>
                    <a:pt x="0" y="0"/>
                  </a:lnTo>
                </a:path>
              </a:pathLst>
            </a:custGeom>
            <a:ln w="9525" cap="flat">
              <a:solidFill>
                <a:srgbClr val="000000">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971" name="tx78">
              <a:extLst>
                <a:ext uri="{FF2B5EF4-FFF2-40B4-BE49-F238E27FC236}">
                  <a16:creationId xmlns:a16="http://schemas.microsoft.com/office/drawing/2014/main" id="{ECAEC52A-ED47-4775-9C59-F67F66C14218}"/>
                </a:ext>
              </a:extLst>
            </p:cNvPr>
            <p:cNvSpPr/>
            <p:nvPr/>
          </p:nvSpPr>
          <p:spPr>
            <a:xfrm>
              <a:off x="766907" y="4935318"/>
              <a:ext cx="386266" cy="58302"/>
            </a:xfrm>
            <a:prstGeom prst="rect">
              <a:avLst/>
            </a:prstGeom>
            <a:noFill/>
            <a:ln w="9525">
              <a:noFill/>
            </a:ln>
          </p:spPr>
          <p:txBody>
            <a:bodyPr wrap="none" lIns="0" tIns="0" rIns="0" bIns="0" anchor="ctr" anchorCtr="1"/>
            <a:lstStyle/>
            <a:p>
              <a:pPr marL="0" marR="0" indent="0" algn="l">
                <a:lnSpc>
                  <a:spcPts val="1500"/>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No Response</a:t>
              </a:r>
            </a:p>
          </p:txBody>
        </p:sp>
        <p:sp>
          <p:nvSpPr>
            <p:cNvPr id="2972" name="tx79">
              <a:extLst>
                <a:ext uri="{FF2B5EF4-FFF2-40B4-BE49-F238E27FC236}">
                  <a16:creationId xmlns:a16="http://schemas.microsoft.com/office/drawing/2014/main" id="{764C72A5-F705-9FA4-2909-A1DEF5D5D8AB}"/>
                </a:ext>
              </a:extLst>
            </p:cNvPr>
            <p:cNvSpPr/>
            <p:nvPr/>
          </p:nvSpPr>
          <p:spPr>
            <a:xfrm>
              <a:off x="1362969" y="4947147"/>
              <a:ext cx="262253" cy="46474"/>
            </a:xfrm>
            <a:prstGeom prst="rect">
              <a:avLst/>
            </a:prstGeom>
            <a:noFill/>
            <a:ln w="9525">
              <a:noFill/>
            </a:ln>
          </p:spPr>
          <p:txBody>
            <a:bodyPr wrap="none" lIns="0" tIns="0" rIns="0" bIns="0" anchor="ctr" anchorCtr="1"/>
            <a:lstStyle/>
            <a:p>
              <a:pPr marL="0" marR="0" indent="0" algn="l">
                <a:lnSpc>
                  <a:spcPts val="1500"/>
                </a:lnSpc>
                <a:spcBef>
                  <a:spcPts val="0"/>
                </a:spcBef>
                <a:spcAft>
                  <a:spcPts val="0"/>
                </a:spcAft>
              </a:pPr>
              <a:r>
                <a:rPr lang="en-US" sz="700" dirty="0">
                  <a:solidFill>
                    <a:srgbClr val="000000">
                      <a:alpha val="100000"/>
                    </a:srgbClr>
                  </a:solidFill>
                  <a:latin typeface="Arial" panose="020B0604020202020204" pitchFamily="34" charset="0"/>
                  <a:cs typeface="Arial" panose="020B0604020202020204" pitchFamily="34" charset="0"/>
                </a:rPr>
                <a:t>R</a:t>
              </a:r>
              <a:r>
                <a:rPr sz="700" dirty="0">
                  <a:solidFill>
                    <a:srgbClr val="000000">
                      <a:alpha val="100000"/>
                    </a:srgbClr>
                  </a:solidFill>
                  <a:latin typeface="Arial" panose="020B0604020202020204" pitchFamily="34" charset="0"/>
                  <a:cs typeface="Arial" panose="020B0604020202020204" pitchFamily="34" charset="0"/>
                </a:rPr>
                <a:t>esponse</a:t>
              </a:r>
            </a:p>
          </p:txBody>
        </p:sp>
        <p:sp>
          <p:nvSpPr>
            <p:cNvPr id="2973" name="tx81">
              <a:extLst>
                <a:ext uri="{FF2B5EF4-FFF2-40B4-BE49-F238E27FC236}">
                  <a16:creationId xmlns:a16="http://schemas.microsoft.com/office/drawing/2014/main" id="{0B0C7C2C-D853-8795-F6C8-7474BC55EFA5}"/>
                </a:ext>
              </a:extLst>
            </p:cNvPr>
            <p:cNvSpPr/>
            <p:nvPr/>
          </p:nvSpPr>
          <p:spPr>
            <a:xfrm rot="16200000">
              <a:off x="350189" y="4078142"/>
              <a:ext cx="113430" cy="59050"/>
            </a:xfrm>
            <a:prstGeom prst="rect">
              <a:avLst/>
            </a:prstGeom>
            <a:noFill/>
          </p:spPr>
          <p:txBody>
            <a:bodyPr wrap="none" lIns="0" tIns="0" rIns="0" bIns="0" anchor="ctr" anchorCtr="1"/>
            <a:lstStyle/>
            <a:p>
              <a:pPr marL="0" marR="0" indent="0" algn="l">
                <a:lnSpc>
                  <a:spcPts val="1500"/>
                </a:lnSpc>
                <a:spcBef>
                  <a:spcPts val="0"/>
                </a:spcBef>
                <a:spcAft>
                  <a:spcPts val="0"/>
                </a:spcAft>
              </a:pPr>
              <a:r>
                <a:rPr lang="en-US" sz="700" dirty="0">
                  <a:solidFill>
                    <a:srgbClr val="000000">
                      <a:alpha val="100000"/>
                    </a:srgbClr>
                  </a:solidFill>
                  <a:latin typeface="Arial" panose="020B0604020202020204" pitchFamily="34" charset="0"/>
                  <a:cs typeface="Arial" panose="020B0604020202020204" pitchFamily="34" charset="0"/>
                </a:rPr>
                <a:t>A</a:t>
              </a:r>
              <a:r>
                <a:rPr sz="700" dirty="0">
                  <a:solidFill>
                    <a:srgbClr val="000000">
                      <a:alpha val="100000"/>
                    </a:srgbClr>
                  </a:solidFill>
                  <a:latin typeface="Arial" panose="020B0604020202020204" pitchFamily="34" charset="0"/>
                  <a:cs typeface="Arial" panose="020B0604020202020204" pitchFamily="34" charset="0"/>
                </a:rPr>
                <a:t>ge</a:t>
              </a:r>
              <a:r>
                <a:rPr lang="en-US" sz="700" dirty="0">
                  <a:solidFill>
                    <a:srgbClr val="000000">
                      <a:alpha val="100000"/>
                    </a:srgbClr>
                  </a:solidFill>
                  <a:latin typeface="Arial" panose="020B0604020202020204" pitchFamily="34" charset="0"/>
                  <a:cs typeface="Arial" panose="020B0604020202020204" pitchFamily="34" charset="0"/>
                </a:rPr>
                <a:t>(years)</a:t>
              </a:r>
              <a:endParaRPr sz="700" dirty="0">
                <a:solidFill>
                  <a:srgbClr val="000000">
                    <a:alpha val="100000"/>
                  </a:srgbClr>
                </a:solidFill>
                <a:latin typeface="Arial" panose="020B0604020202020204" pitchFamily="34" charset="0"/>
                <a:cs typeface="Arial" panose="020B0604020202020204" pitchFamily="34" charset="0"/>
              </a:endParaRPr>
            </a:p>
          </p:txBody>
        </p:sp>
        <p:grpSp>
          <p:nvGrpSpPr>
            <p:cNvPr id="123" name="组合 122">
              <a:extLst>
                <a:ext uri="{FF2B5EF4-FFF2-40B4-BE49-F238E27FC236}">
                  <a16:creationId xmlns:a16="http://schemas.microsoft.com/office/drawing/2014/main" id="{3F30BDC7-D2B0-A883-4A83-CF88F98B8CC4}"/>
                </a:ext>
              </a:extLst>
            </p:cNvPr>
            <p:cNvGrpSpPr/>
            <p:nvPr/>
          </p:nvGrpSpPr>
          <p:grpSpPr>
            <a:xfrm>
              <a:off x="868947" y="3441215"/>
              <a:ext cx="849772" cy="112393"/>
              <a:chOff x="868947" y="2433938"/>
              <a:chExt cx="849772" cy="112393"/>
            </a:xfrm>
          </p:grpSpPr>
          <p:sp>
            <p:nvSpPr>
              <p:cNvPr id="2956" name="tx63">
                <a:extLst>
                  <a:ext uri="{FF2B5EF4-FFF2-40B4-BE49-F238E27FC236}">
                    <a16:creationId xmlns:a16="http://schemas.microsoft.com/office/drawing/2014/main" id="{73497575-B32F-0D7D-1924-5C78AE655812}"/>
                  </a:ext>
                </a:extLst>
              </p:cNvPr>
              <p:cNvSpPr/>
              <p:nvPr/>
            </p:nvSpPr>
            <p:spPr>
              <a:xfrm>
                <a:off x="1044294" y="2433938"/>
                <a:ext cx="499078" cy="55473"/>
              </a:xfrm>
              <a:prstGeom prst="rect">
                <a:avLst/>
              </a:prstGeom>
              <a:noFill/>
            </p:spPr>
            <p:txBody>
              <a:bodyPr wrap="none" lIns="0" tIns="0" rIns="0" bIns="0" anchor="ctr" anchorCtr="1"/>
              <a:lstStyle/>
              <a:p>
                <a:pPr marL="0" marR="0" indent="0" algn="l">
                  <a:lnSpc>
                    <a:spcPts val="1422"/>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Wilcoxon, </a:t>
                </a:r>
                <a:r>
                  <a:rPr sz="700" i="1" dirty="0">
                    <a:solidFill>
                      <a:srgbClr val="000000">
                        <a:alpha val="100000"/>
                      </a:srgbClr>
                    </a:solidFill>
                    <a:latin typeface="Arial" panose="020B0604020202020204" pitchFamily="34" charset="0"/>
                    <a:cs typeface="Arial" panose="020B0604020202020204" pitchFamily="34" charset="0"/>
                  </a:rPr>
                  <a:t>p</a:t>
                </a:r>
                <a:r>
                  <a:rPr sz="700" dirty="0">
                    <a:solidFill>
                      <a:srgbClr val="000000">
                        <a:alpha val="100000"/>
                      </a:srgbClr>
                    </a:solidFill>
                    <a:latin typeface="Arial" panose="020B0604020202020204" pitchFamily="34" charset="0"/>
                    <a:cs typeface="Arial" panose="020B0604020202020204" pitchFamily="34" charset="0"/>
                  </a:rPr>
                  <a:t> = 0.83</a:t>
                </a:r>
              </a:p>
            </p:txBody>
          </p:sp>
          <p:cxnSp>
            <p:nvCxnSpPr>
              <p:cNvPr id="124" name="直接连接符 123">
                <a:extLst>
                  <a:ext uri="{FF2B5EF4-FFF2-40B4-BE49-F238E27FC236}">
                    <a16:creationId xmlns:a16="http://schemas.microsoft.com/office/drawing/2014/main" id="{EB9B2A1F-575C-7259-8F50-53A092F8346E}"/>
                  </a:ext>
                </a:extLst>
              </p:cNvPr>
              <p:cNvCxnSpPr>
                <a:cxnSpLocks/>
              </p:cNvCxnSpPr>
              <p:nvPr/>
            </p:nvCxnSpPr>
            <p:spPr>
              <a:xfrm>
                <a:off x="868947" y="2546331"/>
                <a:ext cx="84977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25" name="组合 124">
            <a:extLst>
              <a:ext uri="{FF2B5EF4-FFF2-40B4-BE49-F238E27FC236}">
                <a16:creationId xmlns:a16="http://schemas.microsoft.com/office/drawing/2014/main" id="{FB2D07E6-2404-57C0-638B-A046327959A7}"/>
              </a:ext>
            </a:extLst>
          </p:cNvPr>
          <p:cNvGrpSpPr/>
          <p:nvPr/>
        </p:nvGrpSpPr>
        <p:grpSpPr>
          <a:xfrm>
            <a:off x="2137821" y="3320676"/>
            <a:ext cx="2039861" cy="1705659"/>
            <a:chOff x="2131514" y="3282593"/>
            <a:chExt cx="2039861" cy="1705659"/>
          </a:xfrm>
        </p:grpSpPr>
        <p:sp>
          <p:nvSpPr>
            <p:cNvPr id="2623" name="rc6">
              <a:extLst>
                <a:ext uri="{FF2B5EF4-FFF2-40B4-BE49-F238E27FC236}">
                  <a16:creationId xmlns:a16="http://schemas.microsoft.com/office/drawing/2014/main" id="{77A07B0C-59AF-21E2-30D3-DBEF901FEA4B}"/>
                </a:ext>
              </a:extLst>
            </p:cNvPr>
            <p:cNvSpPr/>
            <p:nvPr/>
          </p:nvSpPr>
          <p:spPr>
            <a:xfrm>
              <a:off x="2570651" y="3982007"/>
              <a:ext cx="228569" cy="928119"/>
            </a:xfrm>
            <a:prstGeom prst="rect">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624" name="rc7">
              <a:extLst>
                <a:ext uri="{FF2B5EF4-FFF2-40B4-BE49-F238E27FC236}">
                  <a16:creationId xmlns:a16="http://schemas.microsoft.com/office/drawing/2014/main" id="{4B1E91BD-A85E-5053-1CBE-A8529057BF18}"/>
                </a:ext>
              </a:extLst>
            </p:cNvPr>
            <p:cNvSpPr/>
            <p:nvPr/>
          </p:nvSpPr>
          <p:spPr>
            <a:xfrm>
              <a:off x="3332548" y="4748714"/>
              <a:ext cx="228569" cy="161411"/>
            </a:xfrm>
            <a:prstGeom prst="rect">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2625" name="rc8">
              <a:extLst>
                <a:ext uri="{FF2B5EF4-FFF2-40B4-BE49-F238E27FC236}">
                  <a16:creationId xmlns:a16="http://schemas.microsoft.com/office/drawing/2014/main" id="{DC23451D-2310-5568-DEE0-98CFF033470E}"/>
                </a:ext>
              </a:extLst>
            </p:cNvPr>
            <p:cNvSpPr/>
            <p:nvPr/>
          </p:nvSpPr>
          <p:spPr>
            <a:xfrm>
              <a:off x="2875410" y="4264478"/>
              <a:ext cx="228569" cy="645648"/>
            </a:xfrm>
            <a:prstGeom prst="rect">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626" name="rc9">
              <a:extLst>
                <a:ext uri="{FF2B5EF4-FFF2-40B4-BE49-F238E27FC236}">
                  <a16:creationId xmlns:a16="http://schemas.microsoft.com/office/drawing/2014/main" id="{D2BE2728-C302-F6F9-C569-32BB61364615}"/>
                </a:ext>
              </a:extLst>
            </p:cNvPr>
            <p:cNvSpPr/>
            <p:nvPr/>
          </p:nvSpPr>
          <p:spPr>
            <a:xfrm>
              <a:off x="3637308" y="4748714"/>
              <a:ext cx="228569" cy="161411"/>
            </a:xfrm>
            <a:prstGeom prst="rect">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2627" name="tx10">
              <a:extLst>
                <a:ext uri="{FF2B5EF4-FFF2-40B4-BE49-F238E27FC236}">
                  <a16:creationId xmlns:a16="http://schemas.microsoft.com/office/drawing/2014/main" id="{59C2D906-5EEF-53BE-4221-DF3E4CE9FDC1}"/>
                </a:ext>
              </a:extLst>
            </p:cNvPr>
            <p:cNvSpPr/>
            <p:nvPr/>
          </p:nvSpPr>
          <p:spPr>
            <a:xfrm>
              <a:off x="2649509" y="3844924"/>
              <a:ext cx="69678" cy="32994"/>
            </a:xfrm>
            <a:prstGeom prst="rect">
              <a:avLst/>
            </a:prstGeom>
            <a:noFill/>
          </p:spPr>
          <p:txBody>
            <a:bodyPr wrap="none" lIns="0" tIns="0" rIns="0" bIns="0" anchor="ctr" anchorCtr="1"/>
            <a:lstStyle/>
            <a:p>
              <a:pPr marL="0" marR="0" indent="0" algn="l">
                <a:lnSpc>
                  <a:spcPts val="1103"/>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23</a:t>
              </a:r>
            </a:p>
          </p:txBody>
        </p:sp>
        <p:sp>
          <p:nvSpPr>
            <p:cNvPr id="2628" name="tx11">
              <a:extLst>
                <a:ext uri="{FF2B5EF4-FFF2-40B4-BE49-F238E27FC236}">
                  <a16:creationId xmlns:a16="http://schemas.microsoft.com/office/drawing/2014/main" id="{23E36D8D-09D1-CE5E-85A1-BDCB3E0105CB}"/>
                </a:ext>
              </a:extLst>
            </p:cNvPr>
            <p:cNvSpPr/>
            <p:nvPr/>
          </p:nvSpPr>
          <p:spPr>
            <a:xfrm>
              <a:off x="3428826" y="4612336"/>
              <a:ext cx="34839" cy="32290"/>
            </a:xfrm>
            <a:prstGeom prst="rect">
              <a:avLst/>
            </a:prstGeom>
            <a:noFill/>
          </p:spPr>
          <p:txBody>
            <a:bodyPr wrap="none" lIns="0" tIns="0" rIns="0" bIns="0" anchor="ctr" anchorCtr="1"/>
            <a:lstStyle/>
            <a:p>
              <a:pPr marL="0" marR="0" indent="0" algn="l">
                <a:lnSpc>
                  <a:spcPts val="1103"/>
                </a:lnSpc>
                <a:spcBef>
                  <a:spcPts val="0"/>
                </a:spcBef>
                <a:spcAft>
                  <a:spcPts val="0"/>
                </a:spcAft>
              </a:pPr>
              <a:r>
                <a:rPr sz="700">
                  <a:solidFill>
                    <a:srgbClr val="000000">
                      <a:alpha val="100000"/>
                    </a:srgbClr>
                  </a:solidFill>
                  <a:latin typeface="Arial" panose="020B0604020202020204" pitchFamily="34" charset="0"/>
                  <a:cs typeface="Arial" panose="020B0604020202020204" pitchFamily="34" charset="0"/>
                </a:rPr>
                <a:t>4</a:t>
              </a:r>
            </a:p>
          </p:txBody>
        </p:sp>
        <p:sp>
          <p:nvSpPr>
            <p:cNvPr id="2629" name="tx12">
              <a:extLst>
                <a:ext uri="{FF2B5EF4-FFF2-40B4-BE49-F238E27FC236}">
                  <a16:creationId xmlns:a16="http://schemas.microsoft.com/office/drawing/2014/main" id="{1FF9C986-DB1D-7F2A-D08A-9BBBEDD5C471}"/>
                </a:ext>
              </a:extLst>
            </p:cNvPr>
            <p:cNvSpPr/>
            <p:nvPr/>
          </p:nvSpPr>
          <p:spPr>
            <a:xfrm>
              <a:off x="2954268" y="4127416"/>
              <a:ext cx="69678" cy="32972"/>
            </a:xfrm>
            <a:prstGeom prst="rect">
              <a:avLst/>
            </a:prstGeom>
            <a:noFill/>
          </p:spPr>
          <p:txBody>
            <a:bodyPr wrap="none" lIns="0" tIns="0" rIns="0" bIns="0" anchor="ctr" anchorCtr="1"/>
            <a:lstStyle/>
            <a:p>
              <a:pPr marL="0" marR="0" indent="0" algn="l">
                <a:lnSpc>
                  <a:spcPts val="1103"/>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16</a:t>
              </a:r>
            </a:p>
          </p:txBody>
        </p:sp>
        <p:sp>
          <p:nvSpPr>
            <p:cNvPr id="2630" name="tx13">
              <a:extLst>
                <a:ext uri="{FF2B5EF4-FFF2-40B4-BE49-F238E27FC236}">
                  <a16:creationId xmlns:a16="http://schemas.microsoft.com/office/drawing/2014/main" id="{98619DEC-B8AE-37FC-AD4C-43B6EC76B465}"/>
                </a:ext>
              </a:extLst>
            </p:cNvPr>
            <p:cNvSpPr/>
            <p:nvPr/>
          </p:nvSpPr>
          <p:spPr>
            <a:xfrm>
              <a:off x="3733585" y="4612336"/>
              <a:ext cx="34839" cy="32290"/>
            </a:xfrm>
            <a:prstGeom prst="rect">
              <a:avLst/>
            </a:prstGeom>
            <a:noFill/>
          </p:spPr>
          <p:txBody>
            <a:bodyPr wrap="none" lIns="0" tIns="0" rIns="0" bIns="0" anchor="ctr" anchorCtr="1"/>
            <a:lstStyle/>
            <a:p>
              <a:pPr marL="0" marR="0" indent="0" algn="l">
                <a:lnSpc>
                  <a:spcPts val="1103"/>
                </a:lnSpc>
                <a:spcBef>
                  <a:spcPts val="0"/>
                </a:spcBef>
                <a:spcAft>
                  <a:spcPts val="0"/>
                </a:spcAft>
              </a:pPr>
              <a:r>
                <a:rPr sz="700" dirty="0">
                  <a:solidFill>
                    <a:srgbClr val="000000">
                      <a:alpha val="100000"/>
                    </a:srgbClr>
                  </a:solidFill>
                  <a:latin typeface="Arial" panose="020B0604020202020204" pitchFamily="34" charset="0"/>
                  <a:cs typeface="Arial" panose="020B0604020202020204" pitchFamily="34" charset="0"/>
                </a:rPr>
                <a:t>4</a:t>
              </a:r>
            </a:p>
          </p:txBody>
        </p:sp>
        <p:sp>
          <p:nvSpPr>
            <p:cNvPr id="2631" name="pl14">
              <a:extLst>
                <a:ext uri="{FF2B5EF4-FFF2-40B4-BE49-F238E27FC236}">
                  <a16:creationId xmlns:a16="http://schemas.microsoft.com/office/drawing/2014/main" id="{0F010423-443B-3C20-03BF-19CD4E66EAE3}"/>
                </a:ext>
              </a:extLst>
            </p:cNvPr>
            <p:cNvSpPr/>
            <p:nvPr/>
          </p:nvSpPr>
          <p:spPr>
            <a:xfrm>
              <a:off x="2380176" y="3296007"/>
              <a:ext cx="0" cy="1614119"/>
            </a:xfrm>
            <a:custGeom>
              <a:avLst/>
              <a:gdLst/>
              <a:ahLst/>
              <a:cxnLst/>
              <a:rect l="0" t="0" r="0" b="0"/>
              <a:pathLst>
                <a:path h="5016877">
                  <a:moveTo>
                    <a:pt x="0" y="5016877"/>
                  </a:moveTo>
                  <a:lnTo>
                    <a:pt x="0"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32" name="tx15">
              <a:extLst>
                <a:ext uri="{FF2B5EF4-FFF2-40B4-BE49-F238E27FC236}">
                  <a16:creationId xmlns:a16="http://schemas.microsoft.com/office/drawing/2014/main" id="{BB576CCD-2029-863B-DA78-9AD16671281D}"/>
                </a:ext>
              </a:extLst>
            </p:cNvPr>
            <p:cNvSpPr/>
            <p:nvPr/>
          </p:nvSpPr>
          <p:spPr>
            <a:xfrm>
              <a:off x="2308548" y="4896712"/>
              <a:ext cx="27771" cy="26284"/>
            </a:xfrm>
            <a:prstGeom prst="rect">
              <a:avLst/>
            </a:prstGeom>
            <a:noFill/>
          </p:spPr>
          <p:txBody>
            <a:bodyPr wrap="none" lIns="0" tIns="0" rIns="0" bIns="0" anchor="ctr" anchorCtr="1"/>
            <a:lstStyle/>
            <a:p>
              <a:pPr marL="0" marR="0" indent="0" algn="l">
                <a:lnSpc>
                  <a:spcPts val="880"/>
                </a:lnSpc>
                <a:spcBef>
                  <a:spcPts val="0"/>
                </a:spcBef>
                <a:spcAft>
                  <a:spcPts val="0"/>
                </a:spcAft>
              </a:pPr>
              <a:r>
                <a:rPr sz="700">
                  <a:latin typeface="Arial" panose="020B0604020202020204" pitchFamily="34" charset="0"/>
                  <a:cs typeface="Arial" panose="020B0604020202020204" pitchFamily="34" charset="0"/>
                </a:rPr>
                <a:t>0</a:t>
              </a:r>
            </a:p>
          </p:txBody>
        </p:sp>
        <p:sp>
          <p:nvSpPr>
            <p:cNvPr id="2633" name="tx16">
              <a:extLst>
                <a:ext uri="{FF2B5EF4-FFF2-40B4-BE49-F238E27FC236}">
                  <a16:creationId xmlns:a16="http://schemas.microsoft.com/office/drawing/2014/main" id="{F486BE35-F914-6C4A-DF0D-3D32F9A262C4}"/>
                </a:ext>
              </a:extLst>
            </p:cNvPr>
            <p:cNvSpPr/>
            <p:nvPr/>
          </p:nvSpPr>
          <p:spPr>
            <a:xfrm>
              <a:off x="2280776" y="4089652"/>
              <a:ext cx="55542" cy="26284"/>
            </a:xfrm>
            <a:prstGeom prst="rect">
              <a:avLst/>
            </a:prstGeom>
            <a:noFill/>
          </p:spPr>
          <p:txBody>
            <a:bodyPr wrap="none" lIns="0" tIns="0" rIns="0" bIns="0" anchor="ctr" anchorCtr="1"/>
            <a:lstStyle/>
            <a:p>
              <a:pPr marL="0" marR="0" indent="0" algn="l">
                <a:lnSpc>
                  <a:spcPts val="880"/>
                </a:lnSpc>
                <a:spcBef>
                  <a:spcPts val="0"/>
                </a:spcBef>
                <a:spcAft>
                  <a:spcPts val="0"/>
                </a:spcAft>
              </a:pPr>
              <a:r>
                <a:rPr sz="700" dirty="0">
                  <a:latin typeface="Arial" panose="020B0604020202020204" pitchFamily="34" charset="0"/>
                  <a:cs typeface="Arial" panose="020B0604020202020204" pitchFamily="34" charset="0"/>
                </a:rPr>
                <a:t>20</a:t>
              </a:r>
            </a:p>
          </p:txBody>
        </p:sp>
        <p:sp>
          <p:nvSpPr>
            <p:cNvPr id="2634" name="tx17">
              <a:extLst>
                <a:ext uri="{FF2B5EF4-FFF2-40B4-BE49-F238E27FC236}">
                  <a16:creationId xmlns:a16="http://schemas.microsoft.com/office/drawing/2014/main" id="{EEFD5D0A-5F0E-B76C-6164-950496A9B28B}"/>
                </a:ext>
              </a:extLst>
            </p:cNvPr>
            <p:cNvSpPr/>
            <p:nvPr/>
          </p:nvSpPr>
          <p:spPr>
            <a:xfrm>
              <a:off x="2280776" y="3282593"/>
              <a:ext cx="55542" cy="26284"/>
            </a:xfrm>
            <a:prstGeom prst="rect">
              <a:avLst/>
            </a:prstGeom>
            <a:noFill/>
          </p:spPr>
          <p:txBody>
            <a:bodyPr wrap="none" lIns="0" tIns="0" rIns="0" bIns="0" anchor="ctr" anchorCtr="1"/>
            <a:lstStyle/>
            <a:p>
              <a:pPr marL="0" marR="0" indent="0" algn="l">
                <a:lnSpc>
                  <a:spcPts val="880"/>
                </a:lnSpc>
                <a:spcBef>
                  <a:spcPts val="0"/>
                </a:spcBef>
                <a:spcAft>
                  <a:spcPts val="0"/>
                </a:spcAft>
              </a:pPr>
              <a:r>
                <a:rPr sz="700" dirty="0">
                  <a:latin typeface="Arial" panose="020B0604020202020204" pitchFamily="34" charset="0"/>
                  <a:cs typeface="Arial" panose="020B0604020202020204" pitchFamily="34" charset="0"/>
                </a:rPr>
                <a:t>40</a:t>
              </a:r>
            </a:p>
          </p:txBody>
        </p:sp>
        <p:sp>
          <p:nvSpPr>
            <p:cNvPr id="2635" name="pl18">
              <a:extLst>
                <a:ext uri="{FF2B5EF4-FFF2-40B4-BE49-F238E27FC236}">
                  <a16:creationId xmlns:a16="http://schemas.microsoft.com/office/drawing/2014/main" id="{96F02D4A-7C82-3767-9266-8B8A68AE486E}"/>
                </a:ext>
              </a:extLst>
            </p:cNvPr>
            <p:cNvSpPr/>
            <p:nvPr/>
          </p:nvSpPr>
          <p:spPr>
            <a:xfrm>
              <a:off x="2361456" y="4910126"/>
              <a:ext cx="21600" cy="0"/>
            </a:xfrm>
            <a:custGeom>
              <a:avLst/>
              <a:gdLst/>
              <a:ahLst/>
              <a:cxnLst/>
              <a:rect l="0" t="0" r="0" b="0"/>
              <a:pathLst>
                <a:path w="34794">
                  <a:moveTo>
                    <a:pt x="0" y="0"/>
                  </a:moveTo>
                  <a:lnTo>
                    <a:pt x="34794"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36" name="pl19">
              <a:extLst>
                <a:ext uri="{FF2B5EF4-FFF2-40B4-BE49-F238E27FC236}">
                  <a16:creationId xmlns:a16="http://schemas.microsoft.com/office/drawing/2014/main" id="{0120DDF8-BAF8-AF50-DFA8-6DA4D7CF3164}"/>
                </a:ext>
              </a:extLst>
            </p:cNvPr>
            <p:cNvSpPr/>
            <p:nvPr/>
          </p:nvSpPr>
          <p:spPr>
            <a:xfrm>
              <a:off x="2361456" y="4103066"/>
              <a:ext cx="21600" cy="0"/>
            </a:xfrm>
            <a:custGeom>
              <a:avLst/>
              <a:gdLst/>
              <a:ahLst/>
              <a:cxnLst/>
              <a:rect l="0" t="0" r="0" b="0"/>
              <a:pathLst>
                <a:path w="34794">
                  <a:moveTo>
                    <a:pt x="0" y="0"/>
                  </a:moveTo>
                  <a:lnTo>
                    <a:pt x="34794"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37" name="pl20">
              <a:extLst>
                <a:ext uri="{FF2B5EF4-FFF2-40B4-BE49-F238E27FC236}">
                  <a16:creationId xmlns:a16="http://schemas.microsoft.com/office/drawing/2014/main" id="{537BD08F-6B31-8988-CC99-36705E02A9BA}"/>
                </a:ext>
              </a:extLst>
            </p:cNvPr>
            <p:cNvSpPr/>
            <p:nvPr/>
          </p:nvSpPr>
          <p:spPr>
            <a:xfrm>
              <a:off x="2361456" y="3296007"/>
              <a:ext cx="21600" cy="0"/>
            </a:xfrm>
            <a:custGeom>
              <a:avLst/>
              <a:gdLst/>
              <a:ahLst/>
              <a:cxnLst/>
              <a:rect l="0" t="0" r="0" b="0"/>
              <a:pathLst>
                <a:path w="34794">
                  <a:moveTo>
                    <a:pt x="0" y="0"/>
                  </a:moveTo>
                  <a:lnTo>
                    <a:pt x="34794"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38" name="pl21">
              <a:extLst>
                <a:ext uri="{FF2B5EF4-FFF2-40B4-BE49-F238E27FC236}">
                  <a16:creationId xmlns:a16="http://schemas.microsoft.com/office/drawing/2014/main" id="{25D59845-53BE-E768-0A2C-AE2B818C1E45}"/>
                </a:ext>
              </a:extLst>
            </p:cNvPr>
            <p:cNvSpPr/>
            <p:nvPr/>
          </p:nvSpPr>
          <p:spPr>
            <a:xfrm>
              <a:off x="2380176" y="4910126"/>
              <a:ext cx="1676175" cy="0"/>
            </a:xfrm>
            <a:custGeom>
              <a:avLst/>
              <a:gdLst/>
              <a:ahLst/>
              <a:cxnLst/>
              <a:rect l="0" t="0" r="0" b="0"/>
              <a:pathLst>
                <a:path w="3751522">
                  <a:moveTo>
                    <a:pt x="0" y="0"/>
                  </a:moveTo>
                  <a:lnTo>
                    <a:pt x="3751522" y="0"/>
                  </a:lnTo>
                </a:path>
              </a:pathLst>
            </a:custGeom>
            <a:ln w="9525" cap="flat">
              <a:solidFill>
                <a:schemeClr val="tx1"/>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39" name="pl22">
              <a:extLst>
                <a:ext uri="{FF2B5EF4-FFF2-40B4-BE49-F238E27FC236}">
                  <a16:creationId xmlns:a16="http://schemas.microsoft.com/office/drawing/2014/main" id="{ED41CDF1-C184-AB67-E270-3C7272AA33C7}"/>
                </a:ext>
              </a:extLst>
            </p:cNvPr>
            <p:cNvSpPr/>
            <p:nvPr/>
          </p:nvSpPr>
          <p:spPr>
            <a:xfrm>
              <a:off x="2837316" y="4913300"/>
              <a:ext cx="0" cy="21600"/>
            </a:xfrm>
            <a:custGeom>
              <a:avLst/>
              <a:gdLst/>
              <a:ahLst/>
              <a:cxnLst/>
              <a:rect l="0" t="0" r="0" b="0"/>
              <a:pathLst>
                <a:path h="34794">
                  <a:moveTo>
                    <a:pt x="0" y="34794"/>
                  </a:moveTo>
                  <a:lnTo>
                    <a:pt x="0"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40" name="pl23">
              <a:extLst>
                <a:ext uri="{FF2B5EF4-FFF2-40B4-BE49-F238E27FC236}">
                  <a16:creationId xmlns:a16="http://schemas.microsoft.com/office/drawing/2014/main" id="{C85669CD-4C3B-8F0E-29B7-A1CC5B783FCE}"/>
                </a:ext>
              </a:extLst>
            </p:cNvPr>
            <p:cNvSpPr/>
            <p:nvPr/>
          </p:nvSpPr>
          <p:spPr>
            <a:xfrm>
              <a:off x="3599213" y="4913300"/>
              <a:ext cx="0" cy="21600"/>
            </a:xfrm>
            <a:custGeom>
              <a:avLst/>
              <a:gdLst/>
              <a:ahLst/>
              <a:cxnLst/>
              <a:rect l="0" t="0" r="0" b="0"/>
              <a:pathLst>
                <a:path h="34794">
                  <a:moveTo>
                    <a:pt x="0" y="34794"/>
                  </a:moveTo>
                  <a:lnTo>
                    <a:pt x="0" y="0"/>
                  </a:lnTo>
                </a:path>
              </a:pathLst>
            </a:custGeom>
            <a:ln w="9525" cap="flat">
              <a:solidFill>
                <a:srgbClr val="333333">
                  <a:alpha val="100000"/>
                </a:srgbClr>
              </a:solidFill>
              <a:prstDash val="solid"/>
              <a:round/>
            </a:ln>
          </p:spPr>
          <p:txBody>
            <a:bodyPr/>
            <a:lstStyle/>
            <a:p>
              <a:endParaRPr sz="700">
                <a:latin typeface="Arial" panose="020B0604020202020204" pitchFamily="34" charset="0"/>
                <a:cs typeface="Arial" panose="020B0604020202020204" pitchFamily="34" charset="0"/>
              </a:endParaRPr>
            </a:p>
          </p:txBody>
        </p:sp>
        <p:sp>
          <p:nvSpPr>
            <p:cNvPr id="2641" name="tx24">
              <a:extLst>
                <a:ext uri="{FF2B5EF4-FFF2-40B4-BE49-F238E27FC236}">
                  <a16:creationId xmlns:a16="http://schemas.microsoft.com/office/drawing/2014/main" id="{74D2FC1A-9AD4-1065-8BC9-3EDBE9B961B7}"/>
                </a:ext>
              </a:extLst>
            </p:cNvPr>
            <p:cNvSpPr/>
            <p:nvPr/>
          </p:nvSpPr>
          <p:spPr>
            <a:xfrm>
              <a:off x="2754063" y="4962092"/>
              <a:ext cx="166504" cy="26160"/>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sz="700" dirty="0">
                  <a:latin typeface="Arial" panose="020B0604020202020204" pitchFamily="34" charset="0"/>
                  <a:cs typeface="Arial" panose="020B0604020202020204" pitchFamily="34" charset="0"/>
                </a:rPr>
                <a:t>F</a:t>
              </a:r>
              <a:r>
                <a:rPr sz="700" dirty="0">
                  <a:latin typeface="Arial" panose="020B0604020202020204" pitchFamily="34" charset="0"/>
                  <a:cs typeface="Arial" panose="020B0604020202020204" pitchFamily="34" charset="0"/>
                </a:rPr>
                <a:t>emale</a:t>
              </a:r>
            </a:p>
          </p:txBody>
        </p:sp>
        <p:sp>
          <p:nvSpPr>
            <p:cNvPr id="2642" name="tx25">
              <a:extLst>
                <a:ext uri="{FF2B5EF4-FFF2-40B4-BE49-F238E27FC236}">
                  <a16:creationId xmlns:a16="http://schemas.microsoft.com/office/drawing/2014/main" id="{B9DA12F1-B4BB-83EE-F958-D0200CB88D9E}"/>
                </a:ext>
              </a:extLst>
            </p:cNvPr>
            <p:cNvSpPr/>
            <p:nvPr/>
          </p:nvSpPr>
          <p:spPr>
            <a:xfrm>
              <a:off x="3545097" y="4962092"/>
              <a:ext cx="108232" cy="26160"/>
            </a:xfrm>
            <a:prstGeom prst="rect">
              <a:avLst/>
            </a:prstGeom>
            <a:noFill/>
          </p:spPr>
          <p:txBody>
            <a:bodyPr wrap="none" lIns="0" tIns="0" rIns="0" bIns="0" anchor="ctr" anchorCtr="1"/>
            <a:lstStyle/>
            <a:p>
              <a:pPr marL="0" marR="0" indent="0" algn="l">
                <a:lnSpc>
                  <a:spcPts val="880"/>
                </a:lnSpc>
                <a:spcBef>
                  <a:spcPts val="0"/>
                </a:spcBef>
                <a:spcAft>
                  <a:spcPts val="0"/>
                </a:spcAft>
              </a:pPr>
              <a:r>
                <a:rPr lang="en-US" sz="700" dirty="0">
                  <a:latin typeface="Arial" panose="020B0604020202020204" pitchFamily="34" charset="0"/>
                  <a:cs typeface="Arial" panose="020B0604020202020204" pitchFamily="34" charset="0"/>
                </a:rPr>
                <a:t>M</a:t>
              </a:r>
              <a:r>
                <a:rPr sz="700" dirty="0">
                  <a:latin typeface="Arial" panose="020B0604020202020204" pitchFamily="34" charset="0"/>
                  <a:cs typeface="Arial" panose="020B0604020202020204" pitchFamily="34" charset="0"/>
                </a:rPr>
                <a:t>ale</a:t>
              </a:r>
            </a:p>
          </p:txBody>
        </p:sp>
        <p:sp>
          <p:nvSpPr>
            <p:cNvPr id="2643" name="tx27">
              <a:extLst>
                <a:ext uri="{FF2B5EF4-FFF2-40B4-BE49-F238E27FC236}">
                  <a16:creationId xmlns:a16="http://schemas.microsoft.com/office/drawing/2014/main" id="{34FC2E69-FB3E-9C98-8D5A-153DFC108B45}"/>
                </a:ext>
              </a:extLst>
            </p:cNvPr>
            <p:cNvSpPr/>
            <p:nvPr/>
          </p:nvSpPr>
          <p:spPr>
            <a:xfrm rot="16200000">
              <a:off x="1853222" y="4032633"/>
              <a:ext cx="610833" cy="54250"/>
            </a:xfrm>
            <a:prstGeom prst="rect">
              <a:avLst/>
            </a:prstGeom>
            <a:noFill/>
          </p:spPr>
          <p:txBody>
            <a:bodyPr wrap="none" lIns="0" tIns="0" rIns="0" bIns="0" anchor="ctr" anchorCtr="1"/>
            <a:lstStyle/>
            <a:p>
              <a:pPr>
                <a:lnSpc>
                  <a:spcPts val="1100"/>
                </a:lnSpc>
              </a:pPr>
              <a:r>
                <a:rPr lang="en-US" altLang="zh-CN" sz="700" dirty="0">
                  <a:latin typeface="Arial" panose="020B0604020202020204" pitchFamily="34" charset="0"/>
                  <a:cs typeface="Arial" panose="020B0604020202020204" pitchFamily="34" charset="0"/>
                </a:rPr>
                <a:t>Number of samples</a:t>
              </a:r>
            </a:p>
          </p:txBody>
        </p:sp>
        <p:grpSp>
          <p:nvGrpSpPr>
            <p:cNvPr id="126" name="组合 125">
              <a:extLst>
                <a:ext uri="{FF2B5EF4-FFF2-40B4-BE49-F238E27FC236}">
                  <a16:creationId xmlns:a16="http://schemas.microsoft.com/office/drawing/2014/main" id="{4F1CAAA1-F164-9650-06B3-CD53753C9C53}"/>
                </a:ext>
              </a:extLst>
            </p:cNvPr>
            <p:cNvGrpSpPr/>
            <p:nvPr/>
          </p:nvGrpSpPr>
          <p:grpSpPr>
            <a:xfrm>
              <a:off x="2602977" y="3401242"/>
              <a:ext cx="1222879" cy="192339"/>
              <a:chOff x="2602977" y="2441511"/>
              <a:chExt cx="1222879" cy="192339"/>
            </a:xfrm>
          </p:grpSpPr>
          <p:sp>
            <p:nvSpPr>
              <p:cNvPr id="2620" name="文本框 2619">
                <a:extLst>
                  <a:ext uri="{FF2B5EF4-FFF2-40B4-BE49-F238E27FC236}">
                    <a16:creationId xmlns:a16="http://schemas.microsoft.com/office/drawing/2014/main" id="{BF1552D4-312D-E0EA-28A6-C492A9626BDE}"/>
                  </a:ext>
                </a:extLst>
              </p:cNvPr>
              <p:cNvSpPr txBox="1"/>
              <p:nvPr/>
            </p:nvSpPr>
            <p:spPr>
              <a:xfrm>
                <a:off x="2719729" y="2441511"/>
                <a:ext cx="989373" cy="192339"/>
              </a:xfrm>
              <a:prstGeom prst="rect">
                <a:avLst/>
              </a:prstGeom>
              <a:noFill/>
            </p:spPr>
            <p:txBody>
              <a:bodyPr wrap="none" rtlCol="0">
                <a:spAutoFit/>
              </a:bodyPr>
              <a:lstStyle/>
              <a:p>
                <a:r>
                  <a:rPr lang="en-US" altLang="zh-CN" sz="700" dirty="0">
                    <a:latin typeface="Arial" panose="020B0604020202020204" pitchFamily="34" charset="0"/>
                    <a:cs typeface="Arial" panose="020B0604020202020204" pitchFamily="34" charset="0"/>
                  </a:rPr>
                  <a:t>Chi-squared test,</a:t>
                </a:r>
                <a:r>
                  <a:rPr lang="zh-CN" altLang="en-US" sz="700" dirty="0">
                    <a:latin typeface="Arial" panose="020B0604020202020204" pitchFamily="34" charset="0"/>
                    <a:cs typeface="Arial" panose="020B0604020202020204" pitchFamily="34" charset="0"/>
                  </a:rPr>
                  <a:t> </a:t>
                </a:r>
                <a:r>
                  <a:rPr lang="en-US" altLang="zh-CN" sz="700" dirty="0">
                    <a:latin typeface="Arial" panose="020B0604020202020204" pitchFamily="34" charset="0"/>
                    <a:cs typeface="Arial" panose="020B0604020202020204" pitchFamily="34" charset="0"/>
                  </a:rPr>
                  <a:t>ns</a:t>
                </a:r>
                <a:endParaRPr lang="zh-CN" altLang="en-US" sz="700" dirty="0">
                  <a:latin typeface="Arial" panose="020B0604020202020204" pitchFamily="34" charset="0"/>
                  <a:cs typeface="Arial" panose="020B0604020202020204" pitchFamily="34" charset="0"/>
                </a:endParaRPr>
              </a:p>
            </p:txBody>
          </p:sp>
          <p:cxnSp>
            <p:nvCxnSpPr>
              <p:cNvPr id="2621" name="直接连接符 2620">
                <a:extLst>
                  <a:ext uri="{FF2B5EF4-FFF2-40B4-BE49-F238E27FC236}">
                    <a16:creationId xmlns:a16="http://schemas.microsoft.com/office/drawing/2014/main" id="{E258136B-D54C-A3C6-75FF-262BBE08252B}"/>
                  </a:ext>
                </a:extLst>
              </p:cNvPr>
              <p:cNvCxnSpPr>
                <a:cxnSpLocks/>
              </p:cNvCxnSpPr>
              <p:nvPr/>
            </p:nvCxnSpPr>
            <p:spPr>
              <a:xfrm>
                <a:off x="2602977" y="2602522"/>
                <a:ext cx="122287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7" name="组合 126">
              <a:extLst>
                <a:ext uri="{FF2B5EF4-FFF2-40B4-BE49-F238E27FC236}">
                  <a16:creationId xmlns:a16="http://schemas.microsoft.com/office/drawing/2014/main" id="{8043A624-820D-BB37-7F85-9C0EDEEF3881}"/>
                </a:ext>
              </a:extLst>
            </p:cNvPr>
            <p:cNvGrpSpPr/>
            <p:nvPr/>
          </p:nvGrpSpPr>
          <p:grpSpPr>
            <a:xfrm>
              <a:off x="3142706" y="3828593"/>
              <a:ext cx="1028669" cy="266094"/>
              <a:chOff x="4088099" y="4206123"/>
              <a:chExt cx="1028669" cy="266094"/>
            </a:xfrm>
          </p:grpSpPr>
          <p:sp>
            <p:nvSpPr>
              <p:cNvPr id="1856" name="rc28">
                <a:extLst>
                  <a:ext uri="{FF2B5EF4-FFF2-40B4-BE49-F238E27FC236}">
                    <a16:creationId xmlns:a16="http://schemas.microsoft.com/office/drawing/2014/main" id="{A349D3BC-DC3F-1A5F-2266-01160D87D652}"/>
                  </a:ext>
                </a:extLst>
              </p:cNvPr>
              <p:cNvSpPr/>
              <p:nvPr/>
            </p:nvSpPr>
            <p:spPr>
              <a:xfrm>
                <a:off x="4104667" y="4206123"/>
                <a:ext cx="1012101" cy="186606"/>
              </a:xfrm>
              <a:prstGeom prst="rect">
                <a:avLst/>
              </a:prstGeom>
              <a:solidFill>
                <a:srgbClr val="FFFFFF">
                  <a:alpha val="100000"/>
                </a:srgbClr>
              </a:solidFill>
            </p:spPr>
            <p:txBody>
              <a:bodyPr/>
              <a:lstStyle/>
              <a:p>
                <a:r>
                  <a:rPr lang="en-US" sz="700" dirty="0">
                    <a:latin typeface="Arial" panose="020B0604020202020204" pitchFamily="34" charset="0"/>
                    <a:cs typeface="Arial" panose="020B0604020202020204" pitchFamily="34" charset="0"/>
                  </a:rPr>
                  <a:t>No response (n=27)</a:t>
                </a:r>
                <a:endParaRPr sz="700" dirty="0">
                  <a:latin typeface="Arial" panose="020B0604020202020204" pitchFamily="34" charset="0"/>
                  <a:cs typeface="Arial" panose="020B0604020202020204" pitchFamily="34" charset="0"/>
                </a:endParaRPr>
              </a:p>
            </p:txBody>
          </p:sp>
          <p:sp>
            <p:nvSpPr>
              <p:cNvPr id="1857" name="rc30">
                <a:extLst>
                  <a:ext uri="{FF2B5EF4-FFF2-40B4-BE49-F238E27FC236}">
                    <a16:creationId xmlns:a16="http://schemas.microsoft.com/office/drawing/2014/main" id="{BBE7777B-DF0D-32A6-4EEA-77FCD124D2B9}"/>
                  </a:ext>
                </a:extLst>
              </p:cNvPr>
              <p:cNvSpPr/>
              <p:nvPr/>
            </p:nvSpPr>
            <p:spPr>
              <a:xfrm>
                <a:off x="4088099" y="4272068"/>
                <a:ext cx="67416" cy="67416"/>
              </a:xfrm>
              <a:prstGeom prst="rect">
                <a:avLst/>
              </a:prstGeom>
              <a:solidFill>
                <a:srgbClr val="21908C">
                  <a:alpha val="100000"/>
                </a:srgbClr>
              </a:solidFill>
            </p:spPr>
            <p:txBody>
              <a:bodyPr/>
              <a:lstStyle/>
              <a:p>
                <a:endParaRPr sz="700">
                  <a:latin typeface="Arial" panose="020B0604020202020204" pitchFamily="34" charset="0"/>
                  <a:cs typeface="Arial" panose="020B0604020202020204" pitchFamily="34" charset="0"/>
                </a:endParaRPr>
              </a:p>
            </p:txBody>
          </p:sp>
          <p:sp>
            <p:nvSpPr>
              <p:cNvPr id="1858" name="rc31">
                <a:extLst>
                  <a:ext uri="{FF2B5EF4-FFF2-40B4-BE49-F238E27FC236}">
                    <a16:creationId xmlns:a16="http://schemas.microsoft.com/office/drawing/2014/main" id="{7AEB62E7-C83E-3C6E-175C-602F7A76A0FD}"/>
                  </a:ext>
                </a:extLst>
              </p:cNvPr>
              <p:cNvSpPr/>
              <p:nvPr/>
            </p:nvSpPr>
            <p:spPr>
              <a:xfrm>
                <a:off x="4088099" y="4355636"/>
                <a:ext cx="67416" cy="67416"/>
              </a:xfrm>
              <a:prstGeom prst="rect">
                <a:avLst/>
              </a:prstGeom>
              <a:solidFill>
                <a:srgbClr val="FDE725">
                  <a:alpha val="100000"/>
                </a:srgbClr>
              </a:solidFill>
            </p:spPr>
            <p:txBody>
              <a:bodyPr/>
              <a:lstStyle/>
              <a:p>
                <a:endParaRPr sz="700">
                  <a:latin typeface="Arial" panose="020B0604020202020204" pitchFamily="34" charset="0"/>
                  <a:cs typeface="Arial" panose="020B0604020202020204" pitchFamily="34" charset="0"/>
                </a:endParaRPr>
              </a:p>
            </p:txBody>
          </p:sp>
          <p:sp>
            <p:nvSpPr>
              <p:cNvPr id="1859" name="rc28">
                <a:extLst>
                  <a:ext uri="{FF2B5EF4-FFF2-40B4-BE49-F238E27FC236}">
                    <a16:creationId xmlns:a16="http://schemas.microsoft.com/office/drawing/2014/main" id="{1DE75BDD-84BB-AC22-A7C6-43D6A49DDB2F}"/>
                  </a:ext>
                </a:extLst>
              </p:cNvPr>
              <p:cNvSpPr/>
              <p:nvPr/>
            </p:nvSpPr>
            <p:spPr>
              <a:xfrm>
                <a:off x="4104667" y="4285611"/>
                <a:ext cx="909285" cy="186606"/>
              </a:xfrm>
              <a:prstGeom prst="rect">
                <a:avLst/>
              </a:prstGeom>
              <a:noFill/>
            </p:spPr>
            <p:txBody>
              <a:bodyPr/>
              <a:lstStyle/>
              <a:p>
                <a:r>
                  <a:rPr lang="en-US" sz="700" dirty="0">
                    <a:latin typeface="Arial" panose="020B0604020202020204" pitchFamily="34" charset="0"/>
                    <a:cs typeface="Arial" panose="020B0604020202020204" pitchFamily="34" charset="0"/>
                  </a:rPr>
                  <a:t>Response (n=20)</a:t>
                </a:r>
              </a:p>
            </p:txBody>
          </p:sp>
        </p:grpSp>
      </p:grpSp>
      <p:cxnSp>
        <p:nvCxnSpPr>
          <p:cNvPr id="1860" name="直接连接符 1859">
            <a:extLst>
              <a:ext uri="{FF2B5EF4-FFF2-40B4-BE49-F238E27FC236}">
                <a16:creationId xmlns:a16="http://schemas.microsoft.com/office/drawing/2014/main" id="{3383D868-86DF-5865-193A-571BFCE8B4D3}"/>
              </a:ext>
            </a:extLst>
          </p:cNvPr>
          <p:cNvCxnSpPr>
            <a:cxnSpLocks/>
          </p:cNvCxnSpPr>
          <p:nvPr/>
        </p:nvCxnSpPr>
        <p:spPr>
          <a:xfrm flipH="1">
            <a:off x="317356" y="882618"/>
            <a:ext cx="6014082" cy="0"/>
          </a:xfrm>
          <a:prstGeom prst="line">
            <a:avLst/>
          </a:prstGeom>
        </p:spPr>
        <p:style>
          <a:lnRef idx="1">
            <a:schemeClr val="dk1"/>
          </a:lnRef>
          <a:fillRef idx="0">
            <a:schemeClr val="dk1"/>
          </a:fillRef>
          <a:effectRef idx="0">
            <a:schemeClr val="dk1"/>
          </a:effectRef>
          <a:fontRef idx="minor">
            <a:schemeClr val="tx1"/>
          </a:fontRef>
        </p:style>
      </p:cxnSp>
      <p:sp>
        <p:nvSpPr>
          <p:cNvPr id="1861" name="文本框 1860">
            <a:extLst>
              <a:ext uri="{FF2B5EF4-FFF2-40B4-BE49-F238E27FC236}">
                <a16:creationId xmlns:a16="http://schemas.microsoft.com/office/drawing/2014/main" id="{5C73A117-8435-9F94-7AA3-AA530FF7B1C2}"/>
              </a:ext>
            </a:extLst>
          </p:cNvPr>
          <p:cNvSpPr txBox="1"/>
          <p:nvPr/>
        </p:nvSpPr>
        <p:spPr>
          <a:xfrm>
            <a:off x="2681344" y="655222"/>
            <a:ext cx="121573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TX+LEF</a:t>
            </a:r>
            <a:endParaRPr lang="zh-CN" altLang="en-US" sz="800" dirty="0">
              <a:latin typeface="Arial" panose="020B0604020202020204" pitchFamily="34" charset="0"/>
              <a:cs typeface="Arial" panose="020B0604020202020204" pitchFamily="34" charset="0"/>
            </a:endParaRPr>
          </a:p>
        </p:txBody>
      </p:sp>
      <p:cxnSp>
        <p:nvCxnSpPr>
          <p:cNvPr id="1862" name="直接连接符 1861">
            <a:extLst>
              <a:ext uri="{FF2B5EF4-FFF2-40B4-BE49-F238E27FC236}">
                <a16:creationId xmlns:a16="http://schemas.microsoft.com/office/drawing/2014/main" id="{2B7B2C8F-B676-FBF2-8A19-6F7B8D9D7057}"/>
              </a:ext>
            </a:extLst>
          </p:cNvPr>
          <p:cNvCxnSpPr>
            <a:cxnSpLocks/>
          </p:cNvCxnSpPr>
          <p:nvPr/>
        </p:nvCxnSpPr>
        <p:spPr>
          <a:xfrm flipH="1">
            <a:off x="317356" y="3180643"/>
            <a:ext cx="6014082" cy="0"/>
          </a:xfrm>
          <a:prstGeom prst="line">
            <a:avLst/>
          </a:prstGeom>
        </p:spPr>
        <p:style>
          <a:lnRef idx="1">
            <a:schemeClr val="dk1"/>
          </a:lnRef>
          <a:fillRef idx="0">
            <a:schemeClr val="dk1"/>
          </a:fillRef>
          <a:effectRef idx="0">
            <a:schemeClr val="dk1"/>
          </a:effectRef>
          <a:fontRef idx="minor">
            <a:schemeClr val="tx1"/>
          </a:fontRef>
        </p:style>
      </p:cxnSp>
      <p:sp>
        <p:nvSpPr>
          <p:cNvPr id="1863" name="文本框 1862">
            <a:extLst>
              <a:ext uri="{FF2B5EF4-FFF2-40B4-BE49-F238E27FC236}">
                <a16:creationId xmlns:a16="http://schemas.microsoft.com/office/drawing/2014/main" id="{78DCA6D8-1775-C3E1-7BBB-AB117396361B}"/>
              </a:ext>
            </a:extLst>
          </p:cNvPr>
          <p:cNvSpPr txBox="1"/>
          <p:nvPr/>
        </p:nvSpPr>
        <p:spPr>
          <a:xfrm>
            <a:off x="2681344" y="2953247"/>
            <a:ext cx="121573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TX+HCQ</a:t>
            </a:r>
            <a:endParaRPr lang="zh-CN" altLang="en-US"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281184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文本框 10">
            <a:extLst>
              <a:ext uri="{FF2B5EF4-FFF2-40B4-BE49-F238E27FC236}">
                <a16:creationId xmlns:a16="http://schemas.microsoft.com/office/drawing/2014/main" id="{2FBB1810-8D7D-D2F2-9B6A-E366CFEB8E97}"/>
              </a:ext>
            </a:extLst>
          </p:cNvPr>
          <p:cNvSpPr txBox="1"/>
          <p:nvPr/>
        </p:nvSpPr>
        <p:spPr>
          <a:xfrm>
            <a:off x="307329" y="306727"/>
            <a:ext cx="6243342" cy="2002279"/>
          </a:xfrm>
          <a:prstGeom prst="rect">
            <a:avLst/>
          </a:prstGeom>
          <a:noFill/>
        </p:spPr>
        <p:txBody>
          <a:bodyPr wrap="square">
            <a:spAutoFit/>
          </a:bodyPr>
          <a:lstStyle/>
          <a:p>
            <a:pPr algn="just">
              <a:lnSpc>
                <a:spcPct val="150000"/>
              </a:lnSpc>
            </a:pPr>
            <a:r>
              <a:rPr lang="en-US" altLang="zh-CN" sz="1050" dirty="0">
                <a:latin typeface="Times New Roman" panose="02020603050405020304" pitchFamily="18" charset="0"/>
                <a:cs typeface="Times New Roman" panose="02020603050405020304" pitchFamily="18" charset="0"/>
              </a:rPr>
              <a:t>Figure S1. Clinical differences between response groups. A) Clinical differences in MTX+LEF group.</a:t>
            </a:r>
            <a:r>
              <a:rPr lang="zh-CN" altLang="en-US" sz="1050" dirty="0">
                <a:latin typeface="Times New Roman" panose="02020603050405020304" pitchFamily="18" charset="0"/>
                <a:cs typeface="Times New Roman" panose="02020603050405020304" pitchFamily="18" charset="0"/>
              </a:rPr>
              <a:t> </a:t>
            </a:r>
            <a:r>
              <a:rPr lang="en-US" altLang="zh-CN" sz="1050" dirty="0">
                <a:latin typeface="Times New Roman" panose="02020603050405020304" pitchFamily="18" charset="0"/>
                <a:cs typeface="Times New Roman" panose="02020603050405020304" pitchFamily="18" charset="0"/>
              </a:rPr>
              <a:t>Left: Age distribution (median with interquartile range), Middle: Sex proportion, and Right: The comparison of DAS28-CRP parameters between treatment non-responders (green, n=43) and responders (yellow, n=30) in the MTX+LEF group. B) Clinical differences in MTX+HCQ group. Left: Age distribution (median with interquartile range), Middle: Sex proportion, and Right: The comparison of DAS28-CRP parameters between treatment non-responders (green, n=27) and responders (yellow, n=20) in the MTX+HCQ group. Statistical significance was determined by Wilcoxon test (for continuous variables: age, DAS28-CRP parameters) and Chi-squared test (for categorical variable: sex). </a:t>
            </a:r>
          </a:p>
        </p:txBody>
      </p:sp>
    </p:spTree>
    <p:extLst>
      <p:ext uri="{BB962C8B-B14F-4D97-AF65-F5344CB8AC3E}">
        <p14:creationId xmlns:p14="http://schemas.microsoft.com/office/powerpoint/2010/main" val="36036319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形 4">
            <a:extLst>
              <a:ext uri="{FF2B5EF4-FFF2-40B4-BE49-F238E27FC236}">
                <a16:creationId xmlns:a16="http://schemas.microsoft.com/office/drawing/2014/main" id="{915C17F5-6EA0-F2CC-ED40-14F4D273110D}"/>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53625" y="4476998"/>
            <a:ext cx="2808000" cy="1383943"/>
          </a:xfrm>
          <a:prstGeom prst="rect">
            <a:avLst/>
          </a:prstGeom>
        </p:spPr>
      </p:pic>
      <p:pic>
        <p:nvPicPr>
          <p:cNvPr id="7" name="图形 6">
            <a:extLst>
              <a:ext uri="{FF2B5EF4-FFF2-40B4-BE49-F238E27FC236}">
                <a16:creationId xmlns:a16="http://schemas.microsoft.com/office/drawing/2014/main" id="{07F05A4E-0CE2-0B4C-7484-6090F60440C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429000" y="4018529"/>
            <a:ext cx="2808000" cy="1874162"/>
          </a:xfrm>
          <a:prstGeom prst="rect">
            <a:avLst/>
          </a:prstGeom>
        </p:spPr>
      </p:pic>
      <p:pic>
        <p:nvPicPr>
          <p:cNvPr id="461" name="图形 460">
            <a:extLst>
              <a:ext uri="{FF2B5EF4-FFF2-40B4-BE49-F238E27FC236}">
                <a16:creationId xmlns:a16="http://schemas.microsoft.com/office/drawing/2014/main" id="{8C006607-D1EF-1E0E-0822-123B0F86D9D0}"/>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5308911" y="2697995"/>
            <a:ext cx="1275685" cy="1191671"/>
          </a:xfrm>
          <a:prstGeom prst="rect">
            <a:avLst/>
          </a:prstGeom>
        </p:spPr>
      </p:pic>
      <p:pic>
        <p:nvPicPr>
          <p:cNvPr id="459" name="图形 458">
            <a:extLst>
              <a:ext uri="{FF2B5EF4-FFF2-40B4-BE49-F238E27FC236}">
                <a16:creationId xmlns:a16="http://schemas.microsoft.com/office/drawing/2014/main" id="{9B66F922-BCBA-1DF7-41ED-AB6CFD926418}"/>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3491480" y="2675749"/>
            <a:ext cx="1532903" cy="1440000"/>
          </a:xfrm>
          <a:prstGeom prst="rect">
            <a:avLst/>
          </a:prstGeom>
        </p:spPr>
      </p:pic>
      <p:pic>
        <p:nvPicPr>
          <p:cNvPr id="451" name="图形 450">
            <a:extLst>
              <a:ext uri="{FF2B5EF4-FFF2-40B4-BE49-F238E27FC236}">
                <a16:creationId xmlns:a16="http://schemas.microsoft.com/office/drawing/2014/main" id="{A1B713F1-0A6B-D72B-492C-F8A19D066F2E}"/>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361392" y="2686210"/>
            <a:ext cx="1577143" cy="1440000"/>
          </a:xfrm>
          <a:prstGeom prst="rect">
            <a:avLst/>
          </a:prstGeom>
        </p:spPr>
      </p:pic>
      <p:sp>
        <p:nvSpPr>
          <p:cNvPr id="269" name="文本框 268">
            <a:extLst>
              <a:ext uri="{FF2B5EF4-FFF2-40B4-BE49-F238E27FC236}">
                <a16:creationId xmlns:a16="http://schemas.microsoft.com/office/drawing/2014/main" id="{A2D1EE43-64EE-AC25-E8E2-6CD3842C24C2}"/>
              </a:ext>
            </a:extLst>
          </p:cNvPr>
          <p:cNvSpPr txBox="1"/>
          <p:nvPr/>
        </p:nvSpPr>
        <p:spPr>
          <a:xfrm>
            <a:off x="654356" y="2710557"/>
            <a:ext cx="381836"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Train </a:t>
            </a:r>
            <a:endParaRPr lang="zh-CN" altLang="en-US" sz="600" dirty="0">
              <a:latin typeface="Arial" panose="020B0604020202020204" pitchFamily="34" charset="0"/>
              <a:cs typeface="Arial" panose="020B0604020202020204" pitchFamily="34" charset="0"/>
            </a:endParaRPr>
          </a:p>
        </p:txBody>
      </p:sp>
      <p:sp>
        <p:nvSpPr>
          <p:cNvPr id="270" name="文本框 269">
            <a:extLst>
              <a:ext uri="{FF2B5EF4-FFF2-40B4-BE49-F238E27FC236}">
                <a16:creationId xmlns:a16="http://schemas.microsoft.com/office/drawing/2014/main" id="{5039EDFB-6C45-19EE-6DE1-EB18C6716699}"/>
              </a:ext>
            </a:extLst>
          </p:cNvPr>
          <p:cNvSpPr txBox="1"/>
          <p:nvPr/>
        </p:nvSpPr>
        <p:spPr>
          <a:xfrm>
            <a:off x="945876" y="2710557"/>
            <a:ext cx="333746"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Test</a:t>
            </a:r>
          </a:p>
        </p:txBody>
      </p:sp>
      <p:pic>
        <p:nvPicPr>
          <p:cNvPr id="42" name="图形 41">
            <a:extLst>
              <a:ext uri="{FF2B5EF4-FFF2-40B4-BE49-F238E27FC236}">
                <a16:creationId xmlns:a16="http://schemas.microsoft.com/office/drawing/2014/main" id="{1BED7E5E-C141-010A-35E7-DCAED9DF376B}"/>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5270810" y="6281403"/>
            <a:ext cx="1142834" cy="1095273"/>
          </a:xfrm>
          <a:prstGeom prst="rect">
            <a:avLst/>
          </a:prstGeom>
        </p:spPr>
      </p:pic>
      <p:pic>
        <p:nvPicPr>
          <p:cNvPr id="11" name="图形 10">
            <a:extLst>
              <a:ext uri="{FF2B5EF4-FFF2-40B4-BE49-F238E27FC236}">
                <a16:creationId xmlns:a16="http://schemas.microsoft.com/office/drawing/2014/main" id="{BDD381F6-9622-8851-C421-0C6B1E46A595}"/>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3429000" y="7466282"/>
            <a:ext cx="2808000" cy="1874162"/>
          </a:xfrm>
          <a:prstGeom prst="rect">
            <a:avLst/>
          </a:prstGeom>
        </p:spPr>
      </p:pic>
      <p:sp>
        <p:nvSpPr>
          <p:cNvPr id="39" name="文本框 38">
            <a:extLst>
              <a:ext uri="{FF2B5EF4-FFF2-40B4-BE49-F238E27FC236}">
                <a16:creationId xmlns:a16="http://schemas.microsoft.com/office/drawing/2014/main" id="{6D573D7A-C28C-4F0C-9DF7-02DA5EEDE1CE}"/>
              </a:ext>
            </a:extLst>
          </p:cNvPr>
          <p:cNvSpPr txBox="1"/>
          <p:nvPr/>
        </p:nvSpPr>
        <p:spPr>
          <a:xfrm>
            <a:off x="5730302" y="3939437"/>
            <a:ext cx="593204" cy="184004"/>
          </a:xfrm>
          <a:prstGeom prst="rect">
            <a:avLst/>
          </a:prstGeom>
          <a:noFill/>
        </p:spPr>
        <p:txBody>
          <a:bodyPr wrap="none" rtlCol="0">
            <a:spAutoFit/>
          </a:bodyPr>
          <a:lstStyle/>
          <a:p>
            <a:pPr algn="ctr"/>
            <a:r>
              <a:rPr lang="en-US" altLang="zh-CN" sz="600" dirty="0">
                <a:latin typeface="Arial" panose="020B0604020202020204" pitchFamily="34" charset="0"/>
                <a:cs typeface="Arial" panose="020B0604020202020204" pitchFamily="34" charset="0"/>
              </a:rPr>
              <a:t>Coefficients</a:t>
            </a:r>
            <a:endParaRPr lang="zh-CN" altLang="en-US" sz="600" dirty="0">
              <a:latin typeface="Arial" panose="020B0604020202020204" pitchFamily="34" charset="0"/>
              <a:cs typeface="Arial" panose="020B0604020202020204" pitchFamily="34" charset="0"/>
            </a:endParaRPr>
          </a:p>
        </p:txBody>
      </p:sp>
      <p:sp>
        <p:nvSpPr>
          <p:cNvPr id="45" name="文本框 44">
            <a:extLst>
              <a:ext uri="{FF2B5EF4-FFF2-40B4-BE49-F238E27FC236}">
                <a16:creationId xmlns:a16="http://schemas.microsoft.com/office/drawing/2014/main" id="{3981FCE0-73D9-4B0A-5BED-882053B564CA}"/>
              </a:ext>
            </a:extLst>
          </p:cNvPr>
          <p:cNvSpPr txBox="1"/>
          <p:nvPr/>
        </p:nvSpPr>
        <p:spPr>
          <a:xfrm>
            <a:off x="5300065" y="3841458"/>
            <a:ext cx="33534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00</a:t>
            </a:r>
            <a:endParaRPr lang="zh-CN" altLang="en-US" sz="600" dirty="0">
              <a:latin typeface="Arial" panose="020B0604020202020204" pitchFamily="34" charset="0"/>
              <a:cs typeface="Arial" panose="020B0604020202020204" pitchFamily="34" charset="0"/>
            </a:endParaRPr>
          </a:p>
        </p:txBody>
      </p:sp>
      <p:sp>
        <p:nvSpPr>
          <p:cNvPr id="46" name="文本框 45">
            <a:extLst>
              <a:ext uri="{FF2B5EF4-FFF2-40B4-BE49-F238E27FC236}">
                <a16:creationId xmlns:a16="http://schemas.microsoft.com/office/drawing/2014/main" id="{0621259A-BAB5-7C2F-799A-2A6808555443}"/>
              </a:ext>
            </a:extLst>
          </p:cNvPr>
          <p:cNvSpPr txBox="1"/>
          <p:nvPr/>
        </p:nvSpPr>
        <p:spPr>
          <a:xfrm>
            <a:off x="6010466" y="3841458"/>
            <a:ext cx="33534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10</a:t>
            </a:r>
            <a:endParaRPr lang="zh-CN" altLang="en-US" sz="600" dirty="0">
              <a:latin typeface="Arial" panose="020B0604020202020204" pitchFamily="34" charset="0"/>
              <a:cs typeface="Arial" panose="020B0604020202020204" pitchFamily="34" charset="0"/>
            </a:endParaRPr>
          </a:p>
        </p:txBody>
      </p:sp>
      <p:sp>
        <p:nvSpPr>
          <p:cNvPr id="47" name="文本框 46">
            <a:extLst>
              <a:ext uri="{FF2B5EF4-FFF2-40B4-BE49-F238E27FC236}">
                <a16:creationId xmlns:a16="http://schemas.microsoft.com/office/drawing/2014/main" id="{62401D16-9F19-DACF-3D03-A4B0B62EC39D}"/>
              </a:ext>
            </a:extLst>
          </p:cNvPr>
          <p:cNvSpPr txBox="1"/>
          <p:nvPr/>
        </p:nvSpPr>
        <p:spPr>
          <a:xfrm>
            <a:off x="6369860" y="3841458"/>
            <a:ext cx="33534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15</a:t>
            </a:r>
            <a:endParaRPr lang="zh-CN" altLang="en-US" sz="600" dirty="0">
              <a:latin typeface="Arial" panose="020B0604020202020204" pitchFamily="34" charset="0"/>
              <a:cs typeface="Arial" panose="020B0604020202020204" pitchFamily="34" charset="0"/>
            </a:endParaRPr>
          </a:p>
        </p:txBody>
      </p:sp>
      <p:grpSp>
        <p:nvGrpSpPr>
          <p:cNvPr id="462" name="组合 461">
            <a:extLst>
              <a:ext uri="{FF2B5EF4-FFF2-40B4-BE49-F238E27FC236}">
                <a16:creationId xmlns:a16="http://schemas.microsoft.com/office/drawing/2014/main" id="{B5F3B8FF-9405-FC77-1667-C371E352D6DF}"/>
              </a:ext>
            </a:extLst>
          </p:cNvPr>
          <p:cNvGrpSpPr/>
          <p:nvPr/>
        </p:nvGrpSpPr>
        <p:grpSpPr>
          <a:xfrm>
            <a:off x="5054653" y="3084968"/>
            <a:ext cx="307674" cy="713314"/>
            <a:chOff x="5104450" y="2183044"/>
            <a:chExt cx="307674" cy="781344"/>
          </a:xfrm>
        </p:grpSpPr>
        <p:sp>
          <p:nvSpPr>
            <p:cNvPr id="48" name="文本框 47">
              <a:extLst>
                <a:ext uri="{FF2B5EF4-FFF2-40B4-BE49-F238E27FC236}">
                  <a16:creationId xmlns:a16="http://schemas.microsoft.com/office/drawing/2014/main" id="{C2C4EE3C-190A-F174-72D7-4207FD37E235}"/>
                </a:ext>
              </a:extLst>
            </p:cNvPr>
            <p:cNvSpPr txBox="1"/>
            <p:nvPr/>
          </p:nvSpPr>
          <p:spPr>
            <a:xfrm>
              <a:off x="5104450" y="2183044"/>
              <a:ext cx="307674"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VAS</a:t>
              </a:r>
              <a:endParaRPr lang="zh-CN" altLang="en-US" sz="600" dirty="0">
                <a:latin typeface="Arial" panose="020B0604020202020204" pitchFamily="34" charset="0"/>
                <a:cs typeface="Arial" panose="020B0604020202020204" pitchFamily="34" charset="0"/>
              </a:endParaRPr>
            </a:p>
          </p:txBody>
        </p:sp>
        <p:sp>
          <p:nvSpPr>
            <p:cNvPr id="49" name="文本框 48">
              <a:extLst>
                <a:ext uri="{FF2B5EF4-FFF2-40B4-BE49-F238E27FC236}">
                  <a16:creationId xmlns:a16="http://schemas.microsoft.com/office/drawing/2014/main" id="{F75EE104-A8BF-8AD9-C9BE-A22F4C04BC67}"/>
                </a:ext>
              </a:extLst>
            </p:cNvPr>
            <p:cNvSpPr txBox="1"/>
            <p:nvPr/>
          </p:nvSpPr>
          <p:spPr>
            <a:xfrm>
              <a:off x="5104450" y="2481383"/>
              <a:ext cx="296019"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TJC</a:t>
              </a:r>
              <a:endParaRPr lang="zh-CN" altLang="en-US" sz="600" dirty="0">
                <a:latin typeface="Arial" panose="020B0604020202020204" pitchFamily="34" charset="0"/>
                <a:cs typeface="Arial" panose="020B0604020202020204" pitchFamily="34" charset="0"/>
              </a:endParaRPr>
            </a:p>
          </p:txBody>
        </p:sp>
        <p:sp>
          <p:nvSpPr>
            <p:cNvPr id="50" name="文本框 49">
              <a:extLst>
                <a:ext uri="{FF2B5EF4-FFF2-40B4-BE49-F238E27FC236}">
                  <a16:creationId xmlns:a16="http://schemas.microsoft.com/office/drawing/2014/main" id="{7157166A-5732-3CCC-53B9-B72DFDE94FC5}"/>
                </a:ext>
              </a:extLst>
            </p:cNvPr>
            <p:cNvSpPr txBox="1"/>
            <p:nvPr/>
          </p:nvSpPr>
          <p:spPr>
            <a:xfrm>
              <a:off x="5104450" y="2779722"/>
              <a:ext cx="300390"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SJC</a:t>
              </a:r>
              <a:endParaRPr lang="zh-CN" altLang="en-US" sz="600" dirty="0">
                <a:latin typeface="Arial" panose="020B0604020202020204" pitchFamily="34" charset="0"/>
                <a:cs typeface="Arial" panose="020B0604020202020204" pitchFamily="34" charset="0"/>
              </a:endParaRPr>
            </a:p>
          </p:txBody>
        </p:sp>
      </p:grpSp>
      <p:pic>
        <p:nvPicPr>
          <p:cNvPr id="268" name="图形 267">
            <a:extLst>
              <a:ext uri="{FF2B5EF4-FFF2-40B4-BE49-F238E27FC236}">
                <a16:creationId xmlns:a16="http://schemas.microsoft.com/office/drawing/2014/main" id="{74954FD6-7983-8325-4934-68722D1B37C7}"/>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627773" y="2750258"/>
            <a:ext cx="402476" cy="105264"/>
          </a:xfrm>
          <a:prstGeom prst="rect">
            <a:avLst/>
          </a:prstGeom>
        </p:spPr>
      </p:pic>
      <p:cxnSp>
        <p:nvCxnSpPr>
          <p:cNvPr id="484" name="直接连接符 483">
            <a:extLst>
              <a:ext uri="{FF2B5EF4-FFF2-40B4-BE49-F238E27FC236}">
                <a16:creationId xmlns:a16="http://schemas.microsoft.com/office/drawing/2014/main" id="{0783DEAA-898D-B011-F904-BB8D43B90456}"/>
              </a:ext>
            </a:extLst>
          </p:cNvPr>
          <p:cNvCxnSpPr>
            <a:cxnSpLocks/>
          </p:cNvCxnSpPr>
          <p:nvPr/>
        </p:nvCxnSpPr>
        <p:spPr>
          <a:xfrm flipH="1">
            <a:off x="407266" y="6091466"/>
            <a:ext cx="6115897" cy="0"/>
          </a:xfrm>
          <a:prstGeom prst="line">
            <a:avLst/>
          </a:prstGeom>
        </p:spPr>
        <p:style>
          <a:lnRef idx="1">
            <a:schemeClr val="dk1"/>
          </a:lnRef>
          <a:fillRef idx="0">
            <a:schemeClr val="dk1"/>
          </a:fillRef>
          <a:effectRef idx="0">
            <a:schemeClr val="dk1"/>
          </a:effectRef>
          <a:fontRef idx="minor">
            <a:schemeClr val="tx1"/>
          </a:fontRef>
        </p:style>
      </p:cxnSp>
      <p:cxnSp>
        <p:nvCxnSpPr>
          <p:cNvPr id="486" name="直接连接符 485">
            <a:extLst>
              <a:ext uri="{FF2B5EF4-FFF2-40B4-BE49-F238E27FC236}">
                <a16:creationId xmlns:a16="http://schemas.microsoft.com/office/drawing/2014/main" id="{5444B8F0-D2A8-AFDB-ACDA-E07C9FDBBDA1}"/>
              </a:ext>
            </a:extLst>
          </p:cNvPr>
          <p:cNvCxnSpPr>
            <a:cxnSpLocks/>
          </p:cNvCxnSpPr>
          <p:nvPr/>
        </p:nvCxnSpPr>
        <p:spPr>
          <a:xfrm flipH="1">
            <a:off x="345833" y="2577521"/>
            <a:ext cx="6238763" cy="0"/>
          </a:xfrm>
          <a:prstGeom prst="line">
            <a:avLst/>
          </a:prstGeom>
        </p:spPr>
        <p:style>
          <a:lnRef idx="1">
            <a:schemeClr val="dk1"/>
          </a:lnRef>
          <a:fillRef idx="0">
            <a:schemeClr val="dk1"/>
          </a:fillRef>
          <a:effectRef idx="0">
            <a:schemeClr val="dk1"/>
          </a:effectRef>
          <a:fontRef idx="minor">
            <a:schemeClr val="tx1"/>
          </a:fontRef>
        </p:style>
      </p:cxnSp>
      <p:sp>
        <p:nvSpPr>
          <p:cNvPr id="20" name="文本框 19">
            <a:extLst>
              <a:ext uri="{FF2B5EF4-FFF2-40B4-BE49-F238E27FC236}">
                <a16:creationId xmlns:a16="http://schemas.microsoft.com/office/drawing/2014/main" id="{79946EFD-9460-77DD-0BBD-E6C382DEE59D}"/>
              </a:ext>
            </a:extLst>
          </p:cNvPr>
          <p:cNvSpPr txBox="1"/>
          <p:nvPr/>
        </p:nvSpPr>
        <p:spPr>
          <a:xfrm>
            <a:off x="1785334" y="2374789"/>
            <a:ext cx="3359760"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TX+LEF Response Model: 3 Clinical Predictors</a:t>
            </a:r>
          </a:p>
        </p:txBody>
      </p:sp>
      <p:sp>
        <p:nvSpPr>
          <p:cNvPr id="212" name="文本框 211">
            <a:extLst>
              <a:ext uri="{FF2B5EF4-FFF2-40B4-BE49-F238E27FC236}">
                <a16:creationId xmlns:a16="http://schemas.microsoft.com/office/drawing/2014/main" id="{2A054C93-4427-7A9C-5E7B-E91E5CC5577B}"/>
              </a:ext>
            </a:extLst>
          </p:cNvPr>
          <p:cNvSpPr txBox="1"/>
          <p:nvPr/>
        </p:nvSpPr>
        <p:spPr>
          <a:xfrm>
            <a:off x="5007064" y="6759379"/>
            <a:ext cx="307674"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VAS</a:t>
            </a:r>
            <a:endParaRPr lang="zh-CN" altLang="en-US" sz="600" dirty="0">
              <a:latin typeface="Arial" panose="020B0604020202020204" pitchFamily="34" charset="0"/>
              <a:cs typeface="Arial" panose="020B0604020202020204" pitchFamily="34" charset="0"/>
            </a:endParaRPr>
          </a:p>
        </p:txBody>
      </p:sp>
      <p:sp>
        <p:nvSpPr>
          <p:cNvPr id="213" name="文本框 212">
            <a:extLst>
              <a:ext uri="{FF2B5EF4-FFF2-40B4-BE49-F238E27FC236}">
                <a16:creationId xmlns:a16="http://schemas.microsoft.com/office/drawing/2014/main" id="{F98EBAC3-EF8F-27DB-65A2-9A57A6BF8AC3}"/>
              </a:ext>
            </a:extLst>
          </p:cNvPr>
          <p:cNvSpPr txBox="1"/>
          <p:nvPr/>
        </p:nvSpPr>
        <p:spPr>
          <a:xfrm>
            <a:off x="5012892" y="7077917"/>
            <a:ext cx="296019"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TJC</a:t>
            </a:r>
            <a:endParaRPr lang="zh-CN" altLang="en-US" sz="600" dirty="0">
              <a:latin typeface="Arial" panose="020B0604020202020204" pitchFamily="34" charset="0"/>
              <a:cs typeface="Arial" panose="020B0604020202020204" pitchFamily="34" charset="0"/>
            </a:endParaRPr>
          </a:p>
        </p:txBody>
      </p:sp>
      <p:sp>
        <p:nvSpPr>
          <p:cNvPr id="214" name="文本框 213">
            <a:extLst>
              <a:ext uri="{FF2B5EF4-FFF2-40B4-BE49-F238E27FC236}">
                <a16:creationId xmlns:a16="http://schemas.microsoft.com/office/drawing/2014/main" id="{AE4F4A0D-8249-637E-51F4-FD9850B86D95}"/>
              </a:ext>
            </a:extLst>
          </p:cNvPr>
          <p:cNvSpPr txBox="1"/>
          <p:nvPr/>
        </p:nvSpPr>
        <p:spPr>
          <a:xfrm>
            <a:off x="5184844" y="7339106"/>
            <a:ext cx="29206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0</a:t>
            </a:r>
            <a:endParaRPr lang="zh-CN" altLang="en-US" sz="600" dirty="0">
              <a:latin typeface="Arial" panose="020B0604020202020204" pitchFamily="34" charset="0"/>
              <a:cs typeface="Arial" panose="020B0604020202020204" pitchFamily="34" charset="0"/>
            </a:endParaRPr>
          </a:p>
        </p:txBody>
      </p:sp>
      <p:sp>
        <p:nvSpPr>
          <p:cNvPr id="215" name="文本框 214">
            <a:extLst>
              <a:ext uri="{FF2B5EF4-FFF2-40B4-BE49-F238E27FC236}">
                <a16:creationId xmlns:a16="http://schemas.microsoft.com/office/drawing/2014/main" id="{15A7ACD9-7626-F7DA-7564-F730C4DC1341}"/>
              </a:ext>
            </a:extLst>
          </p:cNvPr>
          <p:cNvSpPr txBox="1"/>
          <p:nvPr/>
        </p:nvSpPr>
        <p:spPr>
          <a:xfrm>
            <a:off x="5343096" y="7339106"/>
            <a:ext cx="378630"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025</a:t>
            </a:r>
            <a:endParaRPr lang="zh-CN" altLang="en-US" sz="600" dirty="0">
              <a:latin typeface="Arial" panose="020B0604020202020204" pitchFamily="34" charset="0"/>
              <a:cs typeface="Arial" panose="020B0604020202020204" pitchFamily="34" charset="0"/>
            </a:endParaRPr>
          </a:p>
        </p:txBody>
      </p:sp>
      <p:sp>
        <p:nvSpPr>
          <p:cNvPr id="216" name="文本框 215">
            <a:extLst>
              <a:ext uri="{FF2B5EF4-FFF2-40B4-BE49-F238E27FC236}">
                <a16:creationId xmlns:a16="http://schemas.microsoft.com/office/drawing/2014/main" id="{4BCC933C-2C1E-E4D6-BAB8-F8B5AB5F2CCB}"/>
              </a:ext>
            </a:extLst>
          </p:cNvPr>
          <p:cNvSpPr txBox="1"/>
          <p:nvPr/>
        </p:nvSpPr>
        <p:spPr>
          <a:xfrm>
            <a:off x="5789442" y="7339106"/>
            <a:ext cx="378630"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075</a:t>
            </a:r>
            <a:endParaRPr lang="zh-CN" altLang="en-US" sz="600" dirty="0">
              <a:latin typeface="Arial" panose="020B0604020202020204" pitchFamily="34" charset="0"/>
              <a:cs typeface="Arial" panose="020B0604020202020204" pitchFamily="34" charset="0"/>
            </a:endParaRPr>
          </a:p>
        </p:txBody>
      </p:sp>
      <p:sp>
        <p:nvSpPr>
          <p:cNvPr id="237" name="文本框 236">
            <a:extLst>
              <a:ext uri="{FF2B5EF4-FFF2-40B4-BE49-F238E27FC236}">
                <a16:creationId xmlns:a16="http://schemas.microsoft.com/office/drawing/2014/main" id="{2405321E-ACF5-6DC8-40F0-135202667FEB}"/>
              </a:ext>
            </a:extLst>
          </p:cNvPr>
          <p:cNvSpPr txBox="1"/>
          <p:nvPr/>
        </p:nvSpPr>
        <p:spPr>
          <a:xfrm>
            <a:off x="5716587" y="7490595"/>
            <a:ext cx="593204" cy="184004"/>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Coefficients</a:t>
            </a:r>
            <a:endParaRPr lang="zh-CN" altLang="en-US" sz="600" dirty="0">
              <a:latin typeface="Arial" panose="020B0604020202020204" pitchFamily="34" charset="0"/>
              <a:cs typeface="Arial" panose="020B0604020202020204" pitchFamily="34" charset="0"/>
            </a:endParaRPr>
          </a:p>
        </p:txBody>
      </p:sp>
      <p:sp>
        <p:nvSpPr>
          <p:cNvPr id="257" name="文本框 256">
            <a:extLst>
              <a:ext uri="{FF2B5EF4-FFF2-40B4-BE49-F238E27FC236}">
                <a16:creationId xmlns:a16="http://schemas.microsoft.com/office/drawing/2014/main" id="{CF2890B0-6CE5-6A09-4CB1-417559DC5349}"/>
              </a:ext>
            </a:extLst>
          </p:cNvPr>
          <p:cNvSpPr txBox="1"/>
          <p:nvPr/>
        </p:nvSpPr>
        <p:spPr>
          <a:xfrm>
            <a:off x="1988928" y="5897809"/>
            <a:ext cx="2952572"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TX+HCQ Response Model: 2 Clinical Predictors</a:t>
            </a:r>
          </a:p>
        </p:txBody>
      </p:sp>
      <p:sp>
        <p:nvSpPr>
          <p:cNvPr id="2974" name="文本框 2973">
            <a:extLst>
              <a:ext uri="{FF2B5EF4-FFF2-40B4-BE49-F238E27FC236}">
                <a16:creationId xmlns:a16="http://schemas.microsoft.com/office/drawing/2014/main" id="{CAD67347-603D-2F5A-116C-8B4293839901}"/>
              </a:ext>
            </a:extLst>
          </p:cNvPr>
          <p:cNvSpPr txBox="1"/>
          <p:nvPr/>
        </p:nvSpPr>
        <p:spPr>
          <a:xfrm>
            <a:off x="326904" y="2343155"/>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C</a:t>
            </a:r>
            <a:endParaRPr lang="zh-CN" altLang="en-US" sz="1000" dirty="0">
              <a:latin typeface="Arial" panose="020B0604020202020204" pitchFamily="34" charset="0"/>
              <a:cs typeface="Arial" panose="020B0604020202020204" pitchFamily="34" charset="0"/>
            </a:endParaRPr>
          </a:p>
        </p:txBody>
      </p:sp>
      <p:sp>
        <p:nvSpPr>
          <p:cNvPr id="2975" name="文本框 2974">
            <a:extLst>
              <a:ext uri="{FF2B5EF4-FFF2-40B4-BE49-F238E27FC236}">
                <a16:creationId xmlns:a16="http://schemas.microsoft.com/office/drawing/2014/main" id="{37701A9C-86EB-2125-5ADB-66A0EAA3EC5E}"/>
              </a:ext>
            </a:extLst>
          </p:cNvPr>
          <p:cNvSpPr txBox="1"/>
          <p:nvPr/>
        </p:nvSpPr>
        <p:spPr>
          <a:xfrm>
            <a:off x="326904" y="4177776"/>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D</a:t>
            </a:r>
            <a:endParaRPr lang="zh-CN" altLang="en-US" sz="1000" dirty="0">
              <a:latin typeface="Arial" panose="020B0604020202020204" pitchFamily="34" charset="0"/>
              <a:cs typeface="Arial" panose="020B0604020202020204" pitchFamily="34" charset="0"/>
            </a:endParaRPr>
          </a:p>
        </p:txBody>
      </p:sp>
      <p:pic>
        <p:nvPicPr>
          <p:cNvPr id="9" name="图形 8">
            <a:extLst>
              <a:ext uri="{FF2B5EF4-FFF2-40B4-BE49-F238E27FC236}">
                <a16:creationId xmlns:a16="http://schemas.microsoft.com/office/drawing/2014/main" id="{2CC8A10F-F95D-489E-3333-3427AD42E4DC}"/>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353625" y="7931101"/>
            <a:ext cx="2808000" cy="1383943"/>
          </a:xfrm>
          <a:prstGeom prst="rect">
            <a:avLst/>
          </a:prstGeom>
        </p:spPr>
      </p:pic>
      <p:pic>
        <p:nvPicPr>
          <p:cNvPr id="14" name="图形 13">
            <a:extLst>
              <a:ext uri="{FF2B5EF4-FFF2-40B4-BE49-F238E27FC236}">
                <a16:creationId xmlns:a16="http://schemas.microsoft.com/office/drawing/2014/main" id="{4EF15FA2-D716-AD92-E0D1-8E0733A7ACDC}"/>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345833" y="6204122"/>
            <a:ext cx="1579687" cy="1435389"/>
          </a:xfrm>
          <a:prstGeom prst="rect">
            <a:avLst/>
          </a:prstGeom>
        </p:spPr>
      </p:pic>
      <p:grpSp>
        <p:nvGrpSpPr>
          <p:cNvPr id="21" name="组合 20">
            <a:extLst>
              <a:ext uri="{FF2B5EF4-FFF2-40B4-BE49-F238E27FC236}">
                <a16:creationId xmlns:a16="http://schemas.microsoft.com/office/drawing/2014/main" id="{94B44F91-42F0-B1EE-5A8A-939F1F6430AA}"/>
              </a:ext>
            </a:extLst>
          </p:cNvPr>
          <p:cNvGrpSpPr/>
          <p:nvPr/>
        </p:nvGrpSpPr>
        <p:grpSpPr>
          <a:xfrm>
            <a:off x="701395" y="6531494"/>
            <a:ext cx="648439" cy="184666"/>
            <a:chOff x="1010607" y="6891195"/>
            <a:chExt cx="648439" cy="184666"/>
          </a:xfrm>
        </p:grpSpPr>
        <p:pic>
          <p:nvPicPr>
            <p:cNvPr id="263" name="图形 262">
              <a:extLst>
                <a:ext uri="{FF2B5EF4-FFF2-40B4-BE49-F238E27FC236}">
                  <a16:creationId xmlns:a16="http://schemas.microsoft.com/office/drawing/2014/main" id="{EAB3AA7C-C243-A54C-ECE4-358D351AC237}"/>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1010607" y="6930896"/>
              <a:ext cx="402476" cy="105264"/>
            </a:xfrm>
            <a:prstGeom prst="rect">
              <a:avLst/>
            </a:prstGeom>
          </p:spPr>
        </p:pic>
        <p:sp>
          <p:nvSpPr>
            <p:cNvPr id="264" name="文本框 263">
              <a:extLst>
                <a:ext uri="{FF2B5EF4-FFF2-40B4-BE49-F238E27FC236}">
                  <a16:creationId xmlns:a16="http://schemas.microsoft.com/office/drawing/2014/main" id="{C8F4EE18-38B4-E994-86F8-A50D9D9485F6}"/>
                </a:ext>
              </a:extLst>
            </p:cNvPr>
            <p:cNvSpPr txBox="1"/>
            <p:nvPr/>
          </p:nvSpPr>
          <p:spPr>
            <a:xfrm>
              <a:off x="1031246" y="6891195"/>
              <a:ext cx="381836"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Train </a:t>
              </a:r>
              <a:endParaRPr lang="zh-CN" altLang="en-US" sz="600" dirty="0">
                <a:latin typeface="Arial" panose="020B0604020202020204" pitchFamily="34" charset="0"/>
                <a:cs typeface="Arial" panose="020B0604020202020204" pitchFamily="34" charset="0"/>
              </a:endParaRPr>
            </a:p>
          </p:txBody>
        </p:sp>
        <p:sp>
          <p:nvSpPr>
            <p:cNvPr id="265" name="文本框 264">
              <a:extLst>
                <a:ext uri="{FF2B5EF4-FFF2-40B4-BE49-F238E27FC236}">
                  <a16:creationId xmlns:a16="http://schemas.microsoft.com/office/drawing/2014/main" id="{915C6CF0-8D4C-371E-C71E-396BBC64F487}"/>
                </a:ext>
              </a:extLst>
            </p:cNvPr>
            <p:cNvSpPr txBox="1"/>
            <p:nvPr/>
          </p:nvSpPr>
          <p:spPr>
            <a:xfrm>
              <a:off x="1325300" y="6891195"/>
              <a:ext cx="333746"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Test</a:t>
              </a:r>
            </a:p>
          </p:txBody>
        </p:sp>
      </p:grpSp>
      <p:pic>
        <p:nvPicPr>
          <p:cNvPr id="25" name="图形 24">
            <a:extLst>
              <a:ext uri="{FF2B5EF4-FFF2-40B4-BE49-F238E27FC236}">
                <a16:creationId xmlns:a16="http://schemas.microsoft.com/office/drawing/2014/main" id="{D2319473-6531-C903-56B1-693885D59D24}"/>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a:off x="3457029" y="6201816"/>
            <a:ext cx="1532903" cy="1440000"/>
          </a:xfrm>
          <a:prstGeom prst="rect">
            <a:avLst/>
          </a:prstGeom>
        </p:spPr>
      </p:pic>
      <p:pic>
        <p:nvPicPr>
          <p:cNvPr id="27" name="图形 26">
            <a:extLst>
              <a:ext uri="{FF2B5EF4-FFF2-40B4-BE49-F238E27FC236}">
                <a16:creationId xmlns:a16="http://schemas.microsoft.com/office/drawing/2014/main" id="{D1BB299C-85B0-E986-3B90-D8B34C686172}"/>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a:off x="1924823" y="6201816"/>
            <a:ext cx="1532903" cy="1440000"/>
          </a:xfrm>
          <a:prstGeom prst="rect">
            <a:avLst/>
          </a:prstGeom>
        </p:spPr>
      </p:pic>
      <p:sp>
        <p:nvSpPr>
          <p:cNvPr id="43" name="文本框 42">
            <a:extLst>
              <a:ext uri="{FF2B5EF4-FFF2-40B4-BE49-F238E27FC236}">
                <a16:creationId xmlns:a16="http://schemas.microsoft.com/office/drawing/2014/main" id="{E67B5952-FDC0-EC2B-4D7C-1FE157AC3600}"/>
              </a:ext>
            </a:extLst>
          </p:cNvPr>
          <p:cNvSpPr txBox="1"/>
          <p:nvPr/>
        </p:nvSpPr>
        <p:spPr>
          <a:xfrm>
            <a:off x="5587910" y="7339106"/>
            <a:ext cx="33534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05</a:t>
            </a:r>
            <a:endParaRPr lang="zh-CN" altLang="en-US" sz="600" dirty="0">
              <a:latin typeface="Arial" panose="020B0604020202020204" pitchFamily="34" charset="0"/>
              <a:cs typeface="Arial" panose="020B0604020202020204" pitchFamily="34" charset="0"/>
            </a:endParaRPr>
          </a:p>
        </p:txBody>
      </p:sp>
      <p:sp>
        <p:nvSpPr>
          <p:cNvPr id="44" name="文本框 43">
            <a:extLst>
              <a:ext uri="{FF2B5EF4-FFF2-40B4-BE49-F238E27FC236}">
                <a16:creationId xmlns:a16="http://schemas.microsoft.com/office/drawing/2014/main" id="{D475FA99-D9B5-E100-AB6D-9F676FFA71F5}"/>
              </a:ext>
            </a:extLst>
          </p:cNvPr>
          <p:cNvSpPr txBox="1"/>
          <p:nvPr/>
        </p:nvSpPr>
        <p:spPr>
          <a:xfrm>
            <a:off x="6034256" y="7339106"/>
            <a:ext cx="29206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1</a:t>
            </a:r>
            <a:endParaRPr lang="zh-CN" altLang="en-US" sz="600" dirty="0">
              <a:latin typeface="Arial" panose="020B0604020202020204" pitchFamily="34" charset="0"/>
              <a:cs typeface="Arial" panose="020B0604020202020204" pitchFamily="34" charset="0"/>
            </a:endParaRPr>
          </a:p>
        </p:txBody>
      </p:sp>
      <p:sp>
        <p:nvSpPr>
          <p:cNvPr id="52" name="文本框 51">
            <a:extLst>
              <a:ext uri="{FF2B5EF4-FFF2-40B4-BE49-F238E27FC236}">
                <a16:creationId xmlns:a16="http://schemas.microsoft.com/office/drawing/2014/main" id="{6A127115-D74B-471F-D628-2F4B841899D6}"/>
              </a:ext>
            </a:extLst>
          </p:cNvPr>
          <p:cNvSpPr txBox="1"/>
          <p:nvPr/>
        </p:nvSpPr>
        <p:spPr>
          <a:xfrm>
            <a:off x="6192507" y="7339106"/>
            <a:ext cx="378630"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125</a:t>
            </a:r>
            <a:endParaRPr lang="zh-CN" altLang="en-US" sz="600" dirty="0">
              <a:latin typeface="Arial" panose="020B0604020202020204" pitchFamily="34" charset="0"/>
              <a:cs typeface="Arial" panose="020B0604020202020204" pitchFamily="34" charset="0"/>
            </a:endParaRPr>
          </a:p>
        </p:txBody>
      </p:sp>
      <p:grpSp>
        <p:nvGrpSpPr>
          <p:cNvPr id="449" name="组合 448">
            <a:extLst>
              <a:ext uri="{FF2B5EF4-FFF2-40B4-BE49-F238E27FC236}">
                <a16:creationId xmlns:a16="http://schemas.microsoft.com/office/drawing/2014/main" id="{99684CB7-0B90-E476-D2C5-D88378874C9B}"/>
              </a:ext>
            </a:extLst>
          </p:cNvPr>
          <p:cNvGrpSpPr/>
          <p:nvPr/>
        </p:nvGrpSpPr>
        <p:grpSpPr>
          <a:xfrm>
            <a:off x="5655148" y="6087364"/>
            <a:ext cx="929448" cy="363766"/>
            <a:chOff x="5767126" y="5369765"/>
            <a:chExt cx="929448" cy="363766"/>
          </a:xfrm>
        </p:grpSpPr>
        <p:pic>
          <p:nvPicPr>
            <p:cNvPr id="54" name="图片 53">
              <a:extLst>
                <a:ext uri="{FF2B5EF4-FFF2-40B4-BE49-F238E27FC236}">
                  <a16:creationId xmlns:a16="http://schemas.microsoft.com/office/drawing/2014/main" id="{7F01F87B-05E9-2A46-CE12-E56E90959174}"/>
                </a:ext>
              </a:extLst>
            </p:cNvPr>
            <p:cNvPicPr>
              <a:picLocks noChangeAspect="1"/>
            </p:cNvPicPr>
            <p:nvPr/>
          </p:nvPicPr>
          <p:blipFill>
            <a:blip r:embed="rId27"/>
            <a:stretch>
              <a:fillRect/>
            </a:stretch>
          </p:blipFill>
          <p:spPr>
            <a:xfrm>
              <a:off x="5905045" y="5489940"/>
              <a:ext cx="650084" cy="120240"/>
            </a:xfrm>
            <a:prstGeom prst="rect">
              <a:avLst/>
            </a:prstGeom>
          </p:spPr>
        </p:pic>
        <p:sp>
          <p:nvSpPr>
            <p:cNvPr id="234" name="文本框 233">
              <a:extLst>
                <a:ext uri="{FF2B5EF4-FFF2-40B4-BE49-F238E27FC236}">
                  <a16:creationId xmlns:a16="http://schemas.microsoft.com/office/drawing/2014/main" id="{0FDC9A0A-742C-F5EE-3777-A9174211151B}"/>
                </a:ext>
              </a:extLst>
            </p:cNvPr>
            <p:cNvSpPr txBox="1"/>
            <p:nvPr/>
          </p:nvSpPr>
          <p:spPr>
            <a:xfrm>
              <a:off x="5965124" y="5369765"/>
              <a:ext cx="467185" cy="169277"/>
            </a:xfrm>
            <a:prstGeom prst="rect">
              <a:avLst/>
            </a:prstGeom>
            <a:noFill/>
          </p:spPr>
          <p:txBody>
            <a:bodyPr wrap="none" rtlCol="0">
              <a:spAutoFit/>
            </a:bodyPr>
            <a:lstStyle/>
            <a:p>
              <a:r>
                <a:rPr lang="en-US" altLang="zh-CN" sz="500" dirty="0">
                  <a:latin typeface="Arial" panose="020B0604020202020204" pitchFamily="34" charset="0"/>
                  <a:cs typeface="Arial" panose="020B0604020202020204" pitchFamily="34" charset="0"/>
                </a:rPr>
                <a:t>Coefficients</a:t>
              </a:r>
              <a:endParaRPr lang="zh-CN" altLang="en-US" sz="500" dirty="0">
                <a:latin typeface="Arial" panose="020B0604020202020204" pitchFamily="34" charset="0"/>
                <a:cs typeface="Arial" panose="020B0604020202020204" pitchFamily="34" charset="0"/>
              </a:endParaRPr>
            </a:p>
          </p:txBody>
        </p:sp>
        <p:sp>
          <p:nvSpPr>
            <p:cNvPr id="225" name="文本框 224">
              <a:extLst>
                <a:ext uri="{FF2B5EF4-FFF2-40B4-BE49-F238E27FC236}">
                  <a16:creationId xmlns:a16="http://schemas.microsoft.com/office/drawing/2014/main" id="{C4A46067-C83E-B0E3-9E88-17EDB1C78F71}"/>
                </a:ext>
              </a:extLst>
            </p:cNvPr>
            <p:cNvSpPr txBox="1"/>
            <p:nvPr/>
          </p:nvSpPr>
          <p:spPr>
            <a:xfrm>
              <a:off x="5767126" y="5564254"/>
              <a:ext cx="324627"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00</a:t>
              </a:r>
              <a:endParaRPr lang="zh-CN" altLang="en-US" sz="500" dirty="0">
                <a:latin typeface="Arial" panose="020B0604020202020204" pitchFamily="34" charset="0"/>
                <a:cs typeface="Arial" panose="020B0604020202020204" pitchFamily="34" charset="0"/>
              </a:endParaRPr>
            </a:p>
          </p:txBody>
        </p:sp>
        <p:sp>
          <p:nvSpPr>
            <p:cNvPr id="227" name="文本框 226">
              <a:extLst>
                <a:ext uri="{FF2B5EF4-FFF2-40B4-BE49-F238E27FC236}">
                  <a16:creationId xmlns:a16="http://schemas.microsoft.com/office/drawing/2014/main" id="{AE239C17-DAF6-412F-86CF-B260D929B64D}"/>
                </a:ext>
              </a:extLst>
            </p:cNvPr>
            <p:cNvSpPr txBox="1"/>
            <p:nvPr/>
          </p:nvSpPr>
          <p:spPr>
            <a:xfrm>
              <a:off x="6220741" y="5564254"/>
              <a:ext cx="324627"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09</a:t>
              </a:r>
              <a:endParaRPr lang="zh-CN" altLang="en-US" sz="500" dirty="0">
                <a:latin typeface="Arial" panose="020B0604020202020204" pitchFamily="34" charset="0"/>
                <a:cs typeface="Arial" panose="020B0604020202020204" pitchFamily="34" charset="0"/>
              </a:endParaRPr>
            </a:p>
          </p:txBody>
        </p:sp>
        <p:sp>
          <p:nvSpPr>
            <p:cNvPr id="233" name="文本框 232">
              <a:extLst>
                <a:ext uri="{FF2B5EF4-FFF2-40B4-BE49-F238E27FC236}">
                  <a16:creationId xmlns:a16="http://schemas.microsoft.com/office/drawing/2014/main" id="{26D85809-CC1C-0EFE-540C-39036236EBA5}"/>
                </a:ext>
              </a:extLst>
            </p:cNvPr>
            <p:cNvSpPr txBox="1"/>
            <p:nvPr/>
          </p:nvSpPr>
          <p:spPr>
            <a:xfrm>
              <a:off x="6371947" y="5564254"/>
              <a:ext cx="324627"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12</a:t>
              </a:r>
              <a:endParaRPr lang="zh-CN" altLang="en-US" sz="500" dirty="0">
                <a:latin typeface="Arial" panose="020B0604020202020204" pitchFamily="34" charset="0"/>
                <a:cs typeface="Arial" panose="020B0604020202020204" pitchFamily="34" charset="0"/>
              </a:endParaRPr>
            </a:p>
          </p:txBody>
        </p:sp>
        <p:sp>
          <p:nvSpPr>
            <p:cNvPr id="63" name="文本框 62">
              <a:extLst>
                <a:ext uri="{FF2B5EF4-FFF2-40B4-BE49-F238E27FC236}">
                  <a16:creationId xmlns:a16="http://schemas.microsoft.com/office/drawing/2014/main" id="{9E089294-D823-2E62-6A81-2456CA702E9C}"/>
                </a:ext>
              </a:extLst>
            </p:cNvPr>
            <p:cNvSpPr txBox="1"/>
            <p:nvPr/>
          </p:nvSpPr>
          <p:spPr>
            <a:xfrm>
              <a:off x="6069536" y="5564254"/>
              <a:ext cx="324627"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06</a:t>
              </a:r>
              <a:endParaRPr lang="zh-CN" altLang="en-US" sz="500" dirty="0">
                <a:latin typeface="Arial" panose="020B0604020202020204" pitchFamily="34" charset="0"/>
                <a:cs typeface="Arial" panose="020B0604020202020204" pitchFamily="34" charset="0"/>
              </a:endParaRPr>
            </a:p>
          </p:txBody>
        </p:sp>
        <p:sp>
          <p:nvSpPr>
            <p:cNvPr id="448" name="文本框 447">
              <a:extLst>
                <a:ext uri="{FF2B5EF4-FFF2-40B4-BE49-F238E27FC236}">
                  <a16:creationId xmlns:a16="http://schemas.microsoft.com/office/drawing/2014/main" id="{38594605-18C7-654D-51D5-44B3FF186B8C}"/>
                </a:ext>
              </a:extLst>
            </p:cNvPr>
            <p:cNvSpPr txBox="1"/>
            <p:nvPr/>
          </p:nvSpPr>
          <p:spPr>
            <a:xfrm>
              <a:off x="5918331" y="5564254"/>
              <a:ext cx="324627"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03</a:t>
              </a:r>
              <a:endParaRPr lang="zh-CN" altLang="en-US" sz="500" dirty="0">
                <a:latin typeface="Arial" panose="020B0604020202020204" pitchFamily="34" charset="0"/>
                <a:cs typeface="Arial" panose="020B0604020202020204" pitchFamily="34" charset="0"/>
              </a:endParaRPr>
            </a:p>
          </p:txBody>
        </p:sp>
      </p:grpSp>
      <p:pic>
        <p:nvPicPr>
          <p:cNvPr id="457" name="图形 456">
            <a:extLst>
              <a:ext uri="{FF2B5EF4-FFF2-40B4-BE49-F238E27FC236}">
                <a16:creationId xmlns:a16="http://schemas.microsoft.com/office/drawing/2014/main" id="{6FF7AF63-F18A-B3ED-9990-B757730A792F}"/>
              </a:ext>
            </a:extLst>
          </p:cNvPr>
          <p:cNvPicPr>
            <a:picLocks noChangeAspect="1"/>
          </p:cNvPicPr>
          <p:nvPr/>
        </p:nvPicPr>
        <p:blipFill>
          <a:blip r:embed="rId28">
            <a:extLst>
              <a:ext uri="{96DAC541-7B7A-43D3-8B79-37D633B846F1}">
                <asvg:svgBlip xmlns:asvg="http://schemas.microsoft.com/office/drawing/2016/SVG/main" r:embed="rId29"/>
              </a:ext>
            </a:extLst>
          </a:blip>
          <a:stretch>
            <a:fillRect/>
          </a:stretch>
        </p:blipFill>
        <p:spPr>
          <a:xfrm>
            <a:off x="1914337" y="2667024"/>
            <a:ext cx="1532903" cy="1440000"/>
          </a:xfrm>
          <a:prstGeom prst="rect">
            <a:avLst/>
          </a:prstGeom>
        </p:spPr>
      </p:pic>
      <p:sp>
        <p:nvSpPr>
          <p:cNvPr id="463" name="文本框 462">
            <a:extLst>
              <a:ext uri="{FF2B5EF4-FFF2-40B4-BE49-F238E27FC236}">
                <a16:creationId xmlns:a16="http://schemas.microsoft.com/office/drawing/2014/main" id="{F5E2FFBC-821D-C96F-5C48-C5515BEE784A}"/>
              </a:ext>
            </a:extLst>
          </p:cNvPr>
          <p:cNvSpPr txBox="1"/>
          <p:nvPr/>
        </p:nvSpPr>
        <p:spPr>
          <a:xfrm>
            <a:off x="5656695" y="3841458"/>
            <a:ext cx="335348" cy="184666"/>
          </a:xfrm>
          <a:prstGeom prst="rect">
            <a:avLst/>
          </a:prstGeom>
          <a:noFill/>
        </p:spPr>
        <p:txBody>
          <a:bodyPr wrap="none" rtlCol="0">
            <a:spAutoFit/>
          </a:bodyPr>
          <a:lstStyle/>
          <a:p>
            <a:r>
              <a:rPr lang="en-US" altLang="zh-CN" sz="600" dirty="0">
                <a:latin typeface="Arial" panose="020B0604020202020204" pitchFamily="34" charset="0"/>
                <a:cs typeface="Arial" panose="020B0604020202020204" pitchFamily="34" charset="0"/>
              </a:rPr>
              <a:t>0.05</a:t>
            </a:r>
            <a:endParaRPr lang="zh-CN" altLang="en-US" sz="600" dirty="0">
              <a:latin typeface="Arial" panose="020B0604020202020204" pitchFamily="34" charset="0"/>
              <a:cs typeface="Arial" panose="020B0604020202020204" pitchFamily="34" charset="0"/>
            </a:endParaRPr>
          </a:p>
        </p:txBody>
      </p:sp>
      <p:grpSp>
        <p:nvGrpSpPr>
          <p:cNvPr id="472" name="组合 471">
            <a:extLst>
              <a:ext uri="{FF2B5EF4-FFF2-40B4-BE49-F238E27FC236}">
                <a16:creationId xmlns:a16="http://schemas.microsoft.com/office/drawing/2014/main" id="{84AFA041-9008-47E6-22E5-041709B741AA}"/>
              </a:ext>
            </a:extLst>
          </p:cNvPr>
          <p:cNvGrpSpPr/>
          <p:nvPr/>
        </p:nvGrpSpPr>
        <p:grpSpPr>
          <a:xfrm>
            <a:off x="5801821" y="2663459"/>
            <a:ext cx="675468" cy="381901"/>
            <a:chOff x="5933724" y="1618737"/>
            <a:chExt cx="675468" cy="381901"/>
          </a:xfrm>
        </p:grpSpPr>
        <p:sp>
          <p:nvSpPr>
            <p:cNvPr id="56" name="文本框 55">
              <a:extLst>
                <a:ext uri="{FF2B5EF4-FFF2-40B4-BE49-F238E27FC236}">
                  <a16:creationId xmlns:a16="http://schemas.microsoft.com/office/drawing/2014/main" id="{2486DCD9-6174-EE4E-7207-38ED75DE96BF}"/>
                </a:ext>
              </a:extLst>
            </p:cNvPr>
            <p:cNvSpPr txBox="1"/>
            <p:nvPr/>
          </p:nvSpPr>
          <p:spPr>
            <a:xfrm>
              <a:off x="5933724" y="1831361"/>
              <a:ext cx="360000"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00</a:t>
              </a:r>
              <a:endParaRPr lang="zh-CN" altLang="en-US" sz="500"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3A6497D3-1D07-ED76-C787-2239DA2A3F5C}"/>
                </a:ext>
              </a:extLst>
            </p:cNvPr>
            <p:cNvSpPr txBox="1"/>
            <p:nvPr/>
          </p:nvSpPr>
          <p:spPr>
            <a:xfrm>
              <a:off x="6087111" y="1831361"/>
              <a:ext cx="360000"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05</a:t>
              </a:r>
              <a:endParaRPr lang="zh-CN" altLang="en-US" sz="500" dirty="0">
                <a:latin typeface="Arial" panose="020B0604020202020204" pitchFamily="34" charset="0"/>
                <a:cs typeface="Arial" panose="020B0604020202020204" pitchFamily="34" charset="0"/>
              </a:endParaRPr>
            </a:p>
          </p:txBody>
        </p:sp>
        <p:sp>
          <p:nvSpPr>
            <p:cNvPr id="58" name="文本框 57">
              <a:extLst>
                <a:ext uri="{FF2B5EF4-FFF2-40B4-BE49-F238E27FC236}">
                  <a16:creationId xmlns:a16="http://schemas.microsoft.com/office/drawing/2014/main" id="{DF79468E-44FB-2D97-E635-220F1178B1CE}"/>
                </a:ext>
              </a:extLst>
            </p:cNvPr>
            <p:cNvSpPr txBox="1"/>
            <p:nvPr/>
          </p:nvSpPr>
          <p:spPr>
            <a:xfrm>
              <a:off x="6249192" y="1831361"/>
              <a:ext cx="360000" cy="169277"/>
            </a:xfrm>
            <a:prstGeom prst="rect">
              <a:avLst/>
            </a:prstGeom>
            <a:noFill/>
          </p:spPr>
          <p:txBody>
            <a:bodyPr wrap="square" rtlCol="0">
              <a:spAutoFit/>
            </a:bodyPr>
            <a:lstStyle/>
            <a:p>
              <a:r>
                <a:rPr lang="en-US" altLang="zh-CN" sz="500" dirty="0">
                  <a:latin typeface="Arial" panose="020B0604020202020204" pitchFamily="34" charset="0"/>
                  <a:cs typeface="Arial" panose="020B0604020202020204" pitchFamily="34" charset="0"/>
                </a:rPr>
                <a:t>0.10</a:t>
              </a:r>
              <a:endParaRPr lang="zh-CN" altLang="en-US" sz="500" dirty="0">
                <a:latin typeface="Arial" panose="020B0604020202020204" pitchFamily="34" charset="0"/>
                <a:cs typeface="Arial" panose="020B0604020202020204" pitchFamily="34" charset="0"/>
              </a:endParaRPr>
            </a:p>
          </p:txBody>
        </p:sp>
        <p:sp>
          <p:nvSpPr>
            <p:cNvPr id="59" name="文本框 58">
              <a:extLst>
                <a:ext uri="{FF2B5EF4-FFF2-40B4-BE49-F238E27FC236}">
                  <a16:creationId xmlns:a16="http://schemas.microsoft.com/office/drawing/2014/main" id="{5E549812-E849-A0F1-0085-AD89880B94EB}"/>
                </a:ext>
              </a:extLst>
            </p:cNvPr>
            <p:cNvSpPr txBox="1"/>
            <p:nvPr/>
          </p:nvSpPr>
          <p:spPr>
            <a:xfrm>
              <a:off x="6060263" y="1618737"/>
              <a:ext cx="518091" cy="169277"/>
            </a:xfrm>
            <a:prstGeom prst="rect">
              <a:avLst/>
            </a:prstGeom>
            <a:noFill/>
          </p:spPr>
          <p:txBody>
            <a:bodyPr wrap="none" rtlCol="0">
              <a:spAutoFit/>
            </a:bodyPr>
            <a:lstStyle/>
            <a:p>
              <a:r>
                <a:rPr lang="en-US" altLang="zh-CN" sz="500" dirty="0">
                  <a:latin typeface="Arial" panose="020B0604020202020204" pitchFamily="34" charset="0"/>
                  <a:cs typeface="Arial" panose="020B0604020202020204" pitchFamily="34" charset="0"/>
                </a:rPr>
                <a:t>Coefficients</a:t>
              </a:r>
              <a:endParaRPr lang="zh-CN" altLang="en-US" sz="500" dirty="0">
                <a:latin typeface="Arial" panose="020B0604020202020204" pitchFamily="34" charset="0"/>
                <a:cs typeface="Arial" panose="020B0604020202020204" pitchFamily="34" charset="0"/>
              </a:endParaRPr>
            </a:p>
          </p:txBody>
        </p:sp>
        <p:pic>
          <p:nvPicPr>
            <p:cNvPr id="471" name="图片 470">
              <a:extLst>
                <a:ext uri="{FF2B5EF4-FFF2-40B4-BE49-F238E27FC236}">
                  <a16:creationId xmlns:a16="http://schemas.microsoft.com/office/drawing/2014/main" id="{0A5E1DBE-6CDF-22F6-F409-44E7848E5551}"/>
                </a:ext>
              </a:extLst>
            </p:cNvPr>
            <p:cNvPicPr>
              <a:picLocks noChangeAspect="1"/>
            </p:cNvPicPr>
            <p:nvPr/>
          </p:nvPicPr>
          <p:blipFill>
            <a:blip r:embed="rId30"/>
            <a:stretch>
              <a:fillRect/>
            </a:stretch>
          </p:blipFill>
          <p:spPr>
            <a:xfrm>
              <a:off x="6064043" y="1758765"/>
              <a:ext cx="513660" cy="106274"/>
            </a:xfrm>
            <a:prstGeom prst="rect">
              <a:avLst/>
            </a:prstGeom>
          </p:spPr>
        </p:pic>
      </p:grpSp>
      <p:sp>
        <p:nvSpPr>
          <p:cNvPr id="475" name="文本框 474">
            <a:extLst>
              <a:ext uri="{FF2B5EF4-FFF2-40B4-BE49-F238E27FC236}">
                <a16:creationId xmlns:a16="http://schemas.microsoft.com/office/drawing/2014/main" id="{D5C924CB-CC72-2DDF-FC93-759FDAF853F7}"/>
              </a:ext>
            </a:extLst>
          </p:cNvPr>
          <p:cNvSpPr txBox="1"/>
          <p:nvPr/>
        </p:nvSpPr>
        <p:spPr>
          <a:xfrm>
            <a:off x="326904" y="5839978"/>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E</a:t>
            </a:r>
            <a:endParaRPr lang="zh-CN" altLang="en-US" sz="1000" dirty="0">
              <a:latin typeface="Arial" panose="020B0604020202020204" pitchFamily="34" charset="0"/>
              <a:cs typeface="Arial" panose="020B0604020202020204" pitchFamily="34" charset="0"/>
            </a:endParaRPr>
          </a:p>
        </p:txBody>
      </p:sp>
      <p:sp>
        <p:nvSpPr>
          <p:cNvPr id="476" name="文本框 475">
            <a:extLst>
              <a:ext uri="{FF2B5EF4-FFF2-40B4-BE49-F238E27FC236}">
                <a16:creationId xmlns:a16="http://schemas.microsoft.com/office/drawing/2014/main" id="{EDF3C0BC-8842-C349-D05F-828CD82F1DF7}"/>
              </a:ext>
            </a:extLst>
          </p:cNvPr>
          <p:cNvSpPr txBox="1"/>
          <p:nvPr/>
        </p:nvSpPr>
        <p:spPr>
          <a:xfrm>
            <a:off x="326904" y="7674599"/>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F</a:t>
            </a:r>
            <a:endParaRPr lang="zh-CN" altLang="en-US" sz="1000" dirty="0">
              <a:latin typeface="Arial" panose="020B0604020202020204" pitchFamily="34" charset="0"/>
              <a:cs typeface="Arial" panose="020B0604020202020204" pitchFamily="34" charset="0"/>
            </a:endParaRPr>
          </a:p>
        </p:txBody>
      </p:sp>
      <p:sp>
        <p:nvSpPr>
          <p:cNvPr id="477" name="文本框 476">
            <a:extLst>
              <a:ext uri="{FF2B5EF4-FFF2-40B4-BE49-F238E27FC236}">
                <a16:creationId xmlns:a16="http://schemas.microsoft.com/office/drawing/2014/main" id="{233075BE-E029-F841-DCDF-1BC2E628FE8B}"/>
              </a:ext>
            </a:extLst>
          </p:cNvPr>
          <p:cNvSpPr txBox="1"/>
          <p:nvPr/>
        </p:nvSpPr>
        <p:spPr>
          <a:xfrm>
            <a:off x="-6307" y="-19033"/>
            <a:ext cx="1049438"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Figure S2</a:t>
            </a:r>
            <a:endParaRPr lang="zh-CN" altLang="en-US" sz="1000" dirty="0">
              <a:latin typeface="Arial" panose="020B0604020202020204" pitchFamily="34" charset="0"/>
              <a:cs typeface="Arial" panose="020B0604020202020204" pitchFamily="34" charset="0"/>
            </a:endParaRPr>
          </a:p>
        </p:txBody>
      </p:sp>
      <p:pic>
        <p:nvPicPr>
          <p:cNvPr id="4" name="图形 3">
            <a:extLst>
              <a:ext uri="{FF2B5EF4-FFF2-40B4-BE49-F238E27FC236}">
                <a16:creationId xmlns:a16="http://schemas.microsoft.com/office/drawing/2014/main" id="{41F29F19-2647-EA9E-C78D-E305C43AACCA}"/>
              </a:ext>
            </a:extLst>
          </p:cNvPr>
          <p:cNvPicPr>
            <a:picLocks noChangeAspect="1"/>
          </p:cNvPicPr>
          <p:nvPr/>
        </p:nvPicPr>
        <p:blipFill>
          <a:blip r:embed="rId31">
            <a:extLst>
              <a:ext uri="{96DAC541-7B7A-43D3-8B79-37D633B846F1}">
                <asvg:svgBlip xmlns:asvg="http://schemas.microsoft.com/office/drawing/2016/SVG/main" r:embed="rId32"/>
              </a:ext>
            </a:extLst>
          </a:blip>
          <a:stretch>
            <a:fillRect/>
          </a:stretch>
        </p:blipFill>
        <p:spPr>
          <a:xfrm>
            <a:off x="3497137" y="425068"/>
            <a:ext cx="2158011" cy="1800000"/>
          </a:xfrm>
          <a:prstGeom prst="rect">
            <a:avLst/>
          </a:prstGeom>
        </p:spPr>
      </p:pic>
      <p:pic>
        <p:nvPicPr>
          <p:cNvPr id="6" name="图形 5">
            <a:extLst>
              <a:ext uri="{FF2B5EF4-FFF2-40B4-BE49-F238E27FC236}">
                <a16:creationId xmlns:a16="http://schemas.microsoft.com/office/drawing/2014/main" id="{8010BC96-2F88-B524-2744-5713C3C5C559}"/>
              </a:ext>
            </a:extLst>
          </p:cNvPr>
          <p:cNvPicPr>
            <a:picLocks noChangeAspect="1"/>
          </p:cNvPicPr>
          <p:nvPr/>
        </p:nvPicPr>
        <p:blipFill>
          <a:blip r:embed="rId33">
            <a:extLst>
              <a:ext uri="{96DAC541-7B7A-43D3-8B79-37D633B846F1}">
                <asvg:svgBlip xmlns:asvg="http://schemas.microsoft.com/office/drawing/2016/SVG/main" r:embed="rId34"/>
              </a:ext>
            </a:extLst>
          </a:blip>
          <a:stretch>
            <a:fillRect/>
          </a:stretch>
        </p:blipFill>
        <p:spPr>
          <a:xfrm>
            <a:off x="528426" y="425068"/>
            <a:ext cx="2874033" cy="1800000"/>
          </a:xfrm>
          <a:prstGeom prst="rect">
            <a:avLst/>
          </a:prstGeom>
        </p:spPr>
      </p:pic>
      <p:sp>
        <p:nvSpPr>
          <p:cNvPr id="8" name="文本框 7">
            <a:extLst>
              <a:ext uri="{FF2B5EF4-FFF2-40B4-BE49-F238E27FC236}">
                <a16:creationId xmlns:a16="http://schemas.microsoft.com/office/drawing/2014/main" id="{7521D93E-DAA8-C23B-84BD-993A4A6B5EDC}"/>
              </a:ext>
            </a:extLst>
          </p:cNvPr>
          <p:cNvSpPr txBox="1"/>
          <p:nvPr/>
        </p:nvSpPr>
        <p:spPr>
          <a:xfrm>
            <a:off x="326904" y="288012"/>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A</a:t>
            </a:r>
            <a:endParaRPr lang="zh-CN" altLang="en-US" sz="10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0E054609-73F1-34E6-3D08-017D3FAEF2DF}"/>
              </a:ext>
            </a:extLst>
          </p:cNvPr>
          <p:cNvSpPr txBox="1"/>
          <p:nvPr/>
        </p:nvSpPr>
        <p:spPr>
          <a:xfrm>
            <a:off x="1214614" y="351525"/>
            <a:ext cx="121573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TX+LEF</a:t>
            </a:r>
            <a:endParaRPr lang="zh-CN" altLang="en-US" sz="800" dirty="0">
              <a:latin typeface="Arial" panose="020B0604020202020204" pitchFamily="34" charset="0"/>
              <a:cs typeface="Arial" panose="020B0604020202020204" pitchFamily="34" charset="0"/>
            </a:endParaRPr>
          </a:p>
        </p:txBody>
      </p:sp>
      <p:sp>
        <p:nvSpPr>
          <p:cNvPr id="12" name="文本框 11">
            <a:extLst>
              <a:ext uri="{FF2B5EF4-FFF2-40B4-BE49-F238E27FC236}">
                <a16:creationId xmlns:a16="http://schemas.microsoft.com/office/drawing/2014/main" id="{998A8E49-B458-0078-AD4B-C0B6A6449A7B}"/>
              </a:ext>
            </a:extLst>
          </p:cNvPr>
          <p:cNvSpPr txBox="1"/>
          <p:nvPr/>
        </p:nvSpPr>
        <p:spPr>
          <a:xfrm>
            <a:off x="3884701" y="351525"/>
            <a:ext cx="1215738" cy="215444"/>
          </a:xfrm>
          <a:prstGeom prst="rect">
            <a:avLst/>
          </a:prstGeom>
          <a:noFill/>
        </p:spPr>
        <p:txBody>
          <a:bodyPr wrap="square" rtlCol="0">
            <a:spAutoFit/>
          </a:bodyPr>
          <a:lstStyle/>
          <a:p>
            <a:pPr algn="ctr"/>
            <a:r>
              <a:rPr lang="en-US" altLang="zh-CN" sz="800" dirty="0">
                <a:latin typeface="Arial" panose="020B0604020202020204" pitchFamily="34" charset="0"/>
                <a:cs typeface="Arial" panose="020B0604020202020204" pitchFamily="34" charset="0"/>
              </a:rPr>
              <a:t>MTX+HCQ</a:t>
            </a:r>
            <a:endParaRPr lang="zh-CN" altLang="en-US" sz="800" dirty="0">
              <a:latin typeface="Arial" panose="020B0604020202020204" pitchFamily="34" charset="0"/>
              <a:cs typeface="Arial" panose="020B0604020202020204" pitchFamily="34" charset="0"/>
            </a:endParaRPr>
          </a:p>
        </p:txBody>
      </p:sp>
      <p:sp>
        <p:nvSpPr>
          <p:cNvPr id="13" name="文本框 12">
            <a:extLst>
              <a:ext uri="{FF2B5EF4-FFF2-40B4-BE49-F238E27FC236}">
                <a16:creationId xmlns:a16="http://schemas.microsoft.com/office/drawing/2014/main" id="{C5D167DC-1CC4-DDB4-E890-139510BED56E}"/>
              </a:ext>
            </a:extLst>
          </p:cNvPr>
          <p:cNvSpPr txBox="1"/>
          <p:nvPr/>
        </p:nvSpPr>
        <p:spPr>
          <a:xfrm>
            <a:off x="3497137" y="288012"/>
            <a:ext cx="302193" cy="246221"/>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B</a:t>
            </a:r>
            <a:endParaRPr lang="zh-CN"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65210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5D49429-0CAB-D73A-D997-2FA0CC230902}"/>
            </a:ext>
          </a:extLst>
        </p:cNvPr>
        <p:cNvGrpSpPr/>
        <p:nvPr/>
      </p:nvGrpSpPr>
      <p:grpSpPr>
        <a:xfrm>
          <a:off x="0" y="0"/>
          <a:ext cx="0" cy="0"/>
          <a:chOff x="0" y="0"/>
          <a:chExt cx="0" cy="0"/>
        </a:xfrm>
      </p:grpSpPr>
      <p:sp>
        <p:nvSpPr>
          <p:cNvPr id="11" name="文本框 10">
            <a:extLst>
              <a:ext uri="{FF2B5EF4-FFF2-40B4-BE49-F238E27FC236}">
                <a16:creationId xmlns:a16="http://schemas.microsoft.com/office/drawing/2014/main" id="{A8451B07-2732-CB0B-B65E-8A264B2679F4}"/>
              </a:ext>
            </a:extLst>
          </p:cNvPr>
          <p:cNvSpPr txBox="1"/>
          <p:nvPr/>
        </p:nvSpPr>
        <p:spPr>
          <a:xfrm>
            <a:off x="307329" y="306727"/>
            <a:ext cx="6243342" cy="5395516"/>
          </a:xfrm>
          <a:prstGeom prst="rect">
            <a:avLst/>
          </a:prstGeom>
          <a:noFill/>
        </p:spPr>
        <p:txBody>
          <a:bodyPr wrap="square">
            <a:spAutoFit/>
          </a:bodyPr>
          <a:lstStyle/>
          <a:p>
            <a:pPr algn="just">
              <a:lnSpc>
                <a:spcPct val="150000"/>
              </a:lnSpc>
            </a:pPr>
            <a:r>
              <a:rPr lang="en-US" altLang="zh-CN" sz="1050" dirty="0">
                <a:latin typeface="Times New Roman" panose="02020603050405020304" pitchFamily="18" charset="0"/>
                <a:cs typeface="Times New Roman" panose="02020603050405020304" pitchFamily="18" charset="0"/>
              </a:rPr>
              <a:t>Figure S2. Predictive modeling based on varied features. A-B) Line plot showing area under the receiver operating characteristic curve (AUROC) across models with increasing numbers of metabolite features for MTX+LEF (A) and MTX+HCQ (B). Candidate metabolite features were selected by least absolute shrinkage and selection operator (LASSO) regression and added sequentially to clinical predictors based on the absolute coefficients. Blue and red lines represent the training and testing sets, respectively. Error bars indicate the median and range of AUROC values across all successfully converged iterations. C) Performance evaluation of the machine learning model for predicting response to MTX+LEF based on clinical features across converged iterations. (Left) Distribution of AUROC values for training (red) and test (blue) sets. (Middle) ROC curves for the training set. (Right) ROC curves for the test set. (Far Right) Coefficient contributions of features to the predictive model. D) Dot plots presenting the integrated discrimination improvement (IDI) with 95% confidence intervals across converged iterations, comparing models incorporating both metabolite and clinical features versus clinical features alone for MTX+LEF. Left panel: training set; right panel: testing set. Red dots indicate statistically significant improvement (</a:t>
            </a:r>
            <a:r>
              <a:rPr lang="en-US" altLang="zh-CN" sz="1050" i="1" dirty="0">
                <a:latin typeface="Times New Roman" panose="02020603050405020304" pitchFamily="18" charset="0"/>
                <a:cs typeface="Times New Roman" panose="02020603050405020304" pitchFamily="18" charset="0"/>
              </a:rPr>
              <a:t>p</a:t>
            </a:r>
            <a:r>
              <a:rPr lang="en-US" altLang="zh-CN" sz="1050" dirty="0">
                <a:latin typeface="Times New Roman" panose="02020603050405020304" pitchFamily="18" charset="0"/>
                <a:cs typeface="Times New Roman" panose="02020603050405020304" pitchFamily="18" charset="0"/>
              </a:rPr>
              <a:t> &lt; 0.05, two-sided </a:t>
            </a:r>
            <a:r>
              <a:rPr lang="en-US" altLang="zh-CN" sz="1050" i="1" dirty="0">
                <a:latin typeface="Times New Roman" panose="02020603050405020304" pitchFamily="18" charset="0"/>
                <a:cs typeface="Times New Roman" panose="02020603050405020304" pitchFamily="18" charset="0"/>
              </a:rPr>
              <a:t>t</a:t>
            </a:r>
            <a:r>
              <a:rPr lang="en-US" altLang="zh-CN" sz="1050" dirty="0">
                <a:latin typeface="Times New Roman" panose="02020603050405020304" pitchFamily="18" charset="0"/>
                <a:cs typeface="Times New Roman" panose="02020603050405020304" pitchFamily="18" charset="0"/>
              </a:rPr>
              <a:t>-tests); gray dots denote not significant results. E) Performance evaluation of the machine learning model for predicting response to MTX+HCQ based on clinical features across converged iterations. (Left) Distribution of AUROC values for training (red) and test (blue) sets. (Middle) ROC curves for the training set. (Right) ROC curves for the test set. (Far Right) Coefficient contributions of features to the predictive model. Significance levels: *</a:t>
            </a:r>
            <a:r>
              <a:rPr lang="en-US" altLang="zh-CN" sz="1050" i="1" dirty="0">
                <a:latin typeface="Times New Roman" panose="02020603050405020304" pitchFamily="18" charset="0"/>
                <a:cs typeface="Times New Roman" panose="02020603050405020304" pitchFamily="18" charset="0"/>
              </a:rPr>
              <a:t>p</a:t>
            </a:r>
            <a:r>
              <a:rPr lang="en-US" altLang="zh-CN" sz="1050" dirty="0">
                <a:latin typeface="Times New Roman" panose="02020603050405020304" pitchFamily="18" charset="0"/>
                <a:cs typeface="Times New Roman" panose="02020603050405020304" pitchFamily="18" charset="0"/>
              </a:rPr>
              <a:t> &lt; 0.05, ***</a:t>
            </a:r>
            <a:r>
              <a:rPr lang="en-US" altLang="zh-CN" sz="1050" i="1" dirty="0">
                <a:latin typeface="Times New Roman" panose="02020603050405020304" pitchFamily="18" charset="0"/>
                <a:cs typeface="Times New Roman" panose="02020603050405020304" pitchFamily="18" charset="0"/>
              </a:rPr>
              <a:t>p</a:t>
            </a:r>
            <a:r>
              <a:rPr lang="en-US" altLang="zh-CN" sz="1050" dirty="0">
                <a:latin typeface="Times New Roman" panose="02020603050405020304" pitchFamily="18" charset="0"/>
                <a:cs typeface="Times New Roman" panose="02020603050405020304" pitchFamily="18" charset="0"/>
              </a:rPr>
              <a:t> &lt; 0.001; “ns” indicates not significant. F) Dot plots presenting the IDI with 95% confidence intervals across converged iterations, comparing models incorporating both metabolite and clinical features versus clinical features alone for MTX+HCQ. Left panel: training set; right panel: testing set. Red dots indicate statistically significant improvement (</a:t>
            </a:r>
            <a:r>
              <a:rPr lang="en-US" altLang="zh-CN" sz="1050" i="1" dirty="0">
                <a:latin typeface="Times New Roman" panose="02020603050405020304" pitchFamily="18" charset="0"/>
                <a:cs typeface="Times New Roman" panose="02020603050405020304" pitchFamily="18" charset="0"/>
              </a:rPr>
              <a:t>p</a:t>
            </a:r>
            <a:r>
              <a:rPr lang="en-US" altLang="zh-CN" sz="1050" dirty="0">
                <a:latin typeface="Times New Roman" panose="02020603050405020304" pitchFamily="18" charset="0"/>
                <a:cs typeface="Times New Roman" panose="02020603050405020304" pitchFamily="18" charset="0"/>
              </a:rPr>
              <a:t> &lt; 0.05, two-sided </a:t>
            </a:r>
            <a:r>
              <a:rPr lang="en-US" altLang="zh-CN" sz="1050" i="1" dirty="0">
                <a:latin typeface="Times New Roman" panose="02020603050405020304" pitchFamily="18" charset="0"/>
                <a:cs typeface="Times New Roman" panose="02020603050405020304" pitchFamily="18" charset="0"/>
              </a:rPr>
              <a:t>t</a:t>
            </a:r>
            <a:r>
              <a:rPr lang="en-US" altLang="zh-CN" sz="1050" dirty="0">
                <a:latin typeface="Times New Roman" panose="02020603050405020304" pitchFamily="18" charset="0"/>
                <a:cs typeface="Times New Roman" panose="02020603050405020304" pitchFamily="18" charset="0"/>
              </a:rPr>
              <a:t>-tests); gray dots denote not significant results.</a:t>
            </a:r>
          </a:p>
          <a:p>
            <a:pPr algn="just">
              <a:lnSpc>
                <a:spcPct val="150000"/>
              </a:lnSpc>
            </a:pPr>
            <a:endParaRPr lang="en-US" altLang="zh-CN" sz="105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72088151"/>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font">
      <a:majorFont>
        <a:latin typeface="Calibri Light"/>
        <a:ea typeface="等线 Light"/>
        <a:cs typeface=""/>
      </a:majorFont>
      <a:minorFont>
        <a:latin typeface="Calibri"/>
        <a:ea typeface="等线"/>
        <a:cs typeface=""/>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76181</TotalTime>
  <Words>773</Words>
  <Application>Microsoft Office PowerPoint</Application>
  <PresentationFormat>A4 纸张(210x297 毫米)</PresentationFormat>
  <Paragraphs>121</Paragraphs>
  <Slides>4</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4</vt:i4>
      </vt:variant>
    </vt:vector>
  </HeadingPairs>
  <TitlesOfParts>
    <vt:vector size="10" baseType="lpstr">
      <vt:lpstr>等线</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1191569605@qq.com</dc:creator>
  <cp:lastModifiedBy>佳艺 许</cp:lastModifiedBy>
  <cp:revision>776</cp:revision>
  <dcterms:created xsi:type="dcterms:W3CDTF">2023-07-27T11:11:54Z</dcterms:created>
  <dcterms:modified xsi:type="dcterms:W3CDTF">2025-07-17T05:35:54Z</dcterms:modified>
</cp:coreProperties>
</file>